
<file path=[Content_Types].xml><?xml version="1.0" encoding="utf-8"?>
<Types xmlns="http://schemas.openxmlformats.org/package/2006/content-types">
  <Override PartName="/ppt/notesSlides/notesSlide2.xml" ContentType="application/vnd.openxmlformats-officedocument.presentationml.notesSlide+xml"/>
  <Override PartName="/ppt/slides/slide4.xml" ContentType="application/vnd.openxmlformats-officedocument.presentationml.slide+xml"/>
  <Override PartName="/ppt/slideLayouts/slideLayout6.xml" ContentType="application/vnd.openxmlformats-officedocument.presentationml.slideLayout+xml"/>
  <Override PartName="/ppt/slideLayouts/slideLayout17.xml" ContentType="application/vnd.openxmlformats-officedocument.presentationml.slideLayout+xml"/>
  <Override PartName="/customXml/itemProps1.xml" ContentType="application/vnd.openxmlformats-officedocument.customXmlProperties+xml"/>
  <Default Extension="rels" ContentType="application/vnd.openxmlformats-package.relationships+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15.xml" ContentType="application/vnd.openxmlformats-officedocument.presentationml.slideLayout+xml"/>
  <Default Extension="xml" ContentType="application/xml"/>
  <Override PartName="/ppt/notesMasters/notesMaster1.xml" ContentType="application/vnd.openxmlformats-officedocument.presentationml.notesMaster+xml"/>
  <Override PartName="/ppt/slideLayouts/slideLayout13.xml" ContentType="application/vnd.openxmlformats-officedocument.presentationml.slideLayout+xml"/>
  <Override PartName="/ppt/slideLayouts/slideLayout22.xml" ContentType="application/vnd.openxmlformats-officedocument.presentationml.slideLayout+xml"/>
  <Override PartName="/ppt/slides/slide10.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20.xml" ContentType="application/vnd.openxmlformats-officedocument.presentationml.slideLayout+xml"/>
  <Override PartName="/docProps/custom.xml" ContentType="application/vnd.openxmlformats-officedocument.custom-properties+xml"/>
  <Override PartName="/ppt/charts/chart7.xml" ContentType="application/vnd.openxmlformats-officedocument.drawingml.chart+xml"/>
  <Override PartName="/ppt/charts/chart3.xml" ContentType="application/vnd.openxmlformats-officedocument.drawingml.chart+xml"/>
  <Override PartName="/ppt/charts/chart5.xml" ContentType="application/vnd.openxmlformats-officedocument.drawingml.chart+xml"/>
  <Override PartName="/ppt/diagrams/layout1.xml" ContentType="application/vnd.openxmlformats-officedocument.drawingml.diagramLayout+xml"/>
  <Override PartName="/ppt/slides/slide7.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Default Extension="png" ContentType="image/png"/>
  <Override PartName="/ppt/slideMasters/slideMaster2.xml" ContentType="application/vnd.openxmlformats-officedocument.presentationml.slideMaster+xml"/>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diagrams/drawing1.xml" ContentType="application/vnd.ms-office.drawingml.diagramDrawing+xml"/>
  <Default Extension="jpeg" ContentType="image/jpeg"/>
  <Default Extension="emf" ContentType="image/x-emf"/>
  <Override PartName="/ppt/slides/slide1.xml" ContentType="application/vnd.openxmlformats-officedocument.presentationml.slide+xml"/>
  <Override PartName="/ppt/slideLayouts/slideLayout3.xml" ContentType="application/vnd.openxmlformats-officedocument.presentationml.slideLayout+xml"/>
  <Override PartName="/ppt/slideLayouts/slideLayout16.xml" ContentType="application/vnd.openxmlformats-officedocument.presentationml.slideLayout+xml"/>
  <Override PartName="/ppt/diagrams/quickStyle1.xml" ContentType="application/vnd.openxmlformats-officedocument.drawingml.diagramStyle+xml"/>
  <Override PartName="/ppt/presentation.xml" ContentType="application/vnd.openxmlformats-officedocument.presentationml.presentation.main+xml"/>
  <Override PartName="/ppt/slides/slide13.xml" ContentType="application/vnd.openxmlformats-officedocument.presentationml.slide+xml"/>
  <Override PartName="/ppt/slideLayouts/slideLayout1.xml" ContentType="application/vnd.openxmlformats-officedocument.presentationml.slideLayout+xml"/>
  <Override PartName="/ppt/slideLayouts/slideLayout14.xml" ContentType="application/vnd.openxmlformats-officedocument.presentationml.slideLayout+xml"/>
  <Override PartName="/docProps/app.xml" ContentType="application/vnd.openxmlformats-officedocument.extended-properties+xml"/>
  <Override PartName="/ppt/slides/slide11.xml" ContentType="application/vnd.openxmlformats-officedocument.presentationml.slide+xml"/>
  <Override PartName="/ppt/slideLayouts/slideLayout12.xml" ContentType="application/vnd.openxmlformats-officedocument.presentationml.slideLayout+xml"/>
  <Override PartName="/ppt/slideLayouts/slideLayout21.xml" ContentType="application/vnd.openxmlformats-officedocument.presentationml.slideLayout+xml"/>
  <Override PartName="/ppt/slideLayouts/slideLayout10.xml" ContentType="application/vnd.openxmlformats-officedocument.presentationml.slideLayout+xml"/>
  <Override PartName="/ppt/charts/chart6.xml" ContentType="application/vnd.openxmlformats-officedocument.drawingml.chart+xml"/>
  <Override PartName="/ppt/charts/chart4.xml" ContentType="application/vnd.openxmlformats-officedocument.drawingml.chart+xml"/>
  <Override PartName="/ppt/slides/slide8.xml" ContentType="application/vnd.openxmlformats-officedocument.presentationml.slide+xml"/>
  <Override PartName="/ppt/charts/chart2.xml" ContentType="application/vnd.openxmlformats-officedocument.drawingml.chart+xml"/>
  <Override PartName="/ppt/notesSlides/notesSlide4.xml" ContentType="application/vnd.openxmlformats-officedocument.presentationml.notesSlide+xml"/>
  <Override PartName="/ppt/diagrams/data1.xml" ContentType="application/vnd.openxmlformats-officedocument.drawingml.diagramData+xml"/>
  <Override PartName="/docProps/core.xml" ContentType="application/vnd.openxmlformats-package.core-properties+xml"/>
  <Override PartName="/ppt/slides/slide6.xml" ContentType="application/vnd.openxmlformats-officedocument.presentationml.slide+xml"/>
  <Override PartName="/ppt/slideLayouts/slideLayout8.xml" ContentType="application/vnd.openxmlformats-officedocument.presentationml.slideLayout+xml"/>
  <Override PartName="/ppt/slideLayouts/slideLayout19.xml" ContentType="application/vnd.openxmlformats-officedocument.presentationml.slideLayout+xml"/>
  <Override PartName="/ppt/diagrams/colors1.xml" ContentType="application/vnd.openxmlformats-officedocument.drawingml.diagramColors+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Override PartName="/ppt/theme/theme3.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notesMasterIdLst>
    <p:notesMasterId r:id="rId16"/>
  </p:notesMasterIdLst>
  <p:sldIdLst>
    <p:sldId id="256" r:id="rId3"/>
    <p:sldId id="264" r:id="rId4"/>
    <p:sldId id="257" r:id="rId5"/>
    <p:sldId id="258" r:id="rId6"/>
    <p:sldId id="259" r:id="rId7"/>
    <p:sldId id="262" r:id="rId8"/>
    <p:sldId id="265" r:id="rId9"/>
    <p:sldId id="260" r:id="rId10"/>
    <p:sldId id="267" r:id="rId11"/>
    <p:sldId id="268" r:id="rId12"/>
    <p:sldId id="269" r:id="rId13"/>
    <p:sldId id="261" r:id="rId14"/>
    <p:sldId id="263" r:id="rId15"/>
  </p:sldIdLst>
  <p:sldSz cx="6858000" cy="9144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aximized" horzBarState="maximized">
    <p:restoredLeft sz="15620"/>
    <p:restoredTop sz="90891" autoAdjust="0"/>
  </p:normalViewPr>
  <p:slideViewPr>
    <p:cSldViewPr>
      <p:cViewPr varScale="1">
        <p:scale>
          <a:sx n="88" d="100"/>
          <a:sy n="88" d="100"/>
        </p:scale>
        <p:origin x="2796" y="90"/>
      </p:cViewPr>
      <p:guideLst>
        <p:guide orient="horz" pos="2880"/>
        <p:guide pos="2160"/>
      </p:guideLst>
    </p:cSldViewPr>
  </p:slideViewPr>
  <p:notesTextViewPr>
    <p:cViewPr>
      <p:scale>
        <a:sx n="200" d="100"/>
        <a:sy n="2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viewProps" Target="viewProps.xml"/><Relationship Id="rId3" Type="http://schemas.openxmlformats.org/officeDocument/2006/relationships/slide" Target="slides/slide1.xml"/><Relationship Id="rId21" Type="http://schemas.openxmlformats.org/officeDocument/2006/relationships/customXml" Target="../customXml/item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presProps" Target="presProps.xml"/><Relationship Id="rId2" Type="http://schemas.openxmlformats.org/officeDocument/2006/relationships/slideMaster" Target="slideMasters/slideMaster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customXml" Target="../customXml/item3.xml"/><Relationship Id="rId10" Type="http://schemas.openxmlformats.org/officeDocument/2006/relationships/slide" Target="slides/slide8.xml"/><Relationship Id="rId19" Type="http://schemas.openxmlformats.org/officeDocument/2006/relationships/theme" Target="theme/theme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customXml" Target="../customXml/item2.xml"/></Relationships>
</file>

<file path=ppt/charts/_rels/chart1.xml.rels><?xml version="1.0" encoding="UTF-8" standalone="yes"?>
<Relationships xmlns="http://schemas.openxmlformats.org/package/2006/relationships"><Relationship Id="rId1" Type="http://schemas.openxmlformats.org/officeDocument/2006/relationships/oleObject" Target="file:///D:\NIPGR%20lab\Projects%20handled\Combined%20stress\Results\COMBINED%20STRESS%20STANDAR\10-2-15%20results\RWC,%20D,%20COMBINED.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E:\NIPGR%20lab\Projects%20handled\Combined%20stress\Results\COMBINED%20STRESS%20STANDAR\10-2-15%20results\RWC,%20D,%20COMBINED.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E:\NIPGR%20lab\Projects%20handled\Combined%20stress\CS%20PLOS%20revision\disease%20index.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E:\NIPGR%20lab\Projects%20handled\Combined%20stress\CS%20PLOS%20revision\disease%20index.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E:\NIPGR%20lab\Projects%20handled\Combined%20stress\CS%20PLOS%20revision\disease%20index.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E:\NIPGR%20lab\Projects%20handled\Combined%20stress\CS%20PLOS%20revision\disease%20index.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E:\NIPGR%20lab\Projects%20handled\Combined%20stress\CS%20MS%20Frontiers\NAC6.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021373124069371"/>
          <c:y val="6.3715939110002104E-2"/>
          <c:w val="0.86760862568631658"/>
          <c:h val="0.75311647109476476"/>
        </c:manualLayout>
      </c:layout>
      <c:barChart>
        <c:barDir val="col"/>
        <c:grouping val="clustered"/>
        <c:varyColors val="0"/>
        <c:ser>
          <c:idx val="0"/>
          <c:order val="0"/>
          <c:tx>
            <c:strRef>
              <c:f>'Drought only'!$B$1</c:f>
              <c:strCache>
                <c:ptCount val="1"/>
                <c:pt idx="0">
                  <c:v>0 hpt</c:v>
                </c:pt>
              </c:strCache>
            </c:strRef>
          </c:tx>
          <c:invertIfNegative val="0"/>
          <c:errBars>
            <c:errBarType val="both"/>
            <c:errValType val="cust"/>
            <c:noEndCap val="0"/>
            <c:plus>
              <c:numRef>
                <c:f>'Drought only'!$G$2:$G$6</c:f>
                <c:numCache>
                  <c:formatCode>General</c:formatCode>
                  <c:ptCount val="5"/>
                  <c:pt idx="0">
                    <c:v>3.0023559999999967</c:v>
                  </c:pt>
                  <c:pt idx="1">
                    <c:v>2.8033239999999999</c:v>
                  </c:pt>
                  <c:pt idx="2">
                    <c:v>2.1583559999999977</c:v>
                  </c:pt>
                  <c:pt idx="3">
                    <c:v>3.8937429999999846</c:v>
                  </c:pt>
                  <c:pt idx="4">
                    <c:v>2.2084455999999997</c:v>
                  </c:pt>
                </c:numCache>
              </c:numRef>
            </c:plus>
            <c:minus>
              <c:numRef>
                <c:f>'Drought only'!$G$2:$G$6</c:f>
                <c:numCache>
                  <c:formatCode>General</c:formatCode>
                  <c:ptCount val="5"/>
                  <c:pt idx="0">
                    <c:v>3.0023559999999967</c:v>
                  </c:pt>
                  <c:pt idx="1">
                    <c:v>2.8033239999999999</c:v>
                  </c:pt>
                  <c:pt idx="2">
                    <c:v>2.1583559999999977</c:v>
                  </c:pt>
                  <c:pt idx="3">
                    <c:v>3.8937429999999846</c:v>
                  </c:pt>
                  <c:pt idx="4">
                    <c:v>2.2084455999999997</c:v>
                  </c:pt>
                </c:numCache>
              </c:numRef>
            </c:minus>
          </c:errBars>
          <c:cat>
            <c:strRef>
              <c:f>'Drought only'!$A$2:$A$6</c:f>
              <c:strCache>
                <c:ptCount val="5"/>
                <c:pt idx="0">
                  <c:v>FC100</c:v>
                </c:pt>
                <c:pt idx="1">
                  <c:v>FC80</c:v>
                </c:pt>
                <c:pt idx="2">
                  <c:v>FC60</c:v>
                </c:pt>
                <c:pt idx="3">
                  <c:v>FC40</c:v>
                </c:pt>
                <c:pt idx="4">
                  <c:v>FC20</c:v>
                </c:pt>
              </c:strCache>
            </c:strRef>
          </c:cat>
          <c:val>
            <c:numRef>
              <c:f>'Drought only'!$B$2:$B$6</c:f>
              <c:numCache>
                <c:formatCode>General</c:formatCode>
                <c:ptCount val="5"/>
                <c:pt idx="0">
                  <c:v>92.002310999999978</c:v>
                </c:pt>
                <c:pt idx="1">
                  <c:v>78.304485488126602</c:v>
                </c:pt>
                <c:pt idx="2">
                  <c:v>66.110869999999991</c:v>
                </c:pt>
                <c:pt idx="3">
                  <c:v>55.205517163885602</c:v>
                </c:pt>
                <c:pt idx="4">
                  <c:v>35.312126937959192</c:v>
                </c:pt>
              </c:numCache>
            </c:numRef>
          </c:val>
        </c:ser>
        <c:ser>
          <c:idx val="1"/>
          <c:order val="1"/>
          <c:tx>
            <c:strRef>
              <c:f>'Drought only'!$C$1</c:f>
              <c:strCache>
                <c:ptCount val="1"/>
                <c:pt idx="0">
                  <c:v>24 hpt</c:v>
                </c:pt>
              </c:strCache>
            </c:strRef>
          </c:tx>
          <c:invertIfNegative val="0"/>
          <c:errBars>
            <c:errBarType val="both"/>
            <c:errValType val="cust"/>
            <c:noEndCap val="0"/>
            <c:plus>
              <c:numRef>
                <c:f>'Drought only'!$H$2:$H$6</c:f>
                <c:numCache>
                  <c:formatCode>General</c:formatCode>
                  <c:ptCount val="5"/>
                  <c:pt idx="0">
                    <c:v>4.5988319999999945</c:v>
                  </c:pt>
                  <c:pt idx="1">
                    <c:v>3.8895300000000002</c:v>
                  </c:pt>
                  <c:pt idx="2">
                    <c:v>4.2432200000000124</c:v>
                  </c:pt>
                  <c:pt idx="3">
                    <c:v>2.9167999999999967</c:v>
                  </c:pt>
                  <c:pt idx="4">
                    <c:v>2.8876331999999998</c:v>
                  </c:pt>
                </c:numCache>
              </c:numRef>
            </c:plus>
            <c:minus>
              <c:numRef>
                <c:f>'Drought only'!$H$2:$H$6</c:f>
                <c:numCache>
                  <c:formatCode>General</c:formatCode>
                  <c:ptCount val="5"/>
                  <c:pt idx="0">
                    <c:v>4.5988319999999945</c:v>
                  </c:pt>
                  <c:pt idx="1">
                    <c:v>3.8895300000000002</c:v>
                  </c:pt>
                  <c:pt idx="2">
                    <c:v>4.2432200000000124</c:v>
                  </c:pt>
                  <c:pt idx="3">
                    <c:v>2.9167999999999967</c:v>
                  </c:pt>
                  <c:pt idx="4">
                    <c:v>2.8876331999999998</c:v>
                  </c:pt>
                </c:numCache>
              </c:numRef>
            </c:minus>
          </c:errBars>
          <c:cat>
            <c:strRef>
              <c:f>'Drought only'!$A$2:$A$6</c:f>
              <c:strCache>
                <c:ptCount val="5"/>
                <c:pt idx="0">
                  <c:v>FC100</c:v>
                </c:pt>
                <c:pt idx="1">
                  <c:v>FC80</c:v>
                </c:pt>
                <c:pt idx="2">
                  <c:v>FC60</c:v>
                </c:pt>
                <c:pt idx="3">
                  <c:v>FC40</c:v>
                </c:pt>
                <c:pt idx="4">
                  <c:v>FC20</c:v>
                </c:pt>
              </c:strCache>
            </c:strRef>
          </c:cat>
          <c:val>
            <c:numRef>
              <c:f>'Drought only'!$C$2:$C$6</c:f>
              <c:numCache>
                <c:formatCode>General</c:formatCode>
                <c:ptCount val="5"/>
                <c:pt idx="0">
                  <c:v>89.903283799816037</c:v>
                </c:pt>
                <c:pt idx="1">
                  <c:v>77.419947748752961</c:v>
                </c:pt>
                <c:pt idx="2">
                  <c:v>64.620369760563179</c:v>
                </c:pt>
                <c:pt idx="3">
                  <c:v>55.723755640349189</c:v>
                </c:pt>
                <c:pt idx="4">
                  <c:v>33.369580093118465</c:v>
                </c:pt>
              </c:numCache>
            </c:numRef>
          </c:val>
        </c:ser>
        <c:ser>
          <c:idx val="2"/>
          <c:order val="2"/>
          <c:tx>
            <c:strRef>
              <c:f>'Drought only'!$D$1</c:f>
              <c:strCache>
                <c:ptCount val="1"/>
                <c:pt idx="0">
                  <c:v>48 hpt</c:v>
                </c:pt>
              </c:strCache>
            </c:strRef>
          </c:tx>
          <c:invertIfNegative val="0"/>
          <c:errBars>
            <c:errBarType val="both"/>
            <c:errValType val="cust"/>
            <c:noEndCap val="0"/>
            <c:plus>
              <c:numRef>
                <c:f>'Drought only'!$I$2:$I$6</c:f>
                <c:numCache>
                  <c:formatCode>General</c:formatCode>
                  <c:ptCount val="5"/>
                  <c:pt idx="0">
                    <c:v>3.3509143460000002</c:v>
                  </c:pt>
                  <c:pt idx="1">
                    <c:v>2.6368992099999997</c:v>
                  </c:pt>
                  <c:pt idx="2">
                    <c:v>4.6601123599999434</c:v>
                  </c:pt>
                  <c:pt idx="3">
                    <c:v>2.3680701099999997</c:v>
                  </c:pt>
                  <c:pt idx="4">
                    <c:v>2.1294499999999967</c:v>
                  </c:pt>
                </c:numCache>
              </c:numRef>
            </c:plus>
            <c:minus>
              <c:numRef>
                <c:f>'Drought only'!$I$2:$I$6</c:f>
                <c:numCache>
                  <c:formatCode>General</c:formatCode>
                  <c:ptCount val="5"/>
                  <c:pt idx="0">
                    <c:v>3.3509143460000002</c:v>
                  </c:pt>
                  <c:pt idx="1">
                    <c:v>2.6368992099999997</c:v>
                  </c:pt>
                  <c:pt idx="2">
                    <c:v>4.6601123599999434</c:v>
                  </c:pt>
                  <c:pt idx="3">
                    <c:v>2.3680701099999997</c:v>
                  </c:pt>
                  <c:pt idx="4">
                    <c:v>2.1294499999999967</c:v>
                  </c:pt>
                </c:numCache>
              </c:numRef>
            </c:minus>
          </c:errBars>
          <c:cat>
            <c:strRef>
              <c:f>'Drought only'!$A$2:$A$6</c:f>
              <c:strCache>
                <c:ptCount val="5"/>
                <c:pt idx="0">
                  <c:v>FC100</c:v>
                </c:pt>
                <c:pt idx="1">
                  <c:v>FC80</c:v>
                </c:pt>
                <c:pt idx="2">
                  <c:v>FC60</c:v>
                </c:pt>
                <c:pt idx="3">
                  <c:v>FC40</c:v>
                </c:pt>
                <c:pt idx="4">
                  <c:v>FC20</c:v>
                </c:pt>
              </c:strCache>
            </c:strRef>
          </c:cat>
          <c:val>
            <c:numRef>
              <c:f>'Drought only'!$D$2:$D$6</c:f>
              <c:numCache>
                <c:formatCode>General</c:formatCode>
                <c:ptCount val="5"/>
                <c:pt idx="0">
                  <c:v>90.223890150768824</c:v>
                </c:pt>
                <c:pt idx="1">
                  <c:v>76.535766694491258</c:v>
                </c:pt>
                <c:pt idx="2">
                  <c:v>63.29394340255601</c:v>
                </c:pt>
                <c:pt idx="3">
                  <c:v>54.28571428571</c:v>
                </c:pt>
                <c:pt idx="4">
                  <c:v>29.75206611570249</c:v>
                </c:pt>
              </c:numCache>
            </c:numRef>
          </c:val>
        </c:ser>
        <c:ser>
          <c:idx val="3"/>
          <c:order val="3"/>
          <c:tx>
            <c:strRef>
              <c:f>'Drought only'!$E$1</c:f>
              <c:strCache>
                <c:ptCount val="1"/>
                <c:pt idx="0">
                  <c:v>72 hpt</c:v>
                </c:pt>
              </c:strCache>
            </c:strRef>
          </c:tx>
          <c:invertIfNegative val="0"/>
          <c:errBars>
            <c:errBarType val="both"/>
            <c:errValType val="cust"/>
            <c:noEndCap val="0"/>
            <c:plus>
              <c:numRef>
                <c:f>'Drought only'!$J$2:$J$6</c:f>
                <c:numCache>
                  <c:formatCode>General</c:formatCode>
                  <c:ptCount val="5"/>
                  <c:pt idx="0">
                    <c:v>4.1903286</c:v>
                  </c:pt>
                  <c:pt idx="1">
                    <c:v>4.9334522509000003</c:v>
                  </c:pt>
                  <c:pt idx="2">
                    <c:v>3.907035</c:v>
                  </c:pt>
                  <c:pt idx="3">
                    <c:v>2.3841999999999999</c:v>
                  </c:pt>
                  <c:pt idx="4">
                    <c:v>3.3331675299999999</c:v>
                  </c:pt>
                </c:numCache>
              </c:numRef>
            </c:plus>
            <c:minus>
              <c:numRef>
                <c:f>'Drought only'!$J$2:$J$6</c:f>
                <c:numCache>
                  <c:formatCode>General</c:formatCode>
                  <c:ptCount val="5"/>
                  <c:pt idx="0">
                    <c:v>4.1903286</c:v>
                  </c:pt>
                  <c:pt idx="1">
                    <c:v>4.9334522509000003</c:v>
                  </c:pt>
                  <c:pt idx="2">
                    <c:v>3.907035</c:v>
                  </c:pt>
                  <c:pt idx="3">
                    <c:v>2.3841999999999999</c:v>
                  </c:pt>
                  <c:pt idx="4">
                    <c:v>3.3331675299999999</c:v>
                  </c:pt>
                </c:numCache>
              </c:numRef>
            </c:minus>
          </c:errBars>
          <c:cat>
            <c:strRef>
              <c:f>'Drought only'!$A$2:$A$6</c:f>
              <c:strCache>
                <c:ptCount val="5"/>
                <c:pt idx="0">
                  <c:v>FC100</c:v>
                </c:pt>
                <c:pt idx="1">
                  <c:v>FC80</c:v>
                </c:pt>
                <c:pt idx="2">
                  <c:v>FC60</c:v>
                </c:pt>
                <c:pt idx="3">
                  <c:v>FC40</c:v>
                </c:pt>
                <c:pt idx="4">
                  <c:v>FC20</c:v>
                </c:pt>
              </c:strCache>
            </c:strRef>
          </c:cat>
          <c:val>
            <c:numRef>
              <c:f>'Drought only'!$E$2:$E$6</c:f>
              <c:numCache>
                <c:formatCode>General</c:formatCode>
                <c:ptCount val="5"/>
                <c:pt idx="0">
                  <c:v>88.285182824204185</c:v>
                </c:pt>
                <c:pt idx="1">
                  <c:v>76.696304905806599</c:v>
                </c:pt>
                <c:pt idx="2">
                  <c:v>63.180196892535513</c:v>
                </c:pt>
                <c:pt idx="3">
                  <c:v>53.224500000000013</c:v>
                </c:pt>
                <c:pt idx="4">
                  <c:v>26.739130434782609</c:v>
                </c:pt>
              </c:numCache>
            </c:numRef>
          </c:val>
        </c:ser>
        <c:dLbls>
          <c:showLegendKey val="0"/>
          <c:showVal val="0"/>
          <c:showCatName val="0"/>
          <c:showSerName val="0"/>
          <c:showPercent val="0"/>
          <c:showBubbleSize val="0"/>
        </c:dLbls>
        <c:gapWidth val="150"/>
        <c:axId val="-271748032"/>
        <c:axId val="-271746944"/>
      </c:barChart>
      <c:catAx>
        <c:axId val="-271748032"/>
        <c:scaling>
          <c:orientation val="minMax"/>
        </c:scaling>
        <c:delete val="0"/>
        <c:axPos val="b"/>
        <c:numFmt formatCode="General" sourceLinked="0"/>
        <c:majorTickMark val="out"/>
        <c:minorTickMark val="none"/>
        <c:tickLblPos val="nextTo"/>
        <c:txPr>
          <a:bodyPr rot="-2700000"/>
          <a:lstStyle/>
          <a:p>
            <a:pPr>
              <a:defRPr/>
            </a:pPr>
            <a:endParaRPr lang="en-US"/>
          </a:p>
        </c:txPr>
        <c:crossAx val="-271746944"/>
        <c:crosses val="autoZero"/>
        <c:auto val="1"/>
        <c:lblAlgn val="ctr"/>
        <c:lblOffset val="0"/>
        <c:noMultiLvlLbl val="0"/>
      </c:catAx>
      <c:valAx>
        <c:axId val="-271746944"/>
        <c:scaling>
          <c:orientation val="minMax"/>
        </c:scaling>
        <c:delete val="0"/>
        <c:axPos val="l"/>
        <c:numFmt formatCode="General" sourceLinked="1"/>
        <c:majorTickMark val="out"/>
        <c:minorTickMark val="none"/>
        <c:tickLblPos val="nextTo"/>
        <c:crossAx val="-271748032"/>
        <c:crosses val="autoZero"/>
        <c:crossBetween val="between"/>
      </c:valAx>
    </c:plotArea>
    <c:legend>
      <c:legendPos val="r"/>
      <c:layout>
        <c:manualLayout>
          <c:xMode val="edge"/>
          <c:yMode val="edge"/>
          <c:x val="0.61961479858271162"/>
          <c:y val="1.6738546638060684E-2"/>
          <c:w val="0.37570317894579286"/>
          <c:h val="0.11206251733146518"/>
        </c:manualLayout>
      </c:layout>
      <c:overlay val="0"/>
    </c:legend>
    <c:plotVisOnly val="1"/>
    <c:dispBlanksAs val="gap"/>
    <c:showDLblsOverMax val="0"/>
  </c:chart>
  <c:txPr>
    <a:bodyPr/>
    <a:lstStyle/>
    <a:p>
      <a:pPr>
        <a:defRPr sz="800" b="1">
          <a:latin typeface="Arial" pitchFamily="34" charset="0"/>
          <a:cs typeface="Arial" pitchFamily="34" charset="0"/>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9.8571741032371027E-2"/>
          <c:y val="5.13585977626181E-2"/>
          <c:w val="0.88686023622047405"/>
          <c:h val="0.59910812142748648"/>
        </c:manualLayout>
      </c:layout>
      <c:barChart>
        <c:barDir val="col"/>
        <c:grouping val="clustered"/>
        <c:varyColors val="0"/>
        <c:ser>
          <c:idx val="0"/>
          <c:order val="0"/>
          <c:tx>
            <c:strRef>
              <c:f>'Combined stress'!$O$1</c:f>
              <c:strCache>
                <c:ptCount val="1"/>
                <c:pt idx="0">
                  <c:v>0 hpt</c:v>
                </c:pt>
              </c:strCache>
            </c:strRef>
          </c:tx>
          <c:invertIfNegative val="0"/>
          <c:errBars>
            <c:errBarType val="both"/>
            <c:errValType val="cust"/>
            <c:noEndCap val="0"/>
            <c:plus>
              <c:numRef>
                <c:f>'Combined stress'!$G$2:$G$18</c:f>
                <c:numCache>
                  <c:formatCode>General</c:formatCode>
                  <c:ptCount val="17"/>
                  <c:pt idx="0">
                    <c:v>6.14171611</c:v>
                  </c:pt>
                  <c:pt idx="1">
                    <c:v>8.0316173239999991</c:v>
                  </c:pt>
                  <c:pt idx="2">
                    <c:v>7.6755435599999906</c:v>
                  </c:pt>
                  <c:pt idx="3">
                    <c:v>4.1071429999999909</c:v>
                  </c:pt>
                  <c:pt idx="4">
                    <c:v>6.1615713899999909</c:v>
                  </c:pt>
                  <c:pt idx="5">
                    <c:v>5.5589299999999975</c:v>
                  </c:pt>
                  <c:pt idx="6">
                    <c:v>6.3478220099999945</c:v>
                  </c:pt>
                  <c:pt idx="7">
                    <c:v>8.9148995400000004</c:v>
                  </c:pt>
                  <c:pt idx="8">
                    <c:v>3.1267974760000001</c:v>
                  </c:pt>
                  <c:pt idx="9">
                    <c:v>5.10131712</c:v>
                  </c:pt>
                  <c:pt idx="10">
                    <c:v>4.7111542209999877</c:v>
                  </c:pt>
                  <c:pt idx="11">
                    <c:v>2.3813163139999998</c:v>
                  </c:pt>
                  <c:pt idx="12">
                    <c:v>7.0549744910999888</c:v>
                  </c:pt>
                  <c:pt idx="13">
                    <c:v>4.1144834199999867</c:v>
                  </c:pt>
                  <c:pt idx="14">
                    <c:v>3.58145186</c:v>
                  </c:pt>
                  <c:pt idx="15">
                    <c:v>3.1013414320049999</c:v>
                  </c:pt>
                  <c:pt idx="16">
                    <c:v>2.5910587399999967</c:v>
                  </c:pt>
                </c:numCache>
              </c:numRef>
            </c:plus>
            <c:minus>
              <c:numRef>
                <c:f>'Combined stress'!$G$2:$G$18</c:f>
                <c:numCache>
                  <c:formatCode>General</c:formatCode>
                  <c:ptCount val="17"/>
                  <c:pt idx="0">
                    <c:v>6.14171611</c:v>
                  </c:pt>
                  <c:pt idx="1">
                    <c:v>8.0316173239999991</c:v>
                  </c:pt>
                  <c:pt idx="2">
                    <c:v>7.6755435599999906</c:v>
                  </c:pt>
                  <c:pt idx="3">
                    <c:v>4.1071429999999909</c:v>
                  </c:pt>
                  <c:pt idx="4">
                    <c:v>6.1615713899999909</c:v>
                  </c:pt>
                  <c:pt idx="5">
                    <c:v>5.5589299999999975</c:v>
                  </c:pt>
                  <c:pt idx="6">
                    <c:v>6.3478220099999945</c:v>
                  </c:pt>
                  <c:pt idx="7">
                    <c:v>8.9148995400000004</c:v>
                  </c:pt>
                  <c:pt idx="8">
                    <c:v>3.1267974760000001</c:v>
                  </c:pt>
                  <c:pt idx="9">
                    <c:v>5.10131712</c:v>
                  </c:pt>
                  <c:pt idx="10">
                    <c:v>4.7111542209999877</c:v>
                  </c:pt>
                  <c:pt idx="11">
                    <c:v>2.3813163139999998</c:v>
                  </c:pt>
                  <c:pt idx="12">
                    <c:v>7.0549744910999888</c:v>
                  </c:pt>
                  <c:pt idx="13">
                    <c:v>4.1144834199999867</c:v>
                  </c:pt>
                  <c:pt idx="14">
                    <c:v>3.58145186</c:v>
                  </c:pt>
                  <c:pt idx="15">
                    <c:v>3.1013414320049999</c:v>
                  </c:pt>
                  <c:pt idx="16">
                    <c:v>2.5910587399999967</c:v>
                  </c:pt>
                </c:numCache>
              </c:numRef>
            </c:minus>
          </c:errBars>
          <c:cat>
            <c:strRef>
              <c:f>'Combined stress'!$N$2:$N$17</c:f>
              <c:strCache>
                <c:ptCount val="16"/>
                <c:pt idx="0">
                  <c:v>FC80+2*10^4</c:v>
                </c:pt>
                <c:pt idx="1">
                  <c:v>FC80+5*10^4</c:v>
                </c:pt>
                <c:pt idx="2">
                  <c:v>FC80+10^6</c:v>
                </c:pt>
                <c:pt idx="3">
                  <c:v>FC80+10^5</c:v>
                </c:pt>
                <c:pt idx="4">
                  <c:v>FC60+2*10^4</c:v>
                </c:pt>
                <c:pt idx="5">
                  <c:v>FC60+5*10^4</c:v>
                </c:pt>
                <c:pt idx="6">
                  <c:v>FC60+10^5</c:v>
                </c:pt>
                <c:pt idx="7">
                  <c:v>FC60+10^6</c:v>
                </c:pt>
                <c:pt idx="8">
                  <c:v>FC40+2*10^4</c:v>
                </c:pt>
                <c:pt idx="9">
                  <c:v>FC40+5*10^4</c:v>
                </c:pt>
                <c:pt idx="10">
                  <c:v>FC40+10^5</c:v>
                </c:pt>
                <c:pt idx="11">
                  <c:v>FC40+10^6</c:v>
                </c:pt>
                <c:pt idx="12">
                  <c:v>FC20+2*10^4</c:v>
                </c:pt>
                <c:pt idx="13">
                  <c:v>FC20+5*10^4</c:v>
                </c:pt>
                <c:pt idx="14">
                  <c:v>FC20+10^5</c:v>
                </c:pt>
                <c:pt idx="15">
                  <c:v>FC20+10^6</c:v>
                </c:pt>
              </c:strCache>
            </c:strRef>
          </c:cat>
          <c:val>
            <c:numRef>
              <c:f>'Combined stress'!$O$2:$O$17</c:f>
              <c:numCache>
                <c:formatCode>General</c:formatCode>
                <c:ptCount val="16"/>
                <c:pt idx="0">
                  <c:v>113.29333</c:v>
                </c:pt>
                <c:pt idx="1">
                  <c:v>111.04453000000002</c:v>
                </c:pt>
                <c:pt idx="2">
                  <c:v>115.81986143187066</c:v>
                </c:pt>
                <c:pt idx="3">
                  <c:v>109.23854</c:v>
                </c:pt>
                <c:pt idx="4">
                  <c:v>103.55765599999999</c:v>
                </c:pt>
                <c:pt idx="5">
                  <c:v>99.887901999999983</c:v>
                </c:pt>
                <c:pt idx="6">
                  <c:v>107.44749536178109</c:v>
                </c:pt>
                <c:pt idx="7">
                  <c:v>102.54672897196262</c:v>
                </c:pt>
                <c:pt idx="8">
                  <c:v>85.310129000000174</c:v>
                </c:pt>
                <c:pt idx="9">
                  <c:v>77.291200000000174</c:v>
                </c:pt>
                <c:pt idx="10">
                  <c:v>80.97976391231029</c:v>
                </c:pt>
                <c:pt idx="11">
                  <c:v>83.400357999999983</c:v>
                </c:pt>
                <c:pt idx="12">
                  <c:v>46.16113200000008</c:v>
                </c:pt>
                <c:pt idx="13">
                  <c:v>53.513100000000001</c:v>
                </c:pt>
                <c:pt idx="14">
                  <c:v>54.895652173913099</c:v>
                </c:pt>
                <c:pt idx="15">
                  <c:v>49.179714000000011</c:v>
                </c:pt>
              </c:numCache>
            </c:numRef>
          </c:val>
        </c:ser>
        <c:ser>
          <c:idx val="1"/>
          <c:order val="1"/>
          <c:tx>
            <c:strRef>
              <c:f>'Combined stress'!$P$1</c:f>
              <c:strCache>
                <c:ptCount val="1"/>
                <c:pt idx="0">
                  <c:v>24 hpt</c:v>
                </c:pt>
              </c:strCache>
            </c:strRef>
          </c:tx>
          <c:invertIfNegative val="0"/>
          <c:errBars>
            <c:errBarType val="both"/>
            <c:errValType val="cust"/>
            <c:noEndCap val="0"/>
            <c:plus>
              <c:numRef>
                <c:f>'Combined stress'!$H$2:$H$18</c:f>
                <c:numCache>
                  <c:formatCode>General</c:formatCode>
                  <c:ptCount val="17"/>
                  <c:pt idx="0">
                    <c:v>2.10931517121</c:v>
                  </c:pt>
                  <c:pt idx="1">
                    <c:v>5.71132115411001</c:v>
                  </c:pt>
                  <c:pt idx="2">
                    <c:v>8.3810114999999996</c:v>
                  </c:pt>
                  <c:pt idx="3">
                    <c:v>6.9916385500000002</c:v>
                  </c:pt>
                  <c:pt idx="4">
                    <c:v>4.3221442099999807</c:v>
                  </c:pt>
                  <c:pt idx="5">
                    <c:v>2.8866412909999997</c:v>
                  </c:pt>
                  <c:pt idx="6">
                    <c:v>3.96235428</c:v>
                  </c:pt>
                  <c:pt idx="7">
                    <c:v>2.0183111970000001</c:v>
                  </c:pt>
                  <c:pt idx="8">
                    <c:v>5.3685344999999849</c:v>
                  </c:pt>
                  <c:pt idx="9">
                    <c:v>2.8015013099999999</c:v>
                  </c:pt>
                  <c:pt idx="10">
                    <c:v>6.3469628</c:v>
                  </c:pt>
                  <c:pt idx="11">
                    <c:v>4.5497449110000003</c:v>
                  </c:pt>
                  <c:pt idx="12">
                    <c:v>3.0131811613190012</c:v>
                  </c:pt>
                  <c:pt idx="13">
                    <c:v>2.671121852100006</c:v>
                  </c:pt>
                  <c:pt idx="14">
                    <c:v>4.4196959130000089</c:v>
                  </c:pt>
                  <c:pt idx="15">
                    <c:v>3.575574112</c:v>
                  </c:pt>
                  <c:pt idx="16">
                    <c:v>5.1151310012999858</c:v>
                  </c:pt>
                </c:numCache>
              </c:numRef>
            </c:plus>
            <c:minus>
              <c:numRef>
                <c:f>'Combined stress'!$H$2:$H$18</c:f>
                <c:numCache>
                  <c:formatCode>General</c:formatCode>
                  <c:ptCount val="17"/>
                  <c:pt idx="0">
                    <c:v>2.10931517121</c:v>
                  </c:pt>
                  <c:pt idx="1">
                    <c:v>5.71132115411001</c:v>
                  </c:pt>
                  <c:pt idx="2">
                    <c:v>8.3810114999999996</c:v>
                  </c:pt>
                  <c:pt idx="3">
                    <c:v>6.9916385500000002</c:v>
                  </c:pt>
                  <c:pt idx="4">
                    <c:v>4.3221442099999807</c:v>
                  </c:pt>
                  <c:pt idx="5">
                    <c:v>2.8866412909999997</c:v>
                  </c:pt>
                  <c:pt idx="6">
                    <c:v>3.96235428</c:v>
                  </c:pt>
                  <c:pt idx="7">
                    <c:v>2.0183111970000001</c:v>
                  </c:pt>
                  <c:pt idx="8">
                    <c:v>5.3685344999999849</c:v>
                  </c:pt>
                  <c:pt idx="9">
                    <c:v>2.8015013099999999</c:v>
                  </c:pt>
                  <c:pt idx="10">
                    <c:v>6.3469628</c:v>
                  </c:pt>
                  <c:pt idx="11">
                    <c:v>4.5497449110000003</c:v>
                  </c:pt>
                  <c:pt idx="12">
                    <c:v>3.0131811613190012</c:v>
                  </c:pt>
                  <c:pt idx="13">
                    <c:v>2.671121852100006</c:v>
                  </c:pt>
                  <c:pt idx="14">
                    <c:v>4.4196959130000089</c:v>
                  </c:pt>
                  <c:pt idx="15">
                    <c:v>3.575574112</c:v>
                  </c:pt>
                  <c:pt idx="16">
                    <c:v>5.1151310012999858</c:v>
                  </c:pt>
                </c:numCache>
              </c:numRef>
            </c:minus>
          </c:errBars>
          <c:cat>
            <c:strRef>
              <c:f>'Combined stress'!$N$2:$N$17</c:f>
              <c:strCache>
                <c:ptCount val="16"/>
                <c:pt idx="0">
                  <c:v>FC80+2*10^4</c:v>
                </c:pt>
                <c:pt idx="1">
                  <c:v>FC80+5*10^4</c:v>
                </c:pt>
                <c:pt idx="2">
                  <c:v>FC80+10^6</c:v>
                </c:pt>
                <c:pt idx="3">
                  <c:v>FC80+10^5</c:v>
                </c:pt>
                <c:pt idx="4">
                  <c:v>FC60+2*10^4</c:v>
                </c:pt>
                <c:pt idx="5">
                  <c:v>FC60+5*10^4</c:v>
                </c:pt>
                <c:pt idx="6">
                  <c:v>FC60+10^5</c:v>
                </c:pt>
                <c:pt idx="7">
                  <c:v>FC60+10^6</c:v>
                </c:pt>
                <c:pt idx="8">
                  <c:v>FC40+2*10^4</c:v>
                </c:pt>
                <c:pt idx="9">
                  <c:v>FC40+5*10^4</c:v>
                </c:pt>
                <c:pt idx="10">
                  <c:v>FC40+10^5</c:v>
                </c:pt>
                <c:pt idx="11">
                  <c:v>FC40+10^6</c:v>
                </c:pt>
                <c:pt idx="12">
                  <c:v>FC20+2*10^4</c:v>
                </c:pt>
                <c:pt idx="13">
                  <c:v>FC20+5*10^4</c:v>
                </c:pt>
                <c:pt idx="14">
                  <c:v>FC20+10^5</c:v>
                </c:pt>
                <c:pt idx="15">
                  <c:v>FC20+10^6</c:v>
                </c:pt>
              </c:strCache>
            </c:strRef>
          </c:cat>
          <c:val>
            <c:numRef>
              <c:f>'Combined stress'!$P$2:$P$17</c:f>
              <c:numCache>
                <c:formatCode>General</c:formatCode>
                <c:ptCount val="16"/>
                <c:pt idx="0">
                  <c:v>83.696304905806599</c:v>
                </c:pt>
                <c:pt idx="1">
                  <c:v>80.419947748753003</c:v>
                </c:pt>
                <c:pt idx="2">
                  <c:v>81.285182824204554</c:v>
                </c:pt>
                <c:pt idx="3">
                  <c:v>78.263705206710384</c:v>
                </c:pt>
                <c:pt idx="4">
                  <c:v>65.591391144545298</c:v>
                </c:pt>
                <c:pt idx="5">
                  <c:v>64.859577622330818</c:v>
                </c:pt>
                <c:pt idx="6">
                  <c:v>66.449765168099944</c:v>
                </c:pt>
                <c:pt idx="7">
                  <c:v>64.620369760563179</c:v>
                </c:pt>
                <c:pt idx="8">
                  <c:v>51.1648101435364</c:v>
                </c:pt>
                <c:pt idx="9">
                  <c:v>51.027927927927962</c:v>
                </c:pt>
                <c:pt idx="10">
                  <c:v>57.964601769911397</c:v>
                </c:pt>
                <c:pt idx="11">
                  <c:v>54.800939613624394</c:v>
                </c:pt>
                <c:pt idx="12">
                  <c:v>35.792113000000143</c:v>
                </c:pt>
                <c:pt idx="13">
                  <c:v>30.41037</c:v>
                </c:pt>
                <c:pt idx="14">
                  <c:v>35.115640000000006</c:v>
                </c:pt>
                <c:pt idx="15">
                  <c:v>34.981684981684857</c:v>
                </c:pt>
              </c:numCache>
            </c:numRef>
          </c:val>
        </c:ser>
        <c:ser>
          <c:idx val="2"/>
          <c:order val="2"/>
          <c:tx>
            <c:strRef>
              <c:f>'Combined stress'!$Q$1</c:f>
              <c:strCache>
                <c:ptCount val="1"/>
                <c:pt idx="0">
                  <c:v>48 hpt</c:v>
                </c:pt>
              </c:strCache>
            </c:strRef>
          </c:tx>
          <c:invertIfNegative val="0"/>
          <c:errBars>
            <c:errBarType val="both"/>
            <c:errValType val="cust"/>
            <c:noEndCap val="0"/>
            <c:plus>
              <c:numRef>
                <c:f>'Combined stress'!$I$2:$I$18</c:f>
                <c:numCache>
                  <c:formatCode>General</c:formatCode>
                  <c:ptCount val="17"/>
                  <c:pt idx="0">
                    <c:v>4.1110467999999996</c:v>
                  </c:pt>
                  <c:pt idx="1">
                    <c:v>3.1267992670000049</c:v>
                  </c:pt>
                  <c:pt idx="2">
                    <c:v>7.0970108799999796</c:v>
                  </c:pt>
                  <c:pt idx="3">
                    <c:v>4.0316348477999906</c:v>
                  </c:pt>
                  <c:pt idx="4">
                    <c:v>5.1112666930000099</c:v>
                  </c:pt>
                  <c:pt idx="5">
                    <c:v>2.0111350121410001</c:v>
                  </c:pt>
                  <c:pt idx="6">
                    <c:v>2.6900549209999998</c:v>
                  </c:pt>
                  <c:pt idx="7">
                    <c:v>4.6101224111099945</c:v>
                  </c:pt>
                  <c:pt idx="8">
                    <c:v>5.9783114900000109</c:v>
                  </c:pt>
                  <c:pt idx="9">
                    <c:v>5.4415618000000014</c:v>
                  </c:pt>
                  <c:pt idx="10">
                    <c:v>2.0185101699999999</c:v>
                  </c:pt>
                  <c:pt idx="11">
                    <c:v>7.2013181163900004</c:v>
                  </c:pt>
                  <c:pt idx="12">
                    <c:v>3.7729944099999999</c:v>
                  </c:pt>
                  <c:pt idx="13">
                    <c:v>6.7319332831000098</c:v>
                  </c:pt>
                  <c:pt idx="14">
                    <c:v>4.4014141501499955</c:v>
                  </c:pt>
                  <c:pt idx="15">
                    <c:v>2.3251120221199999</c:v>
                  </c:pt>
                  <c:pt idx="16">
                    <c:v>3.1264428999999967</c:v>
                  </c:pt>
                </c:numCache>
              </c:numRef>
            </c:plus>
            <c:minus>
              <c:numRef>
                <c:f>'Combined stress'!$I$2:$I$18</c:f>
                <c:numCache>
                  <c:formatCode>General</c:formatCode>
                  <c:ptCount val="17"/>
                  <c:pt idx="0">
                    <c:v>4.1110467999999996</c:v>
                  </c:pt>
                  <c:pt idx="1">
                    <c:v>3.1267992670000049</c:v>
                  </c:pt>
                  <c:pt idx="2">
                    <c:v>7.0970108799999796</c:v>
                  </c:pt>
                  <c:pt idx="3">
                    <c:v>4.0316348477999906</c:v>
                  </c:pt>
                  <c:pt idx="4">
                    <c:v>5.1112666930000099</c:v>
                  </c:pt>
                  <c:pt idx="5">
                    <c:v>2.0111350121410001</c:v>
                  </c:pt>
                  <c:pt idx="6">
                    <c:v>2.6900549209999998</c:v>
                  </c:pt>
                  <c:pt idx="7">
                    <c:v>4.6101224111099945</c:v>
                  </c:pt>
                  <c:pt idx="8">
                    <c:v>5.9783114900000109</c:v>
                  </c:pt>
                  <c:pt idx="9">
                    <c:v>5.4415618000000014</c:v>
                  </c:pt>
                  <c:pt idx="10">
                    <c:v>2.0185101699999999</c:v>
                  </c:pt>
                  <c:pt idx="11">
                    <c:v>7.2013181163900004</c:v>
                  </c:pt>
                  <c:pt idx="12">
                    <c:v>3.7729944099999999</c:v>
                  </c:pt>
                  <c:pt idx="13">
                    <c:v>6.7319332831000098</c:v>
                  </c:pt>
                  <c:pt idx="14">
                    <c:v>4.4014141501499955</c:v>
                  </c:pt>
                  <c:pt idx="15">
                    <c:v>2.3251120221199999</c:v>
                  </c:pt>
                  <c:pt idx="16">
                    <c:v>3.1264428999999967</c:v>
                  </c:pt>
                </c:numCache>
              </c:numRef>
            </c:minus>
          </c:errBars>
          <c:cat>
            <c:strRef>
              <c:f>'Combined stress'!$N$2:$N$17</c:f>
              <c:strCache>
                <c:ptCount val="16"/>
                <c:pt idx="0">
                  <c:v>FC80+2*10^4</c:v>
                </c:pt>
                <c:pt idx="1">
                  <c:v>FC80+5*10^4</c:v>
                </c:pt>
                <c:pt idx="2">
                  <c:v>FC80+10^6</c:v>
                </c:pt>
                <c:pt idx="3">
                  <c:v>FC80+10^5</c:v>
                </c:pt>
                <c:pt idx="4">
                  <c:v>FC60+2*10^4</c:v>
                </c:pt>
                <c:pt idx="5">
                  <c:v>FC60+5*10^4</c:v>
                </c:pt>
                <c:pt idx="6">
                  <c:v>FC60+10^5</c:v>
                </c:pt>
                <c:pt idx="7">
                  <c:v>FC60+10^6</c:v>
                </c:pt>
                <c:pt idx="8">
                  <c:v>FC40+2*10^4</c:v>
                </c:pt>
                <c:pt idx="9">
                  <c:v>FC40+5*10^4</c:v>
                </c:pt>
                <c:pt idx="10">
                  <c:v>FC40+10^5</c:v>
                </c:pt>
                <c:pt idx="11">
                  <c:v>FC40+10^6</c:v>
                </c:pt>
                <c:pt idx="12">
                  <c:v>FC20+2*10^4</c:v>
                </c:pt>
                <c:pt idx="13">
                  <c:v>FC20+5*10^4</c:v>
                </c:pt>
                <c:pt idx="14">
                  <c:v>FC20+10^5</c:v>
                </c:pt>
                <c:pt idx="15">
                  <c:v>FC20+10^6</c:v>
                </c:pt>
              </c:strCache>
            </c:strRef>
          </c:cat>
          <c:val>
            <c:numRef>
              <c:f>'Combined stress'!$Q$2:$Q$17</c:f>
              <c:numCache>
                <c:formatCode>General</c:formatCode>
                <c:ptCount val="16"/>
                <c:pt idx="0">
                  <c:v>82.573646040122483</c:v>
                </c:pt>
                <c:pt idx="1">
                  <c:v>78.354310367840782</c:v>
                </c:pt>
                <c:pt idx="2">
                  <c:v>84.364708182323767</c:v>
                </c:pt>
                <c:pt idx="3">
                  <c:v>79.697485354157081</c:v>
                </c:pt>
                <c:pt idx="4">
                  <c:v>63.536462034144257</c:v>
                </c:pt>
                <c:pt idx="5">
                  <c:v>61.133256103000001</c:v>
                </c:pt>
                <c:pt idx="6">
                  <c:v>65.221442325610298</c:v>
                </c:pt>
                <c:pt idx="7">
                  <c:v>64.180196892535278</c:v>
                </c:pt>
                <c:pt idx="8">
                  <c:v>51.834879999999998</c:v>
                </c:pt>
                <c:pt idx="9">
                  <c:v>52.004657000000002</c:v>
                </c:pt>
                <c:pt idx="10">
                  <c:v>55.234454000000007</c:v>
                </c:pt>
                <c:pt idx="11">
                  <c:v>55.900654000000003</c:v>
                </c:pt>
                <c:pt idx="12">
                  <c:v>33.054439999999992</c:v>
                </c:pt>
                <c:pt idx="13">
                  <c:v>28.654880000000048</c:v>
                </c:pt>
                <c:pt idx="14">
                  <c:v>35.504348</c:v>
                </c:pt>
                <c:pt idx="15">
                  <c:v>36.887522799999999</c:v>
                </c:pt>
              </c:numCache>
            </c:numRef>
          </c:val>
        </c:ser>
        <c:ser>
          <c:idx val="3"/>
          <c:order val="3"/>
          <c:tx>
            <c:strRef>
              <c:f>'Combined stress'!$R$1</c:f>
              <c:strCache>
                <c:ptCount val="1"/>
                <c:pt idx="0">
                  <c:v>72 hpt</c:v>
                </c:pt>
              </c:strCache>
            </c:strRef>
          </c:tx>
          <c:invertIfNegative val="0"/>
          <c:errBars>
            <c:errBarType val="both"/>
            <c:errValType val="cust"/>
            <c:noEndCap val="0"/>
            <c:plus>
              <c:numRef>
                <c:f>'Combined stress'!$J$2:$J$18</c:f>
                <c:numCache>
                  <c:formatCode>General</c:formatCode>
                  <c:ptCount val="17"/>
                  <c:pt idx="0">
                    <c:v>4.2215990000000003</c:v>
                  </c:pt>
                  <c:pt idx="1">
                    <c:v>4.3831618959999998</c:v>
                  </c:pt>
                  <c:pt idx="2">
                    <c:v>5.1698660199999908</c:v>
                  </c:pt>
                  <c:pt idx="3">
                    <c:v>3.5447971111000012</c:v>
                  </c:pt>
                  <c:pt idx="4">
                    <c:v>4.335215732</c:v>
                  </c:pt>
                  <c:pt idx="5">
                    <c:v>4.3584229699999906</c:v>
                  </c:pt>
                  <c:pt idx="6">
                    <c:v>8.3113195915000002</c:v>
                  </c:pt>
                  <c:pt idx="7">
                    <c:v>7.2564567000000002</c:v>
                  </c:pt>
                  <c:pt idx="8">
                    <c:v>3.6158425129999987</c:v>
                  </c:pt>
                  <c:pt idx="9">
                    <c:v>4.8596117899999998</c:v>
                  </c:pt>
                  <c:pt idx="10">
                    <c:v>4.1982316800000001</c:v>
                  </c:pt>
                  <c:pt idx="11">
                    <c:v>5.8829441999999945</c:v>
                  </c:pt>
                  <c:pt idx="12">
                    <c:v>2.5841385600000044</c:v>
                  </c:pt>
                  <c:pt idx="13">
                    <c:v>2.0141156498999999</c:v>
                  </c:pt>
                  <c:pt idx="14">
                    <c:v>5.6555452999999867</c:v>
                  </c:pt>
                  <c:pt idx="15">
                    <c:v>6.4223675900000003</c:v>
                  </c:pt>
                  <c:pt idx="16">
                    <c:v>2.1138680099999987</c:v>
                  </c:pt>
                </c:numCache>
              </c:numRef>
            </c:plus>
            <c:minus>
              <c:numRef>
                <c:f>'Combined stress'!$J$2:$J$18</c:f>
                <c:numCache>
                  <c:formatCode>General</c:formatCode>
                  <c:ptCount val="17"/>
                  <c:pt idx="0">
                    <c:v>4.2215990000000003</c:v>
                  </c:pt>
                  <c:pt idx="1">
                    <c:v>4.3831618959999998</c:v>
                  </c:pt>
                  <c:pt idx="2">
                    <c:v>5.1698660199999908</c:v>
                  </c:pt>
                  <c:pt idx="3">
                    <c:v>3.5447971111000012</c:v>
                  </c:pt>
                  <c:pt idx="4">
                    <c:v>4.335215732</c:v>
                  </c:pt>
                  <c:pt idx="5">
                    <c:v>4.3584229699999906</c:v>
                  </c:pt>
                  <c:pt idx="6">
                    <c:v>8.3113195915000002</c:v>
                  </c:pt>
                  <c:pt idx="7">
                    <c:v>7.2564567000000002</c:v>
                  </c:pt>
                  <c:pt idx="8">
                    <c:v>3.6158425129999987</c:v>
                  </c:pt>
                  <c:pt idx="9">
                    <c:v>4.8596117899999998</c:v>
                  </c:pt>
                  <c:pt idx="10">
                    <c:v>4.1982316800000001</c:v>
                  </c:pt>
                  <c:pt idx="11">
                    <c:v>5.8829441999999945</c:v>
                  </c:pt>
                  <c:pt idx="12">
                    <c:v>2.5841385600000044</c:v>
                  </c:pt>
                  <c:pt idx="13">
                    <c:v>2.0141156498999999</c:v>
                  </c:pt>
                  <c:pt idx="14">
                    <c:v>5.6555452999999867</c:v>
                  </c:pt>
                  <c:pt idx="15">
                    <c:v>6.4223675900000003</c:v>
                  </c:pt>
                  <c:pt idx="16">
                    <c:v>2.1138680099999987</c:v>
                  </c:pt>
                </c:numCache>
              </c:numRef>
            </c:minus>
          </c:errBars>
          <c:cat>
            <c:strRef>
              <c:f>'Combined stress'!$N$2:$N$17</c:f>
              <c:strCache>
                <c:ptCount val="16"/>
                <c:pt idx="0">
                  <c:v>FC80+2*10^4</c:v>
                </c:pt>
                <c:pt idx="1">
                  <c:v>FC80+5*10^4</c:v>
                </c:pt>
                <c:pt idx="2">
                  <c:v>FC80+10^6</c:v>
                </c:pt>
                <c:pt idx="3">
                  <c:v>FC80+10^5</c:v>
                </c:pt>
                <c:pt idx="4">
                  <c:v>FC60+2*10^4</c:v>
                </c:pt>
                <c:pt idx="5">
                  <c:v>FC60+5*10^4</c:v>
                </c:pt>
                <c:pt idx="6">
                  <c:v>FC60+10^5</c:v>
                </c:pt>
                <c:pt idx="7">
                  <c:v>FC60+10^6</c:v>
                </c:pt>
                <c:pt idx="8">
                  <c:v>FC40+2*10^4</c:v>
                </c:pt>
                <c:pt idx="9">
                  <c:v>FC40+5*10^4</c:v>
                </c:pt>
                <c:pt idx="10">
                  <c:v>FC40+10^5</c:v>
                </c:pt>
                <c:pt idx="11">
                  <c:v>FC40+10^6</c:v>
                </c:pt>
                <c:pt idx="12">
                  <c:v>FC20+2*10^4</c:v>
                </c:pt>
                <c:pt idx="13">
                  <c:v>FC20+5*10^4</c:v>
                </c:pt>
                <c:pt idx="14">
                  <c:v>FC20+10^5</c:v>
                </c:pt>
                <c:pt idx="15">
                  <c:v>FC20+10^6</c:v>
                </c:pt>
              </c:strCache>
            </c:strRef>
          </c:cat>
          <c:val>
            <c:numRef>
              <c:f>'Combined stress'!$R$2:$R$17</c:f>
              <c:numCache>
                <c:formatCode>General</c:formatCode>
                <c:ptCount val="16"/>
                <c:pt idx="0">
                  <c:v>80.805919407723579</c:v>
                </c:pt>
                <c:pt idx="1">
                  <c:v>77.535766694491556</c:v>
                </c:pt>
                <c:pt idx="2">
                  <c:v>79.298652685391559</c:v>
                </c:pt>
                <c:pt idx="3">
                  <c:v>76.4533940553505</c:v>
                </c:pt>
                <c:pt idx="4">
                  <c:v>64.180196892535278</c:v>
                </c:pt>
                <c:pt idx="5">
                  <c:v>63.591391144545312</c:v>
                </c:pt>
                <c:pt idx="6">
                  <c:v>65.610299999999995</c:v>
                </c:pt>
                <c:pt idx="7">
                  <c:v>62.566467590693698</c:v>
                </c:pt>
                <c:pt idx="8">
                  <c:v>50.008300000000013</c:v>
                </c:pt>
                <c:pt idx="9">
                  <c:v>52.854399999999998</c:v>
                </c:pt>
                <c:pt idx="10">
                  <c:v>53.396700000000003</c:v>
                </c:pt>
                <c:pt idx="11">
                  <c:v>53.227600000000002</c:v>
                </c:pt>
                <c:pt idx="12">
                  <c:v>30.8301886792453</c:v>
                </c:pt>
                <c:pt idx="13">
                  <c:v>29.311650000000043</c:v>
                </c:pt>
                <c:pt idx="14">
                  <c:v>31.307600000000001</c:v>
                </c:pt>
                <c:pt idx="15">
                  <c:v>33.223750000000095</c:v>
                </c:pt>
              </c:numCache>
            </c:numRef>
          </c:val>
        </c:ser>
        <c:dLbls>
          <c:showLegendKey val="0"/>
          <c:showVal val="0"/>
          <c:showCatName val="0"/>
          <c:showSerName val="0"/>
          <c:showPercent val="0"/>
          <c:showBubbleSize val="0"/>
        </c:dLbls>
        <c:gapWidth val="150"/>
        <c:axId val="-271740960"/>
        <c:axId val="-271745312"/>
      </c:barChart>
      <c:catAx>
        <c:axId val="-271740960"/>
        <c:scaling>
          <c:orientation val="minMax"/>
        </c:scaling>
        <c:delete val="0"/>
        <c:axPos val="b"/>
        <c:numFmt formatCode="General" sourceLinked="0"/>
        <c:majorTickMark val="out"/>
        <c:minorTickMark val="none"/>
        <c:tickLblPos val="none"/>
        <c:crossAx val="-271745312"/>
        <c:crosses val="autoZero"/>
        <c:auto val="1"/>
        <c:lblAlgn val="ctr"/>
        <c:lblOffset val="100"/>
        <c:noMultiLvlLbl val="0"/>
      </c:catAx>
      <c:valAx>
        <c:axId val="-271745312"/>
        <c:scaling>
          <c:orientation val="minMax"/>
        </c:scaling>
        <c:delete val="0"/>
        <c:axPos val="l"/>
        <c:numFmt formatCode="General" sourceLinked="1"/>
        <c:majorTickMark val="out"/>
        <c:minorTickMark val="none"/>
        <c:tickLblPos val="nextTo"/>
        <c:crossAx val="-271740960"/>
        <c:crosses val="autoZero"/>
        <c:crossBetween val="between"/>
      </c:valAx>
    </c:plotArea>
    <c:legend>
      <c:legendPos val="r"/>
      <c:layout>
        <c:manualLayout>
          <c:xMode val="edge"/>
          <c:yMode val="edge"/>
          <c:x val="0.78411745846823533"/>
          <c:y val="2.7395962980082282E-2"/>
          <c:w val="0.20620496680318678"/>
          <c:h val="0.11718044569160289"/>
        </c:manualLayout>
      </c:layout>
      <c:overlay val="0"/>
    </c:legend>
    <c:plotVisOnly val="1"/>
    <c:dispBlanksAs val="gap"/>
    <c:showDLblsOverMax val="0"/>
  </c:chart>
  <c:txPr>
    <a:bodyPr/>
    <a:lstStyle/>
    <a:p>
      <a:pPr>
        <a:defRPr sz="800" b="1">
          <a:latin typeface="Arial" pitchFamily="34" charset="0"/>
          <a:cs typeface="Arial" pitchFamily="34" charset="0"/>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001'!$K$1</c:f>
              <c:strCache>
                <c:ptCount val="1"/>
                <c:pt idx="0">
                  <c:v>5</c:v>
                </c:pt>
              </c:strCache>
            </c:strRef>
          </c:tx>
          <c:spPr>
            <a:solidFill>
              <a:schemeClr val="accent1"/>
            </a:solidFill>
            <a:ln>
              <a:noFill/>
            </a:ln>
            <a:effectLst/>
          </c:spPr>
          <c:invertIfNegative val="0"/>
          <c:cat>
            <c:strRef>
              <c:f>'.001'!$J$2:$J$6</c:f>
              <c:strCache>
                <c:ptCount val="5"/>
                <c:pt idx="0">
                  <c:v>FC 100</c:v>
                </c:pt>
                <c:pt idx="1">
                  <c:v>FC 80</c:v>
                </c:pt>
                <c:pt idx="2">
                  <c:v>FC 60</c:v>
                </c:pt>
                <c:pt idx="3">
                  <c:v>FC 40</c:v>
                </c:pt>
                <c:pt idx="4">
                  <c:v>FC 20</c:v>
                </c:pt>
              </c:strCache>
            </c:strRef>
          </c:cat>
          <c:val>
            <c:numRef>
              <c:f>'.001'!$K$2:$K$6</c:f>
              <c:numCache>
                <c:formatCode>General</c:formatCode>
                <c:ptCount val="5"/>
                <c:pt idx="0">
                  <c:v>15.384615384615385</c:v>
                </c:pt>
                <c:pt idx="1">
                  <c:v>8.3333333333333357</c:v>
                </c:pt>
                <c:pt idx="2">
                  <c:v>11.111111111111091</c:v>
                </c:pt>
                <c:pt idx="3">
                  <c:v>11.111111111111091</c:v>
                </c:pt>
                <c:pt idx="4">
                  <c:v>0</c:v>
                </c:pt>
              </c:numCache>
            </c:numRef>
          </c:val>
        </c:ser>
        <c:ser>
          <c:idx val="1"/>
          <c:order val="1"/>
          <c:tx>
            <c:strRef>
              <c:f>'.001'!$L$1</c:f>
              <c:strCache>
                <c:ptCount val="1"/>
                <c:pt idx="0">
                  <c:v>4</c:v>
                </c:pt>
              </c:strCache>
            </c:strRef>
          </c:tx>
          <c:spPr>
            <a:solidFill>
              <a:schemeClr val="accent2"/>
            </a:solidFill>
            <a:ln>
              <a:noFill/>
            </a:ln>
            <a:effectLst/>
          </c:spPr>
          <c:invertIfNegative val="0"/>
          <c:cat>
            <c:strRef>
              <c:f>'.001'!$J$2:$J$6</c:f>
              <c:strCache>
                <c:ptCount val="5"/>
                <c:pt idx="0">
                  <c:v>FC 100</c:v>
                </c:pt>
                <c:pt idx="1">
                  <c:v>FC 80</c:v>
                </c:pt>
                <c:pt idx="2">
                  <c:v>FC 60</c:v>
                </c:pt>
                <c:pt idx="3">
                  <c:v>FC 40</c:v>
                </c:pt>
                <c:pt idx="4">
                  <c:v>FC 20</c:v>
                </c:pt>
              </c:strCache>
            </c:strRef>
          </c:cat>
          <c:val>
            <c:numRef>
              <c:f>'.001'!$L$2:$L$6</c:f>
              <c:numCache>
                <c:formatCode>General</c:formatCode>
                <c:ptCount val="5"/>
                <c:pt idx="0">
                  <c:v>23.076923076923041</c:v>
                </c:pt>
                <c:pt idx="1">
                  <c:v>25</c:v>
                </c:pt>
                <c:pt idx="2">
                  <c:v>22.222222222222175</c:v>
                </c:pt>
                <c:pt idx="3">
                  <c:v>10.526315789473669</c:v>
                </c:pt>
                <c:pt idx="4">
                  <c:v>33.333333333333336</c:v>
                </c:pt>
              </c:numCache>
            </c:numRef>
          </c:val>
        </c:ser>
        <c:ser>
          <c:idx val="2"/>
          <c:order val="2"/>
          <c:tx>
            <c:strRef>
              <c:f>'.001'!$M$1</c:f>
              <c:strCache>
                <c:ptCount val="1"/>
                <c:pt idx="0">
                  <c:v>3</c:v>
                </c:pt>
              </c:strCache>
            </c:strRef>
          </c:tx>
          <c:spPr>
            <a:solidFill>
              <a:schemeClr val="accent3"/>
            </a:solidFill>
            <a:ln>
              <a:noFill/>
            </a:ln>
            <a:effectLst/>
          </c:spPr>
          <c:invertIfNegative val="0"/>
          <c:cat>
            <c:strRef>
              <c:f>'.001'!$J$2:$J$6</c:f>
              <c:strCache>
                <c:ptCount val="5"/>
                <c:pt idx="0">
                  <c:v>FC 100</c:v>
                </c:pt>
                <c:pt idx="1">
                  <c:v>FC 80</c:v>
                </c:pt>
                <c:pt idx="2">
                  <c:v>FC 60</c:v>
                </c:pt>
                <c:pt idx="3">
                  <c:v>FC 40</c:v>
                </c:pt>
                <c:pt idx="4">
                  <c:v>FC 20</c:v>
                </c:pt>
              </c:strCache>
            </c:strRef>
          </c:cat>
          <c:val>
            <c:numRef>
              <c:f>'.001'!$M$2:$M$6</c:f>
              <c:numCache>
                <c:formatCode>General</c:formatCode>
                <c:ptCount val="5"/>
                <c:pt idx="0">
                  <c:v>7.6923076923076925</c:v>
                </c:pt>
                <c:pt idx="1">
                  <c:v>16.666666666666668</c:v>
                </c:pt>
                <c:pt idx="2">
                  <c:v>22.222222222222175</c:v>
                </c:pt>
                <c:pt idx="3">
                  <c:v>11.111111111111091</c:v>
                </c:pt>
                <c:pt idx="4">
                  <c:v>11.111111111111091</c:v>
                </c:pt>
              </c:numCache>
            </c:numRef>
          </c:val>
        </c:ser>
        <c:ser>
          <c:idx val="3"/>
          <c:order val="3"/>
          <c:tx>
            <c:strRef>
              <c:f>'.001'!$N$1</c:f>
              <c:strCache>
                <c:ptCount val="1"/>
                <c:pt idx="0">
                  <c:v>2</c:v>
                </c:pt>
              </c:strCache>
            </c:strRef>
          </c:tx>
          <c:spPr>
            <a:solidFill>
              <a:schemeClr val="accent4"/>
            </a:solidFill>
            <a:ln>
              <a:noFill/>
            </a:ln>
            <a:effectLst/>
          </c:spPr>
          <c:invertIfNegative val="0"/>
          <c:cat>
            <c:strRef>
              <c:f>'.001'!$J$2:$J$6</c:f>
              <c:strCache>
                <c:ptCount val="5"/>
                <c:pt idx="0">
                  <c:v>FC 100</c:v>
                </c:pt>
                <c:pt idx="1">
                  <c:v>FC 80</c:v>
                </c:pt>
                <c:pt idx="2">
                  <c:v>FC 60</c:v>
                </c:pt>
                <c:pt idx="3">
                  <c:v>FC 40</c:v>
                </c:pt>
                <c:pt idx="4">
                  <c:v>FC 20</c:v>
                </c:pt>
              </c:strCache>
            </c:strRef>
          </c:cat>
          <c:val>
            <c:numRef>
              <c:f>'.001'!$N$2:$N$6</c:f>
              <c:numCache>
                <c:formatCode>General</c:formatCode>
                <c:ptCount val="5"/>
                <c:pt idx="0">
                  <c:v>23.076923076923041</c:v>
                </c:pt>
                <c:pt idx="1">
                  <c:v>0</c:v>
                </c:pt>
                <c:pt idx="2">
                  <c:v>22.222222222222175</c:v>
                </c:pt>
                <c:pt idx="3">
                  <c:v>11.111111111111091</c:v>
                </c:pt>
                <c:pt idx="4">
                  <c:v>11.111111111111091</c:v>
                </c:pt>
              </c:numCache>
            </c:numRef>
          </c:val>
        </c:ser>
        <c:ser>
          <c:idx val="4"/>
          <c:order val="4"/>
          <c:tx>
            <c:strRef>
              <c:f>'.001'!$O$1</c:f>
              <c:strCache>
                <c:ptCount val="1"/>
                <c:pt idx="0">
                  <c:v>1</c:v>
                </c:pt>
              </c:strCache>
            </c:strRef>
          </c:tx>
          <c:spPr>
            <a:solidFill>
              <a:schemeClr val="accent5"/>
            </a:solidFill>
            <a:ln>
              <a:noFill/>
            </a:ln>
            <a:effectLst/>
          </c:spPr>
          <c:invertIfNegative val="0"/>
          <c:cat>
            <c:strRef>
              <c:f>'.001'!$J$2:$J$6</c:f>
              <c:strCache>
                <c:ptCount val="5"/>
                <c:pt idx="0">
                  <c:v>FC 100</c:v>
                </c:pt>
                <c:pt idx="1">
                  <c:v>FC 80</c:v>
                </c:pt>
                <c:pt idx="2">
                  <c:v>FC 60</c:v>
                </c:pt>
                <c:pt idx="3">
                  <c:v>FC 40</c:v>
                </c:pt>
                <c:pt idx="4">
                  <c:v>FC 20</c:v>
                </c:pt>
              </c:strCache>
            </c:strRef>
          </c:cat>
          <c:val>
            <c:numRef>
              <c:f>'.001'!$O$2:$O$6</c:f>
              <c:numCache>
                <c:formatCode>General</c:formatCode>
                <c:ptCount val="5"/>
                <c:pt idx="0">
                  <c:v>30.76923076923077</c:v>
                </c:pt>
                <c:pt idx="1">
                  <c:v>41.666666666666551</c:v>
                </c:pt>
                <c:pt idx="2">
                  <c:v>22.222222222222175</c:v>
                </c:pt>
                <c:pt idx="3">
                  <c:v>44.444444444444329</c:v>
                </c:pt>
                <c:pt idx="4">
                  <c:v>44.444444444444329</c:v>
                </c:pt>
              </c:numCache>
            </c:numRef>
          </c:val>
        </c:ser>
        <c:ser>
          <c:idx val="5"/>
          <c:order val="5"/>
          <c:tx>
            <c:strRef>
              <c:f>'.001'!$P$1</c:f>
              <c:strCache>
                <c:ptCount val="1"/>
                <c:pt idx="0">
                  <c:v>0</c:v>
                </c:pt>
              </c:strCache>
            </c:strRef>
          </c:tx>
          <c:spPr>
            <a:solidFill>
              <a:schemeClr val="accent6"/>
            </a:solidFill>
            <a:ln>
              <a:noFill/>
            </a:ln>
            <a:effectLst/>
          </c:spPr>
          <c:invertIfNegative val="0"/>
          <c:cat>
            <c:strRef>
              <c:f>'.001'!$J$2:$J$6</c:f>
              <c:strCache>
                <c:ptCount val="5"/>
                <c:pt idx="0">
                  <c:v>FC 100</c:v>
                </c:pt>
                <c:pt idx="1">
                  <c:v>FC 80</c:v>
                </c:pt>
                <c:pt idx="2">
                  <c:v>FC 60</c:v>
                </c:pt>
                <c:pt idx="3">
                  <c:v>FC 40</c:v>
                </c:pt>
                <c:pt idx="4">
                  <c:v>FC 20</c:v>
                </c:pt>
              </c:strCache>
            </c:strRef>
          </c:cat>
          <c:val>
            <c:numRef>
              <c:f>'.001'!$P$2:$P$6</c:f>
              <c:numCache>
                <c:formatCode>General</c:formatCode>
                <c:ptCount val="5"/>
                <c:pt idx="0">
                  <c:v>0</c:v>
                </c:pt>
                <c:pt idx="1">
                  <c:v>8.3333333333333357</c:v>
                </c:pt>
                <c:pt idx="2">
                  <c:v>0</c:v>
                </c:pt>
                <c:pt idx="3">
                  <c:v>0</c:v>
                </c:pt>
                <c:pt idx="4">
                  <c:v>0</c:v>
                </c:pt>
              </c:numCache>
            </c:numRef>
          </c:val>
        </c:ser>
        <c:dLbls>
          <c:showLegendKey val="0"/>
          <c:showVal val="0"/>
          <c:showCatName val="0"/>
          <c:showSerName val="0"/>
          <c:showPercent val="0"/>
          <c:showBubbleSize val="0"/>
        </c:dLbls>
        <c:gapWidth val="150"/>
        <c:overlap val="100"/>
        <c:axId val="-271743680"/>
        <c:axId val="-271743136"/>
      </c:barChart>
      <c:catAx>
        <c:axId val="-27174368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271743136"/>
        <c:crosses val="autoZero"/>
        <c:auto val="1"/>
        <c:lblAlgn val="ctr"/>
        <c:lblOffset val="100"/>
        <c:noMultiLvlLbl val="0"/>
      </c:catAx>
      <c:valAx>
        <c:axId val="-271743136"/>
        <c:scaling>
          <c:orientation val="minMax"/>
        </c:scaling>
        <c:delete val="0"/>
        <c:axPos val="l"/>
        <c:numFmt formatCode="0%" sourceLinked="1"/>
        <c:majorTickMark val="none"/>
        <c:minorTickMark val="none"/>
        <c:tickLblPos val="nextTo"/>
        <c:spPr>
          <a:noFill/>
          <a:ln>
            <a:solidFill>
              <a:schemeClr val="tx1"/>
            </a:solidFill>
          </a:ln>
          <a:effectLst/>
        </c:spPr>
        <c:txPr>
          <a:bodyPr rot="-60000000" vert="horz"/>
          <a:lstStyle/>
          <a:p>
            <a:pPr>
              <a:defRPr/>
            </a:pPr>
            <a:endParaRPr lang="en-US"/>
          </a:p>
        </c:txPr>
        <c:crossAx val="-271743680"/>
        <c:crosses val="autoZero"/>
        <c:crossBetween val="between"/>
      </c:valAx>
      <c:spPr>
        <a:noFill/>
        <a:ln>
          <a:noFill/>
        </a:ln>
        <a:effectLst/>
      </c:spPr>
    </c:plotArea>
    <c:legend>
      <c:legendPos val="b"/>
      <c:overlay val="0"/>
      <c:spPr>
        <a:noFill/>
        <a:ln>
          <a:noFill/>
        </a:ln>
        <a:effectLst/>
      </c:spPr>
      <c:txPr>
        <a:bodyPr rot="0" vert="horz"/>
        <a:lstStyle/>
        <a:p>
          <a:pPr>
            <a:defRPr/>
          </a:pPr>
          <a:endParaRPr lang="en-US"/>
        </a:p>
      </c:txPr>
    </c:legend>
    <c:plotVisOnly val="1"/>
    <c:dispBlanksAs val="gap"/>
    <c:showDLblsOverMax val="0"/>
  </c:chart>
  <c:spPr>
    <a:solidFill>
      <a:schemeClr val="bg1"/>
    </a:solidFill>
    <a:ln w="9525" cap="flat" cmpd="sng" algn="ctr">
      <a:noFill/>
      <a:round/>
    </a:ln>
    <a:effectLst/>
  </c:spPr>
  <c:txPr>
    <a:bodyPr/>
    <a:lstStyle/>
    <a:p>
      <a:pPr>
        <a:defRPr sz="800" b="1">
          <a:latin typeface="Arial" pitchFamily="34" charset="0"/>
          <a:cs typeface="Arial" pitchFamily="34" charset="0"/>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0001'!$B$2</c:f>
              <c:strCache>
                <c:ptCount val="1"/>
                <c:pt idx="0">
                  <c:v>5</c:v>
                </c:pt>
              </c:strCache>
            </c:strRef>
          </c:tx>
          <c:spPr>
            <a:solidFill>
              <a:schemeClr val="accent1"/>
            </a:solidFill>
            <a:ln>
              <a:noFill/>
            </a:ln>
            <a:effectLst/>
          </c:spPr>
          <c:invertIfNegative val="0"/>
          <c:cat>
            <c:strRef>
              <c:f>'.0001'!$A$3:$A$7</c:f>
              <c:strCache>
                <c:ptCount val="5"/>
                <c:pt idx="0">
                  <c:v>100% FC</c:v>
                </c:pt>
                <c:pt idx="1">
                  <c:v>80%FC</c:v>
                </c:pt>
                <c:pt idx="2">
                  <c:v>60%FC</c:v>
                </c:pt>
                <c:pt idx="3">
                  <c:v>40%FC</c:v>
                </c:pt>
                <c:pt idx="4">
                  <c:v>20%FC</c:v>
                </c:pt>
              </c:strCache>
            </c:strRef>
          </c:cat>
          <c:val>
            <c:numRef>
              <c:f>'.0001'!$B$3:$B$7</c:f>
              <c:numCache>
                <c:formatCode>General</c:formatCode>
                <c:ptCount val="5"/>
                <c:pt idx="0">
                  <c:v>0</c:v>
                </c:pt>
                <c:pt idx="1">
                  <c:v>0</c:v>
                </c:pt>
                <c:pt idx="2">
                  <c:v>0</c:v>
                </c:pt>
                <c:pt idx="3">
                  <c:v>0</c:v>
                </c:pt>
                <c:pt idx="4">
                  <c:v>0</c:v>
                </c:pt>
              </c:numCache>
            </c:numRef>
          </c:val>
        </c:ser>
        <c:ser>
          <c:idx val="1"/>
          <c:order val="1"/>
          <c:tx>
            <c:strRef>
              <c:f>'.0001'!$C$2</c:f>
              <c:strCache>
                <c:ptCount val="1"/>
                <c:pt idx="0">
                  <c:v>4</c:v>
                </c:pt>
              </c:strCache>
            </c:strRef>
          </c:tx>
          <c:spPr>
            <a:solidFill>
              <a:schemeClr val="accent2"/>
            </a:solidFill>
            <a:ln>
              <a:noFill/>
            </a:ln>
            <a:effectLst/>
          </c:spPr>
          <c:invertIfNegative val="0"/>
          <c:cat>
            <c:strRef>
              <c:f>'.0001'!$A$3:$A$7</c:f>
              <c:strCache>
                <c:ptCount val="5"/>
                <c:pt idx="0">
                  <c:v>100% FC</c:v>
                </c:pt>
                <c:pt idx="1">
                  <c:v>80%FC</c:v>
                </c:pt>
                <c:pt idx="2">
                  <c:v>60%FC</c:v>
                </c:pt>
                <c:pt idx="3">
                  <c:v>40%FC</c:v>
                </c:pt>
                <c:pt idx="4">
                  <c:v>20%FC</c:v>
                </c:pt>
              </c:strCache>
            </c:strRef>
          </c:cat>
          <c:val>
            <c:numRef>
              <c:f>'.0001'!$C$3:$C$7</c:f>
              <c:numCache>
                <c:formatCode>General</c:formatCode>
                <c:ptCount val="5"/>
                <c:pt idx="0">
                  <c:v>15.384615384615385</c:v>
                </c:pt>
                <c:pt idx="1">
                  <c:v>27.272727272727181</c:v>
                </c:pt>
                <c:pt idx="2">
                  <c:v>0</c:v>
                </c:pt>
                <c:pt idx="3">
                  <c:v>0</c:v>
                </c:pt>
                <c:pt idx="4">
                  <c:v>0</c:v>
                </c:pt>
              </c:numCache>
            </c:numRef>
          </c:val>
        </c:ser>
        <c:ser>
          <c:idx val="2"/>
          <c:order val="2"/>
          <c:tx>
            <c:strRef>
              <c:f>'.0001'!$D$2</c:f>
              <c:strCache>
                <c:ptCount val="1"/>
                <c:pt idx="0">
                  <c:v>3</c:v>
                </c:pt>
              </c:strCache>
            </c:strRef>
          </c:tx>
          <c:spPr>
            <a:solidFill>
              <a:schemeClr val="accent3"/>
            </a:solidFill>
            <a:ln>
              <a:noFill/>
            </a:ln>
            <a:effectLst/>
          </c:spPr>
          <c:invertIfNegative val="0"/>
          <c:cat>
            <c:strRef>
              <c:f>'.0001'!$A$3:$A$7</c:f>
              <c:strCache>
                <c:ptCount val="5"/>
                <c:pt idx="0">
                  <c:v>100% FC</c:v>
                </c:pt>
                <c:pt idx="1">
                  <c:v>80%FC</c:v>
                </c:pt>
                <c:pt idx="2">
                  <c:v>60%FC</c:v>
                </c:pt>
                <c:pt idx="3">
                  <c:v>40%FC</c:v>
                </c:pt>
                <c:pt idx="4">
                  <c:v>20%FC</c:v>
                </c:pt>
              </c:strCache>
            </c:strRef>
          </c:cat>
          <c:val>
            <c:numRef>
              <c:f>'.0001'!$D$3:$D$7</c:f>
              <c:numCache>
                <c:formatCode>General</c:formatCode>
                <c:ptCount val="5"/>
                <c:pt idx="0">
                  <c:v>15.384615384615385</c:v>
                </c:pt>
                <c:pt idx="1">
                  <c:v>9.0909090909091006</c:v>
                </c:pt>
                <c:pt idx="2">
                  <c:v>37.5</c:v>
                </c:pt>
                <c:pt idx="3">
                  <c:v>12.5</c:v>
                </c:pt>
                <c:pt idx="4">
                  <c:v>0</c:v>
                </c:pt>
              </c:numCache>
            </c:numRef>
          </c:val>
        </c:ser>
        <c:ser>
          <c:idx val="3"/>
          <c:order val="3"/>
          <c:tx>
            <c:strRef>
              <c:f>'.0001'!$E$2</c:f>
              <c:strCache>
                <c:ptCount val="1"/>
                <c:pt idx="0">
                  <c:v>2</c:v>
                </c:pt>
              </c:strCache>
            </c:strRef>
          </c:tx>
          <c:spPr>
            <a:solidFill>
              <a:schemeClr val="accent4"/>
            </a:solidFill>
            <a:ln>
              <a:noFill/>
            </a:ln>
            <a:effectLst/>
          </c:spPr>
          <c:invertIfNegative val="0"/>
          <c:cat>
            <c:strRef>
              <c:f>'.0001'!$A$3:$A$7</c:f>
              <c:strCache>
                <c:ptCount val="5"/>
                <c:pt idx="0">
                  <c:v>100% FC</c:v>
                </c:pt>
                <c:pt idx="1">
                  <c:v>80%FC</c:v>
                </c:pt>
                <c:pt idx="2">
                  <c:v>60%FC</c:v>
                </c:pt>
                <c:pt idx="3">
                  <c:v>40%FC</c:v>
                </c:pt>
                <c:pt idx="4">
                  <c:v>20%FC</c:v>
                </c:pt>
              </c:strCache>
            </c:strRef>
          </c:cat>
          <c:val>
            <c:numRef>
              <c:f>'.0001'!$E$3:$E$7</c:f>
              <c:numCache>
                <c:formatCode>General</c:formatCode>
                <c:ptCount val="5"/>
                <c:pt idx="0">
                  <c:v>23.076923076923041</c:v>
                </c:pt>
                <c:pt idx="1">
                  <c:v>9.0909090909091006</c:v>
                </c:pt>
                <c:pt idx="2">
                  <c:v>0</c:v>
                </c:pt>
                <c:pt idx="3">
                  <c:v>0</c:v>
                </c:pt>
                <c:pt idx="4">
                  <c:v>11.111111111111091</c:v>
                </c:pt>
              </c:numCache>
            </c:numRef>
          </c:val>
        </c:ser>
        <c:ser>
          <c:idx val="4"/>
          <c:order val="4"/>
          <c:tx>
            <c:strRef>
              <c:f>'.0001'!$F$2</c:f>
              <c:strCache>
                <c:ptCount val="1"/>
                <c:pt idx="0">
                  <c:v>1</c:v>
                </c:pt>
              </c:strCache>
            </c:strRef>
          </c:tx>
          <c:spPr>
            <a:solidFill>
              <a:schemeClr val="accent5"/>
            </a:solidFill>
            <a:ln>
              <a:noFill/>
            </a:ln>
            <a:effectLst/>
          </c:spPr>
          <c:invertIfNegative val="0"/>
          <c:cat>
            <c:strRef>
              <c:f>'.0001'!$A$3:$A$7</c:f>
              <c:strCache>
                <c:ptCount val="5"/>
                <c:pt idx="0">
                  <c:v>100% FC</c:v>
                </c:pt>
                <c:pt idx="1">
                  <c:v>80%FC</c:v>
                </c:pt>
                <c:pt idx="2">
                  <c:v>60%FC</c:v>
                </c:pt>
                <c:pt idx="3">
                  <c:v>40%FC</c:v>
                </c:pt>
                <c:pt idx="4">
                  <c:v>20%FC</c:v>
                </c:pt>
              </c:strCache>
            </c:strRef>
          </c:cat>
          <c:val>
            <c:numRef>
              <c:f>'.0001'!$F$3:$F$7</c:f>
              <c:numCache>
                <c:formatCode>General</c:formatCode>
                <c:ptCount val="5"/>
                <c:pt idx="0">
                  <c:v>15.384615384615385</c:v>
                </c:pt>
                <c:pt idx="1">
                  <c:v>0</c:v>
                </c:pt>
                <c:pt idx="2">
                  <c:v>0</c:v>
                </c:pt>
                <c:pt idx="3">
                  <c:v>0</c:v>
                </c:pt>
                <c:pt idx="4">
                  <c:v>11.111111111111091</c:v>
                </c:pt>
              </c:numCache>
            </c:numRef>
          </c:val>
        </c:ser>
        <c:ser>
          <c:idx val="5"/>
          <c:order val="5"/>
          <c:tx>
            <c:strRef>
              <c:f>'.0001'!$G$2</c:f>
              <c:strCache>
                <c:ptCount val="1"/>
                <c:pt idx="0">
                  <c:v>0</c:v>
                </c:pt>
              </c:strCache>
            </c:strRef>
          </c:tx>
          <c:spPr>
            <a:solidFill>
              <a:schemeClr val="accent6"/>
            </a:solidFill>
            <a:ln>
              <a:noFill/>
            </a:ln>
            <a:effectLst/>
          </c:spPr>
          <c:invertIfNegative val="0"/>
          <c:cat>
            <c:strRef>
              <c:f>'.0001'!$A$3:$A$7</c:f>
              <c:strCache>
                <c:ptCount val="5"/>
                <c:pt idx="0">
                  <c:v>100% FC</c:v>
                </c:pt>
                <c:pt idx="1">
                  <c:v>80%FC</c:v>
                </c:pt>
                <c:pt idx="2">
                  <c:v>60%FC</c:v>
                </c:pt>
                <c:pt idx="3">
                  <c:v>40%FC</c:v>
                </c:pt>
                <c:pt idx="4">
                  <c:v>20%FC</c:v>
                </c:pt>
              </c:strCache>
            </c:strRef>
          </c:cat>
          <c:val>
            <c:numRef>
              <c:f>'.0001'!$G$3:$G$7</c:f>
              <c:numCache>
                <c:formatCode>General</c:formatCode>
                <c:ptCount val="5"/>
                <c:pt idx="0">
                  <c:v>30.76923076923077</c:v>
                </c:pt>
                <c:pt idx="1">
                  <c:v>54.545454545454547</c:v>
                </c:pt>
                <c:pt idx="2">
                  <c:v>62.5</c:v>
                </c:pt>
                <c:pt idx="3">
                  <c:v>87.5</c:v>
                </c:pt>
                <c:pt idx="4">
                  <c:v>77.777777777777658</c:v>
                </c:pt>
              </c:numCache>
            </c:numRef>
          </c:val>
        </c:ser>
        <c:dLbls>
          <c:showLegendKey val="0"/>
          <c:showVal val="0"/>
          <c:showCatName val="0"/>
          <c:showSerName val="0"/>
          <c:showPercent val="0"/>
          <c:showBubbleSize val="0"/>
        </c:dLbls>
        <c:gapWidth val="150"/>
        <c:overlap val="100"/>
        <c:axId val="-271738784"/>
        <c:axId val="-271738240"/>
      </c:barChart>
      <c:catAx>
        <c:axId val="-27173878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271738240"/>
        <c:crosses val="autoZero"/>
        <c:auto val="1"/>
        <c:lblAlgn val="ctr"/>
        <c:lblOffset val="100"/>
        <c:noMultiLvlLbl val="0"/>
      </c:catAx>
      <c:valAx>
        <c:axId val="-271738240"/>
        <c:scaling>
          <c:orientation val="minMax"/>
        </c:scaling>
        <c:delete val="0"/>
        <c:axPos val="l"/>
        <c:numFmt formatCode="0%" sourceLinked="1"/>
        <c:majorTickMark val="none"/>
        <c:minorTickMark val="none"/>
        <c:tickLblPos val="nextTo"/>
        <c:spPr>
          <a:noFill/>
          <a:ln>
            <a:solidFill>
              <a:schemeClr val="tx1"/>
            </a:solidFill>
          </a:ln>
          <a:effectLst/>
        </c:spPr>
        <c:txPr>
          <a:bodyPr rot="-60000000" vert="horz"/>
          <a:lstStyle/>
          <a:p>
            <a:pPr>
              <a:defRPr/>
            </a:pPr>
            <a:endParaRPr lang="en-US"/>
          </a:p>
        </c:txPr>
        <c:crossAx val="-271738784"/>
        <c:crosses val="autoZero"/>
        <c:crossBetween val="between"/>
      </c:valAx>
      <c:spPr>
        <a:noFill/>
        <a:ln>
          <a:noFill/>
        </a:ln>
        <a:effectLst/>
      </c:spPr>
    </c:plotArea>
    <c:legend>
      <c:legendPos val="b"/>
      <c:overlay val="0"/>
      <c:spPr>
        <a:noFill/>
        <a:ln>
          <a:noFill/>
        </a:ln>
        <a:effectLst/>
      </c:spPr>
      <c:txPr>
        <a:bodyPr rot="0" vert="horz"/>
        <a:lstStyle/>
        <a:p>
          <a:pPr>
            <a:defRPr/>
          </a:pPr>
          <a:endParaRPr lang="en-US"/>
        </a:p>
      </c:txPr>
    </c:legend>
    <c:plotVisOnly val="1"/>
    <c:dispBlanksAs val="gap"/>
    <c:showDLblsOverMax val="0"/>
  </c:chart>
  <c:spPr>
    <a:solidFill>
      <a:schemeClr val="bg1"/>
    </a:solidFill>
    <a:ln w="9525" cap="flat" cmpd="sng" algn="ctr">
      <a:noFill/>
      <a:round/>
    </a:ln>
    <a:effectLst/>
  </c:spPr>
  <c:txPr>
    <a:bodyPr/>
    <a:lstStyle/>
    <a:p>
      <a:pPr>
        <a:defRPr sz="800" b="1">
          <a:latin typeface="Arial" pitchFamily="34" charset="0"/>
          <a:cs typeface="Arial" pitchFamily="34" charset="0"/>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00005'!$B$2</c:f>
              <c:strCache>
                <c:ptCount val="1"/>
                <c:pt idx="0">
                  <c:v>5</c:v>
                </c:pt>
              </c:strCache>
            </c:strRef>
          </c:tx>
          <c:spPr>
            <a:solidFill>
              <a:schemeClr val="accent1"/>
            </a:solidFill>
            <a:ln>
              <a:noFill/>
            </a:ln>
            <a:effectLst/>
          </c:spPr>
          <c:invertIfNegative val="0"/>
          <c:cat>
            <c:strRef>
              <c:f>'.00005'!$A$3:$A$7</c:f>
              <c:strCache>
                <c:ptCount val="5"/>
                <c:pt idx="0">
                  <c:v>100% FC</c:v>
                </c:pt>
                <c:pt idx="1">
                  <c:v>80%FC</c:v>
                </c:pt>
                <c:pt idx="2">
                  <c:v>60%FC</c:v>
                </c:pt>
                <c:pt idx="3">
                  <c:v>40%FC</c:v>
                </c:pt>
                <c:pt idx="4">
                  <c:v>20%FC</c:v>
                </c:pt>
              </c:strCache>
            </c:strRef>
          </c:cat>
          <c:val>
            <c:numRef>
              <c:f>'.00005'!$B$3:$B$7</c:f>
              <c:numCache>
                <c:formatCode>General</c:formatCode>
                <c:ptCount val="5"/>
                <c:pt idx="0">
                  <c:v>0</c:v>
                </c:pt>
                <c:pt idx="1">
                  <c:v>0</c:v>
                </c:pt>
                <c:pt idx="2">
                  <c:v>0</c:v>
                </c:pt>
                <c:pt idx="3">
                  <c:v>0</c:v>
                </c:pt>
                <c:pt idx="4">
                  <c:v>0</c:v>
                </c:pt>
              </c:numCache>
            </c:numRef>
          </c:val>
        </c:ser>
        <c:ser>
          <c:idx val="1"/>
          <c:order val="1"/>
          <c:tx>
            <c:strRef>
              <c:f>'.00005'!$C$2</c:f>
              <c:strCache>
                <c:ptCount val="1"/>
                <c:pt idx="0">
                  <c:v>4</c:v>
                </c:pt>
              </c:strCache>
            </c:strRef>
          </c:tx>
          <c:spPr>
            <a:solidFill>
              <a:schemeClr val="accent2"/>
            </a:solidFill>
            <a:ln>
              <a:noFill/>
            </a:ln>
            <a:effectLst/>
          </c:spPr>
          <c:invertIfNegative val="0"/>
          <c:cat>
            <c:strRef>
              <c:f>'.00005'!$A$3:$A$7</c:f>
              <c:strCache>
                <c:ptCount val="5"/>
                <c:pt idx="0">
                  <c:v>100% FC</c:v>
                </c:pt>
                <c:pt idx="1">
                  <c:v>80%FC</c:v>
                </c:pt>
                <c:pt idx="2">
                  <c:v>60%FC</c:v>
                </c:pt>
                <c:pt idx="3">
                  <c:v>40%FC</c:v>
                </c:pt>
                <c:pt idx="4">
                  <c:v>20%FC</c:v>
                </c:pt>
              </c:strCache>
            </c:strRef>
          </c:cat>
          <c:val>
            <c:numRef>
              <c:f>'.00005'!$C$3:$C$7</c:f>
              <c:numCache>
                <c:formatCode>General</c:formatCode>
                <c:ptCount val="5"/>
                <c:pt idx="0">
                  <c:v>8.3333333333333357</c:v>
                </c:pt>
                <c:pt idx="1">
                  <c:v>10</c:v>
                </c:pt>
                <c:pt idx="2">
                  <c:v>9.0909090909091006</c:v>
                </c:pt>
                <c:pt idx="3">
                  <c:v>0</c:v>
                </c:pt>
                <c:pt idx="4">
                  <c:v>0</c:v>
                </c:pt>
              </c:numCache>
            </c:numRef>
          </c:val>
        </c:ser>
        <c:ser>
          <c:idx val="2"/>
          <c:order val="2"/>
          <c:tx>
            <c:strRef>
              <c:f>'.00005'!$D$2</c:f>
              <c:strCache>
                <c:ptCount val="1"/>
                <c:pt idx="0">
                  <c:v>3</c:v>
                </c:pt>
              </c:strCache>
            </c:strRef>
          </c:tx>
          <c:spPr>
            <a:solidFill>
              <a:schemeClr val="accent3"/>
            </a:solidFill>
            <a:ln>
              <a:noFill/>
            </a:ln>
            <a:effectLst/>
          </c:spPr>
          <c:invertIfNegative val="0"/>
          <c:cat>
            <c:strRef>
              <c:f>'.00005'!$A$3:$A$7</c:f>
              <c:strCache>
                <c:ptCount val="5"/>
                <c:pt idx="0">
                  <c:v>100% FC</c:v>
                </c:pt>
                <c:pt idx="1">
                  <c:v>80%FC</c:v>
                </c:pt>
                <c:pt idx="2">
                  <c:v>60%FC</c:v>
                </c:pt>
                <c:pt idx="3">
                  <c:v>40%FC</c:v>
                </c:pt>
                <c:pt idx="4">
                  <c:v>20%FC</c:v>
                </c:pt>
              </c:strCache>
            </c:strRef>
          </c:cat>
          <c:val>
            <c:numRef>
              <c:f>'.00005'!$D$3:$D$7</c:f>
              <c:numCache>
                <c:formatCode>General</c:formatCode>
                <c:ptCount val="5"/>
                <c:pt idx="0">
                  <c:v>41.666666666666551</c:v>
                </c:pt>
                <c:pt idx="1">
                  <c:v>30</c:v>
                </c:pt>
                <c:pt idx="2">
                  <c:v>0</c:v>
                </c:pt>
                <c:pt idx="3">
                  <c:v>27.272727272727181</c:v>
                </c:pt>
                <c:pt idx="4">
                  <c:v>0</c:v>
                </c:pt>
              </c:numCache>
            </c:numRef>
          </c:val>
        </c:ser>
        <c:ser>
          <c:idx val="3"/>
          <c:order val="3"/>
          <c:tx>
            <c:strRef>
              <c:f>'.00005'!$E$2</c:f>
              <c:strCache>
                <c:ptCount val="1"/>
                <c:pt idx="0">
                  <c:v>2</c:v>
                </c:pt>
              </c:strCache>
            </c:strRef>
          </c:tx>
          <c:spPr>
            <a:solidFill>
              <a:schemeClr val="accent4"/>
            </a:solidFill>
            <a:ln>
              <a:noFill/>
            </a:ln>
            <a:effectLst/>
          </c:spPr>
          <c:invertIfNegative val="0"/>
          <c:cat>
            <c:strRef>
              <c:f>'.00005'!$A$3:$A$7</c:f>
              <c:strCache>
                <c:ptCount val="5"/>
                <c:pt idx="0">
                  <c:v>100% FC</c:v>
                </c:pt>
                <c:pt idx="1">
                  <c:v>80%FC</c:v>
                </c:pt>
                <c:pt idx="2">
                  <c:v>60%FC</c:v>
                </c:pt>
                <c:pt idx="3">
                  <c:v>40%FC</c:v>
                </c:pt>
                <c:pt idx="4">
                  <c:v>20%FC</c:v>
                </c:pt>
              </c:strCache>
            </c:strRef>
          </c:cat>
          <c:val>
            <c:numRef>
              <c:f>'.00005'!$E$3:$E$7</c:f>
              <c:numCache>
                <c:formatCode>General</c:formatCode>
                <c:ptCount val="5"/>
                <c:pt idx="0">
                  <c:v>8.3333333333333357</c:v>
                </c:pt>
                <c:pt idx="1">
                  <c:v>10</c:v>
                </c:pt>
                <c:pt idx="2">
                  <c:v>27.272727272727181</c:v>
                </c:pt>
                <c:pt idx="3">
                  <c:v>18.181818181818219</c:v>
                </c:pt>
                <c:pt idx="4">
                  <c:v>0</c:v>
                </c:pt>
              </c:numCache>
            </c:numRef>
          </c:val>
        </c:ser>
        <c:ser>
          <c:idx val="4"/>
          <c:order val="4"/>
          <c:tx>
            <c:strRef>
              <c:f>'.00005'!$F$2</c:f>
              <c:strCache>
                <c:ptCount val="1"/>
                <c:pt idx="0">
                  <c:v>1</c:v>
                </c:pt>
              </c:strCache>
            </c:strRef>
          </c:tx>
          <c:spPr>
            <a:solidFill>
              <a:schemeClr val="accent5"/>
            </a:solidFill>
            <a:ln>
              <a:noFill/>
            </a:ln>
            <a:effectLst/>
          </c:spPr>
          <c:invertIfNegative val="0"/>
          <c:cat>
            <c:strRef>
              <c:f>'.00005'!$A$3:$A$7</c:f>
              <c:strCache>
                <c:ptCount val="5"/>
                <c:pt idx="0">
                  <c:v>100% FC</c:v>
                </c:pt>
                <c:pt idx="1">
                  <c:v>80%FC</c:v>
                </c:pt>
                <c:pt idx="2">
                  <c:v>60%FC</c:v>
                </c:pt>
                <c:pt idx="3">
                  <c:v>40%FC</c:v>
                </c:pt>
                <c:pt idx="4">
                  <c:v>20%FC</c:v>
                </c:pt>
              </c:strCache>
            </c:strRef>
          </c:cat>
          <c:val>
            <c:numRef>
              <c:f>'.00005'!$F$3:$F$7</c:f>
              <c:numCache>
                <c:formatCode>General</c:formatCode>
                <c:ptCount val="5"/>
                <c:pt idx="0">
                  <c:v>0</c:v>
                </c:pt>
                <c:pt idx="1">
                  <c:v>0</c:v>
                </c:pt>
                <c:pt idx="2">
                  <c:v>9.0909090909091006</c:v>
                </c:pt>
                <c:pt idx="3">
                  <c:v>9.0909090909091006</c:v>
                </c:pt>
                <c:pt idx="4">
                  <c:v>25</c:v>
                </c:pt>
              </c:numCache>
            </c:numRef>
          </c:val>
        </c:ser>
        <c:ser>
          <c:idx val="5"/>
          <c:order val="5"/>
          <c:tx>
            <c:strRef>
              <c:f>'.00005'!$G$2</c:f>
              <c:strCache>
                <c:ptCount val="1"/>
                <c:pt idx="0">
                  <c:v>0</c:v>
                </c:pt>
              </c:strCache>
            </c:strRef>
          </c:tx>
          <c:spPr>
            <a:solidFill>
              <a:schemeClr val="accent6"/>
            </a:solidFill>
            <a:ln>
              <a:noFill/>
            </a:ln>
            <a:effectLst/>
          </c:spPr>
          <c:invertIfNegative val="0"/>
          <c:cat>
            <c:strRef>
              <c:f>'.00005'!$A$3:$A$7</c:f>
              <c:strCache>
                <c:ptCount val="5"/>
                <c:pt idx="0">
                  <c:v>100% FC</c:v>
                </c:pt>
                <c:pt idx="1">
                  <c:v>80%FC</c:v>
                </c:pt>
                <c:pt idx="2">
                  <c:v>60%FC</c:v>
                </c:pt>
                <c:pt idx="3">
                  <c:v>40%FC</c:v>
                </c:pt>
                <c:pt idx="4">
                  <c:v>20%FC</c:v>
                </c:pt>
              </c:strCache>
            </c:strRef>
          </c:cat>
          <c:val>
            <c:numRef>
              <c:f>'.00005'!$G$3:$G$7</c:f>
              <c:numCache>
                <c:formatCode>General</c:formatCode>
                <c:ptCount val="5"/>
                <c:pt idx="0">
                  <c:v>41.666666666666551</c:v>
                </c:pt>
                <c:pt idx="1">
                  <c:v>50</c:v>
                </c:pt>
                <c:pt idx="2">
                  <c:v>72.727272727272734</c:v>
                </c:pt>
                <c:pt idx="3">
                  <c:v>45.454545454545368</c:v>
                </c:pt>
                <c:pt idx="4">
                  <c:v>75</c:v>
                </c:pt>
              </c:numCache>
            </c:numRef>
          </c:val>
        </c:ser>
        <c:dLbls>
          <c:showLegendKey val="0"/>
          <c:showVal val="0"/>
          <c:showCatName val="0"/>
          <c:showSerName val="0"/>
          <c:showPercent val="0"/>
          <c:showBubbleSize val="0"/>
        </c:dLbls>
        <c:gapWidth val="150"/>
        <c:overlap val="100"/>
        <c:axId val="-96769648"/>
        <c:axId val="-96772912"/>
      </c:barChart>
      <c:catAx>
        <c:axId val="-967696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96772912"/>
        <c:crosses val="autoZero"/>
        <c:auto val="1"/>
        <c:lblAlgn val="ctr"/>
        <c:lblOffset val="100"/>
        <c:noMultiLvlLbl val="0"/>
      </c:catAx>
      <c:valAx>
        <c:axId val="-96772912"/>
        <c:scaling>
          <c:orientation val="minMax"/>
        </c:scaling>
        <c:delete val="0"/>
        <c:axPos val="l"/>
        <c:numFmt formatCode="0%" sourceLinked="1"/>
        <c:majorTickMark val="none"/>
        <c:minorTickMark val="none"/>
        <c:tickLblPos val="nextTo"/>
        <c:spPr>
          <a:noFill/>
          <a:ln>
            <a:solidFill>
              <a:schemeClr val="tx1"/>
            </a:solidFill>
          </a:ln>
          <a:effectLst/>
        </c:spPr>
        <c:txPr>
          <a:bodyPr rot="-60000000" vert="horz"/>
          <a:lstStyle/>
          <a:p>
            <a:pPr>
              <a:defRPr/>
            </a:pPr>
            <a:endParaRPr lang="en-US"/>
          </a:p>
        </c:txPr>
        <c:crossAx val="-96769648"/>
        <c:crosses val="autoZero"/>
        <c:crossBetween val="between"/>
      </c:valAx>
      <c:spPr>
        <a:noFill/>
        <a:ln>
          <a:noFill/>
        </a:ln>
        <a:effectLst/>
      </c:spPr>
    </c:plotArea>
    <c:legend>
      <c:legendPos val="b"/>
      <c:overlay val="0"/>
      <c:spPr>
        <a:noFill/>
        <a:ln>
          <a:noFill/>
        </a:ln>
        <a:effectLst/>
      </c:spPr>
      <c:txPr>
        <a:bodyPr rot="0" vert="horz"/>
        <a:lstStyle/>
        <a:p>
          <a:pPr>
            <a:defRPr/>
          </a:pPr>
          <a:endParaRPr lang="en-US"/>
        </a:p>
      </c:txPr>
    </c:legend>
    <c:plotVisOnly val="1"/>
    <c:dispBlanksAs val="gap"/>
    <c:showDLblsOverMax val="0"/>
  </c:chart>
  <c:spPr>
    <a:solidFill>
      <a:schemeClr val="bg1"/>
    </a:solidFill>
    <a:ln w="9525" cap="flat" cmpd="sng" algn="ctr">
      <a:noFill/>
      <a:round/>
    </a:ln>
    <a:effectLst/>
  </c:spPr>
  <c:txPr>
    <a:bodyPr/>
    <a:lstStyle/>
    <a:p>
      <a:pPr>
        <a:defRPr sz="800" b="1">
          <a:latin typeface="Arial" pitchFamily="34" charset="0"/>
          <a:cs typeface="Arial" pitchFamily="34" charset="0"/>
        </a:defRPr>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00002'!$B$2</c:f>
              <c:strCache>
                <c:ptCount val="1"/>
                <c:pt idx="0">
                  <c:v>5</c:v>
                </c:pt>
              </c:strCache>
            </c:strRef>
          </c:tx>
          <c:spPr>
            <a:solidFill>
              <a:schemeClr val="accent1"/>
            </a:solidFill>
            <a:ln>
              <a:noFill/>
            </a:ln>
            <a:effectLst/>
          </c:spPr>
          <c:invertIfNegative val="0"/>
          <c:cat>
            <c:strRef>
              <c:f>'.00002'!$A$3:$A$7</c:f>
              <c:strCache>
                <c:ptCount val="5"/>
                <c:pt idx="0">
                  <c:v>100% FC</c:v>
                </c:pt>
                <c:pt idx="1">
                  <c:v>80%FC</c:v>
                </c:pt>
                <c:pt idx="2">
                  <c:v>60%FC</c:v>
                </c:pt>
                <c:pt idx="3">
                  <c:v>40%FC</c:v>
                </c:pt>
                <c:pt idx="4">
                  <c:v>20%FC</c:v>
                </c:pt>
              </c:strCache>
            </c:strRef>
          </c:cat>
          <c:val>
            <c:numRef>
              <c:f>'.00002'!$B$3:$B$7</c:f>
              <c:numCache>
                <c:formatCode>General</c:formatCode>
                <c:ptCount val="5"/>
                <c:pt idx="0">
                  <c:v>0</c:v>
                </c:pt>
                <c:pt idx="1">
                  <c:v>0</c:v>
                </c:pt>
                <c:pt idx="2">
                  <c:v>0</c:v>
                </c:pt>
                <c:pt idx="3">
                  <c:v>0</c:v>
                </c:pt>
                <c:pt idx="4">
                  <c:v>0</c:v>
                </c:pt>
              </c:numCache>
            </c:numRef>
          </c:val>
        </c:ser>
        <c:ser>
          <c:idx val="1"/>
          <c:order val="1"/>
          <c:tx>
            <c:strRef>
              <c:f>'.00002'!$C$2</c:f>
              <c:strCache>
                <c:ptCount val="1"/>
                <c:pt idx="0">
                  <c:v>4</c:v>
                </c:pt>
              </c:strCache>
            </c:strRef>
          </c:tx>
          <c:spPr>
            <a:solidFill>
              <a:schemeClr val="accent2"/>
            </a:solidFill>
            <a:ln>
              <a:noFill/>
            </a:ln>
            <a:effectLst/>
          </c:spPr>
          <c:invertIfNegative val="0"/>
          <c:cat>
            <c:strRef>
              <c:f>'.00002'!$A$3:$A$7</c:f>
              <c:strCache>
                <c:ptCount val="5"/>
                <c:pt idx="0">
                  <c:v>100% FC</c:v>
                </c:pt>
                <c:pt idx="1">
                  <c:v>80%FC</c:v>
                </c:pt>
                <c:pt idx="2">
                  <c:v>60%FC</c:v>
                </c:pt>
                <c:pt idx="3">
                  <c:v>40%FC</c:v>
                </c:pt>
                <c:pt idx="4">
                  <c:v>20%FC</c:v>
                </c:pt>
              </c:strCache>
            </c:strRef>
          </c:cat>
          <c:val>
            <c:numRef>
              <c:f>'.00002'!$C$3:$C$7</c:f>
              <c:numCache>
                <c:formatCode>General</c:formatCode>
                <c:ptCount val="5"/>
                <c:pt idx="0">
                  <c:v>0</c:v>
                </c:pt>
                <c:pt idx="1">
                  <c:v>0</c:v>
                </c:pt>
                <c:pt idx="2">
                  <c:v>0</c:v>
                </c:pt>
                <c:pt idx="3">
                  <c:v>0</c:v>
                </c:pt>
                <c:pt idx="4">
                  <c:v>0</c:v>
                </c:pt>
              </c:numCache>
            </c:numRef>
          </c:val>
        </c:ser>
        <c:ser>
          <c:idx val="2"/>
          <c:order val="2"/>
          <c:tx>
            <c:strRef>
              <c:f>'.00002'!$D$2</c:f>
              <c:strCache>
                <c:ptCount val="1"/>
                <c:pt idx="0">
                  <c:v>3</c:v>
                </c:pt>
              </c:strCache>
            </c:strRef>
          </c:tx>
          <c:spPr>
            <a:solidFill>
              <a:schemeClr val="accent3"/>
            </a:solidFill>
            <a:ln>
              <a:noFill/>
            </a:ln>
            <a:effectLst/>
          </c:spPr>
          <c:invertIfNegative val="0"/>
          <c:cat>
            <c:strRef>
              <c:f>'.00002'!$A$3:$A$7</c:f>
              <c:strCache>
                <c:ptCount val="5"/>
                <c:pt idx="0">
                  <c:v>100% FC</c:v>
                </c:pt>
                <c:pt idx="1">
                  <c:v>80%FC</c:v>
                </c:pt>
                <c:pt idx="2">
                  <c:v>60%FC</c:v>
                </c:pt>
                <c:pt idx="3">
                  <c:v>40%FC</c:v>
                </c:pt>
                <c:pt idx="4">
                  <c:v>20%FC</c:v>
                </c:pt>
              </c:strCache>
            </c:strRef>
          </c:cat>
          <c:val>
            <c:numRef>
              <c:f>'.00002'!$D$3:$D$7</c:f>
              <c:numCache>
                <c:formatCode>General</c:formatCode>
                <c:ptCount val="5"/>
                <c:pt idx="0">
                  <c:v>9.0909090909091006</c:v>
                </c:pt>
                <c:pt idx="1">
                  <c:v>0</c:v>
                </c:pt>
                <c:pt idx="2">
                  <c:v>20</c:v>
                </c:pt>
                <c:pt idx="3">
                  <c:v>0</c:v>
                </c:pt>
                <c:pt idx="4">
                  <c:v>16.666666666666668</c:v>
                </c:pt>
              </c:numCache>
            </c:numRef>
          </c:val>
        </c:ser>
        <c:ser>
          <c:idx val="3"/>
          <c:order val="3"/>
          <c:tx>
            <c:strRef>
              <c:f>'.00002'!$E$2</c:f>
              <c:strCache>
                <c:ptCount val="1"/>
                <c:pt idx="0">
                  <c:v>2</c:v>
                </c:pt>
              </c:strCache>
            </c:strRef>
          </c:tx>
          <c:spPr>
            <a:solidFill>
              <a:schemeClr val="accent4"/>
            </a:solidFill>
            <a:ln>
              <a:noFill/>
            </a:ln>
            <a:effectLst/>
          </c:spPr>
          <c:invertIfNegative val="0"/>
          <c:cat>
            <c:strRef>
              <c:f>'.00002'!$A$3:$A$7</c:f>
              <c:strCache>
                <c:ptCount val="5"/>
                <c:pt idx="0">
                  <c:v>100% FC</c:v>
                </c:pt>
                <c:pt idx="1">
                  <c:v>80%FC</c:v>
                </c:pt>
                <c:pt idx="2">
                  <c:v>60%FC</c:v>
                </c:pt>
                <c:pt idx="3">
                  <c:v>40%FC</c:v>
                </c:pt>
                <c:pt idx="4">
                  <c:v>20%FC</c:v>
                </c:pt>
              </c:strCache>
            </c:strRef>
          </c:cat>
          <c:val>
            <c:numRef>
              <c:f>'.00002'!$E$3:$E$7</c:f>
              <c:numCache>
                <c:formatCode>General</c:formatCode>
                <c:ptCount val="5"/>
                <c:pt idx="0">
                  <c:v>27.272727272727181</c:v>
                </c:pt>
                <c:pt idx="1">
                  <c:v>50</c:v>
                </c:pt>
                <c:pt idx="2">
                  <c:v>10</c:v>
                </c:pt>
                <c:pt idx="3">
                  <c:v>22.222222222222175</c:v>
                </c:pt>
                <c:pt idx="4">
                  <c:v>0</c:v>
                </c:pt>
              </c:numCache>
            </c:numRef>
          </c:val>
        </c:ser>
        <c:ser>
          <c:idx val="4"/>
          <c:order val="4"/>
          <c:tx>
            <c:strRef>
              <c:f>'.00002'!$F$2</c:f>
              <c:strCache>
                <c:ptCount val="1"/>
                <c:pt idx="0">
                  <c:v>1</c:v>
                </c:pt>
              </c:strCache>
            </c:strRef>
          </c:tx>
          <c:spPr>
            <a:solidFill>
              <a:schemeClr val="accent5"/>
            </a:solidFill>
            <a:ln>
              <a:noFill/>
            </a:ln>
            <a:effectLst/>
          </c:spPr>
          <c:invertIfNegative val="0"/>
          <c:cat>
            <c:strRef>
              <c:f>'.00002'!$A$3:$A$7</c:f>
              <c:strCache>
                <c:ptCount val="5"/>
                <c:pt idx="0">
                  <c:v>100% FC</c:v>
                </c:pt>
                <c:pt idx="1">
                  <c:v>80%FC</c:v>
                </c:pt>
                <c:pt idx="2">
                  <c:v>60%FC</c:v>
                </c:pt>
                <c:pt idx="3">
                  <c:v>40%FC</c:v>
                </c:pt>
                <c:pt idx="4">
                  <c:v>20%FC</c:v>
                </c:pt>
              </c:strCache>
            </c:strRef>
          </c:cat>
          <c:val>
            <c:numRef>
              <c:f>'.00002'!$F$3:$F$7</c:f>
              <c:numCache>
                <c:formatCode>General</c:formatCode>
                <c:ptCount val="5"/>
                <c:pt idx="0">
                  <c:v>0</c:v>
                </c:pt>
                <c:pt idx="1">
                  <c:v>12.5</c:v>
                </c:pt>
                <c:pt idx="2">
                  <c:v>0</c:v>
                </c:pt>
                <c:pt idx="3">
                  <c:v>0</c:v>
                </c:pt>
                <c:pt idx="4">
                  <c:v>0</c:v>
                </c:pt>
              </c:numCache>
            </c:numRef>
          </c:val>
        </c:ser>
        <c:ser>
          <c:idx val="5"/>
          <c:order val="5"/>
          <c:tx>
            <c:strRef>
              <c:f>'.00002'!$G$2</c:f>
              <c:strCache>
                <c:ptCount val="1"/>
                <c:pt idx="0">
                  <c:v>0</c:v>
                </c:pt>
              </c:strCache>
            </c:strRef>
          </c:tx>
          <c:spPr>
            <a:solidFill>
              <a:schemeClr val="accent6"/>
            </a:solidFill>
            <a:ln>
              <a:noFill/>
            </a:ln>
            <a:effectLst/>
          </c:spPr>
          <c:invertIfNegative val="0"/>
          <c:cat>
            <c:strRef>
              <c:f>'.00002'!$A$3:$A$7</c:f>
              <c:strCache>
                <c:ptCount val="5"/>
                <c:pt idx="0">
                  <c:v>100% FC</c:v>
                </c:pt>
                <c:pt idx="1">
                  <c:v>80%FC</c:v>
                </c:pt>
                <c:pt idx="2">
                  <c:v>60%FC</c:v>
                </c:pt>
                <c:pt idx="3">
                  <c:v>40%FC</c:v>
                </c:pt>
                <c:pt idx="4">
                  <c:v>20%FC</c:v>
                </c:pt>
              </c:strCache>
            </c:strRef>
          </c:cat>
          <c:val>
            <c:numRef>
              <c:f>'.00002'!$G$3:$G$7</c:f>
              <c:numCache>
                <c:formatCode>General</c:formatCode>
                <c:ptCount val="5"/>
                <c:pt idx="0">
                  <c:v>63.636363636363626</c:v>
                </c:pt>
                <c:pt idx="1">
                  <c:v>37.5</c:v>
                </c:pt>
                <c:pt idx="2">
                  <c:v>70</c:v>
                </c:pt>
                <c:pt idx="3">
                  <c:v>77.777777777777658</c:v>
                </c:pt>
                <c:pt idx="4">
                  <c:v>83.333333333333258</c:v>
                </c:pt>
              </c:numCache>
            </c:numRef>
          </c:val>
        </c:ser>
        <c:dLbls>
          <c:showLegendKey val="0"/>
          <c:showVal val="0"/>
          <c:showCatName val="0"/>
          <c:showSerName val="0"/>
          <c:showPercent val="0"/>
          <c:showBubbleSize val="0"/>
        </c:dLbls>
        <c:gapWidth val="150"/>
        <c:overlap val="100"/>
        <c:axId val="-96771824"/>
        <c:axId val="-96771280"/>
      </c:barChart>
      <c:catAx>
        <c:axId val="-9677182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96771280"/>
        <c:crosses val="autoZero"/>
        <c:auto val="1"/>
        <c:lblAlgn val="ctr"/>
        <c:lblOffset val="100"/>
        <c:noMultiLvlLbl val="0"/>
      </c:catAx>
      <c:valAx>
        <c:axId val="-96771280"/>
        <c:scaling>
          <c:orientation val="minMax"/>
          <c:max val="1"/>
          <c:min val="0"/>
        </c:scaling>
        <c:delete val="0"/>
        <c:axPos val="l"/>
        <c:numFmt formatCode="0%" sourceLinked="1"/>
        <c:majorTickMark val="none"/>
        <c:minorTickMark val="none"/>
        <c:tickLblPos val="nextTo"/>
        <c:spPr>
          <a:noFill/>
          <a:ln>
            <a:solidFill>
              <a:schemeClr val="tx1"/>
            </a:solidFill>
          </a:ln>
          <a:effectLst/>
        </c:spPr>
        <c:txPr>
          <a:bodyPr rot="-60000000" vert="horz"/>
          <a:lstStyle/>
          <a:p>
            <a:pPr>
              <a:defRPr/>
            </a:pPr>
            <a:endParaRPr lang="en-US"/>
          </a:p>
        </c:txPr>
        <c:crossAx val="-96771824"/>
        <c:crosses val="autoZero"/>
        <c:crossBetween val="between"/>
        <c:majorUnit val="0.2"/>
        <c:minorUnit val="2.0000000000000011E-2"/>
      </c:valAx>
      <c:spPr>
        <a:noFill/>
        <a:ln>
          <a:noFill/>
        </a:ln>
        <a:effectLst/>
      </c:spPr>
    </c:plotArea>
    <c:legend>
      <c:legendPos val="b"/>
      <c:overlay val="0"/>
      <c:spPr>
        <a:noFill/>
        <a:ln>
          <a:noFill/>
        </a:ln>
        <a:effectLst/>
      </c:spPr>
      <c:txPr>
        <a:bodyPr rot="0" vert="horz"/>
        <a:lstStyle/>
        <a:p>
          <a:pPr>
            <a:defRPr/>
          </a:pPr>
          <a:endParaRPr lang="en-US"/>
        </a:p>
      </c:txPr>
    </c:legend>
    <c:plotVisOnly val="1"/>
    <c:dispBlanksAs val="gap"/>
    <c:showDLblsOverMax val="0"/>
  </c:chart>
  <c:spPr>
    <a:solidFill>
      <a:schemeClr val="bg1"/>
    </a:solidFill>
    <a:ln w="9525" cap="flat" cmpd="sng" algn="ctr">
      <a:noFill/>
      <a:round/>
    </a:ln>
    <a:effectLst/>
  </c:spPr>
  <c:txPr>
    <a:bodyPr/>
    <a:lstStyle/>
    <a:p>
      <a:pPr>
        <a:defRPr sz="800" b="1">
          <a:latin typeface="Arial" pitchFamily="34" charset="0"/>
          <a:cs typeface="Arial" pitchFamily="34" charset="0"/>
        </a:defRPr>
      </a:pPr>
      <a:endParaRPr lang="en-US"/>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8.4969851741505287E-2"/>
          <c:y val="0.12071422890320545"/>
          <c:w val="0.89495734908136393"/>
          <c:h val="0.71741708422810779"/>
        </c:manualLayout>
      </c:layout>
      <c:barChart>
        <c:barDir val="col"/>
        <c:grouping val="clustered"/>
        <c:varyColors val="0"/>
        <c:ser>
          <c:idx val="0"/>
          <c:order val="0"/>
          <c:tx>
            <c:strRef>
              <c:f>Sheet1!$D$11</c:f>
              <c:strCache>
                <c:ptCount val="1"/>
                <c:pt idx="0">
                  <c:v>WT</c:v>
                </c:pt>
              </c:strCache>
            </c:strRef>
          </c:tx>
          <c:invertIfNegative val="0"/>
          <c:errBars>
            <c:errBarType val="both"/>
            <c:errValType val="cust"/>
            <c:noEndCap val="0"/>
            <c:plus>
              <c:numRef>
                <c:f>Sheet1!$G$11:$H$11</c:f>
                <c:numCache>
                  <c:formatCode>General</c:formatCode>
                  <c:ptCount val="2"/>
                  <c:pt idx="0">
                    <c:v>3.6825114064991081E-2</c:v>
                  </c:pt>
                  <c:pt idx="1">
                    <c:v>0.15825310191858738</c:v>
                  </c:pt>
                </c:numCache>
              </c:numRef>
            </c:plus>
            <c:minus>
              <c:numRef>
                <c:f>Sheet1!$G$11:$H$11</c:f>
                <c:numCache>
                  <c:formatCode>General</c:formatCode>
                  <c:ptCount val="2"/>
                  <c:pt idx="0">
                    <c:v>3.6825114064991081E-2</c:v>
                  </c:pt>
                  <c:pt idx="1">
                    <c:v>0.15825310191858738</c:v>
                  </c:pt>
                </c:numCache>
              </c:numRef>
            </c:minus>
          </c:errBars>
          <c:cat>
            <c:strRef>
              <c:f>Sheet1!$E$10:$F$10</c:f>
              <c:strCache>
                <c:ptCount val="2"/>
                <c:pt idx="0">
                  <c:v>P</c:v>
                </c:pt>
                <c:pt idx="1">
                  <c:v>DP</c:v>
                </c:pt>
              </c:strCache>
            </c:strRef>
          </c:cat>
          <c:val>
            <c:numRef>
              <c:f>Sheet1!$E$11:$F$11</c:f>
              <c:numCache>
                <c:formatCode>General</c:formatCode>
                <c:ptCount val="2"/>
                <c:pt idx="0">
                  <c:v>6.7838316868381314</c:v>
                </c:pt>
                <c:pt idx="1">
                  <c:v>5.78828843150289</c:v>
                </c:pt>
              </c:numCache>
            </c:numRef>
          </c:val>
        </c:ser>
        <c:ser>
          <c:idx val="1"/>
          <c:order val="1"/>
          <c:tx>
            <c:strRef>
              <c:f>Sheet1!$D$12</c:f>
              <c:strCache>
                <c:ptCount val="1"/>
                <c:pt idx="0">
                  <c:v>atnac6</c:v>
                </c:pt>
              </c:strCache>
            </c:strRef>
          </c:tx>
          <c:invertIfNegative val="0"/>
          <c:errBars>
            <c:errBarType val="both"/>
            <c:errValType val="cust"/>
            <c:noEndCap val="0"/>
            <c:plus>
              <c:numRef>
                <c:f>Sheet1!$G$12:$H$12</c:f>
                <c:numCache>
                  <c:formatCode>General</c:formatCode>
                  <c:ptCount val="2"/>
                  <c:pt idx="0">
                    <c:v>0.42542206021361201</c:v>
                  </c:pt>
                  <c:pt idx="1">
                    <c:v>7.6890156892308423E-2</c:v>
                  </c:pt>
                </c:numCache>
              </c:numRef>
            </c:plus>
            <c:minus>
              <c:numRef>
                <c:f>Sheet1!$G$12:$H$12</c:f>
                <c:numCache>
                  <c:formatCode>General</c:formatCode>
                  <c:ptCount val="2"/>
                  <c:pt idx="0">
                    <c:v>0.42542206021361201</c:v>
                  </c:pt>
                  <c:pt idx="1">
                    <c:v>7.6890156892308423E-2</c:v>
                  </c:pt>
                </c:numCache>
              </c:numRef>
            </c:minus>
          </c:errBars>
          <c:cat>
            <c:strRef>
              <c:f>Sheet1!$E$10:$F$10</c:f>
              <c:strCache>
                <c:ptCount val="2"/>
                <c:pt idx="0">
                  <c:v>P</c:v>
                </c:pt>
                <c:pt idx="1">
                  <c:v>DP</c:v>
                </c:pt>
              </c:strCache>
            </c:strRef>
          </c:cat>
          <c:val>
            <c:numRef>
              <c:f>Sheet1!$E$12:$F$12</c:f>
              <c:numCache>
                <c:formatCode>General</c:formatCode>
                <c:ptCount val="2"/>
                <c:pt idx="0">
                  <c:v>7.1151062208368439</c:v>
                </c:pt>
                <c:pt idx="1">
                  <c:v>7.84036130532533</c:v>
                </c:pt>
              </c:numCache>
            </c:numRef>
          </c:val>
        </c:ser>
        <c:dLbls>
          <c:showLegendKey val="0"/>
          <c:showVal val="0"/>
          <c:showCatName val="0"/>
          <c:showSerName val="0"/>
          <c:showPercent val="0"/>
          <c:showBubbleSize val="0"/>
        </c:dLbls>
        <c:gapWidth val="150"/>
        <c:axId val="-96769104"/>
        <c:axId val="-96776176"/>
      </c:barChart>
      <c:catAx>
        <c:axId val="-96769104"/>
        <c:scaling>
          <c:orientation val="minMax"/>
        </c:scaling>
        <c:delete val="0"/>
        <c:axPos val="b"/>
        <c:numFmt formatCode="General" sourceLinked="0"/>
        <c:majorTickMark val="out"/>
        <c:minorTickMark val="none"/>
        <c:tickLblPos val="nextTo"/>
        <c:crossAx val="-96776176"/>
        <c:crosses val="autoZero"/>
        <c:auto val="1"/>
        <c:lblAlgn val="ctr"/>
        <c:lblOffset val="100"/>
        <c:noMultiLvlLbl val="0"/>
      </c:catAx>
      <c:valAx>
        <c:axId val="-96776176"/>
        <c:scaling>
          <c:orientation val="minMax"/>
        </c:scaling>
        <c:delete val="0"/>
        <c:axPos val="l"/>
        <c:numFmt formatCode="General" sourceLinked="1"/>
        <c:majorTickMark val="out"/>
        <c:minorTickMark val="none"/>
        <c:tickLblPos val="nextTo"/>
        <c:crossAx val="-96769104"/>
        <c:crosses val="autoZero"/>
        <c:crossBetween val="between"/>
      </c:valAx>
    </c:plotArea>
    <c:legend>
      <c:legendPos val="r"/>
      <c:legendEntry>
        <c:idx val="1"/>
        <c:txPr>
          <a:bodyPr/>
          <a:lstStyle/>
          <a:p>
            <a:pPr>
              <a:defRPr i="1"/>
            </a:pPr>
            <a:endParaRPr lang="en-US"/>
          </a:p>
        </c:txPr>
      </c:legendEntry>
      <c:layout>
        <c:manualLayout>
          <c:xMode val="edge"/>
          <c:yMode val="edge"/>
          <c:x val="8.4806867891513732E-2"/>
          <c:y val="4.245771361913106E-3"/>
          <c:w val="0.47156553960166742"/>
          <c:h val="0.16743438320210011"/>
        </c:manualLayout>
      </c:layout>
      <c:overlay val="0"/>
    </c:legend>
    <c:plotVisOnly val="1"/>
    <c:dispBlanksAs val="gap"/>
    <c:showDLblsOverMax val="0"/>
  </c:chart>
  <c:txPr>
    <a:bodyPr/>
    <a:lstStyle/>
    <a:p>
      <a:pPr>
        <a:defRPr sz="800" b="1">
          <a:latin typeface="Arial" pitchFamily="34" charset="0"/>
          <a:cs typeface="Arial" pitchFamily="34" charset="0"/>
        </a:defRPr>
      </a:pPr>
      <a:endParaRPr lang="en-US"/>
    </a:p>
  </c:txPr>
  <c:externalData r:id="rId1">
    <c:autoUpdate val="0"/>
  </c:externalData>
</c:chartSpace>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B9D30FEB-3F57-4ED3-8753-FB6080425ACD}" type="doc">
      <dgm:prSet loTypeId="urn:microsoft.com/office/officeart/2005/8/layout/venn1" loCatId="relationship" qsTypeId="urn:microsoft.com/office/officeart/2005/8/quickstyle/simple1" qsCatId="simple" csTypeId="urn:microsoft.com/office/officeart/2005/8/colors/colorful5" csCatId="colorful" phldr="1"/>
      <dgm:spPr/>
    </dgm:pt>
    <dgm:pt modelId="{521D8818-890F-4DFC-94C6-85F185D8D0C9}">
      <dgm:prSet phldrT="[Text]" custT="1"/>
      <dgm:spPr/>
      <dgm:t>
        <a:bodyPr/>
        <a:lstStyle/>
        <a:p>
          <a:endParaRPr lang="en-US" sz="1200" b="1" dirty="0"/>
        </a:p>
      </dgm:t>
    </dgm:pt>
    <dgm:pt modelId="{EFCF83BC-9F34-44F0-866C-78D921A7CB68}" type="parTrans" cxnId="{53802DD5-1F38-43A2-A85D-4F29B91FE70A}">
      <dgm:prSet/>
      <dgm:spPr/>
      <dgm:t>
        <a:bodyPr/>
        <a:lstStyle/>
        <a:p>
          <a:endParaRPr lang="en-US"/>
        </a:p>
      </dgm:t>
    </dgm:pt>
    <dgm:pt modelId="{6A2BC7C8-D8A8-47D6-8D1F-CA3F6E7AB00A}" type="sibTrans" cxnId="{53802DD5-1F38-43A2-A85D-4F29B91FE70A}">
      <dgm:prSet/>
      <dgm:spPr/>
      <dgm:t>
        <a:bodyPr/>
        <a:lstStyle/>
        <a:p>
          <a:endParaRPr lang="en-US"/>
        </a:p>
      </dgm:t>
    </dgm:pt>
    <dgm:pt modelId="{BFE04C32-5E92-46B8-8B76-359177C8AF8E}">
      <dgm:prSet phldrT="[Text]" custT="1"/>
      <dgm:spPr/>
      <dgm:t>
        <a:bodyPr/>
        <a:lstStyle/>
        <a:p>
          <a:endParaRPr lang="en-US" sz="1200" b="1" dirty="0"/>
        </a:p>
      </dgm:t>
    </dgm:pt>
    <dgm:pt modelId="{1AB88500-BCC4-4F8D-BF9F-C6B8292A6DE3}" type="parTrans" cxnId="{4E29CE2D-685A-4854-B4FF-CE18405AEDBB}">
      <dgm:prSet/>
      <dgm:spPr/>
      <dgm:t>
        <a:bodyPr/>
        <a:lstStyle/>
        <a:p>
          <a:endParaRPr lang="en-US"/>
        </a:p>
      </dgm:t>
    </dgm:pt>
    <dgm:pt modelId="{9911DFEC-146B-46F3-BF9B-906A142E484F}" type="sibTrans" cxnId="{4E29CE2D-685A-4854-B4FF-CE18405AEDBB}">
      <dgm:prSet/>
      <dgm:spPr/>
      <dgm:t>
        <a:bodyPr/>
        <a:lstStyle/>
        <a:p>
          <a:endParaRPr lang="en-US"/>
        </a:p>
      </dgm:t>
    </dgm:pt>
    <dgm:pt modelId="{C9FFA356-A1E3-43B6-88DA-9075EEE1D33F}" type="pres">
      <dgm:prSet presAssocID="{B9D30FEB-3F57-4ED3-8753-FB6080425ACD}" presName="compositeShape" presStyleCnt="0">
        <dgm:presLayoutVars>
          <dgm:chMax val="7"/>
          <dgm:dir/>
          <dgm:resizeHandles val="exact"/>
        </dgm:presLayoutVars>
      </dgm:prSet>
      <dgm:spPr/>
    </dgm:pt>
    <dgm:pt modelId="{3BAE6D2C-43B6-4C1F-B7D4-C7A1839ED867}" type="pres">
      <dgm:prSet presAssocID="{521D8818-890F-4DFC-94C6-85F185D8D0C9}" presName="circ1" presStyleLbl="vennNode1" presStyleIdx="0" presStyleCnt="2" custLinFactNeighborX="9427"/>
      <dgm:spPr/>
      <dgm:t>
        <a:bodyPr/>
        <a:lstStyle/>
        <a:p>
          <a:endParaRPr lang="en-US"/>
        </a:p>
      </dgm:t>
    </dgm:pt>
    <dgm:pt modelId="{DEC90B75-170A-4886-9FDD-5346D3943B70}" type="pres">
      <dgm:prSet presAssocID="{521D8818-890F-4DFC-94C6-85F185D8D0C9}" presName="circ1Tx" presStyleLbl="revTx" presStyleIdx="0" presStyleCnt="0">
        <dgm:presLayoutVars>
          <dgm:chMax val="0"/>
          <dgm:chPref val="0"/>
          <dgm:bulletEnabled val="1"/>
        </dgm:presLayoutVars>
      </dgm:prSet>
      <dgm:spPr/>
      <dgm:t>
        <a:bodyPr/>
        <a:lstStyle/>
        <a:p>
          <a:endParaRPr lang="en-US"/>
        </a:p>
      </dgm:t>
    </dgm:pt>
    <dgm:pt modelId="{C68BFE50-3A1F-4F8C-A8B8-A7B4C9C8D147}" type="pres">
      <dgm:prSet presAssocID="{BFE04C32-5E92-46B8-8B76-359177C8AF8E}" presName="circ2" presStyleLbl="vennNode1" presStyleIdx="1" presStyleCnt="2" custLinFactNeighborX="-14223" custLinFactNeighborY="273"/>
      <dgm:spPr/>
      <dgm:t>
        <a:bodyPr/>
        <a:lstStyle/>
        <a:p>
          <a:endParaRPr lang="en-US"/>
        </a:p>
      </dgm:t>
    </dgm:pt>
    <dgm:pt modelId="{34206E4C-035C-413E-B114-3EE02D9880F5}" type="pres">
      <dgm:prSet presAssocID="{BFE04C32-5E92-46B8-8B76-359177C8AF8E}" presName="circ2Tx" presStyleLbl="revTx" presStyleIdx="0" presStyleCnt="0">
        <dgm:presLayoutVars>
          <dgm:chMax val="0"/>
          <dgm:chPref val="0"/>
          <dgm:bulletEnabled val="1"/>
        </dgm:presLayoutVars>
      </dgm:prSet>
      <dgm:spPr/>
      <dgm:t>
        <a:bodyPr/>
        <a:lstStyle/>
        <a:p>
          <a:endParaRPr lang="en-US"/>
        </a:p>
      </dgm:t>
    </dgm:pt>
  </dgm:ptLst>
  <dgm:cxnLst>
    <dgm:cxn modelId="{4E29CE2D-685A-4854-B4FF-CE18405AEDBB}" srcId="{B9D30FEB-3F57-4ED3-8753-FB6080425ACD}" destId="{BFE04C32-5E92-46B8-8B76-359177C8AF8E}" srcOrd="1" destOrd="0" parTransId="{1AB88500-BCC4-4F8D-BF9F-C6B8292A6DE3}" sibTransId="{9911DFEC-146B-46F3-BF9B-906A142E484F}"/>
    <dgm:cxn modelId="{53802DD5-1F38-43A2-A85D-4F29B91FE70A}" srcId="{B9D30FEB-3F57-4ED3-8753-FB6080425ACD}" destId="{521D8818-890F-4DFC-94C6-85F185D8D0C9}" srcOrd="0" destOrd="0" parTransId="{EFCF83BC-9F34-44F0-866C-78D921A7CB68}" sibTransId="{6A2BC7C8-D8A8-47D6-8D1F-CA3F6E7AB00A}"/>
    <dgm:cxn modelId="{CEBFD8C4-5EFD-49C3-8294-31FB7DD6718D}" type="presOf" srcId="{BFE04C32-5E92-46B8-8B76-359177C8AF8E}" destId="{34206E4C-035C-413E-B114-3EE02D9880F5}" srcOrd="1" destOrd="0" presId="urn:microsoft.com/office/officeart/2005/8/layout/venn1"/>
    <dgm:cxn modelId="{187D4C21-95B6-47DD-BFDE-5985338A6E00}" type="presOf" srcId="{B9D30FEB-3F57-4ED3-8753-FB6080425ACD}" destId="{C9FFA356-A1E3-43B6-88DA-9075EEE1D33F}" srcOrd="0" destOrd="0" presId="urn:microsoft.com/office/officeart/2005/8/layout/venn1"/>
    <dgm:cxn modelId="{129BFDCA-8834-44E2-A86D-0A4F5894BD91}" type="presOf" srcId="{521D8818-890F-4DFC-94C6-85F185D8D0C9}" destId="{3BAE6D2C-43B6-4C1F-B7D4-C7A1839ED867}" srcOrd="0" destOrd="0" presId="urn:microsoft.com/office/officeart/2005/8/layout/venn1"/>
    <dgm:cxn modelId="{7FC895B3-3522-4C46-AF53-16DD16306D46}" type="presOf" srcId="{BFE04C32-5E92-46B8-8B76-359177C8AF8E}" destId="{C68BFE50-3A1F-4F8C-A8B8-A7B4C9C8D147}" srcOrd="0" destOrd="0" presId="urn:microsoft.com/office/officeart/2005/8/layout/venn1"/>
    <dgm:cxn modelId="{2230837C-C626-44D0-968D-5DAB8D6839E1}" type="presOf" srcId="{521D8818-890F-4DFC-94C6-85F185D8D0C9}" destId="{DEC90B75-170A-4886-9FDD-5346D3943B70}" srcOrd="1" destOrd="0" presId="urn:microsoft.com/office/officeart/2005/8/layout/venn1"/>
    <dgm:cxn modelId="{F79B21C9-0F02-4E2E-91DD-2DC6562D0BB1}" type="presParOf" srcId="{C9FFA356-A1E3-43B6-88DA-9075EEE1D33F}" destId="{3BAE6D2C-43B6-4C1F-B7D4-C7A1839ED867}" srcOrd="0" destOrd="0" presId="urn:microsoft.com/office/officeart/2005/8/layout/venn1"/>
    <dgm:cxn modelId="{D0161796-64CC-48D2-931C-DEAE1B44D592}" type="presParOf" srcId="{C9FFA356-A1E3-43B6-88DA-9075EEE1D33F}" destId="{DEC90B75-170A-4886-9FDD-5346D3943B70}" srcOrd="1" destOrd="0" presId="urn:microsoft.com/office/officeart/2005/8/layout/venn1"/>
    <dgm:cxn modelId="{A575CD93-43DC-4923-812E-5E424A835F75}" type="presParOf" srcId="{C9FFA356-A1E3-43B6-88DA-9075EEE1D33F}" destId="{C68BFE50-3A1F-4F8C-A8B8-A7B4C9C8D147}" srcOrd="2" destOrd="0" presId="urn:microsoft.com/office/officeart/2005/8/layout/venn1"/>
    <dgm:cxn modelId="{2CB52CC5-31F7-4893-A075-480B1089DA6D}" type="presParOf" srcId="{C9FFA356-A1E3-43B6-88DA-9075EEE1D33F}" destId="{34206E4C-035C-413E-B114-3EE02D9880F5}" srcOrd="3"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BAE6D2C-43B6-4C1F-B7D4-C7A1839ED867}">
      <dsp:nvSpPr>
        <dsp:cNvPr id="0" name=""/>
        <dsp:cNvSpPr/>
      </dsp:nvSpPr>
      <dsp:spPr>
        <a:xfrm>
          <a:off x="470422" y="4058"/>
          <a:ext cx="1484064" cy="1484064"/>
        </a:xfrm>
        <a:prstGeom prst="ellipse">
          <a:avLst/>
        </a:prstGeom>
        <a:solidFill>
          <a:schemeClr val="accent5">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US" sz="1200" b="1" kern="1200" dirty="0"/>
        </a:p>
      </dsp:txBody>
      <dsp:txXfrm>
        <a:off x="677656" y="179061"/>
        <a:ext cx="855676" cy="1134058"/>
      </dsp:txXfrm>
    </dsp:sp>
    <dsp:sp modelId="{C68BFE50-3A1F-4F8C-A8B8-A7B4C9C8D147}">
      <dsp:nvSpPr>
        <dsp:cNvPr id="0" name=""/>
        <dsp:cNvSpPr/>
      </dsp:nvSpPr>
      <dsp:spPr>
        <a:xfrm>
          <a:off x="1189037" y="8110"/>
          <a:ext cx="1484064" cy="1484064"/>
        </a:xfrm>
        <a:prstGeom prst="ellipse">
          <a:avLst/>
        </a:prstGeom>
        <a:solidFill>
          <a:schemeClr val="accent5">
            <a:alpha val="50000"/>
            <a:hueOff val="-9933876"/>
            <a:satOff val="39811"/>
            <a:lumOff val="862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US" sz="1200" b="1" kern="1200" dirty="0"/>
        </a:p>
      </dsp:txBody>
      <dsp:txXfrm>
        <a:off x="1610190" y="183113"/>
        <a:ext cx="855676" cy="1134058"/>
      </dsp:txXfrm>
    </dsp:sp>
  </dsp:spTree>
</dsp:drawing>
</file>

<file path=ppt/diagrams/layout1.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cs typeface="+mn-cs"/>
              </a:defRPr>
            </a:lvl1pPr>
          </a:lstStyle>
          <a:p>
            <a:pPr>
              <a:defRPr/>
            </a:pPr>
            <a:endParaRPr lang="en-IN"/>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a:latin typeface="+mn-lt"/>
                <a:cs typeface="+mn-cs"/>
              </a:defRPr>
            </a:lvl1pPr>
          </a:lstStyle>
          <a:p>
            <a:pPr>
              <a:defRPr/>
            </a:pPr>
            <a:fld id="{B3B6A019-82BA-40AB-80B6-86F5031F3745}" type="datetimeFigureOut">
              <a:rPr lang="en-US"/>
              <a:pPr>
                <a:defRPr/>
              </a:pPr>
              <a:t>5/19/2016</a:t>
            </a:fld>
            <a:endParaRPr lang="en-IN"/>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pPr lvl="0"/>
            <a:endParaRPr lang="en-IN" noProof="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IN" noProof="0"/>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cs typeface="+mn-cs"/>
              </a:defRPr>
            </a:lvl1pPr>
          </a:lstStyle>
          <a:p>
            <a:pPr>
              <a:defRPr/>
            </a:pPr>
            <a:endParaRPr lang="en-IN"/>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fontAlgn="auto">
              <a:spcBef>
                <a:spcPts val="0"/>
              </a:spcBef>
              <a:spcAft>
                <a:spcPts val="0"/>
              </a:spcAft>
              <a:defRPr sz="1200">
                <a:latin typeface="+mn-lt"/>
                <a:cs typeface="+mn-cs"/>
              </a:defRPr>
            </a:lvl1pPr>
          </a:lstStyle>
          <a:p>
            <a:pPr>
              <a:defRPr/>
            </a:pPr>
            <a:fld id="{DAFC6B17-3DDE-4BA0-BD97-F9FBE4BF02B9}" type="slidenum">
              <a:rPr lang="en-IN"/>
              <a:pPr>
                <a:defRPr/>
              </a:pPr>
              <a:t>‹#›</a:t>
            </a:fld>
            <a:endParaRPr lang="en-IN"/>
          </a:p>
        </p:txBody>
      </p:sp>
    </p:spTree>
    <p:extLst>
      <p:ext uri="{BB962C8B-B14F-4D97-AF65-F5344CB8AC3E}">
        <p14:creationId xmlns:p14="http://schemas.microsoft.com/office/powerpoint/2010/main" val="1490935236"/>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Slide Image Placeholder 1"/>
          <p:cNvSpPr>
            <a:spLocks noGrp="1" noRot="1" noChangeAspect="1" noTextEdit="1"/>
          </p:cNvSpPr>
          <p:nvPr>
            <p:ph type="sldImg"/>
          </p:nvPr>
        </p:nvSpPr>
        <p:spPr bwMode="auto">
          <a:noFill/>
          <a:ln>
            <a:solidFill>
              <a:srgbClr val="000000"/>
            </a:solidFill>
            <a:miter lim="800000"/>
            <a:headEnd/>
            <a:tailEnd/>
          </a:ln>
        </p:spPr>
      </p:sp>
      <p:sp>
        <p:nvSpPr>
          <p:cNvPr id="14339" name="Notes Placeholder 2"/>
          <p:cNvSpPr>
            <a:spLocks noGrp="1"/>
          </p:cNvSpPr>
          <p:nvPr>
            <p:ph type="body" idx="1"/>
          </p:nvPr>
        </p:nvSpPr>
        <p:spPr bwMode="auto">
          <a:noFill/>
        </p:spPr>
        <p:txBody>
          <a:bodyPr wrap="square" numCol="1" anchor="t" anchorCtr="0" compatLnSpc="1">
            <a:prstTxWarp prst="textNoShape">
              <a:avLst/>
            </a:prstTxWarp>
          </a:bodyPr>
          <a:lstStyle/>
          <a:p>
            <a:pPr eaLnBrk="1" hangingPunct="1">
              <a:spcBef>
                <a:spcPct val="0"/>
              </a:spcBef>
            </a:pPr>
            <a:endParaRPr lang="en-IN" smtClean="0"/>
          </a:p>
        </p:txBody>
      </p:sp>
      <p:sp>
        <p:nvSpPr>
          <p:cNvPr id="9220" name="Slide Number Placeholder 3"/>
          <p:cNvSpPr>
            <a:spLocks noGrp="1"/>
          </p:cNvSpPr>
          <p:nvPr>
            <p:ph type="sldNum" sz="quarter" idx="5"/>
          </p:nvPr>
        </p:nvSpPr>
        <p:spPr bwMode="auto">
          <a:ln>
            <a:miter lim="800000"/>
            <a:headEnd/>
            <a:tailEnd/>
          </a:ln>
        </p:spPr>
        <p:txBody>
          <a:bodyPr/>
          <a:lstStyle/>
          <a:p>
            <a:pPr>
              <a:defRPr/>
            </a:pPr>
            <a:fld id="{3120D726-9B40-417D-BDCC-98332DF333D8}" type="slidenum">
              <a:rPr lang="en-IN" smtClean="0"/>
              <a:pPr>
                <a:defRPr/>
              </a:pPr>
              <a:t>5</a:t>
            </a:fld>
            <a:endParaRPr lang="en-IN" smtClean="0"/>
          </a:p>
        </p:txBody>
      </p:sp>
    </p:spTree>
    <p:extLst>
      <p:ext uri="{BB962C8B-B14F-4D97-AF65-F5344CB8AC3E}">
        <p14:creationId xmlns:p14="http://schemas.microsoft.com/office/powerpoint/2010/main" val="25568348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Slide Image Placeholder 1"/>
          <p:cNvSpPr>
            <a:spLocks noGrp="1" noRot="1" noChangeAspect="1" noTextEdit="1"/>
          </p:cNvSpPr>
          <p:nvPr>
            <p:ph type="sldImg"/>
          </p:nvPr>
        </p:nvSpPr>
        <p:spPr bwMode="auto">
          <a:noFill/>
          <a:ln>
            <a:solidFill>
              <a:srgbClr val="000000"/>
            </a:solidFill>
            <a:miter lim="800000"/>
            <a:headEnd/>
            <a:tailEnd/>
          </a:ln>
        </p:spPr>
      </p:sp>
      <p:sp>
        <p:nvSpPr>
          <p:cNvPr id="15363" name="Notes Placeholder 2"/>
          <p:cNvSpPr>
            <a:spLocks noGrp="1"/>
          </p:cNvSpPr>
          <p:nvPr>
            <p:ph type="body" idx="1"/>
          </p:nvPr>
        </p:nvSpPr>
        <p:spPr bwMode="auto">
          <a:noFill/>
        </p:spPr>
        <p:txBody>
          <a:bodyPr wrap="square" numCol="1" anchor="t" anchorCtr="0" compatLnSpc="1">
            <a:prstTxWarp prst="textNoShape">
              <a:avLst/>
            </a:prstTxWarp>
          </a:bodyPr>
          <a:lstStyle/>
          <a:p>
            <a:endParaRPr lang="en-US" smtClean="0"/>
          </a:p>
        </p:txBody>
      </p:sp>
      <p:sp>
        <p:nvSpPr>
          <p:cNvPr id="4" name="Slide Number Placeholder 3"/>
          <p:cNvSpPr>
            <a:spLocks noGrp="1"/>
          </p:cNvSpPr>
          <p:nvPr>
            <p:ph type="sldNum" sz="quarter" idx="5"/>
          </p:nvPr>
        </p:nvSpPr>
        <p:spPr/>
        <p:txBody>
          <a:bodyPr/>
          <a:lstStyle/>
          <a:p>
            <a:pPr>
              <a:defRPr/>
            </a:pPr>
            <a:fld id="{D50CB767-9854-4C03-8CB5-76B9B81A7DA9}" type="slidenum">
              <a:rPr lang="en-IN" smtClean="0"/>
              <a:pPr>
                <a:defRPr/>
              </a:pPr>
              <a:t>7</a:t>
            </a:fld>
            <a:endParaRPr lang="en-IN"/>
          </a:p>
        </p:txBody>
      </p:sp>
    </p:spTree>
    <p:extLst>
      <p:ext uri="{BB962C8B-B14F-4D97-AF65-F5344CB8AC3E}">
        <p14:creationId xmlns:p14="http://schemas.microsoft.com/office/powerpoint/2010/main" val="196063062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Slide Image Placeholder 1"/>
          <p:cNvSpPr>
            <a:spLocks noGrp="1" noRot="1" noChangeAspect="1" noTextEdit="1"/>
          </p:cNvSpPr>
          <p:nvPr>
            <p:ph type="sldImg"/>
          </p:nvPr>
        </p:nvSpPr>
        <p:spPr bwMode="auto">
          <a:noFill/>
          <a:ln>
            <a:solidFill>
              <a:srgbClr val="000000"/>
            </a:solidFill>
            <a:miter lim="800000"/>
            <a:headEnd/>
            <a:tailEnd/>
          </a:ln>
        </p:spPr>
      </p:sp>
      <p:sp>
        <p:nvSpPr>
          <p:cNvPr id="16387" name="Notes Placeholder 2"/>
          <p:cNvSpPr>
            <a:spLocks noGrp="1"/>
          </p:cNvSpPr>
          <p:nvPr>
            <p:ph type="body" idx="1"/>
          </p:nvPr>
        </p:nvSpPr>
        <p:spPr bwMode="auto">
          <a:noFill/>
        </p:spPr>
        <p:txBody>
          <a:bodyPr wrap="square" numCol="1" anchor="t" anchorCtr="0" compatLnSpc="1">
            <a:prstTxWarp prst="textNoShape">
              <a:avLst/>
            </a:prstTxWarp>
          </a:bodyPr>
          <a:lstStyle/>
          <a:p>
            <a:endParaRPr lang="en-IN" smtClean="0"/>
          </a:p>
        </p:txBody>
      </p:sp>
      <p:sp>
        <p:nvSpPr>
          <p:cNvPr id="4" name="Slide Number Placeholder 3"/>
          <p:cNvSpPr>
            <a:spLocks noGrp="1"/>
          </p:cNvSpPr>
          <p:nvPr>
            <p:ph type="sldNum" sz="quarter" idx="5"/>
          </p:nvPr>
        </p:nvSpPr>
        <p:spPr/>
        <p:txBody>
          <a:bodyPr/>
          <a:lstStyle/>
          <a:p>
            <a:pPr>
              <a:defRPr/>
            </a:pPr>
            <a:fld id="{D44F22C8-6967-4106-8468-BD2011AF88D3}" type="slidenum">
              <a:rPr lang="en-IN" smtClean="0"/>
              <a:pPr>
                <a:defRPr/>
              </a:pPr>
              <a:t>8</a:t>
            </a:fld>
            <a:endParaRPr lang="en-IN"/>
          </a:p>
        </p:txBody>
      </p:sp>
    </p:spTree>
    <p:extLst>
      <p:ext uri="{BB962C8B-B14F-4D97-AF65-F5344CB8AC3E}">
        <p14:creationId xmlns:p14="http://schemas.microsoft.com/office/powerpoint/2010/main" val="268132366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Slide Image Placeholder 1"/>
          <p:cNvSpPr>
            <a:spLocks noGrp="1" noRot="1" noChangeAspect="1" noTextEdit="1"/>
          </p:cNvSpPr>
          <p:nvPr>
            <p:ph type="sldImg"/>
          </p:nvPr>
        </p:nvSpPr>
        <p:spPr bwMode="auto">
          <a:noFill/>
          <a:ln>
            <a:solidFill>
              <a:srgbClr val="000000"/>
            </a:solidFill>
            <a:miter lim="800000"/>
            <a:headEnd/>
            <a:tailEnd/>
          </a:ln>
        </p:spPr>
      </p:sp>
      <p:sp>
        <p:nvSpPr>
          <p:cNvPr id="17411" name="Notes Placeholder 2"/>
          <p:cNvSpPr>
            <a:spLocks noGrp="1"/>
          </p:cNvSpPr>
          <p:nvPr>
            <p:ph type="body" idx="1"/>
          </p:nvPr>
        </p:nvSpPr>
        <p:spPr bwMode="auto">
          <a:noFill/>
        </p:spPr>
        <p:txBody>
          <a:bodyPr wrap="square" numCol="1" anchor="t" anchorCtr="0" compatLnSpc="1">
            <a:prstTxWarp prst="textNoShape">
              <a:avLst/>
            </a:prstTxWarp>
          </a:bodyPr>
          <a:lstStyle/>
          <a:p>
            <a:endParaRPr lang="en-IN" smtClean="0"/>
          </a:p>
        </p:txBody>
      </p:sp>
      <p:sp>
        <p:nvSpPr>
          <p:cNvPr id="9220" name="Slide Number Placeholder 3"/>
          <p:cNvSpPr>
            <a:spLocks noGrp="1"/>
          </p:cNvSpPr>
          <p:nvPr>
            <p:ph type="sldNum" sz="quarter" idx="5"/>
          </p:nvPr>
        </p:nvSpPr>
        <p:spPr bwMode="auto">
          <a:ln>
            <a:miter lim="800000"/>
            <a:headEnd/>
            <a:tailEnd/>
          </a:ln>
        </p:spPr>
        <p:txBody>
          <a:bodyPr/>
          <a:lstStyle/>
          <a:p>
            <a:pPr>
              <a:defRPr/>
            </a:pPr>
            <a:fld id="{1E51ED57-1F52-46F5-B3DC-E305F7054637}" type="slidenum">
              <a:rPr lang="en-IN" smtClean="0">
                <a:cs typeface="Arial" pitchFamily="34" charset="0"/>
              </a:rPr>
              <a:pPr>
                <a:defRPr/>
              </a:pPr>
              <a:t>12</a:t>
            </a:fld>
            <a:endParaRPr lang="en-IN" smtClean="0">
              <a:cs typeface="Arial" pitchFamily="34" charset="0"/>
            </a:endParaRPr>
          </a:p>
        </p:txBody>
      </p:sp>
    </p:spTree>
    <p:extLst>
      <p:ext uri="{BB962C8B-B14F-4D97-AF65-F5344CB8AC3E}">
        <p14:creationId xmlns:p14="http://schemas.microsoft.com/office/powerpoint/2010/main" val="16734229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IN"/>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IN"/>
          </a:p>
        </p:txBody>
      </p:sp>
      <p:sp>
        <p:nvSpPr>
          <p:cNvPr id="4" name="Date Placeholder 3"/>
          <p:cNvSpPr>
            <a:spLocks noGrp="1"/>
          </p:cNvSpPr>
          <p:nvPr>
            <p:ph type="dt" sz="half" idx="10"/>
          </p:nvPr>
        </p:nvSpPr>
        <p:spPr/>
        <p:txBody>
          <a:bodyPr/>
          <a:lstStyle>
            <a:lvl1pPr>
              <a:defRPr/>
            </a:lvl1pPr>
          </a:lstStyle>
          <a:p>
            <a:pPr>
              <a:defRPr/>
            </a:pPr>
            <a:fld id="{DD47A9D8-DE70-4159-AC63-386626F2E8BA}" type="datetimeFigureOut">
              <a:rPr lang="en-US"/>
              <a:pPr>
                <a:defRPr/>
              </a:pPr>
              <a:t>5/19/2016</a:t>
            </a:fld>
            <a:endParaRPr lang="en-IN"/>
          </a:p>
        </p:txBody>
      </p:sp>
      <p:sp>
        <p:nvSpPr>
          <p:cNvPr id="5" name="Footer Placeholder 4"/>
          <p:cNvSpPr>
            <a:spLocks noGrp="1"/>
          </p:cNvSpPr>
          <p:nvPr>
            <p:ph type="ftr" sz="quarter" idx="11"/>
          </p:nvPr>
        </p:nvSpPr>
        <p:spPr/>
        <p:txBody>
          <a:bodyPr/>
          <a:lstStyle>
            <a:lvl1pPr>
              <a:defRPr/>
            </a:lvl1pPr>
          </a:lstStyle>
          <a:p>
            <a:pPr>
              <a:defRPr/>
            </a:pPr>
            <a:endParaRPr lang="en-IN"/>
          </a:p>
        </p:txBody>
      </p:sp>
      <p:sp>
        <p:nvSpPr>
          <p:cNvPr id="6" name="Slide Number Placeholder 5"/>
          <p:cNvSpPr>
            <a:spLocks noGrp="1"/>
          </p:cNvSpPr>
          <p:nvPr>
            <p:ph type="sldNum" sz="quarter" idx="12"/>
          </p:nvPr>
        </p:nvSpPr>
        <p:spPr/>
        <p:txBody>
          <a:bodyPr/>
          <a:lstStyle>
            <a:lvl1pPr>
              <a:defRPr/>
            </a:lvl1pPr>
          </a:lstStyle>
          <a:p>
            <a:pPr>
              <a:defRPr/>
            </a:pPr>
            <a:fld id="{C182C692-2DFE-45C4-A473-88C91B5EC898}" type="slidenum">
              <a:rPr lang="en-IN"/>
              <a:pPr>
                <a:defRPr/>
              </a:pPr>
              <a:t>‹#›</a:t>
            </a:fld>
            <a:endParaRPr lang="en-IN"/>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lvl1pPr>
              <a:defRPr/>
            </a:lvl1pPr>
          </a:lstStyle>
          <a:p>
            <a:pPr>
              <a:defRPr/>
            </a:pPr>
            <a:fld id="{E7A7EEAF-D861-4631-B03D-3B01D9F57B13}" type="datetimeFigureOut">
              <a:rPr lang="en-US"/>
              <a:pPr>
                <a:defRPr/>
              </a:pPr>
              <a:t>5/19/2016</a:t>
            </a:fld>
            <a:endParaRPr lang="en-IN"/>
          </a:p>
        </p:txBody>
      </p:sp>
      <p:sp>
        <p:nvSpPr>
          <p:cNvPr id="5" name="Footer Placeholder 4"/>
          <p:cNvSpPr>
            <a:spLocks noGrp="1"/>
          </p:cNvSpPr>
          <p:nvPr>
            <p:ph type="ftr" sz="quarter" idx="11"/>
          </p:nvPr>
        </p:nvSpPr>
        <p:spPr/>
        <p:txBody>
          <a:bodyPr/>
          <a:lstStyle>
            <a:lvl1pPr>
              <a:defRPr/>
            </a:lvl1pPr>
          </a:lstStyle>
          <a:p>
            <a:pPr>
              <a:defRPr/>
            </a:pPr>
            <a:endParaRPr lang="en-IN"/>
          </a:p>
        </p:txBody>
      </p:sp>
      <p:sp>
        <p:nvSpPr>
          <p:cNvPr id="6" name="Slide Number Placeholder 5"/>
          <p:cNvSpPr>
            <a:spLocks noGrp="1"/>
          </p:cNvSpPr>
          <p:nvPr>
            <p:ph type="sldNum" sz="quarter" idx="12"/>
          </p:nvPr>
        </p:nvSpPr>
        <p:spPr/>
        <p:txBody>
          <a:bodyPr/>
          <a:lstStyle>
            <a:lvl1pPr>
              <a:defRPr/>
            </a:lvl1pPr>
          </a:lstStyle>
          <a:p>
            <a:pPr>
              <a:defRPr/>
            </a:pPr>
            <a:fld id="{A52D5284-966D-4100-90DD-C1AECDC0DFF2}" type="slidenum">
              <a:rPr lang="en-IN"/>
              <a:pPr>
                <a:defRPr/>
              </a:pPr>
              <a:t>‹#›</a:t>
            </a:fld>
            <a:endParaRPr lang="en-IN"/>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IN"/>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lvl1pPr>
              <a:defRPr/>
            </a:lvl1pPr>
          </a:lstStyle>
          <a:p>
            <a:pPr>
              <a:defRPr/>
            </a:pPr>
            <a:fld id="{70D6A3B1-EDBA-4F66-A15B-F472AAB5A228}" type="datetimeFigureOut">
              <a:rPr lang="en-US"/>
              <a:pPr>
                <a:defRPr/>
              </a:pPr>
              <a:t>5/19/2016</a:t>
            </a:fld>
            <a:endParaRPr lang="en-IN"/>
          </a:p>
        </p:txBody>
      </p:sp>
      <p:sp>
        <p:nvSpPr>
          <p:cNvPr id="5" name="Footer Placeholder 4"/>
          <p:cNvSpPr>
            <a:spLocks noGrp="1"/>
          </p:cNvSpPr>
          <p:nvPr>
            <p:ph type="ftr" sz="quarter" idx="11"/>
          </p:nvPr>
        </p:nvSpPr>
        <p:spPr/>
        <p:txBody>
          <a:bodyPr/>
          <a:lstStyle>
            <a:lvl1pPr>
              <a:defRPr/>
            </a:lvl1pPr>
          </a:lstStyle>
          <a:p>
            <a:pPr>
              <a:defRPr/>
            </a:pPr>
            <a:endParaRPr lang="en-IN"/>
          </a:p>
        </p:txBody>
      </p:sp>
      <p:sp>
        <p:nvSpPr>
          <p:cNvPr id="6" name="Slide Number Placeholder 5"/>
          <p:cNvSpPr>
            <a:spLocks noGrp="1"/>
          </p:cNvSpPr>
          <p:nvPr>
            <p:ph type="sldNum" sz="quarter" idx="12"/>
          </p:nvPr>
        </p:nvSpPr>
        <p:spPr/>
        <p:txBody>
          <a:bodyPr/>
          <a:lstStyle>
            <a:lvl1pPr>
              <a:defRPr/>
            </a:lvl1pPr>
          </a:lstStyle>
          <a:p>
            <a:pPr>
              <a:defRPr/>
            </a:pPr>
            <a:fld id="{5AA44CD8-D915-4143-AA31-2D4CFB7950DF}" type="slidenum">
              <a:rPr lang="en-IN"/>
              <a:pPr>
                <a:defRPr/>
              </a:pPr>
              <a:t>‹#›</a:t>
            </a:fld>
            <a:endParaRPr lang="en-IN"/>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9"/>
            <a:ext cx="5829300" cy="1960033"/>
          </a:xfrm>
        </p:spPr>
        <p:txBody>
          <a:bodyPr/>
          <a:lstStyle/>
          <a:p>
            <a:r>
              <a:rPr lang="en-US" smtClean="0"/>
              <a:t>Click to edit Master title style</a:t>
            </a:r>
            <a:endParaRPr lang="en-IN"/>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IN"/>
          </a:p>
        </p:txBody>
      </p:sp>
      <p:sp>
        <p:nvSpPr>
          <p:cNvPr id="4" name="Date Placeholder 3"/>
          <p:cNvSpPr>
            <a:spLocks noGrp="1"/>
          </p:cNvSpPr>
          <p:nvPr>
            <p:ph type="dt" sz="half" idx="10"/>
          </p:nvPr>
        </p:nvSpPr>
        <p:spPr/>
        <p:txBody>
          <a:bodyPr/>
          <a:lstStyle>
            <a:lvl1pPr>
              <a:defRPr/>
            </a:lvl1pPr>
          </a:lstStyle>
          <a:p>
            <a:pPr>
              <a:defRPr/>
            </a:pPr>
            <a:fld id="{76DDD268-4F61-41BE-8500-5FCAE5A1D008}" type="datetimeFigureOut">
              <a:rPr lang="en-US"/>
              <a:pPr>
                <a:defRPr/>
              </a:pPr>
              <a:t>5/19/2016</a:t>
            </a:fld>
            <a:endParaRPr lang="en-IN"/>
          </a:p>
        </p:txBody>
      </p:sp>
      <p:sp>
        <p:nvSpPr>
          <p:cNvPr id="5" name="Footer Placeholder 4"/>
          <p:cNvSpPr>
            <a:spLocks noGrp="1"/>
          </p:cNvSpPr>
          <p:nvPr>
            <p:ph type="ftr" sz="quarter" idx="11"/>
          </p:nvPr>
        </p:nvSpPr>
        <p:spPr/>
        <p:txBody>
          <a:bodyPr/>
          <a:lstStyle>
            <a:lvl1pPr>
              <a:defRPr/>
            </a:lvl1pPr>
          </a:lstStyle>
          <a:p>
            <a:pPr>
              <a:defRPr/>
            </a:pPr>
            <a:endParaRPr lang="en-IN"/>
          </a:p>
        </p:txBody>
      </p:sp>
      <p:sp>
        <p:nvSpPr>
          <p:cNvPr id="6" name="Slide Number Placeholder 5"/>
          <p:cNvSpPr>
            <a:spLocks noGrp="1"/>
          </p:cNvSpPr>
          <p:nvPr>
            <p:ph type="sldNum" sz="quarter" idx="12"/>
          </p:nvPr>
        </p:nvSpPr>
        <p:spPr/>
        <p:txBody>
          <a:bodyPr/>
          <a:lstStyle>
            <a:lvl1pPr>
              <a:defRPr/>
            </a:lvl1pPr>
          </a:lstStyle>
          <a:p>
            <a:pPr>
              <a:defRPr/>
            </a:pPr>
            <a:fld id="{F7DE3E7B-6B85-459A-B2F1-2568A973055A}" type="slidenum">
              <a:rPr lang="en-IN"/>
              <a:pPr>
                <a:defRPr/>
              </a:pPr>
              <a:t>‹#›</a:t>
            </a:fld>
            <a:endParaRPr lang="en-IN"/>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lvl1pPr>
              <a:defRPr/>
            </a:lvl1pPr>
          </a:lstStyle>
          <a:p>
            <a:pPr>
              <a:defRPr/>
            </a:pPr>
            <a:fld id="{D4CFF68A-7E85-4AF0-A6CA-BC2968F81195}" type="datetimeFigureOut">
              <a:rPr lang="en-US"/>
              <a:pPr>
                <a:defRPr/>
              </a:pPr>
              <a:t>5/19/2016</a:t>
            </a:fld>
            <a:endParaRPr lang="en-IN"/>
          </a:p>
        </p:txBody>
      </p:sp>
      <p:sp>
        <p:nvSpPr>
          <p:cNvPr id="5" name="Footer Placeholder 4"/>
          <p:cNvSpPr>
            <a:spLocks noGrp="1"/>
          </p:cNvSpPr>
          <p:nvPr>
            <p:ph type="ftr" sz="quarter" idx="11"/>
          </p:nvPr>
        </p:nvSpPr>
        <p:spPr/>
        <p:txBody>
          <a:bodyPr/>
          <a:lstStyle>
            <a:lvl1pPr>
              <a:defRPr/>
            </a:lvl1pPr>
          </a:lstStyle>
          <a:p>
            <a:pPr>
              <a:defRPr/>
            </a:pPr>
            <a:endParaRPr lang="en-IN"/>
          </a:p>
        </p:txBody>
      </p:sp>
      <p:sp>
        <p:nvSpPr>
          <p:cNvPr id="6" name="Slide Number Placeholder 5"/>
          <p:cNvSpPr>
            <a:spLocks noGrp="1"/>
          </p:cNvSpPr>
          <p:nvPr>
            <p:ph type="sldNum" sz="quarter" idx="12"/>
          </p:nvPr>
        </p:nvSpPr>
        <p:spPr/>
        <p:txBody>
          <a:bodyPr/>
          <a:lstStyle>
            <a:lvl1pPr>
              <a:defRPr/>
            </a:lvl1pPr>
          </a:lstStyle>
          <a:p>
            <a:pPr>
              <a:defRPr/>
            </a:pPr>
            <a:fld id="{4F2704B3-A1E6-41AD-9E82-0BFF13794167}" type="slidenum">
              <a:rPr lang="en-IN"/>
              <a:pPr>
                <a:defRPr/>
              </a:pPr>
              <a:t>‹#›</a:t>
            </a:fld>
            <a:endParaRPr lang="en-IN"/>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IN"/>
          </a:p>
        </p:txBody>
      </p:sp>
      <p:sp>
        <p:nvSpPr>
          <p:cNvPr id="3" name="Text Placeholder 2"/>
          <p:cNvSpPr>
            <a:spLocks noGrp="1"/>
          </p:cNvSpPr>
          <p:nvPr>
            <p:ph type="body" idx="1"/>
          </p:nvPr>
        </p:nvSpPr>
        <p:spPr>
          <a:xfrm>
            <a:off x="541735" y="3875620"/>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10E4048-0DD4-44E6-A503-0A37BE1E4B16}" type="datetimeFigureOut">
              <a:rPr lang="en-US"/>
              <a:pPr>
                <a:defRPr/>
              </a:pPr>
              <a:t>5/19/2016</a:t>
            </a:fld>
            <a:endParaRPr lang="en-IN"/>
          </a:p>
        </p:txBody>
      </p:sp>
      <p:sp>
        <p:nvSpPr>
          <p:cNvPr id="5" name="Footer Placeholder 4"/>
          <p:cNvSpPr>
            <a:spLocks noGrp="1"/>
          </p:cNvSpPr>
          <p:nvPr>
            <p:ph type="ftr" sz="quarter" idx="11"/>
          </p:nvPr>
        </p:nvSpPr>
        <p:spPr/>
        <p:txBody>
          <a:bodyPr/>
          <a:lstStyle>
            <a:lvl1pPr>
              <a:defRPr/>
            </a:lvl1pPr>
          </a:lstStyle>
          <a:p>
            <a:pPr>
              <a:defRPr/>
            </a:pPr>
            <a:endParaRPr lang="en-IN"/>
          </a:p>
        </p:txBody>
      </p:sp>
      <p:sp>
        <p:nvSpPr>
          <p:cNvPr id="6" name="Slide Number Placeholder 5"/>
          <p:cNvSpPr>
            <a:spLocks noGrp="1"/>
          </p:cNvSpPr>
          <p:nvPr>
            <p:ph type="sldNum" sz="quarter" idx="12"/>
          </p:nvPr>
        </p:nvSpPr>
        <p:spPr/>
        <p:txBody>
          <a:bodyPr/>
          <a:lstStyle>
            <a:lvl1pPr>
              <a:defRPr/>
            </a:lvl1pPr>
          </a:lstStyle>
          <a:p>
            <a:pPr>
              <a:defRPr/>
            </a:pPr>
            <a:fld id="{2C187302-1C31-405E-A937-72E50DB3A22B}" type="slidenum">
              <a:rPr lang="en-IN"/>
              <a:pPr>
                <a:defRPr/>
              </a:pPr>
              <a:t>‹#›</a:t>
            </a:fld>
            <a:endParaRPr lang="en-IN"/>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sz="half" idx="1"/>
          </p:nvPr>
        </p:nvSpPr>
        <p:spPr>
          <a:xfrm>
            <a:off x="342900" y="2133602"/>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Content Placeholder 3"/>
          <p:cNvSpPr>
            <a:spLocks noGrp="1"/>
          </p:cNvSpPr>
          <p:nvPr>
            <p:ph sz="half" idx="2"/>
          </p:nvPr>
        </p:nvSpPr>
        <p:spPr>
          <a:xfrm>
            <a:off x="3486150" y="2133602"/>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Date Placeholder 3"/>
          <p:cNvSpPr>
            <a:spLocks noGrp="1"/>
          </p:cNvSpPr>
          <p:nvPr>
            <p:ph type="dt" sz="half" idx="10"/>
          </p:nvPr>
        </p:nvSpPr>
        <p:spPr/>
        <p:txBody>
          <a:bodyPr/>
          <a:lstStyle>
            <a:lvl1pPr>
              <a:defRPr/>
            </a:lvl1pPr>
          </a:lstStyle>
          <a:p>
            <a:pPr>
              <a:defRPr/>
            </a:pPr>
            <a:fld id="{C6FA1E0E-05F0-460C-94D7-402072497D2E}" type="datetimeFigureOut">
              <a:rPr lang="en-US"/>
              <a:pPr>
                <a:defRPr/>
              </a:pPr>
              <a:t>5/19/2016</a:t>
            </a:fld>
            <a:endParaRPr lang="en-IN"/>
          </a:p>
        </p:txBody>
      </p:sp>
      <p:sp>
        <p:nvSpPr>
          <p:cNvPr id="6" name="Footer Placeholder 4"/>
          <p:cNvSpPr>
            <a:spLocks noGrp="1"/>
          </p:cNvSpPr>
          <p:nvPr>
            <p:ph type="ftr" sz="quarter" idx="11"/>
          </p:nvPr>
        </p:nvSpPr>
        <p:spPr/>
        <p:txBody>
          <a:bodyPr/>
          <a:lstStyle>
            <a:lvl1pPr>
              <a:defRPr/>
            </a:lvl1pPr>
          </a:lstStyle>
          <a:p>
            <a:pPr>
              <a:defRPr/>
            </a:pPr>
            <a:endParaRPr lang="en-IN"/>
          </a:p>
        </p:txBody>
      </p:sp>
      <p:sp>
        <p:nvSpPr>
          <p:cNvPr id="7" name="Slide Number Placeholder 5"/>
          <p:cNvSpPr>
            <a:spLocks noGrp="1"/>
          </p:cNvSpPr>
          <p:nvPr>
            <p:ph type="sldNum" sz="quarter" idx="12"/>
          </p:nvPr>
        </p:nvSpPr>
        <p:spPr/>
        <p:txBody>
          <a:bodyPr/>
          <a:lstStyle>
            <a:lvl1pPr>
              <a:defRPr/>
            </a:lvl1pPr>
          </a:lstStyle>
          <a:p>
            <a:pPr>
              <a:defRPr/>
            </a:pPr>
            <a:fld id="{383012D0-4708-4007-B7B8-CBFE3C1A0C53}" type="slidenum">
              <a:rPr lang="en-IN"/>
              <a:pPr>
                <a:defRPr/>
              </a:pPr>
              <a:t>‹#›</a:t>
            </a:fld>
            <a:endParaRPr lang="en-IN"/>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IN"/>
          </a:p>
        </p:txBody>
      </p:sp>
      <p:sp>
        <p:nvSpPr>
          <p:cNvPr id="3" name="Text Placeholder 2"/>
          <p:cNvSpPr>
            <a:spLocks noGrp="1"/>
          </p:cNvSpPr>
          <p:nvPr>
            <p:ph type="body" idx="1"/>
          </p:nvPr>
        </p:nvSpPr>
        <p:spPr>
          <a:xfrm>
            <a:off x="342901"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1"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Text Placeholder 4"/>
          <p:cNvSpPr>
            <a:spLocks noGrp="1"/>
          </p:cNvSpPr>
          <p:nvPr>
            <p:ph type="body" sz="quarter" idx="3"/>
          </p:nvPr>
        </p:nvSpPr>
        <p:spPr>
          <a:xfrm>
            <a:off x="3483770"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70"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7" name="Date Placeholder 3"/>
          <p:cNvSpPr>
            <a:spLocks noGrp="1"/>
          </p:cNvSpPr>
          <p:nvPr>
            <p:ph type="dt" sz="half" idx="10"/>
          </p:nvPr>
        </p:nvSpPr>
        <p:spPr/>
        <p:txBody>
          <a:bodyPr/>
          <a:lstStyle>
            <a:lvl1pPr>
              <a:defRPr/>
            </a:lvl1pPr>
          </a:lstStyle>
          <a:p>
            <a:pPr>
              <a:defRPr/>
            </a:pPr>
            <a:fld id="{CE794E2F-49D5-4F94-928D-C919C92525EB}" type="datetimeFigureOut">
              <a:rPr lang="en-US"/>
              <a:pPr>
                <a:defRPr/>
              </a:pPr>
              <a:t>5/19/2016</a:t>
            </a:fld>
            <a:endParaRPr lang="en-IN"/>
          </a:p>
        </p:txBody>
      </p:sp>
      <p:sp>
        <p:nvSpPr>
          <p:cNvPr id="8" name="Footer Placeholder 4"/>
          <p:cNvSpPr>
            <a:spLocks noGrp="1"/>
          </p:cNvSpPr>
          <p:nvPr>
            <p:ph type="ftr" sz="quarter" idx="11"/>
          </p:nvPr>
        </p:nvSpPr>
        <p:spPr/>
        <p:txBody>
          <a:bodyPr/>
          <a:lstStyle>
            <a:lvl1pPr>
              <a:defRPr/>
            </a:lvl1pPr>
          </a:lstStyle>
          <a:p>
            <a:pPr>
              <a:defRPr/>
            </a:pPr>
            <a:endParaRPr lang="en-IN"/>
          </a:p>
        </p:txBody>
      </p:sp>
      <p:sp>
        <p:nvSpPr>
          <p:cNvPr id="9" name="Slide Number Placeholder 5"/>
          <p:cNvSpPr>
            <a:spLocks noGrp="1"/>
          </p:cNvSpPr>
          <p:nvPr>
            <p:ph type="sldNum" sz="quarter" idx="12"/>
          </p:nvPr>
        </p:nvSpPr>
        <p:spPr/>
        <p:txBody>
          <a:bodyPr/>
          <a:lstStyle>
            <a:lvl1pPr>
              <a:defRPr/>
            </a:lvl1pPr>
          </a:lstStyle>
          <a:p>
            <a:pPr>
              <a:defRPr/>
            </a:pPr>
            <a:fld id="{D0A6D60F-F51D-49D2-92B0-4B7CC3392B23}" type="slidenum">
              <a:rPr lang="en-IN"/>
              <a:pPr>
                <a:defRPr/>
              </a:pPr>
              <a:t>‹#›</a:t>
            </a:fld>
            <a:endParaRPr lang="en-IN"/>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Date Placeholder 3"/>
          <p:cNvSpPr>
            <a:spLocks noGrp="1"/>
          </p:cNvSpPr>
          <p:nvPr>
            <p:ph type="dt" sz="half" idx="10"/>
          </p:nvPr>
        </p:nvSpPr>
        <p:spPr/>
        <p:txBody>
          <a:bodyPr/>
          <a:lstStyle>
            <a:lvl1pPr>
              <a:defRPr/>
            </a:lvl1pPr>
          </a:lstStyle>
          <a:p>
            <a:pPr>
              <a:defRPr/>
            </a:pPr>
            <a:fld id="{D84157F1-1426-49AC-AB66-7A07F5E598B7}" type="datetimeFigureOut">
              <a:rPr lang="en-US"/>
              <a:pPr>
                <a:defRPr/>
              </a:pPr>
              <a:t>5/19/2016</a:t>
            </a:fld>
            <a:endParaRPr lang="en-IN"/>
          </a:p>
        </p:txBody>
      </p:sp>
      <p:sp>
        <p:nvSpPr>
          <p:cNvPr id="4" name="Footer Placeholder 4"/>
          <p:cNvSpPr>
            <a:spLocks noGrp="1"/>
          </p:cNvSpPr>
          <p:nvPr>
            <p:ph type="ftr" sz="quarter" idx="11"/>
          </p:nvPr>
        </p:nvSpPr>
        <p:spPr/>
        <p:txBody>
          <a:bodyPr/>
          <a:lstStyle>
            <a:lvl1pPr>
              <a:defRPr/>
            </a:lvl1pPr>
          </a:lstStyle>
          <a:p>
            <a:pPr>
              <a:defRPr/>
            </a:pPr>
            <a:endParaRPr lang="en-IN"/>
          </a:p>
        </p:txBody>
      </p:sp>
      <p:sp>
        <p:nvSpPr>
          <p:cNvPr id="5" name="Slide Number Placeholder 5"/>
          <p:cNvSpPr>
            <a:spLocks noGrp="1"/>
          </p:cNvSpPr>
          <p:nvPr>
            <p:ph type="sldNum" sz="quarter" idx="12"/>
          </p:nvPr>
        </p:nvSpPr>
        <p:spPr/>
        <p:txBody>
          <a:bodyPr/>
          <a:lstStyle>
            <a:lvl1pPr>
              <a:defRPr/>
            </a:lvl1pPr>
          </a:lstStyle>
          <a:p>
            <a:pPr>
              <a:defRPr/>
            </a:pPr>
            <a:fld id="{28FB08E8-E0D9-4ADB-AC15-3C0FAC0213C1}" type="slidenum">
              <a:rPr lang="en-IN"/>
              <a:pPr>
                <a:defRPr/>
              </a:pPr>
              <a:t>‹#›</a:t>
            </a:fld>
            <a:endParaRPr lang="en-IN"/>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B4584D-527C-4083-A6CB-59FF35E02FE2}" type="datetimeFigureOut">
              <a:rPr lang="en-US"/>
              <a:pPr>
                <a:defRPr/>
              </a:pPr>
              <a:t>5/19/2016</a:t>
            </a:fld>
            <a:endParaRPr lang="en-IN"/>
          </a:p>
        </p:txBody>
      </p:sp>
      <p:sp>
        <p:nvSpPr>
          <p:cNvPr id="3" name="Footer Placeholder 4"/>
          <p:cNvSpPr>
            <a:spLocks noGrp="1"/>
          </p:cNvSpPr>
          <p:nvPr>
            <p:ph type="ftr" sz="quarter" idx="11"/>
          </p:nvPr>
        </p:nvSpPr>
        <p:spPr/>
        <p:txBody>
          <a:bodyPr/>
          <a:lstStyle>
            <a:lvl1pPr>
              <a:defRPr/>
            </a:lvl1pPr>
          </a:lstStyle>
          <a:p>
            <a:pPr>
              <a:defRPr/>
            </a:pPr>
            <a:endParaRPr lang="en-IN"/>
          </a:p>
        </p:txBody>
      </p:sp>
      <p:sp>
        <p:nvSpPr>
          <p:cNvPr id="4" name="Slide Number Placeholder 5"/>
          <p:cNvSpPr>
            <a:spLocks noGrp="1"/>
          </p:cNvSpPr>
          <p:nvPr>
            <p:ph type="sldNum" sz="quarter" idx="12"/>
          </p:nvPr>
        </p:nvSpPr>
        <p:spPr/>
        <p:txBody>
          <a:bodyPr/>
          <a:lstStyle>
            <a:lvl1pPr>
              <a:defRPr/>
            </a:lvl1pPr>
          </a:lstStyle>
          <a:p>
            <a:pPr>
              <a:defRPr/>
            </a:pPr>
            <a:fld id="{6722C6CD-B761-4A56-8B0B-0D9CED4A675F}" type="slidenum">
              <a:rPr lang="en-IN"/>
              <a:pPr>
                <a:defRPr/>
              </a:pPr>
              <a:t>‹#›</a:t>
            </a:fld>
            <a:endParaRPr lang="en-IN"/>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64067"/>
            <a:ext cx="2256235" cy="1549400"/>
          </a:xfrm>
        </p:spPr>
        <p:txBody>
          <a:bodyPr anchor="b"/>
          <a:lstStyle>
            <a:lvl1pPr algn="l">
              <a:defRPr sz="2000" b="1"/>
            </a:lvl1pPr>
          </a:lstStyle>
          <a:p>
            <a:r>
              <a:rPr lang="en-US" smtClean="0"/>
              <a:t>Click to edit Master title style</a:t>
            </a:r>
            <a:endParaRPr lang="en-IN"/>
          </a:p>
        </p:txBody>
      </p:sp>
      <p:sp>
        <p:nvSpPr>
          <p:cNvPr id="3" name="Content Placeholder 2"/>
          <p:cNvSpPr>
            <a:spLocks noGrp="1"/>
          </p:cNvSpPr>
          <p:nvPr>
            <p:ph idx="1"/>
          </p:nvPr>
        </p:nvSpPr>
        <p:spPr>
          <a:xfrm>
            <a:off x="2681288" y="364069"/>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Text Placeholder 3"/>
          <p:cNvSpPr>
            <a:spLocks noGrp="1"/>
          </p:cNvSpPr>
          <p:nvPr>
            <p:ph type="body" sz="half" idx="2"/>
          </p:nvPr>
        </p:nvSpPr>
        <p:spPr>
          <a:xfrm>
            <a:off x="342901" y="1913468"/>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8DDAAEB9-24BB-44E5-AFBE-A22B5C193896}" type="datetimeFigureOut">
              <a:rPr lang="en-US"/>
              <a:pPr>
                <a:defRPr/>
              </a:pPr>
              <a:t>5/19/2016</a:t>
            </a:fld>
            <a:endParaRPr lang="en-IN"/>
          </a:p>
        </p:txBody>
      </p:sp>
      <p:sp>
        <p:nvSpPr>
          <p:cNvPr id="6" name="Footer Placeholder 4"/>
          <p:cNvSpPr>
            <a:spLocks noGrp="1"/>
          </p:cNvSpPr>
          <p:nvPr>
            <p:ph type="ftr" sz="quarter" idx="11"/>
          </p:nvPr>
        </p:nvSpPr>
        <p:spPr/>
        <p:txBody>
          <a:bodyPr/>
          <a:lstStyle>
            <a:lvl1pPr>
              <a:defRPr/>
            </a:lvl1pPr>
          </a:lstStyle>
          <a:p>
            <a:pPr>
              <a:defRPr/>
            </a:pPr>
            <a:endParaRPr lang="en-IN"/>
          </a:p>
        </p:txBody>
      </p:sp>
      <p:sp>
        <p:nvSpPr>
          <p:cNvPr id="7" name="Slide Number Placeholder 5"/>
          <p:cNvSpPr>
            <a:spLocks noGrp="1"/>
          </p:cNvSpPr>
          <p:nvPr>
            <p:ph type="sldNum" sz="quarter" idx="12"/>
          </p:nvPr>
        </p:nvSpPr>
        <p:spPr/>
        <p:txBody>
          <a:bodyPr/>
          <a:lstStyle>
            <a:lvl1pPr>
              <a:defRPr/>
            </a:lvl1pPr>
          </a:lstStyle>
          <a:p>
            <a:pPr>
              <a:defRPr/>
            </a:pPr>
            <a:fld id="{4B492F9A-610D-49C9-9712-9E9B0614DF3D}" type="slidenum">
              <a:rPr lang="en-IN"/>
              <a:pPr>
                <a:defRPr/>
              </a:pPr>
              <a:t>‹#›</a:t>
            </a:fld>
            <a:endParaRPr lang="en-IN"/>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lvl1pPr>
              <a:defRPr/>
            </a:lvl1pPr>
          </a:lstStyle>
          <a:p>
            <a:pPr>
              <a:defRPr/>
            </a:pPr>
            <a:fld id="{8AFCCEBB-262C-4290-AE01-F97E6933CACA}" type="datetimeFigureOut">
              <a:rPr lang="en-US"/>
              <a:pPr>
                <a:defRPr/>
              </a:pPr>
              <a:t>5/19/2016</a:t>
            </a:fld>
            <a:endParaRPr lang="en-IN"/>
          </a:p>
        </p:txBody>
      </p:sp>
      <p:sp>
        <p:nvSpPr>
          <p:cNvPr id="5" name="Footer Placeholder 4"/>
          <p:cNvSpPr>
            <a:spLocks noGrp="1"/>
          </p:cNvSpPr>
          <p:nvPr>
            <p:ph type="ftr" sz="quarter" idx="11"/>
          </p:nvPr>
        </p:nvSpPr>
        <p:spPr/>
        <p:txBody>
          <a:bodyPr/>
          <a:lstStyle>
            <a:lvl1pPr>
              <a:defRPr/>
            </a:lvl1pPr>
          </a:lstStyle>
          <a:p>
            <a:pPr>
              <a:defRPr/>
            </a:pPr>
            <a:endParaRPr lang="en-IN"/>
          </a:p>
        </p:txBody>
      </p:sp>
      <p:sp>
        <p:nvSpPr>
          <p:cNvPr id="6" name="Slide Number Placeholder 5"/>
          <p:cNvSpPr>
            <a:spLocks noGrp="1"/>
          </p:cNvSpPr>
          <p:nvPr>
            <p:ph type="sldNum" sz="quarter" idx="12"/>
          </p:nvPr>
        </p:nvSpPr>
        <p:spPr/>
        <p:txBody>
          <a:bodyPr/>
          <a:lstStyle>
            <a:lvl1pPr>
              <a:defRPr/>
            </a:lvl1pPr>
          </a:lstStyle>
          <a:p>
            <a:pPr>
              <a:defRPr/>
            </a:pPr>
            <a:fld id="{8557CDF8-4B62-4886-B1AF-FCCECD573EC1}" type="slidenum">
              <a:rPr lang="en-IN"/>
              <a:pPr>
                <a:defRPr/>
              </a:pPr>
              <a:t>‹#›</a:t>
            </a:fld>
            <a:endParaRPr lang="en-IN"/>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smtClean="0"/>
              <a:t>Click to edit Master title style</a:t>
            </a:r>
            <a:endParaRPr lang="en-IN"/>
          </a:p>
        </p:txBody>
      </p:sp>
      <p:sp>
        <p:nvSpPr>
          <p:cNvPr id="3" name="Picture Placeholder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IN" noProof="0" smtClean="0"/>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50DDAD5F-FA0A-46D9-ACEE-4B539B058F68}" type="datetimeFigureOut">
              <a:rPr lang="en-US"/>
              <a:pPr>
                <a:defRPr/>
              </a:pPr>
              <a:t>5/19/2016</a:t>
            </a:fld>
            <a:endParaRPr lang="en-IN"/>
          </a:p>
        </p:txBody>
      </p:sp>
      <p:sp>
        <p:nvSpPr>
          <p:cNvPr id="6" name="Footer Placeholder 4"/>
          <p:cNvSpPr>
            <a:spLocks noGrp="1"/>
          </p:cNvSpPr>
          <p:nvPr>
            <p:ph type="ftr" sz="quarter" idx="11"/>
          </p:nvPr>
        </p:nvSpPr>
        <p:spPr/>
        <p:txBody>
          <a:bodyPr/>
          <a:lstStyle>
            <a:lvl1pPr>
              <a:defRPr/>
            </a:lvl1pPr>
          </a:lstStyle>
          <a:p>
            <a:pPr>
              <a:defRPr/>
            </a:pPr>
            <a:endParaRPr lang="en-IN"/>
          </a:p>
        </p:txBody>
      </p:sp>
      <p:sp>
        <p:nvSpPr>
          <p:cNvPr id="7" name="Slide Number Placeholder 5"/>
          <p:cNvSpPr>
            <a:spLocks noGrp="1"/>
          </p:cNvSpPr>
          <p:nvPr>
            <p:ph type="sldNum" sz="quarter" idx="12"/>
          </p:nvPr>
        </p:nvSpPr>
        <p:spPr/>
        <p:txBody>
          <a:bodyPr/>
          <a:lstStyle>
            <a:lvl1pPr>
              <a:defRPr/>
            </a:lvl1pPr>
          </a:lstStyle>
          <a:p>
            <a:pPr>
              <a:defRPr/>
            </a:pPr>
            <a:fld id="{D6D70AE3-54BF-4E30-BD6D-890FBF5BC937}" type="slidenum">
              <a:rPr lang="en-IN"/>
              <a:pPr>
                <a:defRPr/>
              </a:pPr>
              <a:t>‹#›</a:t>
            </a:fld>
            <a:endParaRPr lang="en-IN"/>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lvl1pPr>
              <a:defRPr/>
            </a:lvl1pPr>
          </a:lstStyle>
          <a:p>
            <a:pPr>
              <a:defRPr/>
            </a:pPr>
            <a:fld id="{92835A2E-D55D-49A0-9DFF-B981B79E273B}" type="datetimeFigureOut">
              <a:rPr lang="en-US"/>
              <a:pPr>
                <a:defRPr/>
              </a:pPr>
              <a:t>5/19/2016</a:t>
            </a:fld>
            <a:endParaRPr lang="en-IN"/>
          </a:p>
        </p:txBody>
      </p:sp>
      <p:sp>
        <p:nvSpPr>
          <p:cNvPr id="5" name="Footer Placeholder 4"/>
          <p:cNvSpPr>
            <a:spLocks noGrp="1"/>
          </p:cNvSpPr>
          <p:nvPr>
            <p:ph type="ftr" sz="quarter" idx="11"/>
          </p:nvPr>
        </p:nvSpPr>
        <p:spPr/>
        <p:txBody>
          <a:bodyPr/>
          <a:lstStyle>
            <a:lvl1pPr>
              <a:defRPr/>
            </a:lvl1pPr>
          </a:lstStyle>
          <a:p>
            <a:pPr>
              <a:defRPr/>
            </a:pPr>
            <a:endParaRPr lang="en-IN"/>
          </a:p>
        </p:txBody>
      </p:sp>
      <p:sp>
        <p:nvSpPr>
          <p:cNvPr id="6" name="Slide Number Placeholder 5"/>
          <p:cNvSpPr>
            <a:spLocks noGrp="1"/>
          </p:cNvSpPr>
          <p:nvPr>
            <p:ph type="sldNum" sz="quarter" idx="12"/>
          </p:nvPr>
        </p:nvSpPr>
        <p:spPr/>
        <p:txBody>
          <a:bodyPr/>
          <a:lstStyle>
            <a:lvl1pPr>
              <a:defRPr/>
            </a:lvl1pPr>
          </a:lstStyle>
          <a:p>
            <a:pPr>
              <a:defRPr/>
            </a:pPr>
            <a:fld id="{E5878149-3375-439C-B3EA-5C158AB95A13}" type="slidenum">
              <a:rPr lang="en-IN"/>
              <a:pPr>
                <a:defRPr/>
              </a:pPr>
              <a:t>‹#›</a:t>
            </a:fld>
            <a:endParaRPr lang="en-IN"/>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6"/>
            <a:ext cx="1543050" cy="7802033"/>
          </a:xfrm>
        </p:spPr>
        <p:txBody>
          <a:bodyPr vert="eaVert"/>
          <a:lstStyle/>
          <a:p>
            <a:r>
              <a:rPr lang="en-US" smtClean="0"/>
              <a:t>Click to edit Master title style</a:t>
            </a:r>
            <a:endParaRPr lang="en-IN"/>
          </a:p>
        </p:txBody>
      </p:sp>
      <p:sp>
        <p:nvSpPr>
          <p:cNvPr id="3" name="Vertical Text Placeholder 2"/>
          <p:cNvSpPr>
            <a:spLocks noGrp="1"/>
          </p:cNvSpPr>
          <p:nvPr>
            <p:ph type="body" orient="vert" idx="1"/>
          </p:nvPr>
        </p:nvSpPr>
        <p:spPr>
          <a:xfrm>
            <a:off x="342900" y="366186"/>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lvl1pPr>
              <a:defRPr/>
            </a:lvl1pPr>
          </a:lstStyle>
          <a:p>
            <a:pPr>
              <a:defRPr/>
            </a:pPr>
            <a:fld id="{B240D0C9-4858-4604-BE6D-24159BDB0CE3}" type="datetimeFigureOut">
              <a:rPr lang="en-US"/>
              <a:pPr>
                <a:defRPr/>
              </a:pPr>
              <a:t>5/19/2016</a:t>
            </a:fld>
            <a:endParaRPr lang="en-IN"/>
          </a:p>
        </p:txBody>
      </p:sp>
      <p:sp>
        <p:nvSpPr>
          <p:cNvPr id="5" name="Footer Placeholder 4"/>
          <p:cNvSpPr>
            <a:spLocks noGrp="1"/>
          </p:cNvSpPr>
          <p:nvPr>
            <p:ph type="ftr" sz="quarter" idx="11"/>
          </p:nvPr>
        </p:nvSpPr>
        <p:spPr/>
        <p:txBody>
          <a:bodyPr/>
          <a:lstStyle>
            <a:lvl1pPr>
              <a:defRPr/>
            </a:lvl1pPr>
          </a:lstStyle>
          <a:p>
            <a:pPr>
              <a:defRPr/>
            </a:pPr>
            <a:endParaRPr lang="en-IN"/>
          </a:p>
        </p:txBody>
      </p:sp>
      <p:sp>
        <p:nvSpPr>
          <p:cNvPr id="6" name="Slide Number Placeholder 5"/>
          <p:cNvSpPr>
            <a:spLocks noGrp="1"/>
          </p:cNvSpPr>
          <p:nvPr>
            <p:ph type="sldNum" sz="quarter" idx="12"/>
          </p:nvPr>
        </p:nvSpPr>
        <p:spPr/>
        <p:txBody>
          <a:bodyPr/>
          <a:lstStyle>
            <a:lvl1pPr>
              <a:defRPr/>
            </a:lvl1pPr>
          </a:lstStyle>
          <a:p>
            <a:pPr>
              <a:defRPr/>
            </a:pPr>
            <a:fld id="{455475A0-1283-4850-9665-0D200D5EED1D}" type="slidenum">
              <a:rPr lang="en-IN"/>
              <a:pPr>
                <a:defRPr/>
              </a:pPr>
              <a:t>‹#›</a:t>
            </a:fld>
            <a:endParaRPr lang="en-IN"/>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IN"/>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E1E88665-80D3-471C-8DFE-EFF8FBE42D1D}" type="datetimeFigureOut">
              <a:rPr lang="en-US"/>
              <a:pPr>
                <a:defRPr/>
              </a:pPr>
              <a:t>5/19/2016</a:t>
            </a:fld>
            <a:endParaRPr lang="en-IN"/>
          </a:p>
        </p:txBody>
      </p:sp>
      <p:sp>
        <p:nvSpPr>
          <p:cNvPr id="5" name="Footer Placeholder 4"/>
          <p:cNvSpPr>
            <a:spLocks noGrp="1"/>
          </p:cNvSpPr>
          <p:nvPr>
            <p:ph type="ftr" sz="quarter" idx="11"/>
          </p:nvPr>
        </p:nvSpPr>
        <p:spPr/>
        <p:txBody>
          <a:bodyPr/>
          <a:lstStyle>
            <a:lvl1pPr>
              <a:defRPr/>
            </a:lvl1pPr>
          </a:lstStyle>
          <a:p>
            <a:pPr>
              <a:defRPr/>
            </a:pPr>
            <a:endParaRPr lang="en-IN"/>
          </a:p>
        </p:txBody>
      </p:sp>
      <p:sp>
        <p:nvSpPr>
          <p:cNvPr id="6" name="Slide Number Placeholder 5"/>
          <p:cNvSpPr>
            <a:spLocks noGrp="1"/>
          </p:cNvSpPr>
          <p:nvPr>
            <p:ph type="sldNum" sz="quarter" idx="12"/>
          </p:nvPr>
        </p:nvSpPr>
        <p:spPr/>
        <p:txBody>
          <a:bodyPr/>
          <a:lstStyle>
            <a:lvl1pPr>
              <a:defRPr/>
            </a:lvl1pPr>
          </a:lstStyle>
          <a:p>
            <a:pPr>
              <a:defRPr/>
            </a:pPr>
            <a:fld id="{ED3A5983-8156-4E08-9A74-CD92C1876CE3}" type="slidenum">
              <a:rPr lang="en-IN"/>
              <a:pPr>
                <a:defRPr/>
              </a:pPr>
              <a:t>‹#›</a:t>
            </a:fld>
            <a:endParaRPr lang="en-IN"/>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Date Placeholder 3"/>
          <p:cNvSpPr>
            <a:spLocks noGrp="1"/>
          </p:cNvSpPr>
          <p:nvPr>
            <p:ph type="dt" sz="half" idx="10"/>
          </p:nvPr>
        </p:nvSpPr>
        <p:spPr/>
        <p:txBody>
          <a:bodyPr/>
          <a:lstStyle>
            <a:lvl1pPr>
              <a:defRPr/>
            </a:lvl1pPr>
          </a:lstStyle>
          <a:p>
            <a:pPr>
              <a:defRPr/>
            </a:pPr>
            <a:fld id="{771AB3CE-0332-4E08-BD38-849F8926CC8F}" type="datetimeFigureOut">
              <a:rPr lang="en-US"/>
              <a:pPr>
                <a:defRPr/>
              </a:pPr>
              <a:t>5/19/2016</a:t>
            </a:fld>
            <a:endParaRPr lang="en-IN"/>
          </a:p>
        </p:txBody>
      </p:sp>
      <p:sp>
        <p:nvSpPr>
          <p:cNvPr id="6" name="Footer Placeholder 4"/>
          <p:cNvSpPr>
            <a:spLocks noGrp="1"/>
          </p:cNvSpPr>
          <p:nvPr>
            <p:ph type="ftr" sz="quarter" idx="11"/>
          </p:nvPr>
        </p:nvSpPr>
        <p:spPr/>
        <p:txBody>
          <a:bodyPr/>
          <a:lstStyle>
            <a:lvl1pPr>
              <a:defRPr/>
            </a:lvl1pPr>
          </a:lstStyle>
          <a:p>
            <a:pPr>
              <a:defRPr/>
            </a:pPr>
            <a:endParaRPr lang="en-IN"/>
          </a:p>
        </p:txBody>
      </p:sp>
      <p:sp>
        <p:nvSpPr>
          <p:cNvPr id="7" name="Slide Number Placeholder 5"/>
          <p:cNvSpPr>
            <a:spLocks noGrp="1"/>
          </p:cNvSpPr>
          <p:nvPr>
            <p:ph type="sldNum" sz="quarter" idx="12"/>
          </p:nvPr>
        </p:nvSpPr>
        <p:spPr/>
        <p:txBody>
          <a:bodyPr/>
          <a:lstStyle>
            <a:lvl1pPr>
              <a:defRPr/>
            </a:lvl1pPr>
          </a:lstStyle>
          <a:p>
            <a:pPr>
              <a:defRPr/>
            </a:pPr>
            <a:fld id="{B796E498-10F9-4BA7-9DD0-6EE9B4FD72A6}" type="slidenum">
              <a:rPr lang="en-IN"/>
              <a:pPr>
                <a:defRPr/>
              </a:pPr>
              <a:t>‹#›</a:t>
            </a:fld>
            <a:endParaRPr lang="en-IN"/>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IN"/>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7" name="Date Placeholder 3"/>
          <p:cNvSpPr>
            <a:spLocks noGrp="1"/>
          </p:cNvSpPr>
          <p:nvPr>
            <p:ph type="dt" sz="half" idx="10"/>
          </p:nvPr>
        </p:nvSpPr>
        <p:spPr/>
        <p:txBody>
          <a:bodyPr/>
          <a:lstStyle>
            <a:lvl1pPr>
              <a:defRPr/>
            </a:lvl1pPr>
          </a:lstStyle>
          <a:p>
            <a:pPr>
              <a:defRPr/>
            </a:pPr>
            <a:fld id="{84884079-D8F9-4C6A-8A26-B0034297B628}" type="datetimeFigureOut">
              <a:rPr lang="en-US"/>
              <a:pPr>
                <a:defRPr/>
              </a:pPr>
              <a:t>5/19/2016</a:t>
            </a:fld>
            <a:endParaRPr lang="en-IN"/>
          </a:p>
        </p:txBody>
      </p:sp>
      <p:sp>
        <p:nvSpPr>
          <p:cNvPr id="8" name="Footer Placeholder 4"/>
          <p:cNvSpPr>
            <a:spLocks noGrp="1"/>
          </p:cNvSpPr>
          <p:nvPr>
            <p:ph type="ftr" sz="quarter" idx="11"/>
          </p:nvPr>
        </p:nvSpPr>
        <p:spPr/>
        <p:txBody>
          <a:bodyPr/>
          <a:lstStyle>
            <a:lvl1pPr>
              <a:defRPr/>
            </a:lvl1pPr>
          </a:lstStyle>
          <a:p>
            <a:pPr>
              <a:defRPr/>
            </a:pPr>
            <a:endParaRPr lang="en-IN"/>
          </a:p>
        </p:txBody>
      </p:sp>
      <p:sp>
        <p:nvSpPr>
          <p:cNvPr id="9" name="Slide Number Placeholder 5"/>
          <p:cNvSpPr>
            <a:spLocks noGrp="1"/>
          </p:cNvSpPr>
          <p:nvPr>
            <p:ph type="sldNum" sz="quarter" idx="12"/>
          </p:nvPr>
        </p:nvSpPr>
        <p:spPr/>
        <p:txBody>
          <a:bodyPr/>
          <a:lstStyle>
            <a:lvl1pPr>
              <a:defRPr/>
            </a:lvl1pPr>
          </a:lstStyle>
          <a:p>
            <a:pPr>
              <a:defRPr/>
            </a:pPr>
            <a:fld id="{BD3B1955-1FDD-438F-81B3-ABEDB3D4E802}" type="slidenum">
              <a:rPr lang="en-IN"/>
              <a:pPr>
                <a:defRPr/>
              </a:pPr>
              <a:t>‹#›</a:t>
            </a:fld>
            <a:endParaRPr lang="en-IN"/>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Date Placeholder 3"/>
          <p:cNvSpPr>
            <a:spLocks noGrp="1"/>
          </p:cNvSpPr>
          <p:nvPr>
            <p:ph type="dt" sz="half" idx="10"/>
          </p:nvPr>
        </p:nvSpPr>
        <p:spPr/>
        <p:txBody>
          <a:bodyPr/>
          <a:lstStyle>
            <a:lvl1pPr>
              <a:defRPr/>
            </a:lvl1pPr>
          </a:lstStyle>
          <a:p>
            <a:pPr>
              <a:defRPr/>
            </a:pPr>
            <a:fld id="{F00D7FB9-CE4D-433B-8B09-18E54A34A5F7}" type="datetimeFigureOut">
              <a:rPr lang="en-US"/>
              <a:pPr>
                <a:defRPr/>
              </a:pPr>
              <a:t>5/19/2016</a:t>
            </a:fld>
            <a:endParaRPr lang="en-IN"/>
          </a:p>
        </p:txBody>
      </p:sp>
      <p:sp>
        <p:nvSpPr>
          <p:cNvPr id="4" name="Footer Placeholder 4"/>
          <p:cNvSpPr>
            <a:spLocks noGrp="1"/>
          </p:cNvSpPr>
          <p:nvPr>
            <p:ph type="ftr" sz="quarter" idx="11"/>
          </p:nvPr>
        </p:nvSpPr>
        <p:spPr/>
        <p:txBody>
          <a:bodyPr/>
          <a:lstStyle>
            <a:lvl1pPr>
              <a:defRPr/>
            </a:lvl1pPr>
          </a:lstStyle>
          <a:p>
            <a:pPr>
              <a:defRPr/>
            </a:pPr>
            <a:endParaRPr lang="en-IN"/>
          </a:p>
        </p:txBody>
      </p:sp>
      <p:sp>
        <p:nvSpPr>
          <p:cNvPr id="5" name="Slide Number Placeholder 5"/>
          <p:cNvSpPr>
            <a:spLocks noGrp="1"/>
          </p:cNvSpPr>
          <p:nvPr>
            <p:ph type="sldNum" sz="quarter" idx="12"/>
          </p:nvPr>
        </p:nvSpPr>
        <p:spPr/>
        <p:txBody>
          <a:bodyPr/>
          <a:lstStyle>
            <a:lvl1pPr>
              <a:defRPr/>
            </a:lvl1pPr>
          </a:lstStyle>
          <a:p>
            <a:pPr>
              <a:defRPr/>
            </a:pPr>
            <a:fld id="{827D06FB-A840-4A5B-B773-7DC6D5DAAAC5}" type="slidenum">
              <a:rPr lang="en-IN"/>
              <a:pPr>
                <a:defRPr/>
              </a:pPr>
              <a:t>‹#›</a:t>
            </a:fld>
            <a:endParaRPr lang="en-IN"/>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97CE2AA4-BA8F-4839-AA4C-09B9AE982B21}" type="datetimeFigureOut">
              <a:rPr lang="en-US"/>
              <a:pPr>
                <a:defRPr/>
              </a:pPr>
              <a:t>5/19/2016</a:t>
            </a:fld>
            <a:endParaRPr lang="en-IN"/>
          </a:p>
        </p:txBody>
      </p:sp>
      <p:sp>
        <p:nvSpPr>
          <p:cNvPr id="3" name="Footer Placeholder 4"/>
          <p:cNvSpPr>
            <a:spLocks noGrp="1"/>
          </p:cNvSpPr>
          <p:nvPr>
            <p:ph type="ftr" sz="quarter" idx="11"/>
          </p:nvPr>
        </p:nvSpPr>
        <p:spPr/>
        <p:txBody>
          <a:bodyPr/>
          <a:lstStyle>
            <a:lvl1pPr>
              <a:defRPr/>
            </a:lvl1pPr>
          </a:lstStyle>
          <a:p>
            <a:pPr>
              <a:defRPr/>
            </a:pPr>
            <a:endParaRPr lang="en-IN"/>
          </a:p>
        </p:txBody>
      </p:sp>
      <p:sp>
        <p:nvSpPr>
          <p:cNvPr id="4" name="Slide Number Placeholder 5"/>
          <p:cNvSpPr>
            <a:spLocks noGrp="1"/>
          </p:cNvSpPr>
          <p:nvPr>
            <p:ph type="sldNum" sz="quarter" idx="12"/>
          </p:nvPr>
        </p:nvSpPr>
        <p:spPr/>
        <p:txBody>
          <a:bodyPr/>
          <a:lstStyle>
            <a:lvl1pPr>
              <a:defRPr/>
            </a:lvl1pPr>
          </a:lstStyle>
          <a:p>
            <a:pPr>
              <a:defRPr/>
            </a:pPr>
            <a:fld id="{744273B4-551F-47E8-92E4-5D81499E5E41}" type="slidenum">
              <a:rPr lang="en-IN"/>
              <a:pPr>
                <a:defRPr/>
              </a:pPr>
              <a:t>‹#›</a:t>
            </a:fld>
            <a:endParaRPr lang="en-IN"/>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IN"/>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C9001325-36E0-4D7E-B307-1B87D46C3A59}" type="datetimeFigureOut">
              <a:rPr lang="en-US"/>
              <a:pPr>
                <a:defRPr/>
              </a:pPr>
              <a:t>5/19/2016</a:t>
            </a:fld>
            <a:endParaRPr lang="en-IN"/>
          </a:p>
        </p:txBody>
      </p:sp>
      <p:sp>
        <p:nvSpPr>
          <p:cNvPr id="6" name="Footer Placeholder 4"/>
          <p:cNvSpPr>
            <a:spLocks noGrp="1"/>
          </p:cNvSpPr>
          <p:nvPr>
            <p:ph type="ftr" sz="quarter" idx="11"/>
          </p:nvPr>
        </p:nvSpPr>
        <p:spPr/>
        <p:txBody>
          <a:bodyPr/>
          <a:lstStyle>
            <a:lvl1pPr>
              <a:defRPr/>
            </a:lvl1pPr>
          </a:lstStyle>
          <a:p>
            <a:pPr>
              <a:defRPr/>
            </a:pPr>
            <a:endParaRPr lang="en-IN"/>
          </a:p>
        </p:txBody>
      </p:sp>
      <p:sp>
        <p:nvSpPr>
          <p:cNvPr id="7" name="Slide Number Placeholder 5"/>
          <p:cNvSpPr>
            <a:spLocks noGrp="1"/>
          </p:cNvSpPr>
          <p:nvPr>
            <p:ph type="sldNum" sz="quarter" idx="12"/>
          </p:nvPr>
        </p:nvSpPr>
        <p:spPr/>
        <p:txBody>
          <a:bodyPr/>
          <a:lstStyle>
            <a:lvl1pPr>
              <a:defRPr/>
            </a:lvl1pPr>
          </a:lstStyle>
          <a:p>
            <a:pPr>
              <a:defRPr/>
            </a:pPr>
            <a:fld id="{88328CD6-0DC0-4101-8794-A085E247B297}" type="slidenum">
              <a:rPr lang="en-IN"/>
              <a:pPr>
                <a:defRPr/>
              </a:pPr>
              <a:t>‹#›</a:t>
            </a:fld>
            <a:endParaRPr lang="en-IN"/>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IN"/>
          </a:p>
        </p:txBody>
      </p:sp>
      <p:sp>
        <p:nvSpPr>
          <p:cNvPr id="3" name="Picture Placeholder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IN" noProof="0"/>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ECF429D9-3817-48F9-AAA8-4A1C9DCB8336}" type="datetimeFigureOut">
              <a:rPr lang="en-US"/>
              <a:pPr>
                <a:defRPr/>
              </a:pPr>
              <a:t>5/19/2016</a:t>
            </a:fld>
            <a:endParaRPr lang="en-IN"/>
          </a:p>
        </p:txBody>
      </p:sp>
      <p:sp>
        <p:nvSpPr>
          <p:cNvPr id="6" name="Footer Placeholder 4"/>
          <p:cNvSpPr>
            <a:spLocks noGrp="1"/>
          </p:cNvSpPr>
          <p:nvPr>
            <p:ph type="ftr" sz="quarter" idx="11"/>
          </p:nvPr>
        </p:nvSpPr>
        <p:spPr/>
        <p:txBody>
          <a:bodyPr/>
          <a:lstStyle>
            <a:lvl1pPr>
              <a:defRPr/>
            </a:lvl1pPr>
          </a:lstStyle>
          <a:p>
            <a:pPr>
              <a:defRPr/>
            </a:pPr>
            <a:endParaRPr lang="en-IN"/>
          </a:p>
        </p:txBody>
      </p:sp>
      <p:sp>
        <p:nvSpPr>
          <p:cNvPr id="7" name="Slide Number Placeholder 5"/>
          <p:cNvSpPr>
            <a:spLocks noGrp="1"/>
          </p:cNvSpPr>
          <p:nvPr>
            <p:ph type="sldNum" sz="quarter" idx="12"/>
          </p:nvPr>
        </p:nvSpPr>
        <p:spPr/>
        <p:txBody>
          <a:bodyPr/>
          <a:lstStyle>
            <a:lvl1pPr>
              <a:defRPr/>
            </a:lvl1pPr>
          </a:lstStyle>
          <a:p>
            <a:pPr>
              <a:defRPr/>
            </a:pPr>
            <a:fld id="{42FB5EFE-BEEB-4A82-AF2E-C699C4DCBA3B}" type="slidenum">
              <a:rPr lang="en-IN"/>
              <a:pPr>
                <a:defRPr/>
              </a:pPr>
              <a:t>‹#›</a:t>
            </a:fld>
            <a:endParaRPr lang="en-IN"/>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342900" y="366713"/>
            <a:ext cx="6172200" cy="1524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endParaRPr lang="en-IN" smtClean="0"/>
          </a:p>
        </p:txBody>
      </p:sp>
      <p:sp>
        <p:nvSpPr>
          <p:cNvPr id="1027" name="Text Placeholder 2"/>
          <p:cNvSpPr>
            <a:spLocks noGrp="1"/>
          </p:cNvSpPr>
          <p:nvPr>
            <p:ph type="body" idx="1"/>
          </p:nvPr>
        </p:nvSpPr>
        <p:spPr bwMode="auto">
          <a:xfrm>
            <a:off x="342900" y="2133600"/>
            <a:ext cx="6172200" cy="60340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smtClean="0"/>
          </a:p>
        </p:txBody>
      </p:sp>
      <p:sp>
        <p:nvSpPr>
          <p:cNvPr id="4" name="Date Placeholder 3"/>
          <p:cNvSpPr>
            <a:spLocks noGrp="1"/>
          </p:cNvSpPr>
          <p:nvPr>
            <p:ph type="dt" sz="half" idx="2"/>
          </p:nvPr>
        </p:nvSpPr>
        <p:spPr>
          <a:xfrm>
            <a:off x="342900" y="8475663"/>
            <a:ext cx="1600200" cy="485775"/>
          </a:xfrm>
          <a:prstGeom prst="rect">
            <a:avLst/>
          </a:prstGeom>
        </p:spPr>
        <p:txBody>
          <a:bodyPr vert="horz" lIns="91440" tIns="45720" rIns="91440" bIns="45720" rtlCol="0" anchor="ctr"/>
          <a:lstStyle>
            <a:lvl1pPr algn="l" fontAlgn="auto">
              <a:spcBef>
                <a:spcPts val="0"/>
              </a:spcBef>
              <a:spcAft>
                <a:spcPts val="0"/>
              </a:spcAft>
              <a:defRPr sz="1200">
                <a:solidFill>
                  <a:schemeClr val="tx1">
                    <a:tint val="75000"/>
                  </a:schemeClr>
                </a:solidFill>
                <a:latin typeface="+mn-lt"/>
                <a:cs typeface="+mn-cs"/>
              </a:defRPr>
            </a:lvl1pPr>
          </a:lstStyle>
          <a:p>
            <a:pPr>
              <a:defRPr/>
            </a:pPr>
            <a:fld id="{CB0EB5BA-2B80-4ACB-9C8D-D5EAD84ABAD9}" type="datetimeFigureOut">
              <a:rPr lang="en-US"/>
              <a:pPr>
                <a:defRPr/>
              </a:pPr>
              <a:t>5/19/2016</a:t>
            </a:fld>
            <a:endParaRPr lang="en-IN"/>
          </a:p>
        </p:txBody>
      </p:sp>
      <p:sp>
        <p:nvSpPr>
          <p:cNvPr id="5" name="Footer Placeholder 4"/>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cs typeface="+mn-cs"/>
              </a:defRPr>
            </a:lvl1pPr>
          </a:lstStyle>
          <a:p>
            <a:pPr>
              <a:defRPr/>
            </a:pPr>
            <a:endParaRPr lang="en-IN"/>
          </a:p>
        </p:txBody>
      </p:sp>
      <p:sp>
        <p:nvSpPr>
          <p:cNvPr id="6" name="Slide Number Placeholder 5"/>
          <p:cNvSpPr>
            <a:spLocks noGrp="1"/>
          </p:cNvSpPr>
          <p:nvPr>
            <p:ph type="sldNum" sz="quarter" idx="4"/>
          </p:nvPr>
        </p:nvSpPr>
        <p:spPr>
          <a:xfrm>
            <a:off x="4914900" y="8475663"/>
            <a:ext cx="1600200" cy="485775"/>
          </a:xfrm>
          <a:prstGeom prst="rect">
            <a:avLst/>
          </a:prstGeom>
        </p:spPr>
        <p:txBody>
          <a:bodyPr vert="horz" lIns="91440" tIns="45720" rIns="91440" bIns="45720" rtlCol="0" anchor="ctr"/>
          <a:lstStyle>
            <a:lvl1pPr algn="r" fontAlgn="auto">
              <a:spcBef>
                <a:spcPts val="0"/>
              </a:spcBef>
              <a:spcAft>
                <a:spcPts val="0"/>
              </a:spcAft>
              <a:defRPr sz="1200">
                <a:solidFill>
                  <a:schemeClr val="tx1">
                    <a:tint val="75000"/>
                  </a:schemeClr>
                </a:solidFill>
                <a:latin typeface="+mn-lt"/>
                <a:cs typeface="+mn-cs"/>
              </a:defRPr>
            </a:lvl1pPr>
          </a:lstStyle>
          <a:p>
            <a:pPr>
              <a:defRPr/>
            </a:pPr>
            <a:fld id="{D7629131-76A7-495B-8D7A-C3B43746698C}" type="slidenum">
              <a:rPr lang="en-IN"/>
              <a:pPr>
                <a:defRPr/>
              </a:pPr>
              <a:t>‹#›</a:t>
            </a:fld>
            <a:endParaRPr lang="en-IN"/>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342900" y="366713"/>
            <a:ext cx="6172200" cy="1524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endParaRPr lang="en-IN" smtClean="0"/>
          </a:p>
        </p:txBody>
      </p:sp>
      <p:sp>
        <p:nvSpPr>
          <p:cNvPr id="2051" name="Text Placeholder 2"/>
          <p:cNvSpPr>
            <a:spLocks noGrp="1"/>
          </p:cNvSpPr>
          <p:nvPr>
            <p:ph type="body" idx="1"/>
          </p:nvPr>
        </p:nvSpPr>
        <p:spPr bwMode="auto">
          <a:xfrm>
            <a:off x="342900" y="2133600"/>
            <a:ext cx="6172200" cy="60340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smtClean="0"/>
          </a:p>
        </p:txBody>
      </p:sp>
      <p:sp>
        <p:nvSpPr>
          <p:cNvPr id="4" name="Date Placeholder 3"/>
          <p:cNvSpPr>
            <a:spLocks noGrp="1"/>
          </p:cNvSpPr>
          <p:nvPr>
            <p:ph type="dt" sz="half" idx="2"/>
          </p:nvPr>
        </p:nvSpPr>
        <p:spPr>
          <a:xfrm>
            <a:off x="342900" y="8475663"/>
            <a:ext cx="1600200" cy="485775"/>
          </a:xfrm>
          <a:prstGeom prst="rect">
            <a:avLst/>
          </a:prstGeom>
        </p:spPr>
        <p:txBody>
          <a:bodyPr vert="horz" lIns="91440" tIns="45720" rIns="91440" bIns="45720" rtlCol="0" anchor="ctr"/>
          <a:lstStyle>
            <a:lvl1pPr algn="l" eaLnBrk="1" fontAlgn="auto" hangingPunct="1">
              <a:spcBef>
                <a:spcPts val="0"/>
              </a:spcBef>
              <a:spcAft>
                <a:spcPts val="0"/>
              </a:spcAft>
              <a:defRPr sz="1200">
                <a:solidFill>
                  <a:schemeClr val="tx1">
                    <a:tint val="75000"/>
                  </a:schemeClr>
                </a:solidFill>
                <a:latin typeface="+mn-lt"/>
                <a:cs typeface="+mn-cs"/>
              </a:defRPr>
            </a:lvl1pPr>
          </a:lstStyle>
          <a:p>
            <a:pPr>
              <a:defRPr/>
            </a:pPr>
            <a:fld id="{3AF1BEC9-043E-4ADD-8138-7E50AD8357B7}" type="datetimeFigureOut">
              <a:rPr lang="en-US"/>
              <a:pPr>
                <a:defRPr/>
              </a:pPr>
              <a:t>5/19/2016</a:t>
            </a:fld>
            <a:endParaRPr lang="en-IN"/>
          </a:p>
        </p:txBody>
      </p:sp>
      <p:sp>
        <p:nvSpPr>
          <p:cNvPr id="5" name="Footer Placeholder 4"/>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cs typeface="+mn-cs"/>
              </a:defRPr>
            </a:lvl1pPr>
          </a:lstStyle>
          <a:p>
            <a:pPr>
              <a:defRPr/>
            </a:pPr>
            <a:endParaRPr lang="en-IN"/>
          </a:p>
        </p:txBody>
      </p:sp>
      <p:sp>
        <p:nvSpPr>
          <p:cNvPr id="6" name="Slide Number Placeholder 5"/>
          <p:cNvSpPr>
            <a:spLocks noGrp="1"/>
          </p:cNvSpPr>
          <p:nvPr>
            <p:ph type="sldNum" sz="quarter" idx="4"/>
          </p:nvPr>
        </p:nvSpPr>
        <p:spPr>
          <a:xfrm>
            <a:off x="4914900" y="8475663"/>
            <a:ext cx="1600200" cy="485775"/>
          </a:xfrm>
          <a:prstGeom prst="rect">
            <a:avLst/>
          </a:prstGeom>
        </p:spPr>
        <p:txBody>
          <a:bodyPr vert="horz" wrap="square" lIns="91440" tIns="45720" rIns="91440" bIns="45720" numCol="1" anchor="ctr" anchorCtr="0" compatLnSpc="1">
            <a:prstTxWarp prst="textNoShape">
              <a:avLst/>
            </a:prstTxWarp>
          </a:bodyPr>
          <a:lstStyle>
            <a:lvl1pPr algn="r" eaLnBrk="1" hangingPunct="1">
              <a:defRPr sz="1200">
                <a:solidFill>
                  <a:srgbClr val="898989"/>
                </a:solidFill>
                <a:latin typeface="Calibri" pitchFamily="34" charset="0"/>
                <a:cs typeface="Arial" charset="0"/>
              </a:defRPr>
            </a:lvl1pPr>
          </a:lstStyle>
          <a:p>
            <a:pPr>
              <a:defRPr/>
            </a:pPr>
            <a:fld id="{971B3DD2-185B-471B-A2A7-FEF1D427F42B}" type="slidenum">
              <a:rPr lang="en-IN"/>
              <a:pPr>
                <a:defRPr/>
              </a:pPr>
              <a:t>‹#›</a:t>
            </a:fld>
            <a:endParaRPr lang="en-IN"/>
          </a:p>
        </p:txBody>
      </p:sp>
    </p:spTree>
  </p:cSld>
  <p:clrMap bg1="lt1" tx1="dk1" bg2="lt2" tx2="dk2" accent1="accent1" accent2="accent2" accent3="accent3" accent4="accent4" accent5="accent5" accent6="accent6" hlink="hlink" folHlink="folHlink"/>
  <p:sldLayoutIdLst>
    <p:sldLayoutId id="2147483672" r:id="rId1"/>
    <p:sldLayoutId id="2147483673" r:id="rId2"/>
    <p:sldLayoutId id="2147483674" r:id="rId3"/>
    <p:sldLayoutId id="2147483675" r:id="rId4"/>
    <p:sldLayoutId id="2147483676" r:id="rId5"/>
    <p:sldLayoutId id="2147483677" r:id="rId6"/>
    <p:sldLayoutId id="2147483678" r:id="rId7"/>
    <p:sldLayoutId id="2147483679" r:id="rId8"/>
    <p:sldLayoutId id="2147483680" r:id="rId9"/>
    <p:sldLayoutId id="2147483681" r:id="rId10"/>
    <p:sldLayoutId id="2147483682"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chart" Target="../charts/chart7.xml"/><Relationship Id="rId2" Type="http://schemas.openxmlformats.org/officeDocument/2006/relationships/image" Target="../media/image11.png"/><Relationship Id="rId1" Type="http://schemas.openxmlformats.org/officeDocument/2006/relationships/slideLayout" Target="../slideLayouts/slideLayout18.xml"/><Relationship Id="rId4" Type="http://schemas.openxmlformats.org/officeDocument/2006/relationships/image" Target="../media/image12.jpe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12.xml.rels><?xml version="1.0" encoding="UTF-8" standalone="yes"?>
<Relationships xmlns="http://schemas.openxmlformats.org/package/2006/relationships"><Relationship Id="rId8" Type="http://schemas.openxmlformats.org/officeDocument/2006/relationships/image" Target="../media/image13.png"/><Relationship Id="rId13" Type="http://schemas.openxmlformats.org/officeDocument/2006/relationships/image" Target="../media/image18.png"/><Relationship Id="rId3" Type="http://schemas.openxmlformats.org/officeDocument/2006/relationships/diagramData" Target="../diagrams/data1.xml"/><Relationship Id="rId7" Type="http://schemas.microsoft.com/office/2007/relationships/diagramDrawing" Target="../diagrams/drawing1.xml"/><Relationship Id="rId12" Type="http://schemas.openxmlformats.org/officeDocument/2006/relationships/image" Target="../media/image17.png"/><Relationship Id="rId17" Type="http://schemas.openxmlformats.org/officeDocument/2006/relationships/image" Target="../media/image22.png"/><Relationship Id="rId2" Type="http://schemas.openxmlformats.org/officeDocument/2006/relationships/notesSlide" Target="../notesSlides/notesSlide4.xml"/><Relationship Id="rId16" Type="http://schemas.openxmlformats.org/officeDocument/2006/relationships/image" Target="../media/image21.png"/><Relationship Id="rId1" Type="http://schemas.openxmlformats.org/officeDocument/2006/relationships/slideLayout" Target="../slideLayouts/slideLayout18.xml"/><Relationship Id="rId6" Type="http://schemas.openxmlformats.org/officeDocument/2006/relationships/diagramColors" Target="../diagrams/colors1.xml"/><Relationship Id="rId11" Type="http://schemas.openxmlformats.org/officeDocument/2006/relationships/image" Target="../media/image16.png"/><Relationship Id="rId5" Type="http://schemas.openxmlformats.org/officeDocument/2006/relationships/diagramQuickStyle" Target="../diagrams/quickStyle1.xml"/><Relationship Id="rId15" Type="http://schemas.openxmlformats.org/officeDocument/2006/relationships/image" Target="../media/image20.png"/><Relationship Id="rId10" Type="http://schemas.openxmlformats.org/officeDocument/2006/relationships/image" Target="../media/image15.png"/><Relationship Id="rId4" Type="http://schemas.openxmlformats.org/officeDocument/2006/relationships/diagramLayout" Target="../diagrams/layout1.xml"/><Relationship Id="rId9" Type="http://schemas.openxmlformats.org/officeDocument/2006/relationships/image" Target="../media/image14.png"/><Relationship Id="rId14" Type="http://schemas.openxmlformats.org/officeDocument/2006/relationships/image" Target="../media/image19.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8.xml"/><Relationship Id="rId5" Type="http://schemas.openxmlformats.org/officeDocument/2006/relationships/image" Target="../media/image5.emf"/><Relationship Id="rId4" Type="http://schemas.openxmlformats.org/officeDocument/2006/relationships/chart" Target="../charts/char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7.xml.rels><?xml version="1.0" encoding="UTF-8" standalone="yes"?>
<Relationships xmlns="http://schemas.openxmlformats.org/package/2006/relationships"><Relationship Id="rId3" Type="http://schemas.openxmlformats.org/officeDocument/2006/relationships/chart" Target="../charts/chart3.xml"/><Relationship Id="rId7"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18.xml"/><Relationship Id="rId6" Type="http://schemas.openxmlformats.org/officeDocument/2006/relationships/chart" Target="../charts/chart6.xml"/><Relationship Id="rId5" Type="http://schemas.openxmlformats.org/officeDocument/2006/relationships/chart" Target="../charts/chart5.xml"/><Relationship Id="rId4" Type="http://schemas.openxmlformats.org/officeDocument/2006/relationships/chart" Target="../charts/chart4.xm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18.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9.xml.rels><?xml version="1.0" encoding="UTF-8" standalone="yes"?>
<Relationships xmlns="http://schemas.openxmlformats.org/package/2006/relationships"><Relationship Id="rId2" Type="http://schemas.openxmlformats.org/officeDocument/2006/relationships/hyperlink" Target="http://www.broadinstitute.org/cancer/software/GENE-E/" TargetMode="External"/><Relationship Id="rId1" Type="http://schemas.openxmlformats.org/officeDocument/2006/relationships/slideLayout" Target="../slideLayouts/slideLayout1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74" name="Group 14"/>
          <p:cNvGrpSpPr>
            <a:grpSpLocks/>
          </p:cNvGrpSpPr>
          <p:nvPr/>
        </p:nvGrpSpPr>
        <p:grpSpPr bwMode="auto">
          <a:xfrm>
            <a:off x="309933" y="448432"/>
            <a:ext cx="3904880" cy="4074333"/>
            <a:chOff x="310225" y="-857276"/>
            <a:chExt cx="3904597" cy="4072989"/>
          </a:xfrm>
        </p:grpSpPr>
        <p:grpSp>
          <p:nvGrpSpPr>
            <p:cNvPr id="3076" name="Group 11"/>
            <p:cNvGrpSpPr>
              <a:grpSpLocks/>
            </p:cNvGrpSpPr>
            <p:nvPr/>
          </p:nvGrpSpPr>
          <p:grpSpPr bwMode="auto">
            <a:xfrm>
              <a:off x="310225" y="-857276"/>
              <a:ext cx="3904597" cy="4072989"/>
              <a:chOff x="310225" y="-357178"/>
              <a:chExt cx="3904597" cy="4072989"/>
            </a:xfrm>
          </p:grpSpPr>
          <p:grpSp>
            <p:nvGrpSpPr>
              <p:cNvPr id="3078" name="Group 75"/>
              <p:cNvGrpSpPr>
                <a:grpSpLocks/>
              </p:cNvGrpSpPr>
              <p:nvPr/>
            </p:nvGrpSpPr>
            <p:grpSpPr bwMode="auto">
              <a:xfrm>
                <a:off x="2181850" y="638378"/>
                <a:ext cx="2032972" cy="1814761"/>
                <a:chOff x="2496223" y="682436"/>
                <a:chExt cx="2253567" cy="1361589"/>
              </a:xfrm>
            </p:grpSpPr>
            <p:sp>
              <p:nvSpPr>
                <p:cNvPr id="3081" name="TextBox 64"/>
                <p:cNvSpPr txBox="1">
                  <a:spLocks noChangeArrowheads="1"/>
                </p:cNvSpPr>
                <p:nvPr/>
              </p:nvSpPr>
              <p:spPr bwMode="auto">
                <a:xfrm>
                  <a:off x="2928746" y="1882444"/>
                  <a:ext cx="1757738" cy="161581"/>
                </a:xfrm>
                <a:prstGeom prst="rect">
                  <a:avLst/>
                </a:prstGeom>
                <a:noFill/>
                <a:ln w="9525">
                  <a:noFill/>
                  <a:miter lim="800000"/>
                  <a:headEnd/>
                  <a:tailEnd/>
                </a:ln>
              </p:spPr>
              <p:txBody>
                <a:bodyPr wrap="none">
                  <a:spAutoFit/>
                </a:bodyPr>
                <a:lstStyle/>
                <a:p>
                  <a:r>
                    <a:rPr lang="en-US" sz="800" b="1"/>
                    <a:t>Days after water withholding</a:t>
                  </a:r>
                </a:p>
              </p:txBody>
            </p:sp>
            <p:pic>
              <p:nvPicPr>
                <p:cNvPr id="3082" name="Picture 3"/>
                <p:cNvPicPr>
                  <a:picLocks noChangeAspect="1" noChangeArrowheads="1"/>
                </p:cNvPicPr>
                <p:nvPr/>
              </p:nvPicPr>
              <p:blipFill>
                <a:blip r:embed="rId2"/>
                <a:srcRect/>
                <a:stretch>
                  <a:fillRect/>
                </a:stretch>
              </p:blipFill>
              <p:spPr bwMode="auto">
                <a:xfrm>
                  <a:off x="2690858" y="682436"/>
                  <a:ext cx="2058932" cy="1239154"/>
                </a:xfrm>
                <a:prstGeom prst="rect">
                  <a:avLst/>
                </a:prstGeom>
                <a:noFill/>
                <a:ln w="9525">
                  <a:noFill/>
                  <a:miter lim="800000"/>
                  <a:headEnd/>
                  <a:tailEnd/>
                </a:ln>
              </p:spPr>
            </p:pic>
            <p:sp>
              <p:nvSpPr>
                <p:cNvPr id="3083" name="TextBox 65"/>
                <p:cNvSpPr txBox="1">
                  <a:spLocks noChangeArrowheads="1"/>
                </p:cNvSpPr>
                <p:nvPr/>
              </p:nvSpPr>
              <p:spPr bwMode="auto">
                <a:xfrm rot="-5400000">
                  <a:off x="2219976" y="1135703"/>
                  <a:ext cx="791313" cy="238820"/>
                </a:xfrm>
                <a:prstGeom prst="rect">
                  <a:avLst/>
                </a:prstGeom>
                <a:noFill/>
                <a:ln w="9525">
                  <a:noFill/>
                  <a:miter lim="800000"/>
                  <a:headEnd/>
                  <a:tailEnd/>
                </a:ln>
              </p:spPr>
              <p:txBody>
                <a:bodyPr wrap="none">
                  <a:spAutoFit/>
                </a:bodyPr>
                <a:lstStyle/>
                <a:p>
                  <a:r>
                    <a:rPr lang="en-US" sz="800" b="1"/>
                    <a:t>Field capacity (%)</a:t>
                  </a:r>
                </a:p>
              </p:txBody>
            </p:sp>
          </p:grpSp>
          <p:sp>
            <p:nvSpPr>
              <p:cNvPr id="3079" name="Rectangle 70"/>
              <p:cNvSpPr>
                <a:spLocks noChangeArrowheads="1"/>
              </p:cNvSpPr>
              <p:nvPr/>
            </p:nvSpPr>
            <p:spPr bwMode="auto">
              <a:xfrm>
                <a:off x="310225" y="-357178"/>
                <a:ext cx="1894934" cy="276908"/>
              </a:xfrm>
              <a:prstGeom prst="rect">
                <a:avLst/>
              </a:prstGeom>
              <a:noFill/>
              <a:ln w="9525">
                <a:noFill/>
                <a:miter lim="800000"/>
                <a:headEnd/>
                <a:tailEnd/>
              </a:ln>
            </p:spPr>
            <p:txBody>
              <a:bodyPr wrap="none">
                <a:spAutoFit/>
              </a:bodyPr>
              <a:lstStyle/>
              <a:p>
                <a:r>
                  <a:rPr lang="en-US" sz="1200" b="1" dirty="0" smtClean="0"/>
                  <a:t>Supplementary figure 1</a:t>
                </a:r>
                <a:endParaRPr lang="en-US" sz="1200" b="1" dirty="0"/>
              </a:p>
            </p:txBody>
          </p:sp>
          <p:sp>
            <p:nvSpPr>
              <p:cNvPr id="3080" name="Rectangle 74"/>
              <p:cNvSpPr>
                <a:spLocks noChangeArrowheads="1"/>
              </p:cNvSpPr>
              <p:nvPr/>
            </p:nvSpPr>
            <p:spPr bwMode="auto">
              <a:xfrm>
                <a:off x="357166" y="3500438"/>
                <a:ext cx="325706" cy="215373"/>
              </a:xfrm>
              <a:prstGeom prst="rect">
                <a:avLst/>
              </a:prstGeom>
              <a:noFill/>
              <a:ln w="9525">
                <a:noFill/>
                <a:miter lim="800000"/>
                <a:headEnd/>
                <a:tailEnd/>
              </a:ln>
            </p:spPr>
            <p:txBody>
              <a:bodyPr wrap="none">
                <a:spAutoFit/>
              </a:bodyPr>
              <a:lstStyle/>
              <a:p>
                <a:r>
                  <a:rPr lang="en-US" sz="800" b="1"/>
                  <a:t>(B)</a:t>
                </a:r>
              </a:p>
            </p:txBody>
          </p:sp>
        </p:grpSp>
        <p:sp>
          <p:nvSpPr>
            <p:cNvPr id="3077" name="Rectangle 74"/>
            <p:cNvSpPr>
              <a:spLocks noChangeArrowheads="1"/>
            </p:cNvSpPr>
            <p:nvPr/>
          </p:nvSpPr>
          <p:spPr bwMode="auto">
            <a:xfrm>
              <a:off x="428604" y="428596"/>
              <a:ext cx="325706" cy="215373"/>
            </a:xfrm>
            <a:prstGeom prst="rect">
              <a:avLst/>
            </a:prstGeom>
            <a:noFill/>
            <a:ln w="9525">
              <a:noFill/>
              <a:miter lim="800000"/>
              <a:headEnd/>
              <a:tailEnd/>
            </a:ln>
          </p:spPr>
          <p:txBody>
            <a:bodyPr wrap="none">
              <a:spAutoFit/>
            </a:bodyPr>
            <a:lstStyle/>
            <a:p>
              <a:r>
                <a:rPr lang="en-US" sz="800" b="1" dirty="0"/>
                <a:t>(A)</a:t>
              </a:r>
            </a:p>
          </p:txBody>
        </p:sp>
      </p:grpSp>
      <p:pic>
        <p:nvPicPr>
          <p:cNvPr id="3075" name="Picture 13"/>
          <p:cNvPicPr>
            <a:picLocks noChangeAspect="1" noChangeArrowheads="1"/>
          </p:cNvPicPr>
          <p:nvPr/>
        </p:nvPicPr>
        <p:blipFill>
          <a:blip r:embed="rId3"/>
          <a:srcRect/>
          <a:stretch>
            <a:fillRect/>
          </a:stretch>
        </p:blipFill>
        <p:spPr bwMode="auto">
          <a:xfrm>
            <a:off x="1357313" y="4306888"/>
            <a:ext cx="4429125" cy="3336925"/>
          </a:xfrm>
          <a:prstGeom prst="rect">
            <a:avLst/>
          </a:prstGeom>
          <a:noFill/>
          <a:ln w="9525">
            <a:noFill/>
            <a:miter lim="800000"/>
            <a:headEnd/>
            <a:tailEnd/>
          </a:ln>
        </p:spPr>
      </p:pic>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533400" y="1143000"/>
            <a:ext cx="5582933" cy="1005274"/>
            <a:chOff x="716280" y="3992855"/>
            <a:chExt cx="5582933" cy="1005274"/>
          </a:xfrm>
        </p:grpSpPr>
        <p:sp>
          <p:nvSpPr>
            <p:cNvPr id="3" name="TextBox 136"/>
            <p:cNvSpPr txBox="1">
              <a:spLocks noChangeArrowheads="1"/>
            </p:cNvSpPr>
            <p:nvPr/>
          </p:nvSpPr>
          <p:spPr bwMode="auto">
            <a:xfrm>
              <a:off x="4678769" y="3992855"/>
              <a:ext cx="1031051" cy="230832"/>
            </a:xfrm>
            <a:prstGeom prst="rect">
              <a:avLst/>
            </a:prstGeom>
            <a:noFill/>
            <a:ln w="9525">
              <a:noFill/>
              <a:miter lim="800000"/>
              <a:headEnd/>
              <a:tailEnd/>
            </a:ln>
          </p:spPr>
          <p:txBody>
            <a:bodyPr wrap="none">
              <a:spAutoFit/>
            </a:bodyPr>
            <a:lstStyle/>
            <a:p>
              <a:pPr algn="r"/>
              <a:r>
                <a:rPr lang="en-US" sz="900" dirty="0">
                  <a:latin typeface="Arial" pitchFamily="34" charset="0"/>
                  <a:cs typeface="Arial" pitchFamily="34" charset="0"/>
                </a:rPr>
                <a:t>LB             RB    </a:t>
              </a:r>
            </a:p>
          </p:txBody>
        </p:sp>
        <p:sp>
          <p:nvSpPr>
            <p:cNvPr id="4" name="Pentagon 3"/>
            <p:cNvSpPr/>
            <p:nvPr/>
          </p:nvSpPr>
          <p:spPr bwMode="auto">
            <a:xfrm>
              <a:off x="5645467" y="4588934"/>
              <a:ext cx="430212" cy="97366"/>
            </a:xfrm>
            <a:prstGeom prst="homePlat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sz="900">
                <a:latin typeface="Arial" pitchFamily="34" charset="0"/>
                <a:cs typeface="Arial" pitchFamily="34" charset="0"/>
              </a:endParaRPr>
            </a:p>
          </p:txBody>
        </p:sp>
        <p:sp>
          <p:nvSpPr>
            <p:cNvPr id="5" name="Rectangle 4"/>
            <p:cNvSpPr/>
            <p:nvPr/>
          </p:nvSpPr>
          <p:spPr bwMode="auto">
            <a:xfrm>
              <a:off x="4685030" y="4588934"/>
              <a:ext cx="960438" cy="97366"/>
            </a:xfrm>
            <a:prstGeom prst="rect">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sz="900">
                <a:latin typeface="Arial" pitchFamily="34" charset="0"/>
                <a:cs typeface="Arial" pitchFamily="34" charset="0"/>
              </a:endParaRPr>
            </a:p>
          </p:txBody>
        </p:sp>
        <p:cxnSp>
          <p:nvCxnSpPr>
            <p:cNvPr id="6" name="Straight Connector 5"/>
            <p:cNvCxnSpPr/>
            <p:nvPr/>
          </p:nvCxnSpPr>
          <p:spPr bwMode="auto">
            <a:xfrm flipV="1">
              <a:off x="4423093" y="4646084"/>
              <a:ext cx="271462" cy="211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 name="Rectangle 6"/>
            <p:cNvSpPr/>
            <p:nvPr/>
          </p:nvSpPr>
          <p:spPr bwMode="auto">
            <a:xfrm>
              <a:off x="3613468" y="4601633"/>
              <a:ext cx="809625" cy="95250"/>
            </a:xfrm>
            <a:prstGeom prst="rect">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sz="900">
                <a:latin typeface="Arial" pitchFamily="34" charset="0"/>
                <a:cs typeface="Arial" pitchFamily="34" charset="0"/>
              </a:endParaRPr>
            </a:p>
          </p:txBody>
        </p:sp>
        <p:cxnSp>
          <p:nvCxnSpPr>
            <p:cNvPr id="8" name="Straight Connector 7"/>
            <p:cNvCxnSpPr/>
            <p:nvPr/>
          </p:nvCxnSpPr>
          <p:spPr bwMode="auto">
            <a:xfrm>
              <a:off x="3349943" y="4648200"/>
              <a:ext cx="263525" cy="423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 name="Rectangle 8"/>
            <p:cNvSpPr/>
            <p:nvPr/>
          </p:nvSpPr>
          <p:spPr bwMode="auto">
            <a:xfrm>
              <a:off x="2707004" y="4593167"/>
              <a:ext cx="631825" cy="97366"/>
            </a:xfrm>
            <a:prstGeom prst="rect">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sz="900">
                <a:latin typeface="Arial" pitchFamily="34" charset="0"/>
                <a:cs typeface="Arial" pitchFamily="34" charset="0"/>
              </a:endParaRPr>
            </a:p>
          </p:txBody>
        </p:sp>
        <p:sp>
          <p:nvSpPr>
            <p:cNvPr id="10" name="Rectangle 9"/>
            <p:cNvSpPr/>
            <p:nvPr/>
          </p:nvSpPr>
          <p:spPr bwMode="auto">
            <a:xfrm>
              <a:off x="2332355" y="4593167"/>
              <a:ext cx="374650" cy="9736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sz="900" dirty="0">
                <a:latin typeface="Arial" pitchFamily="34" charset="0"/>
                <a:cs typeface="Arial" pitchFamily="34" charset="0"/>
              </a:endParaRPr>
            </a:p>
          </p:txBody>
        </p:sp>
        <p:cxnSp>
          <p:nvCxnSpPr>
            <p:cNvPr id="11" name="Straight Arrow Connector 10"/>
            <p:cNvCxnSpPr/>
            <p:nvPr/>
          </p:nvCxnSpPr>
          <p:spPr bwMode="auto">
            <a:xfrm>
              <a:off x="4946968" y="4754033"/>
              <a:ext cx="436562" cy="2117"/>
            </a:xfrm>
            <a:prstGeom prst="straightConnector1">
              <a:avLst/>
            </a:prstGeom>
            <a:ln>
              <a:solidFill>
                <a:schemeClr val="tx1"/>
              </a:solidFill>
              <a:headEnd type="arrow"/>
              <a:tailEnd type="arrow"/>
            </a:ln>
          </p:spPr>
          <p:style>
            <a:lnRef idx="1">
              <a:schemeClr val="accent1"/>
            </a:lnRef>
            <a:fillRef idx="0">
              <a:schemeClr val="accent1"/>
            </a:fillRef>
            <a:effectRef idx="0">
              <a:schemeClr val="accent1"/>
            </a:effectRef>
            <a:fontRef idx="minor">
              <a:schemeClr val="tx1"/>
            </a:fontRef>
          </p:style>
        </p:cxnSp>
        <p:sp>
          <p:nvSpPr>
            <p:cNvPr id="12" name="TextBox 148"/>
            <p:cNvSpPr txBox="1">
              <a:spLocks noChangeArrowheads="1"/>
            </p:cNvSpPr>
            <p:nvPr/>
          </p:nvSpPr>
          <p:spPr bwMode="auto">
            <a:xfrm>
              <a:off x="4713808" y="4767297"/>
              <a:ext cx="1031051" cy="230832"/>
            </a:xfrm>
            <a:prstGeom prst="rect">
              <a:avLst/>
            </a:prstGeom>
            <a:noFill/>
            <a:ln w="9525">
              <a:noFill/>
              <a:miter lim="800000"/>
              <a:headEnd/>
              <a:tailEnd/>
            </a:ln>
          </p:spPr>
          <p:txBody>
            <a:bodyPr wrap="none">
              <a:spAutoFit/>
            </a:bodyPr>
            <a:lstStyle/>
            <a:p>
              <a:r>
                <a:rPr lang="en-US" sz="900" b="1" dirty="0">
                  <a:latin typeface="Arial" pitchFamily="34" charset="0"/>
                  <a:cs typeface="Arial" pitchFamily="34" charset="0"/>
                </a:rPr>
                <a:t>SALK_090154C</a:t>
              </a:r>
              <a:endParaRPr lang="en-IN" sz="900" b="1" dirty="0">
                <a:latin typeface="Arial" pitchFamily="34" charset="0"/>
                <a:cs typeface="Arial" pitchFamily="34" charset="0"/>
              </a:endParaRPr>
            </a:p>
          </p:txBody>
        </p:sp>
        <p:sp>
          <p:nvSpPr>
            <p:cNvPr id="13" name="TextBox 150"/>
            <p:cNvSpPr txBox="1">
              <a:spLocks noChangeArrowheads="1"/>
            </p:cNvSpPr>
            <p:nvPr/>
          </p:nvSpPr>
          <p:spPr bwMode="auto">
            <a:xfrm>
              <a:off x="2133617" y="4558334"/>
              <a:ext cx="274434" cy="230832"/>
            </a:xfrm>
            <a:prstGeom prst="rect">
              <a:avLst/>
            </a:prstGeom>
            <a:noFill/>
            <a:ln w="9525">
              <a:noFill/>
              <a:miter lim="800000"/>
              <a:headEnd/>
              <a:tailEnd/>
            </a:ln>
          </p:spPr>
          <p:txBody>
            <a:bodyPr wrap="none">
              <a:spAutoFit/>
            </a:bodyPr>
            <a:lstStyle/>
            <a:p>
              <a:r>
                <a:rPr lang="en-US" sz="900">
                  <a:latin typeface="Arial" pitchFamily="34" charset="0"/>
                  <a:cs typeface="Arial" pitchFamily="34" charset="0"/>
                </a:rPr>
                <a:t>5’</a:t>
              </a:r>
            </a:p>
          </p:txBody>
        </p:sp>
        <p:sp>
          <p:nvSpPr>
            <p:cNvPr id="14" name="TextBox 151"/>
            <p:cNvSpPr txBox="1">
              <a:spLocks noChangeArrowheads="1"/>
            </p:cNvSpPr>
            <p:nvPr/>
          </p:nvSpPr>
          <p:spPr bwMode="auto">
            <a:xfrm>
              <a:off x="6024779" y="4544178"/>
              <a:ext cx="274434" cy="230832"/>
            </a:xfrm>
            <a:prstGeom prst="rect">
              <a:avLst/>
            </a:prstGeom>
            <a:noFill/>
            <a:ln w="9525">
              <a:noFill/>
              <a:miter lim="800000"/>
              <a:headEnd/>
              <a:tailEnd/>
            </a:ln>
          </p:spPr>
          <p:txBody>
            <a:bodyPr wrap="none">
              <a:spAutoFit/>
            </a:bodyPr>
            <a:lstStyle/>
            <a:p>
              <a:r>
                <a:rPr lang="en-US" sz="900">
                  <a:latin typeface="Arial" pitchFamily="34" charset="0"/>
                  <a:cs typeface="Arial" pitchFamily="34" charset="0"/>
                </a:rPr>
                <a:t>3’</a:t>
              </a:r>
            </a:p>
          </p:txBody>
        </p:sp>
        <p:cxnSp>
          <p:nvCxnSpPr>
            <p:cNvPr id="15" name="Straight Arrow Connector 14"/>
            <p:cNvCxnSpPr/>
            <p:nvPr/>
          </p:nvCxnSpPr>
          <p:spPr bwMode="auto">
            <a:xfrm flipH="1">
              <a:off x="5926455" y="4527551"/>
              <a:ext cx="103188"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bwMode="auto">
            <a:xfrm>
              <a:off x="2359343" y="4527551"/>
              <a:ext cx="107950"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7" name="TextBox 154"/>
            <p:cNvSpPr txBox="1">
              <a:spLocks noChangeArrowheads="1"/>
            </p:cNvSpPr>
            <p:nvPr/>
          </p:nvSpPr>
          <p:spPr bwMode="auto">
            <a:xfrm>
              <a:off x="5821093" y="4278370"/>
              <a:ext cx="344966" cy="230832"/>
            </a:xfrm>
            <a:prstGeom prst="rect">
              <a:avLst/>
            </a:prstGeom>
            <a:noFill/>
            <a:ln w="9525">
              <a:noFill/>
              <a:miter lim="800000"/>
              <a:headEnd/>
              <a:tailEnd/>
            </a:ln>
          </p:spPr>
          <p:txBody>
            <a:bodyPr wrap="none">
              <a:spAutoFit/>
            </a:bodyPr>
            <a:lstStyle/>
            <a:p>
              <a:r>
                <a:rPr lang="en-US" sz="900">
                  <a:latin typeface="Arial" pitchFamily="34" charset="0"/>
                  <a:cs typeface="Arial" pitchFamily="34" charset="0"/>
                </a:rPr>
                <a:t>RP</a:t>
              </a:r>
            </a:p>
          </p:txBody>
        </p:sp>
        <p:sp>
          <p:nvSpPr>
            <p:cNvPr id="18" name="TextBox 155"/>
            <p:cNvSpPr txBox="1">
              <a:spLocks noChangeArrowheads="1"/>
            </p:cNvSpPr>
            <p:nvPr/>
          </p:nvSpPr>
          <p:spPr bwMode="auto">
            <a:xfrm>
              <a:off x="2265455" y="4272012"/>
              <a:ext cx="325730" cy="230832"/>
            </a:xfrm>
            <a:prstGeom prst="rect">
              <a:avLst/>
            </a:prstGeom>
            <a:noFill/>
            <a:ln w="9525">
              <a:noFill/>
              <a:miter lim="800000"/>
              <a:headEnd/>
              <a:tailEnd/>
            </a:ln>
          </p:spPr>
          <p:txBody>
            <a:bodyPr wrap="none">
              <a:spAutoFit/>
            </a:bodyPr>
            <a:lstStyle/>
            <a:p>
              <a:r>
                <a:rPr lang="en-US" sz="900">
                  <a:latin typeface="Arial" pitchFamily="34" charset="0"/>
                  <a:cs typeface="Arial" pitchFamily="34" charset="0"/>
                </a:rPr>
                <a:t>LP</a:t>
              </a:r>
            </a:p>
          </p:txBody>
        </p:sp>
        <p:cxnSp>
          <p:nvCxnSpPr>
            <p:cNvPr id="19" name="Straight Connector 18"/>
            <p:cNvCxnSpPr/>
            <p:nvPr/>
          </p:nvCxnSpPr>
          <p:spPr bwMode="auto">
            <a:xfrm flipV="1">
              <a:off x="5231130" y="4203700"/>
              <a:ext cx="109538" cy="37888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bwMode="auto">
            <a:xfrm flipH="1" flipV="1">
              <a:off x="5129530" y="4216400"/>
              <a:ext cx="101600" cy="3767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Rectangle 20"/>
            <p:cNvSpPr/>
            <p:nvPr/>
          </p:nvSpPr>
          <p:spPr bwMode="auto">
            <a:xfrm>
              <a:off x="5129530" y="4155017"/>
              <a:ext cx="211138" cy="5503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900">
                <a:latin typeface="Arial" pitchFamily="34" charset="0"/>
                <a:cs typeface="Arial" pitchFamily="34" charset="0"/>
              </a:endParaRPr>
            </a:p>
          </p:txBody>
        </p:sp>
        <p:cxnSp>
          <p:nvCxnSpPr>
            <p:cNvPr id="22" name="Straight Arrow Connector 21"/>
            <p:cNvCxnSpPr/>
            <p:nvPr/>
          </p:nvCxnSpPr>
          <p:spPr bwMode="auto">
            <a:xfrm>
              <a:off x="5132705" y="4110567"/>
              <a:ext cx="65088"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p:nvPr/>
          </p:nvCxnSpPr>
          <p:spPr bwMode="auto">
            <a:xfrm flipH="1">
              <a:off x="5269230" y="4108451"/>
              <a:ext cx="63500"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4" name="Rectangle 134"/>
            <p:cNvSpPr>
              <a:spLocks noChangeArrowheads="1"/>
            </p:cNvSpPr>
            <p:nvPr/>
          </p:nvSpPr>
          <p:spPr bwMode="auto">
            <a:xfrm>
              <a:off x="716280" y="4351317"/>
              <a:ext cx="1440005" cy="369332"/>
            </a:xfrm>
            <a:prstGeom prst="rect">
              <a:avLst/>
            </a:prstGeom>
            <a:noFill/>
            <a:ln w="9525">
              <a:solidFill>
                <a:schemeClr val="tx1"/>
              </a:solidFill>
              <a:miter lim="800000"/>
              <a:headEnd/>
              <a:tailEnd/>
            </a:ln>
          </p:spPr>
          <p:txBody>
            <a:bodyPr>
              <a:spAutoFit/>
            </a:bodyPr>
            <a:lstStyle/>
            <a:p>
              <a:r>
                <a:rPr lang="en-US" sz="900" b="1" dirty="0">
                  <a:latin typeface="Arial" pitchFamily="34" charset="0"/>
                  <a:cs typeface="Arial" pitchFamily="34" charset="0"/>
                </a:rPr>
                <a:t>Gene ID    : AT5G39610</a:t>
              </a:r>
            </a:p>
            <a:p>
              <a:r>
                <a:rPr lang="en-US" sz="900" b="1" dirty="0">
                  <a:latin typeface="Arial" pitchFamily="34" charset="0"/>
                  <a:cs typeface="Arial" pitchFamily="34" charset="0"/>
                </a:rPr>
                <a:t>Gene size: 1389 </a:t>
              </a:r>
              <a:r>
                <a:rPr lang="en-US" sz="900" b="1" dirty="0" err="1">
                  <a:latin typeface="Arial" pitchFamily="34" charset="0"/>
                  <a:cs typeface="Arial" pitchFamily="34" charset="0"/>
                </a:rPr>
                <a:t>bp</a:t>
              </a:r>
              <a:endParaRPr lang="en-US" sz="900" b="1" dirty="0">
                <a:latin typeface="Arial" pitchFamily="34" charset="0"/>
                <a:cs typeface="Arial" pitchFamily="34" charset="0"/>
              </a:endParaRPr>
            </a:p>
          </p:txBody>
        </p:sp>
      </p:grpSp>
      <p:grpSp>
        <p:nvGrpSpPr>
          <p:cNvPr id="25" name="Group 40"/>
          <p:cNvGrpSpPr/>
          <p:nvPr/>
        </p:nvGrpSpPr>
        <p:grpSpPr>
          <a:xfrm>
            <a:off x="1040028" y="2329542"/>
            <a:ext cx="2277982" cy="2440576"/>
            <a:chOff x="533400" y="2734192"/>
            <a:chExt cx="1404745" cy="1990208"/>
          </a:xfrm>
        </p:grpSpPr>
        <p:grpSp>
          <p:nvGrpSpPr>
            <p:cNvPr id="26" name="Group 24"/>
            <p:cNvGrpSpPr/>
            <p:nvPr/>
          </p:nvGrpSpPr>
          <p:grpSpPr>
            <a:xfrm>
              <a:off x="550113" y="2734192"/>
              <a:ext cx="1388032" cy="1054188"/>
              <a:chOff x="2805577" y="620324"/>
              <a:chExt cx="1388032" cy="1054188"/>
            </a:xfrm>
          </p:grpSpPr>
          <p:grpSp>
            <p:nvGrpSpPr>
              <p:cNvPr id="28" name="Group 411"/>
              <p:cNvGrpSpPr/>
              <p:nvPr/>
            </p:nvGrpSpPr>
            <p:grpSpPr>
              <a:xfrm>
                <a:off x="2805577" y="753745"/>
                <a:ext cx="1236816" cy="920767"/>
                <a:chOff x="2805577" y="753745"/>
                <a:chExt cx="1236816" cy="920767"/>
              </a:xfrm>
            </p:grpSpPr>
            <p:sp>
              <p:nvSpPr>
                <p:cNvPr id="29" name="TextBox 46"/>
                <p:cNvSpPr txBox="1">
                  <a:spLocks noChangeArrowheads="1"/>
                </p:cNvSpPr>
                <p:nvPr/>
              </p:nvSpPr>
              <p:spPr bwMode="auto">
                <a:xfrm rot="16200000">
                  <a:off x="3160529" y="1125019"/>
                  <a:ext cx="894384" cy="151835"/>
                </a:xfrm>
                <a:prstGeom prst="rect">
                  <a:avLst/>
                </a:prstGeom>
                <a:noFill/>
                <a:ln w="9525">
                  <a:noFill/>
                  <a:miter lim="800000"/>
                  <a:headEnd/>
                  <a:tailEnd/>
                </a:ln>
              </p:spPr>
              <p:txBody>
                <a:bodyPr wrap="none">
                  <a:spAutoFit/>
                </a:bodyPr>
                <a:lstStyle/>
                <a:p>
                  <a:r>
                    <a:rPr lang="en-US" sz="1000" dirty="0" smtClean="0">
                      <a:latin typeface="Arial" pitchFamily="34" charset="0"/>
                      <a:cs typeface="Arial" pitchFamily="34" charset="0"/>
                    </a:rPr>
                    <a:t>SALK_090154C</a:t>
                  </a:r>
                  <a:endParaRPr lang="en-US" sz="1000" dirty="0">
                    <a:latin typeface="Arial" pitchFamily="34" charset="0"/>
                    <a:cs typeface="Arial" pitchFamily="34" charset="0"/>
                  </a:endParaRPr>
                </a:p>
              </p:txBody>
            </p:sp>
            <p:sp>
              <p:nvSpPr>
                <p:cNvPr id="30" name="TextBox 47"/>
                <p:cNvSpPr txBox="1">
                  <a:spLocks noChangeArrowheads="1"/>
                </p:cNvSpPr>
                <p:nvPr/>
              </p:nvSpPr>
              <p:spPr bwMode="auto">
                <a:xfrm rot="16200000">
                  <a:off x="3519284" y="1138569"/>
                  <a:ext cx="894384" cy="151835"/>
                </a:xfrm>
                <a:prstGeom prst="rect">
                  <a:avLst/>
                </a:prstGeom>
                <a:noFill/>
                <a:ln w="9525">
                  <a:noFill/>
                  <a:miter lim="800000"/>
                  <a:headEnd/>
                  <a:tailEnd/>
                </a:ln>
              </p:spPr>
              <p:txBody>
                <a:bodyPr wrap="none">
                  <a:spAutoFit/>
                </a:bodyPr>
                <a:lstStyle/>
                <a:p>
                  <a:r>
                    <a:rPr lang="en-US" sz="1000" dirty="0" smtClean="0">
                      <a:latin typeface="Arial" pitchFamily="34" charset="0"/>
                      <a:cs typeface="Arial" pitchFamily="34" charset="0"/>
                    </a:rPr>
                    <a:t>SALK_090154C</a:t>
                  </a:r>
                  <a:endParaRPr lang="en-US" sz="1000" dirty="0">
                    <a:latin typeface="Arial" pitchFamily="34" charset="0"/>
                    <a:cs typeface="Arial" pitchFamily="34" charset="0"/>
                  </a:endParaRPr>
                </a:p>
              </p:txBody>
            </p:sp>
            <p:sp>
              <p:nvSpPr>
                <p:cNvPr id="31" name="TextBox 48"/>
                <p:cNvSpPr txBox="1">
                  <a:spLocks noChangeArrowheads="1"/>
                </p:cNvSpPr>
                <p:nvPr/>
              </p:nvSpPr>
              <p:spPr bwMode="auto">
                <a:xfrm rot="16200000">
                  <a:off x="2807047" y="1125869"/>
                  <a:ext cx="894384" cy="151835"/>
                </a:xfrm>
                <a:prstGeom prst="rect">
                  <a:avLst/>
                </a:prstGeom>
                <a:noFill/>
                <a:ln w="9525">
                  <a:noFill/>
                  <a:miter lim="800000"/>
                  <a:headEnd/>
                  <a:tailEnd/>
                </a:ln>
              </p:spPr>
              <p:txBody>
                <a:bodyPr wrap="none">
                  <a:spAutoFit/>
                </a:bodyPr>
                <a:lstStyle/>
                <a:p>
                  <a:r>
                    <a:rPr lang="en-US" sz="1000" dirty="0" smtClean="0">
                      <a:latin typeface="Arial" pitchFamily="34" charset="0"/>
                      <a:cs typeface="Arial" pitchFamily="34" charset="0"/>
                    </a:rPr>
                    <a:t>SALK_090154C</a:t>
                  </a:r>
                  <a:endParaRPr lang="en-US" sz="1000" dirty="0">
                    <a:latin typeface="Arial" pitchFamily="34" charset="0"/>
                    <a:cs typeface="Arial" pitchFamily="34" charset="0"/>
                  </a:endParaRPr>
                </a:p>
              </p:txBody>
            </p:sp>
            <p:sp>
              <p:nvSpPr>
                <p:cNvPr id="32" name="TextBox 49"/>
                <p:cNvSpPr txBox="1">
                  <a:spLocks noChangeArrowheads="1"/>
                </p:cNvSpPr>
                <p:nvPr/>
              </p:nvSpPr>
              <p:spPr bwMode="auto">
                <a:xfrm rot="16200000">
                  <a:off x="2916218" y="1439885"/>
                  <a:ext cx="313989" cy="151835"/>
                </a:xfrm>
                <a:prstGeom prst="rect">
                  <a:avLst/>
                </a:prstGeom>
                <a:noFill/>
                <a:ln w="9525">
                  <a:noFill/>
                  <a:miter lim="800000"/>
                  <a:headEnd/>
                  <a:tailEnd/>
                </a:ln>
              </p:spPr>
              <p:txBody>
                <a:bodyPr wrap="none">
                  <a:spAutoFit/>
                </a:bodyPr>
                <a:lstStyle/>
                <a:p>
                  <a:r>
                    <a:rPr lang="en-US" sz="1000" dirty="0">
                      <a:latin typeface="Arial" pitchFamily="34" charset="0"/>
                      <a:cs typeface="Arial" pitchFamily="34" charset="0"/>
                    </a:rPr>
                    <a:t>WT</a:t>
                  </a:r>
                </a:p>
              </p:txBody>
            </p:sp>
            <p:sp>
              <p:nvSpPr>
                <p:cNvPr id="33" name="TextBox 50"/>
                <p:cNvSpPr txBox="1">
                  <a:spLocks noChangeArrowheads="1"/>
                </p:cNvSpPr>
                <p:nvPr/>
              </p:nvSpPr>
              <p:spPr bwMode="auto">
                <a:xfrm rot="16200000">
                  <a:off x="2661755" y="1370518"/>
                  <a:ext cx="439479" cy="151835"/>
                </a:xfrm>
                <a:prstGeom prst="rect">
                  <a:avLst/>
                </a:prstGeom>
                <a:noFill/>
                <a:ln w="9525">
                  <a:noFill/>
                  <a:miter lim="800000"/>
                  <a:headEnd/>
                  <a:tailEnd/>
                </a:ln>
              </p:spPr>
              <p:txBody>
                <a:bodyPr wrap="none">
                  <a:spAutoFit/>
                </a:bodyPr>
                <a:lstStyle/>
                <a:p>
                  <a:r>
                    <a:rPr lang="en-US" sz="1000" dirty="0">
                      <a:latin typeface="Arial" pitchFamily="34" charset="0"/>
                      <a:cs typeface="Arial" pitchFamily="34" charset="0"/>
                    </a:rPr>
                    <a:t>ladder</a:t>
                  </a:r>
                </a:p>
              </p:txBody>
            </p:sp>
            <p:sp>
              <p:nvSpPr>
                <p:cNvPr id="34" name="TextBox 51"/>
                <p:cNvSpPr txBox="1">
                  <a:spLocks noChangeArrowheads="1"/>
                </p:cNvSpPr>
                <p:nvPr/>
              </p:nvSpPr>
              <p:spPr bwMode="auto">
                <a:xfrm rot="16200000">
                  <a:off x="3634194" y="1441600"/>
                  <a:ext cx="313989" cy="151835"/>
                </a:xfrm>
                <a:prstGeom prst="rect">
                  <a:avLst/>
                </a:prstGeom>
                <a:noFill/>
                <a:ln w="9525">
                  <a:noFill/>
                  <a:miter lim="800000"/>
                  <a:headEnd/>
                  <a:tailEnd/>
                </a:ln>
              </p:spPr>
              <p:txBody>
                <a:bodyPr wrap="none">
                  <a:spAutoFit/>
                </a:bodyPr>
                <a:lstStyle/>
                <a:p>
                  <a:r>
                    <a:rPr lang="en-US" sz="1000">
                      <a:latin typeface="Arial" pitchFamily="34" charset="0"/>
                      <a:cs typeface="Arial" pitchFamily="34" charset="0"/>
                    </a:rPr>
                    <a:t>WT</a:t>
                  </a:r>
                </a:p>
              </p:txBody>
            </p:sp>
            <p:sp>
              <p:nvSpPr>
                <p:cNvPr id="35" name="TextBox 52"/>
                <p:cNvSpPr txBox="1">
                  <a:spLocks noChangeArrowheads="1"/>
                </p:cNvSpPr>
                <p:nvPr/>
              </p:nvSpPr>
              <p:spPr bwMode="auto">
                <a:xfrm rot="16200000">
                  <a:off x="3289125" y="1440421"/>
                  <a:ext cx="313989" cy="151835"/>
                </a:xfrm>
                <a:prstGeom prst="rect">
                  <a:avLst/>
                </a:prstGeom>
                <a:noFill/>
                <a:ln w="9525">
                  <a:noFill/>
                  <a:miter lim="800000"/>
                  <a:headEnd/>
                  <a:tailEnd/>
                </a:ln>
              </p:spPr>
              <p:txBody>
                <a:bodyPr wrap="none">
                  <a:spAutoFit/>
                </a:bodyPr>
                <a:lstStyle/>
                <a:p>
                  <a:r>
                    <a:rPr lang="en-US" sz="1000">
                      <a:latin typeface="Arial" pitchFamily="34" charset="0"/>
                      <a:cs typeface="Arial" pitchFamily="34" charset="0"/>
                    </a:rPr>
                    <a:t>WT</a:t>
                  </a:r>
                </a:p>
              </p:txBody>
            </p:sp>
            <p:cxnSp>
              <p:nvCxnSpPr>
                <p:cNvPr id="36" name="Straight Connector 35"/>
                <p:cNvCxnSpPr/>
                <p:nvPr/>
              </p:nvCxnSpPr>
              <p:spPr bwMode="auto">
                <a:xfrm>
                  <a:off x="2957531" y="833372"/>
                  <a:ext cx="2571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bwMode="auto">
                <a:xfrm>
                  <a:off x="3346907" y="833372"/>
                  <a:ext cx="2571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bwMode="auto">
                <a:xfrm>
                  <a:off x="3704532" y="833372"/>
                  <a:ext cx="2571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7" name="TextBox 56"/>
              <p:cNvSpPr txBox="1">
                <a:spLocks noChangeArrowheads="1"/>
              </p:cNvSpPr>
              <p:nvPr/>
            </p:nvSpPr>
            <p:spPr bwMode="auto">
              <a:xfrm>
                <a:off x="3042557" y="620324"/>
                <a:ext cx="1151052" cy="200785"/>
              </a:xfrm>
              <a:prstGeom prst="rect">
                <a:avLst/>
              </a:prstGeom>
              <a:noFill/>
              <a:ln w="9525">
                <a:noFill/>
                <a:miter lim="800000"/>
                <a:headEnd/>
                <a:tailEnd/>
              </a:ln>
            </p:spPr>
            <p:txBody>
              <a:bodyPr>
                <a:spAutoFit/>
              </a:bodyPr>
              <a:lstStyle/>
              <a:p>
                <a:r>
                  <a:rPr lang="en-US" sz="1000" b="1" dirty="0" err="1" smtClean="0">
                    <a:latin typeface="Arial" pitchFamily="34" charset="0"/>
                    <a:cs typeface="Arial" pitchFamily="34" charset="0"/>
                  </a:rPr>
                  <a:t>i</a:t>
                </a:r>
                <a:r>
                  <a:rPr lang="en-US" sz="1000" b="1" dirty="0" smtClean="0">
                    <a:latin typeface="Arial" pitchFamily="34" charset="0"/>
                    <a:cs typeface="Arial" pitchFamily="34" charset="0"/>
                  </a:rPr>
                  <a:t>                   ii                  iii    </a:t>
                </a:r>
                <a:endParaRPr lang="en-US" sz="1000" b="1" dirty="0">
                  <a:latin typeface="Arial" pitchFamily="34" charset="0"/>
                  <a:cs typeface="Arial" pitchFamily="34" charset="0"/>
                </a:endParaRPr>
              </a:p>
            </p:txBody>
          </p:sp>
        </p:grpSp>
        <p:pic>
          <p:nvPicPr>
            <p:cNvPr id="40" name="Picture 236"/>
            <p:cNvPicPr preferRelativeResize="0">
              <a:picLocks noChangeArrowheads="1"/>
            </p:cNvPicPr>
            <p:nvPr/>
          </p:nvPicPr>
          <p:blipFill>
            <a:blip r:embed="rId2">
              <a:lum bright="10000" contrast="10000"/>
            </a:blip>
            <a:srcRect l="5078" b="6663"/>
            <a:stretch>
              <a:fillRect/>
            </a:stretch>
          </p:blipFill>
          <p:spPr bwMode="auto">
            <a:xfrm>
              <a:off x="533400" y="3810000"/>
              <a:ext cx="1280160" cy="914400"/>
            </a:xfrm>
            <a:prstGeom prst="rect">
              <a:avLst/>
            </a:prstGeom>
            <a:noFill/>
            <a:ln w="9525">
              <a:noFill/>
              <a:miter lim="800000"/>
              <a:headEnd/>
              <a:tailEnd/>
            </a:ln>
            <a:effectLst/>
          </p:spPr>
        </p:pic>
      </p:grpSp>
      <p:grpSp>
        <p:nvGrpSpPr>
          <p:cNvPr id="41" name="Group 47"/>
          <p:cNvGrpSpPr/>
          <p:nvPr/>
        </p:nvGrpSpPr>
        <p:grpSpPr>
          <a:xfrm>
            <a:off x="2057400" y="5562600"/>
            <a:ext cx="2895598" cy="2577644"/>
            <a:chOff x="457202" y="4724400"/>
            <a:chExt cx="2895598" cy="2577644"/>
          </a:xfrm>
        </p:grpSpPr>
        <p:grpSp>
          <p:nvGrpSpPr>
            <p:cNvPr id="42" name="Group 45"/>
            <p:cNvGrpSpPr/>
            <p:nvPr/>
          </p:nvGrpSpPr>
          <p:grpSpPr>
            <a:xfrm>
              <a:off x="457202" y="4724400"/>
              <a:ext cx="2895598" cy="2577644"/>
              <a:chOff x="457202" y="4724400"/>
              <a:chExt cx="2895598" cy="2577644"/>
            </a:xfrm>
          </p:grpSpPr>
          <p:graphicFrame>
            <p:nvGraphicFramePr>
              <p:cNvPr id="43" name="Chart 42"/>
              <p:cNvGraphicFramePr/>
              <p:nvPr/>
            </p:nvGraphicFramePr>
            <p:xfrm>
              <a:off x="762000" y="4724400"/>
              <a:ext cx="2590800" cy="2514600"/>
            </p:xfrm>
            <a:graphic>
              <a:graphicData uri="http://schemas.openxmlformats.org/drawingml/2006/chart">
                <c:chart xmlns:c="http://schemas.openxmlformats.org/drawingml/2006/chart" xmlns:r="http://schemas.openxmlformats.org/officeDocument/2006/relationships" r:id="rId3"/>
              </a:graphicData>
            </a:graphic>
          </p:graphicFrame>
          <p:sp>
            <p:nvSpPr>
              <p:cNvPr id="44" name="TextBox 2"/>
              <p:cNvSpPr txBox="1">
                <a:spLocks noChangeArrowheads="1"/>
              </p:cNvSpPr>
              <p:nvPr/>
            </p:nvSpPr>
            <p:spPr bwMode="auto">
              <a:xfrm rot="16200000">
                <a:off x="-107056" y="5745858"/>
                <a:ext cx="1467069" cy="338554"/>
              </a:xfrm>
              <a:prstGeom prst="rect">
                <a:avLst/>
              </a:prstGeom>
              <a:noFill/>
              <a:ln w="9525">
                <a:noFill/>
                <a:miter lim="800000"/>
                <a:headEnd/>
                <a:tailEnd/>
              </a:ln>
            </p:spPr>
            <p:txBody>
              <a:bodyPr wrap="none">
                <a:spAutoFit/>
              </a:bodyPr>
              <a:lstStyle/>
              <a:p>
                <a:pPr algn="ctr" eaLnBrk="1" hangingPunct="1">
                  <a:buFont typeface="Arial" charset="0"/>
                  <a:buNone/>
                </a:pPr>
                <a:r>
                  <a:rPr lang="en-US" altLang="en-US" sz="800" b="1" i="1" dirty="0">
                    <a:solidFill>
                      <a:srgbClr val="000000"/>
                    </a:solidFill>
                    <a:latin typeface="Arial" pitchFamily="34" charset="0"/>
                    <a:cs typeface="Arial" pitchFamily="34" charset="0"/>
                  </a:rPr>
                  <a:t>In </a:t>
                </a:r>
                <a:r>
                  <a:rPr lang="en-US" altLang="en-US" sz="800" b="1" i="1" dirty="0" err="1">
                    <a:solidFill>
                      <a:srgbClr val="000000"/>
                    </a:solidFill>
                    <a:latin typeface="Arial" pitchFamily="34" charset="0"/>
                    <a:cs typeface="Arial" pitchFamily="34" charset="0"/>
                  </a:rPr>
                  <a:t>planta</a:t>
                </a:r>
                <a:r>
                  <a:rPr lang="en-US" altLang="en-US" sz="800" b="1" i="1" dirty="0">
                    <a:solidFill>
                      <a:srgbClr val="000000"/>
                    </a:solidFill>
                    <a:latin typeface="Arial" pitchFamily="34" charset="0"/>
                    <a:cs typeface="Arial" pitchFamily="34" charset="0"/>
                  </a:rPr>
                  <a:t> </a:t>
                </a:r>
                <a:r>
                  <a:rPr lang="en-US" altLang="en-US" sz="800" b="1" dirty="0">
                    <a:solidFill>
                      <a:srgbClr val="000000"/>
                    </a:solidFill>
                    <a:latin typeface="Arial" pitchFamily="34" charset="0"/>
                    <a:cs typeface="Arial" pitchFamily="34" charset="0"/>
                  </a:rPr>
                  <a:t>bacterial number</a:t>
                </a:r>
              </a:p>
              <a:p>
                <a:pPr algn="ctr" eaLnBrk="1" hangingPunct="1"/>
                <a:r>
                  <a:rPr lang="en-US" altLang="en-US" sz="800" b="1" dirty="0">
                    <a:latin typeface="Arial" pitchFamily="34" charset="0"/>
                    <a:cs typeface="Arial" pitchFamily="34" charset="0"/>
                  </a:rPr>
                  <a:t>Log (CFU/cm</a:t>
                </a:r>
                <a:r>
                  <a:rPr lang="en-US" altLang="en-US" sz="800" b="1" baseline="30000" dirty="0">
                    <a:latin typeface="Arial" pitchFamily="34" charset="0"/>
                    <a:cs typeface="Arial" pitchFamily="34" charset="0"/>
                  </a:rPr>
                  <a:t>2</a:t>
                </a:r>
                <a:r>
                  <a:rPr lang="en-US" altLang="en-US" sz="800" b="1" dirty="0">
                    <a:latin typeface="Arial" pitchFamily="34" charset="0"/>
                    <a:cs typeface="Arial" pitchFamily="34" charset="0"/>
                  </a:rPr>
                  <a:t>)</a:t>
                </a:r>
              </a:p>
            </p:txBody>
          </p:sp>
          <p:sp>
            <p:nvSpPr>
              <p:cNvPr id="45" name="TextBox 44"/>
              <p:cNvSpPr txBox="1"/>
              <p:nvPr/>
            </p:nvSpPr>
            <p:spPr>
              <a:xfrm>
                <a:off x="1752600" y="7086600"/>
                <a:ext cx="739305" cy="215444"/>
              </a:xfrm>
              <a:prstGeom prst="rect">
                <a:avLst/>
              </a:prstGeom>
              <a:noFill/>
            </p:spPr>
            <p:txBody>
              <a:bodyPr wrap="none" rtlCol="0">
                <a:spAutoFit/>
              </a:bodyPr>
              <a:lstStyle/>
              <a:p>
                <a:r>
                  <a:rPr lang="en-US" sz="800" b="1" dirty="0" smtClean="0">
                    <a:latin typeface="Arial" pitchFamily="34" charset="0"/>
                    <a:cs typeface="Arial" pitchFamily="34" charset="0"/>
                  </a:rPr>
                  <a:t>Treatments</a:t>
                </a:r>
                <a:endParaRPr lang="en-US" sz="800" b="1" dirty="0">
                  <a:latin typeface="Arial" pitchFamily="34" charset="0"/>
                  <a:cs typeface="Arial" pitchFamily="34" charset="0"/>
                </a:endParaRPr>
              </a:p>
            </p:txBody>
          </p:sp>
        </p:grpSp>
        <p:sp>
          <p:nvSpPr>
            <p:cNvPr id="47" name="TextBox 46"/>
            <p:cNvSpPr txBox="1"/>
            <p:nvPr/>
          </p:nvSpPr>
          <p:spPr>
            <a:xfrm>
              <a:off x="2451102" y="5433596"/>
              <a:ext cx="264816" cy="338554"/>
            </a:xfrm>
            <a:prstGeom prst="rect">
              <a:avLst/>
            </a:prstGeom>
            <a:noFill/>
          </p:spPr>
          <p:txBody>
            <a:bodyPr wrap="none" rtlCol="0">
              <a:spAutoFit/>
            </a:bodyPr>
            <a:lstStyle/>
            <a:p>
              <a:r>
                <a:rPr lang="en-US" sz="1600" b="1" dirty="0" smtClean="0">
                  <a:latin typeface="Arial" pitchFamily="34" charset="0"/>
                  <a:cs typeface="Arial" pitchFamily="34" charset="0"/>
                </a:rPr>
                <a:t>*</a:t>
              </a:r>
              <a:endParaRPr lang="en-US" sz="1600" b="1" dirty="0">
                <a:latin typeface="Arial" pitchFamily="34" charset="0"/>
                <a:cs typeface="Arial" pitchFamily="34" charset="0"/>
              </a:endParaRPr>
            </a:p>
          </p:txBody>
        </p:sp>
      </p:grpSp>
      <p:sp>
        <p:nvSpPr>
          <p:cNvPr id="49" name="Rectangle 70"/>
          <p:cNvSpPr>
            <a:spLocks noChangeArrowheads="1"/>
          </p:cNvSpPr>
          <p:nvPr/>
        </p:nvSpPr>
        <p:spPr bwMode="auto">
          <a:xfrm>
            <a:off x="1905000" y="838200"/>
            <a:ext cx="2173993" cy="307777"/>
          </a:xfrm>
          <a:prstGeom prst="rect">
            <a:avLst/>
          </a:prstGeom>
          <a:noFill/>
          <a:ln w="9525">
            <a:noFill/>
            <a:miter lim="800000"/>
            <a:headEnd/>
            <a:tailEnd/>
          </a:ln>
        </p:spPr>
        <p:txBody>
          <a:bodyPr wrap="none">
            <a:spAutoFit/>
          </a:bodyPr>
          <a:lstStyle/>
          <a:p>
            <a:r>
              <a:rPr lang="en-US" sz="1400" b="1" dirty="0" smtClean="0">
                <a:latin typeface="Arial" pitchFamily="34" charset="0"/>
                <a:cs typeface="Arial" pitchFamily="34" charset="0"/>
              </a:rPr>
              <a:t>Supplementary figure 7</a:t>
            </a:r>
            <a:endParaRPr lang="en-US" sz="1400" b="1" dirty="0">
              <a:latin typeface="Arial" pitchFamily="34" charset="0"/>
              <a:cs typeface="Arial" pitchFamily="34" charset="0"/>
            </a:endParaRPr>
          </a:p>
        </p:txBody>
      </p:sp>
      <p:grpSp>
        <p:nvGrpSpPr>
          <p:cNvPr id="55" name="Group 54"/>
          <p:cNvGrpSpPr/>
          <p:nvPr/>
        </p:nvGrpSpPr>
        <p:grpSpPr>
          <a:xfrm>
            <a:off x="4681489" y="2640178"/>
            <a:ext cx="1566911" cy="2101268"/>
            <a:chOff x="4267200" y="1401928"/>
            <a:chExt cx="1566911" cy="2101268"/>
          </a:xfrm>
        </p:grpSpPr>
        <p:pic>
          <p:nvPicPr>
            <p:cNvPr id="1026" name="Picture 2" descr="C:\Users\Dell\Downloads\WT NAC-ACT PS RT2.jpg"/>
            <p:cNvPicPr>
              <a:picLocks noChangeAspect="1" noChangeArrowheads="1"/>
            </p:cNvPicPr>
            <p:nvPr/>
          </p:nvPicPr>
          <p:blipFill>
            <a:blip r:embed="rId4" cstate="print"/>
            <a:srcRect/>
            <a:stretch>
              <a:fillRect/>
            </a:stretch>
          </p:blipFill>
          <p:spPr bwMode="auto">
            <a:xfrm>
              <a:off x="4267200" y="2438401"/>
              <a:ext cx="914400" cy="1064795"/>
            </a:xfrm>
            <a:prstGeom prst="rect">
              <a:avLst/>
            </a:prstGeom>
            <a:noFill/>
          </p:spPr>
        </p:pic>
        <p:grpSp>
          <p:nvGrpSpPr>
            <p:cNvPr id="52" name="Group 51"/>
            <p:cNvGrpSpPr/>
            <p:nvPr/>
          </p:nvGrpSpPr>
          <p:grpSpPr>
            <a:xfrm>
              <a:off x="4343400" y="1401928"/>
              <a:ext cx="627221" cy="1096775"/>
              <a:chOff x="847038" y="1643317"/>
              <a:chExt cx="627221" cy="1096775"/>
            </a:xfrm>
          </p:grpSpPr>
          <p:sp>
            <p:nvSpPr>
              <p:cNvPr id="50" name="TextBox 48"/>
              <p:cNvSpPr txBox="1">
                <a:spLocks noChangeArrowheads="1"/>
              </p:cNvSpPr>
              <p:nvPr/>
            </p:nvSpPr>
            <p:spPr bwMode="auto">
              <a:xfrm rot="16200000">
                <a:off x="802761" y="2068594"/>
                <a:ext cx="1096775" cy="246221"/>
              </a:xfrm>
              <a:prstGeom prst="rect">
                <a:avLst/>
              </a:prstGeom>
              <a:noFill/>
              <a:ln w="9525">
                <a:noFill/>
                <a:miter lim="800000"/>
                <a:headEnd/>
                <a:tailEnd/>
              </a:ln>
            </p:spPr>
            <p:txBody>
              <a:bodyPr wrap="none">
                <a:spAutoFit/>
              </a:bodyPr>
              <a:lstStyle/>
              <a:p>
                <a:r>
                  <a:rPr lang="en-US" sz="1000" dirty="0" smtClean="0">
                    <a:latin typeface="Arial" pitchFamily="34" charset="0"/>
                    <a:cs typeface="Arial" pitchFamily="34" charset="0"/>
                  </a:rPr>
                  <a:t>SALK_090154C</a:t>
                </a:r>
                <a:endParaRPr lang="en-US" sz="1000" dirty="0">
                  <a:latin typeface="Arial" pitchFamily="34" charset="0"/>
                  <a:cs typeface="Arial" pitchFamily="34" charset="0"/>
                </a:endParaRPr>
              </a:p>
            </p:txBody>
          </p:sp>
          <p:sp>
            <p:nvSpPr>
              <p:cNvPr id="51" name="TextBox 49"/>
              <p:cNvSpPr txBox="1">
                <a:spLocks noChangeArrowheads="1"/>
              </p:cNvSpPr>
              <p:nvPr/>
            </p:nvSpPr>
            <p:spPr bwMode="auto">
              <a:xfrm rot="16200000">
                <a:off x="777628" y="2363561"/>
                <a:ext cx="385042" cy="246221"/>
              </a:xfrm>
              <a:prstGeom prst="rect">
                <a:avLst/>
              </a:prstGeom>
              <a:noFill/>
              <a:ln w="9525">
                <a:noFill/>
                <a:miter lim="800000"/>
                <a:headEnd/>
                <a:tailEnd/>
              </a:ln>
            </p:spPr>
            <p:txBody>
              <a:bodyPr wrap="none">
                <a:spAutoFit/>
              </a:bodyPr>
              <a:lstStyle/>
              <a:p>
                <a:r>
                  <a:rPr lang="en-US" sz="1000" dirty="0">
                    <a:latin typeface="Arial" pitchFamily="34" charset="0"/>
                    <a:cs typeface="Arial" pitchFamily="34" charset="0"/>
                  </a:rPr>
                  <a:t>WT</a:t>
                </a:r>
              </a:p>
            </p:txBody>
          </p:sp>
        </p:grpSp>
        <p:sp>
          <p:nvSpPr>
            <p:cNvPr id="53" name="TextBox 52"/>
            <p:cNvSpPr txBox="1"/>
            <p:nvPr/>
          </p:nvSpPr>
          <p:spPr>
            <a:xfrm>
              <a:off x="5181606" y="2496456"/>
              <a:ext cx="570990" cy="215444"/>
            </a:xfrm>
            <a:prstGeom prst="rect">
              <a:avLst/>
            </a:prstGeom>
            <a:noFill/>
          </p:spPr>
          <p:txBody>
            <a:bodyPr wrap="none" rtlCol="0">
              <a:spAutoFit/>
            </a:bodyPr>
            <a:lstStyle/>
            <a:p>
              <a:r>
                <a:rPr lang="en-US" sz="800" b="1" i="1" dirty="0" smtClean="0">
                  <a:latin typeface="Arial" pitchFamily="34" charset="0"/>
                  <a:cs typeface="Arial" pitchFamily="34" charset="0"/>
                </a:rPr>
                <a:t>AtNAC6</a:t>
              </a:r>
              <a:endParaRPr lang="en-US" sz="800" b="1" i="1" dirty="0">
                <a:latin typeface="Arial" pitchFamily="34" charset="0"/>
                <a:cs typeface="Arial" pitchFamily="34" charset="0"/>
              </a:endParaRPr>
            </a:p>
          </p:txBody>
        </p:sp>
        <p:sp>
          <p:nvSpPr>
            <p:cNvPr id="54" name="TextBox 53"/>
            <p:cNvSpPr txBox="1"/>
            <p:nvPr/>
          </p:nvSpPr>
          <p:spPr>
            <a:xfrm>
              <a:off x="5171750" y="3070552"/>
              <a:ext cx="662361" cy="215444"/>
            </a:xfrm>
            <a:prstGeom prst="rect">
              <a:avLst/>
            </a:prstGeom>
            <a:noFill/>
          </p:spPr>
          <p:txBody>
            <a:bodyPr wrap="none" rtlCol="0">
              <a:spAutoFit/>
            </a:bodyPr>
            <a:lstStyle/>
            <a:p>
              <a:r>
                <a:rPr lang="en-US" sz="800" b="1" i="1" dirty="0" smtClean="0">
                  <a:latin typeface="Arial" pitchFamily="34" charset="0"/>
                  <a:cs typeface="Arial" pitchFamily="34" charset="0"/>
                </a:rPr>
                <a:t>AtACTIN2</a:t>
              </a:r>
              <a:endParaRPr lang="en-US" sz="800" b="1" i="1" dirty="0">
                <a:latin typeface="Arial" pitchFamily="34" charset="0"/>
                <a:cs typeface="Arial" pitchFamily="34" charset="0"/>
              </a:endParaRPr>
            </a:p>
          </p:txBody>
        </p:sp>
      </p:grpSp>
      <p:sp>
        <p:nvSpPr>
          <p:cNvPr id="56" name="TextBox 55"/>
          <p:cNvSpPr txBox="1"/>
          <p:nvPr/>
        </p:nvSpPr>
        <p:spPr>
          <a:xfrm>
            <a:off x="304800" y="1219200"/>
            <a:ext cx="258404" cy="215444"/>
          </a:xfrm>
          <a:prstGeom prst="rect">
            <a:avLst/>
          </a:prstGeom>
          <a:noFill/>
        </p:spPr>
        <p:txBody>
          <a:bodyPr wrap="none" rtlCol="0">
            <a:spAutoFit/>
          </a:bodyPr>
          <a:lstStyle/>
          <a:p>
            <a:r>
              <a:rPr lang="en-US" sz="800" b="1" dirty="0" smtClean="0">
                <a:latin typeface="Arial" pitchFamily="34" charset="0"/>
                <a:cs typeface="Arial" pitchFamily="34" charset="0"/>
              </a:rPr>
              <a:t>A</a:t>
            </a:r>
            <a:endParaRPr lang="en-US" sz="800" b="1" dirty="0">
              <a:latin typeface="Arial" pitchFamily="34" charset="0"/>
              <a:cs typeface="Arial" pitchFamily="34" charset="0"/>
            </a:endParaRPr>
          </a:p>
        </p:txBody>
      </p:sp>
      <p:sp>
        <p:nvSpPr>
          <p:cNvPr id="57" name="TextBox 56"/>
          <p:cNvSpPr txBox="1"/>
          <p:nvPr/>
        </p:nvSpPr>
        <p:spPr>
          <a:xfrm>
            <a:off x="381000" y="2971800"/>
            <a:ext cx="258404" cy="215444"/>
          </a:xfrm>
          <a:prstGeom prst="rect">
            <a:avLst/>
          </a:prstGeom>
          <a:noFill/>
        </p:spPr>
        <p:txBody>
          <a:bodyPr wrap="none" rtlCol="0">
            <a:spAutoFit/>
          </a:bodyPr>
          <a:lstStyle/>
          <a:p>
            <a:r>
              <a:rPr lang="en-US" sz="800" b="1" dirty="0" smtClean="0">
                <a:latin typeface="Arial" pitchFamily="34" charset="0"/>
                <a:cs typeface="Arial" pitchFamily="34" charset="0"/>
              </a:rPr>
              <a:t>B</a:t>
            </a:r>
            <a:endParaRPr lang="en-US" sz="800" b="1" dirty="0">
              <a:latin typeface="Arial" pitchFamily="34" charset="0"/>
              <a:cs typeface="Arial" pitchFamily="34" charset="0"/>
            </a:endParaRPr>
          </a:p>
        </p:txBody>
      </p:sp>
      <p:sp>
        <p:nvSpPr>
          <p:cNvPr id="58" name="TextBox 57"/>
          <p:cNvSpPr txBox="1"/>
          <p:nvPr/>
        </p:nvSpPr>
        <p:spPr>
          <a:xfrm>
            <a:off x="457200" y="5715000"/>
            <a:ext cx="258404" cy="215444"/>
          </a:xfrm>
          <a:prstGeom prst="rect">
            <a:avLst/>
          </a:prstGeom>
          <a:noFill/>
        </p:spPr>
        <p:txBody>
          <a:bodyPr wrap="none" rtlCol="0">
            <a:spAutoFit/>
          </a:bodyPr>
          <a:lstStyle/>
          <a:p>
            <a:r>
              <a:rPr lang="en-US" sz="800" b="1" dirty="0" smtClean="0">
                <a:latin typeface="Arial" pitchFamily="34" charset="0"/>
                <a:cs typeface="Arial" pitchFamily="34" charset="0"/>
              </a:rPr>
              <a:t>D</a:t>
            </a:r>
            <a:endParaRPr lang="en-US" sz="800" b="1" dirty="0">
              <a:latin typeface="Arial" pitchFamily="34" charset="0"/>
              <a:cs typeface="Arial" pitchFamily="34" charset="0"/>
            </a:endParaRPr>
          </a:p>
        </p:txBody>
      </p:sp>
      <p:sp>
        <p:nvSpPr>
          <p:cNvPr id="59" name="TextBox 58"/>
          <p:cNvSpPr txBox="1"/>
          <p:nvPr/>
        </p:nvSpPr>
        <p:spPr>
          <a:xfrm>
            <a:off x="4114800" y="2975431"/>
            <a:ext cx="258404" cy="215444"/>
          </a:xfrm>
          <a:prstGeom prst="rect">
            <a:avLst/>
          </a:prstGeom>
          <a:noFill/>
        </p:spPr>
        <p:txBody>
          <a:bodyPr wrap="none" rtlCol="0">
            <a:spAutoFit/>
          </a:bodyPr>
          <a:lstStyle/>
          <a:p>
            <a:r>
              <a:rPr lang="en-US" sz="800" b="1" dirty="0" smtClean="0">
                <a:latin typeface="Arial" pitchFamily="34" charset="0"/>
                <a:cs typeface="Arial" pitchFamily="34" charset="0"/>
              </a:rPr>
              <a:t>C</a:t>
            </a:r>
            <a:endParaRPr lang="en-US" sz="800" b="1" dirty="0">
              <a:latin typeface="Arial" pitchFamily="34" charset="0"/>
              <a:cs typeface="Arial" pitchFamily="34" charset="0"/>
            </a:endParaRPr>
          </a:p>
        </p:txBody>
      </p:sp>
      <p:sp>
        <p:nvSpPr>
          <p:cNvPr id="60" name="Rectangle 59"/>
          <p:cNvSpPr/>
          <p:nvPr/>
        </p:nvSpPr>
        <p:spPr>
          <a:xfrm>
            <a:off x="4386942" y="5895520"/>
            <a:ext cx="272832" cy="215444"/>
          </a:xfrm>
          <a:prstGeom prst="rect">
            <a:avLst/>
          </a:prstGeom>
        </p:spPr>
        <p:txBody>
          <a:bodyPr wrap="none">
            <a:spAutoFit/>
          </a:bodyPr>
          <a:lstStyle/>
          <a:p>
            <a:r>
              <a:rPr lang="en-US" sz="800" b="1" dirty="0" smtClean="0">
                <a:latin typeface="Arial" pitchFamily="34" charset="0"/>
                <a:cs typeface="Arial" pitchFamily="34" charset="0"/>
              </a:rPr>
              <a:t>ǂ </a:t>
            </a:r>
            <a:endParaRPr lang="en-US" sz="800" b="1" dirty="0">
              <a:latin typeface="Arial" pitchFamily="34" charset="0"/>
              <a:cs typeface="Arial" pitchFamily="34" charset="0"/>
            </a:endParaRPr>
          </a:p>
        </p:txBody>
      </p:sp>
    </p:spTree>
    <p:extLst>
      <p:ext uri="{BB962C8B-B14F-4D97-AF65-F5344CB8AC3E}">
        <p14:creationId xmlns:p14="http://schemas.microsoft.com/office/powerpoint/2010/main" val="386013131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2667000"/>
            <a:ext cx="6858000" cy="4339650"/>
          </a:xfrm>
          <a:prstGeom prst="rect">
            <a:avLst/>
          </a:prstGeom>
        </p:spPr>
        <p:txBody>
          <a:bodyPr wrap="square">
            <a:spAutoFit/>
          </a:bodyPr>
          <a:lstStyle/>
          <a:p>
            <a:pPr algn="just" eaLnBrk="0" fontAlgn="base" hangingPunct="0">
              <a:spcBef>
                <a:spcPct val="0"/>
              </a:spcBef>
              <a:spcAft>
                <a:spcPct val="0"/>
              </a:spcAft>
            </a:pPr>
            <a:r>
              <a:rPr lang="en-US" sz="1200" b="1" dirty="0" smtClean="0">
                <a:latin typeface="Arial" panose="020B0604020202020204" pitchFamily="34" charset="0"/>
                <a:cs typeface="Arial" panose="020B0604020202020204" pitchFamily="34" charset="0"/>
              </a:rPr>
              <a:t>Supplementary figure S7.</a:t>
            </a:r>
            <a:r>
              <a:rPr lang="en-IN" sz="1200" b="1" dirty="0" smtClean="0">
                <a:solidFill>
                  <a:srgbClr val="222222"/>
                </a:solidFill>
                <a:latin typeface="Arial" pitchFamily="34" charset="0"/>
                <a:ea typeface="Times New Roman" pitchFamily="18" charset="0"/>
                <a:cs typeface="Arial" pitchFamily="34" charset="0"/>
              </a:rPr>
              <a:t> Response of </a:t>
            </a:r>
            <a:r>
              <a:rPr lang="en-IN" sz="1200" b="1" i="1" dirty="0" smtClean="0">
                <a:solidFill>
                  <a:srgbClr val="222222"/>
                </a:solidFill>
                <a:latin typeface="Arial" pitchFamily="34" charset="0"/>
                <a:ea typeface="Times New Roman" pitchFamily="18" charset="0"/>
                <a:cs typeface="Arial" pitchFamily="34" charset="0"/>
              </a:rPr>
              <a:t>atnac6</a:t>
            </a:r>
            <a:r>
              <a:rPr lang="en-IN" sz="1200" b="1" dirty="0" smtClean="0">
                <a:solidFill>
                  <a:srgbClr val="222222"/>
                </a:solidFill>
                <a:latin typeface="Arial" pitchFamily="34" charset="0"/>
                <a:ea typeface="Times New Roman" pitchFamily="18" charset="0"/>
                <a:cs typeface="Arial" pitchFamily="34" charset="0"/>
              </a:rPr>
              <a:t> mutant plant under combined drought and pathogen stress. </a:t>
            </a:r>
            <a:r>
              <a:rPr lang="en-US" sz="1200" i="1" dirty="0" smtClean="0">
                <a:latin typeface="Arial" pitchFamily="34" charset="0"/>
                <a:cs typeface="Arial" pitchFamily="34" charset="0"/>
              </a:rPr>
              <a:t>Arabidopsis thaliana </a:t>
            </a:r>
            <a:r>
              <a:rPr lang="en-US" sz="1200" dirty="0" smtClean="0">
                <a:latin typeface="Arial" pitchFamily="34" charset="0"/>
                <a:cs typeface="Arial" pitchFamily="34" charset="0"/>
              </a:rPr>
              <a:t>cv. mutants seeds with Col-0  background corresponding to a T-DNA insertion mutation in AtNAC6 gene were obtained as SALK_090154C line from ABRC. </a:t>
            </a:r>
            <a:r>
              <a:rPr lang="en-IN" sz="1200" dirty="0" smtClean="0">
                <a:solidFill>
                  <a:srgbClr val="222222"/>
                </a:solidFill>
                <a:latin typeface="Arial" pitchFamily="34" charset="0"/>
                <a:ea typeface="Times New Roman" pitchFamily="18" charset="0"/>
                <a:cs typeface="Arial" pitchFamily="34" charset="0"/>
              </a:rPr>
              <a:t>Gene structure of </a:t>
            </a:r>
            <a:r>
              <a:rPr lang="en-IN" sz="1200" i="1" dirty="0" smtClean="0">
                <a:solidFill>
                  <a:srgbClr val="222222"/>
                </a:solidFill>
                <a:latin typeface="Arial" pitchFamily="34" charset="0"/>
                <a:ea typeface="Times New Roman" pitchFamily="18" charset="0"/>
                <a:cs typeface="Arial" pitchFamily="34" charset="0"/>
              </a:rPr>
              <a:t>AtNAC6</a:t>
            </a:r>
            <a:r>
              <a:rPr lang="en-IN" sz="1200" dirty="0" smtClean="0">
                <a:solidFill>
                  <a:srgbClr val="222222"/>
                </a:solidFill>
                <a:latin typeface="Arial" pitchFamily="34" charset="0"/>
                <a:ea typeface="Times New Roman" pitchFamily="18" charset="0"/>
                <a:cs typeface="Arial" pitchFamily="34" charset="0"/>
              </a:rPr>
              <a:t> is illustrated here to specify the location of T-DNA insertion </a:t>
            </a:r>
            <a:r>
              <a:rPr lang="en-IN" sz="1200" b="1" dirty="0" smtClean="0">
                <a:solidFill>
                  <a:srgbClr val="222222"/>
                </a:solidFill>
                <a:latin typeface="Arial" pitchFamily="34" charset="0"/>
                <a:ea typeface="Times New Roman" pitchFamily="18" charset="0"/>
                <a:cs typeface="Arial" pitchFamily="34" charset="0"/>
              </a:rPr>
              <a:t>(A)</a:t>
            </a:r>
            <a:r>
              <a:rPr lang="en-IN" sz="1200" dirty="0" smtClean="0">
                <a:solidFill>
                  <a:srgbClr val="222222"/>
                </a:solidFill>
                <a:latin typeface="Arial" pitchFamily="34" charset="0"/>
                <a:ea typeface="Times New Roman" pitchFamily="18" charset="0"/>
                <a:cs typeface="Arial" pitchFamily="34" charset="0"/>
              </a:rPr>
              <a:t>. </a:t>
            </a:r>
            <a:r>
              <a:rPr lang="en-US" sz="1200" dirty="0" smtClean="0">
                <a:latin typeface="Arial" pitchFamily="34" charset="0"/>
                <a:cs typeface="Arial" pitchFamily="34" charset="0"/>
              </a:rPr>
              <a:t>solid boxes, exons; thin lines, introns; empty boxes, untranslated regions. Positions of the primers used for PCR based genotyping are shown here with double headed arrow showing the approximate region distorted by T-DNA insertion. </a:t>
            </a:r>
            <a:r>
              <a:rPr lang="en-US" sz="1200" dirty="0" smtClean="0">
                <a:solidFill>
                  <a:srgbClr val="222222"/>
                </a:solidFill>
                <a:latin typeface="Arial" pitchFamily="34" charset="0"/>
                <a:ea typeface="Calibri" pitchFamily="34" charset="0"/>
                <a:cs typeface="Arial" pitchFamily="34" charset="0"/>
              </a:rPr>
              <a:t>Genotyping of the </a:t>
            </a:r>
            <a:r>
              <a:rPr lang="en-US" sz="1200" i="1" dirty="0" smtClean="0">
                <a:solidFill>
                  <a:srgbClr val="222222"/>
                </a:solidFill>
                <a:latin typeface="Arial" pitchFamily="34" charset="0"/>
                <a:ea typeface="Calibri" pitchFamily="34" charset="0"/>
                <a:cs typeface="Arial" pitchFamily="34" charset="0"/>
              </a:rPr>
              <a:t>atnac6</a:t>
            </a:r>
            <a:r>
              <a:rPr lang="en-US" sz="1200" dirty="0" smtClean="0">
                <a:solidFill>
                  <a:srgbClr val="222222"/>
                </a:solidFill>
                <a:latin typeface="Arial" pitchFamily="34" charset="0"/>
                <a:ea typeface="Calibri" pitchFamily="34" charset="0"/>
                <a:cs typeface="Arial" pitchFamily="34" charset="0"/>
              </a:rPr>
              <a:t> T-DNA insertion line </a:t>
            </a:r>
            <a:r>
              <a:rPr lang="en-US" sz="1200" b="1" dirty="0" smtClean="0">
                <a:solidFill>
                  <a:srgbClr val="222222"/>
                </a:solidFill>
                <a:latin typeface="Arial" pitchFamily="34" charset="0"/>
                <a:ea typeface="Calibri" pitchFamily="34" charset="0"/>
                <a:cs typeface="Arial" pitchFamily="34" charset="0"/>
              </a:rPr>
              <a:t>(B)</a:t>
            </a:r>
            <a:r>
              <a:rPr lang="en-US" sz="1200" dirty="0" smtClean="0">
                <a:solidFill>
                  <a:srgbClr val="222222"/>
                </a:solidFill>
                <a:latin typeface="Arial" pitchFamily="34" charset="0"/>
                <a:ea typeface="Calibri" pitchFamily="34" charset="0"/>
                <a:cs typeface="Arial" pitchFamily="34" charset="0"/>
              </a:rPr>
              <a:t>. </a:t>
            </a:r>
            <a:r>
              <a:rPr lang="en-US" sz="1200" dirty="0" smtClean="0">
                <a:solidFill>
                  <a:srgbClr val="333333"/>
                </a:solidFill>
                <a:latin typeface="Arial" pitchFamily="34" charset="0"/>
                <a:ea typeface="Calibri" pitchFamily="34" charset="0"/>
                <a:cs typeface="Arial" pitchFamily="34" charset="0"/>
              </a:rPr>
              <a:t>PCR reactions with </a:t>
            </a:r>
            <a:r>
              <a:rPr lang="en-US" sz="1200" dirty="0" smtClean="0">
                <a:latin typeface="Arial" pitchFamily="34" charset="0"/>
                <a:ea typeface="Calibri" pitchFamily="34" charset="0"/>
                <a:cs typeface="Arial" pitchFamily="34" charset="0"/>
              </a:rPr>
              <a:t>actin gene specific primers</a:t>
            </a:r>
            <a:r>
              <a:rPr lang="en-US" sz="1200" dirty="0" smtClean="0">
                <a:solidFill>
                  <a:srgbClr val="333333"/>
                </a:solidFill>
                <a:latin typeface="Arial" pitchFamily="34" charset="0"/>
                <a:ea typeface="Calibri" pitchFamily="34" charset="0"/>
                <a:cs typeface="Arial" pitchFamily="34" charset="0"/>
              </a:rPr>
              <a:t> show the DNA quality in both wild type and mutant samples, </a:t>
            </a:r>
            <a:r>
              <a:rPr lang="en-US" sz="1200" b="1" dirty="0" err="1" smtClean="0">
                <a:latin typeface="Arial" pitchFamily="34" charset="0"/>
                <a:ea typeface="Calibri" pitchFamily="34" charset="0"/>
                <a:cs typeface="Arial" pitchFamily="34" charset="0"/>
              </a:rPr>
              <a:t>i</a:t>
            </a:r>
            <a:r>
              <a:rPr lang="en-US" sz="1200" dirty="0" smtClean="0">
                <a:latin typeface="Arial" pitchFamily="34" charset="0"/>
                <a:ea typeface="Calibri" pitchFamily="34" charset="0"/>
                <a:cs typeface="Arial" pitchFamily="34" charset="0"/>
              </a:rPr>
              <a:t>;</a:t>
            </a:r>
            <a:r>
              <a:rPr lang="en-US" sz="1200" dirty="0" smtClean="0">
                <a:solidFill>
                  <a:srgbClr val="333333"/>
                </a:solidFill>
                <a:latin typeface="Arial" pitchFamily="34" charset="0"/>
                <a:ea typeface="Calibri" pitchFamily="34" charset="0"/>
                <a:cs typeface="Arial" pitchFamily="34" charset="0"/>
              </a:rPr>
              <a:t> DNA show a flanking DNA fragment upstream (LP) and downstream of the insertion site (RP) in wild type (WT) but not in mutant, </a:t>
            </a:r>
            <a:r>
              <a:rPr lang="en-US" sz="1200" b="1" dirty="0" smtClean="0">
                <a:solidFill>
                  <a:srgbClr val="333333"/>
                </a:solidFill>
                <a:latin typeface="Arial" pitchFamily="34" charset="0"/>
                <a:ea typeface="Calibri" pitchFamily="34" charset="0"/>
                <a:cs typeface="Arial" pitchFamily="34" charset="0"/>
              </a:rPr>
              <a:t>ii; </a:t>
            </a:r>
            <a:r>
              <a:rPr lang="en-US" sz="1200" dirty="0" smtClean="0">
                <a:solidFill>
                  <a:srgbClr val="333333"/>
                </a:solidFill>
                <a:latin typeface="Arial" pitchFamily="34" charset="0"/>
                <a:ea typeface="Calibri" pitchFamily="34" charset="0"/>
                <a:cs typeface="Arial" pitchFamily="34" charset="0"/>
              </a:rPr>
              <a:t>DNA fragment flanking the T-DNA border (LB) and the downstream of the insertion site (RP) in mutant but not wild type, </a:t>
            </a:r>
            <a:r>
              <a:rPr lang="en-US" sz="1200" b="1" dirty="0" smtClean="0">
                <a:solidFill>
                  <a:srgbClr val="333333"/>
                </a:solidFill>
                <a:latin typeface="Arial" pitchFamily="34" charset="0"/>
                <a:ea typeface="Calibri" pitchFamily="34" charset="0"/>
                <a:cs typeface="Arial" pitchFamily="34" charset="0"/>
              </a:rPr>
              <a:t>iii</a:t>
            </a:r>
            <a:r>
              <a:rPr lang="en-US" sz="1200" dirty="0" smtClean="0">
                <a:solidFill>
                  <a:srgbClr val="333333"/>
                </a:solidFill>
                <a:latin typeface="Arial" pitchFamily="34" charset="0"/>
                <a:ea typeface="Calibri" pitchFamily="34" charset="0"/>
                <a:cs typeface="Arial" pitchFamily="34" charset="0"/>
              </a:rPr>
              <a:t>; depicting that the suggested mutant is a homozygous T-DNA insertion line. </a:t>
            </a:r>
            <a:r>
              <a:rPr lang="en-US" sz="1200" dirty="0" smtClean="0">
                <a:latin typeface="Arial" pitchFamily="34" charset="0"/>
                <a:cs typeface="Arial" pitchFamily="34" charset="0"/>
              </a:rPr>
              <a:t>Semi-quantitative RT-PCR analysis gel showing expression pattern of the AtNAC6 gene in </a:t>
            </a:r>
            <a:r>
              <a:rPr lang="en-US" sz="1200" i="1" dirty="0" smtClean="0">
                <a:latin typeface="Arial" pitchFamily="34" charset="0"/>
                <a:cs typeface="Arial" pitchFamily="34" charset="0"/>
              </a:rPr>
              <a:t>A. thaliana </a:t>
            </a:r>
            <a:r>
              <a:rPr lang="en-US" sz="1200" dirty="0" smtClean="0">
                <a:latin typeface="Arial" pitchFamily="34" charset="0"/>
                <a:cs typeface="Arial" pitchFamily="34" charset="0"/>
              </a:rPr>
              <a:t>mutant in comparison to the WT plants (cycle number=30) </a:t>
            </a:r>
            <a:r>
              <a:rPr lang="en-US" sz="1200" b="1" dirty="0" smtClean="0">
                <a:latin typeface="Arial" pitchFamily="34" charset="0"/>
                <a:cs typeface="Arial" pitchFamily="34" charset="0"/>
              </a:rPr>
              <a:t>(C)</a:t>
            </a:r>
            <a:r>
              <a:rPr lang="en-US" sz="1200" dirty="0" smtClean="0">
                <a:latin typeface="Arial" pitchFamily="34" charset="0"/>
                <a:cs typeface="Arial" pitchFamily="34" charset="0"/>
              </a:rPr>
              <a:t>. There was a severe reduction in </a:t>
            </a:r>
            <a:r>
              <a:rPr lang="en-US" sz="1200" i="1" dirty="0" smtClean="0">
                <a:latin typeface="Arial" pitchFamily="34" charset="0"/>
                <a:cs typeface="Arial" pitchFamily="34" charset="0"/>
              </a:rPr>
              <a:t>AtNAC6</a:t>
            </a:r>
            <a:r>
              <a:rPr lang="en-US" sz="1200" dirty="0" smtClean="0">
                <a:latin typeface="Arial" pitchFamily="34" charset="0"/>
                <a:cs typeface="Arial" pitchFamily="34" charset="0"/>
              </a:rPr>
              <a:t> transcript accumulation in mutant. Confirmed mutant line was the tested for its response towards pathogen infection and combined drought and pathogen stress. Mutant plants were exposed to pathogen only and combined drought and pathogen infection and </a:t>
            </a:r>
            <a:r>
              <a:rPr lang="en-US" sz="1200" i="1" dirty="0" smtClean="0">
                <a:latin typeface="Arial" pitchFamily="34" charset="0"/>
                <a:cs typeface="Arial" pitchFamily="34" charset="0"/>
              </a:rPr>
              <a:t>in </a:t>
            </a:r>
            <a:r>
              <a:rPr lang="en-US" sz="1200" i="1" dirty="0" err="1" smtClean="0">
                <a:latin typeface="Arial" pitchFamily="34" charset="0"/>
                <a:cs typeface="Arial" pitchFamily="34" charset="0"/>
              </a:rPr>
              <a:t>planta</a:t>
            </a:r>
            <a:r>
              <a:rPr lang="en-US" sz="1200" i="1" dirty="0" smtClean="0">
                <a:latin typeface="Arial" pitchFamily="34" charset="0"/>
                <a:cs typeface="Arial" pitchFamily="34" charset="0"/>
              </a:rPr>
              <a:t> </a:t>
            </a:r>
            <a:r>
              <a:rPr lang="en-US" sz="1200" dirty="0" smtClean="0">
                <a:latin typeface="Arial" pitchFamily="34" charset="0"/>
                <a:cs typeface="Arial" pitchFamily="34" charset="0"/>
              </a:rPr>
              <a:t>bacterial numbers were assessed at 72 </a:t>
            </a:r>
            <a:r>
              <a:rPr lang="en-US" sz="1200" dirty="0" err="1" smtClean="0">
                <a:latin typeface="Arial" pitchFamily="34" charset="0"/>
                <a:cs typeface="Arial" pitchFamily="34" charset="0"/>
              </a:rPr>
              <a:t>hpt</a:t>
            </a:r>
            <a:r>
              <a:rPr lang="en-US" sz="1200" dirty="0" smtClean="0">
                <a:latin typeface="Arial" pitchFamily="34" charset="0"/>
                <a:cs typeface="Arial" pitchFamily="34" charset="0"/>
              </a:rPr>
              <a:t> </a:t>
            </a:r>
            <a:r>
              <a:rPr lang="en-US" sz="1200" b="1" dirty="0" smtClean="0">
                <a:latin typeface="Arial" pitchFamily="34" charset="0"/>
                <a:cs typeface="Arial" pitchFamily="34" charset="0"/>
              </a:rPr>
              <a:t>(D)</a:t>
            </a:r>
            <a:r>
              <a:rPr lang="en-US" sz="1200" dirty="0" smtClean="0">
                <a:latin typeface="Arial" pitchFamily="34" charset="0"/>
                <a:cs typeface="Arial" pitchFamily="34" charset="0"/>
              </a:rPr>
              <a:t>. Data represented is the average of six biological and two technical replicates. Errors bars represent ± SEM and * and ǂ denotes the significant differences between WT and mutant plants at p&lt; 0.05 under pathogen infection and combined stress respectively. Test of significance applied is Student’s t-test. Results clearly show that mutant plants exhibited pathogen susceptibility under combined stress</a:t>
            </a:r>
          </a:p>
          <a:p>
            <a:pPr algn="just" eaLnBrk="0" fontAlgn="base" hangingPunct="0">
              <a:spcBef>
                <a:spcPct val="0"/>
              </a:spcBef>
              <a:spcAft>
                <a:spcPct val="0"/>
              </a:spcAft>
            </a:pPr>
            <a:endParaRPr lang="en-US" sz="1200" dirty="0" smtClean="0">
              <a:solidFill>
                <a:srgbClr val="222222"/>
              </a:solidFill>
              <a:latin typeface="Arial" pitchFamily="34" charset="0"/>
              <a:ea typeface="Calibri" pitchFamily="34" charset="0"/>
              <a:cs typeface="Arial" pitchFamily="34" charset="0"/>
            </a:endParaRPr>
          </a:p>
        </p:txBody>
      </p:sp>
    </p:spTree>
    <p:extLst>
      <p:ext uri="{BB962C8B-B14F-4D97-AF65-F5344CB8AC3E}">
        <p14:creationId xmlns:p14="http://schemas.microsoft.com/office/powerpoint/2010/main" val="1726736432"/>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266" name="Group 1"/>
          <p:cNvGrpSpPr>
            <a:grpSpLocks/>
          </p:cNvGrpSpPr>
          <p:nvPr/>
        </p:nvGrpSpPr>
        <p:grpSpPr bwMode="auto">
          <a:xfrm>
            <a:off x="157163" y="625724"/>
            <a:ext cx="6700837" cy="3135312"/>
            <a:chOff x="19050" y="8095582"/>
            <a:chExt cx="6700127" cy="4181049"/>
          </a:xfrm>
        </p:grpSpPr>
        <p:grpSp>
          <p:nvGrpSpPr>
            <p:cNvPr id="11347" name="Group 29"/>
            <p:cNvGrpSpPr>
              <a:grpSpLocks/>
            </p:cNvGrpSpPr>
            <p:nvPr/>
          </p:nvGrpSpPr>
          <p:grpSpPr bwMode="auto">
            <a:xfrm>
              <a:off x="1395082" y="8375642"/>
              <a:ext cx="1048512" cy="2414097"/>
              <a:chOff x="-69426" y="107415"/>
              <a:chExt cx="2080253" cy="5319935"/>
            </a:xfrm>
          </p:grpSpPr>
          <p:sp>
            <p:nvSpPr>
              <p:cNvPr id="114" name="Freeform 113"/>
              <p:cNvSpPr/>
              <p:nvPr/>
            </p:nvSpPr>
            <p:spPr>
              <a:xfrm rot="20683283">
                <a:off x="-69061" y="106054"/>
                <a:ext cx="2078521" cy="3550211"/>
              </a:xfrm>
              <a:custGeom>
                <a:avLst/>
                <a:gdLst>
                  <a:gd name="connsiteX0" fmla="*/ 483980 w 2080024"/>
                  <a:gd name="connsiteY0" fmla="*/ 3391592 h 3547685"/>
                  <a:gd name="connsiteX1" fmla="*/ 450729 w 2080024"/>
                  <a:gd name="connsiteY1" fmla="*/ 3341716 h 3547685"/>
                  <a:gd name="connsiteX2" fmla="*/ 400853 w 2080024"/>
                  <a:gd name="connsiteY2" fmla="*/ 3275214 h 3547685"/>
                  <a:gd name="connsiteX3" fmla="*/ 350977 w 2080024"/>
                  <a:gd name="connsiteY3" fmla="*/ 3125585 h 3547685"/>
                  <a:gd name="connsiteX4" fmla="*/ 334351 w 2080024"/>
                  <a:gd name="connsiteY4" fmla="*/ 3075709 h 3547685"/>
                  <a:gd name="connsiteX5" fmla="*/ 301100 w 2080024"/>
                  <a:gd name="connsiteY5" fmla="*/ 3025832 h 3547685"/>
                  <a:gd name="connsiteX6" fmla="*/ 284475 w 2080024"/>
                  <a:gd name="connsiteY6" fmla="*/ 2975956 h 3547685"/>
                  <a:gd name="connsiteX7" fmla="*/ 251224 w 2080024"/>
                  <a:gd name="connsiteY7" fmla="*/ 2909454 h 3547685"/>
                  <a:gd name="connsiteX8" fmla="*/ 234599 w 2080024"/>
                  <a:gd name="connsiteY8" fmla="*/ 2842952 h 3547685"/>
                  <a:gd name="connsiteX9" fmla="*/ 201348 w 2080024"/>
                  <a:gd name="connsiteY9" fmla="*/ 2793076 h 3547685"/>
                  <a:gd name="connsiteX10" fmla="*/ 151471 w 2080024"/>
                  <a:gd name="connsiteY10" fmla="*/ 2693323 h 3547685"/>
                  <a:gd name="connsiteX11" fmla="*/ 84969 w 2080024"/>
                  <a:gd name="connsiteY11" fmla="*/ 2560320 h 3547685"/>
                  <a:gd name="connsiteX12" fmla="*/ 68344 w 2080024"/>
                  <a:gd name="connsiteY12" fmla="*/ 2510443 h 3547685"/>
                  <a:gd name="connsiteX13" fmla="*/ 35093 w 2080024"/>
                  <a:gd name="connsiteY13" fmla="*/ 2394065 h 3547685"/>
                  <a:gd name="connsiteX14" fmla="*/ 18468 w 2080024"/>
                  <a:gd name="connsiteY14" fmla="*/ 2277687 h 3547685"/>
                  <a:gd name="connsiteX15" fmla="*/ 51719 w 2080024"/>
                  <a:gd name="connsiteY15" fmla="*/ 1745672 h 3547685"/>
                  <a:gd name="connsiteX16" fmla="*/ 101595 w 2080024"/>
                  <a:gd name="connsiteY16" fmla="*/ 1629294 h 3547685"/>
                  <a:gd name="connsiteX17" fmla="*/ 118220 w 2080024"/>
                  <a:gd name="connsiteY17" fmla="*/ 1579418 h 3547685"/>
                  <a:gd name="connsiteX18" fmla="*/ 184722 w 2080024"/>
                  <a:gd name="connsiteY18" fmla="*/ 1479665 h 3547685"/>
                  <a:gd name="connsiteX19" fmla="*/ 284475 w 2080024"/>
                  <a:gd name="connsiteY19" fmla="*/ 1330036 h 3547685"/>
                  <a:gd name="connsiteX20" fmla="*/ 317726 w 2080024"/>
                  <a:gd name="connsiteY20" fmla="*/ 1280160 h 3547685"/>
                  <a:gd name="connsiteX21" fmla="*/ 350977 w 2080024"/>
                  <a:gd name="connsiteY21" fmla="*/ 1230283 h 3547685"/>
                  <a:gd name="connsiteX22" fmla="*/ 417479 w 2080024"/>
                  <a:gd name="connsiteY22" fmla="*/ 1163782 h 3547685"/>
                  <a:gd name="connsiteX23" fmla="*/ 434104 w 2080024"/>
                  <a:gd name="connsiteY23" fmla="*/ 1113905 h 3547685"/>
                  <a:gd name="connsiteX24" fmla="*/ 517231 w 2080024"/>
                  <a:gd name="connsiteY24" fmla="*/ 1030778 h 3547685"/>
                  <a:gd name="connsiteX25" fmla="*/ 550482 w 2080024"/>
                  <a:gd name="connsiteY25" fmla="*/ 980902 h 3547685"/>
                  <a:gd name="connsiteX26" fmla="*/ 666860 w 2080024"/>
                  <a:gd name="connsiteY26" fmla="*/ 881149 h 3547685"/>
                  <a:gd name="connsiteX27" fmla="*/ 700111 w 2080024"/>
                  <a:gd name="connsiteY27" fmla="*/ 831272 h 3547685"/>
                  <a:gd name="connsiteX28" fmla="*/ 799864 w 2080024"/>
                  <a:gd name="connsiteY28" fmla="*/ 731520 h 3547685"/>
                  <a:gd name="connsiteX29" fmla="*/ 849740 w 2080024"/>
                  <a:gd name="connsiteY29" fmla="*/ 665018 h 3547685"/>
                  <a:gd name="connsiteX30" fmla="*/ 949493 w 2080024"/>
                  <a:gd name="connsiteY30" fmla="*/ 581891 h 3547685"/>
                  <a:gd name="connsiteX31" fmla="*/ 982744 w 2080024"/>
                  <a:gd name="connsiteY31" fmla="*/ 532014 h 3547685"/>
                  <a:gd name="connsiteX32" fmla="*/ 1049246 w 2080024"/>
                  <a:gd name="connsiteY32" fmla="*/ 482138 h 3547685"/>
                  <a:gd name="connsiteX33" fmla="*/ 1099122 w 2080024"/>
                  <a:gd name="connsiteY33" fmla="*/ 415636 h 3547685"/>
                  <a:gd name="connsiteX34" fmla="*/ 1265377 w 2080024"/>
                  <a:gd name="connsiteY34" fmla="*/ 266007 h 3547685"/>
                  <a:gd name="connsiteX35" fmla="*/ 1365129 w 2080024"/>
                  <a:gd name="connsiteY35" fmla="*/ 182880 h 3547685"/>
                  <a:gd name="connsiteX36" fmla="*/ 1481508 w 2080024"/>
                  <a:gd name="connsiteY36" fmla="*/ 49876 h 3547685"/>
                  <a:gd name="connsiteX37" fmla="*/ 1498133 w 2080024"/>
                  <a:gd name="connsiteY37" fmla="*/ 0 h 3547685"/>
                  <a:gd name="connsiteX38" fmla="*/ 1548009 w 2080024"/>
                  <a:gd name="connsiteY38" fmla="*/ 116378 h 3547685"/>
                  <a:gd name="connsiteX39" fmla="*/ 1597886 w 2080024"/>
                  <a:gd name="connsiteY39" fmla="*/ 249382 h 3547685"/>
                  <a:gd name="connsiteX40" fmla="*/ 1647762 w 2080024"/>
                  <a:gd name="connsiteY40" fmla="*/ 365760 h 3547685"/>
                  <a:gd name="connsiteX41" fmla="*/ 1664388 w 2080024"/>
                  <a:gd name="connsiteY41" fmla="*/ 448887 h 3547685"/>
                  <a:gd name="connsiteX42" fmla="*/ 1697639 w 2080024"/>
                  <a:gd name="connsiteY42" fmla="*/ 498763 h 3547685"/>
                  <a:gd name="connsiteX43" fmla="*/ 1714264 w 2080024"/>
                  <a:gd name="connsiteY43" fmla="*/ 548640 h 3547685"/>
                  <a:gd name="connsiteX44" fmla="*/ 1730889 w 2080024"/>
                  <a:gd name="connsiteY44" fmla="*/ 615142 h 3547685"/>
                  <a:gd name="connsiteX45" fmla="*/ 1780766 w 2080024"/>
                  <a:gd name="connsiteY45" fmla="*/ 764771 h 3547685"/>
                  <a:gd name="connsiteX46" fmla="*/ 1814017 w 2080024"/>
                  <a:gd name="connsiteY46" fmla="*/ 864523 h 3547685"/>
                  <a:gd name="connsiteX47" fmla="*/ 1847268 w 2080024"/>
                  <a:gd name="connsiteY47" fmla="*/ 914400 h 3547685"/>
                  <a:gd name="connsiteX48" fmla="*/ 1913769 w 2080024"/>
                  <a:gd name="connsiteY48" fmla="*/ 1147156 h 3547685"/>
                  <a:gd name="connsiteX49" fmla="*/ 1930395 w 2080024"/>
                  <a:gd name="connsiteY49" fmla="*/ 1197032 h 3547685"/>
                  <a:gd name="connsiteX50" fmla="*/ 1963646 w 2080024"/>
                  <a:gd name="connsiteY50" fmla="*/ 1246909 h 3547685"/>
                  <a:gd name="connsiteX51" fmla="*/ 1980271 w 2080024"/>
                  <a:gd name="connsiteY51" fmla="*/ 1313411 h 3547685"/>
                  <a:gd name="connsiteX52" fmla="*/ 1996897 w 2080024"/>
                  <a:gd name="connsiteY52" fmla="*/ 1363287 h 3547685"/>
                  <a:gd name="connsiteX53" fmla="*/ 2030148 w 2080024"/>
                  <a:gd name="connsiteY53" fmla="*/ 1546167 h 3547685"/>
                  <a:gd name="connsiteX54" fmla="*/ 2046773 w 2080024"/>
                  <a:gd name="connsiteY54" fmla="*/ 1596043 h 3547685"/>
                  <a:gd name="connsiteX55" fmla="*/ 2063399 w 2080024"/>
                  <a:gd name="connsiteY55" fmla="*/ 1729047 h 3547685"/>
                  <a:gd name="connsiteX56" fmla="*/ 2080024 w 2080024"/>
                  <a:gd name="connsiteY56" fmla="*/ 1828800 h 3547685"/>
                  <a:gd name="connsiteX57" fmla="*/ 2063399 w 2080024"/>
                  <a:gd name="connsiteY57" fmla="*/ 2410691 h 3547685"/>
                  <a:gd name="connsiteX58" fmla="*/ 2013522 w 2080024"/>
                  <a:gd name="connsiteY58" fmla="*/ 2576945 h 3547685"/>
                  <a:gd name="connsiteX59" fmla="*/ 1980271 w 2080024"/>
                  <a:gd name="connsiteY59" fmla="*/ 2676698 h 3547685"/>
                  <a:gd name="connsiteX60" fmla="*/ 1930395 w 2080024"/>
                  <a:gd name="connsiteY60" fmla="*/ 2726574 h 3547685"/>
                  <a:gd name="connsiteX61" fmla="*/ 1847268 w 2080024"/>
                  <a:gd name="connsiteY61" fmla="*/ 2876203 h 3547685"/>
                  <a:gd name="connsiteX62" fmla="*/ 1780766 w 2080024"/>
                  <a:gd name="connsiteY62" fmla="*/ 2975956 h 3547685"/>
                  <a:gd name="connsiteX63" fmla="*/ 1747515 w 2080024"/>
                  <a:gd name="connsiteY63" fmla="*/ 3025832 h 3547685"/>
                  <a:gd name="connsiteX64" fmla="*/ 1697639 w 2080024"/>
                  <a:gd name="connsiteY64" fmla="*/ 3059083 h 3547685"/>
                  <a:gd name="connsiteX65" fmla="*/ 1614511 w 2080024"/>
                  <a:gd name="connsiteY65" fmla="*/ 3142211 h 3547685"/>
                  <a:gd name="connsiteX66" fmla="*/ 1531384 w 2080024"/>
                  <a:gd name="connsiteY66" fmla="*/ 3208712 h 3547685"/>
                  <a:gd name="connsiteX67" fmla="*/ 1431631 w 2080024"/>
                  <a:gd name="connsiteY67" fmla="*/ 3258589 h 3547685"/>
                  <a:gd name="connsiteX68" fmla="*/ 1381755 w 2080024"/>
                  <a:gd name="connsiteY68" fmla="*/ 3291840 h 3547685"/>
                  <a:gd name="connsiteX69" fmla="*/ 1282002 w 2080024"/>
                  <a:gd name="connsiteY69" fmla="*/ 3325091 h 3547685"/>
                  <a:gd name="connsiteX70" fmla="*/ 1232126 w 2080024"/>
                  <a:gd name="connsiteY70" fmla="*/ 3341716 h 3547685"/>
                  <a:gd name="connsiteX71" fmla="*/ 1182249 w 2080024"/>
                  <a:gd name="connsiteY71" fmla="*/ 3374967 h 3547685"/>
                  <a:gd name="connsiteX72" fmla="*/ 1032620 w 2080024"/>
                  <a:gd name="connsiteY72" fmla="*/ 3424843 h 3547685"/>
                  <a:gd name="connsiteX73" fmla="*/ 982744 w 2080024"/>
                  <a:gd name="connsiteY73" fmla="*/ 3441469 h 3547685"/>
                  <a:gd name="connsiteX74" fmla="*/ 932868 w 2080024"/>
                  <a:gd name="connsiteY74" fmla="*/ 3474720 h 3547685"/>
                  <a:gd name="connsiteX75" fmla="*/ 849740 w 2080024"/>
                  <a:gd name="connsiteY75" fmla="*/ 3491345 h 3547685"/>
                  <a:gd name="connsiteX76" fmla="*/ 783239 w 2080024"/>
                  <a:gd name="connsiteY76" fmla="*/ 3507971 h 3547685"/>
                  <a:gd name="connsiteX77" fmla="*/ 600359 w 2080024"/>
                  <a:gd name="connsiteY77" fmla="*/ 3541222 h 3547685"/>
                  <a:gd name="connsiteX78" fmla="*/ 550482 w 2080024"/>
                  <a:gd name="connsiteY78" fmla="*/ 3524596 h 3547685"/>
                  <a:gd name="connsiteX79" fmla="*/ 517231 w 2080024"/>
                  <a:gd name="connsiteY79" fmla="*/ 3474720 h 3547685"/>
                  <a:gd name="connsiteX80" fmla="*/ 467355 w 2080024"/>
                  <a:gd name="connsiteY80" fmla="*/ 3441469 h 3547685"/>
                  <a:gd name="connsiteX81" fmla="*/ 450729 w 2080024"/>
                  <a:gd name="connsiteY81" fmla="*/ 3391592 h 3547685"/>
                  <a:gd name="connsiteX82" fmla="*/ 400853 w 2080024"/>
                  <a:gd name="connsiteY82" fmla="*/ 3325091 h 3547685"/>
                  <a:gd name="connsiteX83" fmla="*/ 367602 w 2080024"/>
                  <a:gd name="connsiteY83" fmla="*/ 3275214 h 3547685"/>
                  <a:gd name="connsiteX84" fmla="*/ 301100 w 2080024"/>
                  <a:gd name="connsiteY84" fmla="*/ 3208712 h 354768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Lst>
                <a:rect l="l" t="t" r="r" b="b"/>
                <a:pathLst>
                  <a:path w="2080024" h="3547685">
                    <a:moveTo>
                      <a:pt x="483980" y="3391592"/>
                    </a:moveTo>
                    <a:cubicBezTo>
                      <a:pt x="472896" y="3374967"/>
                      <a:pt x="462343" y="3357975"/>
                      <a:pt x="450729" y="3341716"/>
                    </a:cubicBezTo>
                    <a:cubicBezTo>
                      <a:pt x="434623" y="3319168"/>
                      <a:pt x="413245" y="3299998"/>
                      <a:pt x="400853" y="3275214"/>
                    </a:cubicBezTo>
                    <a:cubicBezTo>
                      <a:pt x="400845" y="3275198"/>
                      <a:pt x="359292" y="3150531"/>
                      <a:pt x="350977" y="3125585"/>
                    </a:cubicBezTo>
                    <a:cubicBezTo>
                      <a:pt x="345435" y="3108960"/>
                      <a:pt x="344072" y="3090290"/>
                      <a:pt x="334351" y="3075709"/>
                    </a:cubicBezTo>
                    <a:lnTo>
                      <a:pt x="301100" y="3025832"/>
                    </a:lnTo>
                    <a:cubicBezTo>
                      <a:pt x="295558" y="3009207"/>
                      <a:pt x="291378" y="2992064"/>
                      <a:pt x="284475" y="2975956"/>
                    </a:cubicBezTo>
                    <a:cubicBezTo>
                      <a:pt x="274712" y="2953176"/>
                      <a:pt x="259926" y="2932660"/>
                      <a:pt x="251224" y="2909454"/>
                    </a:cubicBezTo>
                    <a:cubicBezTo>
                      <a:pt x="243201" y="2888059"/>
                      <a:pt x="243600" y="2863954"/>
                      <a:pt x="234599" y="2842952"/>
                    </a:cubicBezTo>
                    <a:cubicBezTo>
                      <a:pt x="226728" y="2824586"/>
                      <a:pt x="210284" y="2810948"/>
                      <a:pt x="201348" y="2793076"/>
                    </a:cubicBezTo>
                    <a:cubicBezTo>
                      <a:pt x="132512" y="2655406"/>
                      <a:pt x="246768" y="2836269"/>
                      <a:pt x="151471" y="2693323"/>
                    </a:cubicBezTo>
                    <a:cubicBezTo>
                      <a:pt x="118415" y="2561099"/>
                      <a:pt x="160331" y="2692204"/>
                      <a:pt x="84969" y="2560320"/>
                    </a:cubicBezTo>
                    <a:cubicBezTo>
                      <a:pt x="76274" y="2545104"/>
                      <a:pt x="73158" y="2527294"/>
                      <a:pt x="68344" y="2510443"/>
                    </a:cubicBezTo>
                    <a:cubicBezTo>
                      <a:pt x="26601" y="2364338"/>
                      <a:pt x="74950" y="2513634"/>
                      <a:pt x="35093" y="2394065"/>
                    </a:cubicBezTo>
                    <a:cubicBezTo>
                      <a:pt x="29551" y="2355272"/>
                      <a:pt x="18468" y="2316873"/>
                      <a:pt x="18468" y="2277687"/>
                    </a:cubicBezTo>
                    <a:cubicBezTo>
                      <a:pt x="18468" y="2034785"/>
                      <a:pt x="0" y="1926688"/>
                      <a:pt x="51719" y="1745672"/>
                    </a:cubicBezTo>
                    <a:cubicBezTo>
                      <a:pt x="74000" y="1667688"/>
                      <a:pt x="63591" y="1717970"/>
                      <a:pt x="101595" y="1629294"/>
                    </a:cubicBezTo>
                    <a:cubicBezTo>
                      <a:pt x="108498" y="1613186"/>
                      <a:pt x="109709" y="1594737"/>
                      <a:pt x="118220" y="1579418"/>
                    </a:cubicBezTo>
                    <a:cubicBezTo>
                      <a:pt x="137628" y="1544484"/>
                      <a:pt x="162555" y="1512916"/>
                      <a:pt x="184722" y="1479665"/>
                    </a:cubicBezTo>
                    <a:lnTo>
                      <a:pt x="284475" y="1330036"/>
                    </a:lnTo>
                    <a:lnTo>
                      <a:pt x="317726" y="1280160"/>
                    </a:lnTo>
                    <a:lnTo>
                      <a:pt x="350977" y="1230283"/>
                    </a:lnTo>
                    <a:cubicBezTo>
                      <a:pt x="395311" y="1097280"/>
                      <a:pt x="328809" y="1252452"/>
                      <a:pt x="417479" y="1163782"/>
                    </a:cubicBezTo>
                    <a:cubicBezTo>
                      <a:pt x="429871" y="1151390"/>
                      <a:pt x="426267" y="1129580"/>
                      <a:pt x="434104" y="1113905"/>
                    </a:cubicBezTo>
                    <a:cubicBezTo>
                      <a:pt x="461812" y="1058488"/>
                      <a:pt x="467356" y="1064028"/>
                      <a:pt x="517231" y="1030778"/>
                    </a:cubicBezTo>
                    <a:cubicBezTo>
                      <a:pt x="528315" y="1014153"/>
                      <a:pt x="536353" y="995031"/>
                      <a:pt x="550482" y="980902"/>
                    </a:cubicBezTo>
                    <a:cubicBezTo>
                      <a:pt x="660554" y="870830"/>
                      <a:pt x="576381" y="989725"/>
                      <a:pt x="666860" y="881149"/>
                    </a:cubicBezTo>
                    <a:cubicBezTo>
                      <a:pt x="679652" y="865799"/>
                      <a:pt x="686836" y="846206"/>
                      <a:pt x="700111" y="831272"/>
                    </a:cubicBezTo>
                    <a:cubicBezTo>
                      <a:pt x="731352" y="796126"/>
                      <a:pt x="771650" y="769139"/>
                      <a:pt x="799864" y="731520"/>
                    </a:cubicBezTo>
                    <a:cubicBezTo>
                      <a:pt x="816489" y="709353"/>
                      <a:pt x="830147" y="684611"/>
                      <a:pt x="849740" y="665018"/>
                    </a:cubicBezTo>
                    <a:cubicBezTo>
                      <a:pt x="980517" y="534241"/>
                      <a:pt x="813314" y="745306"/>
                      <a:pt x="949493" y="581891"/>
                    </a:cubicBezTo>
                    <a:cubicBezTo>
                      <a:pt x="962285" y="566541"/>
                      <a:pt x="968615" y="546143"/>
                      <a:pt x="982744" y="532014"/>
                    </a:cubicBezTo>
                    <a:cubicBezTo>
                      <a:pt x="1002337" y="512421"/>
                      <a:pt x="1029653" y="501731"/>
                      <a:pt x="1049246" y="482138"/>
                    </a:cubicBezTo>
                    <a:cubicBezTo>
                      <a:pt x="1068839" y="462545"/>
                      <a:pt x="1080586" y="436232"/>
                      <a:pt x="1099122" y="415636"/>
                    </a:cubicBezTo>
                    <a:cubicBezTo>
                      <a:pt x="1240799" y="258216"/>
                      <a:pt x="1148097" y="366532"/>
                      <a:pt x="1265377" y="266007"/>
                    </a:cubicBezTo>
                    <a:cubicBezTo>
                      <a:pt x="1377390" y="169996"/>
                      <a:pt x="1254891" y="256373"/>
                      <a:pt x="1365129" y="182880"/>
                    </a:cubicBezTo>
                    <a:cubicBezTo>
                      <a:pt x="1442715" y="66501"/>
                      <a:pt x="1398380" y="105294"/>
                      <a:pt x="1481508" y="49876"/>
                    </a:cubicBezTo>
                    <a:cubicBezTo>
                      <a:pt x="1487050" y="33251"/>
                      <a:pt x="1480608" y="0"/>
                      <a:pt x="1498133" y="0"/>
                    </a:cubicBezTo>
                    <a:cubicBezTo>
                      <a:pt x="1527059" y="0"/>
                      <a:pt x="1545978" y="109268"/>
                      <a:pt x="1548009" y="116378"/>
                    </a:cubicBezTo>
                    <a:cubicBezTo>
                      <a:pt x="1563100" y="169198"/>
                      <a:pt x="1576812" y="193184"/>
                      <a:pt x="1597886" y="249382"/>
                    </a:cubicBezTo>
                    <a:cubicBezTo>
                      <a:pt x="1634580" y="347234"/>
                      <a:pt x="1589375" y="248986"/>
                      <a:pt x="1647762" y="365760"/>
                    </a:cubicBezTo>
                    <a:cubicBezTo>
                      <a:pt x="1653304" y="393469"/>
                      <a:pt x="1654466" y="422428"/>
                      <a:pt x="1664388" y="448887"/>
                    </a:cubicBezTo>
                    <a:cubicBezTo>
                      <a:pt x="1671404" y="467596"/>
                      <a:pt x="1688703" y="480891"/>
                      <a:pt x="1697639" y="498763"/>
                    </a:cubicBezTo>
                    <a:cubicBezTo>
                      <a:pt x="1705476" y="514438"/>
                      <a:pt x="1709450" y="531789"/>
                      <a:pt x="1714264" y="548640"/>
                    </a:cubicBezTo>
                    <a:cubicBezTo>
                      <a:pt x="1720541" y="570610"/>
                      <a:pt x="1724323" y="593256"/>
                      <a:pt x="1730889" y="615142"/>
                    </a:cubicBezTo>
                    <a:cubicBezTo>
                      <a:pt x="1730895" y="615164"/>
                      <a:pt x="1772450" y="739823"/>
                      <a:pt x="1780766" y="764771"/>
                    </a:cubicBezTo>
                    <a:cubicBezTo>
                      <a:pt x="1780768" y="764776"/>
                      <a:pt x="1814014" y="864519"/>
                      <a:pt x="1814017" y="864523"/>
                    </a:cubicBezTo>
                    <a:lnTo>
                      <a:pt x="1847268" y="914400"/>
                    </a:lnTo>
                    <a:cubicBezTo>
                      <a:pt x="1889015" y="1081389"/>
                      <a:pt x="1866072" y="1004063"/>
                      <a:pt x="1913769" y="1147156"/>
                    </a:cubicBezTo>
                    <a:cubicBezTo>
                      <a:pt x="1919311" y="1163781"/>
                      <a:pt x="1920674" y="1182451"/>
                      <a:pt x="1930395" y="1197032"/>
                    </a:cubicBezTo>
                    <a:lnTo>
                      <a:pt x="1963646" y="1246909"/>
                    </a:lnTo>
                    <a:cubicBezTo>
                      <a:pt x="1969188" y="1269076"/>
                      <a:pt x="1973994" y="1291441"/>
                      <a:pt x="1980271" y="1313411"/>
                    </a:cubicBezTo>
                    <a:cubicBezTo>
                      <a:pt x="1985085" y="1330261"/>
                      <a:pt x="1993095" y="1346180"/>
                      <a:pt x="1996897" y="1363287"/>
                    </a:cubicBezTo>
                    <a:cubicBezTo>
                      <a:pt x="2026554" y="1496744"/>
                      <a:pt x="1999880" y="1425098"/>
                      <a:pt x="2030148" y="1546167"/>
                    </a:cubicBezTo>
                    <a:cubicBezTo>
                      <a:pt x="2034398" y="1563168"/>
                      <a:pt x="2041231" y="1579418"/>
                      <a:pt x="2046773" y="1596043"/>
                    </a:cubicBezTo>
                    <a:cubicBezTo>
                      <a:pt x="2052315" y="1640378"/>
                      <a:pt x="2057080" y="1684816"/>
                      <a:pt x="2063399" y="1729047"/>
                    </a:cubicBezTo>
                    <a:cubicBezTo>
                      <a:pt x="2068166" y="1762418"/>
                      <a:pt x="2080024" y="1795090"/>
                      <a:pt x="2080024" y="1828800"/>
                    </a:cubicBezTo>
                    <a:cubicBezTo>
                      <a:pt x="2080024" y="2022843"/>
                      <a:pt x="2073337" y="2216903"/>
                      <a:pt x="2063399" y="2410691"/>
                    </a:cubicBezTo>
                    <a:cubicBezTo>
                      <a:pt x="2061876" y="2440382"/>
                      <a:pt x="2017790" y="2564140"/>
                      <a:pt x="2013522" y="2576945"/>
                    </a:cubicBezTo>
                    <a:lnTo>
                      <a:pt x="1980271" y="2676698"/>
                    </a:lnTo>
                    <a:lnTo>
                      <a:pt x="1930395" y="2726574"/>
                    </a:lnTo>
                    <a:cubicBezTo>
                      <a:pt x="1901132" y="2814363"/>
                      <a:pt x="1923490" y="2761869"/>
                      <a:pt x="1847268" y="2876203"/>
                    </a:cubicBezTo>
                    <a:lnTo>
                      <a:pt x="1780766" y="2975956"/>
                    </a:lnTo>
                    <a:cubicBezTo>
                      <a:pt x="1769682" y="2992581"/>
                      <a:pt x="1764140" y="3014748"/>
                      <a:pt x="1747515" y="3025832"/>
                    </a:cubicBezTo>
                    <a:lnTo>
                      <a:pt x="1697639" y="3059083"/>
                    </a:lnTo>
                    <a:cubicBezTo>
                      <a:pt x="1608972" y="3192084"/>
                      <a:pt x="1725346" y="3031378"/>
                      <a:pt x="1614511" y="3142211"/>
                    </a:cubicBezTo>
                    <a:cubicBezTo>
                      <a:pt x="1539310" y="3217411"/>
                      <a:pt x="1628482" y="3176346"/>
                      <a:pt x="1531384" y="3208712"/>
                    </a:cubicBezTo>
                    <a:cubicBezTo>
                      <a:pt x="1388448" y="3304004"/>
                      <a:pt x="1569295" y="3189756"/>
                      <a:pt x="1431631" y="3258589"/>
                    </a:cubicBezTo>
                    <a:cubicBezTo>
                      <a:pt x="1413759" y="3267525"/>
                      <a:pt x="1400014" y="3283725"/>
                      <a:pt x="1381755" y="3291840"/>
                    </a:cubicBezTo>
                    <a:cubicBezTo>
                      <a:pt x="1349726" y="3306075"/>
                      <a:pt x="1315253" y="3314007"/>
                      <a:pt x="1282002" y="3325091"/>
                    </a:cubicBezTo>
                    <a:lnTo>
                      <a:pt x="1232126" y="3341716"/>
                    </a:lnTo>
                    <a:cubicBezTo>
                      <a:pt x="1215500" y="3352800"/>
                      <a:pt x="1200508" y="3366852"/>
                      <a:pt x="1182249" y="3374967"/>
                    </a:cubicBezTo>
                    <a:cubicBezTo>
                      <a:pt x="1182226" y="3374977"/>
                      <a:pt x="1057570" y="3416526"/>
                      <a:pt x="1032620" y="3424843"/>
                    </a:cubicBezTo>
                    <a:cubicBezTo>
                      <a:pt x="1015995" y="3430385"/>
                      <a:pt x="997325" y="3431748"/>
                      <a:pt x="982744" y="3441469"/>
                    </a:cubicBezTo>
                    <a:cubicBezTo>
                      <a:pt x="966119" y="3452553"/>
                      <a:pt x="951577" y="3467704"/>
                      <a:pt x="932868" y="3474720"/>
                    </a:cubicBezTo>
                    <a:cubicBezTo>
                      <a:pt x="906409" y="3484642"/>
                      <a:pt x="877325" y="3485215"/>
                      <a:pt x="849740" y="3491345"/>
                    </a:cubicBezTo>
                    <a:cubicBezTo>
                      <a:pt x="827435" y="3496302"/>
                      <a:pt x="805720" y="3503884"/>
                      <a:pt x="783239" y="3507971"/>
                    </a:cubicBezTo>
                    <a:cubicBezTo>
                      <a:pt x="564814" y="3547685"/>
                      <a:pt x="751189" y="3503513"/>
                      <a:pt x="600359" y="3541222"/>
                    </a:cubicBezTo>
                    <a:cubicBezTo>
                      <a:pt x="583733" y="3535680"/>
                      <a:pt x="564167" y="3535544"/>
                      <a:pt x="550482" y="3524596"/>
                    </a:cubicBezTo>
                    <a:cubicBezTo>
                      <a:pt x="534879" y="3512114"/>
                      <a:pt x="531360" y="3488849"/>
                      <a:pt x="517231" y="3474720"/>
                    </a:cubicBezTo>
                    <a:cubicBezTo>
                      <a:pt x="503102" y="3460591"/>
                      <a:pt x="483980" y="3452553"/>
                      <a:pt x="467355" y="3441469"/>
                    </a:cubicBezTo>
                    <a:cubicBezTo>
                      <a:pt x="461813" y="3424843"/>
                      <a:pt x="459424" y="3406808"/>
                      <a:pt x="450729" y="3391592"/>
                    </a:cubicBezTo>
                    <a:cubicBezTo>
                      <a:pt x="436982" y="3367534"/>
                      <a:pt x="416958" y="3347639"/>
                      <a:pt x="400853" y="3325091"/>
                    </a:cubicBezTo>
                    <a:cubicBezTo>
                      <a:pt x="389239" y="3308831"/>
                      <a:pt x="380394" y="3290564"/>
                      <a:pt x="367602" y="3275214"/>
                    </a:cubicBezTo>
                    <a:lnTo>
                      <a:pt x="301100" y="3208712"/>
                    </a:lnTo>
                  </a:path>
                </a:pathLst>
              </a:custGeom>
              <a:solidFill>
                <a:srgbClr val="00FA42"/>
              </a:solidFill>
              <a:ln>
                <a:solidFill>
                  <a:srgbClr val="00FA42"/>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grpSp>
            <p:nvGrpSpPr>
              <p:cNvPr id="11439" name="Group 28"/>
              <p:cNvGrpSpPr>
                <a:grpSpLocks/>
              </p:cNvGrpSpPr>
              <p:nvPr/>
            </p:nvGrpSpPr>
            <p:grpSpPr bwMode="auto">
              <a:xfrm>
                <a:off x="152306" y="3676906"/>
                <a:ext cx="1560190" cy="1750444"/>
                <a:chOff x="152306" y="3676906"/>
                <a:chExt cx="1560190" cy="1750444"/>
              </a:xfrm>
            </p:grpSpPr>
            <p:sp>
              <p:nvSpPr>
                <p:cNvPr id="116" name="Freeform 115"/>
                <p:cNvSpPr/>
                <p:nvPr/>
              </p:nvSpPr>
              <p:spPr>
                <a:xfrm>
                  <a:off x="151388" y="3712247"/>
                  <a:ext cx="897545" cy="802414"/>
                </a:xfrm>
                <a:custGeom>
                  <a:avLst/>
                  <a:gdLst>
                    <a:gd name="connsiteX0" fmla="*/ 920546 w 920546"/>
                    <a:gd name="connsiteY0" fmla="*/ 0 h 834346"/>
                    <a:gd name="connsiteX1" fmla="*/ 820793 w 920546"/>
                    <a:gd name="connsiteY1" fmla="*/ 116378 h 834346"/>
                    <a:gd name="connsiteX2" fmla="*/ 804168 w 920546"/>
                    <a:gd name="connsiteY2" fmla="*/ 166254 h 834346"/>
                    <a:gd name="connsiteX3" fmla="*/ 754291 w 920546"/>
                    <a:gd name="connsiteY3" fmla="*/ 216131 h 834346"/>
                    <a:gd name="connsiteX4" fmla="*/ 687789 w 920546"/>
                    <a:gd name="connsiteY4" fmla="*/ 315883 h 834346"/>
                    <a:gd name="connsiteX5" fmla="*/ 654538 w 920546"/>
                    <a:gd name="connsiteY5" fmla="*/ 365760 h 834346"/>
                    <a:gd name="connsiteX6" fmla="*/ 554786 w 920546"/>
                    <a:gd name="connsiteY6" fmla="*/ 448887 h 834346"/>
                    <a:gd name="connsiteX7" fmla="*/ 521535 w 920546"/>
                    <a:gd name="connsiteY7" fmla="*/ 498763 h 834346"/>
                    <a:gd name="connsiteX8" fmla="*/ 471658 w 920546"/>
                    <a:gd name="connsiteY8" fmla="*/ 532014 h 834346"/>
                    <a:gd name="connsiteX9" fmla="*/ 371906 w 920546"/>
                    <a:gd name="connsiteY9" fmla="*/ 631767 h 834346"/>
                    <a:gd name="connsiteX10" fmla="*/ 222277 w 920546"/>
                    <a:gd name="connsiteY10" fmla="*/ 714894 h 834346"/>
                    <a:gd name="connsiteX11" fmla="*/ 122524 w 920546"/>
                    <a:gd name="connsiteY11" fmla="*/ 781396 h 834346"/>
                    <a:gd name="connsiteX12" fmla="*/ 72648 w 920546"/>
                    <a:gd name="connsiteY12" fmla="*/ 798022 h 834346"/>
                    <a:gd name="connsiteX13" fmla="*/ 6146 w 920546"/>
                    <a:gd name="connsiteY13" fmla="*/ 831272 h 83434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920546" h="834346">
                      <a:moveTo>
                        <a:pt x="920546" y="0"/>
                      </a:moveTo>
                      <a:cubicBezTo>
                        <a:pt x="881236" y="39309"/>
                        <a:pt x="849231" y="66610"/>
                        <a:pt x="820793" y="116378"/>
                      </a:cubicBezTo>
                      <a:cubicBezTo>
                        <a:pt x="812098" y="131594"/>
                        <a:pt x="813889" y="151673"/>
                        <a:pt x="804168" y="166254"/>
                      </a:cubicBezTo>
                      <a:cubicBezTo>
                        <a:pt x="791126" y="185817"/>
                        <a:pt x="768726" y="197572"/>
                        <a:pt x="754291" y="216131"/>
                      </a:cubicBezTo>
                      <a:cubicBezTo>
                        <a:pt x="729756" y="247675"/>
                        <a:pt x="709956" y="282632"/>
                        <a:pt x="687789" y="315883"/>
                      </a:cubicBezTo>
                      <a:cubicBezTo>
                        <a:pt x="676705" y="332509"/>
                        <a:pt x="671164" y="354676"/>
                        <a:pt x="654538" y="365760"/>
                      </a:cubicBezTo>
                      <a:cubicBezTo>
                        <a:pt x="605497" y="398455"/>
                        <a:pt x="594789" y="400883"/>
                        <a:pt x="554786" y="448887"/>
                      </a:cubicBezTo>
                      <a:cubicBezTo>
                        <a:pt x="541994" y="464237"/>
                        <a:pt x="535664" y="484634"/>
                        <a:pt x="521535" y="498763"/>
                      </a:cubicBezTo>
                      <a:cubicBezTo>
                        <a:pt x="507406" y="512892"/>
                        <a:pt x="486592" y="518739"/>
                        <a:pt x="471658" y="532014"/>
                      </a:cubicBezTo>
                      <a:cubicBezTo>
                        <a:pt x="436512" y="563255"/>
                        <a:pt x="411032" y="605683"/>
                        <a:pt x="371906" y="631767"/>
                      </a:cubicBezTo>
                      <a:cubicBezTo>
                        <a:pt x="257572" y="707990"/>
                        <a:pt x="310065" y="685632"/>
                        <a:pt x="222277" y="714894"/>
                      </a:cubicBezTo>
                      <a:cubicBezTo>
                        <a:pt x="189026" y="737061"/>
                        <a:pt x="160436" y="768758"/>
                        <a:pt x="122524" y="781396"/>
                      </a:cubicBezTo>
                      <a:cubicBezTo>
                        <a:pt x="105899" y="786938"/>
                        <a:pt x="88323" y="790185"/>
                        <a:pt x="72648" y="798022"/>
                      </a:cubicBezTo>
                      <a:cubicBezTo>
                        <a:pt x="0" y="834346"/>
                        <a:pt x="47789" y="831272"/>
                        <a:pt x="6146" y="831272"/>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17" name="Freeform 116"/>
                <p:cNvSpPr/>
                <p:nvPr/>
              </p:nvSpPr>
              <p:spPr>
                <a:xfrm>
                  <a:off x="929260" y="3749568"/>
                  <a:ext cx="125971" cy="1049671"/>
                </a:xfrm>
                <a:custGeom>
                  <a:avLst/>
                  <a:gdLst>
                    <a:gd name="connsiteX0" fmla="*/ 0 w 149629"/>
                    <a:gd name="connsiteY0" fmla="*/ 0 h 1080654"/>
                    <a:gd name="connsiteX1" fmla="*/ 16626 w 149629"/>
                    <a:gd name="connsiteY1" fmla="*/ 831272 h 1080654"/>
                    <a:gd name="connsiteX2" fmla="*/ 49877 w 149629"/>
                    <a:gd name="connsiteY2" fmla="*/ 931025 h 1080654"/>
                    <a:gd name="connsiteX3" fmla="*/ 99753 w 149629"/>
                    <a:gd name="connsiteY3" fmla="*/ 1030778 h 1080654"/>
                    <a:gd name="connsiteX4" fmla="*/ 149629 w 149629"/>
                    <a:gd name="connsiteY4" fmla="*/ 1080654 h 108065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49629" h="1080654">
                      <a:moveTo>
                        <a:pt x="0" y="0"/>
                      </a:moveTo>
                      <a:cubicBezTo>
                        <a:pt x="5542" y="277091"/>
                        <a:pt x="1800" y="554523"/>
                        <a:pt x="16626" y="831272"/>
                      </a:cubicBezTo>
                      <a:cubicBezTo>
                        <a:pt x="18501" y="866271"/>
                        <a:pt x="38793" y="897774"/>
                        <a:pt x="49877" y="931025"/>
                      </a:cubicBezTo>
                      <a:cubicBezTo>
                        <a:pt x="66540" y="981013"/>
                        <a:pt x="63943" y="987805"/>
                        <a:pt x="99753" y="1030778"/>
                      </a:cubicBezTo>
                      <a:cubicBezTo>
                        <a:pt x="114805" y="1048840"/>
                        <a:pt x="149629" y="1080654"/>
                        <a:pt x="149629" y="1080654"/>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18" name="Freeform 117"/>
                <p:cNvSpPr/>
                <p:nvPr/>
              </p:nvSpPr>
              <p:spPr>
                <a:xfrm>
                  <a:off x="614332" y="3791557"/>
                  <a:ext cx="377913" cy="1380899"/>
                </a:xfrm>
                <a:custGeom>
                  <a:avLst/>
                  <a:gdLst>
                    <a:gd name="connsiteX0" fmla="*/ 400098 w 400098"/>
                    <a:gd name="connsiteY0" fmla="*/ 0 h 1413163"/>
                    <a:gd name="connsiteX1" fmla="*/ 267094 w 400098"/>
                    <a:gd name="connsiteY1" fmla="*/ 199505 h 1413163"/>
                    <a:gd name="connsiteX2" fmla="*/ 233843 w 400098"/>
                    <a:gd name="connsiteY2" fmla="*/ 249382 h 1413163"/>
                    <a:gd name="connsiteX3" fmla="*/ 200592 w 400098"/>
                    <a:gd name="connsiteY3" fmla="*/ 299258 h 1413163"/>
                    <a:gd name="connsiteX4" fmla="*/ 183967 w 400098"/>
                    <a:gd name="connsiteY4" fmla="*/ 349134 h 1413163"/>
                    <a:gd name="connsiteX5" fmla="*/ 150716 w 400098"/>
                    <a:gd name="connsiteY5" fmla="*/ 532014 h 1413163"/>
                    <a:gd name="connsiteX6" fmla="*/ 117465 w 400098"/>
                    <a:gd name="connsiteY6" fmla="*/ 881149 h 1413163"/>
                    <a:gd name="connsiteX7" fmla="*/ 84214 w 400098"/>
                    <a:gd name="connsiteY7" fmla="*/ 997527 h 1413163"/>
                    <a:gd name="connsiteX8" fmla="*/ 34338 w 400098"/>
                    <a:gd name="connsiteY8" fmla="*/ 1280160 h 1413163"/>
                    <a:gd name="connsiteX9" fmla="*/ 1087 w 400098"/>
                    <a:gd name="connsiteY9" fmla="*/ 1396538 h 1413163"/>
                    <a:gd name="connsiteX10" fmla="*/ 1087 w 400098"/>
                    <a:gd name="connsiteY10" fmla="*/ 1413163 h 14131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400098" h="1413163">
                      <a:moveTo>
                        <a:pt x="400098" y="0"/>
                      </a:moveTo>
                      <a:lnTo>
                        <a:pt x="267094" y="199505"/>
                      </a:lnTo>
                      <a:lnTo>
                        <a:pt x="233843" y="249382"/>
                      </a:lnTo>
                      <a:lnTo>
                        <a:pt x="200592" y="299258"/>
                      </a:lnTo>
                      <a:cubicBezTo>
                        <a:pt x="195050" y="315883"/>
                        <a:pt x="188217" y="332133"/>
                        <a:pt x="183967" y="349134"/>
                      </a:cubicBezTo>
                      <a:cubicBezTo>
                        <a:pt x="172346" y="395617"/>
                        <a:pt x="158129" y="487534"/>
                        <a:pt x="150716" y="532014"/>
                      </a:cubicBezTo>
                      <a:cubicBezTo>
                        <a:pt x="140975" y="668377"/>
                        <a:pt x="140215" y="756023"/>
                        <a:pt x="117465" y="881149"/>
                      </a:cubicBezTo>
                      <a:cubicBezTo>
                        <a:pt x="109114" y="927082"/>
                        <a:pt x="98460" y="954789"/>
                        <a:pt x="84214" y="997527"/>
                      </a:cubicBezTo>
                      <a:cubicBezTo>
                        <a:pt x="81929" y="1011239"/>
                        <a:pt x="49258" y="1220479"/>
                        <a:pt x="34338" y="1280160"/>
                      </a:cubicBezTo>
                      <a:cubicBezTo>
                        <a:pt x="2643" y="1406941"/>
                        <a:pt x="32189" y="1241026"/>
                        <a:pt x="1087" y="1396538"/>
                      </a:cubicBezTo>
                      <a:cubicBezTo>
                        <a:pt x="0" y="1401972"/>
                        <a:pt x="1087" y="1407621"/>
                        <a:pt x="1087" y="1413163"/>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19" name="Freeform 118"/>
                <p:cNvSpPr/>
                <p:nvPr/>
              </p:nvSpPr>
              <p:spPr>
                <a:xfrm>
                  <a:off x="831631" y="3749568"/>
                  <a:ext cx="144867" cy="1679471"/>
                </a:xfrm>
                <a:custGeom>
                  <a:avLst/>
                  <a:gdLst>
                    <a:gd name="connsiteX0" fmla="*/ 166254 w 166254"/>
                    <a:gd name="connsiteY0" fmla="*/ 0 h 1695796"/>
                    <a:gd name="connsiteX1" fmla="*/ 116378 w 166254"/>
                    <a:gd name="connsiteY1" fmla="*/ 133004 h 1695796"/>
                    <a:gd name="connsiteX2" fmla="*/ 99752 w 166254"/>
                    <a:gd name="connsiteY2" fmla="*/ 282633 h 1695796"/>
                    <a:gd name="connsiteX3" fmla="*/ 83127 w 166254"/>
                    <a:gd name="connsiteY3" fmla="*/ 332509 h 1695796"/>
                    <a:gd name="connsiteX4" fmla="*/ 66502 w 166254"/>
                    <a:gd name="connsiteY4" fmla="*/ 415636 h 1695796"/>
                    <a:gd name="connsiteX5" fmla="*/ 49876 w 166254"/>
                    <a:gd name="connsiteY5" fmla="*/ 665018 h 1695796"/>
                    <a:gd name="connsiteX6" fmla="*/ 33251 w 166254"/>
                    <a:gd name="connsiteY6" fmla="*/ 714894 h 1695796"/>
                    <a:gd name="connsiteX7" fmla="*/ 0 w 166254"/>
                    <a:gd name="connsiteY7" fmla="*/ 980902 h 1695796"/>
                    <a:gd name="connsiteX8" fmla="*/ 16625 w 166254"/>
                    <a:gd name="connsiteY8" fmla="*/ 1579418 h 1695796"/>
                    <a:gd name="connsiteX9" fmla="*/ 33251 w 166254"/>
                    <a:gd name="connsiteY9" fmla="*/ 1645920 h 1695796"/>
                    <a:gd name="connsiteX10" fmla="*/ 49876 w 166254"/>
                    <a:gd name="connsiteY10" fmla="*/ 1695796 h 16957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166254" h="1695796">
                      <a:moveTo>
                        <a:pt x="166254" y="0"/>
                      </a:moveTo>
                      <a:cubicBezTo>
                        <a:pt x="164534" y="4300"/>
                        <a:pt x="120102" y="110659"/>
                        <a:pt x="116378" y="133004"/>
                      </a:cubicBezTo>
                      <a:cubicBezTo>
                        <a:pt x="108128" y="182504"/>
                        <a:pt x="108002" y="233133"/>
                        <a:pt x="99752" y="282633"/>
                      </a:cubicBezTo>
                      <a:cubicBezTo>
                        <a:pt x="96871" y="299919"/>
                        <a:pt x="87377" y="315508"/>
                        <a:pt x="83127" y="332509"/>
                      </a:cubicBezTo>
                      <a:cubicBezTo>
                        <a:pt x="76274" y="359923"/>
                        <a:pt x="72044" y="387927"/>
                        <a:pt x="66502" y="415636"/>
                      </a:cubicBezTo>
                      <a:cubicBezTo>
                        <a:pt x="60960" y="498763"/>
                        <a:pt x="59076" y="582216"/>
                        <a:pt x="49876" y="665018"/>
                      </a:cubicBezTo>
                      <a:cubicBezTo>
                        <a:pt x="47941" y="682435"/>
                        <a:pt x="37053" y="697787"/>
                        <a:pt x="33251" y="714894"/>
                      </a:cubicBezTo>
                      <a:cubicBezTo>
                        <a:pt x="14499" y="799278"/>
                        <a:pt x="8364" y="897263"/>
                        <a:pt x="0" y="980902"/>
                      </a:cubicBezTo>
                      <a:cubicBezTo>
                        <a:pt x="5542" y="1180407"/>
                        <a:pt x="6658" y="1380085"/>
                        <a:pt x="16625" y="1579418"/>
                      </a:cubicBezTo>
                      <a:cubicBezTo>
                        <a:pt x="17766" y="1602239"/>
                        <a:pt x="26974" y="1623950"/>
                        <a:pt x="33251" y="1645920"/>
                      </a:cubicBezTo>
                      <a:cubicBezTo>
                        <a:pt x="38065" y="1662770"/>
                        <a:pt x="49876" y="1695796"/>
                        <a:pt x="49876" y="1695796"/>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20" name="Freeform 119"/>
                <p:cNvSpPr/>
                <p:nvPr/>
              </p:nvSpPr>
              <p:spPr>
                <a:xfrm>
                  <a:off x="976498" y="3842872"/>
                  <a:ext cx="711736" cy="1394896"/>
                </a:xfrm>
                <a:custGeom>
                  <a:avLst/>
                  <a:gdLst>
                    <a:gd name="connsiteX0" fmla="*/ 0 w 714895"/>
                    <a:gd name="connsiteY0" fmla="*/ 0 h 1429789"/>
                    <a:gd name="connsiteX1" fmla="*/ 33251 w 714895"/>
                    <a:gd name="connsiteY1" fmla="*/ 99753 h 1429789"/>
                    <a:gd name="connsiteX2" fmla="*/ 66502 w 714895"/>
                    <a:gd name="connsiteY2" fmla="*/ 166255 h 1429789"/>
                    <a:gd name="connsiteX3" fmla="*/ 133004 w 714895"/>
                    <a:gd name="connsiteY3" fmla="*/ 332509 h 1429789"/>
                    <a:gd name="connsiteX4" fmla="*/ 149629 w 714895"/>
                    <a:gd name="connsiteY4" fmla="*/ 415636 h 1429789"/>
                    <a:gd name="connsiteX5" fmla="*/ 199506 w 714895"/>
                    <a:gd name="connsiteY5" fmla="*/ 565266 h 1429789"/>
                    <a:gd name="connsiteX6" fmla="*/ 216131 w 714895"/>
                    <a:gd name="connsiteY6" fmla="*/ 615142 h 1429789"/>
                    <a:gd name="connsiteX7" fmla="*/ 282633 w 714895"/>
                    <a:gd name="connsiteY7" fmla="*/ 764771 h 1429789"/>
                    <a:gd name="connsiteX8" fmla="*/ 315884 w 714895"/>
                    <a:gd name="connsiteY8" fmla="*/ 814647 h 1429789"/>
                    <a:gd name="connsiteX9" fmla="*/ 349135 w 714895"/>
                    <a:gd name="connsiteY9" fmla="*/ 947651 h 1429789"/>
                    <a:gd name="connsiteX10" fmla="*/ 382386 w 714895"/>
                    <a:gd name="connsiteY10" fmla="*/ 1047404 h 1429789"/>
                    <a:gd name="connsiteX11" fmla="*/ 432262 w 714895"/>
                    <a:gd name="connsiteY11" fmla="*/ 1113906 h 1429789"/>
                    <a:gd name="connsiteX12" fmla="*/ 465513 w 714895"/>
                    <a:gd name="connsiteY12" fmla="*/ 1163782 h 1429789"/>
                    <a:gd name="connsiteX13" fmla="*/ 515389 w 714895"/>
                    <a:gd name="connsiteY13" fmla="*/ 1213658 h 1429789"/>
                    <a:gd name="connsiteX14" fmla="*/ 598517 w 714895"/>
                    <a:gd name="connsiteY14" fmla="*/ 1296786 h 1429789"/>
                    <a:gd name="connsiteX15" fmla="*/ 681644 w 714895"/>
                    <a:gd name="connsiteY15" fmla="*/ 1379913 h 1429789"/>
                    <a:gd name="connsiteX16" fmla="*/ 714895 w 714895"/>
                    <a:gd name="connsiteY16" fmla="*/ 1429789 h 1429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714895" h="1429789">
                      <a:moveTo>
                        <a:pt x="0" y="0"/>
                      </a:moveTo>
                      <a:cubicBezTo>
                        <a:pt x="11084" y="33251"/>
                        <a:pt x="17576" y="68404"/>
                        <a:pt x="33251" y="99753"/>
                      </a:cubicBezTo>
                      <a:cubicBezTo>
                        <a:pt x="44335" y="121920"/>
                        <a:pt x="57297" y="143244"/>
                        <a:pt x="66502" y="166255"/>
                      </a:cubicBezTo>
                      <a:cubicBezTo>
                        <a:pt x="148679" y="371696"/>
                        <a:pt x="55024" y="176550"/>
                        <a:pt x="133004" y="332509"/>
                      </a:cubicBezTo>
                      <a:cubicBezTo>
                        <a:pt x="138546" y="360218"/>
                        <a:pt x="142194" y="388374"/>
                        <a:pt x="149629" y="415636"/>
                      </a:cubicBezTo>
                      <a:cubicBezTo>
                        <a:pt x="149634" y="415654"/>
                        <a:pt x="191190" y="540319"/>
                        <a:pt x="199506" y="565266"/>
                      </a:cubicBezTo>
                      <a:cubicBezTo>
                        <a:pt x="205048" y="581891"/>
                        <a:pt x="209622" y="598871"/>
                        <a:pt x="216131" y="615142"/>
                      </a:cubicBezTo>
                      <a:cubicBezTo>
                        <a:pt x="239882" y="674520"/>
                        <a:pt x="251569" y="710409"/>
                        <a:pt x="282633" y="764771"/>
                      </a:cubicBezTo>
                      <a:cubicBezTo>
                        <a:pt x="292546" y="782120"/>
                        <a:pt x="304800" y="798022"/>
                        <a:pt x="315884" y="814647"/>
                      </a:cubicBezTo>
                      <a:cubicBezTo>
                        <a:pt x="366334" y="966002"/>
                        <a:pt x="288940" y="726938"/>
                        <a:pt x="349135" y="947651"/>
                      </a:cubicBezTo>
                      <a:cubicBezTo>
                        <a:pt x="358357" y="981466"/>
                        <a:pt x="361356" y="1019364"/>
                        <a:pt x="382386" y="1047404"/>
                      </a:cubicBezTo>
                      <a:cubicBezTo>
                        <a:pt x="399011" y="1069571"/>
                        <a:pt x="416156" y="1091358"/>
                        <a:pt x="432262" y="1113906"/>
                      </a:cubicBezTo>
                      <a:cubicBezTo>
                        <a:pt x="443876" y="1130165"/>
                        <a:pt x="452721" y="1148432"/>
                        <a:pt x="465513" y="1163782"/>
                      </a:cubicBezTo>
                      <a:cubicBezTo>
                        <a:pt x="480565" y="1181844"/>
                        <a:pt x="500337" y="1195596"/>
                        <a:pt x="515389" y="1213658"/>
                      </a:cubicBezTo>
                      <a:cubicBezTo>
                        <a:pt x="584662" y="1296786"/>
                        <a:pt x="507076" y="1235826"/>
                        <a:pt x="598517" y="1296786"/>
                      </a:cubicBezTo>
                      <a:cubicBezTo>
                        <a:pt x="687186" y="1429789"/>
                        <a:pt x="570808" y="1269077"/>
                        <a:pt x="681644" y="1379913"/>
                      </a:cubicBezTo>
                      <a:cubicBezTo>
                        <a:pt x="695773" y="1394042"/>
                        <a:pt x="714895" y="1429789"/>
                        <a:pt x="714895" y="1429789"/>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grpSp>
        </p:grpSp>
        <p:grpSp>
          <p:nvGrpSpPr>
            <p:cNvPr id="11348" name="Group 31"/>
            <p:cNvGrpSpPr>
              <a:grpSpLocks/>
            </p:cNvGrpSpPr>
            <p:nvPr/>
          </p:nvGrpSpPr>
          <p:grpSpPr bwMode="auto">
            <a:xfrm>
              <a:off x="2485249" y="8771860"/>
              <a:ext cx="1048512" cy="2414098"/>
              <a:chOff x="-69626" y="106702"/>
              <a:chExt cx="2080253" cy="5319934"/>
            </a:xfrm>
          </p:grpSpPr>
          <p:sp>
            <p:nvSpPr>
              <p:cNvPr id="107" name="Freeform 106"/>
              <p:cNvSpPr/>
              <p:nvPr/>
            </p:nvSpPr>
            <p:spPr>
              <a:xfrm rot="20683283">
                <a:off x="-68604" y="104586"/>
                <a:ext cx="2078521" cy="3550214"/>
              </a:xfrm>
              <a:custGeom>
                <a:avLst/>
                <a:gdLst>
                  <a:gd name="connsiteX0" fmla="*/ 483980 w 2080024"/>
                  <a:gd name="connsiteY0" fmla="*/ 3391592 h 3547685"/>
                  <a:gd name="connsiteX1" fmla="*/ 450729 w 2080024"/>
                  <a:gd name="connsiteY1" fmla="*/ 3341716 h 3547685"/>
                  <a:gd name="connsiteX2" fmla="*/ 400853 w 2080024"/>
                  <a:gd name="connsiteY2" fmla="*/ 3275214 h 3547685"/>
                  <a:gd name="connsiteX3" fmla="*/ 350977 w 2080024"/>
                  <a:gd name="connsiteY3" fmla="*/ 3125585 h 3547685"/>
                  <a:gd name="connsiteX4" fmla="*/ 334351 w 2080024"/>
                  <a:gd name="connsiteY4" fmla="*/ 3075709 h 3547685"/>
                  <a:gd name="connsiteX5" fmla="*/ 301100 w 2080024"/>
                  <a:gd name="connsiteY5" fmla="*/ 3025832 h 3547685"/>
                  <a:gd name="connsiteX6" fmla="*/ 284475 w 2080024"/>
                  <a:gd name="connsiteY6" fmla="*/ 2975956 h 3547685"/>
                  <a:gd name="connsiteX7" fmla="*/ 251224 w 2080024"/>
                  <a:gd name="connsiteY7" fmla="*/ 2909454 h 3547685"/>
                  <a:gd name="connsiteX8" fmla="*/ 234599 w 2080024"/>
                  <a:gd name="connsiteY8" fmla="*/ 2842952 h 3547685"/>
                  <a:gd name="connsiteX9" fmla="*/ 201348 w 2080024"/>
                  <a:gd name="connsiteY9" fmla="*/ 2793076 h 3547685"/>
                  <a:gd name="connsiteX10" fmla="*/ 151471 w 2080024"/>
                  <a:gd name="connsiteY10" fmla="*/ 2693323 h 3547685"/>
                  <a:gd name="connsiteX11" fmla="*/ 84969 w 2080024"/>
                  <a:gd name="connsiteY11" fmla="*/ 2560320 h 3547685"/>
                  <a:gd name="connsiteX12" fmla="*/ 68344 w 2080024"/>
                  <a:gd name="connsiteY12" fmla="*/ 2510443 h 3547685"/>
                  <a:gd name="connsiteX13" fmla="*/ 35093 w 2080024"/>
                  <a:gd name="connsiteY13" fmla="*/ 2394065 h 3547685"/>
                  <a:gd name="connsiteX14" fmla="*/ 18468 w 2080024"/>
                  <a:gd name="connsiteY14" fmla="*/ 2277687 h 3547685"/>
                  <a:gd name="connsiteX15" fmla="*/ 51719 w 2080024"/>
                  <a:gd name="connsiteY15" fmla="*/ 1745672 h 3547685"/>
                  <a:gd name="connsiteX16" fmla="*/ 101595 w 2080024"/>
                  <a:gd name="connsiteY16" fmla="*/ 1629294 h 3547685"/>
                  <a:gd name="connsiteX17" fmla="*/ 118220 w 2080024"/>
                  <a:gd name="connsiteY17" fmla="*/ 1579418 h 3547685"/>
                  <a:gd name="connsiteX18" fmla="*/ 184722 w 2080024"/>
                  <a:gd name="connsiteY18" fmla="*/ 1479665 h 3547685"/>
                  <a:gd name="connsiteX19" fmla="*/ 284475 w 2080024"/>
                  <a:gd name="connsiteY19" fmla="*/ 1330036 h 3547685"/>
                  <a:gd name="connsiteX20" fmla="*/ 317726 w 2080024"/>
                  <a:gd name="connsiteY20" fmla="*/ 1280160 h 3547685"/>
                  <a:gd name="connsiteX21" fmla="*/ 350977 w 2080024"/>
                  <a:gd name="connsiteY21" fmla="*/ 1230283 h 3547685"/>
                  <a:gd name="connsiteX22" fmla="*/ 417479 w 2080024"/>
                  <a:gd name="connsiteY22" fmla="*/ 1163782 h 3547685"/>
                  <a:gd name="connsiteX23" fmla="*/ 434104 w 2080024"/>
                  <a:gd name="connsiteY23" fmla="*/ 1113905 h 3547685"/>
                  <a:gd name="connsiteX24" fmla="*/ 517231 w 2080024"/>
                  <a:gd name="connsiteY24" fmla="*/ 1030778 h 3547685"/>
                  <a:gd name="connsiteX25" fmla="*/ 550482 w 2080024"/>
                  <a:gd name="connsiteY25" fmla="*/ 980902 h 3547685"/>
                  <a:gd name="connsiteX26" fmla="*/ 666860 w 2080024"/>
                  <a:gd name="connsiteY26" fmla="*/ 881149 h 3547685"/>
                  <a:gd name="connsiteX27" fmla="*/ 700111 w 2080024"/>
                  <a:gd name="connsiteY27" fmla="*/ 831272 h 3547685"/>
                  <a:gd name="connsiteX28" fmla="*/ 799864 w 2080024"/>
                  <a:gd name="connsiteY28" fmla="*/ 731520 h 3547685"/>
                  <a:gd name="connsiteX29" fmla="*/ 849740 w 2080024"/>
                  <a:gd name="connsiteY29" fmla="*/ 665018 h 3547685"/>
                  <a:gd name="connsiteX30" fmla="*/ 949493 w 2080024"/>
                  <a:gd name="connsiteY30" fmla="*/ 581891 h 3547685"/>
                  <a:gd name="connsiteX31" fmla="*/ 982744 w 2080024"/>
                  <a:gd name="connsiteY31" fmla="*/ 532014 h 3547685"/>
                  <a:gd name="connsiteX32" fmla="*/ 1049246 w 2080024"/>
                  <a:gd name="connsiteY32" fmla="*/ 482138 h 3547685"/>
                  <a:gd name="connsiteX33" fmla="*/ 1099122 w 2080024"/>
                  <a:gd name="connsiteY33" fmla="*/ 415636 h 3547685"/>
                  <a:gd name="connsiteX34" fmla="*/ 1265377 w 2080024"/>
                  <a:gd name="connsiteY34" fmla="*/ 266007 h 3547685"/>
                  <a:gd name="connsiteX35" fmla="*/ 1365129 w 2080024"/>
                  <a:gd name="connsiteY35" fmla="*/ 182880 h 3547685"/>
                  <a:gd name="connsiteX36" fmla="*/ 1481508 w 2080024"/>
                  <a:gd name="connsiteY36" fmla="*/ 49876 h 3547685"/>
                  <a:gd name="connsiteX37" fmla="*/ 1498133 w 2080024"/>
                  <a:gd name="connsiteY37" fmla="*/ 0 h 3547685"/>
                  <a:gd name="connsiteX38" fmla="*/ 1548009 w 2080024"/>
                  <a:gd name="connsiteY38" fmla="*/ 116378 h 3547685"/>
                  <a:gd name="connsiteX39" fmla="*/ 1597886 w 2080024"/>
                  <a:gd name="connsiteY39" fmla="*/ 249382 h 3547685"/>
                  <a:gd name="connsiteX40" fmla="*/ 1647762 w 2080024"/>
                  <a:gd name="connsiteY40" fmla="*/ 365760 h 3547685"/>
                  <a:gd name="connsiteX41" fmla="*/ 1664388 w 2080024"/>
                  <a:gd name="connsiteY41" fmla="*/ 448887 h 3547685"/>
                  <a:gd name="connsiteX42" fmla="*/ 1697639 w 2080024"/>
                  <a:gd name="connsiteY42" fmla="*/ 498763 h 3547685"/>
                  <a:gd name="connsiteX43" fmla="*/ 1714264 w 2080024"/>
                  <a:gd name="connsiteY43" fmla="*/ 548640 h 3547685"/>
                  <a:gd name="connsiteX44" fmla="*/ 1730889 w 2080024"/>
                  <a:gd name="connsiteY44" fmla="*/ 615142 h 3547685"/>
                  <a:gd name="connsiteX45" fmla="*/ 1780766 w 2080024"/>
                  <a:gd name="connsiteY45" fmla="*/ 764771 h 3547685"/>
                  <a:gd name="connsiteX46" fmla="*/ 1814017 w 2080024"/>
                  <a:gd name="connsiteY46" fmla="*/ 864523 h 3547685"/>
                  <a:gd name="connsiteX47" fmla="*/ 1847268 w 2080024"/>
                  <a:gd name="connsiteY47" fmla="*/ 914400 h 3547685"/>
                  <a:gd name="connsiteX48" fmla="*/ 1913769 w 2080024"/>
                  <a:gd name="connsiteY48" fmla="*/ 1147156 h 3547685"/>
                  <a:gd name="connsiteX49" fmla="*/ 1930395 w 2080024"/>
                  <a:gd name="connsiteY49" fmla="*/ 1197032 h 3547685"/>
                  <a:gd name="connsiteX50" fmla="*/ 1963646 w 2080024"/>
                  <a:gd name="connsiteY50" fmla="*/ 1246909 h 3547685"/>
                  <a:gd name="connsiteX51" fmla="*/ 1980271 w 2080024"/>
                  <a:gd name="connsiteY51" fmla="*/ 1313411 h 3547685"/>
                  <a:gd name="connsiteX52" fmla="*/ 1996897 w 2080024"/>
                  <a:gd name="connsiteY52" fmla="*/ 1363287 h 3547685"/>
                  <a:gd name="connsiteX53" fmla="*/ 2030148 w 2080024"/>
                  <a:gd name="connsiteY53" fmla="*/ 1546167 h 3547685"/>
                  <a:gd name="connsiteX54" fmla="*/ 2046773 w 2080024"/>
                  <a:gd name="connsiteY54" fmla="*/ 1596043 h 3547685"/>
                  <a:gd name="connsiteX55" fmla="*/ 2063399 w 2080024"/>
                  <a:gd name="connsiteY55" fmla="*/ 1729047 h 3547685"/>
                  <a:gd name="connsiteX56" fmla="*/ 2080024 w 2080024"/>
                  <a:gd name="connsiteY56" fmla="*/ 1828800 h 3547685"/>
                  <a:gd name="connsiteX57" fmla="*/ 2063399 w 2080024"/>
                  <a:gd name="connsiteY57" fmla="*/ 2410691 h 3547685"/>
                  <a:gd name="connsiteX58" fmla="*/ 2013522 w 2080024"/>
                  <a:gd name="connsiteY58" fmla="*/ 2576945 h 3547685"/>
                  <a:gd name="connsiteX59" fmla="*/ 1980271 w 2080024"/>
                  <a:gd name="connsiteY59" fmla="*/ 2676698 h 3547685"/>
                  <a:gd name="connsiteX60" fmla="*/ 1930395 w 2080024"/>
                  <a:gd name="connsiteY60" fmla="*/ 2726574 h 3547685"/>
                  <a:gd name="connsiteX61" fmla="*/ 1847268 w 2080024"/>
                  <a:gd name="connsiteY61" fmla="*/ 2876203 h 3547685"/>
                  <a:gd name="connsiteX62" fmla="*/ 1780766 w 2080024"/>
                  <a:gd name="connsiteY62" fmla="*/ 2975956 h 3547685"/>
                  <a:gd name="connsiteX63" fmla="*/ 1747515 w 2080024"/>
                  <a:gd name="connsiteY63" fmla="*/ 3025832 h 3547685"/>
                  <a:gd name="connsiteX64" fmla="*/ 1697639 w 2080024"/>
                  <a:gd name="connsiteY64" fmla="*/ 3059083 h 3547685"/>
                  <a:gd name="connsiteX65" fmla="*/ 1614511 w 2080024"/>
                  <a:gd name="connsiteY65" fmla="*/ 3142211 h 3547685"/>
                  <a:gd name="connsiteX66" fmla="*/ 1531384 w 2080024"/>
                  <a:gd name="connsiteY66" fmla="*/ 3208712 h 3547685"/>
                  <a:gd name="connsiteX67" fmla="*/ 1431631 w 2080024"/>
                  <a:gd name="connsiteY67" fmla="*/ 3258589 h 3547685"/>
                  <a:gd name="connsiteX68" fmla="*/ 1381755 w 2080024"/>
                  <a:gd name="connsiteY68" fmla="*/ 3291840 h 3547685"/>
                  <a:gd name="connsiteX69" fmla="*/ 1282002 w 2080024"/>
                  <a:gd name="connsiteY69" fmla="*/ 3325091 h 3547685"/>
                  <a:gd name="connsiteX70" fmla="*/ 1232126 w 2080024"/>
                  <a:gd name="connsiteY70" fmla="*/ 3341716 h 3547685"/>
                  <a:gd name="connsiteX71" fmla="*/ 1182249 w 2080024"/>
                  <a:gd name="connsiteY71" fmla="*/ 3374967 h 3547685"/>
                  <a:gd name="connsiteX72" fmla="*/ 1032620 w 2080024"/>
                  <a:gd name="connsiteY72" fmla="*/ 3424843 h 3547685"/>
                  <a:gd name="connsiteX73" fmla="*/ 982744 w 2080024"/>
                  <a:gd name="connsiteY73" fmla="*/ 3441469 h 3547685"/>
                  <a:gd name="connsiteX74" fmla="*/ 932868 w 2080024"/>
                  <a:gd name="connsiteY74" fmla="*/ 3474720 h 3547685"/>
                  <a:gd name="connsiteX75" fmla="*/ 849740 w 2080024"/>
                  <a:gd name="connsiteY75" fmla="*/ 3491345 h 3547685"/>
                  <a:gd name="connsiteX76" fmla="*/ 783239 w 2080024"/>
                  <a:gd name="connsiteY76" fmla="*/ 3507971 h 3547685"/>
                  <a:gd name="connsiteX77" fmla="*/ 600359 w 2080024"/>
                  <a:gd name="connsiteY77" fmla="*/ 3541222 h 3547685"/>
                  <a:gd name="connsiteX78" fmla="*/ 550482 w 2080024"/>
                  <a:gd name="connsiteY78" fmla="*/ 3524596 h 3547685"/>
                  <a:gd name="connsiteX79" fmla="*/ 517231 w 2080024"/>
                  <a:gd name="connsiteY79" fmla="*/ 3474720 h 3547685"/>
                  <a:gd name="connsiteX80" fmla="*/ 467355 w 2080024"/>
                  <a:gd name="connsiteY80" fmla="*/ 3441469 h 3547685"/>
                  <a:gd name="connsiteX81" fmla="*/ 450729 w 2080024"/>
                  <a:gd name="connsiteY81" fmla="*/ 3391592 h 3547685"/>
                  <a:gd name="connsiteX82" fmla="*/ 400853 w 2080024"/>
                  <a:gd name="connsiteY82" fmla="*/ 3325091 h 3547685"/>
                  <a:gd name="connsiteX83" fmla="*/ 367602 w 2080024"/>
                  <a:gd name="connsiteY83" fmla="*/ 3275214 h 3547685"/>
                  <a:gd name="connsiteX84" fmla="*/ 301100 w 2080024"/>
                  <a:gd name="connsiteY84" fmla="*/ 3208712 h 354768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Lst>
                <a:rect l="l" t="t" r="r" b="b"/>
                <a:pathLst>
                  <a:path w="2080024" h="3547685">
                    <a:moveTo>
                      <a:pt x="483980" y="3391592"/>
                    </a:moveTo>
                    <a:cubicBezTo>
                      <a:pt x="472896" y="3374967"/>
                      <a:pt x="462343" y="3357975"/>
                      <a:pt x="450729" y="3341716"/>
                    </a:cubicBezTo>
                    <a:cubicBezTo>
                      <a:pt x="434623" y="3319168"/>
                      <a:pt x="413245" y="3299998"/>
                      <a:pt x="400853" y="3275214"/>
                    </a:cubicBezTo>
                    <a:cubicBezTo>
                      <a:pt x="400845" y="3275198"/>
                      <a:pt x="359292" y="3150531"/>
                      <a:pt x="350977" y="3125585"/>
                    </a:cubicBezTo>
                    <a:cubicBezTo>
                      <a:pt x="345435" y="3108960"/>
                      <a:pt x="344072" y="3090290"/>
                      <a:pt x="334351" y="3075709"/>
                    </a:cubicBezTo>
                    <a:lnTo>
                      <a:pt x="301100" y="3025832"/>
                    </a:lnTo>
                    <a:cubicBezTo>
                      <a:pt x="295558" y="3009207"/>
                      <a:pt x="291378" y="2992064"/>
                      <a:pt x="284475" y="2975956"/>
                    </a:cubicBezTo>
                    <a:cubicBezTo>
                      <a:pt x="274712" y="2953176"/>
                      <a:pt x="259926" y="2932660"/>
                      <a:pt x="251224" y="2909454"/>
                    </a:cubicBezTo>
                    <a:cubicBezTo>
                      <a:pt x="243201" y="2888059"/>
                      <a:pt x="243600" y="2863954"/>
                      <a:pt x="234599" y="2842952"/>
                    </a:cubicBezTo>
                    <a:cubicBezTo>
                      <a:pt x="226728" y="2824586"/>
                      <a:pt x="210284" y="2810948"/>
                      <a:pt x="201348" y="2793076"/>
                    </a:cubicBezTo>
                    <a:cubicBezTo>
                      <a:pt x="132512" y="2655406"/>
                      <a:pt x="246768" y="2836269"/>
                      <a:pt x="151471" y="2693323"/>
                    </a:cubicBezTo>
                    <a:cubicBezTo>
                      <a:pt x="118415" y="2561099"/>
                      <a:pt x="160331" y="2692204"/>
                      <a:pt x="84969" y="2560320"/>
                    </a:cubicBezTo>
                    <a:cubicBezTo>
                      <a:pt x="76274" y="2545104"/>
                      <a:pt x="73158" y="2527294"/>
                      <a:pt x="68344" y="2510443"/>
                    </a:cubicBezTo>
                    <a:cubicBezTo>
                      <a:pt x="26601" y="2364338"/>
                      <a:pt x="74950" y="2513634"/>
                      <a:pt x="35093" y="2394065"/>
                    </a:cubicBezTo>
                    <a:cubicBezTo>
                      <a:pt x="29551" y="2355272"/>
                      <a:pt x="18468" y="2316873"/>
                      <a:pt x="18468" y="2277687"/>
                    </a:cubicBezTo>
                    <a:cubicBezTo>
                      <a:pt x="18468" y="2034785"/>
                      <a:pt x="0" y="1926688"/>
                      <a:pt x="51719" y="1745672"/>
                    </a:cubicBezTo>
                    <a:cubicBezTo>
                      <a:pt x="74000" y="1667688"/>
                      <a:pt x="63591" y="1717970"/>
                      <a:pt x="101595" y="1629294"/>
                    </a:cubicBezTo>
                    <a:cubicBezTo>
                      <a:pt x="108498" y="1613186"/>
                      <a:pt x="109709" y="1594737"/>
                      <a:pt x="118220" y="1579418"/>
                    </a:cubicBezTo>
                    <a:cubicBezTo>
                      <a:pt x="137628" y="1544484"/>
                      <a:pt x="162555" y="1512916"/>
                      <a:pt x="184722" y="1479665"/>
                    </a:cubicBezTo>
                    <a:lnTo>
                      <a:pt x="284475" y="1330036"/>
                    </a:lnTo>
                    <a:lnTo>
                      <a:pt x="317726" y="1280160"/>
                    </a:lnTo>
                    <a:lnTo>
                      <a:pt x="350977" y="1230283"/>
                    </a:lnTo>
                    <a:cubicBezTo>
                      <a:pt x="395311" y="1097280"/>
                      <a:pt x="328809" y="1252452"/>
                      <a:pt x="417479" y="1163782"/>
                    </a:cubicBezTo>
                    <a:cubicBezTo>
                      <a:pt x="429871" y="1151390"/>
                      <a:pt x="426267" y="1129580"/>
                      <a:pt x="434104" y="1113905"/>
                    </a:cubicBezTo>
                    <a:cubicBezTo>
                      <a:pt x="461812" y="1058488"/>
                      <a:pt x="467356" y="1064028"/>
                      <a:pt x="517231" y="1030778"/>
                    </a:cubicBezTo>
                    <a:cubicBezTo>
                      <a:pt x="528315" y="1014153"/>
                      <a:pt x="536353" y="995031"/>
                      <a:pt x="550482" y="980902"/>
                    </a:cubicBezTo>
                    <a:cubicBezTo>
                      <a:pt x="660554" y="870830"/>
                      <a:pt x="576381" y="989725"/>
                      <a:pt x="666860" y="881149"/>
                    </a:cubicBezTo>
                    <a:cubicBezTo>
                      <a:pt x="679652" y="865799"/>
                      <a:pt x="686836" y="846206"/>
                      <a:pt x="700111" y="831272"/>
                    </a:cubicBezTo>
                    <a:cubicBezTo>
                      <a:pt x="731352" y="796126"/>
                      <a:pt x="771650" y="769139"/>
                      <a:pt x="799864" y="731520"/>
                    </a:cubicBezTo>
                    <a:cubicBezTo>
                      <a:pt x="816489" y="709353"/>
                      <a:pt x="830147" y="684611"/>
                      <a:pt x="849740" y="665018"/>
                    </a:cubicBezTo>
                    <a:cubicBezTo>
                      <a:pt x="980517" y="534241"/>
                      <a:pt x="813314" y="745306"/>
                      <a:pt x="949493" y="581891"/>
                    </a:cubicBezTo>
                    <a:cubicBezTo>
                      <a:pt x="962285" y="566541"/>
                      <a:pt x="968615" y="546143"/>
                      <a:pt x="982744" y="532014"/>
                    </a:cubicBezTo>
                    <a:cubicBezTo>
                      <a:pt x="1002337" y="512421"/>
                      <a:pt x="1029653" y="501731"/>
                      <a:pt x="1049246" y="482138"/>
                    </a:cubicBezTo>
                    <a:cubicBezTo>
                      <a:pt x="1068839" y="462545"/>
                      <a:pt x="1080586" y="436232"/>
                      <a:pt x="1099122" y="415636"/>
                    </a:cubicBezTo>
                    <a:cubicBezTo>
                      <a:pt x="1240799" y="258216"/>
                      <a:pt x="1148097" y="366532"/>
                      <a:pt x="1265377" y="266007"/>
                    </a:cubicBezTo>
                    <a:cubicBezTo>
                      <a:pt x="1377390" y="169996"/>
                      <a:pt x="1254891" y="256373"/>
                      <a:pt x="1365129" y="182880"/>
                    </a:cubicBezTo>
                    <a:cubicBezTo>
                      <a:pt x="1442715" y="66501"/>
                      <a:pt x="1398380" y="105294"/>
                      <a:pt x="1481508" y="49876"/>
                    </a:cubicBezTo>
                    <a:cubicBezTo>
                      <a:pt x="1487050" y="33251"/>
                      <a:pt x="1480608" y="0"/>
                      <a:pt x="1498133" y="0"/>
                    </a:cubicBezTo>
                    <a:cubicBezTo>
                      <a:pt x="1527059" y="0"/>
                      <a:pt x="1545978" y="109268"/>
                      <a:pt x="1548009" y="116378"/>
                    </a:cubicBezTo>
                    <a:cubicBezTo>
                      <a:pt x="1563100" y="169198"/>
                      <a:pt x="1576812" y="193184"/>
                      <a:pt x="1597886" y="249382"/>
                    </a:cubicBezTo>
                    <a:cubicBezTo>
                      <a:pt x="1634580" y="347234"/>
                      <a:pt x="1589375" y="248986"/>
                      <a:pt x="1647762" y="365760"/>
                    </a:cubicBezTo>
                    <a:cubicBezTo>
                      <a:pt x="1653304" y="393469"/>
                      <a:pt x="1654466" y="422428"/>
                      <a:pt x="1664388" y="448887"/>
                    </a:cubicBezTo>
                    <a:cubicBezTo>
                      <a:pt x="1671404" y="467596"/>
                      <a:pt x="1688703" y="480891"/>
                      <a:pt x="1697639" y="498763"/>
                    </a:cubicBezTo>
                    <a:cubicBezTo>
                      <a:pt x="1705476" y="514438"/>
                      <a:pt x="1709450" y="531789"/>
                      <a:pt x="1714264" y="548640"/>
                    </a:cubicBezTo>
                    <a:cubicBezTo>
                      <a:pt x="1720541" y="570610"/>
                      <a:pt x="1724323" y="593256"/>
                      <a:pt x="1730889" y="615142"/>
                    </a:cubicBezTo>
                    <a:cubicBezTo>
                      <a:pt x="1730895" y="615164"/>
                      <a:pt x="1772450" y="739823"/>
                      <a:pt x="1780766" y="764771"/>
                    </a:cubicBezTo>
                    <a:cubicBezTo>
                      <a:pt x="1780768" y="764776"/>
                      <a:pt x="1814014" y="864519"/>
                      <a:pt x="1814017" y="864523"/>
                    </a:cubicBezTo>
                    <a:lnTo>
                      <a:pt x="1847268" y="914400"/>
                    </a:lnTo>
                    <a:cubicBezTo>
                      <a:pt x="1889015" y="1081389"/>
                      <a:pt x="1866072" y="1004063"/>
                      <a:pt x="1913769" y="1147156"/>
                    </a:cubicBezTo>
                    <a:cubicBezTo>
                      <a:pt x="1919311" y="1163781"/>
                      <a:pt x="1920674" y="1182451"/>
                      <a:pt x="1930395" y="1197032"/>
                    </a:cubicBezTo>
                    <a:lnTo>
                      <a:pt x="1963646" y="1246909"/>
                    </a:lnTo>
                    <a:cubicBezTo>
                      <a:pt x="1969188" y="1269076"/>
                      <a:pt x="1973994" y="1291441"/>
                      <a:pt x="1980271" y="1313411"/>
                    </a:cubicBezTo>
                    <a:cubicBezTo>
                      <a:pt x="1985085" y="1330261"/>
                      <a:pt x="1993095" y="1346180"/>
                      <a:pt x="1996897" y="1363287"/>
                    </a:cubicBezTo>
                    <a:cubicBezTo>
                      <a:pt x="2026554" y="1496744"/>
                      <a:pt x="1999880" y="1425098"/>
                      <a:pt x="2030148" y="1546167"/>
                    </a:cubicBezTo>
                    <a:cubicBezTo>
                      <a:pt x="2034398" y="1563168"/>
                      <a:pt x="2041231" y="1579418"/>
                      <a:pt x="2046773" y="1596043"/>
                    </a:cubicBezTo>
                    <a:cubicBezTo>
                      <a:pt x="2052315" y="1640378"/>
                      <a:pt x="2057080" y="1684816"/>
                      <a:pt x="2063399" y="1729047"/>
                    </a:cubicBezTo>
                    <a:cubicBezTo>
                      <a:pt x="2068166" y="1762418"/>
                      <a:pt x="2080024" y="1795090"/>
                      <a:pt x="2080024" y="1828800"/>
                    </a:cubicBezTo>
                    <a:cubicBezTo>
                      <a:pt x="2080024" y="2022843"/>
                      <a:pt x="2073337" y="2216903"/>
                      <a:pt x="2063399" y="2410691"/>
                    </a:cubicBezTo>
                    <a:cubicBezTo>
                      <a:pt x="2061876" y="2440382"/>
                      <a:pt x="2017790" y="2564140"/>
                      <a:pt x="2013522" y="2576945"/>
                    </a:cubicBezTo>
                    <a:lnTo>
                      <a:pt x="1980271" y="2676698"/>
                    </a:lnTo>
                    <a:lnTo>
                      <a:pt x="1930395" y="2726574"/>
                    </a:lnTo>
                    <a:cubicBezTo>
                      <a:pt x="1901132" y="2814363"/>
                      <a:pt x="1923490" y="2761869"/>
                      <a:pt x="1847268" y="2876203"/>
                    </a:cubicBezTo>
                    <a:lnTo>
                      <a:pt x="1780766" y="2975956"/>
                    </a:lnTo>
                    <a:cubicBezTo>
                      <a:pt x="1769682" y="2992581"/>
                      <a:pt x="1764140" y="3014748"/>
                      <a:pt x="1747515" y="3025832"/>
                    </a:cubicBezTo>
                    <a:lnTo>
                      <a:pt x="1697639" y="3059083"/>
                    </a:lnTo>
                    <a:cubicBezTo>
                      <a:pt x="1608972" y="3192084"/>
                      <a:pt x="1725346" y="3031378"/>
                      <a:pt x="1614511" y="3142211"/>
                    </a:cubicBezTo>
                    <a:cubicBezTo>
                      <a:pt x="1539310" y="3217411"/>
                      <a:pt x="1628482" y="3176346"/>
                      <a:pt x="1531384" y="3208712"/>
                    </a:cubicBezTo>
                    <a:cubicBezTo>
                      <a:pt x="1388448" y="3304004"/>
                      <a:pt x="1569295" y="3189756"/>
                      <a:pt x="1431631" y="3258589"/>
                    </a:cubicBezTo>
                    <a:cubicBezTo>
                      <a:pt x="1413759" y="3267525"/>
                      <a:pt x="1400014" y="3283725"/>
                      <a:pt x="1381755" y="3291840"/>
                    </a:cubicBezTo>
                    <a:cubicBezTo>
                      <a:pt x="1349726" y="3306075"/>
                      <a:pt x="1315253" y="3314007"/>
                      <a:pt x="1282002" y="3325091"/>
                    </a:cubicBezTo>
                    <a:lnTo>
                      <a:pt x="1232126" y="3341716"/>
                    </a:lnTo>
                    <a:cubicBezTo>
                      <a:pt x="1215500" y="3352800"/>
                      <a:pt x="1200508" y="3366852"/>
                      <a:pt x="1182249" y="3374967"/>
                    </a:cubicBezTo>
                    <a:cubicBezTo>
                      <a:pt x="1182226" y="3374977"/>
                      <a:pt x="1057570" y="3416526"/>
                      <a:pt x="1032620" y="3424843"/>
                    </a:cubicBezTo>
                    <a:cubicBezTo>
                      <a:pt x="1015995" y="3430385"/>
                      <a:pt x="997325" y="3431748"/>
                      <a:pt x="982744" y="3441469"/>
                    </a:cubicBezTo>
                    <a:cubicBezTo>
                      <a:pt x="966119" y="3452553"/>
                      <a:pt x="951577" y="3467704"/>
                      <a:pt x="932868" y="3474720"/>
                    </a:cubicBezTo>
                    <a:cubicBezTo>
                      <a:pt x="906409" y="3484642"/>
                      <a:pt x="877325" y="3485215"/>
                      <a:pt x="849740" y="3491345"/>
                    </a:cubicBezTo>
                    <a:cubicBezTo>
                      <a:pt x="827435" y="3496302"/>
                      <a:pt x="805720" y="3503884"/>
                      <a:pt x="783239" y="3507971"/>
                    </a:cubicBezTo>
                    <a:cubicBezTo>
                      <a:pt x="564814" y="3547685"/>
                      <a:pt x="751189" y="3503513"/>
                      <a:pt x="600359" y="3541222"/>
                    </a:cubicBezTo>
                    <a:cubicBezTo>
                      <a:pt x="583733" y="3535680"/>
                      <a:pt x="564167" y="3535544"/>
                      <a:pt x="550482" y="3524596"/>
                    </a:cubicBezTo>
                    <a:cubicBezTo>
                      <a:pt x="534879" y="3512114"/>
                      <a:pt x="531360" y="3488849"/>
                      <a:pt x="517231" y="3474720"/>
                    </a:cubicBezTo>
                    <a:cubicBezTo>
                      <a:pt x="503102" y="3460591"/>
                      <a:pt x="483980" y="3452553"/>
                      <a:pt x="467355" y="3441469"/>
                    </a:cubicBezTo>
                    <a:cubicBezTo>
                      <a:pt x="461813" y="3424843"/>
                      <a:pt x="459424" y="3406808"/>
                      <a:pt x="450729" y="3391592"/>
                    </a:cubicBezTo>
                    <a:cubicBezTo>
                      <a:pt x="436982" y="3367534"/>
                      <a:pt x="416958" y="3347639"/>
                      <a:pt x="400853" y="3325091"/>
                    </a:cubicBezTo>
                    <a:cubicBezTo>
                      <a:pt x="389239" y="3308831"/>
                      <a:pt x="380394" y="3290564"/>
                      <a:pt x="367602" y="3275214"/>
                    </a:cubicBezTo>
                    <a:lnTo>
                      <a:pt x="301100" y="3208712"/>
                    </a:lnTo>
                  </a:path>
                </a:pathLst>
              </a:custGeom>
              <a:solidFill>
                <a:srgbClr val="00C850"/>
              </a:solidFill>
              <a:ln>
                <a:solidFill>
                  <a:srgbClr val="00C850"/>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grpSp>
            <p:nvGrpSpPr>
              <p:cNvPr id="11432" name="Group 33"/>
              <p:cNvGrpSpPr>
                <a:grpSpLocks/>
              </p:cNvGrpSpPr>
              <p:nvPr/>
            </p:nvGrpSpPr>
            <p:grpSpPr bwMode="auto">
              <a:xfrm>
                <a:off x="152106" y="3676193"/>
                <a:ext cx="1560190" cy="1750443"/>
                <a:chOff x="152106" y="3676193"/>
                <a:chExt cx="1560190" cy="1750443"/>
              </a:xfrm>
            </p:grpSpPr>
            <p:sp>
              <p:nvSpPr>
                <p:cNvPr id="109" name="Freeform 108"/>
                <p:cNvSpPr/>
                <p:nvPr/>
              </p:nvSpPr>
              <p:spPr>
                <a:xfrm>
                  <a:off x="151844" y="3678124"/>
                  <a:ext cx="919589" cy="835071"/>
                </a:xfrm>
                <a:custGeom>
                  <a:avLst/>
                  <a:gdLst>
                    <a:gd name="connsiteX0" fmla="*/ 920546 w 920546"/>
                    <a:gd name="connsiteY0" fmla="*/ 0 h 834346"/>
                    <a:gd name="connsiteX1" fmla="*/ 820793 w 920546"/>
                    <a:gd name="connsiteY1" fmla="*/ 116378 h 834346"/>
                    <a:gd name="connsiteX2" fmla="*/ 804168 w 920546"/>
                    <a:gd name="connsiteY2" fmla="*/ 166254 h 834346"/>
                    <a:gd name="connsiteX3" fmla="*/ 754291 w 920546"/>
                    <a:gd name="connsiteY3" fmla="*/ 216131 h 834346"/>
                    <a:gd name="connsiteX4" fmla="*/ 687789 w 920546"/>
                    <a:gd name="connsiteY4" fmla="*/ 315883 h 834346"/>
                    <a:gd name="connsiteX5" fmla="*/ 654538 w 920546"/>
                    <a:gd name="connsiteY5" fmla="*/ 365760 h 834346"/>
                    <a:gd name="connsiteX6" fmla="*/ 554786 w 920546"/>
                    <a:gd name="connsiteY6" fmla="*/ 448887 h 834346"/>
                    <a:gd name="connsiteX7" fmla="*/ 521535 w 920546"/>
                    <a:gd name="connsiteY7" fmla="*/ 498763 h 834346"/>
                    <a:gd name="connsiteX8" fmla="*/ 471658 w 920546"/>
                    <a:gd name="connsiteY8" fmla="*/ 532014 h 834346"/>
                    <a:gd name="connsiteX9" fmla="*/ 371906 w 920546"/>
                    <a:gd name="connsiteY9" fmla="*/ 631767 h 834346"/>
                    <a:gd name="connsiteX10" fmla="*/ 222277 w 920546"/>
                    <a:gd name="connsiteY10" fmla="*/ 714894 h 834346"/>
                    <a:gd name="connsiteX11" fmla="*/ 122524 w 920546"/>
                    <a:gd name="connsiteY11" fmla="*/ 781396 h 834346"/>
                    <a:gd name="connsiteX12" fmla="*/ 72648 w 920546"/>
                    <a:gd name="connsiteY12" fmla="*/ 798022 h 834346"/>
                    <a:gd name="connsiteX13" fmla="*/ 6146 w 920546"/>
                    <a:gd name="connsiteY13" fmla="*/ 831272 h 83434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920546" h="834346">
                      <a:moveTo>
                        <a:pt x="920546" y="0"/>
                      </a:moveTo>
                      <a:cubicBezTo>
                        <a:pt x="881236" y="39309"/>
                        <a:pt x="849231" y="66610"/>
                        <a:pt x="820793" y="116378"/>
                      </a:cubicBezTo>
                      <a:cubicBezTo>
                        <a:pt x="812098" y="131594"/>
                        <a:pt x="813889" y="151673"/>
                        <a:pt x="804168" y="166254"/>
                      </a:cubicBezTo>
                      <a:cubicBezTo>
                        <a:pt x="791126" y="185817"/>
                        <a:pt x="768726" y="197572"/>
                        <a:pt x="754291" y="216131"/>
                      </a:cubicBezTo>
                      <a:cubicBezTo>
                        <a:pt x="729756" y="247675"/>
                        <a:pt x="709956" y="282632"/>
                        <a:pt x="687789" y="315883"/>
                      </a:cubicBezTo>
                      <a:cubicBezTo>
                        <a:pt x="676705" y="332509"/>
                        <a:pt x="671164" y="354676"/>
                        <a:pt x="654538" y="365760"/>
                      </a:cubicBezTo>
                      <a:cubicBezTo>
                        <a:pt x="605497" y="398455"/>
                        <a:pt x="594789" y="400883"/>
                        <a:pt x="554786" y="448887"/>
                      </a:cubicBezTo>
                      <a:cubicBezTo>
                        <a:pt x="541994" y="464237"/>
                        <a:pt x="535664" y="484634"/>
                        <a:pt x="521535" y="498763"/>
                      </a:cubicBezTo>
                      <a:cubicBezTo>
                        <a:pt x="507406" y="512892"/>
                        <a:pt x="486592" y="518739"/>
                        <a:pt x="471658" y="532014"/>
                      </a:cubicBezTo>
                      <a:cubicBezTo>
                        <a:pt x="436512" y="563255"/>
                        <a:pt x="411032" y="605683"/>
                        <a:pt x="371906" y="631767"/>
                      </a:cubicBezTo>
                      <a:cubicBezTo>
                        <a:pt x="257572" y="707990"/>
                        <a:pt x="310065" y="685632"/>
                        <a:pt x="222277" y="714894"/>
                      </a:cubicBezTo>
                      <a:cubicBezTo>
                        <a:pt x="189026" y="737061"/>
                        <a:pt x="160436" y="768758"/>
                        <a:pt x="122524" y="781396"/>
                      </a:cubicBezTo>
                      <a:cubicBezTo>
                        <a:pt x="105899" y="786938"/>
                        <a:pt x="88323" y="790185"/>
                        <a:pt x="72648" y="798022"/>
                      </a:cubicBezTo>
                      <a:cubicBezTo>
                        <a:pt x="0" y="834346"/>
                        <a:pt x="47789" y="831272"/>
                        <a:pt x="6146" y="831272"/>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10" name="Freeform 109"/>
                <p:cNvSpPr/>
                <p:nvPr/>
              </p:nvSpPr>
              <p:spPr>
                <a:xfrm>
                  <a:off x="929714" y="3715445"/>
                  <a:ext cx="148017" cy="1082325"/>
                </a:xfrm>
                <a:custGeom>
                  <a:avLst/>
                  <a:gdLst>
                    <a:gd name="connsiteX0" fmla="*/ 0 w 149629"/>
                    <a:gd name="connsiteY0" fmla="*/ 0 h 1080654"/>
                    <a:gd name="connsiteX1" fmla="*/ 16626 w 149629"/>
                    <a:gd name="connsiteY1" fmla="*/ 831272 h 1080654"/>
                    <a:gd name="connsiteX2" fmla="*/ 49877 w 149629"/>
                    <a:gd name="connsiteY2" fmla="*/ 931025 h 1080654"/>
                    <a:gd name="connsiteX3" fmla="*/ 99753 w 149629"/>
                    <a:gd name="connsiteY3" fmla="*/ 1030778 h 1080654"/>
                    <a:gd name="connsiteX4" fmla="*/ 149629 w 149629"/>
                    <a:gd name="connsiteY4" fmla="*/ 1080654 h 108065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49629" h="1080654">
                      <a:moveTo>
                        <a:pt x="0" y="0"/>
                      </a:moveTo>
                      <a:cubicBezTo>
                        <a:pt x="5542" y="277091"/>
                        <a:pt x="1800" y="554523"/>
                        <a:pt x="16626" y="831272"/>
                      </a:cubicBezTo>
                      <a:cubicBezTo>
                        <a:pt x="18501" y="866271"/>
                        <a:pt x="38793" y="897774"/>
                        <a:pt x="49877" y="931025"/>
                      </a:cubicBezTo>
                      <a:cubicBezTo>
                        <a:pt x="66540" y="981013"/>
                        <a:pt x="63943" y="987805"/>
                        <a:pt x="99753" y="1030778"/>
                      </a:cubicBezTo>
                      <a:cubicBezTo>
                        <a:pt x="114805" y="1048840"/>
                        <a:pt x="149629" y="1080654"/>
                        <a:pt x="149629" y="1080654"/>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11" name="Freeform 110"/>
                <p:cNvSpPr/>
                <p:nvPr/>
              </p:nvSpPr>
              <p:spPr>
                <a:xfrm>
                  <a:off x="614787" y="3757434"/>
                  <a:ext cx="399959" cy="1413553"/>
                </a:xfrm>
                <a:custGeom>
                  <a:avLst/>
                  <a:gdLst>
                    <a:gd name="connsiteX0" fmla="*/ 400098 w 400098"/>
                    <a:gd name="connsiteY0" fmla="*/ 0 h 1413163"/>
                    <a:gd name="connsiteX1" fmla="*/ 267094 w 400098"/>
                    <a:gd name="connsiteY1" fmla="*/ 199505 h 1413163"/>
                    <a:gd name="connsiteX2" fmla="*/ 233843 w 400098"/>
                    <a:gd name="connsiteY2" fmla="*/ 249382 h 1413163"/>
                    <a:gd name="connsiteX3" fmla="*/ 200592 w 400098"/>
                    <a:gd name="connsiteY3" fmla="*/ 299258 h 1413163"/>
                    <a:gd name="connsiteX4" fmla="*/ 183967 w 400098"/>
                    <a:gd name="connsiteY4" fmla="*/ 349134 h 1413163"/>
                    <a:gd name="connsiteX5" fmla="*/ 150716 w 400098"/>
                    <a:gd name="connsiteY5" fmla="*/ 532014 h 1413163"/>
                    <a:gd name="connsiteX6" fmla="*/ 117465 w 400098"/>
                    <a:gd name="connsiteY6" fmla="*/ 881149 h 1413163"/>
                    <a:gd name="connsiteX7" fmla="*/ 84214 w 400098"/>
                    <a:gd name="connsiteY7" fmla="*/ 997527 h 1413163"/>
                    <a:gd name="connsiteX8" fmla="*/ 34338 w 400098"/>
                    <a:gd name="connsiteY8" fmla="*/ 1280160 h 1413163"/>
                    <a:gd name="connsiteX9" fmla="*/ 1087 w 400098"/>
                    <a:gd name="connsiteY9" fmla="*/ 1396538 h 1413163"/>
                    <a:gd name="connsiteX10" fmla="*/ 1087 w 400098"/>
                    <a:gd name="connsiteY10" fmla="*/ 1413163 h 14131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400098" h="1413163">
                      <a:moveTo>
                        <a:pt x="400098" y="0"/>
                      </a:moveTo>
                      <a:lnTo>
                        <a:pt x="267094" y="199505"/>
                      </a:lnTo>
                      <a:lnTo>
                        <a:pt x="233843" y="249382"/>
                      </a:lnTo>
                      <a:lnTo>
                        <a:pt x="200592" y="299258"/>
                      </a:lnTo>
                      <a:cubicBezTo>
                        <a:pt x="195050" y="315883"/>
                        <a:pt x="188217" y="332133"/>
                        <a:pt x="183967" y="349134"/>
                      </a:cubicBezTo>
                      <a:cubicBezTo>
                        <a:pt x="172346" y="395617"/>
                        <a:pt x="158129" y="487534"/>
                        <a:pt x="150716" y="532014"/>
                      </a:cubicBezTo>
                      <a:cubicBezTo>
                        <a:pt x="140975" y="668377"/>
                        <a:pt x="140215" y="756023"/>
                        <a:pt x="117465" y="881149"/>
                      </a:cubicBezTo>
                      <a:cubicBezTo>
                        <a:pt x="109114" y="927082"/>
                        <a:pt x="98460" y="954789"/>
                        <a:pt x="84214" y="997527"/>
                      </a:cubicBezTo>
                      <a:cubicBezTo>
                        <a:pt x="81929" y="1011239"/>
                        <a:pt x="49258" y="1220479"/>
                        <a:pt x="34338" y="1280160"/>
                      </a:cubicBezTo>
                      <a:cubicBezTo>
                        <a:pt x="2643" y="1406941"/>
                        <a:pt x="32189" y="1241026"/>
                        <a:pt x="1087" y="1396538"/>
                      </a:cubicBezTo>
                      <a:cubicBezTo>
                        <a:pt x="0" y="1401972"/>
                        <a:pt x="1087" y="1407621"/>
                        <a:pt x="1087" y="1413163"/>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12" name="Freeform 111"/>
                <p:cNvSpPr/>
                <p:nvPr/>
              </p:nvSpPr>
              <p:spPr>
                <a:xfrm>
                  <a:off x="832088" y="3715445"/>
                  <a:ext cx="166911" cy="1712128"/>
                </a:xfrm>
                <a:custGeom>
                  <a:avLst/>
                  <a:gdLst>
                    <a:gd name="connsiteX0" fmla="*/ 166254 w 166254"/>
                    <a:gd name="connsiteY0" fmla="*/ 0 h 1695796"/>
                    <a:gd name="connsiteX1" fmla="*/ 116378 w 166254"/>
                    <a:gd name="connsiteY1" fmla="*/ 133004 h 1695796"/>
                    <a:gd name="connsiteX2" fmla="*/ 99752 w 166254"/>
                    <a:gd name="connsiteY2" fmla="*/ 282633 h 1695796"/>
                    <a:gd name="connsiteX3" fmla="*/ 83127 w 166254"/>
                    <a:gd name="connsiteY3" fmla="*/ 332509 h 1695796"/>
                    <a:gd name="connsiteX4" fmla="*/ 66502 w 166254"/>
                    <a:gd name="connsiteY4" fmla="*/ 415636 h 1695796"/>
                    <a:gd name="connsiteX5" fmla="*/ 49876 w 166254"/>
                    <a:gd name="connsiteY5" fmla="*/ 665018 h 1695796"/>
                    <a:gd name="connsiteX6" fmla="*/ 33251 w 166254"/>
                    <a:gd name="connsiteY6" fmla="*/ 714894 h 1695796"/>
                    <a:gd name="connsiteX7" fmla="*/ 0 w 166254"/>
                    <a:gd name="connsiteY7" fmla="*/ 980902 h 1695796"/>
                    <a:gd name="connsiteX8" fmla="*/ 16625 w 166254"/>
                    <a:gd name="connsiteY8" fmla="*/ 1579418 h 1695796"/>
                    <a:gd name="connsiteX9" fmla="*/ 33251 w 166254"/>
                    <a:gd name="connsiteY9" fmla="*/ 1645920 h 1695796"/>
                    <a:gd name="connsiteX10" fmla="*/ 49876 w 166254"/>
                    <a:gd name="connsiteY10" fmla="*/ 1695796 h 16957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166254" h="1695796">
                      <a:moveTo>
                        <a:pt x="166254" y="0"/>
                      </a:moveTo>
                      <a:cubicBezTo>
                        <a:pt x="164534" y="4300"/>
                        <a:pt x="120102" y="110659"/>
                        <a:pt x="116378" y="133004"/>
                      </a:cubicBezTo>
                      <a:cubicBezTo>
                        <a:pt x="108128" y="182504"/>
                        <a:pt x="108002" y="233133"/>
                        <a:pt x="99752" y="282633"/>
                      </a:cubicBezTo>
                      <a:cubicBezTo>
                        <a:pt x="96871" y="299919"/>
                        <a:pt x="87377" y="315508"/>
                        <a:pt x="83127" y="332509"/>
                      </a:cubicBezTo>
                      <a:cubicBezTo>
                        <a:pt x="76274" y="359923"/>
                        <a:pt x="72044" y="387927"/>
                        <a:pt x="66502" y="415636"/>
                      </a:cubicBezTo>
                      <a:cubicBezTo>
                        <a:pt x="60960" y="498763"/>
                        <a:pt x="59076" y="582216"/>
                        <a:pt x="49876" y="665018"/>
                      </a:cubicBezTo>
                      <a:cubicBezTo>
                        <a:pt x="47941" y="682435"/>
                        <a:pt x="37053" y="697787"/>
                        <a:pt x="33251" y="714894"/>
                      </a:cubicBezTo>
                      <a:cubicBezTo>
                        <a:pt x="14499" y="799278"/>
                        <a:pt x="8364" y="897263"/>
                        <a:pt x="0" y="980902"/>
                      </a:cubicBezTo>
                      <a:cubicBezTo>
                        <a:pt x="5542" y="1180407"/>
                        <a:pt x="6658" y="1380085"/>
                        <a:pt x="16625" y="1579418"/>
                      </a:cubicBezTo>
                      <a:cubicBezTo>
                        <a:pt x="17766" y="1602239"/>
                        <a:pt x="26974" y="1623950"/>
                        <a:pt x="33251" y="1645920"/>
                      </a:cubicBezTo>
                      <a:cubicBezTo>
                        <a:pt x="38065" y="1662770"/>
                        <a:pt x="49876" y="1695796"/>
                        <a:pt x="49876" y="1695796"/>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13" name="Freeform 38"/>
                <p:cNvSpPr/>
                <p:nvPr/>
              </p:nvSpPr>
              <p:spPr>
                <a:xfrm>
                  <a:off x="998998" y="3808749"/>
                  <a:ext cx="711736" cy="1427550"/>
                </a:xfrm>
                <a:custGeom>
                  <a:avLst/>
                  <a:gdLst>
                    <a:gd name="connsiteX0" fmla="*/ 0 w 714895"/>
                    <a:gd name="connsiteY0" fmla="*/ 0 h 1429789"/>
                    <a:gd name="connsiteX1" fmla="*/ 33251 w 714895"/>
                    <a:gd name="connsiteY1" fmla="*/ 99753 h 1429789"/>
                    <a:gd name="connsiteX2" fmla="*/ 66502 w 714895"/>
                    <a:gd name="connsiteY2" fmla="*/ 166255 h 1429789"/>
                    <a:gd name="connsiteX3" fmla="*/ 133004 w 714895"/>
                    <a:gd name="connsiteY3" fmla="*/ 332509 h 1429789"/>
                    <a:gd name="connsiteX4" fmla="*/ 149629 w 714895"/>
                    <a:gd name="connsiteY4" fmla="*/ 415636 h 1429789"/>
                    <a:gd name="connsiteX5" fmla="*/ 199506 w 714895"/>
                    <a:gd name="connsiteY5" fmla="*/ 565266 h 1429789"/>
                    <a:gd name="connsiteX6" fmla="*/ 216131 w 714895"/>
                    <a:gd name="connsiteY6" fmla="*/ 615142 h 1429789"/>
                    <a:gd name="connsiteX7" fmla="*/ 282633 w 714895"/>
                    <a:gd name="connsiteY7" fmla="*/ 764771 h 1429789"/>
                    <a:gd name="connsiteX8" fmla="*/ 315884 w 714895"/>
                    <a:gd name="connsiteY8" fmla="*/ 814647 h 1429789"/>
                    <a:gd name="connsiteX9" fmla="*/ 349135 w 714895"/>
                    <a:gd name="connsiteY9" fmla="*/ 947651 h 1429789"/>
                    <a:gd name="connsiteX10" fmla="*/ 382386 w 714895"/>
                    <a:gd name="connsiteY10" fmla="*/ 1047404 h 1429789"/>
                    <a:gd name="connsiteX11" fmla="*/ 432262 w 714895"/>
                    <a:gd name="connsiteY11" fmla="*/ 1113906 h 1429789"/>
                    <a:gd name="connsiteX12" fmla="*/ 465513 w 714895"/>
                    <a:gd name="connsiteY12" fmla="*/ 1163782 h 1429789"/>
                    <a:gd name="connsiteX13" fmla="*/ 515389 w 714895"/>
                    <a:gd name="connsiteY13" fmla="*/ 1213658 h 1429789"/>
                    <a:gd name="connsiteX14" fmla="*/ 598517 w 714895"/>
                    <a:gd name="connsiteY14" fmla="*/ 1296786 h 1429789"/>
                    <a:gd name="connsiteX15" fmla="*/ 681644 w 714895"/>
                    <a:gd name="connsiteY15" fmla="*/ 1379913 h 1429789"/>
                    <a:gd name="connsiteX16" fmla="*/ 714895 w 714895"/>
                    <a:gd name="connsiteY16" fmla="*/ 1429789 h 1429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714895" h="1429789">
                      <a:moveTo>
                        <a:pt x="0" y="0"/>
                      </a:moveTo>
                      <a:cubicBezTo>
                        <a:pt x="11084" y="33251"/>
                        <a:pt x="17576" y="68404"/>
                        <a:pt x="33251" y="99753"/>
                      </a:cubicBezTo>
                      <a:cubicBezTo>
                        <a:pt x="44335" y="121920"/>
                        <a:pt x="57297" y="143244"/>
                        <a:pt x="66502" y="166255"/>
                      </a:cubicBezTo>
                      <a:cubicBezTo>
                        <a:pt x="148679" y="371696"/>
                        <a:pt x="55024" y="176550"/>
                        <a:pt x="133004" y="332509"/>
                      </a:cubicBezTo>
                      <a:cubicBezTo>
                        <a:pt x="138546" y="360218"/>
                        <a:pt x="142194" y="388374"/>
                        <a:pt x="149629" y="415636"/>
                      </a:cubicBezTo>
                      <a:cubicBezTo>
                        <a:pt x="149634" y="415654"/>
                        <a:pt x="191190" y="540319"/>
                        <a:pt x="199506" y="565266"/>
                      </a:cubicBezTo>
                      <a:cubicBezTo>
                        <a:pt x="205048" y="581891"/>
                        <a:pt x="209622" y="598871"/>
                        <a:pt x="216131" y="615142"/>
                      </a:cubicBezTo>
                      <a:cubicBezTo>
                        <a:pt x="239882" y="674520"/>
                        <a:pt x="251569" y="710409"/>
                        <a:pt x="282633" y="764771"/>
                      </a:cubicBezTo>
                      <a:cubicBezTo>
                        <a:pt x="292546" y="782120"/>
                        <a:pt x="304800" y="798022"/>
                        <a:pt x="315884" y="814647"/>
                      </a:cubicBezTo>
                      <a:cubicBezTo>
                        <a:pt x="366334" y="966002"/>
                        <a:pt x="288940" y="726938"/>
                        <a:pt x="349135" y="947651"/>
                      </a:cubicBezTo>
                      <a:cubicBezTo>
                        <a:pt x="358357" y="981466"/>
                        <a:pt x="361356" y="1019364"/>
                        <a:pt x="382386" y="1047404"/>
                      </a:cubicBezTo>
                      <a:cubicBezTo>
                        <a:pt x="399011" y="1069571"/>
                        <a:pt x="416156" y="1091358"/>
                        <a:pt x="432262" y="1113906"/>
                      </a:cubicBezTo>
                      <a:cubicBezTo>
                        <a:pt x="443876" y="1130165"/>
                        <a:pt x="452721" y="1148432"/>
                        <a:pt x="465513" y="1163782"/>
                      </a:cubicBezTo>
                      <a:cubicBezTo>
                        <a:pt x="480565" y="1181844"/>
                        <a:pt x="500337" y="1195596"/>
                        <a:pt x="515389" y="1213658"/>
                      </a:cubicBezTo>
                      <a:cubicBezTo>
                        <a:pt x="584662" y="1296786"/>
                        <a:pt x="507076" y="1235826"/>
                        <a:pt x="598517" y="1296786"/>
                      </a:cubicBezTo>
                      <a:cubicBezTo>
                        <a:pt x="687186" y="1429789"/>
                        <a:pt x="570808" y="1269077"/>
                        <a:pt x="681644" y="1379913"/>
                      </a:cubicBezTo>
                      <a:cubicBezTo>
                        <a:pt x="695773" y="1394042"/>
                        <a:pt x="714895" y="1429789"/>
                        <a:pt x="714895" y="1429789"/>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grpSp>
        </p:grpSp>
        <p:grpSp>
          <p:nvGrpSpPr>
            <p:cNvPr id="11349" name="Group 39"/>
            <p:cNvGrpSpPr>
              <a:grpSpLocks/>
            </p:cNvGrpSpPr>
            <p:nvPr/>
          </p:nvGrpSpPr>
          <p:grpSpPr bwMode="auto">
            <a:xfrm>
              <a:off x="3662794" y="9119021"/>
              <a:ext cx="1048512" cy="2414096"/>
              <a:chOff x="-70836" y="107849"/>
              <a:chExt cx="2080253" cy="5319934"/>
            </a:xfrm>
          </p:grpSpPr>
          <p:sp>
            <p:nvSpPr>
              <p:cNvPr id="100" name="Freeform 40"/>
              <p:cNvSpPr/>
              <p:nvPr/>
            </p:nvSpPr>
            <p:spPr>
              <a:xfrm rot="20683283">
                <a:off x="-69308" y="105789"/>
                <a:ext cx="2078521" cy="3550216"/>
              </a:xfrm>
              <a:custGeom>
                <a:avLst/>
                <a:gdLst>
                  <a:gd name="connsiteX0" fmla="*/ 483980 w 2080024"/>
                  <a:gd name="connsiteY0" fmla="*/ 3391592 h 3547685"/>
                  <a:gd name="connsiteX1" fmla="*/ 450729 w 2080024"/>
                  <a:gd name="connsiteY1" fmla="*/ 3341716 h 3547685"/>
                  <a:gd name="connsiteX2" fmla="*/ 400853 w 2080024"/>
                  <a:gd name="connsiteY2" fmla="*/ 3275214 h 3547685"/>
                  <a:gd name="connsiteX3" fmla="*/ 350977 w 2080024"/>
                  <a:gd name="connsiteY3" fmla="*/ 3125585 h 3547685"/>
                  <a:gd name="connsiteX4" fmla="*/ 334351 w 2080024"/>
                  <a:gd name="connsiteY4" fmla="*/ 3075709 h 3547685"/>
                  <a:gd name="connsiteX5" fmla="*/ 301100 w 2080024"/>
                  <a:gd name="connsiteY5" fmla="*/ 3025832 h 3547685"/>
                  <a:gd name="connsiteX6" fmla="*/ 284475 w 2080024"/>
                  <a:gd name="connsiteY6" fmla="*/ 2975956 h 3547685"/>
                  <a:gd name="connsiteX7" fmla="*/ 251224 w 2080024"/>
                  <a:gd name="connsiteY7" fmla="*/ 2909454 h 3547685"/>
                  <a:gd name="connsiteX8" fmla="*/ 234599 w 2080024"/>
                  <a:gd name="connsiteY8" fmla="*/ 2842952 h 3547685"/>
                  <a:gd name="connsiteX9" fmla="*/ 201348 w 2080024"/>
                  <a:gd name="connsiteY9" fmla="*/ 2793076 h 3547685"/>
                  <a:gd name="connsiteX10" fmla="*/ 151471 w 2080024"/>
                  <a:gd name="connsiteY10" fmla="*/ 2693323 h 3547685"/>
                  <a:gd name="connsiteX11" fmla="*/ 84969 w 2080024"/>
                  <a:gd name="connsiteY11" fmla="*/ 2560320 h 3547685"/>
                  <a:gd name="connsiteX12" fmla="*/ 68344 w 2080024"/>
                  <a:gd name="connsiteY12" fmla="*/ 2510443 h 3547685"/>
                  <a:gd name="connsiteX13" fmla="*/ 35093 w 2080024"/>
                  <a:gd name="connsiteY13" fmla="*/ 2394065 h 3547685"/>
                  <a:gd name="connsiteX14" fmla="*/ 18468 w 2080024"/>
                  <a:gd name="connsiteY14" fmla="*/ 2277687 h 3547685"/>
                  <a:gd name="connsiteX15" fmla="*/ 51719 w 2080024"/>
                  <a:gd name="connsiteY15" fmla="*/ 1745672 h 3547685"/>
                  <a:gd name="connsiteX16" fmla="*/ 101595 w 2080024"/>
                  <a:gd name="connsiteY16" fmla="*/ 1629294 h 3547685"/>
                  <a:gd name="connsiteX17" fmla="*/ 118220 w 2080024"/>
                  <a:gd name="connsiteY17" fmla="*/ 1579418 h 3547685"/>
                  <a:gd name="connsiteX18" fmla="*/ 184722 w 2080024"/>
                  <a:gd name="connsiteY18" fmla="*/ 1479665 h 3547685"/>
                  <a:gd name="connsiteX19" fmla="*/ 284475 w 2080024"/>
                  <a:gd name="connsiteY19" fmla="*/ 1330036 h 3547685"/>
                  <a:gd name="connsiteX20" fmla="*/ 317726 w 2080024"/>
                  <a:gd name="connsiteY20" fmla="*/ 1280160 h 3547685"/>
                  <a:gd name="connsiteX21" fmla="*/ 350977 w 2080024"/>
                  <a:gd name="connsiteY21" fmla="*/ 1230283 h 3547685"/>
                  <a:gd name="connsiteX22" fmla="*/ 417479 w 2080024"/>
                  <a:gd name="connsiteY22" fmla="*/ 1163782 h 3547685"/>
                  <a:gd name="connsiteX23" fmla="*/ 434104 w 2080024"/>
                  <a:gd name="connsiteY23" fmla="*/ 1113905 h 3547685"/>
                  <a:gd name="connsiteX24" fmla="*/ 517231 w 2080024"/>
                  <a:gd name="connsiteY24" fmla="*/ 1030778 h 3547685"/>
                  <a:gd name="connsiteX25" fmla="*/ 550482 w 2080024"/>
                  <a:gd name="connsiteY25" fmla="*/ 980902 h 3547685"/>
                  <a:gd name="connsiteX26" fmla="*/ 666860 w 2080024"/>
                  <a:gd name="connsiteY26" fmla="*/ 881149 h 3547685"/>
                  <a:gd name="connsiteX27" fmla="*/ 700111 w 2080024"/>
                  <a:gd name="connsiteY27" fmla="*/ 831272 h 3547685"/>
                  <a:gd name="connsiteX28" fmla="*/ 799864 w 2080024"/>
                  <a:gd name="connsiteY28" fmla="*/ 731520 h 3547685"/>
                  <a:gd name="connsiteX29" fmla="*/ 849740 w 2080024"/>
                  <a:gd name="connsiteY29" fmla="*/ 665018 h 3547685"/>
                  <a:gd name="connsiteX30" fmla="*/ 949493 w 2080024"/>
                  <a:gd name="connsiteY30" fmla="*/ 581891 h 3547685"/>
                  <a:gd name="connsiteX31" fmla="*/ 982744 w 2080024"/>
                  <a:gd name="connsiteY31" fmla="*/ 532014 h 3547685"/>
                  <a:gd name="connsiteX32" fmla="*/ 1049246 w 2080024"/>
                  <a:gd name="connsiteY32" fmla="*/ 482138 h 3547685"/>
                  <a:gd name="connsiteX33" fmla="*/ 1099122 w 2080024"/>
                  <a:gd name="connsiteY33" fmla="*/ 415636 h 3547685"/>
                  <a:gd name="connsiteX34" fmla="*/ 1265377 w 2080024"/>
                  <a:gd name="connsiteY34" fmla="*/ 266007 h 3547685"/>
                  <a:gd name="connsiteX35" fmla="*/ 1365129 w 2080024"/>
                  <a:gd name="connsiteY35" fmla="*/ 182880 h 3547685"/>
                  <a:gd name="connsiteX36" fmla="*/ 1481508 w 2080024"/>
                  <a:gd name="connsiteY36" fmla="*/ 49876 h 3547685"/>
                  <a:gd name="connsiteX37" fmla="*/ 1498133 w 2080024"/>
                  <a:gd name="connsiteY37" fmla="*/ 0 h 3547685"/>
                  <a:gd name="connsiteX38" fmla="*/ 1548009 w 2080024"/>
                  <a:gd name="connsiteY38" fmla="*/ 116378 h 3547685"/>
                  <a:gd name="connsiteX39" fmla="*/ 1597886 w 2080024"/>
                  <a:gd name="connsiteY39" fmla="*/ 249382 h 3547685"/>
                  <a:gd name="connsiteX40" fmla="*/ 1647762 w 2080024"/>
                  <a:gd name="connsiteY40" fmla="*/ 365760 h 3547685"/>
                  <a:gd name="connsiteX41" fmla="*/ 1664388 w 2080024"/>
                  <a:gd name="connsiteY41" fmla="*/ 448887 h 3547685"/>
                  <a:gd name="connsiteX42" fmla="*/ 1697639 w 2080024"/>
                  <a:gd name="connsiteY42" fmla="*/ 498763 h 3547685"/>
                  <a:gd name="connsiteX43" fmla="*/ 1714264 w 2080024"/>
                  <a:gd name="connsiteY43" fmla="*/ 548640 h 3547685"/>
                  <a:gd name="connsiteX44" fmla="*/ 1730889 w 2080024"/>
                  <a:gd name="connsiteY44" fmla="*/ 615142 h 3547685"/>
                  <a:gd name="connsiteX45" fmla="*/ 1780766 w 2080024"/>
                  <a:gd name="connsiteY45" fmla="*/ 764771 h 3547685"/>
                  <a:gd name="connsiteX46" fmla="*/ 1814017 w 2080024"/>
                  <a:gd name="connsiteY46" fmla="*/ 864523 h 3547685"/>
                  <a:gd name="connsiteX47" fmla="*/ 1847268 w 2080024"/>
                  <a:gd name="connsiteY47" fmla="*/ 914400 h 3547685"/>
                  <a:gd name="connsiteX48" fmla="*/ 1913769 w 2080024"/>
                  <a:gd name="connsiteY48" fmla="*/ 1147156 h 3547685"/>
                  <a:gd name="connsiteX49" fmla="*/ 1930395 w 2080024"/>
                  <a:gd name="connsiteY49" fmla="*/ 1197032 h 3547685"/>
                  <a:gd name="connsiteX50" fmla="*/ 1963646 w 2080024"/>
                  <a:gd name="connsiteY50" fmla="*/ 1246909 h 3547685"/>
                  <a:gd name="connsiteX51" fmla="*/ 1980271 w 2080024"/>
                  <a:gd name="connsiteY51" fmla="*/ 1313411 h 3547685"/>
                  <a:gd name="connsiteX52" fmla="*/ 1996897 w 2080024"/>
                  <a:gd name="connsiteY52" fmla="*/ 1363287 h 3547685"/>
                  <a:gd name="connsiteX53" fmla="*/ 2030148 w 2080024"/>
                  <a:gd name="connsiteY53" fmla="*/ 1546167 h 3547685"/>
                  <a:gd name="connsiteX54" fmla="*/ 2046773 w 2080024"/>
                  <a:gd name="connsiteY54" fmla="*/ 1596043 h 3547685"/>
                  <a:gd name="connsiteX55" fmla="*/ 2063399 w 2080024"/>
                  <a:gd name="connsiteY55" fmla="*/ 1729047 h 3547685"/>
                  <a:gd name="connsiteX56" fmla="*/ 2080024 w 2080024"/>
                  <a:gd name="connsiteY56" fmla="*/ 1828800 h 3547685"/>
                  <a:gd name="connsiteX57" fmla="*/ 2063399 w 2080024"/>
                  <a:gd name="connsiteY57" fmla="*/ 2410691 h 3547685"/>
                  <a:gd name="connsiteX58" fmla="*/ 2013522 w 2080024"/>
                  <a:gd name="connsiteY58" fmla="*/ 2576945 h 3547685"/>
                  <a:gd name="connsiteX59" fmla="*/ 1980271 w 2080024"/>
                  <a:gd name="connsiteY59" fmla="*/ 2676698 h 3547685"/>
                  <a:gd name="connsiteX60" fmla="*/ 1930395 w 2080024"/>
                  <a:gd name="connsiteY60" fmla="*/ 2726574 h 3547685"/>
                  <a:gd name="connsiteX61" fmla="*/ 1847268 w 2080024"/>
                  <a:gd name="connsiteY61" fmla="*/ 2876203 h 3547685"/>
                  <a:gd name="connsiteX62" fmla="*/ 1780766 w 2080024"/>
                  <a:gd name="connsiteY62" fmla="*/ 2975956 h 3547685"/>
                  <a:gd name="connsiteX63" fmla="*/ 1747515 w 2080024"/>
                  <a:gd name="connsiteY63" fmla="*/ 3025832 h 3547685"/>
                  <a:gd name="connsiteX64" fmla="*/ 1697639 w 2080024"/>
                  <a:gd name="connsiteY64" fmla="*/ 3059083 h 3547685"/>
                  <a:gd name="connsiteX65" fmla="*/ 1614511 w 2080024"/>
                  <a:gd name="connsiteY65" fmla="*/ 3142211 h 3547685"/>
                  <a:gd name="connsiteX66" fmla="*/ 1531384 w 2080024"/>
                  <a:gd name="connsiteY66" fmla="*/ 3208712 h 3547685"/>
                  <a:gd name="connsiteX67" fmla="*/ 1431631 w 2080024"/>
                  <a:gd name="connsiteY67" fmla="*/ 3258589 h 3547685"/>
                  <a:gd name="connsiteX68" fmla="*/ 1381755 w 2080024"/>
                  <a:gd name="connsiteY68" fmla="*/ 3291840 h 3547685"/>
                  <a:gd name="connsiteX69" fmla="*/ 1282002 w 2080024"/>
                  <a:gd name="connsiteY69" fmla="*/ 3325091 h 3547685"/>
                  <a:gd name="connsiteX70" fmla="*/ 1232126 w 2080024"/>
                  <a:gd name="connsiteY70" fmla="*/ 3341716 h 3547685"/>
                  <a:gd name="connsiteX71" fmla="*/ 1182249 w 2080024"/>
                  <a:gd name="connsiteY71" fmla="*/ 3374967 h 3547685"/>
                  <a:gd name="connsiteX72" fmla="*/ 1032620 w 2080024"/>
                  <a:gd name="connsiteY72" fmla="*/ 3424843 h 3547685"/>
                  <a:gd name="connsiteX73" fmla="*/ 982744 w 2080024"/>
                  <a:gd name="connsiteY73" fmla="*/ 3441469 h 3547685"/>
                  <a:gd name="connsiteX74" fmla="*/ 932868 w 2080024"/>
                  <a:gd name="connsiteY74" fmla="*/ 3474720 h 3547685"/>
                  <a:gd name="connsiteX75" fmla="*/ 849740 w 2080024"/>
                  <a:gd name="connsiteY75" fmla="*/ 3491345 h 3547685"/>
                  <a:gd name="connsiteX76" fmla="*/ 783239 w 2080024"/>
                  <a:gd name="connsiteY76" fmla="*/ 3507971 h 3547685"/>
                  <a:gd name="connsiteX77" fmla="*/ 600359 w 2080024"/>
                  <a:gd name="connsiteY77" fmla="*/ 3541222 h 3547685"/>
                  <a:gd name="connsiteX78" fmla="*/ 550482 w 2080024"/>
                  <a:gd name="connsiteY78" fmla="*/ 3524596 h 3547685"/>
                  <a:gd name="connsiteX79" fmla="*/ 517231 w 2080024"/>
                  <a:gd name="connsiteY79" fmla="*/ 3474720 h 3547685"/>
                  <a:gd name="connsiteX80" fmla="*/ 467355 w 2080024"/>
                  <a:gd name="connsiteY80" fmla="*/ 3441469 h 3547685"/>
                  <a:gd name="connsiteX81" fmla="*/ 450729 w 2080024"/>
                  <a:gd name="connsiteY81" fmla="*/ 3391592 h 3547685"/>
                  <a:gd name="connsiteX82" fmla="*/ 400853 w 2080024"/>
                  <a:gd name="connsiteY82" fmla="*/ 3325091 h 3547685"/>
                  <a:gd name="connsiteX83" fmla="*/ 367602 w 2080024"/>
                  <a:gd name="connsiteY83" fmla="*/ 3275214 h 3547685"/>
                  <a:gd name="connsiteX84" fmla="*/ 301100 w 2080024"/>
                  <a:gd name="connsiteY84" fmla="*/ 3208712 h 354768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Lst>
                <a:rect l="l" t="t" r="r" b="b"/>
                <a:pathLst>
                  <a:path w="2080024" h="3547685">
                    <a:moveTo>
                      <a:pt x="483980" y="3391592"/>
                    </a:moveTo>
                    <a:cubicBezTo>
                      <a:pt x="472896" y="3374967"/>
                      <a:pt x="462343" y="3357975"/>
                      <a:pt x="450729" y="3341716"/>
                    </a:cubicBezTo>
                    <a:cubicBezTo>
                      <a:pt x="434623" y="3319168"/>
                      <a:pt x="413245" y="3299998"/>
                      <a:pt x="400853" y="3275214"/>
                    </a:cubicBezTo>
                    <a:cubicBezTo>
                      <a:pt x="400845" y="3275198"/>
                      <a:pt x="359292" y="3150531"/>
                      <a:pt x="350977" y="3125585"/>
                    </a:cubicBezTo>
                    <a:cubicBezTo>
                      <a:pt x="345435" y="3108960"/>
                      <a:pt x="344072" y="3090290"/>
                      <a:pt x="334351" y="3075709"/>
                    </a:cubicBezTo>
                    <a:lnTo>
                      <a:pt x="301100" y="3025832"/>
                    </a:lnTo>
                    <a:cubicBezTo>
                      <a:pt x="295558" y="3009207"/>
                      <a:pt x="291378" y="2992064"/>
                      <a:pt x="284475" y="2975956"/>
                    </a:cubicBezTo>
                    <a:cubicBezTo>
                      <a:pt x="274712" y="2953176"/>
                      <a:pt x="259926" y="2932660"/>
                      <a:pt x="251224" y="2909454"/>
                    </a:cubicBezTo>
                    <a:cubicBezTo>
                      <a:pt x="243201" y="2888059"/>
                      <a:pt x="243600" y="2863954"/>
                      <a:pt x="234599" y="2842952"/>
                    </a:cubicBezTo>
                    <a:cubicBezTo>
                      <a:pt x="226728" y="2824586"/>
                      <a:pt x="210284" y="2810948"/>
                      <a:pt x="201348" y="2793076"/>
                    </a:cubicBezTo>
                    <a:cubicBezTo>
                      <a:pt x="132512" y="2655406"/>
                      <a:pt x="246768" y="2836269"/>
                      <a:pt x="151471" y="2693323"/>
                    </a:cubicBezTo>
                    <a:cubicBezTo>
                      <a:pt x="118415" y="2561099"/>
                      <a:pt x="160331" y="2692204"/>
                      <a:pt x="84969" y="2560320"/>
                    </a:cubicBezTo>
                    <a:cubicBezTo>
                      <a:pt x="76274" y="2545104"/>
                      <a:pt x="73158" y="2527294"/>
                      <a:pt x="68344" y="2510443"/>
                    </a:cubicBezTo>
                    <a:cubicBezTo>
                      <a:pt x="26601" y="2364338"/>
                      <a:pt x="74950" y="2513634"/>
                      <a:pt x="35093" y="2394065"/>
                    </a:cubicBezTo>
                    <a:cubicBezTo>
                      <a:pt x="29551" y="2355272"/>
                      <a:pt x="18468" y="2316873"/>
                      <a:pt x="18468" y="2277687"/>
                    </a:cubicBezTo>
                    <a:cubicBezTo>
                      <a:pt x="18468" y="2034785"/>
                      <a:pt x="0" y="1926688"/>
                      <a:pt x="51719" y="1745672"/>
                    </a:cubicBezTo>
                    <a:cubicBezTo>
                      <a:pt x="74000" y="1667688"/>
                      <a:pt x="63591" y="1717970"/>
                      <a:pt x="101595" y="1629294"/>
                    </a:cubicBezTo>
                    <a:cubicBezTo>
                      <a:pt x="108498" y="1613186"/>
                      <a:pt x="109709" y="1594737"/>
                      <a:pt x="118220" y="1579418"/>
                    </a:cubicBezTo>
                    <a:cubicBezTo>
                      <a:pt x="137628" y="1544484"/>
                      <a:pt x="162555" y="1512916"/>
                      <a:pt x="184722" y="1479665"/>
                    </a:cubicBezTo>
                    <a:lnTo>
                      <a:pt x="284475" y="1330036"/>
                    </a:lnTo>
                    <a:lnTo>
                      <a:pt x="317726" y="1280160"/>
                    </a:lnTo>
                    <a:lnTo>
                      <a:pt x="350977" y="1230283"/>
                    </a:lnTo>
                    <a:cubicBezTo>
                      <a:pt x="395311" y="1097280"/>
                      <a:pt x="328809" y="1252452"/>
                      <a:pt x="417479" y="1163782"/>
                    </a:cubicBezTo>
                    <a:cubicBezTo>
                      <a:pt x="429871" y="1151390"/>
                      <a:pt x="426267" y="1129580"/>
                      <a:pt x="434104" y="1113905"/>
                    </a:cubicBezTo>
                    <a:cubicBezTo>
                      <a:pt x="461812" y="1058488"/>
                      <a:pt x="467356" y="1064028"/>
                      <a:pt x="517231" y="1030778"/>
                    </a:cubicBezTo>
                    <a:cubicBezTo>
                      <a:pt x="528315" y="1014153"/>
                      <a:pt x="536353" y="995031"/>
                      <a:pt x="550482" y="980902"/>
                    </a:cubicBezTo>
                    <a:cubicBezTo>
                      <a:pt x="660554" y="870830"/>
                      <a:pt x="576381" y="989725"/>
                      <a:pt x="666860" y="881149"/>
                    </a:cubicBezTo>
                    <a:cubicBezTo>
                      <a:pt x="679652" y="865799"/>
                      <a:pt x="686836" y="846206"/>
                      <a:pt x="700111" y="831272"/>
                    </a:cubicBezTo>
                    <a:cubicBezTo>
                      <a:pt x="731352" y="796126"/>
                      <a:pt x="771650" y="769139"/>
                      <a:pt x="799864" y="731520"/>
                    </a:cubicBezTo>
                    <a:cubicBezTo>
                      <a:pt x="816489" y="709353"/>
                      <a:pt x="830147" y="684611"/>
                      <a:pt x="849740" y="665018"/>
                    </a:cubicBezTo>
                    <a:cubicBezTo>
                      <a:pt x="980517" y="534241"/>
                      <a:pt x="813314" y="745306"/>
                      <a:pt x="949493" y="581891"/>
                    </a:cubicBezTo>
                    <a:cubicBezTo>
                      <a:pt x="962285" y="566541"/>
                      <a:pt x="968615" y="546143"/>
                      <a:pt x="982744" y="532014"/>
                    </a:cubicBezTo>
                    <a:cubicBezTo>
                      <a:pt x="1002337" y="512421"/>
                      <a:pt x="1029653" y="501731"/>
                      <a:pt x="1049246" y="482138"/>
                    </a:cubicBezTo>
                    <a:cubicBezTo>
                      <a:pt x="1068839" y="462545"/>
                      <a:pt x="1080586" y="436232"/>
                      <a:pt x="1099122" y="415636"/>
                    </a:cubicBezTo>
                    <a:cubicBezTo>
                      <a:pt x="1240799" y="258216"/>
                      <a:pt x="1148097" y="366532"/>
                      <a:pt x="1265377" y="266007"/>
                    </a:cubicBezTo>
                    <a:cubicBezTo>
                      <a:pt x="1377390" y="169996"/>
                      <a:pt x="1254891" y="256373"/>
                      <a:pt x="1365129" y="182880"/>
                    </a:cubicBezTo>
                    <a:cubicBezTo>
                      <a:pt x="1442715" y="66501"/>
                      <a:pt x="1398380" y="105294"/>
                      <a:pt x="1481508" y="49876"/>
                    </a:cubicBezTo>
                    <a:cubicBezTo>
                      <a:pt x="1487050" y="33251"/>
                      <a:pt x="1480608" y="0"/>
                      <a:pt x="1498133" y="0"/>
                    </a:cubicBezTo>
                    <a:cubicBezTo>
                      <a:pt x="1527059" y="0"/>
                      <a:pt x="1545978" y="109268"/>
                      <a:pt x="1548009" y="116378"/>
                    </a:cubicBezTo>
                    <a:cubicBezTo>
                      <a:pt x="1563100" y="169198"/>
                      <a:pt x="1576812" y="193184"/>
                      <a:pt x="1597886" y="249382"/>
                    </a:cubicBezTo>
                    <a:cubicBezTo>
                      <a:pt x="1634580" y="347234"/>
                      <a:pt x="1589375" y="248986"/>
                      <a:pt x="1647762" y="365760"/>
                    </a:cubicBezTo>
                    <a:cubicBezTo>
                      <a:pt x="1653304" y="393469"/>
                      <a:pt x="1654466" y="422428"/>
                      <a:pt x="1664388" y="448887"/>
                    </a:cubicBezTo>
                    <a:cubicBezTo>
                      <a:pt x="1671404" y="467596"/>
                      <a:pt x="1688703" y="480891"/>
                      <a:pt x="1697639" y="498763"/>
                    </a:cubicBezTo>
                    <a:cubicBezTo>
                      <a:pt x="1705476" y="514438"/>
                      <a:pt x="1709450" y="531789"/>
                      <a:pt x="1714264" y="548640"/>
                    </a:cubicBezTo>
                    <a:cubicBezTo>
                      <a:pt x="1720541" y="570610"/>
                      <a:pt x="1724323" y="593256"/>
                      <a:pt x="1730889" y="615142"/>
                    </a:cubicBezTo>
                    <a:cubicBezTo>
                      <a:pt x="1730895" y="615164"/>
                      <a:pt x="1772450" y="739823"/>
                      <a:pt x="1780766" y="764771"/>
                    </a:cubicBezTo>
                    <a:cubicBezTo>
                      <a:pt x="1780768" y="764776"/>
                      <a:pt x="1814014" y="864519"/>
                      <a:pt x="1814017" y="864523"/>
                    </a:cubicBezTo>
                    <a:lnTo>
                      <a:pt x="1847268" y="914400"/>
                    </a:lnTo>
                    <a:cubicBezTo>
                      <a:pt x="1889015" y="1081389"/>
                      <a:pt x="1866072" y="1004063"/>
                      <a:pt x="1913769" y="1147156"/>
                    </a:cubicBezTo>
                    <a:cubicBezTo>
                      <a:pt x="1919311" y="1163781"/>
                      <a:pt x="1920674" y="1182451"/>
                      <a:pt x="1930395" y="1197032"/>
                    </a:cubicBezTo>
                    <a:lnTo>
                      <a:pt x="1963646" y="1246909"/>
                    </a:lnTo>
                    <a:cubicBezTo>
                      <a:pt x="1969188" y="1269076"/>
                      <a:pt x="1973994" y="1291441"/>
                      <a:pt x="1980271" y="1313411"/>
                    </a:cubicBezTo>
                    <a:cubicBezTo>
                      <a:pt x="1985085" y="1330261"/>
                      <a:pt x="1993095" y="1346180"/>
                      <a:pt x="1996897" y="1363287"/>
                    </a:cubicBezTo>
                    <a:cubicBezTo>
                      <a:pt x="2026554" y="1496744"/>
                      <a:pt x="1999880" y="1425098"/>
                      <a:pt x="2030148" y="1546167"/>
                    </a:cubicBezTo>
                    <a:cubicBezTo>
                      <a:pt x="2034398" y="1563168"/>
                      <a:pt x="2041231" y="1579418"/>
                      <a:pt x="2046773" y="1596043"/>
                    </a:cubicBezTo>
                    <a:cubicBezTo>
                      <a:pt x="2052315" y="1640378"/>
                      <a:pt x="2057080" y="1684816"/>
                      <a:pt x="2063399" y="1729047"/>
                    </a:cubicBezTo>
                    <a:cubicBezTo>
                      <a:pt x="2068166" y="1762418"/>
                      <a:pt x="2080024" y="1795090"/>
                      <a:pt x="2080024" y="1828800"/>
                    </a:cubicBezTo>
                    <a:cubicBezTo>
                      <a:pt x="2080024" y="2022843"/>
                      <a:pt x="2073337" y="2216903"/>
                      <a:pt x="2063399" y="2410691"/>
                    </a:cubicBezTo>
                    <a:cubicBezTo>
                      <a:pt x="2061876" y="2440382"/>
                      <a:pt x="2017790" y="2564140"/>
                      <a:pt x="2013522" y="2576945"/>
                    </a:cubicBezTo>
                    <a:lnTo>
                      <a:pt x="1980271" y="2676698"/>
                    </a:lnTo>
                    <a:lnTo>
                      <a:pt x="1930395" y="2726574"/>
                    </a:lnTo>
                    <a:cubicBezTo>
                      <a:pt x="1901132" y="2814363"/>
                      <a:pt x="1923490" y="2761869"/>
                      <a:pt x="1847268" y="2876203"/>
                    </a:cubicBezTo>
                    <a:lnTo>
                      <a:pt x="1780766" y="2975956"/>
                    </a:lnTo>
                    <a:cubicBezTo>
                      <a:pt x="1769682" y="2992581"/>
                      <a:pt x="1764140" y="3014748"/>
                      <a:pt x="1747515" y="3025832"/>
                    </a:cubicBezTo>
                    <a:lnTo>
                      <a:pt x="1697639" y="3059083"/>
                    </a:lnTo>
                    <a:cubicBezTo>
                      <a:pt x="1608972" y="3192084"/>
                      <a:pt x="1725346" y="3031378"/>
                      <a:pt x="1614511" y="3142211"/>
                    </a:cubicBezTo>
                    <a:cubicBezTo>
                      <a:pt x="1539310" y="3217411"/>
                      <a:pt x="1628482" y="3176346"/>
                      <a:pt x="1531384" y="3208712"/>
                    </a:cubicBezTo>
                    <a:cubicBezTo>
                      <a:pt x="1388448" y="3304004"/>
                      <a:pt x="1569295" y="3189756"/>
                      <a:pt x="1431631" y="3258589"/>
                    </a:cubicBezTo>
                    <a:cubicBezTo>
                      <a:pt x="1413759" y="3267525"/>
                      <a:pt x="1400014" y="3283725"/>
                      <a:pt x="1381755" y="3291840"/>
                    </a:cubicBezTo>
                    <a:cubicBezTo>
                      <a:pt x="1349726" y="3306075"/>
                      <a:pt x="1315253" y="3314007"/>
                      <a:pt x="1282002" y="3325091"/>
                    </a:cubicBezTo>
                    <a:lnTo>
                      <a:pt x="1232126" y="3341716"/>
                    </a:lnTo>
                    <a:cubicBezTo>
                      <a:pt x="1215500" y="3352800"/>
                      <a:pt x="1200508" y="3366852"/>
                      <a:pt x="1182249" y="3374967"/>
                    </a:cubicBezTo>
                    <a:cubicBezTo>
                      <a:pt x="1182226" y="3374977"/>
                      <a:pt x="1057570" y="3416526"/>
                      <a:pt x="1032620" y="3424843"/>
                    </a:cubicBezTo>
                    <a:cubicBezTo>
                      <a:pt x="1015995" y="3430385"/>
                      <a:pt x="997325" y="3431748"/>
                      <a:pt x="982744" y="3441469"/>
                    </a:cubicBezTo>
                    <a:cubicBezTo>
                      <a:pt x="966119" y="3452553"/>
                      <a:pt x="951577" y="3467704"/>
                      <a:pt x="932868" y="3474720"/>
                    </a:cubicBezTo>
                    <a:cubicBezTo>
                      <a:pt x="906409" y="3484642"/>
                      <a:pt x="877325" y="3485215"/>
                      <a:pt x="849740" y="3491345"/>
                    </a:cubicBezTo>
                    <a:cubicBezTo>
                      <a:pt x="827435" y="3496302"/>
                      <a:pt x="805720" y="3503884"/>
                      <a:pt x="783239" y="3507971"/>
                    </a:cubicBezTo>
                    <a:cubicBezTo>
                      <a:pt x="564814" y="3547685"/>
                      <a:pt x="751189" y="3503513"/>
                      <a:pt x="600359" y="3541222"/>
                    </a:cubicBezTo>
                    <a:cubicBezTo>
                      <a:pt x="583733" y="3535680"/>
                      <a:pt x="564167" y="3535544"/>
                      <a:pt x="550482" y="3524596"/>
                    </a:cubicBezTo>
                    <a:cubicBezTo>
                      <a:pt x="534879" y="3512114"/>
                      <a:pt x="531360" y="3488849"/>
                      <a:pt x="517231" y="3474720"/>
                    </a:cubicBezTo>
                    <a:cubicBezTo>
                      <a:pt x="503102" y="3460591"/>
                      <a:pt x="483980" y="3452553"/>
                      <a:pt x="467355" y="3441469"/>
                    </a:cubicBezTo>
                    <a:cubicBezTo>
                      <a:pt x="461813" y="3424843"/>
                      <a:pt x="459424" y="3406808"/>
                      <a:pt x="450729" y="3391592"/>
                    </a:cubicBezTo>
                    <a:cubicBezTo>
                      <a:pt x="436982" y="3367534"/>
                      <a:pt x="416958" y="3347639"/>
                      <a:pt x="400853" y="3325091"/>
                    </a:cubicBezTo>
                    <a:cubicBezTo>
                      <a:pt x="389239" y="3308831"/>
                      <a:pt x="380394" y="3290564"/>
                      <a:pt x="367602" y="3275214"/>
                    </a:cubicBezTo>
                    <a:lnTo>
                      <a:pt x="301100" y="3208712"/>
                    </a:lnTo>
                  </a:path>
                </a:pathLst>
              </a:custGeom>
              <a:solidFill>
                <a:srgbClr val="009650"/>
              </a:solidFill>
              <a:ln>
                <a:solidFill>
                  <a:srgbClr val="009650"/>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grpSp>
            <p:nvGrpSpPr>
              <p:cNvPr id="11425" name="Group 41"/>
              <p:cNvGrpSpPr>
                <a:grpSpLocks/>
              </p:cNvGrpSpPr>
              <p:nvPr/>
            </p:nvGrpSpPr>
            <p:grpSpPr bwMode="auto">
              <a:xfrm>
                <a:off x="150896" y="3677340"/>
                <a:ext cx="1560190" cy="1750443"/>
                <a:chOff x="150896" y="3677340"/>
                <a:chExt cx="1560190" cy="1750443"/>
              </a:xfrm>
            </p:grpSpPr>
            <p:sp>
              <p:nvSpPr>
                <p:cNvPr id="102" name="Freeform 42"/>
                <p:cNvSpPr/>
                <p:nvPr/>
              </p:nvSpPr>
              <p:spPr>
                <a:xfrm>
                  <a:off x="151140" y="3679330"/>
                  <a:ext cx="919589" cy="835071"/>
                </a:xfrm>
                <a:custGeom>
                  <a:avLst/>
                  <a:gdLst>
                    <a:gd name="connsiteX0" fmla="*/ 920546 w 920546"/>
                    <a:gd name="connsiteY0" fmla="*/ 0 h 834346"/>
                    <a:gd name="connsiteX1" fmla="*/ 820793 w 920546"/>
                    <a:gd name="connsiteY1" fmla="*/ 116378 h 834346"/>
                    <a:gd name="connsiteX2" fmla="*/ 804168 w 920546"/>
                    <a:gd name="connsiteY2" fmla="*/ 166254 h 834346"/>
                    <a:gd name="connsiteX3" fmla="*/ 754291 w 920546"/>
                    <a:gd name="connsiteY3" fmla="*/ 216131 h 834346"/>
                    <a:gd name="connsiteX4" fmla="*/ 687789 w 920546"/>
                    <a:gd name="connsiteY4" fmla="*/ 315883 h 834346"/>
                    <a:gd name="connsiteX5" fmla="*/ 654538 w 920546"/>
                    <a:gd name="connsiteY5" fmla="*/ 365760 h 834346"/>
                    <a:gd name="connsiteX6" fmla="*/ 554786 w 920546"/>
                    <a:gd name="connsiteY6" fmla="*/ 448887 h 834346"/>
                    <a:gd name="connsiteX7" fmla="*/ 521535 w 920546"/>
                    <a:gd name="connsiteY7" fmla="*/ 498763 h 834346"/>
                    <a:gd name="connsiteX8" fmla="*/ 471658 w 920546"/>
                    <a:gd name="connsiteY8" fmla="*/ 532014 h 834346"/>
                    <a:gd name="connsiteX9" fmla="*/ 371906 w 920546"/>
                    <a:gd name="connsiteY9" fmla="*/ 631767 h 834346"/>
                    <a:gd name="connsiteX10" fmla="*/ 222277 w 920546"/>
                    <a:gd name="connsiteY10" fmla="*/ 714894 h 834346"/>
                    <a:gd name="connsiteX11" fmla="*/ 122524 w 920546"/>
                    <a:gd name="connsiteY11" fmla="*/ 781396 h 834346"/>
                    <a:gd name="connsiteX12" fmla="*/ 72648 w 920546"/>
                    <a:gd name="connsiteY12" fmla="*/ 798022 h 834346"/>
                    <a:gd name="connsiteX13" fmla="*/ 6146 w 920546"/>
                    <a:gd name="connsiteY13" fmla="*/ 831272 h 83434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920546" h="834346">
                      <a:moveTo>
                        <a:pt x="920546" y="0"/>
                      </a:moveTo>
                      <a:cubicBezTo>
                        <a:pt x="881236" y="39309"/>
                        <a:pt x="849231" y="66610"/>
                        <a:pt x="820793" y="116378"/>
                      </a:cubicBezTo>
                      <a:cubicBezTo>
                        <a:pt x="812098" y="131594"/>
                        <a:pt x="813889" y="151673"/>
                        <a:pt x="804168" y="166254"/>
                      </a:cubicBezTo>
                      <a:cubicBezTo>
                        <a:pt x="791126" y="185817"/>
                        <a:pt x="768726" y="197572"/>
                        <a:pt x="754291" y="216131"/>
                      </a:cubicBezTo>
                      <a:cubicBezTo>
                        <a:pt x="729756" y="247675"/>
                        <a:pt x="709956" y="282632"/>
                        <a:pt x="687789" y="315883"/>
                      </a:cubicBezTo>
                      <a:cubicBezTo>
                        <a:pt x="676705" y="332509"/>
                        <a:pt x="671164" y="354676"/>
                        <a:pt x="654538" y="365760"/>
                      </a:cubicBezTo>
                      <a:cubicBezTo>
                        <a:pt x="605497" y="398455"/>
                        <a:pt x="594789" y="400883"/>
                        <a:pt x="554786" y="448887"/>
                      </a:cubicBezTo>
                      <a:cubicBezTo>
                        <a:pt x="541994" y="464237"/>
                        <a:pt x="535664" y="484634"/>
                        <a:pt x="521535" y="498763"/>
                      </a:cubicBezTo>
                      <a:cubicBezTo>
                        <a:pt x="507406" y="512892"/>
                        <a:pt x="486592" y="518739"/>
                        <a:pt x="471658" y="532014"/>
                      </a:cubicBezTo>
                      <a:cubicBezTo>
                        <a:pt x="436512" y="563255"/>
                        <a:pt x="411032" y="605683"/>
                        <a:pt x="371906" y="631767"/>
                      </a:cubicBezTo>
                      <a:cubicBezTo>
                        <a:pt x="257572" y="707990"/>
                        <a:pt x="310065" y="685632"/>
                        <a:pt x="222277" y="714894"/>
                      </a:cubicBezTo>
                      <a:cubicBezTo>
                        <a:pt x="189026" y="737061"/>
                        <a:pt x="160436" y="768758"/>
                        <a:pt x="122524" y="781396"/>
                      </a:cubicBezTo>
                      <a:cubicBezTo>
                        <a:pt x="105899" y="786938"/>
                        <a:pt x="88323" y="790185"/>
                        <a:pt x="72648" y="798022"/>
                      </a:cubicBezTo>
                      <a:cubicBezTo>
                        <a:pt x="0" y="834346"/>
                        <a:pt x="47789" y="831272"/>
                        <a:pt x="6146" y="831272"/>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03" name="Freeform 102"/>
                <p:cNvSpPr/>
                <p:nvPr/>
              </p:nvSpPr>
              <p:spPr>
                <a:xfrm>
                  <a:off x="929010" y="3716651"/>
                  <a:ext cx="148017" cy="1082325"/>
                </a:xfrm>
                <a:custGeom>
                  <a:avLst/>
                  <a:gdLst>
                    <a:gd name="connsiteX0" fmla="*/ 0 w 149629"/>
                    <a:gd name="connsiteY0" fmla="*/ 0 h 1080654"/>
                    <a:gd name="connsiteX1" fmla="*/ 16626 w 149629"/>
                    <a:gd name="connsiteY1" fmla="*/ 831272 h 1080654"/>
                    <a:gd name="connsiteX2" fmla="*/ 49877 w 149629"/>
                    <a:gd name="connsiteY2" fmla="*/ 931025 h 1080654"/>
                    <a:gd name="connsiteX3" fmla="*/ 99753 w 149629"/>
                    <a:gd name="connsiteY3" fmla="*/ 1030778 h 1080654"/>
                    <a:gd name="connsiteX4" fmla="*/ 149629 w 149629"/>
                    <a:gd name="connsiteY4" fmla="*/ 1080654 h 108065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49629" h="1080654">
                      <a:moveTo>
                        <a:pt x="0" y="0"/>
                      </a:moveTo>
                      <a:cubicBezTo>
                        <a:pt x="5542" y="277091"/>
                        <a:pt x="1800" y="554523"/>
                        <a:pt x="16626" y="831272"/>
                      </a:cubicBezTo>
                      <a:cubicBezTo>
                        <a:pt x="18501" y="866271"/>
                        <a:pt x="38793" y="897774"/>
                        <a:pt x="49877" y="931025"/>
                      </a:cubicBezTo>
                      <a:cubicBezTo>
                        <a:pt x="66540" y="981013"/>
                        <a:pt x="63943" y="987805"/>
                        <a:pt x="99753" y="1030778"/>
                      </a:cubicBezTo>
                      <a:cubicBezTo>
                        <a:pt x="114805" y="1048840"/>
                        <a:pt x="149629" y="1080654"/>
                        <a:pt x="149629" y="1080654"/>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04" name="Freeform 103"/>
                <p:cNvSpPr/>
                <p:nvPr/>
              </p:nvSpPr>
              <p:spPr>
                <a:xfrm>
                  <a:off x="683367" y="3758639"/>
                  <a:ext cx="396809" cy="1413553"/>
                </a:xfrm>
                <a:custGeom>
                  <a:avLst/>
                  <a:gdLst>
                    <a:gd name="connsiteX0" fmla="*/ 400098 w 400098"/>
                    <a:gd name="connsiteY0" fmla="*/ 0 h 1413163"/>
                    <a:gd name="connsiteX1" fmla="*/ 267094 w 400098"/>
                    <a:gd name="connsiteY1" fmla="*/ 199505 h 1413163"/>
                    <a:gd name="connsiteX2" fmla="*/ 233843 w 400098"/>
                    <a:gd name="connsiteY2" fmla="*/ 249382 h 1413163"/>
                    <a:gd name="connsiteX3" fmla="*/ 200592 w 400098"/>
                    <a:gd name="connsiteY3" fmla="*/ 299258 h 1413163"/>
                    <a:gd name="connsiteX4" fmla="*/ 183967 w 400098"/>
                    <a:gd name="connsiteY4" fmla="*/ 349134 h 1413163"/>
                    <a:gd name="connsiteX5" fmla="*/ 150716 w 400098"/>
                    <a:gd name="connsiteY5" fmla="*/ 532014 h 1413163"/>
                    <a:gd name="connsiteX6" fmla="*/ 117465 w 400098"/>
                    <a:gd name="connsiteY6" fmla="*/ 881149 h 1413163"/>
                    <a:gd name="connsiteX7" fmla="*/ 84214 w 400098"/>
                    <a:gd name="connsiteY7" fmla="*/ 997527 h 1413163"/>
                    <a:gd name="connsiteX8" fmla="*/ 34338 w 400098"/>
                    <a:gd name="connsiteY8" fmla="*/ 1280160 h 1413163"/>
                    <a:gd name="connsiteX9" fmla="*/ 1087 w 400098"/>
                    <a:gd name="connsiteY9" fmla="*/ 1396538 h 1413163"/>
                    <a:gd name="connsiteX10" fmla="*/ 1087 w 400098"/>
                    <a:gd name="connsiteY10" fmla="*/ 1413163 h 14131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400098" h="1413163">
                      <a:moveTo>
                        <a:pt x="400098" y="0"/>
                      </a:moveTo>
                      <a:lnTo>
                        <a:pt x="267094" y="199505"/>
                      </a:lnTo>
                      <a:lnTo>
                        <a:pt x="233843" y="249382"/>
                      </a:lnTo>
                      <a:lnTo>
                        <a:pt x="200592" y="299258"/>
                      </a:lnTo>
                      <a:cubicBezTo>
                        <a:pt x="195050" y="315883"/>
                        <a:pt x="188217" y="332133"/>
                        <a:pt x="183967" y="349134"/>
                      </a:cubicBezTo>
                      <a:cubicBezTo>
                        <a:pt x="172346" y="395617"/>
                        <a:pt x="158129" y="487534"/>
                        <a:pt x="150716" y="532014"/>
                      </a:cubicBezTo>
                      <a:cubicBezTo>
                        <a:pt x="140975" y="668377"/>
                        <a:pt x="140215" y="756023"/>
                        <a:pt x="117465" y="881149"/>
                      </a:cubicBezTo>
                      <a:cubicBezTo>
                        <a:pt x="109114" y="927082"/>
                        <a:pt x="98460" y="954789"/>
                        <a:pt x="84214" y="997527"/>
                      </a:cubicBezTo>
                      <a:cubicBezTo>
                        <a:pt x="81929" y="1011239"/>
                        <a:pt x="49258" y="1220479"/>
                        <a:pt x="34338" y="1280160"/>
                      </a:cubicBezTo>
                      <a:cubicBezTo>
                        <a:pt x="2643" y="1406941"/>
                        <a:pt x="32189" y="1241026"/>
                        <a:pt x="1087" y="1396538"/>
                      </a:cubicBezTo>
                      <a:cubicBezTo>
                        <a:pt x="0" y="1401972"/>
                        <a:pt x="1087" y="1407621"/>
                        <a:pt x="1087" y="1413163"/>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05" name="Freeform 104"/>
                <p:cNvSpPr/>
                <p:nvPr/>
              </p:nvSpPr>
              <p:spPr>
                <a:xfrm>
                  <a:off x="831384" y="3716651"/>
                  <a:ext cx="166911" cy="1712128"/>
                </a:xfrm>
                <a:custGeom>
                  <a:avLst/>
                  <a:gdLst>
                    <a:gd name="connsiteX0" fmla="*/ 166254 w 166254"/>
                    <a:gd name="connsiteY0" fmla="*/ 0 h 1695796"/>
                    <a:gd name="connsiteX1" fmla="*/ 116378 w 166254"/>
                    <a:gd name="connsiteY1" fmla="*/ 133004 h 1695796"/>
                    <a:gd name="connsiteX2" fmla="*/ 99752 w 166254"/>
                    <a:gd name="connsiteY2" fmla="*/ 282633 h 1695796"/>
                    <a:gd name="connsiteX3" fmla="*/ 83127 w 166254"/>
                    <a:gd name="connsiteY3" fmla="*/ 332509 h 1695796"/>
                    <a:gd name="connsiteX4" fmla="*/ 66502 w 166254"/>
                    <a:gd name="connsiteY4" fmla="*/ 415636 h 1695796"/>
                    <a:gd name="connsiteX5" fmla="*/ 49876 w 166254"/>
                    <a:gd name="connsiteY5" fmla="*/ 665018 h 1695796"/>
                    <a:gd name="connsiteX6" fmla="*/ 33251 w 166254"/>
                    <a:gd name="connsiteY6" fmla="*/ 714894 h 1695796"/>
                    <a:gd name="connsiteX7" fmla="*/ 0 w 166254"/>
                    <a:gd name="connsiteY7" fmla="*/ 980902 h 1695796"/>
                    <a:gd name="connsiteX8" fmla="*/ 16625 w 166254"/>
                    <a:gd name="connsiteY8" fmla="*/ 1579418 h 1695796"/>
                    <a:gd name="connsiteX9" fmla="*/ 33251 w 166254"/>
                    <a:gd name="connsiteY9" fmla="*/ 1645920 h 1695796"/>
                    <a:gd name="connsiteX10" fmla="*/ 49876 w 166254"/>
                    <a:gd name="connsiteY10" fmla="*/ 1695796 h 16957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166254" h="1695796">
                      <a:moveTo>
                        <a:pt x="166254" y="0"/>
                      </a:moveTo>
                      <a:cubicBezTo>
                        <a:pt x="164534" y="4300"/>
                        <a:pt x="120102" y="110659"/>
                        <a:pt x="116378" y="133004"/>
                      </a:cubicBezTo>
                      <a:cubicBezTo>
                        <a:pt x="108128" y="182504"/>
                        <a:pt x="108002" y="233133"/>
                        <a:pt x="99752" y="282633"/>
                      </a:cubicBezTo>
                      <a:cubicBezTo>
                        <a:pt x="96871" y="299919"/>
                        <a:pt x="87377" y="315508"/>
                        <a:pt x="83127" y="332509"/>
                      </a:cubicBezTo>
                      <a:cubicBezTo>
                        <a:pt x="76274" y="359923"/>
                        <a:pt x="72044" y="387927"/>
                        <a:pt x="66502" y="415636"/>
                      </a:cubicBezTo>
                      <a:cubicBezTo>
                        <a:pt x="60960" y="498763"/>
                        <a:pt x="59076" y="582216"/>
                        <a:pt x="49876" y="665018"/>
                      </a:cubicBezTo>
                      <a:cubicBezTo>
                        <a:pt x="47941" y="682435"/>
                        <a:pt x="37053" y="697787"/>
                        <a:pt x="33251" y="714894"/>
                      </a:cubicBezTo>
                      <a:cubicBezTo>
                        <a:pt x="14499" y="799278"/>
                        <a:pt x="8364" y="897263"/>
                        <a:pt x="0" y="980902"/>
                      </a:cubicBezTo>
                      <a:cubicBezTo>
                        <a:pt x="5542" y="1180407"/>
                        <a:pt x="6658" y="1380085"/>
                        <a:pt x="16625" y="1579418"/>
                      </a:cubicBezTo>
                      <a:cubicBezTo>
                        <a:pt x="17766" y="1602239"/>
                        <a:pt x="26974" y="1623950"/>
                        <a:pt x="33251" y="1645920"/>
                      </a:cubicBezTo>
                      <a:cubicBezTo>
                        <a:pt x="38065" y="1662770"/>
                        <a:pt x="49876" y="1695796"/>
                        <a:pt x="49876" y="1695796"/>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06" name="Freeform 105"/>
                <p:cNvSpPr/>
                <p:nvPr/>
              </p:nvSpPr>
              <p:spPr>
                <a:xfrm>
                  <a:off x="998294" y="3809955"/>
                  <a:ext cx="711736" cy="1427550"/>
                </a:xfrm>
                <a:custGeom>
                  <a:avLst/>
                  <a:gdLst>
                    <a:gd name="connsiteX0" fmla="*/ 0 w 714895"/>
                    <a:gd name="connsiteY0" fmla="*/ 0 h 1429789"/>
                    <a:gd name="connsiteX1" fmla="*/ 33251 w 714895"/>
                    <a:gd name="connsiteY1" fmla="*/ 99753 h 1429789"/>
                    <a:gd name="connsiteX2" fmla="*/ 66502 w 714895"/>
                    <a:gd name="connsiteY2" fmla="*/ 166255 h 1429789"/>
                    <a:gd name="connsiteX3" fmla="*/ 133004 w 714895"/>
                    <a:gd name="connsiteY3" fmla="*/ 332509 h 1429789"/>
                    <a:gd name="connsiteX4" fmla="*/ 149629 w 714895"/>
                    <a:gd name="connsiteY4" fmla="*/ 415636 h 1429789"/>
                    <a:gd name="connsiteX5" fmla="*/ 199506 w 714895"/>
                    <a:gd name="connsiteY5" fmla="*/ 565266 h 1429789"/>
                    <a:gd name="connsiteX6" fmla="*/ 216131 w 714895"/>
                    <a:gd name="connsiteY6" fmla="*/ 615142 h 1429789"/>
                    <a:gd name="connsiteX7" fmla="*/ 282633 w 714895"/>
                    <a:gd name="connsiteY7" fmla="*/ 764771 h 1429789"/>
                    <a:gd name="connsiteX8" fmla="*/ 315884 w 714895"/>
                    <a:gd name="connsiteY8" fmla="*/ 814647 h 1429789"/>
                    <a:gd name="connsiteX9" fmla="*/ 349135 w 714895"/>
                    <a:gd name="connsiteY9" fmla="*/ 947651 h 1429789"/>
                    <a:gd name="connsiteX10" fmla="*/ 382386 w 714895"/>
                    <a:gd name="connsiteY10" fmla="*/ 1047404 h 1429789"/>
                    <a:gd name="connsiteX11" fmla="*/ 432262 w 714895"/>
                    <a:gd name="connsiteY11" fmla="*/ 1113906 h 1429789"/>
                    <a:gd name="connsiteX12" fmla="*/ 465513 w 714895"/>
                    <a:gd name="connsiteY12" fmla="*/ 1163782 h 1429789"/>
                    <a:gd name="connsiteX13" fmla="*/ 515389 w 714895"/>
                    <a:gd name="connsiteY13" fmla="*/ 1213658 h 1429789"/>
                    <a:gd name="connsiteX14" fmla="*/ 598517 w 714895"/>
                    <a:gd name="connsiteY14" fmla="*/ 1296786 h 1429789"/>
                    <a:gd name="connsiteX15" fmla="*/ 681644 w 714895"/>
                    <a:gd name="connsiteY15" fmla="*/ 1379913 h 1429789"/>
                    <a:gd name="connsiteX16" fmla="*/ 714895 w 714895"/>
                    <a:gd name="connsiteY16" fmla="*/ 1429789 h 1429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714895" h="1429789">
                      <a:moveTo>
                        <a:pt x="0" y="0"/>
                      </a:moveTo>
                      <a:cubicBezTo>
                        <a:pt x="11084" y="33251"/>
                        <a:pt x="17576" y="68404"/>
                        <a:pt x="33251" y="99753"/>
                      </a:cubicBezTo>
                      <a:cubicBezTo>
                        <a:pt x="44335" y="121920"/>
                        <a:pt x="57297" y="143244"/>
                        <a:pt x="66502" y="166255"/>
                      </a:cubicBezTo>
                      <a:cubicBezTo>
                        <a:pt x="148679" y="371696"/>
                        <a:pt x="55024" y="176550"/>
                        <a:pt x="133004" y="332509"/>
                      </a:cubicBezTo>
                      <a:cubicBezTo>
                        <a:pt x="138546" y="360218"/>
                        <a:pt x="142194" y="388374"/>
                        <a:pt x="149629" y="415636"/>
                      </a:cubicBezTo>
                      <a:cubicBezTo>
                        <a:pt x="149634" y="415654"/>
                        <a:pt x="191190" y="540319"/>
                        <a:pt x="199506" y="565266"/>
                      </a:cubicBezTo>
                      <a:cubicBezTo>
                        <a:pt x="205048" y="581891"/>
                        <a:pt x="209622" y="598871"/>
                        <a:pt x="216131" y="615142"/>
                      </a:cubicBezTo>
                      <a:cubicBezTo>
                        <a:pt x="239882" y="674520"/>
                        <a:pt x="251569" y="710409"/>
                        <a:pt x="282633" y="764771"/>
                      </a:cubicBezTo>
                      <a:cubicBezTo>
                        <a:pt x="292546" y="782120"/>
                        <a:pt x="304800" y="798022"/>
                        <a:pt x="315884" y="814647"/>
                      </a:cubicBezTo>
                      <a:cubicBezTo>
                        <a:pt x="366334" y="966002"/>
                        <a:pt x="288940" y="726938"/>
                        <a:pt x="349135" y="947651"/>
                      </a:cubicBezTo>
                      <a:cubicBezTo>
                        <a:pt x="358357" y="981466"/>
                        <a:pt x="361356" y="1019364"/>
                        <a:pt x="382386" y="1047404"/>
                      </a:cubicBezTo>
                      <a:cubicBezTo>
                        <a:pt x="399011" y="1069571"/>
                        <a:pt x="416156" y="1091358"/>
                        <a:pt x="432262" y="1113906"/>
                      </a:cubicBezTo>
                      <a:cubicBezTo>
                        <a:pt x="443876" y="1130165"/>
                        <a:pt x="452721" y="1148432"/>
                        <a:pt x="465513" y="1163782"/>
                      </a:cubicBezTo>
                      <a:cubicBezTo>
                        <a:pt x="480565" y="1181844"/>
                        <a:pt x="500337" y="1195596"/>
                        <a:pt x="515389" y="1213658"/>
                      </a:cubicBezTo>
                      <a:cubicBezTo>
                        <a:pt x="584662" y="1296786"/>
                        <a:pt x="507076" y="1235826"/>
                        <a:pt x="598517" y="1296786"/>
                      </a:cubicBezTo>
                      <a:cubicBezTo>
                        <a:pt x="687186" y="1429789"/>
                        <a:pt x="570808" y="1269077"/>
                        <a:pt x="681644" y="1379913"/>
                      </a:cubicBezTo>
                      <a:cubicBezTo>
                        <a:pt x="695773" y="1394042"/>
                        <a:pt x="714895" y="1429789"/>
                        <a:pt x="714895" y="1429789"/>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grpSp>
        </p:grpSp>
        <p:grpSp>
          <p:nvGrpSpPr>
            <p:cNvPr id="11350" name="Group 47"/>
            <p:cNvGrpSpPr>
              <a:grpSpLocks/>
            </p:cNvGrpSpPr>
            <p:nvPr/>
          </p:nvGrpSpPr>
          <p:grpSpPr bwMode="auto">
            <a:xfrm>
              <a:off x="4814938" y="9477504"/>
              <a:ext cx="1048512" cy="2414097"/>
              <a:chOff x="-70992" y="106716"/>
              <a:chExt cx="2080253" cy="5319935"/>
            </a:xfrm>
          </p:grpSpPr>
          <p:sp>
            <p:nvSpPr>
              <p:cNvPr id="93" name="Freeform 92"/>
              <p:cNvSpPr/>
              <p:nvPr/>
            </p:nvSpPr>
            <p:spPr>
              <a:xfrm rot="20683283">
                <a:off x="-72101" y="107750"/>
                <a:ext cx="2081671" cy="3545548"/>
              </a:xfrm>
              <a:custGeom>
                <a:avLst/>
                <a:gdLst>
                  <a:gd name="connsiteX0" fmla="*/ 483980 w 2080024"/>
                  <a:gd name="connsiteY0" fmla="*/ 3391592 h 3547685"/>
                  <a:gd name="connsiteX1" fmla="*/ 450729 w 2080024"/>
                  <a:gd name="connsiteY1" fmla="*/ 3341716 h 3547685"/>
                  <a:gd name="connsiteX2" fmla="*/ 400853 w 2080024"/>
                  <a:gd name="connsiteY2" fmla="*/ 3275214 h 3547685"/>
                  <a:gd name="connsiteX3" fmla="*/ 350977 w 2080024"/>
                  <a:gd name="connsiteY3" fmla="*/ 3125585 h 3547685"/>
                  <a:gd name="connsiteX4" fmla="*/ 334351 w 2080024"/>
                  <a:gd name="connsiteY4" fmla="*/ 3075709 h 3547685"/>
                  <a:gd name="connsiteX5" fmla="*/ 301100 w 2080024"/>
                  <a:gd name="connsiteY5" fmla="*/ 3025832 h 3547685"/>
                  <a:gd name="connsiteX6" fmla="*/ 284475 w 2080024"/>
                  <a:gd name="connsiteY6" fmla="*/ 2975956 h 3547685"/>
                  <a:gd name="connsiteX7" fmla="*/ 251224 w 2080024"/>
                  <a:gd name="connsiteY7" fmla="*/ 2909454 h 3547685"/>
                  <a:gd name="connsiteX8" fmla="*/ 234599 w 2080024"/>
                  <a:gd name="connsiteY8" fmla="*/ 2842952 h 3547685"/>
                  <a:gd name="connsiteX9" fmla="*/ 201348 w 2080024"/>
                  <a:gd name="connsiteY9" fmla="*/ 2793076 h 3547685"/>
                  <a:gd name="connsiteX10" fmla="*/ 151471 w 2080024"/>
                  <a:gd name="connsiteY10" fmla="*/ 2693323 h 3547685"/>
                  <a:gd name="connsiteX11" fmla="*/ 84969 w 2080024"/>
                  <a:gd name="connsiteY11" fmla="*/ 2560320 h 3547685"/>
                  <a:gd name="connsiteX12" fmla="*/ 68344 w 2080024"/>
                  <a:gd name="connsiteY12" fmla="*/ 2510443 h 3547685"/>
                  <a:gd name="connsiteX13" fmla="*/ 35093 w 2080024"/>
                  <a:gd name="connsiteY13" fmla="*/ 2394065 h 3547685"/>
                  <a:gd name="connsiteX14" fmla="*/ 18468 w 2080024"/>
                  <a:gd name="connsiteY14" fmla="*/ 2277687 h 3547685"/>
                  <a:gd name="connsiteX15" fmla="*/ 51719 w 2080024"/>
                  <a:gd name="connsiteY15" fmla="*/ 1745672 h 3547685"/>
                  <a:gd name="connsiteX16" fmla="*/ 101595 w 2080024"/>
                  <a:gd name="connsiteY16" fmla="*/ 1629294 h 3547685"/>
                  <a:gd name="connsiteX17" fmla="*/ 118220 w 2080024"/>
                  <a:gd name="connsiteY17" fmla="*/ 1579418 h 3547685"/>
                  <a:gd name="connsiteX18" fmla="*/ 184722 w 2080024"/>
                  <a:gd name="connsiteY18" fmla="*/ 1479665 h 3547685"/>
                  <a:gd name="connsiteX19" fmla="*/ 284475 w 2080024"/>
                  <a:gd name="connsiteY19" fmla="*/ 1330036 h 3547685"/>
                  <a:gd name="connsiteX20" fmla="*/ 317726 w 2080024"/>
                  <a:gd name="connsiteY20" fmla="*/ 1280160 h 3547685"/>
                  <a:gd name="connsiteX21" fmla="*/ 350977 w 2080024"/>
                  <a:gd name="connsiteY21" fmla="*/ 1230283 h 3547685"/>
                  <a:gd name="connsiteX22" fmla="*/ 417479 w 2080024"/>
                  <a:gd name="connsiteY22" fmla="*/ 1163782 h 3547685"/>
                  <a:gd name="connsiteX23" fmla="*/ 434104 w 2080024"/>
                  <a:gd name="connsiteY23" fmla="*/ 1113905 h 3547685"/>
                  <a:gd name="connsiteX24" fmla="*/ 517231 w 2080024"/>
                  <a:gd name="connsiteY24" fmla="*/ 1030778 h 3547685"/>
                  <a:gd name="connsiteX25" fmla="*/ 550482 w 2080024"/>
                  <a:gd name="connsiteY25" fmla="*/ 980902 h 3547685"/>
                  <a:gd name="connsiteX26" fmla="*/ 666860 w 2080024"/>
                  <a:gd name="connsiteY26" fmla="*/ 881149 h 3547685"/>
                  <a:gd name="connsiteX27" fmla="*/ 700111 w 2080024"/>
                  <a:gd name="connsiteY27" fmla="*/ 831272 h 3547685"/>
                  <a:gd name="connsiteX28" fmla="*/ 799864 w 2080024"/>
                  <a:gd name="connsiteY28" fmla="*/ 731520 h 3547685"/>
                  <a:gd name="connsiteX29" fmla="*/ 849740 w 2080024"/>
                  <a:gd name="connsiteY29" fmla="*/ 665018 h 3547685"/>
                  <a:gd name="connsiteX30" fmla="*/ 949493 w 2080024"/>
                  <a:gd name="connsiteY30" fmla="*/ 581891 h 3547685"/>
                  <a:gd name="connsiteX31" fmla="*/ 982744 w 2080024"/>
                  <a:gd name="connsiteY31" fmla="*/ 532014 h 3547685"/>
                  <a:gd name="connsiteX32" fmla="*/ 1049246 w 2080024"/>
                  <a:gd name="connsiteY32" fmla="*/ 482138 h 3547685"/>
                  <a:gd name="connsiteX33" fmla="*/ 1099122 w 2080024"/>
                  <a:gd name="connsiteY33" fmla="*/ 415636 h 3547685"/>
                  <a:gd name="connsiteX34" fmla="*/ 1265377 w 2080024"/>
                  <a:gd name="connsiteY34" fmla="*/ 266007 h 3547685"/>
                  <a:gd name="connsiteX35" fmla="*/ 1365129 w 2080024"/>
                  <a:gd name="connsiteY35" fmla="*/ 182880 h 3547685"/>
                  <a:gd name="connsiteX36" fmla="*/ 1481508 w 2080024"/>
                  <a:gd name="connsiteY36" fmla="*/ 49876 h 3547685"/>
                  <a:gd name="connsiteX37" fmla="*/ 1498133 w 2080024"/>
                  <a:gd name="connsiteY37" fmla="*/ 0 h 3547685"/>
                  <a:gd name="connsiteX38" fmla="*/ 1548009 w 2080024"/>
                  <a:gd name="connsiteY38" fmla="*/ 116378 h 3547685"/>
                  <a:gd name="connsiteX39" fmla="*/ 1597886 w 2080024"/>
                  <a:gd name="connsiteY39" fmla="*/ 249382 h 3547685"/>
                  <a:gd name="connsiteX40" fmla="*/ 1647762 w 2080024"/>
                  <a:gd name="connsiteY40" fmla="*/ 365760 h 3547685"/>
                  <a:gd name="connsiteX41" fmla="*/ 1664388 w 2080024"/>
                  <a:gd name="connsiteY41" fmla="*/ 448887 h 3547685"/>
                  <a:gd name="connsiteX42" fmla="*/ 1697639 w 2080024"/>
                  <a:gd name="connsiteY42" fmla="*/ 498763 h 3547685"/>
                  <a:gd name="connsiteX43" fmla="*/ 1714264 w 2080024"/>
                  <a:gd name="connsiteY43" fmla="*/ 548640 h 3547685"/>
                  <a:gd name="connsiteX44" fmla="*/ 1730889 w 2080024"/>
                  <a:gd name="connsiteY44" fmla="*/ 615142 h 3547685"/>
                  <a:gd name="connsiteX45" fmla="*/ 1780766 w 2080024"/>
                  <a:gd name="connsiteY45" fmla="*/ 764771 h 3547685"/>
                  <a:gd name="connsiteX46" fmla="*/ 1814017 w 2080024"/>
                  <a:gd name="connsiteY46" fmla="*/ 864523 h 3547685"/>
                  <a:gd name="connsiteX47" fmla="*/ 1847268 w 2080024"/>
                  <a:gd name="connsiteY47" fmla="*/ 914400 h 3547685"/>
                  <a:gd name="connsiteX48" fmla="*/ 1913769 w 2080024"/>
                  <a:gd name="connsiteY48" fmla="*/ 1147156 h 3547685"/>
                  <a:gd name="connsiteX49" fmla="*/ 1930395 w 2080024"/>
                  <a:gd name="connsiteY49" fmla="*/ 1197032 h 3547685"/>
                  <a:gd name="connsiteX50" fmla="*/ 1963646 w 2080024"/>
                  <a:gd name="connsiteY50" fmla="*/ 1246909 h 3547685"/>
                  <a:gd name="connsiteX51" fmla="*/ 1980271 w 2080024"/>
                  <a:gd name="connsiteY51" fmla="*/ 1313411 h 3547685"/>
                  <a:gd name="connsiteX52" fmla="*/ 1996897 w 2080024"/>
                  <a:gd name="connsiteY52" fmla="*/ 1363287 h 3547685"/>
                  <a:gd name="connsiteX53" fmla="*/ 2030148 w 2080024"/>
                  <a:gd name="connsiteY53" fmla="*/ 1546167 h 3547685"/>
                  <a:gd name="connsiteX54" fmla="*/ 2046773 w 2080024"/>
                  <a:gd name="connsiteY54" fmla="*/ 1596043 h 3547685"/>
                  <a:gd name="connsiteX55" fmla="*/ 2063399 w 2080024"/>
                  <a:gd name="connsiteY55" fmla="*/ 1729047 h 3547685"/>
                  <a:gd name="connsiteX56" fmla="*/ 2080024 w 2080024"/>
                  <a:gd name="connsiteY56" fmla="*/ 1828800 h 3547685"/>
                  <a:gd name="connsiteX57" fmla="*/ 2063399 w 2080024"/>
                  <a:gd name="connsiteY57" fmla="*/ 2410691 h 3547685"/>
                  <a:gd name="connsiteX58" fmla="*/ 2013522 w 2080024"/>
                  <a:gd name="connsiteY58" fmla="*/ 2576945 h 3547685"/>
                  <a:gd name="connsiteX59" fmla="*/ 1980271 w 2080024"/>
                  <a:gd name="connsiteY59" fmla="*/ 2676698 h 3547685"/>
                  <a:gd name="connsiteX60" fmla="*/ 1930395 w 2080024"/>
                  <a:gd name="connsiteY60" fmla="*/ 2726574 h 3547685"/>
                  <a:gd name="connsiteX61" fmla="*/ 1847268 w 2080024"/>
                  <a:gd name="connsiteY61" fmla="*/ 2876203 h 3547685"/>
                  <a:gd name="connsiteX62" fmla="*/ 1780766 w 2080024"/>
                  <a:gd name="connsiteY62" fmla="*/ 2975956 h 3547685"/>
                  <a:gd name="connsiteX63" fmla="*/ 1747515 w 2080024"/>
                  <a:gd name="connsiteY63" fmla="*/ 3025832 h 3547685"/>
                  <a:gd name="connsiteX64" fmla="*/ 1697639 w 2080024"/>
                  <a:gd name="connsiteY64" fmla="*/ 3059083 h 3547685"/>
                  <a:gd name="connsiteX65" fmla="*/ 1614511 w 2080024"/>
                  <a:gd name="connsiteY65" fmla="*/ 3142211 h 3547685"/>
                  <a:gd name="connsiteX66" fmla="*/ 1531384 w 2080024"/>
                  <a:gd name="connsiteY66" fmla="*/ 3208712 h 3547685"/>
                  <a:gd name="connsiteX67" fmla="*/ 1431631 w 2080024"/>
                  <a:gd name="connsiteY67" fmla="*/ 3258589 h 3547685"/>
                  <a:gd name="connsiteX68" fmla="*/ 1381755 w 2080024"/>
                  <a:gd name="connsiteY68" fmla="*/ 3291840 h 3547685"/>
                  <a:gd name="connsiteX69" fmla="*/ 1282002 w 2080024"/>
                  <a:gd name="connsiteY69" fmla="*/ 3325091 h 3547685"/>
                  <a:gd name="connsiteX70" fmla="*/ 1232126 w 2080024"/>
                  <a:gd name="connsiteY70" fmla="*/ 3341716 h 3547685"/>
                  <a:gd name="connsiteX71" fmla="*/ 1182249 w 2080024"/>
                  <a:gd name="connsiteY71" fmla="*/ 3374967 h 3547685"/>
                  <a:gd name="connsiteX72" fmla="*/ 1032620 w 2080024"/>
                  <a:gd name="connsiteY72" fmla="*/ 3424843 h 3547685"/>
                  <a:gd name="connsiteX73" fmla="*/ 982744 w 2080024"/>
                  <a:gd name="connsiteY73" fmla="*/ 3441469 h 3547685"/>
                  <a:gd name="connsiteX74" fmla="*/ 932868 w 2080024"/>
                  <a:gd name="connsiteY74" fmla="*/ 3474720 h 3547685"/>
                  <a:gd name="connsiteX75" fmla="*/ 849740 w 2080024"/>
                  <a:gd name="connsiteY75" fmla="*/ 3491345 h 3547685"/>
                  <a:gd name="connsiteX76" fmla="*/ 783239 w 2080024"/>
                  <a:gd name="connsiteY76" fmla="*/ 3507971 h 3547685"/>
                  <a:gd name="connsiteX77" fmla="*/ 600359 w 2080024"/>
                  <a:gd name="connsiteY77" fmla="*/ 3541222 h 3547685"/>
                  <a:gd name="connsiteX78" fmla="*/ 550482 w 2080024"/>
                  <a:gd name="connsiteY78" fmla="*/ 3524596 h 3547685"/>
                  <a:gd name="connsiteX79" fmla="*/ 517231 w 2080024"/>
                  <a:gd name="connsiteY79" fmla="*/ 3474720 h 3547685"/>
                  <a:gd name="connsiteX80" fmla="*/ 467355 w 2080024"/>
                  <a:gd name="connsiteY80" fmla="*/ 3441469 h 3547685"/>
                  <a:gd name="connsiteX81" fmla="*/ 450729 w 2080024"/>
                  <a:gd name="connsiteY81" fmla="*/ 3391592 h 3547685"/>
                  <a:gd name="connsiteX82" fmla="*/ 400853 w 2080024"/>
                  <a:gd name="connsiteY82" fmla="*/ 3325091 h 3547685"/>
                  <a:gd name="connsiteX83" fmla="*/ 367602 w 2080024"/>
                  <a:gd name="connsiteY83" fmla="*/ 3275214 h 3547685"/>
                  <a:gd name="connsiteX84" fmla="*/ 301100 w 2080024"/>
                  <a:gd name="connsiteY84" fmla="*/ 3208712 h 354768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Lst>
                <a:rect l="l" t="t" r="r" b="b"/>
                <a:pathLst>
                  <a:path w="2080024" h="3547685">
                    <a:moveTo>
                      <a:pt x="483980" y="3391592"/>
                    </a:moveTo>
                    <a:cubicBezTo>
                      <a:pt x="472896" y="3374967"/>
                      <a:pt x="462343" y="3357975"/>
                      <a:pt x="450729" y="3341716"/>
                    </a:cubicBezTo>
                    <a:cubicBezTo>
                      <a:pt x="434623" y="3319168"/>
                      <a:pt x="413245" y="3299998"/>
                      <a:pt x="400853" y="3275214"/>
                    </a:cubicBezTo>
                    <a:cubicBezTo>
                      <a:pt x="400845" y="3275198"/>
                      <a:pt x="359292" y="3150531"/>
                      <a:pt x="350977" y="3125585"/>
                    </a:cubicBezTo>
                    <a:cubicBezTo>
                      <a:pt x="345435" y="3108960"/>
                      <a:pt x="344072" y="3090290"/>
                      <a:pt x="334351" y="3075709"/>
                    </a:cubicBezTo>
                    <a:lnTo>
                      <a:pt x="301100" y="3025832"/>
                    </a:lnTo>
                    <a:cubicBezTo>
                      <a:pt x="295558" y="3009207"/>
                      <a:pt x="291378" y="2992064"/>
                      <a:pt x="284475" y="2975956"/>
                    </a:cubicBezTo>
                    <a:cubicBezTo>
                      <a:pt x="274712" y="2953176"/>
                      <a:pt x="259926" y="2932660"/>
                      <a:pt x="251224" y="2909454"/>
                    </a:cubicBezTo>
                    <a:cubicBezTo>
                      <a:pt x="243201" y="2888059"/>
                      <a:pt x="243600" y="2863954"/>
                      <a:pt x="234599" y="2842952"/>
                    </a:cubicBezTo>
                    <a:cubicBezTo>
                      <a:pt x="226728" y="2824586"/>
                      <a:pt x="210284" y="2810948"/>
                      <a:pt x="201348" y="2793076"/>
                    </a:cubicBezTo>
                    <a:cubicBezTo>
                      <a:pt x="132512" y="2655406"/>
                      <a:pt x="246768" y="2836269"/>
                      <a:pt x="151471" y="2693323"/>
                    </a:cubicBezTo>
                    <a:cubicBezTo>
                      <a:pt x="118415" y="2561099"/>
                      <a:pt x="160331" y="2692204"/>
                      <a:pt x="84969" y="2560320"/>
                    </a:cubicBezTo>
                    <a:cubicBezTo>
                      <a:pt x="76274" y="2545104"/>
                      <a:pt x="73158" y="2527294"/>
                      <a:pt x="68344" y="2510443"/>
                    </a:cubicBezTo>
                    <a:cubicBezTo>
                      <a:pt x="26601" y="2364338"/>
                      <a:pt x="74950" y="2513634"/>
                      <a:pt x="35093" y="2394065"/>
                    </a:cubicBezTo>
                    <a:cubicBezTo>
                      <a:pt x="29551" y="2355272"/>
                      <a:pt x="18468" y="2316873"/>
                      <a:pt x="18468" y="2277687"/>
                    </a:cubicBezTo>
                    <a:cubicBezTo>
                      <a:pt x="18468" y="2034785"/>
                      <a:pt x="0" y="1926688"/>
                      <a:pt x="51719" y="1745672"/>
                    </a:cubicBezTo>
                    <a:cubicBezTo>
                      <a:pt x="74000" y="1667688"/>
                      <a:pt x="63591" y="1717970"/>
                      <a:pt x="101595" y="1629294"/>
                    </a:cubicBezTo>
                    <a:cubicBezTo>
                      <a:pt x="108498" y="1613186"/>
                      <a:pt x="109709" y="1594737"/>
                      <a:pt x="118220" y="1579418"/>
                    </a:cubicBezTo>
                    <a:cubicBezTo>
                      <a:pt x="137628" y="1544484"/>
                      <a:pt x="162555" y="1512916"/>
                      <a:pt x="184722" y="1479665"/>
                    </a:cubicBezTo>
                    <a:lnTo>
                      <a:pt x="284475" y="1330036"/>
                    </a:lnTo>
                    <a:lnTo>
                      <a:pt x="317726" y="1280160"/>
                    </a:lnTo>
                    <a:lnTo>
                      <a:pt x="350977" y="1230283"/>
                    </a:lnTo>
                    <a:cubicBezTo>
                      <a:pt x="395311" y="1097280"/>
                      <a:pt x="328809" y="1252452"/>
                      <a:pt x="417479" y="1163782"/>
                    </a:cubicBezTo>
                    <a:cubicBezTo>
                      <a:pt x="429871" y="1151390"/>
                      <a:pt x="426267" y="1129580"/>
                      <a:pt x="434104" y="1113905"/>
                    </a:cubicBezTo>
                    <a:cubicBezTo>
                      <a:pt x="461812" y="1058488"/>
                      <a:pt x="467356" y="1064028"/>
                      <a:pt x="517231" y="1030778"/>
                    </a:cubicBezTo>
                    <a:cubicBezTo>
                      <a:pt x="528315" y="1014153"/>
                      <a:pt x="536353" y="995031"/>
                      <a:pt x="550482" y="980902"/>
                    </a:cubicBezTo>
                    <a:cubicBezTo>
                      <a:pt x="660554" y="870830"/>
                      <a:pt x="576381" y="989725"/>
                      <a:pt x="666860" y="881149"/>
                    </a:cubicBezTo>
                    <a:cubicBezTo>
                      <a:pt x="679652" y="865799"/>
                      <a:pt x="686836" y="846206"/>
                      <a:pt x="700111" y="831272"/>
                    </a:cubicBezTo>
                    <a:cubicBezTo>
                      <a:pt x="731352" y="796126"/>
                      <a:pt x="771650" y="769139"/>
                      <a:pt x="799864" y="731520"/>
                    </a:cubicBezTo>
                    <a:cubicBezTo>
                      <a:pt x="816489" y="709353"/>
                      <a:pt x="830147" y="684611"/>
                      <a:pt x="849740" y="665018"/>
                    </a:cubicBezTo>
                    <a:cubicBezTo>
                      <a:pt x="980517" y="534241"/>
                      <a:pt x="813314" y="745306"/>
                      <a:pt x="949493" y="581891"/>
                    </a:cubicBezTo>
                    <a:cubicBezTo>
                      <a:pt x="962285" y="566541"/>
                      <a:pt x="968615" y="546143"/>
                      <a:pt x="982744" y="532014"/>
                    </a:cubicBezTo>
                    <a:cubicBezTo>
                      <a:pt x="1002337" y="512421"/>
                      <a:pt x="1029653" y="501731"/>
                      <a:pt x="1049246" y="482138"/>
                    </a:cubicBezTo>
                    <a:cubicBezTo>
                      <a:pt x="1068839" y="462545"/>
                      <a:pt x="1080586" y="436232"/>
                      <a:pt x="1099122" y="415636"/>
                    </a:cubicBezTo>
                    <a:cubicBezTo>
                      <a:pt x="1240799" y="258216"/>
                      <a:pt x="1148097" y="366532"/>
                      <a:pt x="1265377" y="266007"/>
                    </a:cubicBezTo>
                    <a:cubicBezTo>
                      <a:pt x="1377390" y="169996"/>
                      <a:pt x="1254891" y="256373"/>
                      <a:pt x="1365129" y="182880"/>
                    </a:cubicBezTo>
                    <a:cubicBezTo>
                      <a:pt x="1442715" y="66501"/>
                      <a:pt x="1398380" y="105294"/>
                      <a:pt x="1481508" y="49876"/>
                    </a:cubicBezTo>
                    <a:cubicBezTo>
                      <a:pt x="1487050" y="33251"/>
                      <a:pt x="1480608" y="0"/>
                      <a:pt x="1498133" y="0"/>
                    </a:cubicBezTo>
                    <a:cubicBezTo>
                      <a:pt x="1527059" y="0"/>
                      <a:pt x="1545978" y="109268"/>
                      <a:pt x="1548009" y="116378"/>
                    </a:cubicBezTo>
                    <a:cubicBezTo>
                      <a:pt x="1563100" y="169198"/>
                      <a:pt x="1576812" y="193184"/>
                      <a:pt x="1597886" y="249382"/>
                    </a:cubicBezTo>
                    <a:cubicBezTo>
                      <a:pt x="1634580" y="347234"/>
                      <a:pt x="1589375" y="248986"/>
                      <a:pt x="1647762" y="365760"/>
                    </a:cubicBezTo>
                    <a:cubicBezTo>
                      <a:pt x="1653304" y="393469"/>
                      <a:pt x="1654466" y="422428"/>
                      <a:pt x="1664388" y="448887"/>
                    </a:cubicBezTo>
                    <a:cubicBezTo>
                      <a:pt x="1671404" y="467596"/>
                      <a:pt x="1688703" y="480891"/>
                      <a:pt x="1697639" y="498763"/>
                    </a:cubicBezTo>
                    <a:cubicBezTo>
                      <a:pt x="1705476" y="514438"/>
                      <a:pt x="1709450" y="531789"/>
                      <a:pt x="1714264" y="548640"/>
                    </a:cubicBezTo>
                    <a:cubicBezTo>
                      <a:pt x="1720541" y="570610"/>
                      <a:pt x="1724323" y="593256"/>
                      <a:pt x="1730889" y="615142"/>
                    </a:cubicBezTo>
                    <a:cubicBezTo>
                      <a:pt x="1730895" y="615164"/>
                      <a:pt x="1772450" y="739823"/>
                      <a:pt x="1780766" y="764771"/>
                    </a:cubicBezTo>
                    <a:cubicBezTo>
                      <a:pt x="1780768" y="764776"/>
                      <a:pt x="1814014" y="864519"/>
                      <a:pt x="1814017" y="864523"/>
                    </a:cubicBezTo>
                    <a:lnTo>
                      <a:pt x="1847268" y="914400"/>
                    </a:lnTo>
                    <a:cubicBezTo>
                      <a:pt x="1889015" y="1081389"/>
                      <a:pt x="1866072" y="1004063"/>
                      <a:pt x="1913769" y="1147156"/>
                    </a:cubicBezTo>
                    <a:cubicBezTo>
                      <a:pt x="1919311" y="1163781"/>
                      <a:pt x="1920674" y="1182451"/>
                      <a:pt x="1930395" y="1197032"/>
                    </a:cubicBezTo>
                    <a:lnTo>
                      <a:pt x="1963646" y="1246909"/>
                    </a:lnTo>
                    <a:cubicBezTo>
                      <a:pt x="1969188" y="1269076"/>
                      <a:pt x="1973994" y="1291441"/>
                      <a:pt x="1980271" y="1313411"/>
                    </a:cubicBezTo>
                    <a:cubicBezTo>
                      <a:pt x="1985085" y="1330261"/>
                      <a:pt x="1993095" y="1346180"/>
                      <a:pt x="1996897" y="1363287"/>
                    </a:cubicBezTo>
                    <a:cubicBezTo>
                      <a:pt x="2026554" y="1496744"/>
                      <a:pt x="1999880" y="1425098"/>
                      <a:pt x="2030148" y="1546167"/>
                    </a:cubicBezTo>
                    <a:cubicBezTo>
                      <a:pt x="2034398" y="1563168"/>
                      <a:pt x="2041231" y="1579418"/>
                      <a:pt x="2046773" y="1596043"/>
                    </a:cubicBezTo>
                    <a:cubicBezTo>
                      <a:pt x="2052315" y="1640378"/>
                      <a:pt x="2057080" y="1684816"/>
                      <a:pt x="2063399" y="1729047"/>
                    </a:cubicBezTo>
                    <a:cubicBezTo>
                      <a:pt x="2068166" y="1762418"/>
                      <a:pt x="2080024" y="1795090"/>
                      <a:pt x="2080024" y="1828800"/>
                    </a:cubicBezTo>
                    <a:cubicBezTo>
                      <a:pt x="2080024" y="2022843"/>
                      <a:pt x="2073337" y="2216903"/>
                      <a:pt x="2063399" y="2410691"/>
                    </a:cubicBezTo>
                    <a:cubicBezTo>
                      <a:pt x="2061876" y="2440382"/>
                      <a:pt x="2017790" y="2564140"/>
                      <a:pt x="2013522" y="2576945"/>
                    </a:cubicBezTo>
                    <a:lnTo>
                      <a:pt x="1980271" y="2676698"/>
                    </a:lnTo>
                    <a:lnTo>
                      <a:pt x="1930395" y="2726574"/>
                    </a:lnTo>
                    <a:cubicBezTo>
                      <a:pt x="1901132" y="2814363"/>
                      <a:pt x="1923490" y="2761869"/>
                      <a:pt x="1847268" y="2876203"/>
                    </a:cubicBezTo>
                    <a:lnTo>
                      <a:pt x="1780766" y="2975956"/>
                    </a:lnTo>
                    <a:cubicBezTo>
                      <a:pt x="1769682" y="2992581"/>
                      <a:pt x="1764140" y="3014748"/>
                      <a:pt x="1747515" y="3025832"/>
                    </a:cubicBezTo>
                    <a:lnTo>
                      <a:pt x="1697639" y="3059083"/>
                    </a:lnTo>
                    <a:cubicBezTo>
                      <a:pt x="1608972" y="3192084"/>
                      <a:pt x="1725346" y="3031378"/>
                      <a:pt x="1614511" y="3142211"/>
                    </a:cubicBezTo>
                    <a:cubicBezTo>
                      <a:pt x="1539310" y="3217411"/>
                      <a:pt x="1628482" y="3176346"/>
                      <a:pt x="1531384" y="3208712"/>
                    </a:cubicBezTo>
                    <a:cubicBezTo>
                      <a:pt x="1388448" y="3304004"/>
                      <a:pt x="1569295" y="3189756"/>
                      <a:pt x="1431631" y="3258589"/>
                    </a:cubicBezTo>
                    <a:cubicBezTo>
                      <a:pt x="1413759" y="3267525"/>
                      <a:pt x="1400014" y="3283725"/>
                      <a:pt x="1381755" y="3291840"/>
                    </a:cubicBezTo>
                    <a:cubicBezTo>
                      <a:pt x="1349726" y="3306075"/>
                      <a:pt x="1315253" y="3314007"/>
                      <a:pt x="1282002" y="3325091"/>
                    </a:cubicBezTo>
                    <a:lnTo>
                      <a:pt x="1232126" y="3341716"/>
                    </a:lnTo>
                    <a:cubicBezTo>
                      <a:pt x="1215500" y="3352800"/>
                      <a:pt x="1200508" y="3366852"/>
                      <a:pt x="1182249" y="3374967"/>
                    </a:cubicBezTo>
                    <a:cubicBezTo>
                      <a:pt x="1182226" y="3374977"/>
                      <a:pt x="1057570" y="3416526"/>
                      <a:pt x="1032620" y="3424843"/>
                    </a:cubicBezTo>
                    <a:cubicBezTo>
                      <a:pt x="1015995" y="3430385"/>
                      <a:pt x="997325" y="3431748"/>
                      <a:pt x="982744" y="3441469"/>
                    </a:cubicBezTo>
                    <a:cubicBezTo>
                      <a:pt x="966119" y="3452553"/>
                      <a:pt x="951577" y="3467704"/>
                      <a:pt x="932868" y="3474720"/>
                    </a:cubicBezTo>
                    <a:cubicBezTo>
                      <a:pt x="906409" y="3484642"/>
                      <a:pt x="877325" y="3485215"/>
                      <a:pt x="849740" y="3491345"/>
                    </a:cubicBezTo>
                    <a:cubicBezTo>
                      <a:pt x="827435" y="3496302"/>
                      <a:pt x="805720" y="3503884"/>
                      <a:pt x="783239" y="3507971"/>
                    </a:cubicBezTo>
                    <a:cubicBezTo>
                      <a:pt x="564814" y="3547685"/>
                      <a:pt x="751189" y="3503513"/>
                      <a:pt x="600359" y="3541222"/>
                    </a:cubicBezTo>
                    <a:cubicBezTo>
                      <a:pt x="583733" y="3535680"/>
                      <a:pt x="564167" y="3535544"/>
                      <a:pt x="550482" y="3524596"/>
                    </a:cubicBezTo>
                    <a:cubicBezTo>
                      <a:pt x="534879" y="3512114"/>
                      <a:pt x="531360" y="3488849"/>
                      <a:pt x="517231" y="3474720"/>
                    </a:cubicBezTo>
                    <a:cubicBezTo>
                      <a:pt x="503102" y="3460591"/>
                      <a:pt x="483980" y="3452553"/>
                      <a:pt x="467355" y="3441469"/>
                    </a:cubicBezTo>
                    <a:cubicBezTo>
                      <a:pt x="461813" y="3424843"/>
                      <a:pt x="459424" y="3406808"/>
                      <a:pt x="450729" y="3391592"/>
                    </a:cubicBezTo>
                    <a:cubicBezTo>
                      <a:pt x="436982" y="3367534"/>
                      <a:pt x="416958" y="3347639"/>
                      <a:pt x="400853" y="3325091"/>
                    </a:cubicBezTo>
                    <a:cubicBezTo>
                      <a:pt x="389239" y="3308831"/>
                      <a:pt x="380394" y="3290564"/>
                      <a:pt x="367602" y="3275214"/>
                    </a:cubicBezTo>
                    <a:lnTo>
                      <a:pt x="301100" y="3208712"/>
                    </a:lnTo>
                  </a:path>
                </a:pathLst>
              </a:custGeom>
              <a:solidFill>
                <a:srgbClr val="006450"/>
              </a:solidFill>
              <a:ln>
                <a:solidFill>
                  <a:srgbClr val="006450"/>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grpSp>
            <p:nvGrpSpPr>
              <p:cNvPr id="11418" name="Group 49"/>
              <p:cNvGrpSpPr>
                <a:grpSpLocks/>
              </p:cNvGrpSpPr>
              <p:nvPr/>
            </p:nvGrpSpPr>
            <p:grpSpPr bwMode="auto">
              <a:xfrm>
                <a:off x="150740" y="3676207"/>
                <a:ext cx="1560190" cy="1750444"/>
                <a:chOff x="150740" y="3676207"/>
                <a:chExt cx="1560190" cy="1750444"/>
              </a:xfrm>
            </p:grpSpPr>
            <p:sp>
              <p:nvSpPr>
                <p:cNvPr id="95" name="Freeform 94"/>
                <p:cNvSpPr/>
                <p:nvPr/>
              </p:nvSpPr>
              <p:spPr>
                <a:xfrm>
                  <a:off x="126304" y="3676624"/>
                  <a:ext cx="944783" cy="835069"/>
                </a:xfrm>
                <a:custGeom>
                  <a:avLst/>
                  <a:gdLst>
                    <a:gd name="connsiteX0" fmla="*/ 920546 w 920546"/>
                    <a:gd name="connsiteY0" fmla="*/ 0 h 834346"/>
                    <a:gd name="connsiteX1" fmla="*/ 820793 w 920546"/>
                    <a:gd name="connsiteY1" fmla="*/ 116378 h 834346"/>
                    <a:gd name="connsiteX2" fmla="*/ 804168 w 920546"/>
                    <a:gd name="connsiteY2" fmla="*/ 166254 h 834346"/>
                    <a:gd name="connsiteX3" fmla="*/ 754291 w 920546"/>
                    <a:gd name="connsiteY3" fmla="*/ 216131 h 834346"/>
                    <a:gd name="connsiteX4" fmla="*/ 687789 w 920546"/>
                    <a:gd name="connsiteY4" fmla="*/ 315883 h 834346"/>
                    <a:gd name="connsiteX5" fmla="*/ 654538 w 920546"/>
                    <a:gd name="connsiteY5" fmla="*/ 365760 h 834346"/>
                    <a:gd name="connsiteX6" fmla="*/ 554786 w 920546"/>
                    <a:gd name="connsiteY6" fmla="*/ 448887 h 834346"/>
                    <a:gd name="connsiteX7" fmla="*/ 521535 w 920546"/>
                    <a:gd name="connsiteY7" fmla="*/ 498763 h 834346"/>
                    <a:gd name="connsiteX8" fmla="*/ 471658 w 920546"/>
                    <a:gd name="connsiteY8" fmla="*/ 532014 h 834346"/>
                    <a:gd name="connsiteX9" fmla="*/ 371906 w 920546"/>
                    <a:gd name="connsiteY9" fmla="*/ 631767 h 834346"/>
                    <a:gd name="connsiteX10" fmla="*/ 222277 w 920546"/>
                    <a:gd name="connsiteY10" fmla="*/ 714894 h 834346"/>
                    <a:gd name="connsiteX11" fmla="*/ 122524 w 920546"/>
                    <a:gd name="connsiteY11" fmla="*/ 781396 h 834346"/>
                    <a:gd name="connsiteX12" fmla="*/ 72648 w 920546"/>
                    <a:gd name="connsiteY12" fmla="*/ 798022 h 834346"/>
                    <a:gd name="connsiteX13" fmla="*/ 6146 w 920546"/>
                    <a:gd name="connsiteY13" fmla="*/ 831272 h 83434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920546" h="834346">
                      <a:moveTo>
                        <a:pt x="920546" y="0"/>
                      </a:moveTo>
                      <a:cubicBezTo>
                        <a:pt x="881236" y="39309"/>
                        <a:pt x="849231" y="66610"/>
                        <a:pt x="820793" y="116378"/>
                      </a:cubicBezTo>
                      <a:cubicBezTo>
                        <a:pt x="812098" y="131594"/>
                        <a:pt x="813889" y="151673"/>
                        <a:pt x="804168" y="166254"/>
                      </a:cubicBezTo>
                      <a:cubicBezTo>
                        <a:pt x="791126" y="185817"/>
                        <a:pt x="768726" y="197572"/>
                        <a:pt x="754291" y="216131"/>
                      </a:cubicBezTo>
                      <a:cubicBezTo>
                        <a:pt x="729756" y="247675"/>
                        <a:pt x="709956" y="282632"/>
                        <a:pt x="687789" y="315883"/>
                      </a:cubicBezTo>
                      <a:cubicBezTo>
                        <a:pt x="676705" y="332509"/>
                        <a:pt x="671164" y="354676"/>
                        <a:pt x="654538" y="365760"/>
                      </a:cubicBezTo>
                      <a:cubicBezTo>
                        <a:pt x="605497" y="398455"/>
                        <a:pt x="594789" y="400883"/>
                        <a:pt x="554786" y="448887"/>
                      </a:cubicBezTo>
                      <a:cubicBezTo>
                        <a:pt x="541994" y="464237"/>
                        <a:pt x="535664" y="484634"/>
                        <a:pt x="521535" y="498763"/>
                      </a:cubicBezTo>
                      <a:cubicBezTo>
                        <a:pt x="507406" y="512892"/>
                        <a:pt x="486592" y="518739"/>
                        <a:pt x="471658" y="532014"/>
                      </a:cubicBezTo>
                      <a:cubicBezTo>
                        <a:pt x="436512" y="563255"/>
                        <a:pt x="411032" y="605683"/>
                        <a:pt x="371906" y="631767"/>
                      </a:cubicBezTo>
                      <a:cubicBezTo>
                        <a:pt x="257572" y="707990"/>
                        <a:pt x="310065" y="685632"/>
                        <a:pt x="222277" y="714894"/>
                      </a:cubicBezTo>
                      <a:cubicBezTo>
                        <a:pt x="189026" y="737061"/>
                        <a:pt x="160436" y="768758"/>
                        <a:pt x="122524" y="781396"/>
                      </a:cubicBezTo>
                      <a:cubicBezTo>
                        <a:pt x="105899" y="786938"/>
                        <a:pt x="88323" y="790185"/>
                        <a:pt x="72648" y="798022"/>
                      </a:cubicBezTo>
                      <a:cubicBezTo>
                        <a:pt x="0" y="834346"/>
                        <a:pt x="47789" y="831272"/>
                        <a:pt x="6146" y="831272"/>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96" name="Freeform 95"/>
                <p:cNvSpPr/>
                <p:nvPr/>
              </p:nvSpPr>
              <p:spPr>
                <a:xfrm>
                  <a:off x="926220" y="3713946"/>
                  <a:ext cx="151165" cy="1082326"/>
                </a:xfrm>
                <a:custGeom>
                  <a:avLst/>
                  <a:gdLst>
                    <a:gd name="connsiteX0" fmla="*/ 0 w 149629"/>
                    <a:gd name="connsiteY0" fmla="*/ 0 h 1080654"/>
                    <a:gd name="connsiteX1" fmla="*/ 16626 w 149629"/>
                    <a:gd name="connsiteY1" fmla="*/ 831272 h 1080654"/>
                    <a:gd name="connsiteX2" fmla="*/ 49877 w 149629"/>
                    <a:gd name="connsiteY2" fmla="*/ 931025 h 1080654"/>
                    <a:gd name="connsiteX3" fmla="*/ 99753 w 149629"/>
                    <a:gd name="connsiteY3" fmla="*/ 1030778 h 1080654"/>
                    <a:gd name="connsiteX4" fmla="*/ 149629 w 149629"/>
                    <a:gd name="connsiteY4" fmla="*/ 1080654 h 108065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49629" h="1080654">
                      <a:moveTo>
                        <a:pt x="0" y="0"/>
                      </a:moveTo>
                      <a:cubicBezTo>
                        <a:pt x="5542" y="277091"/>
                        <a:pt x="1800" y="554523"/>
                        <a:pt x="16626" y="831272"/>
                      </a:cubicBezTo>
                      <a:cubicBezTo>
                        <a:pt x="18501" y="866271"/>
                        <a:pt x="38793" y="897774"/>
                        <a:pt x="49877" y="931025"/>
                      </a:cubicBezTo>
                      <a:cubicBezTo>
                        <a:pt x="66540" y="981013"/>
                        <a:pt x="63943" y="987805"/>
                        <a:pt x="99753" y="1030778"/>
                      </a:cubicBezTo>
                      <a:cubicBezTo>
                        <a:pt x="114805" y="1048840"/>
                        <a:pt x="149629" y="1080654"/>
                        <a:pt x="149629" y="1080654"/>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97" name="Freeform 96"/>
                <p:cNvSpPr/>
                <p:nvPr/>
              </p:nvSpPr>
              <p:spPr>
                <a:xfrm>
                  <a:off x="589246" y="3755931"/>
                  <a:ext cx="422003" cy="1413556"/>
                </a:xfrm>
                <a:custGeom>
                  <a:avLst/>
                  <a:gdLst>
                    <a:gd name="connsiteX0" fmla="*/ 400098 w 400098"/>
                    <a:gd name="connsiteY0" fmla="*/ 0 h 1413163"/>
                    <a:gd name="connsiteX1" fmla="*/ 267094 w 400098"/>
                    <a:gd name="connsiteY1" fmla="*/ 199505 h 1413163"/>
                    <a:gd name="connsiteX2" fmla="*/ 233843 w 400098"/>
                    <a:gd name="connsiteY2" fmla="*/ 249382 h 1413163"/>
                    <a:gd name="connsiteX3" fmla="*/ 200592 w 400098"/>
                    <a:gd name="connsiteY3" fmla="*/ 299258 h 1413163"/>
                    <a:gd name="connsiteX4" fmla="*/ 183967 w 400098"/>
                    <a:gd name="connsiteY4" fmla="*/ 349134 h 1413163"/>
                    <a:gd name="connsiteX5" fmla="*/ 150716 w 400098"/>
                    <a:gd name="connsiteY5" fmla="*/ 532014 h 1413163"/>
                    <a:gd name="connsiteX6" fmla="*/ 117465 w 400098"/>
                    <a:gd name="connsiteY6" fmla="*/ 881149 h 1413163"/>
                    <a:gd name="connsiteX7" fmla="*/ 84214 w 400098"/>
                    <a:gd name="connsiteY7" fmla="*/ 997527 h 1413163"/>
                    <a:gd name="connsiteX8" fmla="*/ 34338 w 400098"/>
                    <a:gd name="connsiteY8" fmla="*/ 1280160 h 1413163"/>
                    <a:gd name="connsiteX9" fmla="*/ 1087 w 400098"/>
                    <a:gd name="connsiteY9" fmla="*/ 1396538 h 1413163"/>
                    <a:gd name="connsiteX10" fmla="*/ 1087 w 400098"/>
                    <a:gd name="connsiteY10" fmla="*/ 1413163 h 14131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400098" h="1413163">
                      <a:moveTo>
                        <a:pt x="400098" y="0"/>
                      </a:moveTo>
                      <a:lnTo>
                        <a:pt x="267094" y="199505"/>
                      </a:lnTo>
                      <a:lnTo>
                        <a:pt x="233843" y="249382"/>
                      </a:lnTo>
                      <a:lnTo>
                        <a:pt x="200592" y="299258"/>
                      </a:lnTo>
                      <a:cubicBezTo>
                        <a:pt x="195050" y="315883"/>
                        <a:pt x="188217" y="332133"/>
                        <a:pt x="183967" y="349134"/>
                      </a:cubicBezTo>
                      <a:cubicBezTo>
                        <a:pt x="172346" y="395617"/>
                        <a:pt x="158129" y="487534"/>
                        <a:pt x="150716" y="532014"/>
                      </a:cubicBezTo>
                      <a:cubicBezTo>
                        <a:pt x="140975" y="668377"/>
                        <a:pt x="140215" y="756023"/>
                        <a:pt x="117465" y="881149"/>
                      </a:cubicBezTo>
                      <a:cubicBezTo>
                        <a:pt x="109114" y="927082"/>
                        <a:pt x="98460" y="954789"/>
                        <a:pt x="84214" y="997527"/>
                      </a:cubicBezTo>
                      <a:cubicBezTo>
                        <a:pt x="81929" y="1011239"/>
                        <a:pt x="49258" y="1220479"/>
                        <a:pt x="34338" y="1280160"/>
                      </a:cubicBezTo>
                      <a:cubicBezTo>
                        <a:pt x="2643" y="1406941"/>
                        <a:pt x="32189" y="1241026"/>
                        <a:pt x="1087" y="1396538"/>
                      </a:cubicBezTo>
                      <a:cubicBezTo>
                        <a:pt x="0" y="1401972"/>
                        <a:pt x="1087" y="1407621"/>
                        <a:pt x="1087" y="1413163"/>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98" name="Freeform 97"/>
                <p:cNvSpPr/>
                <p:nvPr/>
              </p:nvSpPr>
              <p:spPr>
                <a:xfrm>
                  <a:off x="806547" y="3713946"/>
                  <a:ext cx="192105" cy="1712126"/>
                </a:xfrm>
                <a:custGeom>
                  <a:avLst/>
                  <a:gdLst>
                    <a:gd name="connsiteX0" fmla="*/ 166254 w 166254"/>
                    <a:gd name="connsiteY0" fmla="*/ 0 h 1695796"/>
                    <a:gd name="connsiteX1" fmla="*/ 116378 w 166254"/>
                    <a:gd name="connsiteY1" fmla="*/ 133004 h 1695796"/>
                    <a:gd name="connsiteX2" fmla="*/ 99752 w 166254"/>
                    <a:gd name="connsiteY2" fmla="*/ 282633 h 1695796"/>
                    <a:gd name="connsiteX3" fmla="*/ 83127 w 166254"/>
                    <a:gd name="connsiteY3" fmla="*/ 332509 h 1695796"/>
                    <a:gd name="connsiteX4" fmla="*/ 66502 w 166254"/>
                    <a:gd name="connsiteY4" fmla="*/ 415636 h 1695796"/>
                    <a:gd name="connsiteX5" fmla="*/ 49876 w 166254"/>
                    <a:gd name="connsiteY5" fmla="*/ 665018 h 1695796"/>
                    <a:gd name="connsiteX6" fmla="*/ 33251 w 166254"/>
                    <a:gd name="connsiteY6" fmla="*/ 714894 h 1695796"/>
                    <a:gd name="connsiteX7" fmla="*/ 0 w 166254"/>
                    <a:gd name="connsiteY7" fmla="*/ 980902 h 1695796"/>
                    <a:gd name="connsiteX8" fmla="*/ 16625 w 166254"/>
                    <a:gd name="connsiteY8" fmla="*/ 1579418 h 1695796"/>
                    <a:gd name="connsiteX9" fmla="*/ 33251 w 166254"/>
                    <a:gd name="connsiteY9" fmla="*/ 1645920 h 1695796"/>
                    <a:gd name="connsiteX10" fmla="*/ 49876 w 166254"/>
                    <a:gd name="connsiteY10" fmla="*/ 1695796 h 16957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166254" h="1695796">
                      <a:moveTo>
                        <a:pt x="166254" y="0"/>
                      </a:moveTo>
                      <a:cubicBezTo>
                        <a:pt x="164534" y="4300"/>
                        <a:pt x="120102" y="110659"/>
                        <a:pt x="116378" y="133004"/>
                      </a:cubicBezTo>
                      <a:cubicBezTo>
                        <a:pt x="108128" y="182504"/>
                        <a:pt x="108002" y="233133"/>
                        <a:pt x="99752" y="282633"/>
                      </a:cubicBezTo>
                      <a:cubicBezTo>
                        <a:pt x="96871" y="299919"/>
                        <a:pt x="87377" y="315508"/>
                        <a:pt x="83127" y="332509"/>
                      </a:cubicBezTo>
                      <a:cubicBezTo>
                        <a:pt x="76274" y="359923"/>
                        <a:pt x="72044" y="387927"/>
                        <a:pt x="66502" y="415636"/>
                      </a:cubicBezTo>
                      <a:cubicBezTo>
                        <a:pt x="60960" y="498763"/>
                        <a:pt x="59076" y="582216"/>
                        <a:pt x="49876" y="665018"/>
                      </a:cubicBezTo>
                      <a:cubicBezTo>
                        <a:pt x="47941" y="682435"/>
                        <a:pt x="37053" y="697787"/>
                        <a:pt x="33251" y="714894"/>
                      </a:cubicBezTo>
                      <a:cubicBezTo>
                        <a:pt x="14499" y="799278"/>
                        <a:pt x="8364" y="897263"/>
                        <a:pt x="0" y="980902"/>
                      </a:cubicBezTo>
                      <a:cubicBezTo>
                        <a:pt x="5542" y="1180407"/>
                        <a:pt x="6658" y="1380085"/>
                        <a:pt x="16625" y="1579418"/>
                      </a:cubicBezTo>
                      <a:cubicBezTo>
                        <a:pt x="17766" y="1602239"/>
                        <a:pt x="26974" y="1623950"/>
                        <a:pt x="33251" y="1645920"/>
                      </a:cubicBezTo>
                      <a:cubicBezTo>
                        <a:pt x="38065" y="1662770"/>
                        <a:pt x="49876" y="1695796"/>
                        <a:pt x="49876" y="1695796"/>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99" name="Freeform 98"/>
                <p:cNvSpPr/>
                <p:nvPr/>
              </p:nvSpPr>
              <p:spPr>
                <a:xfrm>
                  <a:off x="995504" y="3807250"/>
                  <a:ext cx="714885" cy="1427551"/>
                </a:xfrm>
                <a:custGeom>
                  <a:avLst/>
                  <a:gdLst>
                    <a:gd name="connsiteX0" fmla="*/ 0 w 714895"/>
                    <a:gd name="connsiteY0" fmla="*/ 0 h 1429789"/>
                    <a:gd name="connsiteX1" fmla="*/ 33251 w 714895"/>
                    <a:gd name="connsiteY1" fmla="*/ 99753 h 1429789"/>
                    <a:gd name="connsiteX2" fmla="*/ 66502 w 714895"/>
                    <a:gd name="connsiteY2" fmla="*/ 166255 h 1429789"/>
                    <a:gd name="connsiteX3" fmla="*/ 133004 w 714895"/>
                    <a:gd name="connsiteY3" fmla="*/ 332509 h 1429789"/>
                    <a:gd name="connsiteX4" fmla="*/ 149629 w 714895"/>
                    <a:gd name="connsiteY4" fmla="*/ 415636 h 1429789"/>
                    <a:gd name="connsiteX5" fmla="*/ 199506 w 714895"/>
                    <a:gd name="connsiteY5" fmla="*/ 565266 h 1429789"/>
                    <a:gd name="connsiteX6" fmla="*/ 216131 w 714895"/>
                    <a:gd name="connsiteY6" fmla="*/ 615142 h 1429789"/>
                    <a:gd name="connsiteX7" fmla="*/ 282633 w 714895"/>
                    <a:gd name="connsiteY7" fmla="*/ 764771 h 1429789"/>
                    <a:gd name="connsiteX8" fmla="*/ 315884 w 714895"/>
                    <a:gd name="connsiteY8" fmla="*/ 814647 h 1429789"/>
                    <a:gd name="connsiteX9" fmla="*/ 349135 w 714895"/>
                    <a:gd name="connsiteY9" fmla="*/ 947651 h 1429789"/>
                    <a:gd name="connsiteX10" fmla="*/ 382386 w 714895"/>
                    <a:gd name="connsiteY10" fmla="*/ 1047404 h 1429789"/>
                    <a:gd name="connsiteX11" fmla="*/ 432262 w 714895"/>
                    <a:gd name="connsiteY11" fmla="*/ 1113906 h 1429789"/>
                    <a:gd name="connsiteX12" fmla="*/ 465513 w 714895"/>
                    <a:gd name="connsiteY12" fmla="*/ 1163782 h 1429789"/>
                    <a:gd name="connsiteX13" fmla="*/ 515389 w 714895"/>
                    <a:gd name="connsiteY13" fmla="*/ 1213658 h 1429789"/>
                    <a:gd name="connsiteX14" fmla="*/ 598517 w 714895"/>
                    <a:gd name="connsiteY14" fmla="*/ 1296786 h 1429789"/>
                    <a:gd name="connsiteX15" fmla="*/ 681644 w 714895"/>
                    <a:gd name="connsiteY15" fmla="*/ 1379913 h 1429789"/>
                    <a:gd name="connsiteX16" fmla="*/ 714895 w 714895"/>
                    <a:gd name="connsiteY16" fmla="*/ 1429789 h 1429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714895" h="1429789">
                      <a:moveTo>
                        <a:pt x="0" y="0"/>
                      </a:moveTo>
                      <a:cubicBezTo>
                        <a:pt x="11084" y="33251"/>
                        <a:pt x="17576" y="68404"/>
                        <a:pt x="33251" y="99753"/>
                      </a:cubicBezTo>
                      <a:cubicBezTo>
                        <a:pt x="44335" y="121920"/>
                        <a:pt x="57297" y="143244"/>
                        <a:pt x="66502" y="166255"/>
                      </a:cubicBezTo>
                      <a:cubicBezTo>
                        <a:pt x="148679" y="371696"/>
                        <a:pt x="55024" y="176550"/>
                        <a:pt x="133004" y="332509"/>
                      </a:cubicBezTo>
                      <a:cubicBezTo>
                        <a:pt x="138546" y="360218"/>
                        <a:pt x="142194" y="388374"/>
                        <a:pt x="149629" y="415636"/>
                      </a:cubicBezTo>
                      <a:cubicBezTo>
                        <a:pt x="149634" y="415654"/>
                        <a:pt x="191190" y="540319"/>
                        <a:pt x="199506" y="565266"/>
                      </a:cubicBezTo>
                      <a:cubicBezTo>
                        <a:pt x="205048" y="581891"/>
                        <a:pt x="209622" y="598871"/>
                        <a:pt x="216131" y="615142"/>
                      </a:cubicBezTo>
                      <a:cubicBezTo>
                        <a:pt x="239882" y="674520"/>
                        <a:pt x="251569" y="710409"/>
                        <a:pt x="282633" y="764771"/>
                      </a:cubicBezTo>
                      <a:cubicBezTo>
                        <a:pt x="292546" y="782120"/>
                        <a:pt x="304800" y="798022"/>
                        <a:pt x="315884" y="814647"/>
                      </a:cubicBezTo>
                      <a:cubicBezTo>
                        <a:pt x="366334" y="966002"/>
                        <a:pt x="288940" y="726938"/>
                        <a:pt x="349135" y="947651"/>
                      </a:cubicBezTo>
                      <a:cubicBezTo>
                        <a:pt x="358357" y="981466"/>
                        <a:pt x="361356" y="1019364"/>
                        <a:pt x="382386" y="1047404"/>
                      </a:cubicBezTo>
                      <a:cubicBezTo>
                        <a:pt x="399011" y="1069571"/>
                        <a:pt x="416156" y="1091358"/>
                        <a:pt x="432262" y="1113906"/>
                      </a:cubicBezTo>
                      <a:cubicBezTo>
                        <a:pt x="443876" y="1130165"/>
                        <a:pt x="452721" y="1148432"/>
                        <a:pt x="465513" y="1163782"/>
                      </a:cubicBezTo>
                      <a:cubicBezTo>
                        <a:pt x="480565" y="1181844"/>
                        <a:pt x="500337" y="1195596"/>
                        <a:pt x="515389" y="1213658"/>
                      </a:cubicBezTo>
                      <a:cubicBezTo>
                        <a:pt x="584662" y="1296786"/>
                        <a:pt x="507076" y="1235826"/>
                        <a:pt x="598517" y="1296786"/>
                      </a:cubicBezTo>
                      <a:cubicBezTo>
                        <a:pt x="687186" y="1429789"/>
                        <a:pt x="570808" y="1269077"/>
                        <a:pt x="681644" y="1379913"/>
                      </a:cubicBezTo>
                      <a:cubicBezTo>
                        <a:pt x="695773" y="1394042"/>
                        <a:pt x="714895" y="1429789"/>
                        <a:pt x="714895" y="1429789"/>
                      </a:cubicBezTo>
                    </a:path>
                  </a:pathLst>
                </a:cu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grpSp>
        </p:grpSp>
        <p:sp>
          <p:nvSpPr>
            <p:cNvPr id="7" name="Can 6"/>
            <p:cNvSpPr/>
            <p:nvPr/>
          </p:nvSpPr>
          <p:spPr bwMode="auto">
            <a:xfrm>
              <a:off x="1971468" y="8796304"/>
              <a:ext cx="34921" cy="163009"/>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8" name="Can 7"/>
            <p:cNvSpPr/>
            <p:nvPr/>
          </p:nvSpPr>
          <p:spPr bwMode="auto">
            <a:xfrm>
              <a:off x="1898451" y="8667169"/>
              <a:ext cx="36508" cy="163007"/>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9" name="Can 8"/>
            <p:cNvSpPr/>
            <p:nvPr/>
          </p:nvSpPr>
          <p:spPr bwMode="auto">
            <a:xfrm>
              <a:off x="2115915" y="8796304"/>
              <a:ext cx="34921" cy="163009"/>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0" name="Can 9"/>
            <p:cNvSpPr/>
            <p:nvPr/>
          </p:nvSpPr>
          <p:spPr bwMode="auto">
            <a:xfrm>
              <a:off x="1898451" y="8861931"/>
              <a:ext cx="36508" cy="160891"/>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1" name="Can 10"/>
            <p:cNvSpPr/>
            <p:nvPr/>
          </p:nvSpPr>
          <p:spPr bwMode="auto">
            <a:xfrm rot="16200000">
              <a:off x="2116440" y="8949280"/>
              <a:ext cx="33872" cy="180956"/>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2" name="Can 11"/>
            <p:cNvSpPr/>
            <p:nvPr/>
          </p:nvSpPr>
          <p:spPr bwMode="auto">
            <a:xfrm rot="16200000">
              <a:off x="2009559" y="9013848"/>
              <a:ext cx="31755" cy="180956"/>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3" name="Can 63"/>
            <p:cNvSpPr/>
            <p:nvPr/>
          </p:nvSpPr>
          <p:spPr bwMode="auto">
            <a:xfrm>
              <a:off x="2971487" y="9082098"/>
              <a:ext cx="36508" cy="163007"/>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4" name="Can 64"/>
            <p:cNvSpPr/>
            <p:nvPr/>
          </p:nvSpPr>
          <p:spPr bwMode="auto">
            <a:xfrm>
              <a:off x="3049266" y="9151958"/>
              <a:ext cx="34921" cy="160891"/>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5" name="Can 65"/>
            <p:cNvSpPr/>
            <p:nvPr/>
          </p:nvSpPr>
          <p:spPr bwMode="auto">
            <a:xfrm>
              <a:off x="3125458" y="9221819"/>
              <a:ext cx="36509" cy="160891"/>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6" name="Can 66"/>
            <p:cNvSpPr/>
            <p:nvPr/>
          </p:nvSpPr>
          <p:spPr bwMode="auto">
            <a:xfrm>
              <a:off x="2042898" y="8830176"/>
              <a:ext cx="36509" cy="160891"/>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7" name="Can 16"/>
            <p:cNvSpPr/>
            <p:nvPr/>
          </p:nvSpPr>
          <p:spPr bwMode="auto">
            <a:xfrm>
              <a:off x="3050854" y="8959313"/>
              <a:ext cx="36508" cy="160891"/>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8" name="Can 17"/>
            <p:cNvSpPr/>
            <p:nvPr/>
          </p:nvSpPr>
          <p:spPr bwMode="auto">
            <a:xfrm>
              <a:off x="3230222" y="9154076"/>
              <a:ext cx="38096" cy="160891"/>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19" name="Can 18"/>
            <p:cNvSpPr/>
            <p:nvPr/>
          </p:nvSpPr>
          <p:spPr bwMode="auto">
            <a:xfrm rot="16200000">
              <a:off x="2045274" y="8658988"/>
              <a:ext cx="31755" cy="179368"/>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20" name="Can 19"/>
            <p:cNvSpPr/>
            <p:nvPr/>
          </p:nvSpPr>
          <p:spPr bwMode="auto">
            <a:xfrm>
              <a:off x="5295341" y="9770118"/>
              <a:ext cx="36508" cy="160891"/>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21" name="Can 20"/>
            <p:cNvSpPr/>
            <p:nvPr/>
          </p:nvSpPr>
          <p:spPr bwMode="auto">
            <a:xfrm>
              <a:off x="5401692" y="9702375"/>
              <a:ext cx="34921" cy="160891"/>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22" name="Can 21"/>
            <p:cNvSpPr/>
            <p:nvPr/>
          </p:nvSpPr>
          <p:spPr bwMode="auto">
            <a:xfrm>
              <a:off x="4133414" y="9412348"/>
              <a:ext cx="36508" cy="163007"/>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23" name="Can 22"/>
            <p:cNvSpPr/>
            <p:nvPr/>
          </p:nvSpPr>
          <p:spPr bwMode="auto">
            <a:xfrm>
              <a:off x="4238178" y="9346721"/>
              <a:ext cx="36508" cy="160891"/>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24" name="Can 23"/>
            <p:cNvSpPr/>
            <p:nvPr/>
          </p:nvSpPr>
          <p:spPr bwMode="auto">
            <a:xfrm>
              <a:off x="4211193" y="9575355"/>
              <a:ext cx="36509" cy="160891"/>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25" name="Can 24"/>
            <p:cNvSpPr/>
            <p:nvPr/>
          </p:nvSpPr>
          <p:spPr bwMode="auto">
            <a:xfrm>
              <a:off x="4315957" y="9507612"/>
              <a:ext cx="34921" cy="163009"/>
            </a:xfrm>
            <a:prstGeom prst="can">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grpSp>
          <p:nvGrpSpPr>
            <p:cNvPr id="11370" name="Group 16"/>
            <p:cNvGrpSpPr>
              <a:grpSpLocks/>
            </p:cNvGrpSpPr>
            <p:nvPr/>
          </p:nvGrpSpPr>
          <p:grpSpPr bwMode="auto">
            <a:xfrm>
              <a:off x="1395082" y="10061455"/>
              <a:ext cx="5324095" cy="1424498"/>
              <a:chOff x="1357290" y="3215714"/>
              <a:chExt cx="3841114" cy="3139159"/>
            </a:xfrm>
          </p:grpSpPr>
          <p:cxnSp>
            <p:nvCxnSpPr>
              <p:cNvPr id="89" name="Elbow Connector 88"/>
              <p:cNvCxnSpPr/>
              <p:nvPr/>
            </p:nvCxnSpPr>
            <p:spPr>
              <a:xfrm>
                <a:off x="1357423" y="3217492"/>
                <a:ext cx="1571206" cy="783752"/>
              </a:xfrm>
              <a:prstGeom prst="bentConnector3">
                <a:avLst>
                  <a:gd name="adj1"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Elbow Connector 89"/>
              <p:cNvCxnSpPr/>
              <p:nvPr/>
            </p:nvCxnSpPr>
            <p:spPr>
              <a:xfrm>
                <a:off x="2148752" y="4001244"/>
                <a:ext cx="1571206" cy="788419"/>
              </a:xfrm>
              <a:prstGeom prst="bentConnector3">
                <a:avLst>
                  <a:gd name="adj1"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Elbow Connector 90"/>
              <p:cNvCxnSpPr/>
              <p:nvPr/>
            </p:nvCxnSpPr>
            <p:spPr>
              <a:xfrm>
                <a:off x="2948098" y="4784997"/>
                <a:ext cx="1532270" cy="788419"/>
              </a:xfrm>
              <a:prstGeom prst="bentConnector3">
                <a:avLst>
                  <a:gd name="adj1"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Elbow Connector 91"/>
              <p:cNvCxnSpPr/>
              <p:nvPr/>
            </p:nvCxnSpPr>
            <p:spPr>
              <a:xfrm>
                <a:off x="3744007" y="5573416"/>
                <a:ext cx="1454397" cy="783752"/>
              </a:xfrm>
              <a:prstGeom prst="bentConnector3">
                <a:avLst>
                  <a:gd name="adj1"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1" name="Oval 30"/>
            <p:cNvSpPr/>
            <p:nvPr/>
          </p:nvSpPr>
          <p:spPr bwMode="auto">
            <a:xfrm>
              <a:off x="1647652" y="9348838"/>
              <a:ext cx="71429"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32" name="Oval 31"/>
            <p:cNvSpPr/>
            <p:nvPr/>
          </p:nvSpPr>
          <p:spPr bwMode="auto">
            <a:xfrm>
              <a:off x="1723844" y="9416582"/>
              <a:ext cx="73017"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33" name="Oval 32"/>
            <p:cNvSpPr/>
            <p:nvPr/>
          </p:nvSpPr>
          <p:spPr bwMode="auto">
            <a:xfrm>
              <a:off x="1827020" y="9638865"/>
              <a:ext cx="71430"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34" name="Oval 33"/>
            <p:cNvSpPr/>
            <p:nvPr/>
          </p:nvSpPr>
          <p:spPr bwMode="auto">
            <a:xfrm>
              <a:off x="1827020" y="9736246"/>
              <a:ext cx="71430"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35" name="Oval 34"/>
            <p:cNvSpPr/>
            <p:nvPr/>
          </p:nvSpPr>
          <p:spPr bwMode="auto">
            <a:xfrm>
              <a:off x="2223853" y="9477974"/>
              <a:ext cx="71430"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36" name="Oval 35"/>
            <p:cNvSpPr/>
            <p:nvPr/>
          </p:nvSpPr>
          <p:spPr bwMode="auto">
            <a:xfrm>
              <a:off x="2031787" y="9446220"/>
              <a:ext cx="71429"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37" name="Oval 36"/>
            <p:cNvSpPr/>
            <p:nvPr/>
          </p:nvSpPr>
          <p:spPr bwMode="auto">
            <a:xfrm>
              <a:off x="1684161" y="9446220"/>
              <a:ext cx="69843"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38" name="Oval 37"/>
            <p:cNvSpPr/>
            <p:nvPr/>
          </p:nvSpPr>
          <p:spPr bwMode="auto">
            <a:xfrm>
              <a:off x="1611143" y="9185830"/>
              <a:ext cx="73017"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39" name="Oval 38"/>
            <p:cNvSpPr/>
            <p:nvPr/>
          </p:nvSpPr>
          <p:spPr bwMode="auto">
            <a:xfrm>
              <a:off x="1695272" y="9175245"/>
              <a:ext cx="73017"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40" name="Oval 39"/>
            <p:cNvSpPr/>
            <p:nvPr/>
          </p:nvSpPr>
          <p:spPr bwMode="auto">
            <a:xfrm>
              <a:off x="2834977" y="9543601"/>
              <a:ext cx="71429" cy="95264"/>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41" name="Oval 40"/>
            <p:cNvSpPr/>
            <p:nvPr/>
          </p:nvSpPr>
          <p:spPr bwMode="auto">
            <a:xfrm>
              <a:off x="2912755" y="9611345"/>
              <a:ext cx="71430"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42" name="Oval 41"/>
            <p:cNvSpPr/>
            <p:nvPr/>
          </p:nvSpPr>
          <p:spPr bwMode="auto">
            <a:xfrm>
              <a:off x="3015932" y="9833628"/>
              <a:ext cx="71429"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43" name="Oval 42"/>
            <p:cNvSpPr/>
            <p:nvPr/>
          </p:nvSpPr>
          <p:spPr bwMode="auto">
            <a:xfrm>
              <a:off x="3015932" y="9931009"/>
              <a:ext cx="71429"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44" name="Oval 25"/>
            <p:cNvSpPr/>
            <p:nvPr/>
          </p:nvSpPr>
          <p:spPr bwMode="auto">
            <a:xfrm>
              <a:off x="3411178" y="9672737"/>
              <a:ext cx="71430" cy="95265"/>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45" name="Oval 26"/>
            <p:cNvSpPr/>
            <p:nvPr/>
          </p:nvSpPr>
          <p:spPr bwMode="auto">
            <a:xfrm>
              <a:off x="3219111" y="9638865"/>
              <a:ext cx="71429"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46" name="Oval 27"/>
            <p:cNvSpPr/>
            <p:nvPr/>
          </p:nvSpPr>
          <p:spPr bwMode="auto">
            <a:xfrm>
              <a:off x="2871485" y="9638865"/>
              <a:ext cx="71430"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47" name="Oval 28"/>
            <p:cNvSpPr/>
            <p:nvPr/>
          </p:nvSpPr>
          <p:spPr bwMode="auto">
            <a:xfrm>
              <a:off x="2798467" y="9380593"/>
              <a:ext cx="73017"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48" name="Oval 29"/>
            <p:cNvSpPr/>
            <p:nvPr/>
          </p:nvSpPr>
          <p:spPr bwMode="auto">
            <a:xfrm>
              <a:off x="2884183" y="9370008"/>
              <a:ext cx="71430" cy="95264"/>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49" name="Oval 48"/>
            <p:cNvSpPr/>
            <p:nvPr/>
          </p:nvSpPr>
          <p:spPr bwMode="auto">
            <a:xfrm>
              <a:off x="3915949" y="9899255"/>
              <a:ext cx="71430"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50" name="Oval 49"/>
            <p:cNvSpPr/>
            <p:nvPr/>
          </p:nvSpPr>
          <p:spPr bwMode="auto">
            <a:xfrm>
              <a:off x="3992141" y="9969115"/>
              <a:ext cx="71430" cy="95265"/>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51" name="Oval 50"/>
            <p:cNvSpPr/>
            <p:nvPr/>
          </p:nvSpPr>
          <p:spPr bwMode="auto">
            <a:xfrm>
              <a:off x="4095318" y="10191399"/>
              <a:ext cx="73017"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52" name="Oval 51"/>
            <p:cNvSpPr/>
            <p:nvPr/>
          </p:nvSpPr>
          <p:spPr bwMode="auto">
            <a:xfrm>
              <a:off x="4492151" y="10028391"/>
              <a:ext cx="71429"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53" name="Oval 52"/>
            <p:cNvSpPr/>
            <p:nvPr/>
          </p:nvSpPr>
          <p:spPr bwMode="auto">
            <a:xfrm>
              <a:off x="4300083" y="9996636"/>
              <a:ext cx="71430"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54" name="Oval 53"/>
            <p:cNvSpPr/>
            <p:nvPr/>
          </p:nvSpPr>
          <p:spPr bwMode="auto">
            <a:xfrm>
              <a:off x="3879441" y="9736246"/>
              <a:ext cx="71429"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55" name="Oval 54"/>
            <p:cNvSpPr/>
            <p:nvPr/>
          </p:nvSpPr>
          <p:spPr bwMode="auto">
            <a:xfrm>
              <a:off x="3965157" y="9725662"/>
              <a:ext cx="71429"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56" name="Oval 55"/>
            <p:cNvSpPr/>
            <p:nvPr/>
          </p:nvSpPr>
          <p:spPr bwMode="auto">
            <a:xfrm>
              <a:off x="5112797" y="10297249"/>
              <a:ext cx="71430" cy="95264"/>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57" name="Oval 56"/>
            <p:cNvSpPr/>
            <p:nvPr/>
          </p:nvSpPr>
          <p:spPr bwMode="auto">
            <a:xfrm>
              <a:off x="5688999" y="10426384"/>
              <a:ext cx="71429"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58" name="Oval 57"/>
            <p:cNvSpPr/>
            <p:nvPr/>
          </p:nvSpPr>
          <p:spPr bwMode="auto">
            <a:xfrm>
              <a:off x="5496932" y="10392512"/>
              <a:ext cx="71430"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59" name="Oval 58"/>
            <p:cNvSpPr/>
            <p:nvPr/>
          </p:nvSpPr>
          <p:spPr bwMode="auto">
            <a:xfrm>
              <a:off x="5076289" y="10134240"/>
              <a:ext cx="71429"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60" name="Oval 59"/>
            <p:cNvSpPr/>
            <p:nvPr/>
          </p:nvSpPr>
          <p:spPr bwMode="auto">
            <a:xfrm>
              <a:off x="5162005" y="10123656"/>
              <a:ext cx="71429" cy="95264"/>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61" name="Oval 60"/>
            <p:cNvSpPr/>
            <p:nvPr/>
          </p:nvSpPr>
          <p:spPr bwMode="auto">
            <a:xfrm>
              <a:off x="1773051" y="8927557"/>
              <a:ext cx="71430" cy="95265"/>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62" name="Oval 61"/>
            <p:cNvSpPr/>
            <p:nvPr/>
          </p:nvSpPr>
          <p:spPr bwMode="auto">
            <a:xfrm>
              <a:off x="1849243" y="8677753"/>
              <a:ext cx="71430" cy="97381"/>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63" name="Oval 62"/>
            <p:cNvSpPr/>
            <p:nvPr/>
          </p:nvSpPr>
          <p:spPr bwMode="auto">
            <a:xfrm>
              <a:off x="1927023" y="9249339"/>
              <a:ext cx="71429" cy="99499"/>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sp>
          <p:nvSpPr>
            <p:cNvPr id="64" name="Oval 63"/>
            <p:cNvSpPr/>
            <p:nvPr/>
          </p:nvSpPr>
          <p:spPr bwMode="auto">
            <a:xfrm>
              <a:off x="2223853" y="9249339"/>
              <a:ext cx="71430" cy="99499"/>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latin typeface="Arial" panose="020B0604020202020204" pitchFamily="34" charset="0"/>
                <a:cs typeface="Arial" panose="020B0604020202020204" pitchFamily="34" charset="0"/>
              </a:endParaRPr>
            </a:p>
          </p:txBody>
        </p:sp>
        <p:cxnSp>
          <p:nvCxnSpPr>
            <p:cNvPr id="65" name="Straight Connector 5"/>
            <p:cNvCxnSpPr/>
            <p:nvPr/>
          </p:nvCxnSpPr>
          <p:spPr>
            <a:xfrm rot="5400000">
              <a:off x="267232" y="11109378"/>
              <a:ext cx="1829077" cy="1587"/>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11406" name="TextBox 116"/>
            <p:cNvSpPr txBox="1">
              <a:spLocks noChangeArrowheads="1"/>
            </p:cNvSpPr>
            <p:nvPr/>
          </p:nvSpPr>
          <p:spPr bwMode="auto">
            <a:xfrm>
              <a:off x="40021" y="10868419"/>
              <a:ext cx="1193638" cy="697627"/>
            </a:xfrm>
            <a:prstGeom prst="rect">
              <a:avLst/>
            </a:prstGeom>
            <a:noFill/>
            <a:ln w="9525">
              <a:noFill/>
              <a:miter lim="800000"/>
              <a:headEnd/>
              <a:tailEnd/>
            </a:ln>
          </p:spPr>
          <p:txBody>
            <a:bodyPr>
              <a:spAutoFit/>
            </a:bodyPr>
            <a:lstStyle/>
            <a:p>
              <a:r>
                <a:rPr lang="en-US" sz="1400" b="1" dirty="0"/>
                <a:t>Drought stress</a:t>
              </a:r>
              <a:endParaRPr lang="en-IN" sz="1400" b="1" dirty="0"/>
            </a:p>
          </p:txBody>
        </p:sp>
        <p:sp>
          <p:nvSpPr>
            <p:cNvPr id="11407" name="TextBox 118"/>
            <p:cNvSpPr txBox="1">
              <a:spLocks noChangeArrowheads="1"/>
            </p:cNvSpPr>
            <p:nvPr/>
          </p:nvSpPr>
          <p:spPr bwMode="auto">
            <a:xfrm>
              <a:off x="19050" y="8788394"/>
              <a:ext cx="1248822" cy="697627"/>
            </a:xfrm>
            <a:prstGeom prst="rect">
              <a:avLst/>
            </a:prstGeom>
            <a:noFill/>
            <a:ln w="9525">
              <a:noFill/>
              <a:miter lim="800000"/>
              <a:headEnd/>
              <a:tailEnd/>
            </a:ln>
          </p:spPr>
          <p:txBody>
            <a:bodyPr>
              <a:spAutoFit/>
            </a:bodyPr>
            <a:lstStyle/>
            <a:p>
              <a:r>
                <a:rPr lang="en-US" sz="1400" b="1"/>
                <a:t>Pathogen stress</a:t>
              </a:r>
              <a:endParaRPr lang="en-IN" sz="1400" b="1"/>
            </a:p>
          </p:txBody>
        </p:sp>
        <p:cxnSp>
          <p:nvCxnSpPr>
            <p:cNvPr id="68" name="Straight Connector 7"/>
            <p:cNvCxnSpPr/>
            <p:nvPr/>
          </p:nvCxnSpPr>
          <p:spPr>
            <a:xfrm rot="5400000">
              <a:off x="271466" y="9008268"/>
              <a:ext cx="1826959" cy="1587"/>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11409" name="TextBox 68"/>
            <p:cNvSpPr txBox="1">
              <a:spLocks noChangeArrowheads="1"/>
            </p:cNvSpPr>
            <p:nvPr/>
          </p:nvSpPr>
          <p:spPr bwMode="auto">
            <a:xfrm>
              <a:off x="1509382" y="10899170"/>
              <a:ext cx="832191" cy="410426"/>
            </a:xfrm>
            <a:prstGeom prst="rect">
              <a:avLst/>
            </a:prstGeom>
            <a:noFill/>
            <a:ln w="9525">
              <a:noFill/>
              <a:miter lim="800000"/>
              <a:headEnd/>
              <a:tailEnd/>
            </a:ln>
          </p:spPr>
          <p:txBody>
            <a:bodyPr wrap="none">
              <a:spAutoFit/>
            </a:bodyPr>
            <a:lstStyle/>
            <a:p>
              <a:r>
                <a:rPr lang="en-US" sz="1400" b="1"/>
                <a:t>FC 80%</a:t>
              </a:r>
            </a:p>
          </p:txBody>
        </p:sp>
        <p:sp>
          <p:nvSpPr>
            <p:cNvPr id="11410" name="TextBox 69"/>
            <p:cNvSpPr txBox="1">
              <a:spLocks noChangeArrowheads="1"/>
            </p:cNvSpPr>
            <p:nvPr/>
          </p:nvSpPr>
          <p:spPr bwMode="auto">
            <a:xfrm>
              <a:off x="2582201" y="11292198"/>
              <a:ext cx="832191" cy="410426"/>
            </a:xfrm>
            <a:prstGeom prst="rect">
              <a:avLst/>
            </a:prstGeom>
            <a:noFill/>
            <a:ln w="9525">
              <a:noFill/>
              <a:miter lim="800000"/>
              <a:headEnd/>
              <a:tailEnd/>
            </a:ln>
          </p:spPr>
          <p:txBody>
            <a:bodyPr wrap="none">
              <a:spAutoFit/>
            </a:bodyPr>
            <a:lstStyle/>
            <a:p>
              <a:r>
                <a:rPr lang="en-US" sz="1400" b="1"/>
                <a:t>FC 60%</a:t>
              </a:r>
            </a:p>
          </p:txBody>
        </p:sp>
        <p:sp>
          <p:nvSpPr>
            <p:cNvPr id="11411" name="TextBox 70"/>
            <p:cNvSpPr txBox="1">
              <a:spLocks noChangeArrowheads="1"/>
            </p:cNvSpPr>
            <p:nvPr/>
          </p:nvSpPr>
          <p:spPr bwMode="auto">
            <a:xfrm>
              <a:off x="3740745" y="11599505"/>
              <a:ext cx="832191" cy="410426"/>
            </a:xfrm>
            <a:prstGeom prst="rect">
              <a:avLst/>
            </a:prstGeom>
            <a:noFill/>
            <a:ln w="9525">
              <a:noFill/>
              <a:miter lim="800000"/>
              <a:headEnd/>
              <a:tailEnd/>
            </a:ln>
          </p:spPr>
          <p:txBody>
            <a:bodyPr wrap="none">
              <a:spAutoFit/>
            </a:bodyPr>
            <a:lstStyle/>
            <a:p>
              <a:r>
                <a:rPr lang="en-US" sz="1400" b="1"/>
                <a:t>FC 40%</a:t>
              </a:r>
            </a:p>
          </p:txBody>
        </p:sp>
        <p:sp>
          <p:nvSpPr>
            <p:cNvPr id="11412" name="TextBox 71"/>
            <p:cNvSpPr txBox="1">
              <a:spLocks noChangeArrowheads="1"/>
            </p:cNvSpPr>
            <p:nvPr/>
          </p:nvSpPr>
          <p:spPr bwMode="auto">
            <a:xfrm>
              <a:off x="4921845" y="11866205"/>
              <a:ext cx="832191" cy="410426"/>
            </a:xfrm>
            <a:prstGeom prst="rect">
              <a:avLst/>
            </a:prstGeom>
            <a:noFill/>
            <a:ln w="9525">
              <a:noFill/>
              <a:miter lim="800000"/>
              <a:headEnd/>
              <a:tailEnd/>
            </a:ln>
          </p:spPr>
          <p:txBody>
            <a:bodyPr wrap="none">
              <a:spAutoFit/>
            </a:bodyPr>
            <a:lstStyle/>
            <a:p>
              <a:r>
                <a:rPr lang="en-US" sz="1400" b="1"/>
                <a:t>FC 20%</a:t>
              </a:r>
            </a:p>
          </p:txBody>
        </p:sp>
      </p:grpSp>
      <p:sp>
        <p:nvSpPr>
          <p:cNvPr id="11267" name="TextBox 20"/>
          <p:cNvSpPr txBox="1">
            <a:spLocks noChangeArrowheads="1"/>
          </p:cNvSpPr>
          <p:nvPr/>
        </p:nvSpPr>
        <p:spPr bwMode="auto">
          <a:xfrm>
            <a:off x="176213" y="395536"/>
            <a:ext cx="401637" cy="338138"/>
          </a:xfrm>
          <a:prstGeom prst="rect">
            <a:avLst/>
          </a:prstGeom>
          <a:noFill/>
          <a:ln w="9525">
            <a:noFill/>
            <a:miter lim="800000"/>
            <a:headEnd/>
            <a:tailEnd/>
          </a:ln>
        </p:spPr>
        <p:txBody>
          <a:bodyPr wrap="none">
            <a:spAutoFit/>
          </a:bodyPr>
          <a:lstStyle/>
          <a:p>
            <a:r>
              <a:rPr lang="en-US" sz="1600" b="1"/>
              <a:t>A)</a:t>
            </a:r>
            <a:endParaRPr lang="en-IN" sz="1600" b="1"/>
          </a:p>
        </p:txBody>
      </p:sp>
      <p:sp>
        <p:nvSpPr>
          <p:cNvPr id="11268" name="Rectangle 19"/>
          <p:cNvSpPr>
            <a:spLocks noChangeArrowheads="1"/>
          </p:cNvSpPr>
          <p:nvPr/>
        </p:nvSpPr>
        <p:spPr bwMode="auto">
          <a:xfrm>
            <a:off x="3857625" y="411411"/>
            <a:ext cx="1895071" cy="276999"/>
          </a:xfrm>
          <a:prstGeom prst="rect">
            <a:avLst/>
          </a:prstGeom>
          <a:noFill/>
          <a:ln w="9525">
            <a:noFill/>
            <a:miter lim="800000"/>
            <a:headEnd/>
            <a:tailEnd/>
          </a:ln>
        </p:spPr>
        <p:txBody>
          <a:bodyPr wrap="none">
            <a:spAutoFit/>
          </a:bodyPr>
          <a:lstStyle/>
          <a:p>
            <a:r>
              <a:rPr lang="en-US" sz="1200" b="1" dirty="0" smtClean="0"/>
              <a:t>Supplementary figure 8</a:t>
            </a:r>
            <a:endParaRPr lang="en-IN" sz="1200" b="1" dirty="0"/>
          </a:p>
        </p:txBody>
      </p:sp>
      <p:grpSp>
        <p:nvGrpSpPr>
          <p:cNvPr id="218" name="Group 217"/>
          <p:cNvGrpSpPr/>
          <p:nvPr/>
        </p:nvGrpSpPr>
        <p:grpSpPr>
          <a:xfrm>
            <a:off x="428604" y="4126155"/>
            <a:ext cx="6078537" cy="4594225"/>
            <a:chOff x="185738" y="3357563"/>
            <a:chExt cx="6078537" cy="4594225"/>
          </a:xfrm>
        </p:grpSpPr>
        <p:grpSp>
          <p:nvGrpSpPr>
            <p:cNvPr id="11269" name="Group 183"/>
            <p:cNvGrpSpPr>
              <a:grpSpLocks/>
            </p:cNvGrpSpPr>
            <p:nvPr/>
          </p:nvGrpSpPr>
          <p:grpSpPr bwMode="auto">
            <a:xfrm>
              <a:off x="185738" y="3357563"/>
              <a:ext cx="6078537" cy="4594225"/>
              <a:chOff x="185738" y="3940144"/>
              <a:chExt cx="6078537" cy="4594284"/>
            </a:xfrm>
          </p:grpSpPr>
          <p:grpSp>
            <p:nvGrpSpPr>
              <p:cNvPr id="11270" name="Group 137"/>
              <p:cNvGrpSpPr>
                <a:grpSpLocks/>
              </p:cNvGrpSpPr>
              <p:nvPr/>
            </p:nvGrpSpPr>
            <p:grpSpPr bwMode="auto">
              <a:xfrm>
                <a:off x="2051040" y="7042227"/>
                <a:ext cx="3214700" cy="1492201"/>
                <a:chOff x="4085672" y="3930707"/>
                <a:chExt cx="3670316" cy="2478236"/>
              </a:xfrm>
            </p:grpSpPr>
            <p:graphicFrame>
              <p:nvGraphicFramePr>
                <p:cNvPr id="140" name="Diagram 139"/>
                <p:cNvGraphicFramePr/>
                <p:nvPr/>
              </p:nvGraphicFramePr>
              <p:xfrm>
                <a:off x="4085672" y="3930707"/>
                <a:ext cx="3670316" cy="247823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pSp>
              <p:nvGrpSpPr>
                <p:cNvPr id="11343" name="Group 142"/>
                <p:cNvGrpSpPr>
                  <a:grpSpLocks/>
                </p:cNvGrpSpPr>
                <p:nvPr/>
              </p:nvGrpSpPr>
              <p:grpSpPr bwMode="auto">
                <a:xfrm>
                  <a:off x="4633603" y="4862672"/>
                  <a:ext cx="2536879" cy="696331"/>
                  <a:chOff x="4633603" y="4862672"/>
                  <a:chExt cx="2536879" cy="696331"/>
                </a:xfrm>
              </p:grpSpPr>
              <p:sp>
                <p:nvSpPr>
                  <p:cNvPr id="11344" name="TextBox 141"/>
                  <p:cNvSpPr txBox="1">
                    <a:spLocks noChangeArrowheads="1"/>
                  </p:cNvSpPr>
                  <p:nvPr/>
                </p:nvSpPr>
                <p:spPr bwMode="auto">
                  <a:xfrm>
                    <a:off x="5570212" y="4950813"/>
                    <a:ext cx="785495" cy="324955"/>
                  </a:xfrm>
                  <a:prstGeom prst="rect">
                    <a:avLst/>
                  </a:prstGeom>
                  <a:noFill/>
                  <a:ln w="9525">
                    <a:noFill/>
                    <a:miter lim="800000"/>
                    <a:headEnd/>
                    <a:tailEnd/>
                  </a:ln>
                </p:spPr>
                <p:txBody>
                  <a:bodyPr wrap="none">
                    <a:spAutoFit/>
                  </a:bodyPr>
                  <a:lstStyle/>
                  <a:p>
                    <a:r>
                      <a:rPr lang="en-US" sz="800" b="1"/>
                      <a:t>Endurance</a:t>
                    </a:r>
                  </a:p>
                </p:txBody>
              </p:sp>
              <p:sp>
                <p:nvSpPr>
                  <p:cNvPr id="11345" name="TextBox 142"/>
                  <p:cNvSpPr txBox="1">
                    <a:spLocks noChangeArrowheads="1"/>
                  </p:cNvSpPr>
                  <p:nvPr/>
                </p:nvSpPr>
                <p:spPr bwMode="auto">
                  <a:xfrm>
                    <a:off x="4633603" y="4862672"/>
                    <a:ext cx="824137" cy="696331"/>
                  </a:xfrm>
                  <a:prstGeom prst="rect">
                    <a:avLst/>
                  </a:prstGeom>
                  <a:noFill/>
                  <a:ln w="9525">
                    <a:noFill/>
                    <a:miter lim="800000"/>
                    <a:headEnd/>
                    <a:tailEnd/>
                  </a:ln>
                </p:spPr>
                <p:txBody>
                  <a:bodyPr wrap="none">
                    <a:spAutoFit/>
                  </a:bodyPr>
                  <a:lstStyle/>
                  <a:p>
                    <a:r>
                      <a:rPr lang="en-US" sz="800" b="1"/>
                      <a:t>Resistant</a:t>
                    </a:r>
                  </a:p>
                  <a:p>
                    <a:r>
                      <a:rPr lang="en-US" sz="800" b="1"/>
                      <a:t>(no disease</a:t>
                    </a:r>
                  </a:p>
                  <a:p>
                    <a:r>
                      <a:rPr lang="en-US" sz="800" b="1"/>
                      <a:t>Wilting)</a:t>
                    </a:r>
                  </a:p>
                </p:txBody>
              </p:sp>
              <p:sp>
                <p:nvSpPr>
                  <p:cNvPr id="11346" name="TextBox 143"/>
                  <p:cNvSpPr txBox="1">
                    <a:spLocks noChangeArrowheads="1"/>
                  </p:cNvSpPr>
                  <p:nvPr/>
                </p:nvSpPr>
                <p:spPr bwMode="auto">
                  <a:xfrm>
                    <a:off x="6233930" y="4881374"/>
                    <a:ext cx="936552" cy="510643"/>
                  </a:xfrm>
                  <a:prstGeom prst="rect">
                    <a:avLst/>
                  </a:prstGeom>
                  <a:noFill/>
                  <a:ln w="9525">
                    <a:noFill/>
                    <a:miter lim="800000"/>
                    <a:headEnd/>
                    <a:tailEnd/>
                  </a:ln>
                </p:spPr>
                <p:txBody>
                  <a:bodyPr wrap="none">
                    <a:spAutoFit/>
                  </a:bodyPr>
                  <a:lstStyle/>
                  <a:p>
                    <a:r>
                      <a:rPr lang="en-US" sz="800" b="1"/>
                      <a:t>Susceptibility</a:t>
                    </a:r>
                  </a:p>
                  <a:p>
                    <a:r>
                      <a:rPr lang="en-US" sz="800" b="1"/>
                      <a:t>(disease)</a:t>
                    </a:r>
                  </a:p>
                </p:txBody>
              </p:sp>
            </p:grpSp>
          </p:grpSp>
          <p:grpSp>
            <p:nvGrpSpPr>
              <p:cNvPr id="11271" name="Group 225"/>
              <p:cNvGrpSpPr>
                <a:grpSpLocks/>
              </p:cNvGrpSpPr>
              <p:nvPr/>
            </p:nvGrpSpPr>
            <p:grpSpPr bwMode="auto">
              <a:xfrm>
                <a:off x="185738" y="3940144"/>
                <a:ext cx="6078537" cy="3278229"/>
                <a:chOff x="185738" y="4448175"/>
                <a:chExt cx="6079307" cy="3278252"/>
              </a:xfrm>
            </p:grpSpPr>
            <p:sp>
              <p:nvSpPr>
                <p:cNvPr id="11274" name="TextBox 21"/>
                <p:cNvSpPr txBox="1">
                  <a:spLocks noChangeArrowheads="1"/>
                </p:cNvSpPr>
                <p:nvPr/>
              </p:nvSpPr>
              <p:spPr bwMode="auto">
                <a:xfrm>
                  <a:off x="185738" y="4448175"/>
                  <a:ext cx="400050" cy="338138"/>
                </a:xfrm>
                <a:prstGeom prst="rect">
                  <a:avLst/>
                </a:prstGeom>
                <a:noFill/>
                <a:ln w="9525">
                  <a:noFill/>
                  <a:miter lim="800000"/>
                  <a:headEnd/>
                  <a:tailEnd/>
                </a:ln>
              </p:spPr>
              <p:txBody>
                <a:bodyPr wrap="none">
                  <a:spAutoFit/>
                </a:bodyPr>
                <a:lstStyle/>
                <a:p>
                  <a:r>
                    <a:rPr lang="en-US" sz="1600" b="1"/>
                    <a:t>B)</a:t>
                  </a:r>
                  <a:endParaRPr lang="en-IN" sz="1600" b="1"/>
                </a:p>
              </p:txBody>
            </p:sp>
            <p:grpSp>
              <p:nvGrpSpPr>
                <p:cNvPr id="11275" name="Group 215"/>
                <p:cNvGrpSpPr>
                  <a:grpSpLocks/>
                </p:cNvGrpSpPr>
                <p:nvPr/>
              </p:nvGrpSpPr>
              <p:grpSpPr bwMode="auto">
                <a:xfrm>
                  <a:off x="214294" y="4592734"/>
                  <a:ext cx="6050751" cy="3133693"/>
                  <a:chOff x="214294" y="4592734"/>
                  <a:chExt cx="6050751" cy="3133693"/>
                </a:xfrm>
              </p:grpSpPr>
              <p:cxnSp>
                <p:nvCxnSpPr>
                  <p:cNvPr id="138" name="Straight Arrow Connector 137"/>
                  <p:cNvCxnSpPr/>
                  <p:nvPr/>
                </p:nvCxnSpPr>
                <p:spPr bwMode="auto">
                  <a:xfrm flipH="1">
                    <a:off x="3572304" y="7262868"/>
                    <a:ext cx="0" cy="35878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11281" name="Group 214"/>
                  <p:cNvGrpSpPr>
                    <a:grpSpLocks/>
                  </p:cNvGrpSpPr>
                  <p:nvPr/>
                </p:nvGrpSpPr>
                <p:grpSpPr bwMode="auto">
                  <a:xfrm>
                    <a:off x="214294" y="4592734"/>
                    <a:ext cx="6050751" cy="2726568"/>
                    <a:chOff x="214294" y="4592734"/>
                    <a:chExt cx="6050751" cy="2726568"/>
                  </a:xfrm>
                </p:grpSpPr>
                <p:sp>
                  <p:nvSpPr>
                    <p:cNvPr id="11284" name="TextBox 126"/>
                    <p:cNvSpPr txBox="1">
                      <a:spLocks noChangeArrowheads="1"/>
                    </p:cNvSpPr>
                    <p:nvPr/>
                  </p:nvSpPr>
                  <p:spPr bwMode="auto">
                    <a:xfrm>
                      <a:off x="214294" y="5508666"/>
                      <a:ext cx="1065976" cy="523223"/>
                    </a:xfrm>
                    <a:prstGeom prst="rect">
                      <a:avLst/>
                    </a:prstGeom>
                    <a:noFill/>
                    <a:ln w="9525">
                      <a:noFill/>
                      <a:miter lim="800000"/>
                      <a:headEnd/>
                      <a:tailEnd/>
                    </a:ln>
                  </p:spPr>
                  <p:txBody>
                    <a:bodyPr>
                      <a:spAutoFit/>
                    </a:bodyPr>
                    <a:lstStyle/>
                    <a:p>
                      <a:r>
                        <a:rPr lang="en-US" sz="1400" b="1"/>
                        <a:t>Molecular event</a:t>
                      </a:r>
                    </a:p>
                  </p:txBody>
                </p:sp>
                <p:sp>
                  <p:nvSpPr>
                    <p:cNvPr id="11285" name="TextBox 127"/>
                    <p:cNvSpPr txBox="1">
                      <a:spLocks noChangeArrowheads="1"/>
                    </p:cNvSpPr>
                    <p:nvPr/>
                  </p:nvSpPr>
                  <p:spPr bwMode="auto">
                    <a:xfrm>
                      <a:off x="241300" y="6553603"/>
                      <a:ext cx="882085" cy="307779"/>
                    </a:xfrm>
                    <a:prstGeom prst="rect">
                      <a:avLst/>
                    </a:prstGeom>
                    <a:noFill/>
                    <a:ln w="9525">
                      <a:noFill/>
                      <a:miter lim="800000"/>
                      <a:headEnd/>
                      <a:tailEnd/>
                    </a:ln>
                  </p:spPr>
                  <p:txBody>
                    <a:bodyPr wrap="none">
                      <a:spAutoFit/>
                    </a:bodyPr>
                    <a:lstStyle/>
                    <a:p>
                      <a:r>
                        <a:rPr lang="en-US" sz="1400" b="1"/>
                        <a:t>Process</a:t>
                      </a:r>
                    </a:p>
                  </p:txBody>
                </p:sp>
                <p:grpSp>
                  <p:nvGrpSpPr>
                    <p:cNvPr id="11286" name="Group 213"/>
                    <p:cNvGrpSpPr>
                      <a:grpSpLocks/>
                    </p:cNvGrpSpPr>
                    <p:nvPr/>
                  </p:nvGrpSpPr>
                  <p:grpSpPr bwMode="auto">
                    <a:xfrm>
                      <a:off x="1297129" y="4592734"/>
                      <a:ext cx="4967916" cy="2726568"/>
                      <a:chOff x="1297129" y="4592734"/>
                      <a:chExt cx="4967916" cy="2726568"/>
                    </a:xfrm>
                  </p:grpSpPr>
                  <p:sp>
                    <p:nvSpPr>
                      <p:cNvPr id="11287" name="TextBox 122"/>
                      <p:cNvSpPr txBox="1">
                        <a:spLocks noChangeArrowheads="1"/>
                      </p:cNvSpPr>
                      <p:nvPr/>
                    </p:nvSpPr>
                    <p:spPr bwMode="auto">
                      <a:xfrm>
                        <a:off x="2956651" y="4606127"/>
                        <a:ext cx="1755483" cy="307777"/>
                      </a:xfrm>
                      <a:prstGeom prst="rect">
                        <a:avLst/>
                      </a:prstGeom>
                      <a:noFill/>
                      <a:ln w="9525">
                        <a:noFill/>
                        <a:miter lim="800000"/>
                        <a:headEnd/>
                        <a:tailEnd/>
                      </a:ln>
                    </p:spPr>
                    <p:txBody>
                      <a:bodyPr>
                        <a:spAutoFit/>
                      </a:bodyPr>
                      <a:lstStyle/>
                      <a:p>
                        <a:pPr algn="ctr"/>
                        <a:r>
                          <a:rPr lang="en-US" sz="1400" b="1"/>
                          <a:t>Combined stress</a:t>
                        </a:r>
                      </a:p>
                    </p:txBody>
                  </p:sp>
                  <p:sp>
                    <p:nvSpPr>
                      <p:cNvPr id="11288" name="TextBox 123"/>
                      <p:cNvSpPr txBox="1">
                        <a:spLocks noChangeArrowheads="1"/>
                      </p:cNvSpPr>
                      <p:nvPr/>
                    </p:nvSpPr>
                    <p:spPr bwMode="auto">
                      <a:xfrm>
                        <a:off x="1335883" y="4592734"/>
                        <a:ext cx="1459914" cy="307777"/>
                      </a:xfrm>
                      <a:prstGeom prst="rect">
                        <a:avLst/>
                      </a:prstGeom>
                      <a:noFill/>
                      <a:ln w="9525">
                        <a:noFill/>
                        <a:miter lim="800000"/>
                        <a:headEnd/>
                        <a:tailEnd/>
                      </a:ln>
                    </p:spPr>
                    <p:txBody>
                      <a:bodyPr>
                        <a:spAutoFit/>
                      </a:bodyPr>
                      <a:lstStyle/>
                      <a:p>
                        <a:pPr algn="ctr"/>
                        <a:r>
                          <a:rPr lang="en-US" sz="1400" b="1"/>
                          <a:t>Drought stress</a:t>
                        </a:r>
                      </a:p>
                    </p:txBody>
                  </p:sp>
                  <p:sp>
                    <p:nvSpPr>
                      <p:cNvPr id="125" name="Rectangle 124"/>
                      <p:cNvSpPr/>
                      <p:nvPr/>
                    </p:nvSpPr>
                    <p:spPr bwMode="auto">
                      <a:xfrm>
                        <a:off x="1297129" y="5086363"/>
                        <a:ext cx="282611" cy="121287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latin typeface="Arial" panose="020B0604020202020204" pitchFamily="34" charset="0"/>
                          <a:cs typeface="Arial" panose="020B0604020202020204" pitchFamily="34" charset="0"/>
                        </a:endParaRPr>
                      </a:p>
                    </p:txBody>
                  </p:sp>
                  <p:sp>
                    <p:nvSpPr>
                      <p:cNvPr id="126" name="Rectangle 125"/>
                      <p:cNvSpPr/>
                      <p:nvPr/>
                    </p:nvSpPr>
                    <p:spPr bwMode="auto">
                      <a:xfrm>
                        <a:off x="1297129" y="6348450"/>
                        <a:ext cx="282611" cy="60485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latin typeface="Arial" panose="020B0604020202020204" pitchFamily="34" charset="0"/>
                          <a:cs typeface="Arial" panose="020B0604020202020204" pitchFamily="34" charset="0"/>
                        </a:endParaRPr>
                      </a:p>
                    </p:txBody>
                  </p:sp>
                  <p:sp>
                    <p:nvSpPr>
                      <p:cNvPr id="132" name="Rectangle 131"/>
                      <p:cNvSpPr/>
                      <p:nvPr/>
                    </p:nvSpPr>
                    <p:spPr bwMode="auto">
                      <a:xfrm>
                        <a:off x="1468601" y="4930785"/>
                        <a:ext cx="1217766" cy="5873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latin typeface="Arial" panose="020B0604020202020204" pitchFamily="34" charset="0"/>
                          <a:cs typeface="Arial" panose="020B0604020202020204" pitchFamily="34" charset="0"/>
                        </a:endParaRPr>
                      </a:p>
                    </p:txBody>
                  </p:sp>
                  <p:sp>
                    <p:nvSpPr>
                      <p:cNvPr id="133" name="Rectangle 132"/>
                      <p:cNvSpPr/>
                      <p:nvPr/>
                    </p:nvSpPr>
                    <p:spPr bwMode="auto">
                      <a:xfrm>
                        <a:off x="3215072" y="4938722"/>
                        <a:ext cx="1217766" cy="5873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latin typeface="Arial" panose="020B0604020202020204" pitchFamily="34" charset="0"/>
                          <a:cs typeface="Arial" panose="020B0604020202020204" pitchFamily="34" charset="0"/>
                        </a:endParaRPr>
                      </a:p>
                    </p:txBody>
                  </p:sp>
                  <p:sp>
                    <p:nvSpPr>
                      <p:cNvPr id="11293" name="TextBox 144"/>
                      <p:cNvSpPr txBox="1">
                        <a:spLocks noChangeArrowheads="1"/>
                      </p:cNvSpPr>
                      <p:nvPr/>
                    </p:nvSpPr>
                    <p:spPr bwMode="auto">
                      <a:xfrm>
                        <a:off x="4684569" y="4600892"/>
                        <a:ext cx="1580476" cy="307777"/>
                      </a:xfrm>
                      <a:prstGeom prst="rect">
                        <a:avLst/>
                      </a:prstGeom>
                      <a:noFill/>
                      <a:ln w="9525">
                        <a:noFill/>
                        <a:miter lim="800000"/>
                        <a:headEnd/>
                        <a:tailEnd/>
                      </a:ln>
                    </p:spPr>
                    <p:txBody>
                      <a:bodyPr>
                        <a:spAutoFit/>
                      </a:bodyPr>
                      <a:lstStyle/>
                      <a:p>
                        <a:pPr algn="ctr"/>
                        <a:r>
                          <a:rPr lang="en-US" sz="1400" b="1"/>
                          <a:t>Pathogen stress</a:t>
                        </a:r>
                      </a:p>
                    </p:txBody>
                  </p:sp>
                  <p:grpSp>
                    <p:nvGrpSpPr>
                      <p:cNvPr id="11294" name="Group 147"/>
                      <p:cNvGrpSpPr>
                        <a:grpSpLocks/>
                      </p:cNvGrpSpPr>
                      <p:nvPr/>
                    </p:nvGrpSpPr>
                    <p:grpSpPr bwMode="auto">
                      <a:xfrm>
                        <a:off x="4820238" y="4941897"/>
                        <a:ext cx="1290853" cy="2377405"/>
                        <a:chOff x="8365234" y="527931"/>
                        <a:chExt cx="1414237" cy="3585823"/>
                      </a:xfrm>
                    </p:grpSpPr>
                    <p:sp>
                      <p:nvSpPr>
                        <p:cNvPr id="11333" name="Rectangle 150"/>
                        <p:cNvSpPr>
                          <a:spLocks noChangeArrowheads="1"/>
                        </p:cNvSpPr>
                        <p:nvPr/>
                      </p:nvSpPr>
                      <p:spPr bwMode="auto">
                        <a:xfrm>
                          <a:off x="8844690" y="2484322"/>
                          <a:ext cx="934781" cy="464227"/>
                        </a:xfrm>
                        <a:prstGeom prst="rect">
                          <a:avLst/>
                        </a:prstGeom>
                        <a:solidFill>
                          <a:srgbClr val="FFFF00"/>
                        </a:solidFill>
                        <a:ln w="9525">
                          <a:noFill/>
                          <a:miter lim="800000"/>
                          <a:headEnd/>
                          <a:tailEnd/>
                        </a:ln>
                      </p:spPr>
                      <p:txBody>
                        <a:bodyPr wrap="none">
                          <a:spAutoFit/>
                        </a:bodyPr>
                        <a:lstStyle/>
                        <a:p>
                          <a:r>
                            <a:rPr lang="en-US" sz="1400" i="1"/>
                            <a:t>AtPR1/5</a:t>
                          </a:r>
                        </a:p>
                      </p:txBody>
                    </p:sp>
                    <p:sp>
                      <p:nvSpPr>
                        <p:cNvPr id="11334" name="TextBox 146"/>
                        <p:cNvSpPr txBox="1">
                          <a:spLocks noChangeArrowheads="1"/>
                        </p:cNvSpPr>
                        <p:nvPr/>
                      </p:nvSpPr>
                      <p:spPr bwMode="auto">
                        <a:xfrm>
                          <a:off x="8859237" y="702839"/>
                          <a:ext cx="465749" cy="464218"/>
                        </a:xfrm>
                        <a:prstGeom prst="rect">
                          <a:avLst/>
                        </a:prstGeom>
                        <a:solidFill>
                          <a:srgbClr val="92D050"/>
                        </a:solidFill>
                        <a:ln w="9525">
                          <a:noFill/>
                          <a:miter lim="800000"/>
                          <a:headEnd/>
                          <a:tailEnd/>
                        </a:ln>
                      </p:spPr>
                      <p:txBody>
                        <a:bodyPr wrap="none">
                          <a:spAutoFit/>
                        </a:bodyPr>
                        <a:lstStyle/>
                        <a:p>
                          <a:r>
                            <a:rPr lang="en-US" sz="1400"/>
                            <a:t>SA</a:t>
                          </a:r>
                        </a:p>
                      </p:txBody>
                    </p:sp>
                    <p:cxnSp>
                      <p:nvCxnSpPr>
                        <p:cNvPr id="148" name="Straight Arrow Connector 147"/>
                        <p:cNvCxnSpPr/>
                        <p:nvPr/>
                      </p:nvCxnSpPr>
                      <p:spPr>
                        <a:xfrm flipH="1">
                          <a:off x="9064495" y="1081053"/>
                          <a:ext cx="0" cy="54114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336" name="Rectangle 148"/>
                        <p:cNvSpPr>
                          <a:spLocks noChangeArrowheads="1"/>
                        </p:cNvSpPr>
                        <p:nvPr/>
                      </p:nvSpPr>
                      <p:spPr bwMode="auto">
                        <a:xfrm>
                          <a:off x="8806191" y="1553295"/>
                          <a:ext cx="913705" cy="464227"/>
                        </a:xfrm>
                        <a:prstGeom prst="rect">
                          <a:avLst/>
                        </a:prstGeom>
                        <a:noFill/>
                        <a:ln w="9525">
                          <a:noFill/>
                          <a:miter lim="800000"/>
                          <a:headEnd/>
                          <a:tailEnd/>
                        </a:ln>
                      </p:spPr>
                      <p:txBody>
                        <a:bodyPr wrap="none">
                          <a:spAutoFit/>
                        </a:bodyPr>
                        <a:lstStyle/>
                        <a:p>
                          <a:r>
                            <a:rPr lang="en-US" sz="1400" i="1"/>
                            <a:t>AtNPR1</a:t>
                          </a:r>
                        </a:p>
                      </p:txBody>
                    </p:sp>
                    <p:cxnSp>
                      <p:nvCxnSpPr>
                        <p:cNvPr id="150" name="Straight Arrow Connector 149"/>
                        <p:cNvCxnSpPr/>
                        <p:nvPr/>
                      </p:nvCxnSpPr>
                      <p:spPr>
                        <a:xfrm flipH="1">
                          <a:off x="9061017" y="1921508"/>
                          <a:ext cx="0" cy="54114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11338" name="Group 153"/>
                        <p:cNvGrpSpPr>
                          <a:grpSpLocks/>
                        </p:cNvGrpSpPr>
                        <p:nvPr/>
                      </p:nvGrpSpPr>
                      <p:grpSpPr bwMode="auto">
                        <a:xfrm>
                          <a:off x="8495010" y="2905632"/>
                          <a:ext cx="1199853" cy="1208122"/>
                          <a:chOff x="9310933" y="2905632"/>
                          <a:chExt cx="1199853" cy="1208122"/>
                        </a:xfrm>
                      </p:grpSpPr>
                      <p:sp>
                        <p:nvSpPr>
                          <p:cNvPr id="11340" name="TextBox 153"/>
                          <p:cNvSpPr txBox="1">
                            <a:spLocks noChangeArrowheads="1"/>
                          </p:cNvSpPr>
                          <p:nvPr/>
                        </p:nvSpPr>
                        <p:spPr bwMode="auto">
                          <a:xfrm>
                            <a:off x="9310933" y="3649536"/>
                            <a:ext cx="1199853" cy="464218"/>
                          </a:xfrm>
                          <a:prstGeom prst="rect">
                            <a:avLst/>
                          </a:prstGeom>
                          <a:noFill/>
                          <a:ln w="9525">
                            <a:noFill/>
                            <a:miter lim="800000"/>
                            <a:headEnd/>
                            <a:tailEnd/>
                          </a:ln>
                        </p:spPr>
                        <p:txBody>
                          <a:bodyPr wrap="none">
                            <a:spAutoFit/>
                          </a:bodyPr>
                          <a:lstStyle/>
                          <a:p>
                            <a:r>
                              <a:rPr lang="en-US" sz="1400"/>
                              <a:t>Cell death&gt;</a:t>
                            </a:r>
                          </a:p>
                        </p:txBody>
                      </p:sp>
                      <p:cxnSp>
                        <p:nvCxnSpPr>
                          <p:cNvPr id="155" name="Straight Arrow Connector 154"/>
                          <p:cNvCxnSpPr/>
                          <p:nvPr/>
                        </p:nvCxnSpPr>
                        <p:spPr>
                          <a:xfrm flipH="1">
                            <a:off x="9889116" y="2905632"/>
                            <a:ext cx="0" cy="27296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153" name="Rectangle 152"/>
                        <p:cNvSpPr/>
                        <p:nvPr/>
                      </p:nvSpPr>
                      <p:spPr>
                        <a:xfrm>
                          <a:off x="8365234" y="527931"/>
                          <a:ext cx="1334165" cy="8859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latin typeface="Arial" panose="020B0604020202020204" pitchFamily="34" charset="0"/>
                            <a:cs typeface="Arial" panose="020B0604020202020204" pitchFamily="34" charset="0"/>
                          </a:endParaRPr>
                        </a:p>
                      </p:txBody>
                    </p:sp>
                  </p:grpSp>
                  <p:grpSp>
                    <p:nvGrpSpPr>
                      <p:cNvPr id="11295" name="Group 189"/>
                      <p:cNvGrpSpPr>
                        <a:grpSpLocks/>
                      </p:cNvGrpSpPr>
                      <p:nvPr/>
                    </p:nvGrpSpPr>
                    <p:grpSpPr bwMode="auto">
                      <a:xfrm>
                        <a:off x="3112805" y="5092567"/>
                        <a:ext cx="2619219" cy="1976622"/>
                        <a:chOff x="3112805" y="5092567"/>
                        <a:chExt cx="2619219" cy="1976622"/>
                      </a:xfrm>
                    </p:grpSpPr>
                    <p:sp>
                      <p:nvSpPr>
                        <p:cNvPr id="11312" name="TextBox 211"/>
                        <p:cNvSpPr txBox="1">
                          <a:spLocks noChangeArrowheads="1"/>
                        </p:cNvSpPr>
                        <p:nvPr/>
                      </p:nvSpPr>
                      <p:spPr bwMode="auto">
                        <a:xfrm>
                          <a:off x="5213933" y="6643698"/>
                          <a:ext cx="518091" cy="276999"/>
                        </a:xfrm>
                        <a:prstGeom prst="rect">
                          <a:avLst/>
                        </a:prstGeom>
                        <a:noFill/>
                        <a:ln w="9525">
                          <a:noFill/>
                          <a:miter lim="800000"/>
                          <a:headEnd/>
                          <a:tailEnd/>
                        </a:ln>
                      </p:spPr>
                      <p:txBody>
                        <a:bodyPr wrap="none">
                          <a:spAutoFit/>
                        </a:bodyPr>
                        <a:lstStyle/>
                        <a:p>
                          <a:r>
                            <a:rPr lang="en-US" sz="1200"/>
                            <a:t>ROS</a:t>
                          </a:r>
                          <a:endParaRPr lang="en-IN" sz="1200"/>
                        </a:p>
                      </p:txBody>
                    </p:sp>
                    <p:grpSp>
                      <p:nvGrpSpPr>
                        <p:cNvPr id="11313" name="Group 132"/>
                        <p:cNvGrpSpPr>
                          <a:grpSpLocks/>
                        </p:cNvGrpSpPr>
                        <p:nvPr/>
                      </p:nvGrpSpPr>
                      <p:grpSpPr bwMode="auto">
                        <a:xfrm>
                          <a:off x="3112805" y="5092567"/>
                          <a:ext cx="2091166" cy="1363175"/>
                          <a:chOff x="5922092" y="801807"/>
                          <a:chExt cx="2291039" cy="2056068"/>
                        </a:xfrm>
                      </p:grpSpPr>
                      <p:sp>
                        <p:nvSpPr>
                          <p:cNvPr id="11320" name="Rectangle 156"/>
                          <p:cNvSpPr>
                            <a:spLocks noChangeArrowheads="1"/>
                          </p:cNvSpPr>
                          <p:nvPr/>
                        </p:nvSpPr>
                        <p:spPr bwMode="auto">
                          <a:xfrm>
                            <a:off x="7278353" y="1805128"/>
                            <a:ext cx="934778" cy="464227"/>
                          </a:xfrm>
                          <a:prstGeom prst="rect">
                            <a:avLst/>
                          </a:prstGeom>
                          <a:solidFill>
                            <a:srgbClr val="FFFF00"/>
                          </a:solidFill>
                          <a:ln w="9525">
                            <a:noFill/>
                            <a:miter lim="800000"/>
                            <a:headEnd/>
                            <a:tailEnd/>
                          </a:ln>
                        </p:spPr>
                        <p:txBody>
                          <a:bodyPr wrap="none">
                            <a:spAutoFit/>
                          </a:bodyPr>
                          <a:lstStyle/>
                          <a:p>
                            <a:r>
                              <a:rPr lang="en-US" sz="1400" i="1"/>
                              <a:t>AtPR1/5</a:t>
                            </a:r>
                          </a:p>
                        </p:txBody>
                      </p:sp>
                      <p:grpSp>
                        <p:nvGrpSpPr>
                          <p:cNvPr id="11321" name="Group 159"/>
                          <p:cNvGrpSpPr>
                            <a:grpSpLocks/>
                          </p:cNvGrpSpPr>
                          <p:nvPr/>
                        </p:nvGrpSpPr>
                        <p:grpSpPr bwMode="auto">
                          <a:xfrm>
                            <a:off x="5922092" y="801807"/>
                            <a:ext cx="1208385" cy="2056068"/>
                            <a:chOff x="5922092" y="801807"/>
                            <a:chExt cx="1208385" cy="2056068"/>
                          </a:xfrm>
                        </p:grpSpPr>
                        <p:grpSp>
                          <p:nvGrpSpPr>
                            <p:cNvPr id="11323" name="Group 161"/>
                            <p:cNvGrpSpPr>
                              <a:grpSpLocks/>
                            </p:cNvGrpSpPr>
                            <p:nvPr/>
                          </p:nvGrpSpPr>
                          <p:grpSpPr bwMode="auto">
                            <a:xfrm>
                              <a:off x="5922092" y="1185140"/>
                              <a:ext cx="1208385" cy="1672735"/>
                              <a:chOff x="5922092" y="1185140"/>
                              <a:chExt cx="1208385" cy="1672735"/>
                            </a:xfrm>
                          </p:grpSpPr>
                          <p:sp>
                            <p:nvSpPr>
                              <p:cNvPr id="11325" name="Rectangle 162"/>
                              <p:cNvSpPr>
                                <a:spLocks noChangeArrowheads="1"/>
                              </p:cNvSpPr>
                              <p:nvPr/>
                            </p:nvSpPr>
                            <p:spPr bwMode="auto">
                              <a:xfrm>
                                <a:off x="5922092" y="1809652"/>
                                <a:ext cx="804801" cy="464227"/>
                              </a:xfrm>
                              <a:prstGeom prst="rect">
                                <a:avLst/>
                              </a:prstGeom>
                              <a:noFill/>
                              <a:ln w="9525">
                                <a:noFill/>
                                <a:miter lim="800000"/>
                                <a:headEnd/>
                                <a:tailEnd/>
                              </a:ln>
                            </p:spPr>
                            <p:txBody>
                              <a:bodyPr wrap="none">
                                <a:spAutoFit/>
                              </a:bodyPr>
                              <a:lstStyle/>
                              <a:p>
                                <a:r>
                                  <a:rPr lang="en-US" sz="1400" i="1" dirty="0" err="1" smtClean="0"/>
                                  <a:t>AtNAC</a:t>
                                </a:r>
                                <a:endParaRPr lang="en-US" sz="1400" i="1" dirty="0"/>
                              </a:p>
                            </p:txBody>
                          </p:sp>
                          <p:grpSp>
                            <p:nvGrpSpPr>
                              <p:cNvPr id="11326" name="Group 163"/>
                              <p:cNvGrpSpPr>
                                <a:grpSpLocks/>
                              </p:cNvGrpSpPr>
                              <p:nvPr/>
                            </p:nvGrpSpPr>
                            <p:grpSpPr bwMode="auto">
                              <a:xfrm>
                                <a:off x="6027741" y="1185140"/>
                                <a:ext cx="597466" cy="1218782"/>
                                <a:chOff x="2651493" y="1283619"/>
                                <a:chExt cx="597466" cy="1218782"/>
                              </a:xfrm>
                            </p:grpSpPr>
                            <p:sp>
                              <p:nvSpPr>
                                <p:cNvPr id="11328" name="TextBox 165"/>
                                <p:cNvSpPr txBox="1">
                                  <a:spLocks noChangeArrowheads="1"/>
                                </p:cNvSpPr>
                                <p:nvPr/>
                              </p:nvSpPr>
                              <p:spPr bwMode="auto">
                                <a:xfrm>
                                  <a:off x="2651493" y="1436897"/>
                                  <a:ext cx="597466" cy="464218"/>
                                </a:xfrm>
                                <a:prstGeom prst="rect">
                                  <a:avLst/>
                                </a:prstGeom>
                                <a:solidFill>
                                  <a:srgbClr val="92D050"/>
                                </a:solidFill>
                                <a:ln w="9525">
                                  <a:noFill/>
                                  <a:miter lim="800000"/>
                                  <a:headEnd/>
                                  <a:tailEnd/>
                                </a:ln>
                              </p:spPr>
                              <p:txBody>
                                <a:bodyPr wrap="none">
                                  <a:spAutoFit/>
                                </a:bodyPr>
                                <a:lstStyle/>
                                <a:p>
                                  <a:r>
                                    <a:rPr lang="en-US" sz="1400"/>
                                    <a:t>ABA</a:t>
                                  </a:r>
                                </a:p>
                              </p:txBody>
                            </p:sp>
                            <p:cxnSp>
                              <p:nvCxnSpPr>
                                <p:cNvPr id="167" name="Straight Arrow Connector 166"/>
                                <p:cNvCxnSpPr/>
                                <p:nvPr/>
                              </p:nvCxnSpPr>
                              <p:spPr>
                                <a:xfrm flipH="1">
                                  <a:off x="2965768" y="1283619"/>
                                  <a:ext cx="0" cy="18197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8" name="Straight Arrow Connector 167"/>
                                <p:cNvCxnSpPr/>
                                <p:nvPr/>
                              </p:nvCxnSpPr>
                              <p:spPr>
                                <a:xfrm flipH="1">
                                  <a:off x="2991861" y="2330000"/>
                                  <a:ext cx="0" cy="17240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11327" name="TextBox 163"/>
                              <p:cNvSpPr txBox="1">
                                <a:spLocks noChangeArrowheads="1"/>
                              </p:cNvSpPr>
                              <p:nvPr/>
                            </p:nvSpPr>
                            <p:spPr bwMode="auto">
                              <a:xfrm>
                                <a:off x="5953311" y="2393648"/>
                                <a:ext cx="1177166" cy="464227"/>
                              </a:xfrm>
                              <a:prstGeom prst="rect">
                                <a:avLst/>
                              </a:prstGeom>
                              <a:solidFill>
                                <a:srgbClr val="FFFF00"/>
                              </a:solidFill>
                              <a:ln w="9525">
                                <a:noFill/>
                                <a:miter lim="800000"/>
                                <a:headEnd/>
                                <a:tailEnd/>
                              </a:ln>
                            </p:spPr>
                            <p:txBody>
                              <a:bodyPr wrap="none">
                                <a:spAutoFit/>
                              </a:bodyPr>
                              <a:lstStyle/>
                              <a:p>
                                <a:r>
                                  <a:rPr lang="en-US" sz="1400" i="1" dirty="0"/>
                                  <a:t>AtDREB1A</a:t>
                                </a:r>
                              </a:p>
                            </p:txBody>
                          </p:sp>
                        </p:grpSp>
                        <p:sp>
                          <p:nvSpPr>
                            <p:cNvPr id="11324" name="TextBox 160"/>
                            <p:cNvSpPr txBox="1">
                              <a:spLocks noChangeArrowheads="1"/>
                            </p:cNvSpPr>
                            <p:nvPr/>
                          </p:nvSpPr>
                          <p:spPr bwMode="auto">
                            <a:xfrm>
                              <a:off x="5953312" y="801807"/>
                              <a:ext cx="1055971" cy="464227"/>
                            </a:xfrm>
                            <a:prstGeom prst="rect">
                              <a:avLst/>
                            </a:prstGeom>
                            <a:solidFill>
                              <a:srgbClr val="FFFF00"/>
                            </a:solidFill>
                            <a:ln w="9525">
                              <a:noFill/>
                              <a:miter lim="800000"/>
                              <a:headEnd/>
                              <a:tailEnd/>
                            </a:ln>
                          </p:spPr>
                          <p:txBody>
                            <a:bodyPr wrap="none">
                              <a:spAutoFit/>
                            </a:bodyPr>
                            <a:lstStyle/>
                            <a:p>
                              <a:r>
                                <a:rPr lang="en-US" sz="1400" i="1"/>
                                <a:t>AtNCED3</a:t>
                              </a:r>
                            </a:p>
                          </p:txBody>
                        </p:sp>
                      </p:grpSp>
                    </p:grpSp>
                    <p:cxnSp>
                      <p:nvCxnSpPr>
                        <p:cNvPr id="135" name="Straight Arrow Connector 134"/>
                        <p:cNvCxnSpPr/>
                        <p:nvPr/>
                      </p:nvCxnSpPr>
                      <p:spPr bwMode="auto">
                        <a:xfrm flipH="1">
                          <a:off x="3559602" y="6475452"/>
                          <a:ext cx="0" cy="18097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315" name="TextBox 186"/>
                        <p:cNvSpPr txBox="1">
                          <a:spLocks noChangeArrowheads="1"/>
                        </p:cNvSpPr>
                        <p:nvPr/>
                      </p:nvSpPr>
                      <p:spPr bwMode="auto">
                        <a:xfrm>
                          <a:off x="3253466" y="6643702"/>
                          <a:ext cx="518091" cy="276999"/>
                        </a:xfrm>
                        <a:prstGeom prst="rect">
                          <a:avLst/>
                        </a:prstGeom>
                        <a:noFill/>
                        <a:ln w="9525">
                          <a:noFill/>
                          <a:miter lim="800000"/>
                          <a:headEnd/>
                          <a:tailEnd/>
                        </a:ln>
                      </p:spPr>
                      <p:txBody>
                        <a:bodyPr wrap="none">
                          <a:spAutoFit/>
                        </a:bodyPr>
                        <a:lstStyle/>
                        <a:p>
                          <a:r>
                            <a:rPr lang="en-US" sz="1200"/>
                            <a:t>ROS</a:t>
                          </a:r>
                          <a:endParaRPr lang="en-IN" sz="1200"/>
                        </a:p>
                      </p:txBody>
                    </p:sp>
                    <p:cxnSp>
                      <p:nvCxnSpPr>
                        <p:cNvPr id="188" name="Straight Arrow Connector 187"/>
                        <p:cNvCxnSpPr/>
                        <p:nvPr/>
                      </p:nvCxnSpPr>
                      <p:spPr bwMode="auto">
                        <a:xfrm flipH="1">
                          <a:off x="3561190" y="6883448"/>
                          <a:ext cx="0" cy="18097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9" name="Straight Arrow Connector 188"/>
                        <p:cNvCxnSpPr/>
                        <p:nvPr/>
                      </p:nvCxnSpPr>
                      <p:spPr bwMode="auto">
                        <a:xfrm flipH="1">
                          <a:off x="3510384" y="5654699"/>
                          <a:ext cx="0" cy="12065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3" name="Straight Arrow Connector 212"/>
                        <p:cNvCxnSpPr/>
                        <p:nvPr/>
                      </p:nvCxnSpPr>
                      <p:spPr bwMode="auto">
                        <a:xfrm flipH="1">
                          <a:off x="5455317" y="6888210"/>
                          <a:ext cx="0" cy="18097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11296" name="Group 190"/>
                      <p:cNvGrpSpPr>
                        <a:grpSpLocks/>
                      </p:cNvGrpSpPr>
                      <p:nvPr/>
                    </p:nvGrpSpPr>
                    <p:grpSpPr bwMode="auto">
                      <a:xfrm>
                        <a:off x="1610387" y="5089071"/>
                        <a:ext cx="1343637" cy="2194069"/>
                        <a:chOff x="3075584" y="5092564"/>
                        <a:chExt cx="1343637" cy="2194069"/>
                      </a:xfrm>
                    </p:grpSpPr>
                    <p:grpSp>
                      <p:nvGrpSpPr>
                        <p:cNvPr id="11297" name="Group 132"/>
                        <p:cNvGrpSpPr>
                          <a:grpSpLocks/>
                        </p:cNvGrpSpPr>
                        <p:nvPr/>
                      </p:nvGrpSpPr>
                      <p:grpSpPr bwMode="auto">
                        <a:xfrm>
                          <a:off x="3075584" y="5092564"/>
                          <a:ext cx="1343637" cy="2194069"/>
                          <a:chOff x="5881320" y="801807"/>
                          <a:chExt cx="1472063" cy="3309311"/>
                        </a:xfrm>
                      </p:grpSpPr>
                      <p:grpSp>
                        <p:nvGrpSpPr>
                          <p:cNvPr id="11302" name="Group 159"/>
                          <p:cNvGrpSpPr>
                            <a:grpSpLocks/>
                          </p:cNvGrpSpPr>
                          <p:nvPr/>
                        </p:nvGrpSpPr>
                        <p:grpSpPr bwMode="auto">
                          <a:xfrm>
                            <a:off x="5953313" y="801807"/>
                            <a:ext cx="1177168" cy="2056071"/>
                            <a:chOff x="5953313" y="801807"/>
                            <a:chExt cx="1177168" cy="2056071"/>
                          </a:xfrm>
                        </p:grpSpPr>
                        <p:grpSp>
                          <p:nvGrpSpPr>
                            <p:cNvPr id="11304" name="Group 161"/>
                            <p:cNvGrpSpPr>
                              <a:grpSpLocks/>
                            </p:cNvGrpSpPr>
                            <p:nvPr/>
                          </p:nvGrpSpPr>
                          <p:grpSpPr bwMode="auto">
                            <a:xfrm>
                              <a:off x="5953313" y="1199993"/>
                              <a:ext cx="1177168" cy="1657885"/>
                              <a:chOff x="5953313" y="1199993"/>
                              <a:chExt cx="1177168" cy="1657885"/>
                            </a:xfrm>
                          </p:grpSpPr>
                          <p:sp>
                            <p:nvSpPr>
                              <p:cNvPr id="11306" name="Rectangle 162"/>
                              <p:cNvSpPr>
                                <a:spLocks noChangeArrowheads="1"/>
                              </p:cNvSpPr>
                              <p:nvPr/>
                            </p:nvSpPr>
                            <p:spPr bwMode="auto">
                              <a:xfrm>
                                <a:off x="6013936" y="1809653"/>
                                <a:ext cx="804802" cy="464229"/>
                              </a:xfrm>
                              <a:prstGeom prst="rect">
                                <a:avLst/>
                              </a:prstGeom>
                              <a:noFill/>
                              <a:ln w="9525">
                                <a:noFill/>
                                <a:miter lim="800000"/>
                                <a:headEnd/>
                                <a:tailEnd/>
                              </a:ln>
                            </p:spPr>
                            <p:txBody>
                              <a:bodyPr wrap="none">
                                <a:spAutoFit/>
                              </a:bodyPr>
                              <a:lstStyle/>
                              <a:p>
                                <a:r>
                                  <a:rPr lang="en-US" sz="1400" i="1" dirty="0" err="1" smtClean="0"/>
                                  <a:t>AtNAC</a:t>
                                </a:r>
                                <a:endParaRPr lang="en-US" sz="1400" i="1" dirty="0"/>
                              </a:p>
                            </p:txBody>
                          </p:sp>
                          <p:grpSp>
                            <p:nvGrpSpPr>
                              <p:cNvPr id="11307" name="Group 163"/>
                              <p:cNvGrpSpPr>
                                <a:grpSpLocks/>
                              </p:cNvGrpSpPr>
                              <p:nvPr/>
                            </p:nvGrpSpPr>
                            <p:grpSpPr bwMode="auto">
                              <a:xfrm>
                                <a:off x="6027741" y="1199993"/>
                                <a:ext cx="597466" cy="1218785"/>
                                <a:chOff x="2651493" y="1298472"/>
                                <a:chExt cx="597466" cy="1218785"/>
                              </a:xfrm>
                            </p:grpSpPr>
                            <p:sp>
                              <p:nvSpPr>
                                <p:cNvPr id="11309" name="TextBox 165"/>
                                <p:cNvSpPr txBox="1">
                                  <a:spLocks noChangeArrowheads="1"/>
                                </p:cNvSpPr>
                                <p:nvPr/>
                              </p:nvSpPr>
                              <p:spPr bwMode="auto">
                                <a:xfrm>
                                  <a:off x="2651493" y="1436897"/>
                                  <a:ext cx="597466" cy="464218"/>
                                </a:xfrm>
                                <a:prstGeom prst="rect">
                                  <a:avLst/>
                                </a:prstGeom>
                                <a:solidFill>
                                  <a:srgbClr val="92D050"/>
                                </a:solidFill>
                                <a:ln w="9525">
                                  <a:noFill/>
                                  <a:miter lim="800000"/>
                                  <a:headEnd/>
                                  <a:tailEnd/>
                                </a:ln>
                              </p:spPr>
                              <p:txBody>
                                <a:bodyPr wrap="none">
                                  <a:spAutoFit/>
                                </a:bodyPr>
                                <a:lstStyle/>
                                <a:p>
                                  <a:r>
                                    <a:rPr lang="en-US" sz="1400"/>
                                    <a:t>ABA</a:t>
                                  </a:r>
                                </a:p>
                              </p:txBody>
                            </p:sp>
                            <p:cxnSp>
                              <p:nvCxnSpPr>
                                <p:cNvPr id="207" name="Straight Arrow Connector 206"/>
                                <p:cNvCxnSpPr/>
                                <p:nvPr/>
                              </p:nvCxnSpPr>
                              <p:spPr>
                                <a:xfrm flipH="1">
                                  <a:off x="2970719" y="1298472"/>
                                  <a:ext cx="0" cy="17000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8" name="Straight Arrow Connector 207"/>
                                <p:cNvCxnSpPr/>
                                <p:nvPr/>
                              </p:nvCxnSpPr>
                              <p:spPr>
                                <a:xfrm flipH="1">
                                  <a:off x="2996811" y="2335277"/>
                                  <a:ext cx="0" cy="18198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11308" name="TextBox 163"/>
                              <p:cNvSpPr txBox="1">
                                <a:spLocks noChangeArrowheads="1"/>
                              </p:cNvSpPr>
                              <p:nvPr/>
                            </p:nvSpPr>
                            <p:spPr bwMode="auto">
                              <a:xfrm>
                                <a:off x="5953313" y="2393649"/>
                                <a:ext cx="1177168" cy="464229"/>
                              </a:xfrm>
                              <a:prstGeom prst="rect">
                                <a:avLst/>
                              </a:prstGeom>
                              <a:solidFill>
                                <a:srgbClr val="FFFF00"/>
                              </a:solidFill>
                              <a:ln w="9525">
                                <a:noFill/>
                                <a:miter lim="800000"/>
                                <a:headEnd/>
                                <a:tailEnd/>
                              </a:ln>
                            </p:spPr>
                            <p:txBody>
                              <a:bodyPr wrap="none">
                                <a:spAutoFit/>
                              </a:bodyPr>
                              <a:lstStyle/>
                              <a:p>
                                <a:r>
                                  <a:rPr lang="en-US" sz="1400" i="1"/>
                                  <a:t>AtDREB1A</a:t>
                                </a:r>
                              </a:p>
                            </p:txBody>
                          </p:sp>
                        </p:grpSp>
                        <p:sp>
                          <p:nvSpPr>
                            <p:cNvPr id="11305" name="TextBox 160"/>
                            <p:cNvSpPr txBox="1">
                              <a:spLocks noChangeArrowheads="1"/>
                            </p:cNvSpPr>
                            <p:nvPr/>
                          </p:nvSpPr>
                          <p:spPr bwMode="auto">
                            <a:xfrm>
                              <a:off x="5953313" y="801807"/>
                              <a:ext cx="1055972" cy="464229"/>
                            </a:xfrm>
                            <a:prstGeom prst="rect">
                              <a:avLst/>
                            </a:prstGeom>
                            <a:solidFill>
                              <a:srgbClr val="FFFF00"/>
                            </a:solidFill>
                            <a:ln w="9525">
                              <a:noFill/>
                              <a:miter lim="800000"/>
                              <a:headEnd/>
                              <a:tailEnd/>
                            </a:ln>
                          </p:spPr>
                          <p:txBody>
                            <a:bodyPr wrap="none">
                              <a:spAutoFit/>
                            </a:bodyPr>
                            <a:lstStyle/>
                            <a:p>
                              <a:r>
                                <a:rPr lang="en-US" sz="1400" i="1"/>
                                <a:t>AtNCED3</a:t>
                              </a:r>
                            </a:p>
                          </p:txBody>
                        </p:sp>
                      </p:grpSp>
                      <p:sp>
                        <p:nvSpPr>
                          <p:cNvPr id="11303" name="TextBox 158"/>
                          <p:cNvSpPr txBox="1">
                            <a:spLocks noChangeArrowheads="1"/>
                          </p:cNvSpPr>
                          <p:nvPr/>
                        </p:nvSpPr>
                        <p:spPr bwMode="auto">
                          <a:xfrm>
                            <a:off x="5881320" y="3646900"/>
                            <a:ext cx="1472063" cy="464218"/>
                          </a:xfrm>
                          <a:prstGeom prst="rect">
                            <a:avLst/>
                          </a:prstGeom>
                          <a:noFill/>
                          <a:ln w="9525">
                            <a:noFill/>
                            <a:miter lim="800000"/>
                            <a:headEnd/>
                            <a:tailEnd/>
                          </a:ln>
                        </p:spPr>
                        <p:txBody>
                          <a:bodyPr wrap="none">
                            <a:spAutoFit/>
                          </a:bodyPr>
                          <a:lstStyle/>
                          <a:p>
                            <a:r>
                              <a:rPr lang="en-US" sz="1400"/>
                              <a:t>Cell death=d,p</a:t>
                            </a:r>
                          </a:p>
                        </p:txBody>
                      </p:sp>
                    </p:grpSp>
                    <p:cxnSp>
                      <p:nvCxnSpPr>
                        <p:cNvPr id="193" name="Straight Arrow Connector 192"/>
                        <p:cNvCxnSpPr/>
                        <p:nvPr/>
                      </p:nvCxnSpPr>
                      <p:spPr bwMode="auto">
                        <a:xfrm flipH="1">
                          <a:off x="3559352" y="6483708"/>
                          <a:ext cx="0" cy="18097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299" name="TextBox 193"/>
                        <p:cNvSpPr txBox="1">
                          <a:spLocks noChangeArrowheads="1"/>
                        </p:cNvSpPr>
                        <p:nvPr/>
                      </p:nvSpPr>
                      <p:spPr bwMode="auto">
                        <a:xfrm>
                          <a:off x="3253466" y="6643702"/>
                          <a:ext cx="518091" cy="276999"/>
                        </a:xfrm>
                        <a:prstGeom prst="rect">
                          <a:avLst/>
                        </a:prstGeom>
                        <a:noFill/>
                        <a:ln w="9525">
                          <a:noFill/>
                          <a:miter lim="800000"/>
                          <a:headEnd/>
                          <a:tailEnd/>
                        </a:ln>
                      </p:spPr>
                      <p:txBody>
                        <a:bodyPr wrap="none">
                          <a:spAutoFit/>
                        </a:bodyPr>
                        <a:lstStyle/>
                        <a:p>
                          <a:r>
                            <a:rPr lang="en-US" sz="1200"/>
                            <a:t>ROS</a:t>
                          </a:r>
                          <a:endParaRPr lang="en-IN" sz="1200"/>
                        </a:p>
                      </p:txBody>
                    </p:sp>
                    <p:cxnSp>
                      <p:nvCxnSpPr>
                        <p:cNvPr id="195" name="Straight Arrow Connector 194"/>
                        <p:cNvCxnSpPr/>
                        <p:nvPr/>
                      </p:nvCxnSpPr>
                      <p:spPr bwMode="auto">
                        <a:xfrm flipH="1">
                          <a:off x="3560939" y="6883766"/>
                          <a:ext cx="0" cy="18097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6" name="Straight Arrow Connector 195"/>
                        <p:cNvCxnSpPr/>
                        <p:nvPr/>
                      </p:nvCxnSpPr>
                      <p:spPr bwMode="auto">
                        <a:xfrm flipH="1">
                          <a:off x="3511721" y="5655017"/>
                          <a:ext cx="0" cy="12065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grpSp>
              <p:cxnSp>
                <p:nvCxnSpPr>
                  <p:cNvPr id="211" name="Straight Arrow Connector 210"/>
                  <p:cNvCxnSpPr/>
                  <p:nvPr/>
                </p:nvCxnSpPr>
                <p:spPr bwMode="auto">
                  <a:xfrm rot="10800000" flipV="1">
                    <a:off x="4501110" y="7223180"/>
                    <a:ext cx="714465" cy="50324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2" name="Straight Arrow Connector 181"/>
                  <p:cNvCxnSpPr/>
                  <p:nvPr/>
                </p:nvCxnSpPr>
                <p:spPr bwMode="auto">
                  <a:xfrm>
                    <a:off x="2071927" y="7223180"/>
                    <a:ext cx="760508" cy="50007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sp>
            <p:nvSpPr>
              <p:cNvPr id="179" name="Rectangle 178"/>
              <p:cNvSpPr/>
              <p:nvPr/>
            </p:nvSpPr>
            <p:spPr bwMode="auto">
              <a:xfrm>
                <a:off x="1298575" y="6497639"/>
                <a:ext cx="282575" cy="36036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latin typeface="Arial" panose="020B0604020202020204" pitchFamily="34" charset="0"/>
                  <a:cs typeface="Arial" panose="020B0604020202020204" pitchFamily="34" charset="0"/>
                </a:endParaRPr>
              </a:p>
            </p:txBody>
          </p:sp>
          <p:sp>
            <p:nvSpPr>
              <p:cNvPr id="11273" name="TextBox 127"/>
              <p:cNvSpPr txBox="1">
                <a:spLocks noChangeArrowheads="1"/>
              </p:cNvSpPr>
              <p:nvPr/>
            </p:nvSpPr>
            <p:spPr bwMode="auto">
              <a:xfrm>
                <a:off x="239690" y="6550239"/>
                <a:ext cx="681597" cy="307777"/>
              </a:xfrm>
              <a:prstGeom prst="rect">
                <a:avLst/>
              </a:prstGeom>
              <a:noFill/>
              <a:ln w="9525">
                <a:noFill/>
                <a:miter lim="800000"/>
                <a:headEnd/>
                <a:tailEnd/>
              </a:ln>
            </p:spPr>
            <p:txBody>
              <a:bodyPr wrap="none">
                <a:spAutoFit/>
              </a:bodyPr>
              <a:lstStyle/>
              <a:p>
                <a:r>
                  <a:rPr lang="en-US" sz="1400" b="1"/>
                  <a:t>Effect</a:t>
                </a:r>
              </a:p>
            </p:txBody>
          </p:sp>
        </p:grpSp>
        <p:grpSp>
          <p:nvGrpSpPr>
            <p:cNvPr id="184" name="Group 183"/>
            <p:cNvGrpSpPr/>
            <p:nvPr/>
          </p:nvGrpSpPr>
          <p:grpSpPr>
            <a:xfrm>
              <a:off x="3643314" y="5357818"/>
              <a:ext cx="581028" cy="142876"/>
              <a:chOff x="285728" y="4857752"/>
              <a:chExt cx="581028" cy="142876"/>
            </a:xfrm>
          </p:grpSpPr>
          <p:pic>
            <p:nvPicPr>
              <p:cNvPr id="1026" name="Picture 2"/>
              <p:cNvPicPr>
                <a:picLocks noChangeAspect="1" noChangeArrowheads="1"/>
              </p:cNvPicPr>
              <p:nvPr/>
            </p:nvPicPr>
            <p:blipFill>
              <a:blip r:embed="rId8"/>
              <a:srcRect l="24998" t="72001" r="62502" b="15999"/>
              <a:stretch>
                <a:fillRect/>
              </a:stretch>
            </p:blipFill>
            <p:spPr bwMode="auto">
              <a:xfrm>
                <a:off x="285728" y="4857752"/>
                <a:ext cx="142876" cy="142876"/>
              </a:xfrm>
              <a:prstGeom prst="rect">
                <a:avLst/>
              </a:prstGeom>
              <a:noFill/>
              <a:ln w="9525">
                <a:noFill/>
                <a:miter lim="800000"/>
                <a:headEnd/>
                <a:tailEnd/>
              </a:ln>
              <a:effectLst/>
            </p:spPr>
          </p:pic>
          <p:pic>
            <p:nvPicPr>
              <p:cNvPr id="183" name="Picture 2"/>
              <p:cNvPicPr>
                <a:picLocks noChangeAspect="1" noChangeArrowheads="1"/>
              </p:cNvPicPr>
              <p:nvPr/>
            </p:nvPicPr>
            <p:blipFill>
              <a:blip r:embed="rId8"/>
              <a:srcRect l="55415" t="72001" r="6251" b="15999"/>
              <a:stretch>
                <a:fillRect/>
              </a:stretch>
            </p:blipFill>
            <p:spPr bwMode="auto">
              <a:xfrm>
                <a:off x="428604" y="4857752"/>
                <a:ext cx="438152" cy="142876"/>
              </a:xfrm>
              <a:prstGeom prst="rect">
                <a:avLst/>
              </a:prstGeom>
              <a:noFill/>
              <a:ln w="9525">
                <a:noFill/>
                <a:miter lim="800000"/>
                <a:headEnd/>
                <a:tailEnd/>
              </a:ln>
              <a:effectLst/>
            </p:spPr>
          </p:pic>
        </p:grpSp>
        <p:grpSp>
          <p:nvGrpSpPr>
            <p:cNvPr id="186" name="Group 185"/>
            <p:cNvGrpSpPr/>
            <p:nvPr/>
          </p:nvGrpSpPr>
          <p:grpSpPr>
            <a:xfrm>
              <a:off x="2136766" y="5376868"/>
              <a:ext cx="584997" cy="147638"/>
              <a:chOff x="1853395" y="5291142"/>
              <a:chExt cx="584997" cy="147638"/>
            </a:xfrm>
          </p:grpSpPr>
          <p:pic>
            <p:nvPicPr>
              <p:cNvPr id="185" name="Picture 3"/>
              <p:cNvPicPr>
                <a:picLocks noChangeAspect="1" noChangeArrowheads="1"/>
              </p:cNvPicPr>
              <p:nvPr/>
            </p:nvPicPr>
            <p:blipFill>
              <a:blip r:embed="rId9"/>
              <a:srcRect l="55417" t="70513" r="6249" b="16666"/>
              <a:stretch>
                <a:fillRect/>
              </a:stretch>
            </p:blipFill>
            <p:spPr bwMode="auto">
              <a:xfrm>
                <a:off x="2000240" y="5295904"/>
                <a:ext cx="438152" cy="142876"/>
              </a:xfrm>
              <a:prstGeom prst="rect">
                <a:avLst/>
              </a:prstGeom>
              <a:noFill/>
              <a:ln w="9525">
                <a:noFill/>
                <a:miter lim="800000"/>
                <a:headEnd/>
                <a:tailEnd/>
              </a:ln>
              <a:effectLst/>
            </p:spPr>
          </p:pic>
          <p:pic>
            <p:nvPicPr>
              <p:cNvPr id="1027" name="Picture 3"/>
              <p:cNvPicPr>
                <a:picLocks noChangeAspect="1" noChangeArrowheads="1"/>
              </p:cNvPicPr>
              <p:nvPr/>
            </p:nvPicPr>
            <p:blipFill>
              <a:blip r:embed="rId9"/>
              <a:srcRect l="25000" t="70513" r="62500" b="16666"/>
              <a:stretch>
                <a:fillRect/>
              </a:stretch>
            </p:blipFill>
            <p:spPr bwMode="auto">
              <a:xfrm>
                <a:off x="1853395" y="5291142"/>
                <a:ext cx="142876" cy="142876"/>
              </a:xfrm>
              <a:prstGeom prst="rect">
                <a:avLst/>
              </a:prstGeom>
              <a:noFill/>
              <a:ln w="9525">
                <a:noFill/>
                <a:miter lim="800000"/>
                <a:headEnd/>
                <a:tailEnd/>
              </a:ln>
              <a:effectLst/>
            </p:spPr>
          </p:pic>
        </p:grpSp>
        <p:grpSp>
          <p:nvGrpSpPr>
            <p:cNvPr id="191" name="Group 190"/>
            <p:cNvGrpSpPr/>
            <p:nvPr/>
          </p:nvGrpSpPr>
          <p:grpSpPr>
            <a:xfrm>
              <a:off x="3786190" y="4714876"/>
              <a:ext cx="438152" cy="274309"/>
              <a:chOff x="3286124" y="5643570"/>
              <a:chExt cx="438152" cy="274309"/>
            </a:xfrm>
          </p:grpSpPr>
          <p:pic>
            <p:nvPicPr>
              <p:cNvPr id="1028" name="Picture 4"/>
              <p:cNvPicPr>
                <a:picLocks noChangeAspect="1" noChangeArrowheads="1"/>
              </p:cNvPicPr>
              <p:nvPr/>
            </p:nvPicPr>
            <p:blipFill>
              <a:blip r:embed="rId10"/>
              <a:srcRect l="26549" t="65694" r="59469" b="14015"/>
              <a:stretch>
                <a:fillRect/>
              </a:stretch>
            </p:blipFill>
            <p:spPr bwMode="auto">
              <a:xfrm>
                <a:off x="3286124" y="5643570"/>
                <a:ext cx="150483" cy="264785"/>
              </a:xfrm>
              <a:prstGeom prst="rect">
                <a:avLst/>
              </a:prstGeom>
              <a:noFill/>
              <a:ln w="9525">
                <a:noFill/>
                <a:miter lim="800000"/>
                <a:headEnd/>
                <a:tailEnd/>
              </a:ln>
              <a:effectLst/>
            </p:spPr>
          </p:pic>
          <p:pic>
            <p:nvPicPr>
              <p:cNvPr id="190" name="Picture 4"/>
              <p:cNvPicPr>
                <a:picLocks noChangeAspect="1" noChangeArrowheads="1"/>
              </p:cNvPicPr>
              <p:nvPr/>
            </p:nvPicPr>
            <p:blipFill>
              <a:blip r:embed="rId10"/>
              <a:srcRect l="58850" t="65694" r="13716" b="14015"/>
              <a:stretch>
                <a:fillRect/>
              </a:stretch>
            </p:blipFill>
            <p:spPr bwMode="auto">
              <a:xfrm>
                <a:off x="3429000" y="5653094"/>
                <a:ext cx="295276" cy="264785"/>
              </a:xfrm>
              <a:prstGeom prst="rect">
                <a:avLst/>
              </a:prstGeom>
              <a:noFill/>
              <a:ln w="9525">
                <a:noFill/>
                <a:miter lim="800000"/>
                <a:headEnd/>
                <a:tailEnd/>
              </a:ln>
              <a:effectLst/>
            </p:spPr>
          </p:pic>
        </p:grpSp>
        <p:grpSp>
          <p:nvGrpSpPr>
            <p:cNvPr id="194" name="Group 193"/>
            <p:cNvGrpSpPr/>
            <p:nvPr/>
          </p:nvGrpSpPr>
          <p:grpSpPr>
            <a:xfrm>
              <a:off x="2376482" y="4729165"/>
              <a:ext cx="451020" cy="279585"/>
              <a:chOff x="3531391" y="4887267"/>
              <a:chExt cx="451020" cy="279585"/>
            </a:xfrm>
          </p:grpSpPr>
          <p:pic>
            <p:nvPicPr>
              <p:cNvPr id="1029" name="Picture 5"/>
              <p:cNvPicPr>
                <a:picLocks noChangeAspect="1" noChangeArrowheads="1"/>
              </p:cNvPicPr>
              <p:nvPr/>
            </p:nvPicPr>
            <p:blipFill>
              <a:blip r:embed="rId11"/>
              <a:srcRect l="26336" t="63256" r="59469" b="14884"/>
              <a:stretch>
                <a:fillRect/>
              </a:stretch>
            </p:blipFill>
            <p:spPr bwMode="auto">
              <a:xfrm>
                <a:off x="3531391" y="4898237"/>
                <a:ext cx="152779" cy="268615"/>
              </a:xfrm>
              <a:prstGeom prst="rect">
                <a:avLst/>
              </a:prstGeom>
              <a:noFill/>
              <a:ln w="9525">
                <a:noFill/>
                <a:miter lim="800000"/>
                <a:headEnd/>
                <a:tailEnd/>
              </a:ln>
              <a:effectLst/>
            </p:spPr>
          </p:pic>
          <p:pic>
            <p:nvPicPr>
              <p:cNvPr id="192" name="Picture 5"/>
              <p:cNvPicPr>
                <a:picLocks noChangeAspect="1" noChangeArrowheads="1"/>
              </p:cNvPicPr>
              <p:nvPr/>
            </p:nvPicPr>
            <p:blipFill>
              <a:blip r:embed="rId11"/>
              <a:srcRect l="59469" t="63256" r="12743" b="14884"/>
              <a:stretch>
                <a:fillRect/>
              </a:stretch>
            </p:blipFill>
            <p:spPr bwMode="auto">
              <a:xfrm>
                <a:off x="3683321" y="4887267"/>
                <a:ext cx="299090" cy="268615"/>
              </a:xfrm>
              <a:prstGeom prst="rect">
                <a:avLst/>
              </a:prstGeom>
              <a:noFill/>
              <a:ln w="9525">
                <a:noFill/>
                <a:miter lim="800000"/>
                <a:headEnd/>
                <a:tailEnd/>
              </a:ln>
              <a:effectLst/>
            </p:spPr>
          </p:pic>
        </p:grpSp>
        <p:grpSp>
          <p:nvGrpSpPr>
            <p:cNvPr id="201" name="Group 200"/>
            <p:cNvGrpSpPr/>
            <p:nvPr/>
          </p:nvGrpSpPr>
          <p:grpSpPr>
            <a:xfrm>
              <a:off x="2289167" y="4295453"/>
              <a:ext cx="489594" cy="163393"/>
              <a:chOff x="3386137" y="4778497"/>
              <a:chExt cx="489594" cy="163393"/>
            </a:xfrm>
          </p:grpSpPr>
          <p:pic>
            <p:nvPicPr>
              <p:cNvPr id="1030" name="Picture 6"/>
              <p:cNvPicPr>
                <a:picLocks noChangeAspect="1" noChangeArrowheads="1"/>
              </p:cNvPicPr>
              <p:nvPr/>
            </p:nvPicPr>
            <p:blipFill>
              <a:blip r:embed="rId12"/>
              <a:srcRect l="59469" t="68690" r="8496" b="16552"/>
              <a:stretch>
                <a:fillRect/>
              </a:stretch>
            </p:blipFill>
            <p:spPr bwMode="auto">
              <a:xfrm>
                <a:off x="3530931" y="4778497"/>
                <a:ext cx="344800" cy="163073"/>
              </a:xfrm>
              <a:prstGeom prst="rect">
                <a:avLst/>
              </a:prstGeom>
              <a:noFill/>
              <a:ln w="9525">
                <a:noFill/>
                <a:miter lim="800000"/>
                <a:headEnd/>
                <a:tailEnd/>
              </a:ln>
              <a:effectLst/>
            </p:spPr>
          </p:pic>
          <p:pic>
            <p:nvPicPr>
              <p:cNvPr id="200" name="Picture 6"/>
              <p:cNvPicPr>
                <a:picLocks noChangeAspect="1" noChangeArrowheads="1"/>
              </p:cNvPicPr>
              <p:nvPr/>
            </p:nvPicPr>
            <p:blipFill>
              <a:blip r:embed="rId12"/>
              <a:srcRect l="27186" t="68690" r="59469" b="16552"/>
              <a:stretch>
                <a:fillRect/>
              </a:stretch>
            </p:blipFill>
            <p:spPr bwMode="auto">
              <a:xfrm>
                <a:off x="3386137" y="4778817"/>
                <a:ext cx="143633" cy="163073"/>
              </a:xfrm>
              <a:prstGeom prst="rect">
                <a:avLst/>
              </a:prstGeom>
              <a:noFill/>
              <a:ln w="9525">
                <a:noFill/>
                <a:miter lim="800000"/>
                <a:headEnd/>
                <a:tailEnd/>
              </a:ln>
              <a:effectLst/>
            </p:spPr>
          </p:pic>
        </p:grpSp>
        <p:grpSp>
          <p:nvGrpSpPr>
            <p:cNvPr id="203" name="Group 202"/>
            <p:cNvGrpSpPr/>
            <p:nvPr/>
          </p:nvGrpSpPr>
          <p:grpSpPr>
            <a:xfrm>
              <a:off x="3786190" y="4357686"/>
              <a:ext cx="489586" cy="169801"/>
              <a:chOff x="3386137" y="4868736"/>
              <a:chExt cx="489586" cy="169801"/>
            </a:xfrm>
          </p:grpSpPr>
          <p:pic>
            <p:nvPicPr>
              <p:cNvPr id="1031" name="Picture 7"/>
              <p:cNvPicPr>
                <a:picLocks noChangeAspect="1" noChangeArrowheads="1"/>
              </p:cNvPicPr>
              <p:nvPr/>
            </p:nvPicPr>
            <p:blipFill>
              <a:blip r:embed="rId13"/>
              <a:srcRect l="59469" t="70656" r="8496" b="15360"/>
              <a:stretch>
                <a:fillRect/>
              </a:stretch>
            </p:blipFill>
            <p:spPr bwMode="auto">
              <a:xfrm>
                <a:off x="3530926" y="4868736"/>
                <a:ext cx="344797" cy="166497"/>
              </a:xfrm>
              <a:prstGeom prst="rect">
                <a:avLst/>
              </a:prstGeom>
              <a:noFill/>
              <a:ln w="9525">
                <a:noFill/>
                <a:miter lim="800000"/>
                <a:headEnd/>
                <a:tailEnd/>
              </a:ln>
              <a:effectLst/>
            </p:spPr>
          </p:pic>
          <p:pic>
            <p:nvPicPr>
              <p:cNvPr id="202" name="Picture 7"/>
              <p:cNvPicPr>
                <a:picLocks noChangeAspect="1" noChangeArrowheads="1"/>
              </p:cNvPicPr>
              <p:nvPr/>
            </p:nvPicPr>
            <p:blipFill>
              <a:blip r:embed="rId13"/>
              <a:srcRect l="27186" t="70656" r="59469" b="15360"/>
              <a:stretch>
                <a:fillRect/>
              </a:stretch>
            </p:blipFill>
            <p:spPr bwMode="auto">
              <a:xfrm>
                <a:off x="3386137" y="4872040"/>
                <a:ext cx="143632" cy="166497"/>
              </a:xfrm>
              <a:prstGeom prst="rect">
                <a:avLst/>
              </a:prstGeom>
              <a:noFill/>
              <a:ln w="9525">
                <a:noFill/>
                <a:miter lim="800000"/>
                <a:headEnd/>
                <a:tailEnd/>
              </a:ln>
              <a:effectLst/>
            </p:spPr>
          </p:pic>
        </p:grpSp>
        <p:cxnSp>
          <p:nvCxnSpPr>
            <p:cNvPr id="204" name="Straight Arrow Connector 203"/>
            <p:cNvCxnSpPr/>
            <p:nvPr/>
          </p:nvCxnSpPr>
          <p:spPr bwMode="auto">
            <a:xfrm rot="5400000">
              <a:off x="3178967" y="5536413"/>
              <a:ext cx="1857388" cy="78581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6" name="TextBox 158"/>
            <p:cNvSpPr txBox="1">
              <a:spLocks noChangeArrowheads="1"/>
            </p:cNvSpPr>
            <p:nvPr/>
          </p:nvSpPr>
          <p:spPr bwMode="auto">
            <a:xfrm>
              <a:off x="3000372" y="5786446"/>
              <a:ext cx="1343469" cy="307771"/>
            </a:xfrm>
            <a:prstGeom prst="rect">
              <a:avLst/>
            </a:prstGeom>
            <a:solidFill>
              <a:schemeClr val="bg1"/>
            </a:solidFill>
            <a:ln w="9525">
              <a:solidFill>
                <a:schemeClr val="bg1"/>
              </a:solidFill>
              <a:miter lim="800000"/>
              <a:headEnd/>
              <a:tailEnd/>
            </a:ln>
          </p:spPr>
          <p:txBody>
            <a:bodyPr wrap="none">
              <a:spAutoFit/>
            </a:bodyPr>
            <a:lstStyle/>
            <a:p>
              <a:r>
                <a:rPr lang="en-US" sz="1400" dirty="0"/>
                <a:t>Cell death=</a:t>
              </a:r>
              <a:r>
                <a:rPr lang="en-US" sz="1400" dirty="0" err="1"/>
                <a:t>d,p</a:t>
              </a:r>
              <a:endParaRPr lang="en-US" sz="1400" dirty="0"/>
            </a:p>
          </p:txBody>
        </p:sp>
        <p:cxnSp>
          <p:nvCxnSpPr>
            <p:cNvPr id="209" name="Straight Arrow Connector 208"/>
            <p:cNvCxnSpPr/>
            <p:nvPr/>
          </p:nvCxnSpPr>
          <p:spPr bwMode="auto">
            <a:xfrm rot="16200000" flipH="1">
              <a:off x="4305306" y="4695827"/>
              <a:ext cx="0" cy="1809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212" name="Group 211"/>
            <p:cNvGrpSpPr/>
            <p:nvPr/>
          </p:nvGrpSpPr>
          <p:grpSpPr>
            <a:xfrm>
              <a:off x="4572008" y="5072066"/>
              <a:ext cx="356813" cy="264776"/>
              <a:chOff x="1785926" y="6572264"/>
              <a:chExt cx="356813" cy="264776"/>
            </a:xfrm>
          </p:grpSpPr>
          <p:pic>
            <p:nvPicPr>
              <p:cNvPr id="1032" name="Picture 8"/>
              <p:cNvPicPr>
                <a:picLocks noChangeAspect="1" noChangeArrowheads="1"/>
              </p:cNvPicPr>
              <p:nvPr/>
            </p:nvPicPr>
            <p:blipFill>
              <a:blip r:embed="rId14"/>
              <a:srcRect l="59469" t="65869" r="20389" b="14015"/>
              <a:stretch>
                <a:fillRect/>
              </a:stretch>
            </p:blipFill>
            <p:spPr bwMode="auto">
              <a:xfrm>
                <a:off x="1925949" y="6574536"/>
                <a:ext cx="216790" cy="262504"/>
              </a:xfrm>
              <a:prstGeom prst="rect">
                <a:avLst/>
              </a:prstGeom>
              <a:noFill/>
              <a:ln w="9525">
                <a:noFill/>
                <a:miter lim="800000"/>
                <a:headEnd/>
                <a:tailEnd/>
              </a:ln>
              <a:effectLst/>
            </p:spPr>
          </p:pic>
          <p:pic>
            <p:nvPicPr>
              <p:cNvPr id="210" name="Picture 8"/>
              <p:cNvPicPr>
                <a:picLocks noChangeAspect="1" noChangeArrowheads="1"/>
              </p:cNvPicPr>
              <p:nvPr/>
            </p:nvPicPr>
            <p:blipFill>
              <a:blip r:embed="rId14"/>
              <a:srcRect l="27186" t="65869" r="59469" b="14015"/>
              <a:stretch>
                <a:fillRect/>
              </a:stretch>
            </p:blipFill>
            <p:spPr bwMode="auto">
              <a:xfrm>
                <a:off x="1785926" y="6572264"/>
                <a:ext cx="143632" cy="262504"/>
              </a:xfrm>
              <a:prstGeom prst="rect">
                <a:avLst/>
              </a:prstGeom>
              <a:noFill/>
              <a:ln w="9525">
                <a:noFill/>
                <a:miter lim="800000"/>
                <a:headEnd/>
                <a:tailEnd/>
              </a:ln>
              <a:effectLst/>
            </p:spPr>
          </p:pic>
        </p:grpSp>
        <p:grpSp>
          <p:nvGrpSpPr>
            <p:cNvPr id="215" name="Group 214"/>
            <p:cNvGrpSpPr/>
            <p:nvPr/>
          </p:nvGrpSpPr>
          <p:grpSpPr>
            <a:xfrm>
              <a:off x="5786454" y="5500694"/>
              <a:ext cx="350809" cy="262896"/>
              <a:chOff x="873608" y="7073276"/>
              <a:chExt cx="350809" cy="262896"/>
            </a:xfrm>
          </p:grpSpPr>
          <p:pic>
            <p:nvPicPr>
              <p:cNvPr id="1033" name="Picture 9"/>
              <p:cNvPicPr>
                <a:picLocks noChangeAspect="1" noChangeArrowheads="1"/>
              </p:cNvPicPr>
              <p:nvPr/>
            </p:nvPicPr>
            <p:blipFill>
              <a:blip r:embed="rId15"/>
              <a:srcRect l="59469" t="63750" r="21239" b="15000"/>
              <a:stretch>
                <a:fillRect/>
              </a:stretch>
            </p:blipFill>
            <p:spPr bwMode="auto">
              <a:xfrm>
                <a:off x="1016775" y="7077092"/>
                <a:ext cx="207642" cy="259080"/>
              </a:xfrm>
              <a:prstGeom prst="rect">
                <a:avLst/>
              </a:prstGeom>
              <a:noFill/>
              <a:ln w="9525">
                <a:noFill/>
                <a:miter lim="800000"/>
                <a:headEnd/>
                <a:tailEnd/>
              </a:ln>
              <a:effectLst/>
            </p:spPr>
          </p:pic>
          <p:pic>
            <p:nvPicPr>
              <p:cNvPr id="214" name="Picture 9"/>
              <p:cNvPicPr>
                <a:picLocks noChangeAspect="1" noChangeArrowheads="1"/>
              </p:cNvPicPr>
              <p:nvPr/>
            </p:nvPicPr>
            <p:blipFill>
              <a:blip r:embed="rId15"/>
              <a:srcRect l="27186" t="63750" r="59469" b="15000"/>
              <a:stretch>
                <a:fillRect/>
              </a:stretch>
            </p:blipFill>
            <p:spPr bwMode="auto">
              <a:xfrm>
                <a:off x="873608" y="7073276"/>
                <a:ext cx="143634" cy="259080"/>
              </a:xfrm>
              <a:prstGeom prst="rect">
                <a:avLst/>
              </a:prstGeom>
              <a:noFill/>
              <a:ln w="9525">
                <a:noFill/>
                <a:miter lim="800000"/>
                <a:headEnd/>
                <a:tailEnd/>
              </a:ln>
              <a:effectLst/>
            </p:spPr>
          </p:pic>
        </p:grpSp>
        <p:grpSp>
          <p:nvGrpSpPr>
            <p:cNvPr id="217" name="Group 216"/>
            <p:cNvGrpSpPr/>
            <p:nvPr/>
          </p:nvGrpSpPr>
          <p:grpSpPr>
            <a:xfrm>
              <a:off x="5857892" y="4786314"/>
              <a:ext cx="388655" cy="155247"/>
              <a:chOff x="-571528" y="4981580"/>
              <a:chExt cx="388655" cy="155247"/>
            </a:xfrm>
          </p:grpSpPr>
          <p:pic>
            <p:nvPicPr>
              <p:cNvPr id="1034" name="Picture 10"/>
              <p:cNvPicPr>
                <a:picLocks noChangeAspect="1" noChangeArrowheads="1"/>
              </p:cNvPicPr>
              <p:nvPr/>
            </p:nvPicPr>
            <p:blipFill>
              <a:blip r:embed="rId16"/>
              <a:srcRect l="59469" t="69517" r="16991" b="16552"/>
              <a:stretch>
                <a:fillRect/>
              </a:stretch>
            </p:blipFill>
            <p:spPr bwMode="auto">
              <a:xfrm>
                <a:off x="-436238" y="4982893"/>
                <a:ext cx="253365" cy="153934"/>
              </a:xfrm>
              <a:prstGeom prst="rect">
                <a:avLst/>
              </a:prstGeom>
              <a:noFill/>
              <a:ln w="9525">
                <a:noFill/>
                <a:miter lim="800000"/>
                <a:headEnd/>
                <a:tailEnd/>
              </a:ln>
              <a:effectLst/>
            </p:spPr>
          </p:pic>
          <p:pic>
            <p:nvPicPr>
              <p:cNvPr id="216" name="Picture 10"/>
              <p:cNvPicPr>
                <a:picLocks noChangeAspect="1" noChangeArrowheads="1"/>
              </p:cNvPicPr>
              <p:nvPr/>
            </p:nvPicPr>
            <p:blipFill>
              <a:blip r:embed="rId16"/>
              <a:srcRect l="27186" t="69517" r="59469" b="16552"/>
              <a:stretch>
                <a:fillRect/>
              </a:stretch>
            </p:blipFill>
            <p:spPr bwMode="auto">
              <a:xfrm>
                <a:off x="-571528" y="4981580"/>
                <a:ext cx="143633" cy="153934"/>
              </a:xfrm>
              <a:prstGeom prst="rect">
                <a:avLst/>
              </a:prstGeom>
              <a:noFill/>
              <a:ln w="9525">
                <a:noFill/>
                <a:miter lim="800000"/>
                <a:headEnd/>
                <a:tailEnd/>
              </a:ln>
              <a:effectLst/>
            </p:spPr>
          </p:pic>
        </p:grpSp>
      </p:grpSp>
      <p:pic>
        <p:nvPicPr>
          <p:cNvPr id="221" name="Picture 220"/>
          <p:cNvPicPr>
            <a:picLocks noChangeAspect="1"/>
          </p:cNvPicPr>
          <p:nvPr/>
        </p:nvPicPr>
        <p:blipFill rotWithShape="1">
          <a:blip r:embed="rId17"/>
          <a:srcRect l="18433" t="1626" r="45925" b="95472"/>
          <a:stretch/>
        </p:blipFill>
        <p:spPr>
          <a:xfrm>
            <a:off x="5715016" y="8412435"/>
            <a:ext cx="508000" cy="211667"/>
          </a:xfrm>
          <a:prstGeom prst="rect">
            <a:avLst/>
          </a:prstGeom>
        </p:spPr>
      </p:pic>
    </p:spTree>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Rectangle 178"/>
          <p:cNvSpPr>
            <a:spLocks noChangeArrowheads="1"/>
          </p:cNvSpPr>
          <p:nvPr/>
        </p:nvSpPr>
        <p:spPr bwMode="auto">
          <a:xfrm>
            <a:off x="0" y="2479403"/>
            <a:ext cx="6858000" cy="3231654"/>
          </a:xfrm>
          <a:prstGeom prst="rect">
            <a:avLst/>
          </a:prstGeom>
          <a:noFill/>
          <a:ln w="9525">
            <a:noFill/>
            <a:miter lim="800000"/>
            <a:headEnd/>
            <a:tailEnd/>
          </a:ln>
        </p:spPr>
        <p:txBody>
          <a:bodyPr anchor="ctr">
            <a:spAutoFit/>
          </a:bodyPr>
          <a:lstStyle/>
          <a:p>
            <a:r>
              <a:rPr lang="en-US" sz="1200" b="1" dirty="0"/>
              <a:t>Supplementary figure S8. Impact of interaction between drought and pathogen stressors on plant. </a:t>
            </a:r>
            <a:r>
              <a:rPr lang="en-US" sz="1200" dirty="0"/>
              <a:t>Summary of results obtained from the current study on combined stress (A). Plants inoculated with pathogen, at severe drought stress (FC 20%) exhibited unaltered chlorophyll content, reduced pathogen growth and cell death in comparison to the pants inoculated at 80% FC. Model explaining possible interaction between drought and pathogen stress during their concurrence</a:t>
            </a:r>
            <a:r>
              <a:rPr lang="en-US" sz="1200" b="1" dirty="0"/>
              <a:t> </a:t>
            </a:r>
            <a:r>
              <a:rPr lang="en-US" sz="1200" dirty="0"/>
              <a:t>(B)</a:t>
            </a:r>
            <a:r>
              <a:rPr lang="en-US" sz="1200" b="1" dirty="0"/>
              <a:t>. </a:t>
            </a:r>
            <a:r>
              <a:rPr lang="en-US" sz="1200" dirty="0"/>
              <a:t>Expression profile of the genes included in model is presented along every step.</a:t>
            </a:r>
            <a:r>
              <a:rPr lang="en-US" sz="1200" b="1" dirty="0"/>
              <a:t> </a:t>
            </a:r>
            <a:r>
              <a:rPr lang="en-IN" sz="1200" dirty="0"/>
              <a:t>Expression values of the respective genes under individual drought (D), pathogen (P) and combined drought and pathogen stress (DP) were retrieved from </a:t>
            </a:r>
            <a:r>
              <a:rPr lang="en-IN" sz="1200" dirty="0" err="1"/>
              <a:t>transcriptome</a:t>
            </a:r>
            <a:r>
              <a:rPr lang="en-IN" sz="1200" dirty="0"/>
              <a:t> study performed by Gupta et al. (2016) [</a:t>
            </a:r>
            <a:r>
              <a:rPr lang="en-IN" sz="1200" i="1" dirty="0"/>
              <a:t>Front. Plant Sci.</a:t>
            </a:r>
            <a:r>
              <a:rPr lang="en-IN" sz="1200" dirty="0"/>
              <a:t> 7, 686] and are represented in the form of heat map. </a:t>
            </a:r>
            <a:r>
              <a:rPr lang="en-IN" sz="1200" dirty="0" err="1"/>
              <a:t>Color</a:t>
            </a:r>
            <a:r>
              <a:rPr lang="en-IN" sz="1200" dirty="0"/>
              <a:t> bar scale shows the fold change range with red and blue </a:t>
            </a:r>
            <a:r>
              <a:rPr lang="en-IN" sz="1200" dirty="0" err="1"/>
              <a:t>color</a:t>
            </a:r>
            <a:r>
              <a:rPr lang="en-IN" sz="1200" dirty="0"/>
              <a:t> representing up- and down-regulation respectively.</a:t>
            </a:r>
            <a:r>
              <a:rPr lang="en-IN" sz="1200" b="1" dirty="0"/>
              <a:t> </a:t>
            </a:r>
            <a:r>
              <a:rPr lang="en-IN" sz="1200" dirty="0"/>
              <a:t>From the proposed model it can be inferred that </a:t>
            </a:r>
            <a:r>
              <a:rPr lang="en-US" sz="1200" dirty="0"/>
              <a:t>during combined stress, </a:t>
            </a:r>
            <a:r>
              <a:rPr lang="en-IN" sz="1200" dirty="0"/>
              <a:t>the </a:t>
            </a:r>
            <a:r>
              <a:rPr lang="en-IN" sz="1200" i="1" dirty="0"/>
              <a:t>AtNCED3</a:t>
            </a:r>
            <a:r>
              <a:rPr lang="en-IN" sz="1200" dirty="0"/>
              <a:t> gene induction leads to accumulation of ABA, which in turn activates the expression of </a:t>
            </a:r>
            <a:r>
              <a:rPr lang="en-IN" sz="1200" i="1" dirty="0"/>
              <a:t>AtNAC6 </a:t>
            </a:r>
            <a:r>
              <a:rPr lang="en-IN" sz="1200" dirty="0"/>
              <a:t>gene but represses </a:t>
            </a:r>
            <a:r>
              <a:rPr lang="en-IN" sz="1200" i="1" dirty="0"/>
              <a:t>AtNAC1</a:t>
            </a:r>
            <a:r>
              <a:rPr lang="en-IN" sz="1200" dirty="0"/>
              <a:t> expression. Down-regulation of </a:t>
            </a:r>
            <a:r>
              <a:rPr lang="en-IN" sz="1200" i="1" dirty="0"/>
              <a:t>AtNAC1</a:t>
            </a:r>
            <a:r>
              <a:rPr lang="en-IN" sz="1200" dirty="0"/>
              <a:t> gene expression leads to loss of NAC mediated suppression of </a:t>
            </a:r>
            <a:r>
              <a:rPr lang="en-IN" sz="1200" i="1" dirty="0"/>
              <a:t>AtPR1</a:t>
            </a:r>
            <a:r>
              <a:rPr lang="en-IN" sz="1200" dirty="0"/>
              <a:t> or </a:t>
            </a:r>
            <a:r>
              <a:rPr lang="en-IN" sz="1200" i="1" dirty="0"/>
              <a:t>AtPR5</a:t>
            </a:r>
            <a:r>
              <a:rPr lang="en-IN" sz="1200" dirty="0"/>
              <a:t>. At the same time up-regulation of </a:t>
            </a:r>
            <a:r>
              <a:rPr lang="en-IN" sz="1200" i="1" dirty="0"/>
              <a:t>AtNAC6</a:t>
            </a:r>
            <a:r>
              <a:rPr lang="en-IN" sz="1200" dirty="0"/>
              <a:t> could directly influence plant defences resulting in reduced bacterial load. These could be part of reason for reduced </a:t>
            </a:r>
            <a:r>
              <a:rPr lang="en-IN" sz="1200" i="1" dirty="0"/>
              <a:t>in </a:t>
            </a:r>
            <a:r>
              <a:rPr lang="en-IN" sz="1200" i="1" dirty="0" err="1"/>
              <a:t>planta</a:t>
            </a:r>
            <a:r>
              <a:rPr lang="en-IN" sz="1200" dirty="0"/>
              <a:t> bacterial number. </a:t>
            </a:r>
            <a:r>
              <a:rPr lang="en-US" sz="1200" dirty="0"/>
              <a:t>The model is drawn based on the results from present study and previous research studies on </a:t>
            </a:r>
            <a:r>
              <a:rPr lang="en-US" sz="1200" i="1" dirty="0"/>
              <a:t>A.</a:t>
            </a:r>
            <a:r>
              <a:rPr lang="en-US" sz="1200" dirty="0"/>
              <a:t> </a:t>
            </a:r>
            <a:r>
              <a:rPr lang="en-US" sz="1200" i="1" dirty="0"/>
              <a:t>thaliana.</a:t>
            </a:r>
            <a:endParaRPr lang="en-IN" sz="1200" dirty="0"/>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TextBox 13"/>
          <p:cNvSpPr txBox="1">
            <a:spLocks noChangeArrowheads="1"/>
          </p:cNvSpPr>
          <p:nvPr/>
        </p:nvSpPr>
        <p:spPr bwMode="auto">
          <a:xfrm>
            <a:off x="0" y="2215108"/>
            <a:ext cx="6858000" cy="4524315"/>
          </a:xfrm>
          <a:prstGeom prst="rect">
            <a:avLst/>
          </a:prstGeom>
          <a:noFill/>
          <a:ln w="9525">
            <a:noFill/>
            <a:miter lim="800000"/>
            <a:headEnd/>
            <a:tailEnd/>
          </a:ln>
        </p:spPr>
        <p:txBody>
          <a:bodyPr>
            <a:spAutoFit/>
          </a:bodyPr>
          <a:lstStyle/>
          <a:p>
            <a:pPr algn="just"/>
            <a:r>
              <a:rPr lang="en-IN" sz="1200" b="1" dirty="0" smtClean="0"/>
              <a:t>Supplementary figure S1. </a:t>
            </a:r>
            <a:r>
              <a:rPr lang="en-US" sz="1200" b="1" dirty="0" smtClean="0"/>
              <a:t>Scheme for drought stress imposition</a:t>
            </a:r>
            <a:r>
              <a:rPr lang="en-US" sz="1200" dirty="0" smtClean="0"/>
              <a:t>. </a:t>
            </a:r>
            <a:r>
              <a:rPr lang="en-IN" sz="1200" dirty="0" smtClean="0"/>
              <a:t>Number of days required to attain the specific field capacity (FC) for a 32-d-old potted </a:t>
            </a:r>
            <a:r>
              <a:rPr lang="en-IN" sz="1200" i="1" dirty="0" smtClean="0"/>
              <a:t>A. thaliana</a:t>
            </a:r>
            <a:r>
              <a:rPr lang="en-IN" sz="1200" dirty="0" smtClean="0"/>
              <a:t> is illustrated here </a:t>
            </a:r>
            <a:r>
              <a:rPr lang="en-IN" sz="1200" b="1" dirty="0" smtClean="0"/>
              <a:t>(A)</a:t>
            </a:r>
            <a:r>
              <a:rPr lang="en-US" sz="1200" dirty="0" smtClean="0"/>
              <a:t>. </a:t>
            </a:r>
            <a:r>
              <a:rPr lang="en-US" sz="1200" i="1" dirty="0" smtClean="0"/>
              <a:t>A. thaliana</a:t>
            </a:r>
            <a:r>
              <a:rPr lang="en-US" sz="1200" dirty="0" smtClean="0"/>
              <a:t> was grown in controlled environmental chamber at 12-h-light/12-h-dark; 200 µE m-2s-1 photon flux intensity, at 22 °C temperature, 70% relative humidity and 792.9 Pa </a:t>
            </a:r>
            <a:r>
              <a:rPr lang="en-US" sz="1200" dirty="0" err="1" smtClean="0"/>
              <a:t>vapour</a:t>
            </a:r>
            <a:r>
              <a:rPr lang="en-US" sz="1200" dirty="0" smtClean="0"/>
              <a:t> pressure deficit (VPD). Gravimetric method of drought imposition was employed, wherein 1 g of oven dried potting mix could hold 5 g of water at 100% FC. The surface area of the pots used in our experiment was less and hence at the time of drought stress initiation (32-d-old) plants covered entire surface of pot mix which leads to only minimal evaporation. Also we maintained control pots without plant (but with minor cover with artificial material to reflect plant occupied area) at the time of water withdrawal and the amount of water lost through evaporation was estimated. Plants were maintained under 100% FC until the start of experiment. The saturated pots were then deprived of water supply and were allowed to reach different FC. It took 7 d, 5 d, 3 d and 1 d to reach at 20% FC, 40% FC, 60% FC and 80% FC, respectively. Chart represents plan for drought stress imposition </a:t>
            </a:r>
            <a:r>
              <a:rPr lang="en-US" sz="1200" b="1" dirty="0" smtClean="0"/>
              <a:t>(B)</a:t>
            </a:r>
            <a:r>
              <a:rPr lang="en-US" sz="1200" dirty="0" smtClean="0"/>
              <a:t>. Based on the standardized period for drought stress, a protocol was established to impose drought stress in </a:t>
            </a:r>
            <a:r>
              <a:rPr lang="en-US" sz="1200" i="1" dirty="0" smtClean="0"/>
              <a:t>A. thaliana</a:t>
            </a:r>
            <a:r>
              <a:rPr lang="en-US" sz="1200" dirty="0" smtClean="0"/>
              <a:t> in pots, such that the effective period for reaching different FC. Water was withdrawn from plants at day 1 (i.e., 32-d-old) and these plants were tagged as FC 20%. Similarly water withdrawal was initiated at 3rd, 5th and 6th day for 40%, 60% and 80% FC respectively. Since the start of the experiment day 7 was marked as 0 day for drought stress realization by plants. Depending on the parameter assayed, samples were collected from 38 d, 39 d, 40 d and 41 d as 0, 24, 48 and 72 hour post treatment. Once pots reach destined FC, they were maintained at the respective FC, by replenishing the lost amount of water, till the desired duration. Upward arrow refers to the time of water withdrawal. Plants at FC 100% were considered as control. Blue line refers to the plants maintained at 100% FC. Dropping lines refers to the gradual water loss when plants were deprived of irrigation.</a:t>
            </a:r>
            <a:endParaRPr lang="en-US" sz="1200" dirty="0"/>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Rectangle 74"/>
          <p:cNvSpPr>
            <a:spLocks noChangeArrowheads="1"/>
          </p:cNvSpPr>
          <p:nvPr/>
        </p:nvSpPr>
        <p:spPr bwMode="auto">
          <a:xfrm>
            <a:off x="714375" y="571500"/>
            <a:ext cx="1895071" cy="276999"/>
          </a:xfrm>
          <a:prstGeom prst="rect">
            <a:avLst/>
          </a:prstGeom>
          <a:noFill/>
          <a:ln w="9525">
            <a:noFill/>
            <a:miter lim="800000"/>
            <a:headEnd/>
            <a:tailEnd/>
          </a:ln>
        </p:spPr>
        <p:txBody>
          <a:bodyPr wrap="none">
            <a:spAutoFit/>
          </a:bodyPr>
          <a:lstStyle/>
          <a:p>
            <a:r>
              <a:rPr lang="en-US" sz="1200" b="1" dirty="0" smtClean="0"/>
              <a:t>Supplementary figure 2</a:t>
            </a:r>
            <a:endParaRPr lang="en-US" sz="1200" b="1" dirty="0">
              <a:latin typeface="Arial" pitchFamily="34" charset="0"/>
              <a:cs typeface="Arial" pitchFamily="34" charset="0"/>
            </a:endParaRPr>
          </a:p>
        </p:txBody>
      </p:sp>
      <p:sp>
        <p:nvSpPr>
          <p:cNvPr id="5123" name="TextBox 97"/>
          <p:cNvSpPr txBox="1">
            <a:spLocks noChangeArrowheads="1"/>
          </p:cNvSpPr>
          <p:nvPr/>
        </p:nvSpPr>
        <p:spPr bwMode="auto">
          <a:xfrm>
            <a:off x="0" y="4714875"/>
            <a:ext cx="6858000" cy="1015663"/>
          </a:xfrm>
          <a:prstGeom prst="rect">
            <a:avLst/>
          </a:prstGeom>
          <a:noFill/>
          <a:ln w="9525">
            <a:noFill/>
            <a:miter lim="800000"/>
            <a:headEnd/>
            <a:tailEnd/>
          </a:ln>
        </p:spPr>
        <p:txBody>
          <a:bodyPr wrap="square">
            <a:spAutoFit/>
          </a:bodyPr>
          <a:lstStyle/>
          <a:p>
            <a:pPr algn="just"/>
            <a:r>
              <a:rPr lang="en-IN" sz="1200" b="1" dirty="0" smtClean="0"/>
              <a:t>Supplementary figure S2</a:t>
            </a:r>
            <a:r>
              <a:rPr lang="en-US" sz="1200" b="1" dirty="0" smtClean="0"/>
              <a:t>. Schematic representation of protocol followed to optimize pathogen concentration. </a:t>
            </a:r>
            <a:r>
              <a:rPr lang="en-US" sz="1200" i="1" dirty="0" smtClean="0"/>
              <a:t>P. </a:t>
            </a:r>
            <a:r>
              <a:rPr lang="en-US" sz="1200" i="1" dirty="0" err="1" smtClean="0"/>
              <a:t>syringae</a:t>
            </a:r>
            <a:r>
              <a:rPr lang="en-US" sz="1200" dirty="0" smtClean="0"/>
              <a:t> </a:t>
            </a:r>
            <a:r>
              <a:rPr lang="en-US" sz="1200" dirty="0" err="1" smtClean="0"/>
              <a:t>pv</a:t>
            </a:r>
            <a:r>
              <a:rPr lang="en-US" sz="1200" dirty="0" smtClean="0"/>
              <a:t>. tomato DC3000 was syringe infiltrated at different concentrations into the 38-d-old </a:t>
            </a:r>
            <a:r>
              <a:rPr lang="en-US" sz="1200" i="1" dirty="0" smtClean="0"/>
              <a:t>A. thaliana </a:t>
            </a:r>
            <a:r>
              <a:rPr lang="en-US" sz="1200" dirty="0" smtClean="0"/>
              <a:t>leaves. Plants infiltrated with water served as mock control. Samples were harvested at 0 </a:t>
            </a:r>
            <a:r>
              <a:rPr lang="en-US" sz="1200" dirty="0" err="1" smtClean="0"/>
              <a:t>hpt</a:t>
            </a:r>
            <a:r>
              <a:rPr lang="en-US" sz="1200" dirty="0" smtClean="0"/>
              <a:t>, 24 </a:t>
            </a:r>
            <a:r>
              <a:rPr lang="en-US" sz="1200" dirty="0" err="1" smtClean="0"/>
              <a:t>hpt</a:t>
            </a:r>
            <a:r>
              <a:rPr lang="en-US" sz="1200" dirty="0" smtClean="0"/>
              <a:t>, 48 </a:t>
            </a:r>
            <a:r>
              <a:rPr lang="en-US" sz="1200" dirty="0" err="1" smtClean="0"/>
              <a:t>hpt</a:t>
            </a:r>
            <a:r>
              <a:rPr lang="en-US" sz="1200" dirty="0" smtClean="0"/>
              <a:t> and 72 </a:t>
            </a:r>
            <a:r>
              <a:rPr lang="en-US" sz="1200" dirty="0" err="1" smtClean="0"/>
              <a:t>hpt</a:t>
            </a:r>
            <a:r>
              <a:rPr lang="en-US" sz="1200" dirty="0" smtClean="0"/>
              <a:t>. </a:t>
            </a:r>
            <a:r>
              <a:rPr lang="en-US" sz="1200" dirty="0" err="1" smtClean="0"/>
              <a:t>cfu</a:t>
            </a:r>
            <a:r>
              <a:rPr lang="en-US" sz="1200" dirty="0" smtClean="0"/>
              <a:t>; colony forming units, d; days</a:t>
            </a:r>
            <a:r>
              <a:rPr lang="en-IN" sz="1200" dirty="0" smtClean="0"/>
              <a:t> </a:t>
            </a:r>
            <a:endParaRPr lang="en-US" sz="1200" dirty="0"/>
          </a:p>
        </p:txBody>
      </p:sp>
      <p:pic>
        <p:nvPicPr>
          <p:cNvPr id="5124" name="Picture 5"/>
          <p:cNvPicPr>
            <a:picLocks noChangeAspect="1" noChangeArrowheads="1"/>
          </p:cNvPicPr>
          <p:nvPr/>
        </p:nvPicPr>
        <p:blipFill>
          <a:blip r:embed="rId2"/>
          <a:srcRect/>
          <a:stretch>
            <a:fillRect/>
          </a:stretch>
        </p:blipFill>
        <p:spPr bwMode="auto">
          <a:xfrm>
            <a:off x="357188" y="1071563"/>
            <a:ext cx="6248400" cy="3252787"/>
          </a:xfrm>
          <a:prstGeom prst="rect">
            <a:avLst/>
          </a:prstGeom>
          <a:noFill/>
          <a:ln w="9525">
            <a:noFill/>
            <a:miter lim="800000"/>
            <a:headEnd/>
            <a:tailEnd/>
          </a:ln>
        </p:spPr>
      </p:pic>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Rectangle 74"/>
          <p:cNvSpPr>
            <a:spLocks noChangeArrowheads="1"/>
          </p:cNvSpPr>
          <p:nvPr/>
        </p:nvSpPr>
        <p:spPr bwMode="auto">
          <a:xfrm>
            <a:off x="260648" y="224455"/>
            <a:ext cx="1895071" cy="276999"/>
          </a:xfrm>
          <a:prstGeom prst="rect">
            <a:avLst/>
          </a:prstGeom>
          <a:noFill/>
          <a:ln w="9525">
            <a:noFill/>
            <a:miter lim="800000"/>
            <a:headEnd/>
            <a:tailEnd/>
          </a:ln>
        </p:spPr>
        <p:txBody>
          <a:bodyPr wrap="none">
            <a:spAutoFit/>
          </a:bodyPr>
          <a:lstStyle/>
          <a:p>
            <a:r>
              <a:rPr lang="en-US" sz="1200" b="1" dirty="0" smtClean="0"/>
              <a:t>Supplementary figure 3</a:t>
            </a:r>
            <a:endParaRPr lang="en-US" sz="1200" b="1" dirty="0">
              <a:latin typeface="Arial" pitchFamily="34" charset="0"/>
              <a:cs typeface="Arial" pitchFamily="34" charset="0"/>
            </a:endParaRPr>
          </a:p>
        </p:txBody>
      </p:sp>
      <p:sp>
        <p:nvSpPr>
          <p:cNvPr id="6147" name="TextBox 4"/>
          <p:cNvSpPr txBox="1">
            <a:spLocks noChangeArrowheads="1"/>
          </p:cNvSpPr>
          <p:nvPr/>
        </p:nvSpPr>
        <p:spPr bwMode="auto">
          <a:xfrm>
            <a:off x="0" y="7545388"/>
            <a:ext cx="6858000" cy="1384995"/>
          </a:xfrm>
          <a:prstGeom prst="rect">
            <a:avLst/>
          </a:prstGeom>
          <a:noFill/>
          <a:ln w="9525">
            <a:noFill/>
            <a:miter lim="800000"/>
            <a:headEnd/>
            <a:tailEnd/>
          </a:ln>
        </p:spPr>
        <p:txBody>
          <a:bodyPr>
            <a:spAutoFit/>
          </a:bodyPr>
          <a:lstStyle/>
          <a:p>
            <a:pPr algn="just"/>
            <a:r>
              <a:rPr lang="en-IN" sz="1200" b="1" dirty="0" smtClean="0"/>
              <a:t>Supplementary figure S3</a:t>
            </a:r>
            <a:r>
              <a:rPr lang="en-US" sz="1200" b="1" dirty="0" smtClean="0"/>
              <a:t> Fig. Outline of combined drought and </a:t>
            </a:r>
            <a:r>
              <a:rPr lang="en-US" sz="1200" b="1" i="1" dirty="0" smtClean="0"/>
              <a:t>P. </a:t>
            </a:r>
            <a:r>
              <a:rPr lang="en-US" sz="1200" b="1" i="1" dirty="0" err="1" smtClean="0"/>
              <a:t>syringae</a:t>
            </a:r>
            <a:r>
              <a:rPr lang="en-US" sz="1200" b="1" dirty="0" smtClean="0"/>
              <a:t> </a:t>
            </a:r>
            <a:r>
              <a:rPr lang="en-US" sz="1200" b="1" dirty="0" err="1" smtClean="0"/>
              <a:t>pv</a:t>
            </a:r>
            <a:r>
              <a:rPr lang="en-US" sz="1200" b="1" dirty="0" smtClean="0"/>
              <a:t> DC3000 stress imposition in </a:t>
            </a:r>
            <a:r>
              <a:rPr lang="en-US" sz="1200" b="1" i="1" dirty="0" smtClean="0"/>
              <a:t>A. thaliana </a:t>
            </a:r>
            <a:r>
              <a:rPr lang="en-US" sz="1200" b="1" dirty="0" smtClean="0"/>
              <a:t>leaves. </a:t>
            </a:r>
            <a:r>
              <a:rPr lang="en-US" sz="1200" dirty="0" smtClean="0"/>
              <a:t>Drought stress was imposed on </a:t>
            </a:r>
            <a:r>
              <a:rPr lang="en-US" sz="1200" i="1" dirty="0" smtClean="0"/>
              <a:t>A. thaliana</a:t>
            </a:r>
            <a:r>
              <a:rPr lang="en-US" sz="1200" dirty="0" smtClean="0"/>
              <a:t> according to the schedule outlined in Figure S1B, so as to impose respective drought levels. On the day when plants achieved their respective FCs, the </a:t>
            </a:r>
            <a:r>
              <a:rPr lang="en-US" sz="1200" dirty="0" err="1" smtClean="0"/>
              <a:t>abaxial</a:t>
            </a:r>
            <a:r>
              <a:rPr lang="en-US" sz="1200" dirty="0" smtClean="0"/>
              <a:t> surface of the leaves (drought stressed) were syringe infiltrated with </a:t>
            </a:r>
            <a:r>
              <a:rPr lang="en-US" sz="1200" i="1" dirty="0" smtClean="0"/>
              <a:t>P. </a:t>
            </a:r>
            <a:r>
              <a:rPr lang="en-US" sz="1200" i="1" dirty="0" err="1" smtClean="0"/>
              <a:t>syringae</a:t>
            </a:r>
            <a:r>
              <a:rPr lang="en-US" sz="1200" dirty="0" smtClean="0"/>
              <a:t> DC3000. The outline thus overlays the two stresses together. Samples were collected at 0 </a:t>
            </a:r>
            <a:r>
              <a:rPr lang="en-US" sz="1200" dirty="0" err="1" smtClean="0"/>
              <a:t>hpt</a:t>
            </a:r>
            <a:r>
              <a:rPr lang="en-US" sz="1200" dirty="0" smtClean="0"/>
              <a:t>, 24hpt, 48 </a:t>
            </a:r>
            <a:r>
              <a:rPr lang="en-US" sz="1200" dirty="0" err="1" smtClean="0"/>
              <a:t>hpt</a:t>
            </a:r>
            <a:r>
              <a:rPr lang="en-US" sz="1200" dirty="0" smtClean="0"/>
              <a:t> and 72 </a:t>
            </a:r>
            <a:r>
              <a:rPr lang="en-US" sz="1200" dirty="0" err="1" smtClean="0"/>
              <a:t>hpt</a:t>
            </a:r>
            <a:r>
              <a:rPr lang="en-US" sz="1200" dirty="0" smtClean="0"/>
              <a:t>. Upward arrows marks the time point to withhold water; downward arrows show the time of bacterial inoculation</a:t>
            </a:r>
            <a:endParaRPr lang="en-IN" sz="1200" dirty="0"/>
          </a:p>
        </p:txBody>
      </p:sp>
      <p:pic>
        <p:nvPicPr>
          <p:cNvPr id="6148" name="Picture 5"/>
          <p:cNvPicPr>
            <a:picLocks noChangeAspect="1" noChangeArrowheads="1"/>
          </p:cNvPicPr>
          <p:nvPr/>
        </p:nvPicPr>
        <p:blipFill>
          <a:blip r:embed="rId2"/>
          <a:srcRect/>
          <a:stretch>
            <a:fillRect/>
          </a:stretch>
        </p:blipFill>
        <p:spPr bwMode="auto">
          <a:xfrm>
            <a:off x="548680" y="755576"/>
            <a:ext cx="6047422" cy="6158458"/>
          </a:xfrm>
          <a:prstGeom prst="rect">
            <a:avLst/>
          </a:prstGeom>
          <a:noFill/>
          <a:ln w="9525">
            <a:noFill/>
            <a:miter lim="800000"/>
            <a:headEnd/>
            <a:tailEnd/>
          </a:ln>
        </p:spPr>
      </p:pic>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Rectangle 29"/>
          <p:cNvSpPr>
            <a:spLocks noChangeArrowheads="1"/>
          </p:cNvSpPr>
          <p:nvPr/>
        </p:nvSpPr>
        <p:spPr bwMode="auto">
          <a:xfrm>
            <a:off x="2643188" y="13041"/>
            <a:ext cx="1895071" cy="276999"/>
          </a:xfrm>
          <a:prstGeom prst="rect">
            <a:avLst/>
          </a:prstGeom>
          <a:noFill/>
          <a:ln w="9525">
            <a:noFill/>
            <a:miter lim="800000"/>
            <a:headEnd/>
            <a:tailEnd/>
          </a:ln>
        </p:spPr>
        <p:txBody>
          <a:bodyPr wrap="none">
            <a:spAutoFit/>
          </a:bodyPr>
          <a:lstStyle/>
          <a:p>
            <a:r>
              <a:rPr lang="en-US" sz="1200" b="1" dirty="0" smtClean="0"/>
              <a:t>Supplementary figure 4</a:t>
            </a:r>
            <a:endParaRPr lang="en-IN" sz="1200" b="1" dirty="0"/>
          </a:p>
        </p:txBody>
      </p:sp>
      <p:sp>
        <p:nvSpPr>
          <p:cNvPr id="7171" name="TextBox 30"/>
          <p:cNvSpPr txBox="1">
            <a:spLocks noChangeArrowheads="1"/>
          </p:cNvSpPr>
          <p:nvPr/>
        </p:nvSpPr>
        <p:spPr bwMode="auto">
          <a:xfrm>
            <a:off x="-12700" y="988983"/>
            <a:ext cx="292068" cy="215444"/>
          </a:xfrm>
          <a:prstGeom prst="rect">
            <a:avLst/>
          </a:prstGeom>
          <a:noFill/>
          <a:ln w="9525">
            <a:noFill/>
            <a:miter lim="800000"/>
            <a:headEnd/>
            <a:tailEnd/>
          </a:ln>
        </p:spPr>
        <p:txBody>
          <a:bodyPr wrap="none">
            <a:spAutoFit/>
          </a:bodyPr>
          <a:lstStyle/>
          <a:p>
            <a:r>
              <a:rPr lang="en-US" sz="800" b="1"/>
              <a:t>A)</a:t>
            </a:r>
            <a:endParaRPr lang="en-IN" sz="800" b="1"/>
          </a:p>
        </p:txBody>
      </p:sp>
      <p:grpSp>
        <p:nvGrpSpPr>
          <p:cNvPr id="7172" name="Group 136"/>
          <p:cNvGrpSpPr>
            <a:grpSpLocks/>
          </p:cNvGrpSpPr>
          <p:nvPr/>
        </p:nvGrpSpPr>
        <p:grpSpPr bwMode="auto">
          <a:xfrm>
            <a:off x="1250950" y="428596"/>
            <a:ext cx="2732394" cy="2162175"/>
            <a:chOff x="1251710" y="-26988"/>
            <a:chExt cx="2731636" cy="2162176"/>
          </a:xfrm>
        </p:grpSpPr>
        <p:grpSp>
          <p:nvGrpSpPr>
            <p:cNvPr id="7259" name="Group 120"/>
            <p:cNvGrpSpPr>
              <a:grpSpLocks/>
            </p:cNvGrpSpPr>
            <p:nvPr/>
          </p:nvGrpSpPr>
          <p:grpSpPr bwMode="auto">
            <a:xfrm>
              <a:off x="1251710" y="-26988"/>
              <a:ext cx="2731636" cy="2162176"/>
              <a:chOff x="1251149" y="-26865"/>
              <a:chExt cx="2732986" cy="2161393"/>
            </a:xfrm>
          </p:grpSpPr>
          <p:sp>
            <p:nvSpPr>
              <p:cNvPr id="7261" name="TextBox 6"/>
              <p:cNvSpPr txBox="1">
                <a:spLocks noChangeArrowheads="1"/>
              </p:cNvSpPr>
              <p:nvPr/>
            </p:nvSpPr>
            <p:spPr bwMode="auto">
              <a:xfrm>
                <a:off x="3137752" y="571472"/>
                <a:ext cx="224791" cy="215366"/>
              </a:xfrm>
              <a:prstGeom prst="rect">
                <a:avLst/>
              </a:prstGeom>
              <a:noFill/>
              <a:ln w="9525">
                <a:noFill/>
                <a:miter lim="800000"/>
                <a:headEnd/>
                <a:tailEnd/>
              </a:ln>
            </p:spPr>
            <p:txBody>
              <a:bodyPr wrap="none">
                <a:spAutoFit/>
              </a:bodyPr>
              <a:lstStyle/>
              <a:p>
                <a:r>
                  <a:rPr lang="en-US" sz="800" b="1"/>
                  <a:t>*</a:t>
                </a:r>
                <a:endParaRPr lang="en-IN" sz="800" b="1"/>
              </a:p>
            </p:txBody>
          </p:sp>
          <p:grpSp>
            <p:nvGrpSpPr>
              <p:cNvPr id="7262" name="Group 33"/>
              <p:cNvGrpSpPr>
                <a:grpSpLocks/>
              </p:cNvGrpSpPr>
              <p:nvPr/>
            </p:nvGrpSpPr>
            <p:grpSpPr bwMode="auto">
              <a:xfrm>
                <a:off x="1251149" y="-26865"/>
                <a:ext cx="2719222" cy="2161393"/>
                <a:chOff x="1749620" y="415161"/>
                <a:chExt cx="3630812" cy="2390814"/>
              </a:xfrm>
            </p:grpSpPr>
            <p:graphicFrame>
              <p:nvGraphicFramePr>
                <p:cNvPr id="93" name="Chart 92"/>
                <p:cNvGraphicFramePr/>
                <p:nvPr/>
              </p:nvGraphicFramePr>
              <p:xfrm>
                <a:off x="1904702" y="468831"/>
                <a:ext cx="3475730" cy="2337144"/>
              </p:xfrm>
              <a:graphic>
                <a:graphicData uri="http://schemas.openxmlformats.org/drawingml/2006/chart">
                  <c:chart xmlns:c="http://schemas.openxmlformats.org/drawingml/2006/chart" xmlns:r="http://schemas.openxmlformats.org/officeDocument/2006/relationships" r:id="rId3"/>
                </a:graphicData>
              </a:graphic>
            </p:graphicFrame>
            <p:sp>
              <p:nvSpPr>
                <p:cNvPr id="7275" name="TextBox 2"/>
                <p:cNvSpPr txBox="1">
                  <a:spLocks noChangeArrowheads="1"/>
                </p:cNvSpPr>
                <p:nvPr/>
              </p:nvSpPr>
              <p:spPr bwMode="auto">
                <a:xfrm rot="-5400000">
                  <a:off x="897995" y="1266786"/>
                  <a:ext cx="1991061" cy="287811"/>
                </a:xfrm>
                <a:prstGeom prst="rect">
                  <a:avLst/>
                </a:prstGeom>
                <a:noFill/>
                <a:ln w="9525">
                  <a:noFill/>
                  <a:miter lim="800000"/>
                  <a:headEnd/>
                  <a:tailEnd/>
                </a:ln>
              </p:spPr>
              <p:txBody>
                <a:bodyPr>
                  <a:spAutoFit/>
                </a:bodyPr>
                <a:lstStyle/>
                <a:p>
                  <a:pPr algn="ctr"/>
                  <a:r>
                    <a:rPr lang="en-US" sz="800" b="1"/>
                    <a:t>Relative water content (%)</a:t>
                  </a:r>
                  <a:endParaRPr lang="en-IN" sz="800" b="1"/>
                </a:p>
              </p:txBody>
            </p:sp>
          </p:grpSp>
          <p:sp>
            <p:nvSpPr>
              <p:cNvPr id="7263" name="Rectangle 42"/>
              <p:cNvSpPr>
                <a:spLocks noChangeArrowheads="1"/>
              </p:cNvSpPr>
              <p:nvPr/>
            </p:nvSpPr>
            <p:spPr bwMode="auto">
              <a:xfrm>
                <a:off x="2312480" y="255411"/>
                <a:ext cx="242427" cy="215366"/>
              </a:xfrm>
              <a:prstGeom prst="rect">
                <a:avLst/>
              </a:prstGeom>
              <a:noFill/>
              <a:ln w="9525">
                <a:noFill/>
                <a:miter lim="800000"/>
                <a:headEnd/>
                <a:tailEnd/>
              </a:ln>
            </p:spPr>
            <p:txBody>
              <a:bodyPr wrap="none">
                <a:spAutoFit/>
              </a:bodyPr>
              <a:lstStyle/>
              <a:p>
                <a:r>
                  <a:rPr lang="en-IN" sz="800" b="1"/>
                  <a:t>†</a:t>
                </a:r>
              </a:p>
            </p:txBody>
          </p:sp>
          <p:sp>
            <p:nvSpPr>
              <p:cNvPr id="7264" name="Rectangle 51"/>
              <p:cNvSpPr>
                <a:spLocks noChangeArrowheads="1"/>
              </p:cNvSpPr>
              <p:nvPr/>
            </p:nvSpPr>
            <p:spPr bwMode="auto">
              <a:xfrm>
                <a:off x="2399499" y="231296"/>
                <a:ext cx="242427" cy="215366"/>
              </a:xfrm>
              <a:prstGeom prst="rect">
                <a:avLst/>
              </a:prstGeom>
              <a:noFill/>
              <a:ln w="9525">
                <a:noFill/>
                <a:miter lim="800000"/>
                <a:headEnd/>
                <a:tailEnd/>
              </a:ln>
            </p:spPr>
            <p:txBody>
              <a:bodyPr wrap="none">
                <a:spAutoFit/>
              </a:bodyPr>
              <a:lstStyle/>
              <a:p>
                <a:r>
                  <a:rPr lang="en-IN" sz="800" b="1"/>
                  <a:t>‡</a:t>
                </a:r>
              </a:p>
            </p:txBody>
          </p:sp>
          <p:sp>
            <p:nvSpPr>
              <p:cNvPr id="7265" name="Rectangle 51"/>
              <p:cNvSpPr>
                <a:spLocks noChangeArrowheads="1"/>
              </p:cNvSpPr>
              <p:nvPr/>
            </p:nvSpPr>
            <p:spPr bwMode="auto">
              <a:xfrm>
                <a:off x="2828742" y="458695"/>
                <a:ext cx="242427" cy="215366"/>
              </a:xfrm>
              <a:prstGeom prst="rect">
                <a:avLst/>
              </a:prstGeom>
              <a:noFill/>
              <a:ln w="9525">
                <a:noFill/>
                <a:miter lim="800000"/>
                <a:headEnd/>
                <a:tailEnd/>
              </a:ln>
            </p:spPr>
            <p:txBody>
              <a:bodyPr wrap="none">
                <a:spAutoFit/>
              </a:bodyPr>
              <a:lstStyle/>
              <a:p>
                <a:r>
                  <a:rPr lang="en-IN" sz="800" b="1"/>
                  <a:t>‡</a:t>
                </a:r>
              </a:p>
            </p:txBody>
          </p:sp>
          <p:sp>
            <p:nvSpPr>
              <p:cNvPr id="7266" name="Rectangle 51"/>
              <p:cNvSpPr>
                <a:spLocks noChangeArrowheads="1"/>
              </p:cNvSpPr>
              <p:nvPr/>
            </p:nvSpPr>
            <p:spPr bwMode="auto">
              <a:xfrm>
                <a:off x="3297839" y="602475"/>
                <a:ext cx="242427" cy="215366"/>
              </a:xfrm>
              <a:prstGeom prst="rect">
                <a:avLst/>
              </a:prstGeom>
              <a:noFill/>
              <a:ln w="9525">
                <a:noFill/>
                <a:miter lim="800000"/>
                <a:headEnd/>
                <a:tailEnd/>
              </a:ln>
            </p:spPr>
            <p:txBody>
              <a:bodyPr wrap="none">
                <a:spAutoFit/>
              </a:bodyPr>
              <a:lstStyle/>
              <a:p>
                <a:r>
                  <a:rPr lang="en-IN" sz="800" b="1"/>
                  <a:t>‡</a:t>
                </a:r>
              </a:p>
            </p:txBody>
          </p:sp>
          <p:sp>
            <p:nvSpPr>
              <p:cNvPr id="7267" name="Rectangle 51"/>
              <p:cNvSpPr>
                <a:spLocks noChangeArrowheads="1"/>
              </p:cNvSpPr>
              <p:nvPr/>
            </p:nvSpPr>
            <p:spPr bwMode="auto">
              <a:xfrm>
                <a:off x="3741708" y="928662"/>
                <a:ext cx="242427" cy="215366"/>
              </a:xfrm>
              <a:prstGeom prst="rect">
                <a:avLst/>
              </a:prstGeom>
              <a:noFill/>
              <a:ln w="9525">
                <a:noFill/>
                <a:miter lim="800000"/>
                <a:headEnd/>
                <a:tailEnd/>
              </a:ln>
            </p:spPr>
            <p:txBody>
              <a:bodyPr wrap="none">
                <a:spAutoFit/>
              </a:bodyPr>
              <a:lstStyle/>
              <a:p>
                <a:r>
                  <a:rPr lang="en-IN" sz="800" b="1"/>
                  <a:t>‡</a:t>
                </a:r>
              </a:p>
            </p:txBody>
          </p:sp>
          <p:sp>
            <p:nvSpPr>
              <p:cNvPr id="7268" name="Rectangle 42"/>
              <p:cNvSpPr>
                <a:spLocks noChangeArrowheads="1"/>
              </p:cNvSpPr>
              <p:nvPr/>
            </p:nvSpPr>
            <p:spPr bwMode="auto">
              <a:xfrm>
                <a:off x="2752326" y="444911"/>
                <a:ext cx="242427" cy="215366"/>
              </a:xfrm>
              <a:prstGeom prst="rect">
                <a:avLst/>
              </a:prstGeom>
              <a:noFill/>
              <a:ln w="9525">
                <a:noFill/>
                <a:miter lim="800000"/>
                <a:headEnd/>
                <a:tailEnd/>
              </a:ln>
            </p:spPr>
            <p:txBody>
              <a:bodyPr wrap="none">
                <a:spAutoFit/>
              </a:bodyPr>
              <a:lstStyle/>
              <a:p>
                <a:r>
                  <a:rPr lang="en-IN" sz="800" b="1"/>
                  <a:t>†</a:t>
                </a:r>
              </a:p>
            </p:txBody>
          </p:sp>
          <p:sp>
            <p:nvSpPr>
              <p:cNvPr id="7269" name="Rectangle 42"/>
              <p:cNvSpPr>
                <a:spLocks noChangeArrowheads="1"/>
              </p:cNvSpPr>
              <p:nvPr/>
            </p:nvSpPr>
            <p:spPr bwMode="auto">
              <a:xfrm>
                <a:off x="3206798" y="571472"/>
                <a:ext cx="242427" cy="215366"/>
              </a:xfrm>
              <a:prstGeom prst="rect">
                <a:avLst/>
              </a:prstGeom>
              <a:noFill/>
              <a:ln w="9525">
                <a:noFill/>
                <a:miter lim="800000"/>
                <a:headEnd/>
                <a:tailEnd/>
              </a:ln>
            </p:spPr>
            <p:txBody>
              <a:bodyPr wrap="none">
                <a:spAutoFit/>
              </a:bodyPr>
              <a:lstStyle/>
              <a:p>
                <a:r>
                  <a:rPr lang="en-IN" sz="800" b="1"/>
                  <a:t>†</a:t>
                </a:r>
              </a:p>
            </p:txBody>
          </p:sp>
          <p:sp>
            <p:nvSpPr>
              <p:cNvPr id="7270" name="Rectangle 42"/>
              <p:cNvSpPr>
                <a:spLocks noChangeArrowheads="1"/>
              </p:cNvSpPr>
              <p:nvPr/>
            </p:nvSpPr>
            <p:spPr bwMode="auto">
              <a:xfrm>
                <a:off x="3668639" y="928662"/>
                <a:ext cx="242427" cy="215366"/>
              </a:xfrm>
              <a:prstGeom prst="rect">
                <a:avLst/>
              </a:prstGeom>
              <a:noFill/>
              <a:ln w="9525">
                <a:noFill/>
                <a:miter lim="800000"/>
                <a:headEnd/>
                <a:tailEnd/>
              </a:ln>
            </p:spPr>
            <p:txBody>
              <a:bodyPr wrap="none">
                <a:spAutoFit/>
              </a:bodyPr>
              <a:lstStyle/>
              <a:p>
                <a:r>
                  <a:rPr lang="en-IN" sz="800" b="1"/>
                  <a:t>†</a:t>
                </a:r>
              </a:p>
            </p:txBody>
          </p:sp>
          <p:sp>
            <p:nvSpPr>
              <p:cNvPr id="7271" name="TextBox 6"/>
              <p:cNvSpPr txBox="1">
                <a:spLocks noChangeArrowheads="1"/>
              </p:cNvSpPr>
              <p:nvPr/>
            </p:nvSpPr>
            <p:spPr bwMode="auto">
              <a:xfrm>
                <a:off x="2246540" y="276899"/>
                <a:ext cx="224791" cy="215366"/>
              </a:xfrm>
              <a:prstGeom prst="rect">
                <a:avLst/>
              </a:prstGeom>
              <a:noFill/>
              <a:ln w="9525">
                <a:noFill/>
                <a:miter lim="800000"/>
                <a:headEnd/>
                <a:tailEnd/>
              </a:ln>
            </p:spPr>
            <p:txBody>
              <a:bodyPr wrap="none">
                <a:spAutoFit/>
              </a:bodyPr>
              <a:lstStyle/>
              <a:p>
                <a:r>
                  <a:rPr lang="en-US" sz="800" b="1"/>
                  <a:t>*</a:t>
                </a:r>
                <a:endParaRPr lang="en-IN" sz="800" b="1"/>
              </a:p>
            </p:txBody>
          </p:sp>
          <p:sp>
            <p:nvSpPr>
              <p:cNvPr id="7272" name="TextBox 6"/>
              <p:cNvSpPr txBox="1">
                <a:spLocks noChangeArrowheads="1"/>
              </p:cNvSpPr>
              <p:nvPr/>
            </p:nvSpPr>
            <p:spPr bwMode="auto">
              <a:xfrm>
                <a:off x="2675968" y="481559"/>
                <a:ext cx="224791" cy="215366"/>
              </a:xfrm>
              <a:prstGeom prst="rect">
                <a:avLst/>
              </a:prstGeom>
              <a:noFill/>
              <a:ln w="9525">
                <a:noFill/>
                <a:miter lim="800000"/>
                <a:headEnd/>
                <a:tailEnd/>
              </a:ln>
            </p:spPr>
            <p:txBody>
              <a:bodyPr wrap="none">
                <a:spAutoFit/>
              </a:bodyPr>
              <a:lstStyle/>
              <a:p>
                <a:r>
                  <a:rPr lang="en-US" sz="800" b="1"/>
                  <a:t>*</a:t>
                </a:r>
                <a:endParaRPr lang="en-IN" sz="800" b="1"/>
              </a:p>
            </p:txBody>
          </p:sp>
          <p:sp>
            <p:nvSpPr>
              <p:cNvPr id="7273" name="TextBox 6"/>
              <p:cNvSpPr txBox="1">
                <a:spLocks noChangeArrowheads="1"/>
              </p:cNvSpPr>
              <p:nvPr/>
            </p:nvSpPr>
            <p:spPr bwMode="auto">
              <a:xfrm>
                <a:off x="3599658" y="928662"/>
                <a:ext cx="224791" cy="215366"/>
              </a:xfrm>
              <a:prstGeom prst="rect">
                <a:avLst/>
              </a:prstGeom>
              <a:noFill/>
              <a:ln w="9525">
                <a:noFill/>
                <a:miter lim="800000"/>
                <a:headEnd/>
                <a:tailEnd/>
              </a:ln>
            </p:spPr>
            <p:txBody>
              <a:bodyPr wrap="none">
                <a:spAutoFit/>
              </a:bodyPr>
              <a:lstStyle/>
              <a:p>
                <a:r>
                  <a:rPr lang="en-US" sz="800" b="1"/>
                  <a:t>*</a:t>
                </a:r>
                <a:endParaRPr lang="en-IN" sz="800" b="1"/>
              </a:p>
            </p:txBody>
          </p:sp>
        </p:grpSp>
        <p:sp>
          <p:nvSpPr>
            <p:cNvPr id="7260" name="TextBox 93"/>
            <p:cNvSpPr txBox="1">
              <a:spLocks noChangeArrowheads="1"/>
            </p:cNvSpPr>
            <p:nvPr/>
          </p:nvSpPr>
          <p:spPr bwMode="auto">
            <a:xfrm>
              <a:off x="2009931" y="1903076"/>
              <a:ext cx="1419225" cy="215900"/>
            </a:xfrm>
            <a:prstGeom prst="rect">
              <a:avLst/>
            </a:prstGeom>
            <a:noFill/>
            <a:ln w="9525">
              <a:noFill/>
              <a:miter lim="800000"/>
              <a:headEnd/>
              <a:tailEnd/>
            </a:ln>
          </p:spPr>
          <p:txBody>
            <a:bodyPr>
              <a:spAutoFit/>
            </a:bodyPr>
            <a:lstStyle/>
            <a:p>
              <a:r>
                <a:rPr lang="en-US" sz="800" b="1"/>
                <a:t>Drought stress levels (%)</a:t>
              </a:r>
            </a:p>
          </p:txBody>
        </p:sp>
      </p:grpSp>
      <p:grpSp>
        <p:nvGrpSpPr>
          <p:cNvPr id="7173" name="Group 154"/>
          <p:cNvGrpSpPr>
            <a:grpSpLocks/>
          </p:cNvGrpSpPr>
          <p:nvPr/>
        </p:nvGrpSpPr>
        <p:grpSpPr bwMode="auto">
          <a:xfrm>
            <a:off x="0" y="2428860"/>
            <a:ext cx="6710363" cy="3046412"/>
            <a:chOff x="-24" y="2341563"/>
            <a:chExt cx="6710362" cy="3047052"/>
          </a:xfrm>
        </p:grpSpPr>
        <p:grpSp>
          <p:nvGrpSpPr>
            <p:cNvPr id="7174" name="Group 153"/>
            <p:cNvGrpSpPr>
              <a:grpSpLocks/>
            </p:cNvGrpSpPr>
            <p:nvPr/>
          </p:nvGrpSpPr>
          <p:grpSpPr bwMode="auto">
            <a:xfrm>
              <a:off x="-24" y="2341563"/>
              <a:ext cx="6710362" cy="3047052"/>
              <a:chOff x="-24" y="2341563"/>
              <a:chExt cx="6710362" cy="3047052"/>
            </a:xfrm>
          </p:grpSpPr>
          <p:grpSp>
            <p:nvGrpSpPr>
              <p:cNvPr id="7176" name="Group 136"/>
              <p:cNvGrpSpPr>
                <a:grpSpLocks/>
              </p:cNvGrpSpPr>
              <p:nvPr/>
            </p:nvGrpSpPr>
            <p:grpSpPr bwMode="auto">
              <a:xfrm>
                <a:off x="-24" y="2341563"/>
                <a:ext cx="6710362" cy="3047052"/>
                <a:chOff x="147638" y="2341563"/>
                <a:chExt cx="6710362" cy="3047052"/>
              </a:xfrm>
            </p:grpSpPr>
            <p:graphicFrame>
              <p:nvGraphicFramePr>
                <p:cNvPr id="136" name="Chart 135"/>
                <p:cNvGraphicFramePr/>
                <p:nvPr/>
              </p:nvGraphicFramePr>
              <p:xfrm>
                <a:off x="214290" y="2643174"/>
                <a:ext cx="6643710" cy="2745441"/>
              </p:xfrm>
              <a:graphic>
                <a:graphicData uri="http://schemas.openxmlformats.org/drawingml/2006/chart">
                  <c:chart xmlns:c="http://schemas.openxmlformats.org/drawingml/2006/chart" xmlns:r="http://schemas.openxmlformats.org/officeDocument/2006/relationships" r:id="rId4"/>
                </a:graphicData>
              </a:graphic>
            </p:graphicFrame>
            <p:grpSp>
              <p:nvGrpSpPr>
                <p:cNvPr id="7203" name="Group 119"/>
                <p:cNvGrpSpPr>
                  <a:grpSpLocks/>
                </p:cNvGrpSpPr>
                <p:nvPr/>
              </p:nvGrpSpPr>
              <p:grpSpPr bwMode="auto">
                <a:xfrm>
                  <a:off x="147638" y="2341563"/>
                  <a:ext cx="6655149" cy="2235113"/>
                  <a:chOff x="147411" y="2349796"/>
                  <a:chExt cx="6797317" cy="2452077"/>
                </a:xfrm>
              </p:grpSpPr>
              <p:sp>
                <p:nvSpPr>
                  <p:cNvPr id="7204" name="TextBox 31"/>
                  <p:cNvSpPr txBox="1">
                    <a:spLocks noChangeArrowheads="1"/>
                  </p:cNvSpPr>
                  <p:nvPr/>
                </p:nvSpPr>
                <p:spPr bwMode="auto">
                  <a:xfrm>
                    <a:off x="147411" y="2349796"/>
                    <a:ext cx="298307" cy="236407"/>
                  </a:xfrm>
                  <a:prstGeom prst="rect">
                    <a:avLst/>
                  </a:prstGeom>
                  <a:noFill/>
                  <a:ln w="9525">
                    <a:noFill/>
                    <a:miter lim="800000"/>
                    <a:headEnd/>
                    <a:tailEnd/>
                  </a:ln>
                </p:spPr>
                <p:txBody>
                  <a:bodyPr wrap="none">
                    <a:spAutoFit/>
                  </a:bodyPr>
                  <a:lstStyle/>
                  <a:p>
                    <a:r>
                      <a:rPr lang="en-US" sz="800" b="1" dirty="0"/>
                      <a:t>B)</a:t>
                    </a:r>
                    <a:endParaRPr lang="en-IN" sz="800" b="1" dirty="0"/>
                  </a:p>
                </p:txBody>
              </p:sp>
              <p:grpSp>
                <p:nvGrpSpPr>
                  <p:cNvPr id="7205" name="Group 116"/>
                  <p:cNvGrpSpPr>
                    <a:grpSpLocks/>
                  </p:cNvGrpSpPr>
                  <p:nvPr/>
                </p:nvGrpSpPr>
                <p:grpSpPr bwMode="auto">
                  <a:xfrm>
                    <a:off x="932181" y="2994323"/>
                    <a:ext cx="6012547" cy="1316123"/>
                    <a:chOff x="932181" y="2994323"/>
                    <a:chExt cx="6012547" cy="1316123"/>
                  </a:xfrm>
                </p:grpSpPr>
                <p:sp>
                  <p:nvSpPr>
                    <p:cNvPr id="7208" name="TextBox 6"/>
                    <p:cNvSpPr txBox="1">
                      <a:spLocks noChangeArrowheads="1"/>
                    </p:cNvSpPr>
                    <p:nvPr/>
                  </p:nvSpPr>
                  <p:spPr bwMode="auto">
                    <a:xfrm>
                      <a:off x="932181" y="3391265"/>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09" name="Rectangle 42"/>
                    <p:cNvSpPr>
                      <a:spLocks noChangeArrowheads="1"/>
                    </p:cNvSpPr>
                    <p:nvPr/>
                  </p:nvSpPr>
                  <p:spPr bwMode="auto">
                    <a:xfrm>
                      <a:off x="984066" y="3309410"/>
                      <a:ext cx="247552" cy="236407"/>
                    </a:xfrm>
                    <a:prstGeom prst="rect">
                      <a:avLst/>
                    </a:prstGeom>
                    <a:noFill/>
                    <a:ln w="9525">
                      <a:noFill/>
                      <a:miter lim="800000"/>
                      <a:headEnd/>
                      <a:tailEnd/>
                    </a:ln>
                  </p:spPr>
                  <p:txBody>
                    <a:bodyPr wrap="none">
                      <a:spAutoFit/>
                    </a:bodyPr>
                    <a:lstStyle/>
                    <a:p>
                      <a:r>
                        <a:rPr lang="en-IN" sz="800" b="1"/>
                        <a:t>†</a:t>
                      </a:r>
                    </a:p>
                  </p:txBody>
                </p:sp>
                <p:sp>
                  <p:nvSpPr>
                    <p:cNvPr id="7210" name="Rectangle 51"/>
                    <p:cNvSpPr>
                      <a:spLocks noChangeArrowheads="1"/>
                    </p:cNvSpPr>
                    <p:nvPr/>
                  </p:nvSpPr>
                  <p:spPr bwMode="auto">
                    <a:xfrm>
                      <a:off x="1055408" y="3300701"/>
                      <a:ext cx="247552" cy="236407"/>
                    </a:xfrm>
                    <a:prstGeom prst="rect">
                      <a:avLst/>
                    </a:prstGeom>
                    <a:noFill/>
                    <a:ln w="9525">
                      <a:noFill/>
                      <a:miter lim="800000"/>
                      <a:headEnd/>
                      <a:tailEnd/>
                    </a:ln>
                  </p:spPr>
                  <p:txBody>
                    <a:bodyPr wrap="none">
                      <a:spAutoFit/>
                    </a:bodyPr>
                    <a:lstStyle/>
                    <a:p>
                      <a:r>
                        <a:rPr lang="en-IN" sz="800" b="1"/>
                        <a:t>‡</a:t>
                      </a:r>
                    </a:p>
                  </p:txBody>
                </p:sp>
                <p:sp>
                  <p:nvSpPr>
                    <p:cNvPr id="7211" name="Rectangle 42"/>
                    <p:cNvSpPr>
                      <a:spLocks noChangeArrowheads="1"/>
                    </p:cNvSpPr>
                    <p:nvPr/>
                  </p:nvSpPr>
                  <p:spPr bwMode="auto">
                    <a:xfrm>
                      <a:off x="1361858" y="3365142"/>
                      <a:ext cx="247552" cy="236407"/>
                    </a:xfrm>
                    <a:prstGeom prst="rect">
                      <a:avLst/>
                    </a:prstGeom>
                    <a:noFill/>
                    <a:ln w="9525">
                      <a:noFill/>
                      <a:miter lim="800000"/>
                      <a:headEnd/>
                      <a:tailEnd/>
                    </a:ln>
                  </p:spPr>
                  <p:txBody>
                    <a:bodyPr wrap="none">
                      <a:spAutoFit/>
                    </a:bodyPr>
                    <a:lstStyle/>
                    <a:p>
                      <a:r>
                        <a:rPr lang="en-IN" sz="800" b="1"/>
                        <a:t>†</a:t>
                      </a:r>
                    </a:p>
                  </p:txBody>
                </p:sp>
                <p:sp>
                  <p:nvSpPr>
                    <p:cNvPr id="7212" name="Rectangle 42"/>
                    <p:cNvSpPr>
                      <a:spLocks noChangeArrowheads="1"/>
                    </p:cNvSpPr>
                    <p:nvPr/>
                  </p:nvSpPr>
                  <p:spPr bwMode="auto">
                    <a:xfrm>
                      <a:off x="1726678" y="3242033"/>
                      <a:ext cx="247552" cy="236407"/>
                    </a:xfrm>
                    <a:prstGeom prst="rect">
                      <a:avLst/>
                    </a:prstGeom>
                    <a:noFill/>
                    <a:ln w="9525">
                      <a:noFill/>
                      <a:miter lim="800000"/>
                      <a:headEnd/>
                      <a:tailEnd/>
                    </a:ln>
                  </p:spPr>
                  <p:txBody>
                    <a:bodyPr wrap="none">
                      <a:spAutoFit/>
                    </a:bodyPr>
                    <a:lstStyle/>
                    <a:p>
                      <a:r>
                        <a:rPr lang="en-IN" sz="800" b="1"/>
                        <a:t>†</a:t>
                      </a:r>
                    </a:p>
                  </p:txBody>
                </p:sp>
                <p:sp>
                  <p:nvSpPr>
                    <p:cNvPr id="7213" name="Rectangle 42"/>
                    <p:cNvSpPr>
                      <a:spLocks noChangeArrowheads="1"/>
                    </p:cNvSpPr>
                    <p:nvPr/>
                  </p:nvSpPr>
                  <p:spPr bwMode="auto">
                    <a:xfrm>
                      <a:off x="2113412" y="3327372"/>
                      <a:ext cx="247552" cy="236407"/>
                    </a:xfrm>
                    <a:prstGeom prst="rect">
                      <a:avLst/>
                    </a:prstGeom>
                    <a:noFill/>
                    <a:ln w="9525">
                      <a:noFill/>
                      <a:miter lim="800000"/>
                      <a:headEnd/>
                      <a:tailEnd/>
                    </a:ln>
                  </p:spPr>
                  <p:txBody>
                    <a:bodyPr wrap="none">
                      <a:spAutoFit/>
                    </a:bodyPr>
                    <a:lstStyle/>
                    <a:p>
                      <a:r>
                        <a:rPr lang="en-IN" sz="800" b="1"/>
                        <a:t>†</a:t>
                      </a:r>
                    </a:p>
                  </p:txBody>
                </p:sp>
                <p:sp>
                  <p:nvSpPr>
                    <p:cNvPr id="7214" name="Rectangle 42"/>
                    <p:cNvSpPr>
                      <a:spLocks noChangeArrowheads="1"/>
                    </p:cNvSpPr>
                    <p:nvPr/>
                  </p:nvSpPr>
                  <p:spPr bwMode="auto">
                    <a:xfrm>
                      <a:off x="2484281" y="3505017"/>
                      <a:ext cx="247552" cy="236407"/>
                    </a:xfrm>
                    <a:prstGeom prst="rect">
                      <a:avLst/>
                    </a:prstGeom>
                    <a:noFill/>
                    <a:ln w="9525">
                      <a:noFill/>
                      <a:miter lim="800000"/>
                      <a:headEnd/>
                      <a:tailEnd/>
                    </a:ln>
                  </p:spPr>
                  <p:txBody>
                    <a:bodyPr wrap="none">
                      <a:spAutoFit/>
                    </a:bodyPr>
                    <a:lstStyle/>
                    <a:p>
                      <a:r>
                        <a:rPr lang="en-IN" sz="800" b="1"/>
                        <a:t>†</a:t>
                      </a:r>
                    </a:p>
                  </p:txBody>
                </p:sp>
                <p:sp>
                  <p:nvSpPr>
                    <p:cNvPr id="7215" name="Rectangle 42"/>
                    <p:cNvSpPr>
                      <a:spLocks noChangeArrowheads="1"/>
                    </p:cNvSpPr>
                    <p:nvPr/>
                  </p:nvSpPr>
                  <p:spPr bwMode="auto">
                    <a:xfrm>
                      <a:off x="2868995" y="3569457"/>
                      <a:ext cx="247552" cy="236407"/>
                    </a:xfrm>
                    <a:prstGeom prst="rect">
                      <a:avLst/>
                    </a:prstGeom>
                    <a:noFill/>
                    <a:ln w="9525">
                      <a:noFill/>
                      <a:miter lim="800000"/>
                      <a:headEnd/>
                      <a:tailEnd/>
                    </a:ln>
                  </p:spPr>
                  <p:txBody>
                    <a:bodyPr wrap="none">
                      <a:spAutoFit/>
                    </a:bodyPr>
                    <a:lstStyle/>
                    <a:p>
                      <a:r>
                        <a:rPr lang="en-IN" sz="800" b="1"/>
                        <a:t>†</a:t>
                      </a:r>
                    </a:p>
                  </p:txBody>
                </p:sp>
                <p:sp>
                  <p:nvSpPr>
                    <p:cNvPr id="7216" name="Rectangle 42"/>
                    <p:cNvSpPr>
                      <a:spLocks noChangeArrowheads="1"/>
                    </p:cNvSpPr>
                    <p:nvPr/>
                  </p:nvSpPr>
                  <p:spPr bwMode="auto">
                    <a:xfrm>
                      <a:off x="3247804" y="3548558"/>
                      <a:ext cx="247552" cy="236407"/>
                    </a:xfrm>
                    <a:prstGeom prst="rect">
                      <a:avLst/>
                    </a:prstGeom>
                    <a:noFill/>
                    <a:ln w="9525">
                      <a:noFill/>
                      <a:miter lim="800000"/>
                      <a:headEnd/>
                      <a:tailEnd/>
                    </a:ln>
                  </p:spPr>
                  <p:txBody>
                    <a:bodyPr wrap="none">
                      <a:spAutoFit/>
                    </a:bodyPr>
                    <a:lstStyle/>
                    <a:p>
                      <a:r>
                        <a:rPr lang="en-IN" sz="800" b="1"/>
                        <a:t>†</a:t>
                      </a:r>
                    </a:p>
                  </p:txBody>
                </p:sp>
                <p:sp>
                  <p:nvSpPr>
                    <p:cNvPr id="7217" name="Rectangle 42"/>
                    <p:cNvSpPr>
                      <a:spLocks noChangeArrowheads="1"/>
                    </p:cNvSpPr>
                    <p:nvPr/>
                  </p:nvSpPr>
                  <p:spPr bwMode="auto">
                    <a:xfrm>
                      <a:off x="3615636" y="3527659"/>
                      <a:ext cx="247552" cy="236407"/>
                    </a:xfrm>
                    <a:prstGeom prst="rect">
                      <a:avLst/>
                    </a:prstGeom>
                    <a:noFill/>
                    <a:ln w="9525">
                      <a:noFill/>
                      <a:miter lim="800000"/>
                      <a:headEnd/>
                      <a:tailEnd/>
                    </a:ln>
                  </p:spPr>
                  <p:txBody>
                    <a:bodyPr wrap="none">
                      <a:spAutoFit/>
                    </a:bodyPr>
                    <a:lstStyle/>
                    <a:p>
                      <a:r>
                        <a:rPr lang="en-IN" sz="800" b="1"/>
                        <a:t>†</a:t>
                      </a:r>
                    </a:p>
                  </p:txBody>
                </p:sp>
                <p:sp>
                  <p:nvSpPr>
                    <p:cNvPr id="7218" name="Rectangle 42"/>
                    <p:cNvSpPr>
                      <a:spLocks noChangeArrowheads="1"/>
                    </p:cNvSpPr>
                    <p:nvPr/>
                  </p:nvSpPr>
                  <p:spPr bwMode="auto">
                    <a:xfrm>
                      <a:off x="3993005" y="3650590"/>
                      <a:ext cx="247552" cy="236407"/>
                    </a:xfrm>
                    <a:prstGeom prst="rect">
                      <a:avLst/>
                    </a:prstGeom>
                    <a:noFill/>
                    <a:ln w="9525">
                      <a:noFill/>
                      <a:miter lim="800000"/>
                      <a:headEnd/>
                      <a:tailEnd/>
                    </a:ln>
                  </p:spPr>
                  <p:txBody>
                    <a:bodyPr wrap="none">
                      <a:spAutoFit/>
                    </a:bodyPr>
                    <a:lstStyle/>
                    <a:p>
                      <a:r>
                        <a:rPr lang="en-IN" sz="800" b="1"/>
                        <a:t>†</a:t>
                      </a:r>
                    </a:p>
                  </p:txBody>
                </p:sp>
                <p:sp>
                  <p:nvSpPr>
                    <p:cNvPr id="7219" name="Rectangle 42"/>
                    <p:cNvSpPr>
                      <a:spLocks noChangeArrowheads="1"/>
                    </p:cNvSpPr>
                    <p:nvPr/>
                  </p:nvSpPr>
                  <p:spPr bwMode="auto">
                    <a:xfrm>
                      <a:off x="4369415" y="3676762"/>
                      <a:ext cx="247552" cy="236407"/>
                    </a:xfrm>
                    <a:prstGeom prst="rect">
                      <a:avLst/>
                    </a:prstGeom>
                    <a:noFill/>
                    <a:ln w="9525">
                      <a:noFill/>
                      <a:miter lim="800000"/>
                      <a:headEnd/>
                      <a:tailEnd/>
                    </a:ln>
                  </p:spPr>
                  <p:txBody>
                    <a:bodyPr wrap="none">
                      <a:spAutoFit/>
                    </a:bodyPr>
                    <a:lstStyle/>
                    <a:p>
                      <a:r>
                        <a:rPr lang="en-IN" sz="800" b="1"/>
                        <a:t>†</a:t>
                      </a:r>
                    </a:p>
                  </p:txBody>
                </p:sp>
                <p:sp>
                  <p:nvSpPr>
                    <p:cNvPr id="7220" name="Rectangle 42"/>
                    <p:cNvSpPr>
                      <a:spLocks noChangeArrowheads="1"/>
                    </p:cNvSpPr>
                    <p:nvPr/>
                  </p:nvSpPr>
                  <p:spPr bwMode="auto">
                    <a:xfrm>
                      <a:off x="4742422" y="3697168"/>
                      <a:ext cx="247552" cy="236407"/>
                    </a:xfrm>
                    <a:prstGeom prst="rect">
                      <a:avLst/>
                    </a:prstGeom>
                    <a:noFill/>
                    <a:ln w="9525">
                      <a:noFill/>
                      <a:miter lim="800000"/>
                      <a:headEnd/>
                      <a:tailEnd/>
                    </a:ln>
                  </p:spPr>
                  <p:txBody>
                    <a:bodyPr wrap="none">
                      <a:spAutoFit/>
                    </a:bodyPr>
                    <a:lstStyle/>
                    <a:p>
                      <a:r>
                        <a:rPr lang="en-IN" sz="800" b="1"/>
                        <a:t>†</a:t>
                      </a:r>
                    </a:p>
                  </p:txBody>
                </p:sp>
                <p:sp>
                  <p:nvSpPr>
                    <p:cNvPr id="7221" name="Rectangle 42"/>
                    <p:cNvSpPr>
                      <a:spLocks noChangeArrowheads="1"/>
                    </p:cNvSpPr>
                    <p:nvPr/>
                  </p:nvSpPr>
                  <p:spPr bwMode="auto">
                    <a:xfrm>
                      <a:off x="5117698" y="3605520"/>
                      <a:ext cx="247552" cy="236407"/>
                    </a:xfrm>
                    <a:prstGeom prst="rect">
                      <a:avLst/>
                    </a:prstGeom>
                    <a:noFill/>
                    <a:ln w="9525">
                      <a:noFill/>
                      <a:miter lim="800000"/>
                      <a:headEnd/>
                      <a:tailEnd/>
                    </a:ln>
                  </p:spPr>
                  <p:txBody>
                    <a:bodyPr wrap="none">
                      <a:spAutoFit/>
                    </a:bodyPr>
                    <a:lstStyle/>
                    <a:p>
                      <a:r>
                        <a:rPr lang="en-IN" sz="800" b="1"/>
                        <a:t>†</a:t>
                      </a:r>
                    </a:p>
                  </p:txBody>
                </p:sp>
                <p:sp>
                  <p:nvSpPr>
                    <p:cNvPr id="7222" name="Rectangle 42"/>
                    <p:cNvSpPr>
                      <a:spLocks noChangeArrowheads="1"/>
                    </p:cNvSpPr>
                    <p:nvPr/>
                  </p:nvSpPr>
                  <p:spPr bwMode="auto">
                    <a:xfrm>
                      <a:off x="5497323" y="3933456"/>
                      <a:ext cx="247552" cy="236407"/>
                    </a:xfrm>
                    <a:prstGeom prst="rect">
                      <a:avLst/>
                    </a:prstGeom>
                    <a:noFill/>
                    <a:ln w="9525">
                      <a:noFill/>
                      <a:miter lim="800000"/>
                      <a:headEnd/>
                      <a:tailEnd/>
                    </a:ln>
                  </p:spPr>
                  <p:txBody>
                    <a:bodyPr wrap="none">
                      <a:spAutoFit/>
                    </a:bodyPr>
                    <a:lstStyle/>
                    <a:p>
                      <a:r>
                        <a:rPr lang="en-IN" sz="800" b="1"/>
                        <a:t>†</a:t>
                      </a:r>
                    </a:p>
                  </p:txBody>
                </p:sp>
                <p:sp>
                  <p:nvSpPr>
                    <p:cNvPr id="7223" name="Rectangle 42"/>
                    <p:cNvSpPr>
                      <a:spLocks noChangeArrowheads="1"/>
                    </p:cNvSpPr>
                    <p:nvPr/>
                  </p:nvSpPr>
                  <p:spPr bwMode="auto">
                    <a:xfrm>
                      <a:off x="5867007" y="3947389"/>
                      <a:ext cx="247552" cy="236407"/>
                    </a:xfrm>
                    <a:prstGeom prst="rect">
                      <a:avLst/>
                    </a:prstGeom>
                    <a:noFill/>
                    <a:ln w="9525">
                      <a:noFill/>
                      <a:miter lim="800000"/>
                      <a:headEnd/>
                      <a:tailEnd/>
                    </a:ln>
                  </p:spPr>
                  <p:txBody>
                    <a:bodyPr wrap="none">
                      <a:spAutoFit/>
                    </a:bodyPr>
                    <a:lstStyle/>
                    <a:p>
                      <a:r>
                        <a:rPr lang="en-IN" sz="800" b="1"/>
                        <a:t>†</a:t>
                      </a:r>
                    </a:p>
                  </p:txBody>
                </p:sp>
                <p:sp>
                  <p:nvSpPr>
                    <p:cNvPr id="7224" name="Rectangle 42"/>
                    <p:cNvSpPr>
                      <a:spLocks noChangeArrowheads="1"/>
                    </p:cNvSpPr>
                    <p:nvPr/>
                  </p:nvSpPr>
                  <p:spPr bwMode="auto">
                    <a:xfrm>
                      <a:off x="6243965" y="3913751"/>
                      <a:ext cx="247552" cy="236407"/>
                    </a:xfrm>
                    <a:prstGeom prst="rect">
                      <a:avLst/>
                    </a:prstGeom>
                    <a:noFill/>
                    <a:ln w="9525">
                      <a:noFill/>
                      <a:miter lim="800000"/>
                      <a:headEnd/>
                      <a:tailEnd/>
                    </a:ln>
                  </p:spPr>
                  <p:txBody>
                    <a:bodyPr wrap="none">
                      <a:spAutoFit/>
                    </a:bodyPr>
                    <a:lstStyle/>
                    <a:p>
                      <a:r>
                        <a:rPr lang="en-IN" sz="800" b="1"/>
                        <a:t>†</a:t>
                      </a:r>
                    </a:p>
                  </p:txBody>
                </p:sp>
                <p:sp>
                  <p:nvSpPr>
                    <p:cNvPr id="7225" name="Rectangle 42"/>
                    <p:cNvSpPr>
                      <a:spLocks noChangeArrowheads="1"/>
                    </p:cNvSpPr>
                    <p:nvPr/>
                  </p:nvSpPr>
                  <p:spPr bwMode="auto">
                    <a:xfrm>
                      <a:off x="6624213" y="3908522"/>
                      <a:ext cx="247552" cy="236407"/>
                    </a:xfrm>
                    <a:prstGeom prst="rect">
                      <a:avLst/>
                    </a:prstGeom>
                    <a:noFill/>
                    <a:ln w="9525">
                      <a:noFill/>
                      <a:miter lim="800000"/>
                      <a:headEnd/>
                      <a:tailEnd/>
                    </a:ln>
                  </p:spPr>
                  <p:txBody>
                    <a:bodyPr wrap="none">
                      <a:spAutoFit/>
                    </a:bodyPr>
                    <a:lstStyle/>
                    <a:p>
                      <a:r>
                        <a:rPr lang="en-IN" sz="800" b="1"/>
                        <a:t>†</a:t>
                      </a:r>
                    </a:p>
                  </p:txBody>
                </p:sp>
                <p:sp>
                  <p:nvSpPr>
                    <p:cNvPr id="7226" name="Rectangle 51"/>
                    <p:cNvSpPr>
                      <a:spLocks noChangeArrowheads="1"/>
                    </p:cNvSpPr>
                    <p:nvPr/>
                  </p:nvSpPr>
                  <p:spPr bwMode="auto">
                    <a:xfrm>
                      <a:off x="1426714" y="3365142"/>
                      <a:ext cx="247552" cy="236407"/>
                    </a:xfrm>
                    <a:prstGeom prst="rect">
                      <a:avLst/>
                    </a:prstGeom>
                    <a:noFill/>
                    <a:ln w="9525">
                      <a:noFill/>
                      <a:miter lim="800000"/>
                      <a:headEnd/>
                      <a:tailEnd/>
                    </a:ln>
                  </p:spPr>
                  <p:txBody>
                    <a:bodyPr wrap="none">
                      <a:spAutoFit/>
                    </a:bodyPr>
                    <a:lstStyle/>
                    <a:p>
                      <a:r>
                        <a:rPr lang="en-IN" sz="800" b="1"/>
                        <a:t>‡</a:t>
                      </a:r>
                    </a:p>
                  </p:txBody>
                </p:sp>
                <p:sp>
                  <p:nvSpPr>
                    <p:cNvPr id="7227" name="Rectangle 51"/>
                    <p:cNvSpPr>
                      <a:spLocks noChangeArrowheads="1"/>
                    </p:cNvSpPr>
                    <p:nvPr/>
                  </p:nvSpPr>
                  <p:spPr bwMode="auto">
                    <a:xfrm>
                      <a:off x="1819099" y="3304731"/>
                      <a:ext cx="247552" cy="236407"/>
                    </a:xfrm>
                    <a:prstGeom prst="rect">
                      <a:avLst/>
                    </a:prstGeom>
                    <a:noFill/>
                    <a:ln w="9525">
                      <a:noFill/>
                      <a:miter lim="800000"/>
                      <a:headEnd/>
                      <a:tailEnd/>
                    </a:ln>
                  </p:spPr>
                  <p:txBody>
                    <a:bodyPr wrap="none">
                      <a:spAutoFit/>
                    </a:bodyPr>
                    <a:lstStyle/>
                    <a:p>
                      <a:r>
                        <a:rPr lang="en-IN" sz="800" b="1"/>
                        <a:t>‡</a:t>
                      </a:r>
                    </a:p>
                  </p:txBody>
                </p:sp>
                <p:sp>
                  <p:nvSpPr>
                    <p:cNvPr id="7228" name="Rectangle 51"/>
                    <p:cNvSpPr>
                      <a:spLocks noChangeArrowheads="1"/>
                    </p:cNvSpPr>
                    <p:nvPr/>
                  </p:nvSpPr>
                  <p:spPr bwMode="auto">
                    <a:xfrm>
                      <a:off x="2190405" y="3365142"/>
                      <a:ext cx="247552" cy="236407"/>
                    </a:xfrm>
                    <a:prstGeom prst="rect">
                      <a:avLst/>
                    </a:prstGeom>
                    <a:noFill/>
                    <a:ln w="9525">
                      <a:noFill/>
                      <a:miter lim="800000"/>
                      <a:headEnd/>
                      <a:tailEnd/>
                    </a:ln>
                  </p:spPr>
                  <p:txBody>
                    <a:bodyPr wrap="none">
                      <a:spAutoFit/>
                    </a:bodyPr>
                    <a:lstStyle/>
                    <a:p>
                      <a:r>
                        <a:rPr lang="en-IN" sz="800" b="1"/>
                        <a:t>‡</a:t>
                      </a:r>
                    </a:p>
                  </p:txBody>
                </p:sp>
                <p:sp>
                  <p:nvSpPr>
                    <p:cNvPr id="7229" name="Rectangle 51"/>
                    <p:cNvSpPr>
                      <a:spLocks noChangeArrowheads="1"/>
                    </p:cNvSpPr>
                    <p:nvPr/>
                  </p:nvSpPr>
                  <p:spPr bwMode="auto">
                    <a:xfrm>
                      <a:off x="2555226" y="3518950"/>
                      <a:ext cx="247552" cy="236407"/>
                    </a:xfrm>
                    <a:prstGeom prst="rect">
                      <a:avLst/>
                    </a:prstGeom>
                    <a:noFill/>
                    <a:ln w="9525">
                      <a:noFill/>
                      <a:miter lim="800000"/>
                      <a:headEnd/>
                      <a:tailEnd/>
                    </a:ln>
                  </p:spPr>
                  <p:txBody>
                    <a:bodyPr wrap="none">
                      <a:spAutoFit/>
                    </a:bodyPr>
                    <a:lstStyle/>
                    <a:p>
                      <a:r>
                        <a:rPr lang="en-IN" sz="800" b="1"/>
                        <a:t>‡</a:t>
                      </a:r>
                    </a:p>
                  </p:txBody>
                </p:sp>
                <p:sp>
                  <p:nvSpPr>
                    <p:cNvPr id="7230" name="Rectangle 51"/>
                    <p:cNvSpPr>
                      <a:spLocks noChangeArrowheads="1"/>
                    </p:cNvSpPr>
                    <p:nvPr/>
                  </p:nvSpPr>
                  <p:spPr bwMode="auto">
                    <a:xfrm>
                      <a:off x="2933017" y="3535820"/>
                      <a:ext cx="247552" cy="236407"/>
                    </a:xfrm>
                    <a:prstGeom prst="rect">
                      <a:avLst/>
                    </a:prstGeom>
                    <a:noFill/>
                    <a:ln w="9525">
                      <a:noFill/>
                      <a:miter lim="800000"/>
                      <a:headEnd/>
                      <a:tailEnd/>
                    </a:ln>
                  </p:spPr>
                  <p:txBody>
                    <a:bodyPr wrap="none">
                      <a:spAutoFit/>
                    </a:bodyPr>
                    <a:lstStyle/>
                    <a:p>
                      <a:r>
                        <a:rPr lang="en-IN" sz="800" b="1"/>
                        <a:t>‡</a:t>
                      </a:r>
                    </a:p>
                  </p:txBody>
                </p:sp>
                <p:sp>
                  <p:nvSpPr>
                    <p:cNvPr id="7231" name="Rectangle 51"/>
                    <p:cNvSpPr>
                      <a:spLocks noChangeArrowheads="1"/>
                    </p:cNvSpPr>
                    <p:nvPr/>
                  </p:nvSpPr>
                  <p:spPr bwMode="auto">
                    <a:xfrm>
                      <a:off x="3313933" y="3463219"/>
                      <a:ext cx="247552" cy="236407"/>
                    </a:xfrm>
                    <a:prstGeom prst="rect">
                      <a:avLst/>
                    </a:prstGeom>
                    <a:noFill/>
                    <a:ln w="9525">
                      <a:noFill/>
                      <a:miter lim="800000"/>
                      <a:headEnd/>
                      <a:tailEnd/>
                    </a:ln>
                  </p:spPr>
                  <p:txBody>
                    <a:bodyPr wrap="none">
                      <a:spAutoFit/>
                    </a:bodyPr>
                    <a:lstStyle/>
                    <a:p>
                      <a:r>
                        <a:rPr lang="en-IN" sz="800" b="1"/>
                        <a:t>‡</a:t>
                      </a:r>
                    </a:p>
                  </p:txBody>
                </p:sp>
                <p:sp>
                  <p:nvSpPr>
                    <p:cNvPr id="7232" name="Rectangle 51"/>
                    <p:cNvSpPr>
                      <a:spLocks noChangeArrowheads="1"/>
                    </p:cNvSpPr>
                    <p:nvPr/>
                  </p:nvSpPr>
                  <p:spPr bwMode="auto">
                    <a:xfrm>
                      <a:off x="3694203" y="3505017"/>
                      <a:ext cx="247552" cy="236407"/>
                    </a:xfrm>
                    <a:prstGeom prst="rect">
                      <a:avLst/>
                    </a:prstGeom>
                    <a:noFill/>
                    <a:ln w="9525">
                      <a:noFill/>
                      <a:miter lim="800000"/>
                      <a:headEnd/>
                      <a:tailEnd/>
                    </a:ln>
                  </p:spPr>
                  <p:txBody>
                    <a:bodyPr wrap="none">
                      <a:spAutoFit/>
                    </a:bodyPr>
                    <a:lstStyle/>
                    <a:p>
                      <a:r>
                        <a:rPr lang="en-IN" sz="800" b="1"/>
                        <a:t>‡</a:t>
                      </a:r>
                    </a:p>
                  </p:txBody>
                </p:sp>
                <p:sp>
                  <p:nvSpPr>
                    <p:cNvPr id="7233" name="Rectangle 51"/>
                    <p:cNvSpPr>
                      <a:spLocks noChangeArrowheads="1"/>
                    </p:cNvSpPr>
                    <p:nvPr/>
                  </p:nvSpPr>
                  <p:spPr bwMode="auto">
                    <a:xfrm>
                      <a:off x="4067988" y="3698337"/>
                      <a:ext cx="247552" cy="236407"/>
                    </a:xfrm>
                    <a:prstGeom prst="rect">
                      <a:avLst/>
                    </a:prstGeom>
                    <a:noFill/>
                    <a:ln w="9525">
                      <a:noFill/>
                      <a:miter lim="800000"/>
                      <a:headEnd/>
                      <a:tailEnd/>
                    </a:ln>
                  </p:spPr>
                  <p:txBody>
                    <a:bodyPr wrap="none">
                      <a:spAutoFit/>
                    </a:bodyPr>
                    <a:lstStyle/>
                    <a:p>
                      <a:r>
                        <a:rPr lang="en-IN" sz="800" b="1"/>
                        <a:t>‡</a:t>
                      </a:r>
                    </a:p>
                  </p:txBody>
                </p:sp>
                <p:sp>
                  <p:nvSpPr>
                    <p:cNvPr id="7234" name="Rectangle 51"/>
                    <p:cNvSpPr>
                      <a:spLocks noChangeArrowheads="1"/>
                    </p:cNvSpPr>
                    <p:nvPr/>
                  </p:nvSpPr>
                  <p:spPr bwMode="auto">
                    <a:xfrm>
                      <a:off x="4435287" y="3675696"/>
                      <a:ext cx="247552" cy="236407"/>
                    </a:xfrm>
                    <a:prstGeom prst="rect">
                      <a:avLst/>
                    </a:prstGeom>
                    <a:noFill/>
                    <a:ln w="9525">
                      <a:noFill/>
                      <a:miter lim="800000"/>
                      <a:headEnd/>
                      <a:tailEnd/>
                    </a:ln>
                  </p:spPr>
                  <p:txBody>
                    <a:bodyPr wrap="none">
                      <a:spAutoFit/>
                    </a:bodyPr>
                    <a:lstStyle/>
                    <a:p>
                      <a:r>
                        <a:rPr lang="en-IN" sz="800" b="1"/>
                        <a:t>‡</a:t>
                      </a:r>
                    </a:p>
                  </p:txBody>
                </p:sp>
                <p:sp>
                  <p:nvSpPr>
                    <p:cNvPr id="7235" name="Rectangle 51"/>
                    <p:cNvSpPr>
                      <a:spLocks noChangeArrowheads="1"/>
                    </p:cNvSpPr>
                    <p:nvPr/>
                  </p:nvSpPr>
                  <p:spPr bwMode="auto">
                    <a:xfrm>
                      <a:off x="4813288" y="3684404"/>
                      <a:ext cx="247552" cy="236407"/>
                    </a:xfrm>
                    <a:prstGeom prst="rect">
                      <a:avLst/>
                    </a:prstGeom>
                    <a:noFill/>
                    <a:ln w="9525">
                      <a:noFill/>
                      <a:miter lim="800000"/>
                      <a:headEnd/>
                      <a:tailEnd/>
                    </a:ln>
                  </p:spPr>
                  <p:txBody>
                    <a:bodyPr wrap="none">
                      <a:spAutoFit/>
                    </a:bodyPr>
                    <a:lstStyle/>
                    <a:p>
                      <a:r>
                        <a:rPr lang="en-IN" sz="800" b="1"/>
                        <a:t>‡</a:t>
                      </a:r>
                    </a:p>
                  </p:txBody>
                </p:sp>
                <p:sp>
                  <p:nvSpPr>
                    <p:cNvPr id="7236" name="Rectangle 51"/>
                    <p:cNvSpPr>
                      <a:spLocks noChangeArrowheads="1"/>
                    </p:cNvSpPr>
                    <p:nvPr/>
                  </p:nvSpPr>
                  <p:spPr bwMode="auto">
                    <a:xfrm>
                      <a:off x="5192496" y="3628720"/>
                      <a:ext cx="247552" cy="236407"/>
                    </a:xfrm>
                    <a:prstGeom prst="rect">
                      <a:avLst/>
                    </a:prstGeom>
                    <a:noFill/>
                    <a:ln w="9525">
                      <a:noFill/>
                      <a:miter lim="800000"/>
                      <a:headEnd/>
                      <a:tailEnd/>
                    </a:ln>
                  </p:spPr>
                  <p:txBody>
                    <a:bodyPr wrap="none">
                      <a:spAutoFit/>
                    </a:bodyPr>
                    <a:lstStyle/>
                    <a:p>
                      <a:r>
                        <a:rPr lang="en-IN" sz="800" b="1"/>
                        <a:t>‡</a:t>
                      </a:r>
                    </a:p>
                  </p:txBody>
                </p:sp>
                <p:sp>
                  <p:nvSpPr>
                    <p:cNvPr id="7237" name="Rectangle 51"/>
                    <p:cNvSpPr>
                      <a:spLocks noChangeArrowheads="1"/>
                    </p:cNvSpPr>
                    <p:nvPr/>
                  </p:nvSpPr>
                  <p:spPr bwMode="auto">
                    <a:xfrm>
                      <a:off x="5563802" y="3968288"/>
                      <a:ext cx="247552" cy="236407"/>
                    </a:xfrm>
                    <a:prstGeom prst="rect">
                      <a:avLst/>
                    </a:prstGeom>
                    <a:noFill/>
                    <a:ln w="9525">
                      <a:noFill/>
                      <a:miter lim="800000"/>
                      <a:headEnd/>
                      <a:tailEnd/>
                    </a:ln>
                  </p:spPr>
                  <p:txBody>
                    <a:bodyPr wrap="none">
                      <a:spAutoFit/>
                    </a:bodyPr>
                    <a:lstStyle/>
                    <a:p>
                      <a:r>
                        <a:rPr lang="en-IN" sz="800" b="1"/>
                        <a:t>‡</a:t>
                      </a:r>
                    </a:p>
                  </p:txBody>
                </p:sp>
                <p:sp>
                  <p:nvSpPr>
                    <p:cNvPr id="7238" name="Rectangle 51"/>
                    <p:cNvSpPr>
                      <a:spLocks noChangeArrowheads="1"/>
                    </p:cNvSpPr>
                    <p:nvPr/>
                  </p:nvSpPr>
                  <p:spPr bwMode="auto">
                    <a:xfrm>
                      <a:off x="5939992" y="3990929"/>
                      <a:ext cx="247552" cy="236407"/>
                    </a:xfrm>
                    <a:prstGeom prst="rect">
                      <a:avLst/>
                    </a:prstGeom>
                    <a:noFill/>
                    <a:ln w="9525">
                      <a:noFill/>
                      <a:miter lim="800000"/>
                      <a:headEnd/>
                      <a:tailEnd/>
                    </a:ln>
                  </p:spPr>
                  <p:txBody>
                    <a:bodyPr wrap="none">
                      <a:spAutoFit/>
                    </a:bodyPr>
                    <a:lstStyle/>
                    <a:p>
                      <a:r>
                        <a:rPr lang="en-IN" sz="800" b="1"/>
                        <a:t>‡</a:t>
                      </a:r>
                    </a:p>
                  </p:txBody>
                </p:sp>
                <p:sp>
                  <p:nvSpPr>
                    <p:cNvPr id="7239" name="Rectangle 51"/>
                    <p:cNvSpPr>
                      <a:spLocks noChangeArrowheads="1"/>
                    </p:cNvSpPr>
                    <p:nvPr/>
                  </p:nvSpPr>
                  <p:spPr bwMode="auto">
                    <a:xfrm>
                      <a:off x="6319385" y="3922388"/>
                      <a:ext cx="247552" cy="236407"/>
                    </a:xfrm>
                    <a:prstGeom prst="rect">
                      <a:avLst/>
                    </a:prstGeom>
                    <a:noFill/>
                    <a:ln w="9525">
                      <a:noFill/>
                      <a:miter lim="800000"/>
                      <a:headEnd/>
                      <a:tailEnd/>
                    </a:ln>
                  </p:spPr>
                  <p:txBody>
                    <a:bodyPr wrap="none">
                      <a:spAutoFit/>
                    </a:bodyPr>
                    <a:lstStyle/>
                    <a:p>
                      <a:r>
                        <a:rPr lang="en-IN" sz="800" b="1"/>
                        <a:t>‡</a:t>
                      </a:r>
                    </a:p>
                  </p:txBody>
                </p:sp>
                <p:sp>
                  <p:nvSpPr>
                    <p:cNvPr id="7240" name="Rectangle 51"/>
                    <p:cNvSpPr>
                      <a:spLocks noChangeArrowheads="1"/>
                    </p:cNvSpPr>
                    <p:nvPr/>
                  </p:nvSpPr>
                  <p:spPr bwMode="auto">
                    <a:xfrm>
                      <a:off x="6697176" y="3913751"/>
                      <a:ext cx="247552" cy="236407"/>
                    </a:xfrm>
                    <a:prstGeom prst="rect">
                      <a:avLst/>
                    </a:prstGeom>
                    <a:noFill/>
                    <a:ln w="9525">
                      <a:noFill/>
                      <a:miter lim="800000"/>
                      <a:headEnd/>
                      <a:tailEnd/>
                    </a:ln>
                  </p:spPr>
                  <p:txBody>
                    <a:bodyPr wrap="none">
                      <a:spAutoFit/>
                    </a:bodyPr>
                    <a:lstStyle/>
                    <a:p>
                      <a:r>
                        <a:rPr lang="en-IN" sz="800" b="1"/>
                        <a:t>‡</a:t>
                      </a:r>
                    </a:p>
                  </p:txBody>
                </p:sp>
                <p:sp>
                  <p:nvSpPr>
                    <p:cNvPr id="7241" name="TextBox 6"/>
                    <p:cNvSpPr txBox="1">
                      <a:spLocks noChangeArrowheads="1"/>
                    </p:cNvSpPr>
                    <p:nvPr/>
                  </p:nvSpPr>
                  <p:spPr bwMode="auto">
                    <a:xfrm>
                      <a:off x="1308351" y="3377333"/>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42" name="TextBox 6"/>
                    <p:cNvSpPr txBox="1">
                      <a:spLocks noChangeArrowheads="1"/>
                    </p:cNvSpPr>
                    <p:nvPr/>
                  </p:nvSpPr>
                  <p:spPr bwMode="auto">
                    <a:xfrm>
                      <a:off x="1681279" y="3332111"/>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43" name="TextBox 6"/>
                    <p:cNvSpPr txBox="1">
                      <a:spLocks noChangeArrowheads="1"/>
                    </p:cNvSpPr>
                    <p:nvPr/>
                  </p:nvSpPr>
                  <p:spPr bwMode="auto">
                    <a:xfrm>
                      <a:off x="2059070" y="3398293"/>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44" name="TextBox 6"/>
                    <p:cNvSpPr txBox="1">
                      <a:spLocks noChangeArrowheads="1"/>
                    </p:cNvSpPr>
                    <p:nvPr/>
                  </p:nvSpPr>
                  <p:spPr bwMode="auto">
                    <a:xfrm>
                      <a:off x="2443348" y="3582904"/>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45" name="TextBox 6"/>
                    <p:cNvSpPr txBox="1">
                      <a:spLocks noChangeArrowheads="1"/>
                    </p:cNvSpPr>
                    <p:nvPr/>
                  </p:nvSpPr>
                  <p:spPr bwMode="auto">
                    <a:xfrm>
                      <a:off x="2814654" y="3624703"/>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46" name="TextBox 6"/>
                    <p:cNvSpPr txBox="1">
                      <a:spLocks noChangeArrowheads="1"/>
                    </p:cNvSpPr>
                    <p:nvPr/>
                  </p:nvSpPr>
                  <p:spPr bwMode="auto">
                    <a:xfrm>
                      <a:off x="3192711" y="3574195"/>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47" name="TextBox 6"/>
                    <p:cNvSpPr txBox="1">
                      <a:spLocks noChangeArrowheads="1"/>
                    </p:cNvSpPr>
                    <p:nvPr/>
                  </p:nvSpPr>
                  <p:spPr bwMode="auto">
                    <a:xfrm>
                      <a:off x="3570036" y="3631669"/>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48" name="TextBox 6"/>
                    <p:cNvSpPr txBox="1">
                      <a:spLocks noChangeArrowheads="1"/>
                    </p:cNvSpPr>
                    <p:nvPr/>
                  </p:nvSpPr>
                  <p:spPr bwMode="auto">
                    <a:xfrm>
                      <a:off x="3935659" y="3760549"/>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49" name="TextBox 6"/>
                    <p:cNvSpPr txBox="1">
                      <a:spLocks noChangeArrowheads="1"/>
                    </p:cNvSpPr>
                    <p:nvPr/>
                  </p:nvSpPr>
                  <p:spPr bwMode="auto">
                    <a:xfrm>
                      <a:off x="4307633" y="3797122"/>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50" name="TextBox 6"/>
                    <p:cNvSpPr txBox="1">
                      <a:spLocks noChangeArrowheads="1"/>
                    </p:cNvSpPr>
                    <p:nvPr/>
                  </p:nvSpPr>
                  <p:spPr bwMode="auto">
                    <a:xfrm>
                      <a:off x="4686227" y="3652942"/>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51" name="TextBox 6"/>
                    <p:cNvSpPr txBox="1">
                      <a:spLocks noChangeArrowheads="1"/>
                    </p:cNvSpPr>
                    <p:nvPr/>
                  </p:nvSpPr>
                  <p:spPr bwMode="auto">
                    <a:xfrm>
                      <a:off x="5058618" y="3726984"/>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52" name="TextBox 6"/>
                    <p:cNvSpPr txBox="1">
                      <a:spLocks noChangeArrowheads="1"/>
                    </p:cNvSpPr>
                    <p:nvPr/>
                  </p:nvSpPr>
                  <p:spPr bwMode="auto">
                    <a:xfrm>
                      <a:off x="5449381" y="3993625"/>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53" name="TextBox 6"/>
                    <p:cNvSpPr txBox="1">
                      <a:spLocks noChangeArrowheads="1"/>
                    </p:cNvSpPr>
                    <p:nvPr/>
                  </p:nvSpPr>
                  <p:spPr bwMode="auto">
                    <a:xfrm>
                      <a:off x="5814201" y="4074039"/>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54" name="TextBox 6"/>
                    <p:cNvSpPr txBox="1">
                      <a:spLocks noChangeArrowheads="1"/>
                    </p:cNvSpPr>
                    <p:nvPr/>
                  </p:nvSpPr>
                  <p:spPr bwMode="auto">
                    <a:xfrm>
                      <a:off x="6196943" y="3981675"/>
                      <a:ext cx="229543" cy="236407"/>
                    </a:xfrm>
                    <a:prstGeom prst="rect">
                      <a:avLst/>
                    </a:prstGeom>
                    <a:noFill/>
                    <a:ln w="9525">
                      <a:noFill/>
                      <a:miter lim="800000"/>
                      <a:headEnd/>
                      <a:tailEnd/>
                    </a:ln>
                  </p:spPr>
                  <p:txBody>
                    <a:bodyPr wrap="none">
                      <a:spAutoFit/>
                    </a:bodyPr>
                    <a:lstStyle/>
                    <a:p>
                      <a:r>
                        <a:rPr lang="en-US" sz="800" b="1"/>
                        <a:t>*</a:t>
                      </a:r>
                      <a:endParaRPr lang="en-IN" sz="800" b="1"/>
                    </a:p>
                  </p:txBody>
                </p:sp>
                <p:sp>
                  <p:nvSpPr>
                    <p:cNvPr id="7255" name="TextBox 6"/>
                    <p:cNvSpPr txBox="1">
                      <a:spLocks noChangeArrowheads="1"/>
                    </p:cNvSpPr>
                    <p:nvPr/>
                  </p:nvSpPr>
                  <p:spPr bwMode="auto">
                    <a:xfrm>
                      <a:off x="6572308" y="4000282"/>
                      <a:ext cx="229543" cy="236407"/>
                    </a:xfrm>
                    <a:prstGeom prst="rect">
                      <a:avLst/>
                    </a:prstGeom>
                    <a:noFill/>
                    <a:ln w="9525">
                      <a:noFill/>
                      <a:miter lim="800000"/>
                      <a:headEnd/>
                      <a:tailEnd/>
                    </a:ln>
                  </p:spPr>
                  <p:txBody>
                    <a:bodyPr wrap="none">
                      <a:spAutoFit/>
                    </a:bodyPr>
                    <a:lstStyle/>
                    <a:p>
                      <a:r>
                        <a:rPr lang="en-US" sz="800" b="1"/>
                        <a:t>*</a:t>
                      </a:r>
                      <a:endParaRPr lang="en-IN" sz="800" b="1"/>
                    </a:p>
                  </p:txBody>
                </p:sp>
                <p:cxnSp>
                  <p:nvCxnSpPr>
                    <p:cNvPr id="22" name="Straight Connector 21"/>
                    <p:cNvCxnSpPr/>
                    <p:nvPr/>
                  </p:nvCxnSpPr>
                  <p:spPr bwMode="auto">
                    <a:xfrm>
                      <a:off x="950011" y="2994323"/>
                      <a:ext cx="13717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9" name="Straight Connector 148"/>
                    <p:cNvCxnSpPr/>
                    <p:nvPr/>
                  </p:nvCxnSpPr>
                  <p:spPr bwMode="auto">
                    <a:xfrm>
                      <a:off x="2475759" y="3072711"/>
                      <a:ext cx="13717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0" name="Straight Connector 149"/>
                    <p:cNvCxnSpPr/>
                    <p:nvPr/>
                  </p:nvCxnSpPr>
                  <p:spPr bwMode="auto">
                    <a:xfrm>
                      <a:off x="3941516" y="3386265"/>
                      <a:ext cx="13717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51" name="Straight Connector 150"/>
                  <p:cNvCxnSpPr/>
                  <p:nvPr/>
                </p:nvCxnSpPr>
                <p:spPr bwMode="auto">
                  <a:xfrm>
                    <a:off x="5473750" y="3778208"/>
                    <a:ext cx="13717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207" name="TextBox 3"/>
                  <p:cNvSpPr txBox="1">
                    <a:spLocks noChangeArrowheads="1"/>
                  </p:cNvSpPr>
                  <p:nvPr/>
                </p:nvSpPr>
                <p:spPr bwMode="auto">
                  <a:xfrm rot="-5400000">
                    <a:off x="-575219" y="3642565"/>
                    <a:ext cx="2098593" cy="220024"/>
                  </a:xfrm>
                  <a:prstGeom prst="rect">
                    <a:avLst/>
                  </a:prstGeom>
                  <a:noFill/>
                  <a:ln w="9525">
                    <a:noFill/>
                    <a:miter lim="800000"/>
                    <a:headEnd/>
                    <a:tailEnd/>
                  </a:ln>
                </p:spPr>
                <p:txBody>
                  <a:bodyPr>
                    <a:spAutoFit/>
                  </a:bodyPr>
                  <a:lstStyle/>
                  <a:p>
                    <a:pPr algn="ctr"/>
                    <a:r>
                      <a:rPr lang="en-US" sz="800" b="1"/>
                      <a:t>Relative water content (%)</a:t>
                    </a:r>
                    <a:endParaRPr lang="en-IN" sz="800" b="1"/>
                  </a:p>
                </p:txBody>
              </p:sp>
            </p:grpSp>
          </p:grpSp>
          <p:grpSp>
            <p:nvGrpSpPr>
              <p:cNvPr id="7177" name="Group 130"/>
              <p:cNvGrpSpPr>
                <a:grpSpLocks/>
              </p:cNvGrpSpPr>
              <p:nvPr/>
            </p:nvGrpSpPr>
            <p:grpSpPr bwMode="auto">
              <a:xfrm>
                <a:off x="598530" y="4477919"/>
                <a:ext cx="6033546" cy="603668"/>
                <a:chOff x="495339" y="5201770"/>
                <a:chExt cx="6033406" cy="603758"/>
              </a:xfrm>
            </p:grpSpPr>
            <p:sp>
              <p:nvSpPr>
                <p:cNvPr id="7178" name="TextBox 62"/>
                <p:cNvSpPr txBox="1">
                  <a:spLocks noChangeArrowheads="1"/>
                </p:cNvSpPr>
                <p:nvPr/>
              </p:nvSpPr>
              <p:spPr bwMode="auto">
                <a:xfrm rot="-2700000">
                  <a:off x="1625637" y="5201770"/>
                  <a:ext cx="465191" cy="215402"/>
                </a:xfrm>
                <a:prstGeom prst="rect">
                  <a:avLst/>
                </a:prstGeom>
                <a:noFill/>
                <a:ln w="9525">
                  <a:noFill/>
                  <a:miter lim="800000"/>
                  <a:headEnd/>
                  <a:tailEnd/>
                </a:ln>
              </p:spPr>
              <p:txBody>
                <a:bodyPr wrap="none">
                  <a:spAutoFit/>
                </a:bodyPr>
                <a:lstStyle/>
                <a:p>
                  <a:r>
                    <a:rPr lang="en-US" sz="800" b="1"/>
                    <a:t>1X10</a:t>
                  </a:r>
                  <a:r>
                    <a:rPr lang="en-US" sz="800" b="1" baseline="30000"/>
                    <a:t>5</a:t>
                  </a:r>
                  <a:endParaRPr lang="en-US" sz="800" b="1"/>
                </a:p>
              </p:txBody>
            </p:sp>
            <p:sp>
              <p:nvSpPr>
                <p:cNvPr id="7179" name="TextBox 63"/>
                <p:cNvSpPr txBox="1">
                  <a:spLocks noChangeArrowheads="1"/>
                </p:cNvSpPr>
                <p:nvPr/>
              </p:nvSpPr>
              <p:spPr bwMode="auto">
                <a:xfrm rot="-2700000">
                  <a:off x="1215848" y="5214479"/>
                  <a:ext cx="465191" cy="215403"/>
                </a:xfrm>
                <a:prstGeom prst="rect">
                  <a:avLst/>
                </a:prstGeom>
                <a:noFill/>
                <a:ln w="9525">
                  <a:noFill/>
                  <a:miter lim="800000"/>
                  <a:headEnd/>
                  <a:tailEnd/>
                </a:ln>
              </p:spPr>
              <p:txBody>
                <a:bodyPr wrap="none">
                  <a:spAutoFit/>
                </a:bodyPr>
                <a:lstStyle/>
                <a:p>
                  <a:r>
                    <a:rPr lang="en-US" sz="800" b="1"/>
                    <a:t>1X10</a:t>
                  </a:r>
                  <a:r>
                    <a:rPr lang="en-US" sz="800" b="1" baseline="30000"/>
                    <a:t>4</a:t>
                  </a:r>
                </a:p>
              </p:txBody>
            </p:sp>
            <p:sp>
              <p:nvSpPr>
                <p:cNvPr id="7180" name="TextBox 64"/>
                <p:cNvSpPr txBox="1">
                  <a:spLocks noChangeArrowheads="1"/>
                </p:cNvSpPr>
                <p:nvPr/>
              </p:nvSpPr>
              <p:spPr bwMode="auto">
                <a:xfrm rot="-2700000">
                  <a:off x="873158" y="5206319"/>
                  <a:ext cx="465253" cy="215377"/>
                </a:xfrm>
                <a:prstGeom prst="rect">
                  <a:avLst/>
                </a:prstGeom>
                <a:noFill/>
                <a:ln w="9525">
                  <a:noFill/>
                  <a:miter lim="800000"/>
                  <a:headEnd/>
                  <a:tailEnd/>
                </a:ln>
              </p:spPr>
              <p:txBody>
                <a:bodyPr wrap="none">
                  <a:spAutoFit/>
                </a:bodyPr>
                <a:lstStyle/>
                <a:p>
                  <a:r>
                    <a:rPr lang="en-US" sz="800" b="1"/>
                    <a:t>5X10</a:t>
                  </a:r>
                  <a:r>
                    <a:rPr lang="en-US" sz="800" b="1" baseline="30000"/>
                    <a:t>3</a:t>
                  </a:r>
                </a:p>
              </p:txBody>
            </p:sp>
            <p:sp>
              <p:nvSpPr>
                <p:cNvPr id="7181" name="TextBox 65"/>
                <p:cNvSpPr txBox="1">
                  <a:spLocks noChangeArrowheads="1"/>
                </p:cNvSpPr>
                <p:nvPr/>
              </p:nvSpPr>
              <p:spPr bwMode="auto">
                <a:xfrm rot="-2700000">
                  <a:off x="495339" y="5203391"/>
                  <a:ext cx="465253" cy="215377"/>
                </a:xfrm>
                <a:prstGeom prst="rect">
                  <a:avLst/>
                </a:prstGeom>
                <a:noFill/>
                <a:ln w="9525">
                  <a:noFill/>
                  <a:miter lim="800000"/>
                  <a:headEnd/>
                  <a:tailEnd/>
                </a:ln>
              </p:spPr>
              <p:txBody>
                <a:bodyPr wrap="none">
                  <a:spAutoFit/>
                </a:bodyPr>
                <a:lstStyle/>
                <a:p>
                  <a:r>
                    <a:rPr lang="en-US" sz="800" b="1"/>
                    <a:t>2X10</a:t>
                  </a:r>
                  <a:r>
                    <a:rPr lang="en-US" sz="800" b="1" baseline="30000"/>
                    <a:t>3</a:t>
                  </a:r>
                </a:p>
              </p:txBody>
            </p:sp>
            <p:cxnSp>
              <p:nvCxnSpPr>
                <p:cNvPr id="123" name="Straight Connector 122"/>
                <p:cNvCxnSpPr/>
                <p:nvPr/>
              </p:nvCxnSpPr>
              <p:spPr bwMode="auto">
                <a:xfrm>
                  <a:off x="630207" y="5582187"/>
                  <a:ext cx="1314419" cy="158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183" name="TextBox 125"/>
                <p:cNvSpPr txBox="1">
                  <a:spLocks noChangeArrowheads="1"/>
                </p:cNvSpPr>
                <p:nvPr/>
              </p:nvSpPr>
              <p:spPr bwMode="auto">
                <a:xfrm>
                  <a:off x="1041368" y="5590126"/>
                  <a:ext cx="465191" cy="215402"/>
                </a:xfrm>
                <a:prstGeom prst="rect">
                  <a:avLst/>
                </a:prstGeom>
                <a:noFill/>
                <a:ln w="9525">
                  <a:noFill/>
                  <a:miter lim="800000"/>
                  <a:headEnd/>
                  <a:tailEnd/>
                </a:ln>
              </p:spPr>
              <p:txBody>
                <a:bodyPr wrap="none">
                  <a:spAutoFit/>
                </a:bodyPr>
                <a:lstStyle/>
                <a:p>
                  <a:r>
                    <a:rPr lang="en-US" sz="800" b="1"/>
                    <a:t>FC 80</a:t>
                  </a:r>
                </a:p>
              </p:txBody>
            </p:sp>
            <p:sp>
              <p:nvSpPr>
                <p:cNvPr id="7184" name="TextBox 125"/>
                <p:cNvSpPr txBox="1">
                  <a:spLocks noChangeArrowheads="1"/>
                </p:cNvSpPr>
                <p:nvPr/>
              </p:nvSpPr>
              <p:spPr bwMode="auto">
                <a:xfrm>
                  <a:off x="2514544" y="5588996"/>
                  <a:ext cx="465191" cy="215402"/>
                </a:xfrm>
                <a:prstGeom prst="rect">
                  <a:avLst/>
                </a:prstGeom>
                <a:noFill/>
                <a:ln w="9525">
                  <a:noFill/>
                  <a:miter lim="800000"/>
                  <a:headEnd/>
                  <a:tailEnd/>
                </a:ln>
              </p:spPr>
              <p:txBody>
                <a:bodyPr wrap="none">
                  <a:spAutoFit/>
                </a:bodyPr>
                <a:lstStyle/>
                <a:p>
                  <a:r>
                    <a:rPr lang="en-US" sz="800" b="1"/>
                    <a:t>FC 60</a:t>
                  </a:r>
                </a:p>
              </p:txBody>
            </p:sp>
            <p:sp>
              <p:nvSpPr>
                <p:cNvPr id="7185" name="TextBox 125"/>
                <p:cNvSpPr txBox="1">
                  <a:spLocks noChangeArrowheads="1"/>
                </p:cNvSpPr>
                <p:nvPr/>
              </p:nvSpPr>
              <p:spPr bwMode="auto">
                <a:xfrm>
                  <a:off x="3973099" y="5587867"/>
                  <a:ext cx="465191" cy="215402"/>
                </a:xfrm>
                <a:prstGeom prst="rect">
                  <a:avLst/>
                </a:prstGeom>
                <a:noFill/>
                <a:ln w="9525">
                  <a:noFill/>
                  <a:miter lim="800000"/>
                  <a:headEnd/>
                  <a:tailEnd/>
                </a:ln>
              </p:spPr>
              <p:txBody>
                <a:bodyPr wrap="none">
                  <a:spAutoFit/>
                </a:bodyPr>
                <a:lstStyle/>
                <a:p>
                  <a:r>
                    <a:rPr lang="en-US" sz="800" b="1"/>
                    <a:t>FC 40</a:t>
                  </a:r>
                </a:p>
              </p:txBody>
            </p:sp>
            <p:sp>
              <p:nvSpPr>
                <p:cNvPr id="7186" name="TextBox 125"/>
                <p:cNvSpPr txBox="1">
                  <a:spLocks noChangeArrowheads="1"/>
                </p:cNvSpPr>
                <p:nvPr/>
              </p:nvSpPr>
              <p:spPr bwMode="auto">
                <a:xfrm>
                  <a:off x="5529096" y="5586737"/>
                  <a:ext cx="465191" cy="215402"/>
                </a:xfrm>
                <a:prstGeom prst="rect">
                  <a:avLst/>
                </a:prstGeom>
                <a:noFill/>
                <a:ln w="9525">
                  <a:noFill/>
                  <a:miter lim="800000"/>
                  <a:headEnd/>
                  <a:tailEnd/>
                </a:ln>
              </p:spPr>
              <p:txBody>
                <a:bodyPr wrap="none">
                  <a:spAutoFit/>
                </a:bodyPr>
                <a:lstStyle/>
                <a:p>
                  <a:r>
                    <a:rPr lang="en-US" sz="800" b="1"/>
                    <a:t>FC 20</a:t>
                  </a:r>
                </a:p>
              </p:txBody>
            </p:sp>
            <p:cxnSp>
              <p:nvCxnSpPr>
                <p:cNvPr id="132" name="Straight Connector 131"/>
                <p:cNvCxnSpPr/>
                <p:nvPr/>
              </p:nvCxnSpPr>
              <p:spPr bwMode="auto">
                <a:xfrm>
                  <a:off x="2144646" y="5577423"/>
                  <a:ext cx="1314419" cy="158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3" name="Straight Connector 132"/>
                <p:cNvCxnSpPr/>
                <p:nvPr/>
              </p:nvCxnSpPr>
              <p:spPr bwMode="auto">
                <a:xfrm>
                  <a:off x="3603525" y="5579011"/>
                  <a:ext cx="1312831" cy="158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4" name="Straight Connector 133"/>
                <p:cNvCxnSpPr/>
                <p:nvPr/>
              </p:nvCxnSpPr>
              <p:spPr bwMode="auto">
                <a:xfrm>
                  <a:off x="5092566" y="5580599"/>
                  <a:ext cx="1314419" cy="158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190" name="TextBox 62"/>
                <p:cNvSpPr txBox="1">
                  <a:spLocks noChangeArrowheads="1"/>
                </p:cNvSpPr>
                <p:nvPr/>
              </p:nvSpPr>
              <p:spPr bwMode="auto">
                <a:xfrm rot="-2700000">
                  <a:off x="3104943" y="5201771"/>
                  <a:ext cx="465191" cy="215402"/>
                </a:xfrm>
                <a:prstGeom prst="rect">
                  <a:avLst/>
                </a:prstGeom>
                <a:noFill/>
                <a:ln w="9525">
                  <a:noFill/>
                  <a:miter lim="800000"/>
                  <a:headEnd/>
                  <a:tailEnd/>
                </a:ln>
              </p:spPr>
              <p:txBody>
                <a:bodyPr wrap="none">
                  <a:spAutoFit/>
                </a:bodyPr>
                <a:lstStyle/>
                <a:p>
                  <a:r>
                    <a:rPr lang="en-US" sz="800" b="1"/>
                    <a:t>1X10</a:t>
                  </a:r>
                  <a:r>
                    <a:rPr lang="en-US" sz="800" b="1" baseline="30000"/>
                    <a:t>5</a:t>
                  </a:r>
                  <a:endParaRPr lang="en-US" sz="800" b="1"/>
                </a:p>
              </p:txBody>
            </p:sp>
            <p:sp>
              <p:nvSpPr>
                <p:cNvPr id="7191" name="TextBox 63"/>
                <p:cNvSpPr txBox="1">
                  <a:spLocks noChangeArrowheads="1"/>
                </p:cNvSpPr>
                <p:nvPr/>
              </p:nvSpPr>
              <p:spPr bwMode="auto">
                <a:xfrm rot="-2700000">
                  <a:off x="2695154" y="5214480"/>
                  <a:ext cx="465191" cy="215403"/>
                </a:xfrm>
                <a:prstGeom prst="rect">
                  <a:avLst/>
                </a:prstGeom>
                <a:noFill/>
                <a:ln w="9525">
                  <a:noFill/>
                  <a:miter lim="800000"/>
                  <a:headEnd/>
                  <a:tailEnd/>
                </a:ln>
              </p:spPr>
              <p:txBody>
                <a:bodyPr wrap="none">
                  <a:spAutoFit/>
                </a:bodyPr>
                <a:lstStyle/>
                <a:p>
                  <a:r>
                    <a:rPr lang="en-US" sz="800" b="1"/>
                    <a:t>1X10</a:t>
                  </a:r>
                  <a:r>
                    <a:rPr lang="en-US" sz="800" b="1" baseline="30000"/>
                    <a:t>4</a:t>
                  </a:r>
                </a:p>
              </p:txBody>
            </p:sp>
            <p:sp>
              <p:nvSpPr>
                <p:cNvPr id="7192" name="TextBox 64"/>
                <p:cNvSpPr txBox="1">
                  <a:spLocks noChangeArrowheads="1"/>
                </p:cNvSpPr>
                <p:nvPr/>
              </p:nvSpPr>
              <p:spPr bwMode="auto">
                <a:xfrm rot="-2700000">
                  <a:off x="2352464" y="5206320"/>
                  <a:ext cx="465253" cy="215377"/>
                </a:xfrm>
                <a:prstGeom prst="rect">
                  <a:avLst/>
                </a:prstGeom>
                <a:noFill/>
                <a:ln w="9525">
                  <a:noFill/>
                  <a:miter lim="800000"/>
                  <a:headEnd/>
                  <a:tailEnd/>
                </a:ln>
              </p:spPr>
              <p:txBody>
                <a:bodyPr wrap="none">
                  <a:spAutoFit/>
                </a:bodyPr>
                <a:lstStyle/>
                <a:p>
                  <a:r>
                    <a:rPr lang="en-US" sz="800" b="1"/>
                    <a:t>5X10</a:t>
                  </a:r>
                  <a:r>
                    <a:rPr lang="en-US" sz="800" b="1" baseline="30000"/>
                    <a:t>3</a:t>
                  </a:r>
                </a:p>
              </p:txBody>
            </p:sp>
            <p:sp>
              <p:nvSpPr>
                <p:cNvPr id="7193" name="TextBox 65"/>
                <p:cNvSpPr txBox="1">
                  <a:spLocks noChangeArrowheads="1"/>
                </p:cNvSpPr>
                <p:nvPr/>
              </p:nvSpPr>
              <p:spPr bwMode="auto">
                <a:xfrm rot="-2700000">
                  <a:off x="1974645" y="5203392"/>
                  <a:ext cx="465253" cy="215377"/>
                </a:xfrm>
                <a:prstGeom prst="rect">
                  <a:avLst/>
                </a:prstGeom>
                <a:noFill/>
                <a:ln w="9525">
                  <a:noFill/>
                  <a:miter lim="800000"/>
                  <a:headEnd/>
                  <a:tailEnd/>
                </a:ln>
              </p:spPr>
              <p:txBody>
                <a:bodyPr wrap="none">
                  <a:spAutoFit/>
                </a:bodyPr>
                <a:lstStyle/>
                <a:p>
                  <a:r>
                    <a:rPr lang="en-US" sz="800" b="1"/>
                    <a:t>2X10</a:t>
                  </a:r>
                  <a:r>
                    <a:rPr lang="en-US" sz="800" b="1" baseline="30000"/>
                    <a:t>3</a:t>
                  </a:r>
                </a:p>
              </p:txBody>
            </p:sp>
            <p:sp>
              <p:nvSpPr>
                <p:cNvPr id="7194" name="TextBox 62"/>
                <p:cNvSpPr txBox="1">
                  <a:spLocks noChangeArrowheads="1"/>
                </p:cNvSpPr>
                <p:nvPr/>
              </p:nvSpPr>
              <p:spPr bwMode="auto">
                <a:xfrm rot="-2700000">
                  <a:off x="4584248" y="5201772"/>
                  <a:ext cx="465191" cy="215402"/>
                </a:xfrm>
                <a:prstGeom prst="rect">
                  <a:avLst/>
                </a:prstGeom>
                <a:noFill/>
                <a:ln w="9525">
                  <a:noFill/>
                  <a:miter lim="800000"/>
                  <a:headEnd/>
                  <a:tailEnd/>
                </a:ln>
              </p:spPr>
              <p:txBody>
                <a:bodyPr wrap="none">
                  <a:spAutoFit/>
                </a:bodyPr>
                <a:lstStyle/>
                <a:p>
                  <a:r>
                    <a:rPr lang="en-US" sz="800" b="1"/>
                    <a:t>1X10</a:t>
                  </a:r>
                  <a:r>
                    <a:rPr lang="en-US" sz="800" b="1" baseline="30000"/>
                    <a:t>5</a:t>
                  </a:r>
                  <a:endParaRPr lang="en-US" sz="800" b="1"/>
                </a:p>
              </p:txBody>
            </p:sp>
            <p:sp>
              <p:nvSpPr>
                <p:cNvPr id="7195" name="TextBox 63"/>
                <p:cNvSpPr txBox="1">
                  <a:spLocks noChangeArrowheads="1"/>
                </p:cNvSpPr>
                <p:nvPr/>
              </p:nvSpPr>
              <p:spPr bwMode="auto">
                <a:xfrm rot="-2700000">
                  <a:off x="4174460" y="5214481"/>
                  <a:ext cx="465191" cy="215403"/>
                </a:xfrm>
                <a:prstGeom prst="rect">
                  <a:avLst/>
                </a:prstGeom>
                <a:noFill/>
                <a:ln w="9525">
                  <a:noFill/>
                  <a:miter lim="800000"/>
                  <a:headEnd/>
                  <a:tailEnd/>
                </a:ln>
              </p:spPr>
              <p:txBody>
                <a:bodyPr wrap="none">
                  <a:spAutoFit/>
                </a:bodyPr>
                <a:lstStyle/>
                <a:p>
                  <a:r>
                    <a:rPr lang="en-US" sz="800" b="1"/>
                    <a:t>1X10</a:t>
                  </a:r>
                  <a:r>
                    <a:rPr lang="en-US" sz="800" b="1" baseline="30000"/>
                    <a:t>4</a:t>
                  </a:r>
                </a:p>
              </p:txBody>
            </p:sp>
            <p:sp>
              <p:nvSpPr>
                <p:cNvPr id="7196" name="TextBox 64"/>
                <p:cNvSpPr txBox="1">
                  <a:spLocks noChangeArrowheads="1"/>
                </p:cNvSpPr>
                <p:nvPr/>
              </p:nvSpPr>
              <p:spPr bwMode="auto">
                <a:xfrm rot="-2700000">
                  <a:off x="3831770" y="5206321"/>
                  <a:ext cx="465253" cy="215377"/>
                </a:xfrm>
                <a:prstGeom prst="rect">
                  <a:avLst/>
                </a:prstGeom>
                <a:noFill/>
                <a:ln w="9525">
                  <a:noFill/>
                  <a:miter lim="800000"/>
                  <a:headEnd/>
                  <a:tailEnd/>
                </a:ln>
              </p:spPr>
              <p:txBody>
                <a:bodyPr wrap="none">
                  <a:spAutoFit/>
                </a:bodyPr>
                <a:lstStyle/>
                <a:p>
                  <a:r>
                    <a:rPr lang="en-US" sz="800" b="1"/>
                    <a:t>5X10</a:t>
                  </a:r>
                  <a:r>
                    <a:rPr lang="en-US" sz="800" b="1" baseline="30000"/>
                    <a:t>3</a:t>
                  </a:r>
                </a:p>
              </p:txBody>
            </p:sp>
            <p:sp>
              <p:nvSpPr>
                <p:cNvPr id="7197" name="TextBox 65"/>
                <p:cNvSpPr txBox="1">
                  <a:spLocks noChangeArrowheads="1"/>
                </p:cNvSpPr>
                <p:nvPr/>
              </p:nvSpPr>
              <p:spPr bwMode="auto">
                <a:xfrm rot="-2700000">
                  <a:off x="3453951" y="5203393"/>
                  <a:ext cx="465253" cy="215377"/>
                </a:xfrm>
                <a:prstGeom prst="rect">
                  <a:avLst/>
                </a:prstGeom>
                <a:noFill/>
                <a:ln w="9525">
                  <a:noFill/>
                  <a:miter lim="800000"/>
                  <a:headEnd/>
                  <a:tailEnd/>
                </a:ln>
              </p:spPr>
              <p:txBody>
                <a:bodyPr wrap="none">
                  <a:spAutoFit/>
                </a:bodyPr>
                <a:lstStyle/>
                <a:p>
                  <a:r>
                    <a:rPr lang="en-US" sz="800" b="1"/>
                    <a:t>2X10</a:t>
                  </a:r>
                  <a:r>
                    <a:rPr lang="en-US" sz="800" b="1" baseline="30000"/>
                    <a:t>3</a:t>
                  </a:r>
                </a:p>
              </p:txBody>
            </p:sp>
            <p:sp>
              <p:nvSpPr>
                <p:cNvPr id="7198" name="TextBox 62"/>
                <p:cNvSpPr txBox="1">
                  <a:spLocks noChangeArrowheads="1"/>
                </p:cNvSpPr>
                <p:nvPr/>
              </p:nvSpPr>
              <p:spPr bwMode="auto">
                <a:xfrm rot="-2700000">
                  <a:off x="6063554" y="5201773"/>
                  <a:ext cx="465191" cy="215402"/>
                </a:xfrm>
                <a:prstGeom prst="rect">
                  <a:avLst/>
                </a:prstGeom>
                <a:noFill/>
                <a:ln w="9525">
                  <a:noFill/>
                  <a:miter lim="800000"/>
                  <a:headEnd/>
                  <a:tailEnd/>
                </a:ln>
              </p:spPr>
              <p:txBody>
                <a:bodyPr wrap="none">
                  <a:spAutoFit/>
                </a:bodyPr>
                <a:lstStyle/>
                <a:p>
                  <a:r>
                    <a:rPr lang="en-US" sz="800" b="1"/>
                    <a:t>1X10</a:t>
                  </a:r>
                  <a:r>
                    <a:rPr lang="en-US" sz="800" b="1" baseline="30000"/>
                    <a:t>5</a:t>
                  </a:r>
                  <a:endParaRPr lang="en-US" sz="800" b="1"/>
                </a:p>
              </p:txBody>
            </p:sp>
            <p:sp>
              <p:nvSpPr>
                <p:cNvPr id="7199" name="TextBox 63"/>
                <p:cNvSpPr txBox="1">
                  <a:spLocks noChangeArrowheads="1"/>
                </p:cNvSpPr>
                <p:nvPr/>
              </p:nvSpPr>
              <p:spPr bwMode="auto">
                <a:xfrm rot="-2700000">
                  <a:off x="5653766" y="5214482"/>
                  <a:ext cx="465191" cy="215403"/>
                </a:xfrm>
                <a:prstGeom prst="rect">
                  <a:avLst/>
                </a:prstGeom>
                <a:noFill/>
                <a:ln w="9525">
                  <a:noFill/>
                  <a:miter lim="800000"/>
                  <a:headEnd/>
                  <a:tailEnd/>
                </a:ln>
              </p:spPr>
              <p:txBody>
                <a:bodyPr wrap="none">
                  <a:spAutoFit/>
                </a:bodyPr>
                <a:lstStyle/>
                <a:p>
                  <a:r>
                    <a:rPr lang="en-US" sz="800" b="1"/>
                    <a:t>1X10</a:t>
                  </a:r>
                  <a:r>
                    <a:rPr lang="en-US" sz="800" b="1" baseline="30000"/>
                    <a:t>4</a:t>
                  </a:r>
                </a:p>
              </p:txBody>
            </p:sp>
            <p:sp>
              <p:nvSpPr>
                <p:cNvPr id="7200" name="TextBox 64"/>
                <p:cNvSpPr txBox="1">
                  <a:spLocks noChangeArrowheads="1"/>
                </p:cNvSpPr>
                <p:nvPr/>
              </p:nvSpPr>
              <p:spPr bwMode="auto">
                <a:xfrm rot="-2700000">
                  <a:off x="5311076" y="5206322"/>
                  <a:ext cx="465253" cy="215377"/>
                </a:xfrm>
                <a:prstGeom prst="rect">
                  <a:avLst/>
                </a:prstGeom>
                <a:noFill/>
                <a:ln w="9525">
                  <a:noFill/>
                  <a:miter lim="800000"/>
                  <a:headEnd/>
                  <a:tailEnd/>
                </a:ln>
              </p:spPr>
              <p:txBody>
                <a:bodyPr wrap="none">
                  <a:spAutoFit/>
                </a:bodyPr>
                <a:lstStyle/>
                <a:p>
                  <a:r>
                    <a:rPr lang="en-US" sz="800" b="1"/>
                    <a:t>5X10</a:t>
                  </a:r>
                  <a:r>
                    <a:rPr lang="en-US" sz="800" b="1" baseline="30000"/>
                    <a:t>3</a:t>
                  </a:r>
                </a:p>
              </p:txBody>
            </p:sp>
            <p:sp>
              <p:nvSpPr>
                <p:cNvPr id="7201" name="TextBox 65"/>
                <p:cNvSpPr txBox="1">
                  <a:spLocks noChangeArrowheads="1"/>
                </p:cNvSpPr>
                <p:nvPr/>
              </p:nvSpPr>
              <p:spPr bwMode="auto">
                <a:xfrm rot="-2700000">
                  <a:off x="4933256" y="5203394"/>
                  <a:ext cx="465253" cy="215377"/>
                </a:xfrm>
                <a:prstGeom prst="rect">
                  <a:avLst/>
                </a:prstGeom>
                <a:noFill/>
                <a:ln w="9525">
                  <a:noFill/>
                  <a:miter lim="800000"/>
                  <a:headEnd/>
                  <a:tailEnd/>
                </a:ln>
              </p:spPr>
              <p:txBody>
                <a:bodyPr wrap="none">
                  <a:spAutoFit/>
                </a:bodyPr>
                <a:lstStyle/>
                <a:p>
                  <a:r>
                    <a:rPr lang="en-US" sz="800" b="1"/>
                    <a:t>2X10</a:t>
                  </a:r>
                  <a:r>
                    <a:rPr lang="en-US" sz="800" b="1" baseline="30000"/>
                    <a:t>3</a:t>
                  </a:r>
                </a:p>
              </p:txBody>
            </p:sp>
          </p:grpSp>
        </p:grpSp>
        <p:sp>
          <p:nvSpPr>
            <p:cNvPr id="7175" name="TextBox 93"/>
            <p:cNvSpPr txBox="1">
              <a:spLocks noChangeArrowheads="1"/>
            </p:cNvSpPr>
            <p:nvPr/>
          </p:nvSpPr>
          <p:spPr bwMode="auto">
            <a:xfrm>
              <a:off x="3000375" y="5143500"/>
              <a:ext cx="1357313" cy="215900"/>
            </a:xfrm>
            <a:prstGeom prst="rect">
              <a:avLst/>
            </a:prstGeom>
            <a:noFill/>
            <a:ln w="9525">
              <a:noFill/>
              <a:miter lim="800000"/>
              <a:headEnd/>
              <a:tailEnd/>
            </a:ln>
          </p:spPr>
          <p:txBody>
            <a:bodyPr>
              <a:spAutoFit/>
            </a:bodyPr>
            <a:lstStyle/>
            <a:p>
              <a:r>
                <a:rPr lang="en-US" sz="800" b="1"/>
                <a:t>Combined stress levels</a:t>
              </a:r>
            </a:p>
          </p:txBody>
        </p:sp>
      </p:grpSp>
      <p:grpSp>
        <p:nvGrpSpPr>
          <p:cNvPr id="108" name="Group 152"/>
          <p:cNvGrpSpPr>
            <a:grpSpLocks/>
          </p:cNvGrpSpPr>
          <p:nvPr/>
        </p:nvGrpSpPr>
        <p:grpSpPr bwMode="auto">
          <a:xfrm>
            <a:off x="1102294" y="5780123"/>
            <a:ext cx="4001377" cy="3221033"/>
            <a:chOff x="1078501" y="5649918"/>
            <a:chExt cx="4001766" cy="3220462"/>
          </a:xfrm>
        </p:grpSpPr>
        <p:grpSp>
          <p:nvGrpSpPr>
            <p:cNvPr id="109" name="Group 1"/>
            <p:cNvGrpSpPr>
              <a:grpSpLocks/>
            </p:cNvGrpSpPr>
            <p:nvPr/>
          </p:nvGrpSpPr>
          <p:grpSpPr bwMode="auto">
            <a:xfrm>
              <a:off x="1078501" y="5649918"/>
              <a:ext cx="3470051" cy="3051849"/>
              <a:chOff x="585341" y="5376423"/>
              <a:chExt cx="3884530" cy="3540442"/>
            </a:xfrm>
          </p:grpSpPr>
          <p:sp>
            <p:nvSpPr>
              <p:cNvPr id="117" name="TextBox 111"/>
              <p:cNvSpPr txBox="1">
                <a:spLocks noChangeArrowheads="1"/>
              </p:cNvSpPr>
              <p:nvPr/>
            </p:nvSpPr>
            <p:spPr bwMode="auto">
              <a:xfrm>
                <a:off x="1890604" y="5376423"/>
                <a:ext cx="2579267" cy="249892"/>
              </a:xfrm>
              <a:prstGeom prst="rect">
                <a:avLst/>
              </a:prstGeom>
              <a:noFill/>
              <a:ln w="9525">
                <a:noFill/>
                <a:miter lim="800000"/>
                <a:headEnd/>
                <a:tailEnd/>
              </a:ln>
            </p:spPr>
            <p:txBody>
              <a:bodyPr wrap="none">
                <a:spAutoFit/>
              </a:bodyPr>
              <a:lstStyle/>
              <a:p>
                <a:r>
                  <a:rPr lang="en-US" sz="800" b="1" dirty="0"/>
                  <a:t>Bacterial </a:t>
                </a:r>
                <a:r>
                  <a:rPr lang="en-US" sz="800" b="1" dirty="0" err="1"/>
                  <a:t>inoculum</a:t>
                </a:r>
                <a:r>
                  <a:rPr lang="en-US" sz="800" b="1" dirty="0"/>
                  <a:t> concentration (CFU/</a:t>
                </a:r>
                <a:r>
                  <a:rPr lang="en-US" sz="800" b="1" dirty="0" err="1"/>
                  <a:t>mL</a:t>
                </a:r>
                <a:r>
                  <a:rPr lang="en-US" sz="800" b="1" dirty="0"/>
                  <a:t>)</a:t>
                </a:r>
              </a:p>
            </p:txBody>
          </p:sp>
          <p:sp>
            <p:nvSpPr>
              <p:cNvPr id="118" name="TextBox 112"/>
              <p:cNvSpPr txBox="1">
                <a:spLocks noChangeArrowheads="1"/>
              </p:cNvSpPr>
              <p:nvPr/>
            </p:nvSpPr>
            <p:spPr bwMode="auto">
              <a:xfrm rot="16200000">
                <a:off x="-117919" y="7281944"/>
                <a:ext cx="1647721" cy="241201"/>
              </a:xfrm>
              <a:prstGeom prst="rect">
                <a:avLst/>
              </a:prstGeom>
              <a:noFill/>
              <a:ln w="9525">
                <a:noFill/>
                <a:miter lim="800000"/>
                <a:headEnd/>
                <a:tailEnd/>
              </a:ln>
            </p:spPr>
            <p:txBody>
              <a:bodyPr wrap="none">
                <a:spAutoFit/>
              </a:bodyPr>
              <a:lstStyle/>
              <a:p>
                <a:r>
                  <a:rPr lang="en-US" sz="800" b="1" dirty="0"/>
                  <a:t>Drought stress levels (%)</a:t>
                </a:r>
              </a:p>
            </p:txBody>
          </p:sp>
          <p:sp>
            <p:nvSpPr>
              <p:cNvPr id="119" name="TextBox 7"/>
              <p:cNvSpPr txBox="1">
                <a:spLocks noChangeArrowheads="1"/>
              </p:cNvSpPr>
              <p:nvPr/>
            </p:nvSpPr>
            <p:spPr bwMode="auto">
              <a:xfrm>
                <a:off x="859572" y="6056040"/>
                <a:ext cx="585414" cy="249892"/>
              </a:xfrm>
              <a:prstGeom prst="rect">
                <a:avLst/>
              </a:prstGeom>
              <a:noFill/>
              <a:ln w="9525">
                <a:noFill/>
                <a:miter lim="800000"/>
                <a:headEnd/>
                <a:tailEnd/>
              </a:ln>
            </p:spPr>
            <p:txBody>
              <a:bodyPr wrap="none">
                <a:spAutoFit/>
              </a:bodyPr>
              <a:lstStyle/>
              <a:p>
                <a:r>
                  <a:rPr lang="en-US" sz="800" b="1"/>
                  <a:t>FC 100</a:t>
                </a:r>
              </a:p>
            </p:txBody>
          </p:sp>
          <p:sp>
            <p:nvSpPr>
              <p:cNvPr id="120" name="TextBox 124"/>
              <p:cNvSpPr txBox="1">
                <a:spLocks noChangeArrowheads="1"/>
              </p:cNvSpPr>
              <p:nvPr/>
            </p:nvSpPr>
            <p:spPr bwMode="auto">
              <a:xfrm>
                <a:off x="861409" y="6639724"/>
                <a:ext cx="520807" cy="249892"/>
              </a:xfrm>
              <a:prstGeom prst="rect">
                <a:avLst/>
              </a:prstGeom>
              <a:noFill/>
              <a:ln w="9525">
                <a:noFill/>
                <a:miter lim="800000"/>
                <a:headEnd/>
                <a:tailEnd/>
              </a:ln>
            </p:spPr>
            <p:txBody>
              <a:bodyPr wrap="none">
                <a:spAutoFit/>
              </a:bodyPr>
              <a:lstStyle/>
              <a:p>
                <a:r>
                  <a:rPr lang="en-US" sz="800" b="1"/>
                  <a:t>FC 80</a:t>
                </a:r>
              </a:p>
            </p:txBody>
          </p:sp>
          <p:sp>
            <p:nvSpPr>
              <p:cNvPr id="121" name="TextBox 125"/>
              <p:cNvSpPr txBox="1">
                <a:spLocks noChangeArrowheads="1"/>
              </p:cNvSpPr>
              <p:nvPr/>
            </p:nvSpPr>
            <p:spPr bwMode="auto">
              <a:xfrm>
                <a:off x="863245" y="7310690"/>
                <a:ext cx="520807" cy="249892"/>
              </a:xfrm>
              <a:prstGeom prst="rect">
                <a:avLst/>
              </a:prstGeom>
              <a:noFill/>
              <a:ln w="9525">
                <a:noFill/>
                <a:miter lim="800000"/>
                <a:headEnd/>
                <a:tailEnd/>
              </a:ln>
            </p:spPr>
            <p:txBody>
              <a:bodyPr wrap="none">
                <a:spAutoFit/>
              </a:bodyPr>
              <a:lstStyle/>
              <a:p>
                <a:r>
                  <a:rPr lang="en-US" sz="800" b="1"/>
                  <a:t>FC 60</a:t>
                </a:r>
              </a:p>
            </p:txBody>
          </p:sp>
          <p:sp>
            <p:nvSpPr>
              <p:cNvPr id="122" name="TextBox 126"/>
              <p:cNvSpPr txBox="1">
                <a:spLocks noChangeArrowheads="1"/>
              </p:cNvSpPr>
              <p:nvPr/>
            </p:nvSpPr>
            <p:spPr bwMode="auto">
              <a:xfrm>
                <a:off x="865084" y="7980801"/>
                <a:ext cx="520807" cy="249892"/>
              </a:xfrm>
              <a:prstGeom prst="rect">
                <a:avLst/>
              </a:prstGeom>
              <a:noFill/>
              <a:ln w="9525">
                <a:noFill/>
                <a:miter lim="800000"/>
                <a:headEnd/>
                <a:tailEnd/>
              </a:ln>
            </p:spPr>
            <p:txBody>
              <a:bodyPr wrap="none">
                <a:spAutoFit/>
              </a:bodyPr>
              <a:lstStyle/>
              <a:p>
                <a:r>
                  <a:rPr lang="en-US" sz="800" b="1"/>
                  <a:t>FC 40</a:t>
                </a:r>
              </a:p>
            </p:txBody>
          </p:sp>
          <p:sp>
            <p:nvSpPr>
              <p:cNvPr id="124" name="TextBox 127"/>
              <p:cNvSpPr txBox="1">
                <a:spLocks noChangeArrowheads="1"/>
              </p:cNvSpPr>
              <p:nvPr/>
            </p:nvSpPr>
            <p:spPr bwMode="auto">
              <a:xfrm>
                <a:off x="866921" y="8666973"/>
                <a:ext cx="520807" cy="249892"/>
              </a:xfrm>
              <a:prstGeom prst="rect">
                <a:avLst/>
              </a:prstGeom>
              <a:noFill/>
              <a:ln w="9525">
                <a:noFill/>
                <a:miter lim="800000"/>
                <a:headEnd/>
                <a:tailEnd/>
              </a:ln>
            </p:spPr>
            <p:txBody>
              <a:bodyPr wrap="none">
                <a:spAutoFit/>
              </a:bodyPr>
              <a:lstStyle/>
              <a:p>
                <a:r>
                  <a:rPr lang="en-US" sz="800" b="1"/>
                  <a:t>FC 20</a:t>
                </a:r>
              </a:p>
            </p:txBody>
          </p:sp>
        </p:grpSp>
        <p:grpSp>
          <p:nvGrpSpPr>
            <p:cNvPr id="110" name="Group 87"/>
            <p:cNvGrpSpPr>
              <a:grpSpLocks/>
            </p:cNvGrpSpPr>
            <p:nvPr/>
          </p:nvGrpSpPr>
          <p:grpSpPr bwMode="auto">
            <a:xfrm>
              <a:off x="1994277" y="5876936"/>
              <a:ext cx="2914378" cy="228929"/>
              <a:chOff x="2780851" y="5215563"/>
              <a:chExt cx="1714537" cy="151217"/>
            </a:xfrm>
          </p:grpSpPr>
          <p:sp>
            <p:nvSpPr>
              <p:cNvPr id="112" name="TextBox 82"/>
              <p:cNvSpPr txBox="1">
                <a:spLocks noChangeArrowheads="1"/>
              </p:cNvSpPr>
              <p:nvPr/>
            </p:nvSpPr>
            <p:spPr bwMode="auto">
              <a:xfrm>
                <a:off x="2780851" y="5224496"/>
                <a:ext cx="263325" cy="142284"/>
              </a:xfrm>
              <a:prstGeom prst="rect">
                <a:avLst/>
              </a:prstGeom>
              <a:noFill/>
              <a:ln w="9525">
                <a:noFill/>
                <a:miter lim="800000"/>
                <a:headEnd/>
                <a:tailEnd/>
              </a:ln>
            </p:spPr>
            <p:txBody>
              <a:bodyPr wrap="none">
                <a:spAutoFit/>
              </a:bodyPr>
              <a:lstStyle/>
              <a:p>
                <a:r>
                  <a:rPr lang="en-US" sz="800" b="1"/>
                  <a:t>Mock</a:t>
                </a:r>
                <a:endParaRPr lang="en-IN" sz="800" b="1"/>
              </a:p>
            </p:txBody>
          </p:sp>
          <p:sp>
            <p:nvSpPr>
              <p:cNvPr id="113" name="Rectangle 83"/>
              <p:cNvSpPr>
                <a:spLocks noChangeArrowheads="1"/>
              </p:cNvSpPr>
              <p:nvPr/>
            </p:nvSpPr>
            <p:spPr bwMode="auto">
              <a:xfrm>
                <a:off x="4221688" y="5219753"/>
                <a:ext cx="273700" cy="142285"/>
              </a:xfrm>
              <a:prstGeom prst="rect">
                <a:avLst/>
              </a:prstGeom>
              <a:noFill/>
              <a:ln w="9525">
                <a:noFill/>
                <a:miter lim="800000"/>
                <a:headEnd/>
                <a:tailEnd/>
              </a:ln>
            </p:spPr>
            <p:txBody>
              <a:bodyPr wrap="none">
                <a:spAutoFit/>
              </a:bodyPr>
              <a:lstStyle/>
              <a:p>
                <a:r>
                  <a:rPr lang="en-US" sz="800" b="1"/>
                  <a:t>1X10</a:t>
                </a:r>
                <a:r>
                  <a:rPr lang="en-US" sz="800" b="1" baseline="30000"/>
                  <a:t>5</a:t>
                </a:r>
              </a:p>
            </p:txBody>
          </p:sp>
          <p:sp>
            <p:nvSpPr>
              <p:cNvPr id="114" name="Rectangle 84"/>
              <p:cNvSpPr>
                <a:spLocks noChangeArrowheads="1"/>
              </p:cNvSpPr>
              <p:nvPr/>
            </p:nvSpPr>
            <p:spPr bwMode="auto">
              <a:xfrm>
                <a:off x="3877060" y="5215571"/>
                <a:ext cx="273700" cy="142285"/>
              </a:xfrm>
              <a:prstGeom prst="rect">
                <a:avLst/>
              </a:prstGeom>
              <a:noFill/>
              <a:ln w="9525">
                <a:noFill/>
                <a:miter lim="800000"/>
                <a:headEnd/>
                <a:tailEnd/>
              </a:ln>
            </p:spPr>
            <p:txBody>
              <a:bodyPr wrap="none">
                <a:spAutoFit/>
              </a:bodyPr>
              <a:lstStyle/>
              <a:p>
                <a:r>
                  <a:rPr lang="en-US" sz="800" b="1"/>
                  <a:t>1X10</a:t>
                </a:r>
                <a:r>
                  <a:rPr lang="en-US" sz="800" b="1" baseline="30000"/>
                  <a:t>4</a:t>
                </a:r>
              </a:p>
            </p:txBody>
          </p:sp>
          <p:sp>
            <p:nvSpPr>
              <p:cNvPr id="115" name="Rectangle 85"/>
              <p:cNvSpPr>
                <a:spLocks noChangeArrowheads="1"/>
              </p:cNvSpPr>
              <p:nvPr/>
            </p:nvSpPr>
            <p:spPr bwMode="auto">
              <a:xfrm>
                <a:off x="3509044" y="5215563"/>
                <a:ext cx="284074" cy="142285"/>
              </a:xfrm>
              <a:prstGeom prst="rect">
                <a:avLst/>
              </a:prstGeom>
              <a:noFill/>
              <a:ln w="9525">
                <a:noFill/>
                <a:miter lim="800000"/>
                <a:headEnd/>
                <a:tailEnd/>
              </a:ln>
            </p:spPr>
            <p:txBody>
              <a:bodyPr wrap="none">
                <a:spAutoFit/>
              </a:bodyPr>
              <a:lstStyle/>
              <a:p>
                <a:r>
                  <a:rPr lang="en-US" sz="800" b="1"/>
                  <a:t>5 x10</a:t>
                </a:r>
                <a:r>
                  <a:rPr lang="en-US" sz="800" b="1" baseline="30000"/>
                  <a:t>3</a:t>
                </a:r>
              </a:p>
            </p:txBody>
          </p:sp>
          <p:sp>
            <p:nvSpPr>
              <p:cNvPr id="116" name="Rectangle 86"/>
              <p:cNvSpPr>
                <a:spLocks noChangeArrowheads="1"/>
              </p:cNvSpPr>
              <p:nvPr/>
            </p:nvSpPr>
            <p:spPr bwMode="auto">
              <a:xfrm>
                <a:off x="3130800" y="5219735"/>
                <a:ext cx="284074" cy="142285"/>
              </a:xfrm>
              <a:prstGeom prst="rect">
                <a:avLst/>
              </a:prstGeom>
              <a:noFill/>
              <a:ln w="9525">
                <a:noFill/>
                <a:miter lim="800000"/>
                <a:headEnd/>
                <a:tailEnd/>
              </a:ln>
            </p:spPr>
            <p:txBody>
              <a:bodyPr wrap="none">
                <a:spAutoFit/>
              </a:bodyPr>
              <a:lstStyle/>
              <a:p>
                <a:r>
                  <a:rPr lang="en-US" sz="800" b="1"/>
                  <a:t>2 x10</a:t>
                </a:r>
                <a:r>
                  <a:rPr lang="en-US" sz="800" b="1" baseline="30000"/>
                  <a:t>3</a:t>
                </a:r>
              </a:p>
            </p:txBody>
          </p:sp>
        </p:grpSp>
        <p:pic>
          <p:nvPicPr>
            <p:cNvPr id="111" name="Picture 120"/>
            <p:cNvPicPr>
              <a:picLocks noChangeAspect="1" noChangeArrowheads="1"/>
            </p:cNvPicPr>
            <p:nvPr/>
          </p:nvPicPr>
          <p:blipFill>
            <a:blip r:embed="rId5"/>
            <a:srcRect/>
            <a:stretch>
              <a:fillRect/>
            </a:stretch>
          </p:blipFill>
          <p:spPr bwMode="auto">
            <a:xfrm>
              <a:off x="1943090" y="6124586"/>
              <a:ext cx="3137177" cy="2745794"/>
            </a:xfrm>
            <a:prstGeom prst="rect">
              <a:avLst/>
            </a:prstGeom>
            <a:noFill/>
            <a:ln w="9525">
              <a:noFill/>
              <a:miter lim="800000"/>
              <a:headEnd/>
              <a:tailEnd/>
            </a:ln>
          </p:spPr>
        </p:pic>
      </p:grpSp>
      <p:sp>
        <p:nvSpPr>
          <p:cNvPr id="125" name="TextBox 31"/>
          <p:cNvSpPr txBox="1">
            <a:spLocks noChangeArrowheads="1"/>
          </p:cNvSpPr>
          <p:nvPr/>
        </p:nvSpPr>
        <p:spPr bwMode="auto">
          <a:xfrm>
            <a:off x="-3553" y="5572132"/>
            <a:ext cx="292068" cy="215444"/>
          </a:xfrm>
          <a:prstGeom prst="rect">
            <a:avLst/>
          </a:prstGeom>
          <a:noFill/>
          <a:ln w="9525">
            <a:noFill/>
            <a:miter lim="800000"/>
            <a:headEnd/>
            <a:tailEnd/>
          </a:ln>
        </p:spPr>
        <p:txBody>
          <a:bodyPr wrap="none">
            <a:spAutoFit/>
          </a:bodyPr>
          <a:lstStyle/>
          <a:p>
            <a:r>
              <a:rPr lang="en-US" sz="800" b="1" dirty="0" smtClean="0"/>
              <a:t>C)</a:t>
            </a:r>
            <a:endParaRPr lang="en-IN" sz="800" b="1" dirty="0"/>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Rectangle 1"/>
          <p:cNvSpPr>
            <a:spLocks noChangeArrowheads="1"/>
          </p:cNvSpPr>
          <p:nvPr/>
        </p:nvSpPr>
        <p:spPr bwMode="auto">
          <a:xfrm>
            <a:off x="0" y="2857500"/>
            <a:ext cx="6858000" cy="2677656"/>
          </a:xfrm>
          <a:prstGeom prst="rect">
            <a:avLst/>
          </a:prstGeom>
          <a:solidFill>
            <a:srgbClr val="FFFFFF"/>
          </a:solidFill>
          <a:ln w="9525">
            <a:noFill/>
            <a:miter lim="800000"/>
            <a:headEnd/>
            <a:tailEnd/>
          </a:ln>
        </p:spPr>
        <p:txBody>
          <a:bodyPr anchor="ctr">
            <a:spAutoFit/>
          </a:bodyPr>
          <a:lstStyle/>
          <a:p>
            <a:pPr algn="just" eaLnBrk="0" hangingPunct="0"/>
            <a:r>
              <a:rPr lang="en-IN" sz="1200" b="1" dirty="0" smtClean="0"/>
              <a:t>Supplementary figure S4</a:t>
            </a:r>
            <a:r>
              <a:rPr lang="en-US" sz="1200" b="1" dirty="0" smtClean="0"/>
              <a:t>. </a:t>
            </a:r>
            <a:r>
              <a:rPr lang="en-IN" sz="1200" b="1" dirty="0" smtClean="0"/>
              <a:t>Impact of drought and combined stress on plant water status.</a:t>
            </a:r>
            <a:r>
              <a:rPr lang="en-IN" sz="1200" dirty="0" smtClean="0"/>
              <a:t> Drought stress was imposed on </a:t>
            </a:r>
            <a:r>
              <a:rPr lang="en-IN" sz="1200" i="1" dirty="0" smtClean="0"/>
              <a:t>A. thaliana</a:t>
            </a:r>
            <a:r>
              <a:rPr lang="en-IN" sz="1200" dirty="0" smtClean="0"/>
              <a:t> by withholding water for the indicated days. Once plants reached desired FC, RWC of the leaves from drought stressed plants was measured at 0 </a:t>
            </a:r>
            <a:r>
              <a:rPr lang="en-IN" sz="1200" dirty="0" err="1" smtClean="0"/>
              <a:t>hpt</a:t>
            </a:r>
            <a:r>
              <a:rPr lang="en-IN" sz="1200" dirty="0" smtClean="0"/>
              <a:t> (when they just reached the designated FC), and subsequently at 24 h interval for three days. Plants at FC 100% served as control </a:t>
            </a:r>
            <a:r>
              <a:rPr lang="en-IN" sz="1200" b="1" dirty="0" smtClean="0"/>
              <a:t>(A)</a:t>
            </a:r>
            <a:r>
              <a:rPr lang="en-IN" sz="1200" dirty="0" smtClean="0"/>
              <a:t>. Similarly RWC in the leaves from combined stressed plants were also measured. The higher RWC at 0 </a:t>
            </a:r>
            <a:r>
              <a:rPr lang="en-IN" sz="1200" dirty="0" err="1" smtClean="0"/>
              <a:t>hpt</a:t>
            </a:r>
            <a:r>
              <a:rPr lang="en-IN" sz="1200" dirty="0" smtClean="0"/>
              <a:t> is the consequence of infiltrated water </a:t>
            </a:r>
            <a:r>
              <a:rPr lang="en-IN" sz="1200" b="1" dirty="0" smtClean="0"/>
              <a:t>(B)</a:t>
            </a:r>
            <a:r>
              <a:rPr lang="en-IN" sz="1200" dirty="0" smtClean="0"/>
              <a:t>. Phenotypic response of </a:t>
            </a:r>
            <a:r>
              <a:rPr lang="en-IN" sz="1200" i="1" dirty="0" smtClean="0"/>
              <a:t>A. thaliana</a:t>
            </a:r>
            <a:r>
              <a:rPr lang="en-IN" sz="1200" dirty="0" smtClean="0"/>
              <a:t> under combined drought and </a:t>
            </a:r>
            <a:r>
              <a:rPr lang="en-IN" sz="1200" i="1" dirty="0" smtClean="0"/>
              <a:t>P. </a:t>
            </a:r>
            <a:r>
              <a:rPr lang="en-IN" sz="1200" i="1" dirty="0" err="1" smtClean="0"/>
              <a:t>syringae</a:t>
            </a:r>
            <a:r>
              <a:rPr lang="en-IN" sz="1200" dirty="0" smtClean="0"/>
              <a:t> </a:t>
            </a:r>
            <a:r>
              <a:rPr lang="en-IN" sz="1200" dirty="0" err="1" smtClean="0"/>
              <a:t>pv</a:t>
            </a:r>
            <a:r>
              <a:rPr lang="en-IN" sz="1200" dirty="0" smtClean="0"/>
              <a:t>. tomato DC3000 stress was photographed at 72 </a:t>
            </a:r>
            <a:r>
              <a:rPr lang="en-IN" sz="1200" dirty="0" err="1" smtClean="0"/>
              <a:t>hpt</a:t>
            </a:r>
            <a:r>
              <a:rPr lang="en-IN" sz="1200" dirty="0" smtClean="0"/>
              <a:t> </a:t>
            </a:r>
            <a:r>
              <a:rPr lang="en-IN" sz="1200" b="1" dirty="0" smtClean="0"/>
              <a:t>(C)</a:t>
            </a:r>
            <a:r>
              <a:rPr lang="en-IN" sz="1200" dirty="0" smtClean="0"/>
              <a:t>. Plants were photographed from the same experiment as used to demonstrate the </a:t>
            </a:r>
            <a:r>
              <a:rPr lang="en-IN" sz="1200" dirty="0" err="1" smtClean="0"/>
              <a:t>chlorosis</a:t>
            </a:r>
            <a:r>
              <a:rPr lang="en-IN" sz="1200" dirty="0" smtClean="0"/>
              <a:t> symptoms in Figure 1. </a:t>
            </a:r>
            <a:r>
              <a:rPr lang="en-US" sz="1200" dirty="0" smtClean="0"/>
              <a:t>Data represents the mean of six biological replicates (n= 6) and error bars show ± SEM</a:t>
            </a:r>
            <a:r>
              <a:rPr lang="en-IN" sz="1200" dirty="0" smtClean="0"/>
              <a:t>. Statistical s</a:t>
            </a:r>
            <a:r>
              <a:rPr lang="en-US" sz="1200" dirty="0" err="1" smtClean="0"/>
              <a:t>ignificance</a:t>
            </a:r>
            <a:r>
              <a:rPr lang="en-US" sz="1200" dirty="0" smtClean="0"/>
              <a:t> using Student’s </a:t>
            </a:r>
            <a:r>
              <a:rPr lang="en-US" sz="1200" i="1" dirty="0" smtClean="0"/>
              <a:t>t</a:t>
            </a:r>
            <a:r>
              <a:rPr lang="en-US" sz="1200" dirty="0" smtClean="0"/>
              <a:t> test was calculated over well-watered control at respective time point. Symbols *, </a:t>
            </a:r>
            <a:r>
              <a:rPr lang="en-IN" sz="1200" dirty="0" smtClean="0"/>
              <a:t>† and ‡ denotes significance for 24, 48 and 72 </a:t>
            </a:r>
            <a:r>
              <a:rPr lang="en-IN" sz="1200" dirty="0" err="1" smtClean="0"/>
              <a:t>hpt</a:t>
            </a:r>
            <a:r>
              <a:rPr lang="en-IN" sz="1200" dirty="0" smtClean="0"/>
              <a:t> respectively over well-watered control at p≤0.05. FC, field capacity (%); </a:t>
            </a:r>
            <a:r>
              <a:rPr lang="en-IN" sz="1200" dirty="0" err="1" smtClean="0"/>
              <a:t>hpt</a:t>
            </a:r>
            <a:r>
              <a:rPr lang="en-IN" sz="1200" dirty="0" smtClean="0"/>
              <a:t>, </a:t>
            </a:r>
            <a:r>
              <a:rPr lang="en-IN" sz="1200" u="sng" dirty="0" smtClean="0"/>
              <a:t>h</a:t>
            </a:r>
            <a:r>
              <a:rPr lang="en-IN" sz="1200" dirty="0" smtClean="0"/>
              <a:t>ours </a:t>
            </a:r>
            <a:r>
              <a:rPr lang="en-IN" sz="1200" u="sng" dirty="0" smtClean="0"/>
              <a:t>p</a:t>
            </a:r>
            <a:r>
              <a:rPr lang="en-IN" sz="1200" dirty="0" smtClean="0"/>
              <a:t>ost combined stress </a:t>
            </a:r>
            <a:r>
              <a:rPr lang="en-IN" sz="1200" u="sng" dirty="0" smtClean="0"/>
              <a:t>t</a:t>
            </a:r>
            <a:r>
              <a:rPr lang="en-IN" sz="1200" dirty="0" smtClean="0"/>
              <a:t>reatment. The experiment was repeated thrice with similar results.</a:t>
            </a:r>
            <a:endParaRPr lang="en-US" dirty="0"/>
          </a:p>
        </p:txBody>
      </p:sp>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219" name="Group 9"/>
          <p:cNvGrpSpPr>
            <a:grpSpLocks/>
          </p:cNvGrpSpPr>
          <p:nvPr/>
        </p:nvGrpSpPr>
        <p:grpSpPr bwMode="auto">
          <a:xfrm>
            <a:off x="500063" y="1079468"/>
            <a:ext cx="2925762" cy="2135187"/>
            <a:chOff x="1785925" y="234403"/>
            <a:chExt cx="2926080" cy="2134435"/>
          </a:xfrm>
        </p:grpSpPr>
        <p:graphicFrame>
          <p:nvGraphicFramePr>
            <p:cNvPr id="2" name="Chart 1"/>
            <p:cNvGraphicFramePr/>
            <p:nvPr/>
          </p:nvGraphicFramePr>
          <p:xfrm>
            <a:off x="1785925" y="357158"/>
            <a:ext cx="2926080" cy="2011680"/>
          </p:xfrm>
          <a:graphic>
            <a:graphicData uri="http://schemas.openxmlformats.org/drawingml/2006/chart">
              <c:chart xmlns:c="http://schemas.openxmlformats.org/drawingml/2006/chart" xmlns:r="http://schemas.openxmlformats.org/officeDocument/2006/relationships" r:id="rId3"/>
            </a:graphicData>
          </a:graphic>
        </p:graphicFrame>
        <p:sp>
          <p:nvSpPr>
            <p:cNvPr id="9254" name="Rectangle 83"/>
            <p:cNvSpPr>
              <a:spLocks noChangeArrowheads="1"/>
            </p:cNvSpPr>
            <p:nvPr/>
          </p:nvSpPr>
          <p:spPr bwMode="auto">
            <a:xfrm>
              <a:off x="3000372" y="234403"/>
              <a:ext cx="465243" cy="215368"/>
            </a:xfrm>
            <a:prstGeom prst="rect">
              <a:avLst/>
            </a:prstGeom>
            <a:noFill/>
            <a:ln w="9525">
              <a:noFill/>
              <a:miter lim="800000"/>
              <a:headEnd/>
              <a:tailEnd/>
            </a:ln>
          </p:spPr>
          <p:txBody>
            <a:bodyPr wrap="none">
              <a:spAutoFit/>
            </a:bodyPr>
            <a:lstStyle/>
            <a:p>
              <a:r>
                <a:rPr lang="en-US" sz="800" b="1" dirty="0">
                  <a:latin typeface="Arial" pitchFamily="34" charset="0"/>
                  <a:cs typeface="Arial" pitchFamily="34" charset="0"/>
                </a:rPr>
                <a:t>1X10</a:t>
              </a:r>
              <a:r>
                <a:rPr lang="en-US" sz="800" b="1" baseline="30000" dirty="0">
                  <a:latin typeface="Arial" pitchFamily="34" charset="0"/>
                  <a:cs typeface="Arial" pitchFamily="34" charset="0"/>
                </a:rPr>
                <a:t>5</a:t>
              </a:r>
            </a:p>
          </p:txBody>
        </p:sp>
      </p:grpSp>
      <p:grpSp>
        <p:nvGrpSpPr>
          <p:cNvPr id="9220" name="Group 10"/>
          <p:cNvGrpSpPr>
            <a:grpSpLocks/>
          </p:cNvGrpSpPr>
          <p:nvPr/>
        </p:nvGrpSpPr>
        <p:grpSpPr bwMode="auto">
          <a:xfrm>
            <a:off x="3789363" y="1039780"/>
            <a:ext cx="2925762" cy="2154238"/>
            <a:chOff x="1785926" y="2285984"/>
            <a:chExt cx="2926080" cy="2154556"/>
          </a:xfrm>
        </p:grpSpPr>
        <p:graphicFrame>
          <p:nvGraphicFramePr>
            <p:cNvPr id="4" name="Chart 3"/>
            <p:cNvGraphicFramePr/>
            <p:nvPr/>
          </p:nvGraphicFramePr>
          <p:xfrm>
            <a:off x="1785926" y="2428860"/>
            <a:ext cx="2926080" cy="2011680"/>
          </p:xfrm>
          <a:graphic>
            <a:graphicData uri="http://schemas.openxmlformats.org/drawingml/2006/chart">
              <c:chart xmlns:c="http://schemas.openxmlformats.org/drawingml/2006/chart" xmlns:r="http://schemas.openxmlformats.org/officeDocument/2006/relationships" r:id="rId4"/>
            </a:graphicData>
          </a:graphic>
        </p:graphicFrame>
        <p:sp>
          <p:nvSpPr>
            <p:cNvPr id="9252" name="Rectangle 84"/>
            <p:cNvSpPr>
              <a:spLocks noChangeArrowheads="1"/>
            </p:cNvSpPr>
            <p:nvPr/>
          </p:nvSpPr>
          <p:spPr bwMode="auto">
            <a:xfrm>
              <a:off x="3143216" y="2285984"/>
              <a:ext cx="465243" cy="215476"/>
            </a:xfrm>
            <a:prstGeom prst="rect">
              <a:avLst/>
            </a:prstGeom>
            <a:noFill/>
            <a:ln w="9525">
              <a:noFill/>
              <a:miter lim="800000"/>
              <a:headEnd/>
              <a:tailEnd/>
            </a:ln>
          </p:spPr>
          <p:txBody>
            <a:bodyPr wrap="none">
              <a:spAutoFit/>
            </a:bodyPr>
            <a:lstStyle/>
            <a:p>
              <a:r>
                <a:rPr lang="en-US" sz="800" b="1" dirty="0">
                  <a:latin typeface="Arial" pitchFamily="34" charset="0"/>
                  <a:cs typeface="Arial" pitchFamily="34" charset="0"/>
                </a:rPr>
                <a:t>1X10</a:t>
              </a:r>
              <a:r>
                <a:rPr lang="en-US" sz="800" b="1" baseline="30000" dirty="0">
                  <a:latin typeface="Arial" pitchFamily="34" charset="0"/>
                  <a:cs typeface="Arial" pitchFamily="34" charset="0"/>
                </a:rPr>
                <a:t>4</a:t>
              </a:r>
            </a:p>
          </p:txBody>
        </p:sp>
      </p:grpSp>
      <p:grpSp>
        <p:nvGrpSpPr>
          <p:cNvPr id="9221" name="Group 11"/>
          <p:cNvGrpSpPr>
            <a:grpSpLocks/>
          </p:cNvGrpSpPr>
          <p:nvPr/>
        </p:nvGrpSpPr>
        <p:grpSpPr bwMode="auto">
          <a:xfrm>
            <a:off x="500063" y="3151155"/>
            <a:ext cx="2925762" cy="2225675"/>
            <a:chOff x="1714488" y="4286248"/>
            <a:chExt cx="2926080" cy="2225994"/>
          </a:xfrm>
        </p:grpSpPr>
        <p:graphicFrame>
          <p:nvGraphicFramePr>
            <p:cNvPr id="6" name="Chart 5"/>
            <p:cNvGraphicFramePr/>
            <p:nvPr/>
          </p:nvGraphicFramePr>
          <p:xfrm>
            <a:off x="1714488" y="4500562"/>
            <a:ext cx="2926080" cy="2011680"/>
          </p:xfrm>
          <a:graphic>
            <a:graphicData uri="http://schemas.openxmlformats.org/drawingml/2006/chart">
              <c:chart xmlns:c="http://schemas.openxmlformats.org/drawingml/2006/chart" xmlns:r="http://schemas.openxmlformats.org/officeDocument/2006/relationships" r:id="rId5"/>
            </a:graphicData>
          </a:graphic>
        </p:graphicFrame>
        <p:sp>
          <p:nvSpPr>
            <p:cNvPr id="9250" name="Rectangle 85"/>
            <p:cNvSpPr>
              <a:spLocks noChangeArrowheads="1"/>
            </p:cNvSpPr>
            <p:nvPr/>
          </p:nvSpPr>
          <p:spPr bwMode="auto">
            <a:xfrm>
              <a:off x="2857496" y="4286248"/>
              <a:ext cx="482876" cy="215475"/>
            </a:xfrm>
            <a:prstGeom prst="rect">
              <a:avLst/>
            </a:prstGeom>
            <a:noFill/>
            <a:ln w="9525">
              <a:noFill/>
              <a:miter lim="800000"/>
              <a:headEnd/>
              <a:tailEnd/>
            </a:ln>
          </p:spPr>
          <p:txBody>
            <a:bodyPr wrap="none">
              <a:spAutoFit/>
            </a:bodyPr>
            <a:lstStyle/>
            <a:p>
              <a:r>
                <a:rPr lang="en-US" sz="800" b="1" dirty="0">
                  <a:latin typeface="Arial" pitchFamily="34" charset="0"/>
                  <a:cs typeface="Arial" pitchFamily="34" charset="0"/>
                </a:rPr>
                <a:t>5 x10</a:t>
              </a:r>
              <a:r>
                <a:rPr lang="en-US" sz="800" b="1" baseline="30000" dirty="0">
                  <a:latin typeface="Arial" pitchFamily="34" charset="0"/>
                  <a:cs typeface="Arial" pitchFamily="34" charset="0"/>
                </a:rPr>
                <a:t>3</a:t>
              </a:r>
            </a:p>
          </p:txBody>
        </p:sp>
      </p:grpSp>
      <p:grpSp>
        <p:nvGrpSpPr>
          <p:cNvPr id="9222" name="Group 12"/>
          <p:cNvGrpSpPr>
            <a:grpSpLocks/>
          </p:cNvGrpSpPr>
          <p:nvPr/>
        </p:nvGrpSpPr>
        <p:grpSpPr bwMode="auto">
          <a:xfrm>
            <a:off x="3789363" y="3151155"/>
            <a:ext cx="2925762" cy="2225675"/>
            <a:chOff x="1857364" y="6429388"/>
            <a:chExt cx="2926080" cy="2225994"/>
          </a:xfrm>
        </p:grpSpPr>
        <p:graphicFrame>
          <p:nvGraphicFramePr>
            <p:cNvPr id="8" name="Chart 7"/>
            <p:cNvGraphicFramePr/>
            <p:nvPr/>
          </p:nvGraphicFramePr>
          <p:xfrm>
            <a:off x="1857364" y="6643702"/>
            <a:ext cx="2926080" cy="2011680"/>
          </p:xfrm>
          <a:graphic>
            <a:graphicData uri="http://schemas.openxmlformats.org/drawingml/2006/chart">
              <c:chart xmlns:c="http://schemas.openxmlformats.org/drawingml/2006/chart" xmlns:r="http://schemas.openxmlformats.org/officeDocument/2006/relationships" r:id="rId6"/>
            </a:graphicData>
          </a:graphic>
        </p:graphicFrame>
        <p:sp>
          <p:nvSpPr>
            <p:cNvPr id="9248" name="Rectangle 86"/>
            <p:cNvSpPr>
              <a:spLocks noChangeArrowheads="1"/>
            </p:cNvSpPr>
            <p:nvPr/>
          </p:nvSpPr>
          <p:spPr bwMode="auto">
            <a:xfrm>
              <a:off x="3214686" y="6429388"/>
              <a:ext cx="482876" cy="215475"/>
            </a:xfrm>
            <a:prstGeom prst="rect">
              <a:avLst/>
            </a:prstGeom>
            <a:noFill/>
            <a:ln w="9525">
              <a:noFill/>
              <a:miter lim="800000"/>
              <a:headEnd/>
              <a:tailEnd/>
            </a:ln>
          </p:spPr>
          <p:txBody>
            <a:bodyPr wrap="none">
              <a:spAutoFit/>
            </a:bodyPr>
            <a:lstStyle/>
            <a:p>
              <a:r>
                <a:rPr lang="en-US" sz="800" b="1" dirty="0">
                  <a:latin typeface="Arial" pitchFamily="34" charset="0"/>
                  <a:cs typeface="Arial" pitchFamily="34" charset="0"/>
                </a:rPr>
                <a:t>2 x10</a:t>
              </a:r>
              <a:r>
                <a:rPr lang="en-US" sz="800" b="1" baseline="30000" dirty="0">
                  <a:latin typeface="Arial" pitchFamily="34" charset="0"/>
                  <a:cs typeface="Arial" pitchFamily="34" charset="0"/>
                </a:rPr>
                <a:t>3</a:t>
              </a:r>
            </a:p>
          </p:txBody>
        </p:sp>
      </p:grpSp>
      <p:grpSp>
        <p:nvGrpSpPr>
          <p:cNvPr id="51" name="Group 50"/>
          <p:cNvGrpSpPr/>
          <p:nvPr/>
        </p:nvGrpSpPr>
        <p:grpSpPr>
          <a:xfrm>
            <a:off x="1928802" y="5572132"/>
            <a:ext cx="3355164" cy="984870"/>
            <a:chOff x="1714500" y="785785"/>
            <a:chExt cx="3355164" cy="984870"/>
          </a:xfrm>
        </p:grpSpPr>
        <p:grpSp>
          <p:nvGrpSpPr>
            <p:cNvPr id="9218" name="Group 29"/>
            <p:cNvGrpSpPr>
              <a:grpSpLocks/>
            </p:cNvGrpSpPr>
            <p:nvPr/>
          </p:nvGrpSpPr>
          <p:grpSpPr bwMode="auto">
            <a:xfrm>
              <a:off x="1714500" y="825473"/>
              <a:ext cx="3355164" cy="945182"/>
              <a:chOff x="858329" y="3188065"/>
              <a:chExt cx="7660938" cy="2038596"/>
            </a:xfrm>
          </p:grpSpPr>
          <p:pic>
            <p:nvPicPr>
              <p:cNvPr id="31" name="Picture 30"/>
              <p:cNvPicPr>
                <a:picLocks noChangeAspect="1"/>
              </p:cNvPicPr>
              <p:nvPr/>
            </p:nvPicPr>
            <p:blipFill>
              <a:blip r:embed="rId7"/>
              <a:stretch>
                <a:fillRect/>
              </a:stretch>
            </p:blipFill>
            <p:spPr>
              <a:xfrm>
                <a:off x="1021445" y="3188065"/>
                <a:ext cx="7340183" cy="1999596"/>
              </a:xfrm>
              <a:prstGeom prst="rect">
                <a:avLst/>
              </a:prstGeom>
              <a:ln>
                <a:noFill/>
              </a:ln>
            </p:spPr>
            <p:style>
              <a:lnRef idx="2">
                <a:schemeClr val="dk1"/>
              </a:lnRef>
              <a:fillRef idx="1">
                <a:schemeClr val="lt1"/>
              </a:fillRef>
              <a:effectRef idx="0">
                <a:schemeClr val="dk1"/>
              </a:effectRef>
              <a:fontRef idx="minor">
                <a:schemeClr val="dk1"/>
              </a:fontRef>
            </p:style>
          </p:pic>
          <p:sp>
            <p:nvSpPr>
              <p:cNvPr id="9256" name="Rectangle 31"/>
              <p:cNvSpPr>
                <a:spLocks noChangeArrowheads="1"/>
              </p:cNvSpPr>
              <p:nvPr/>
            </p:nvSpPr>
            <p:spPr bwMode="auto">
              <a:xfrm>
                <a:off x="858329" y="4748196"/>
                <a:ext cx="1274476" cy="464676"/>
              </a:xfrm>
              <a:prstGeom prst="rect">
                <a:avLst/>
              </a:prstGeom>
              <a:noFill/>
              <a:ln w="9525">
                <a:noFill/>
                <a:miter lim="800000"/>
                <a:headEnd/>
                <a:tailEnd/>
              </a:ln>
            </p:spPr>
            <p:txBody>
              <a:bodyPr wrap="none">
                <a:spAutoFit/>
              </a:bodyPr>
              <a:lstStyle/>
              <a:p>
                <a:r>
                  <a:rPr lang="en-US" sz="800" b="1">
                    <a:latin typeface="Arial" pitchFamily="34" charset="0"/>
                    <a:cs typeface="Arial" pitchFamily="34" charset="0"/>
                  </a:rPr>
                  <a:t>Score 5</a:t>
                </a:r>
              </a:p>
            </p:txBody>
          </p:sp>
          <p:sp>
            <p:nvSpPr>
              <p:cNvPr id="9257" name="Rectangle 32"/>
              <p:cNvSpPr>
                <a:spLocks noChangeArrowheads="1"/>
              </p:cNvSpPr>
              <p:nvPr/>
            </p:nvSpPr>
            <p:spPr bwMode="auto">
              <a:xfrm>
                <a:off x="2039777" y="4755504"/>
                <a:ext cx="1274476" cy="464676"/>
              </a:xfrm>
              <a:prstGeom prst="rect">
                <a:avLst/>
              </a:prstGeom>
              <a:noFill/>
              <a:ln w="9525">
                <a:noFill/>
                <a:miter lim="800000"/>
                <a:headEnd/>
                <a:tailEnd/>
              </a:ln>
            </p:spPr>
            <p:txBody>
              <a:bodyPr wrap="none">
                <a:spAutoFit/>
              </a:bodyPr>
              <a:lstStyle/>
              <a:p>
                <a:r>
                  <a:rPr lang="en-US" sz="800" b="1">
                    <a:latin typeface="Arial" pitchFamily="34" charset="0"/>
                    <a:cs typeface="Arial" pitchFamily="34" charset="0"/>
                  </a:rPr>
                  <a:t>Score 4</a:t>
                </a:r>
              </a:p>
            </p:txBody>
          </p:sp>
          <p:sp>
            <p:nvSpPr>
              <p:cNvPr id="9258" name="Rectangle 33"/>
              <p:cNvSpPr>
                <a:spLocks noChangeArrowheads="1"/>
              </p:cNvSpPr>
              <p:nvPr/>
            </p:nvSpPr>
            <p:spPr bwMode="auto">
              <a:xfrm>
                <a:off x="3303099" y="4748197"/>
                <a:ext cx="1274476" cy="464676"/>
              </a:xfrm>
              <a:prstGeom prst="rect">
                <a:avLst/>
              </a:prstGeom>
              <a:noFill/>
              <a:ln w="9525">
                <a:noFill/>
                <a:miter lim="800000"/>
                <a:headEnd/>
                <a:tailEnd/>
              </a:ln>
            </p:spPr>
            <p:txBody>
              <a:bodyPr wrap="none">
                <a:spAutoFit/>
              </a:bodyPr>
              <a:lstStyle/>
              <a:p>
                <a:r>
                  <a:rPr lang="en-US" sz="800" b="1">
                    <a:latin typeface="Arial" pitchFamily="34" charset="0"/>
                    <a:cs typeface="Arial" pitchFamily="34" charset="0"/>
                  </a:rPr>
                  <a:t>Score 3</a:t>
                </a:r>
              </a:p>
            </p:txBody>
          </p:sp>
          <p:sp>
            <p:nvSpPr>
              <p:cNvPr id="9259" name="Rectangle 34"/>
              <p:cNvSpPr>
                <a:spLocks noChangeArrowheads="1"/>
              </p:cNvSpPr>
              <p:nvPr/>
            </p:nvSpPr>
            <p:spPr bwMode="auto">
              <a:xfrm>
                <a:off x="4492226" y="4748943"/>
                <a:ext cx="1274476" cy="464676"/>
              </a:xfrm>
              <a:prstGeom prst="rect">
                <a:avLst/>
              </a:prstGeom>
              <a:noFill/>
              <a:ln w="9525">
                <a:noFill/>
                <a:miter lim="800000"/>
                <a:headEnd/>
                <a:tailEnd/>
              </a:ln>
            </p:spPr>
            <p:txBody>
              <a:bodyPr wrap="none">
                <a:spAutoFit/>
              </a:bodyPr>
              <a:lstStyle/>
              <a:p>
                <a:r>
                  <a:rPr lang="en-US" sz="800" b="1">
                    <a:latin typeface="Arial" pitchFamily="34" charset="0"/>
                    <a:cs typeface="Arial" pitchFamily="34" charset="0"/>
                  </a:rPr>
                  <a:t>Score 2</a:t>
                </a:r>
              </a:p>
            </p:txBody>
          </p:sp>
          <p:sp>
            <p:nvSpPr>
              <p:cNvPr id="9260" name="Rectangle 35"/>
              <p:cNvSpPr>
                <a:spLocks noChangeArrowheads="1"/>
              </p:cNvSpPr>
              <p:nvPr/>
            </p:nvSpPr>
            <p:spPr bwMode="auto">
              <a:xfrm>
                <a:off x="5872854" y="4761985"/>
                <a:ext cx="1274476" cy="464676"/>
              </a:xfrm>
              <a:prstGeom prst="rect">
                <a:avLst/>
              </a:prstGeom>
              <a:noFill/>
              <a:ln w="9525">
                <a:noFill/>
                <a:miter lim="800000"/>
                <a:headEnd/>
                <a:tailEnd/>
              </a:ln>
            </p:spPr>
            <p:txBody>
              <a:bodyPr wrap="none">
                <a:spAutoFit/>
              </a:bodyPr>
              <a:lstStyle/>
              <a:p>
                <a:r>
                  <a:rPr lang="en-US" sz="800" b="1">
                    <a:latin typeface="Arial" pitchFamily="34" charset="0"/>
                    <a:cs typeface="Arial" pitchFamily="34" charset="0"/>
                  </a:rPr>
                  <a:t>Score 1</a:t>
                </a:r>
              </a:p>
            </p:txBody>
          </p:sp>
          <p:sp>
            <p:nvSpPr>
              <p:cNvPr id="9261" name="Rectangle 36"/>
              <p:cNvSpPr>
                <a:spLocks noChangeArrowheads="1"/>
              </p:cNvSpPr>
              <p:nvPr/>
            </p:nvSpPr>
            <p:spPr bwMode="auto">
              <a:xfrm>
                <a:off x="7244791" y="4748197"/>
                <a:ext cx="1274476" cy="464676"/>
              </a:xfrm>
              <a:prstGeom prst="rect">
                <a:avLst/>
              </a:prstGeom>
              <a:noFill/>
              <a:ln w="9525">
                <a:noFill/>
                <a:miter lim="800000"/>
                <a:headEnd/>
                <a:tailEnd/>
              </a:ln>
            </p:spPr>
            <p:txBody>
              <a:bodyPr wrap="none">
                <a:spAutoFit/>
              </a:bodyPr>
              <a:lstStyle/>
              <a:p>
                <a:r>
                  <a:rPr lang="en-US" sz="800" b="1">
                    <a:latin typeface="Arial" pitchFamily="34" charset="0"/>
                    <a:cs typeface="Arial" pitchFamily="34" charset="0"/>
                  </a:rPr>
                  <a:t>Score 0</a:t>
                </a:r>
              </a:p>
            </p:txBody>
          </p:sp>
        </p:grpSp>
        <p:sp>
          <p:nvSpPr>
            <p:cNvPr id="38" name="Rectangle 37"/>
            <p:cNvSpPr/>
            <p:nvPr/>
          </p:nvSpPr>
          <p:spPr>
            <a:xfrm>
              <a:off x="1785938" y="785785"/>
              <a:ext cx="3200400" cy="928688"/>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800">
                <a:latin typeface="Arial" pitchFamily="34" charset="0"/>
                <a:cs typeface="Arial" pitchFamily="34" charset="0"/>
              </a:endParaRPr>
            </a:p>
          </p:txBody>
        </p:sp>
      </p:grpSp>
      <p:sp>
        <p:nvSpPr>
          <p:cNvPr id="9225" name="Rectangle 29"/>
          <p:cNvSpPr>
            <a:spLocks noChangeArrowheads="1"/>
          </p:cNvSpPr>
          <p:nvPr/>
        </p:nvSpPr>
        <p:spPr bwMode="auto">
          <a:xfrm>
            <a:off x="2528549" y="338523"/>
            <a:ext cx="1895071" cy="276999"/>
          </a:xfrm>
          <a:prstGeom prst="rect">
            <a:avLst/>
          </a:prstGeom>
          <a:noFill/>
          <a:ln w="9525">
            <a:noFill/>
            <a:miter lim="800000"/>
            <a:headEnd/>
            <a:tailEnd/>
          </a:ln>
        </p:spPr>
        <p:txBody>
          <a:bodyPr wrap="none">
            <a:spAutoFit/>
          </a:bodyPr>
          <a:lstStyle/>
          <a:p>
            <a:r>
              <a:rPr lang="en-US" sz="1200" b="1" dirty="0" smtClean="0"/>
              <a:t>Supplementary figure 5</a:t>
            </a:r>
            <a:endParaRPr lang="en-IN" sz="1200" b="1" dirty="0">
              <a:latin typeface="Arial" pitchFamily="34" charset="0"/>
              <a:cs typeface="Arial" pitchFamily="34" charset="0"/>
            </a:endParaRPr>
          </a:p>
        </p:txBody>
      </p:sp>
      <p:sp>
        <p:nvSpPr>
          <p:cNvPr id="9228" name="TextBox 30"/>
          <p:cNvSpPr txBox="1">
            <a:spLocks noChangeArrowheads="1"/>
          </p:cNvSpPr>
          <p:nvPr/>
        </p:nvSpPr>
        <p:spPr bwMode="auto">
          <a:xfrm>
            <a:off x="0" y="1000100"/>
            <a:ext cx="292068" cy="215444"/>
          </a:xfrm>
          <a:prstGeom prst="rect">
            <a:avLst/>
          </a:prstGeom>
          <a:noFill/>
          <a:ln w="9525">
            <a:noFill/>
            <a:miter lim="800000"/>
            <a:headEnd/>
            <a:tailEnd/>
          </a:ln>
        </p:spPr>
        <p:txBody>
          <a:bodyPr wrap="none">
            <a:spAutoFit/>
          </a:bodyPr>
          <a:lstStyle/>
          <a:p>
            <a:r>
              <a:rPr lang="en-US" sz="800" b="1" dirty="0" smtClean="0">
                <a:latin typeface="Arial" pitchFamily="34" charset="0"/>
                <a:cs typeface="Arial" pitchFamily="34" charset="0"/>
              </a:rPr>
              <a:t>A)</a:t>
            </a:r>
            <a:endParaRPr lang="en-IN" sz="800" b="1" dirty="0">
              <a:latin typeface="Arial" pitchFamily="34" charset="0"/>
              <a:cs typeface="Arial" pitchFamily="34" charset="0"/>
            </a:endParaRPr>
          </a:p>
        </p:txBody>
      </p:sp>
      <p:sp>
        <p:nvSpPr>
          <p:cNvPr id="9229" name="TextBox 30"/>
          <p:cNvSpPr txBox="1">
            <a:spLocks noChangeArrowheads="1"/>
          </p:cNvSpPr>
          <p:nvPr/>
        </p:nvSpPr>
        <p:spPr bwMode="auto">
          <a:xfrm>
            <a:off x="0" y="3000350"/>
            <a:ext cx="292068" cy="215444"/>
          </a:xfrm>
          <a:prstGeom prst="rect">
            <a:avLst/>
          </a:prstGeom>
          <a:noFill/>
          <a:ln w="9525">
            <a:noFill/>
            <a:miter lim="800000"/>
            <a:headEnd/>
            <a:tailEnd/>
          </a:ln>
        </p:spPr>
        <p:txBody>
          <a:bodyPr wrap="none">
            <a:spAutoFit/>
          </a:bodyPr>
          <a:lstStyle/>
          <a:p>
            <a:r>
              <a:rPr lang="en-US" sz="800" b="1" dirty="0" smtClean="0">
                <a:latin typeface="Arial" pitchFamily="34" charset="0"/>
                <a:cs typeface="Arial" pitchFamily="34" charset="0"/>
              </a:rPr>
              <a:t>C)</a:t>
            </a:r>
            <a:endParaRPr lang="en-IN" sz="800" b="1" dirty="0">
              <a:latin typeface="Arial" pitchFamily="34" charset="0"/>
              <a:cs typeface="Arial" pitchFamily="34" charset="0"/>
            </a:endParaRPr>
          </a:p>
        </p:txBody>
      </p:sp>
      <p:sp>
        <p:nvSpPr>
          <p:cNvPr id="9230" name="TextBox 30"/>
          <p:cNvSpPr txBox="1">
            <a:spLocks noChangeArrowheads="1"/>
          </p:cNvSpPr>
          <p:nvPr/>
        </p:nvSpPr>
        <p:spPr bwMode="auto">
          <a:xfrm>
            <a:off x="3527425" y="1000100"/>
            <a:ext cx="292068" cy="215444"/>
          </a:xfrm>
          <a:prstGeom prst="rect">
            <a:avLst/>
          </a:prstGeom>
          <a:noFill/>
          <a:ln w="9525">
            <a:noFill/>
            <a:miter lim="800000"/>
            <a:headEnd/>
            <a:tailEnd/>
          </a:ln>
        </p:spPr>
        <p:txBody>
          <a:bodyPr wrap="none">
            <a:spAutoFit/>
          </a:bodyPr>
          <a:lstStyle/>
          <a:p>
            <a:r>
              <a:rPr lang="en-US" sz="800" b="1" dirty="0" smtClean="0">
                <a:latin typeface="Arial" pitchFamily="34" charset="0"/>
                <a:cs typeface="Arial" pitchFamily="34" charset="0"/>
              </a:rPr>
              <a:t>B)</a:t>
            </a:r>
            <a:endParaRPr lang="en-IN" sz="800" b="1" dirty="0">
              <a:latin typeface="Arial" pitchFamily="34" charset="0"/>
              <a:cs typeface="Arial" pitchFamily="34" charset="0"/>
            </a:endParaRPr>
          </a:p>
        </p:txBody>
      </p:sp>
      <p:sp>
        <p:nvSpPr>
          <p:cNvPr id="9231" name="TextBox 30"/>
          <p:cNvSpPr txBox="1">
            <a:spLocks noChangeArrowheads="1"/>
          </p:cNvSpPr>
          <p:nvPr/>
        </p:nvSpPr>
        <p:spPr bwMode="auto">
          <a:xfrm>
            <a:off x="3543300" y="3000350"/>
            <a:ext cx="292068" cy="215444"/>
          </a:xfrm>
          <a:prstGeom prst="rect">
            <a:avLst/>
          </a:prstGeom>
          <a:noFill/>
          <a:ln w="9525">
            <a:noFill/>
            <a:miter lim="800000"/>
            <a:headEnd/>
            <a:tailEnd/>
          </a:ln>
        </p:spPr>
        <p:txBody>
          <a:bodyPr wrap="none">
            <a:spAutoFit/>
          </a:bodyPr>
          <a:lstStyle/>
          <a:p>
            <a:r>
              <a:rPr lang="en-US" sz="800" b="1" dirty="0" smtClean="0">
                <a:latin typeface="Arial" pitchFamily="34" charset="0"/>
                <a:cs typeface="Arial" pitchFamily="34" charset="0"/>
              </a:rPr>
              <a:t>D)</a:t>
            </a:r>
            <a:endParaRPr lang="en-IN" sz="800" b="1" dirty="0">
              <a:latin typeface="Arial" pitchFamily="34" charset="0"/>
              <a:cs typeface="Arial" pitchFamily="34" charset="0"/>
            </a:endParaRPr>
          </a:p>
        </p:txBody>
      </p:sp>
      <p:sp>
        <p:nvSpPr>
          <p:cNvPr id="46" name="Rectangle 45"/>
          <p:cNvSpPr/>
          <p:nvPr/>
        </p:nvSpPr>
        <p:spPr>
          <a:xfrm>
            <a:off x="0" y="6913923"/>
            <a:ext cx="6858000" cy="1015663"/>
          </a:xfrm>
          <a:prstGeom prst="rect">
            <a:avLst/>
          </a:prstGeom>
        </p:spPr>
        <p:txBody>
          <a:bodyPr wrap="square">
            <a:spAutoFit/>
          </a:bodyPr>
          <a:lstStyle/>
          <a:p>
            <a:pPr algn="just"/>
            <a:r>
              <a:rPr lang="en-US" sz="1200" b="1" dirty="0" smtClean="0"/>
              <a:t>Supplementary figure S</a:t>
            </a:r>
            <a:r>
              <a:rPr lang="en-US" sz="1200" b="1" dirty="0" smtClean="0">
                <a:solidFill>
                  <a:srgbClr val="000000"/>
                </a:solidFill>
                <a:ea typeface="Arial Unicode MS" pitchFamily="34" charset="-128"/>
                <a:cs typeface="Arial Unicode MS" pitchFamily="34" charset="-128"/>
              </a:rPr>
              <a:t>5. Extent of disease severity in combined stressed plants. </a:t>
            </a:r>
            <a:r>
              <a:rPr lang="en-US" sz="1200" dirty="0" smtClean="0">
                <a:solidFill>
                  <a:srgbClr val="000000"/>
                </a:solidFill>
                <a:ea typeface="Arial Unicode MS" pitchFamily="34" charset="-128"/>
                <a:cs typeface="Arial Unicode MS" pitchFamily="34" charset="-128"/>
              </a:rPr>
              <a:t>Disease index of individual and combined stressed plants maintained at different field capacities and inoculated with </a:t>
            </a:r>
            <a:r>
              <a:rPr lang="en-US" sz="1200" dirty="0" smtClean="0"/>
              <a:t>1X10</a:t>
            </a:r>
            <a:r>
              <a:rPr lang="en-US" sz="1200" baseline="30000" dirty="0" smtClean="0"/>
              <a:t>5</a:t>
            </a:r>
            <a:r>
              <a:rPr lang="en-US" sz="1200" dirty="0" smtClean="0"/>
              <a:t> </a:t>
            </a:r>
            <a:r>
              <a:rPr lang="en-US" sz="1200" b="1" dirty="0" smtClean="0"/>
              <a:t>(A)</a:t>
            </a:r>
            <a:r>
              <a:rPr lang="en-US" sz="1200" dirty="0" smtClean="0"/>
              <a:t>, 1X10</a:t>
            </a:r>
            <a:r>
              <a:rPr lang="en-US" sz="1200" baseline="30000" dirty="0" smtClean="0"/>
              <a:t>4 </a:t>
            </a:r>
            <a:r>
              <a:rPr lang="en-US" sz="1200" b="1" dirty="0" smtClean="0"/>
              <a:t>(B)</a:t>
            </a:r>
            <a:r>
              <a:rPr lang="en-US" sz="1200" dirty="0" smtClean="0"/>
              <a:t>, 5 x10</a:t>
            </a:r>
            <a:r>
              <a:rPr lang="en-US" sz="1200" baseline="30000" dirty="0" smtClean="0"/>
              <a:t>3</a:t>
            </a:r>
            <a:r>
              <a:rPr lang="en-US" sz="1200" dirty="0"/>
              <a:t> </a:t>
            </a:r>
            <a:r>
              <a:rPr lang="en-US" sz="1200" b="1" dirty="0" smtClean="0"/>
              <a:t>(C)</a:t>
            </a:r>
            <a:r>
              <a:rPr lang="en-US" sz="1200" dirty="0" smtClean="0"/>
              <a:t>, and 2 x10</a:t>
            </a:r>
            <a:r>
              <a:rPr lang="en-US" sz="1200" baseline="30000" dirty="0" smtClean="0"/>
              <a:t>3.</a:t>
            </a:r>
            <a:r>
              <a:rPr lang="en-US" sz="1200" dirty="0" smtClean="0"/>
              <a:t> </a:t>
            </a:r>
            <a:r>
              <a:rPr lang="en-US" sz="1200" b="1" dirty="0" smtClean="0"/>
              <a:t>(D) </a:t>
            </a:r>
            <a:r>
              <a:rPr lang="en-US" sz="1200" dirty="0" smtClean="0"/>
              <a:t>is presented. </a:t>
            </a:r>
            <a:r>
              <a:rPr lang="en-US" sz="1200" dirty="0" smtClean="0">
                <a:solidFill>
                  <a:srgbClr val="000000"/>
                </a:solidFill>
                <a:ea typeface="Arial Unicode MS" pitchFamily="34" charset="-128"/>
                <a:cs typeface="Arial Unicode MS" pitchFamily="34" charset="-128"/>
              </a:rPr>
              <a:t>Disease severity was </a:t>
            </a:r>
            <a:r>
              <a:rPr lang="en-US" sz="1200" dirty="0" smtClean="0"/>
              <a:t>visually</a:t>
            </a:r>
            <a:r>
              <a:rPr lang="en-US" sz="1200" i="1" dirty="0" smtClean="0"/>
              <a:t> scored </a:t>
            </a:r>
            <a:r>
              <a:rPr lang="en-US" sz="1200" dirty="0" smtClean="0"/>
              <a:t>0 (no disease symptoms) to 5 (whole leaf </a:t>
            </a:r>
            <a:r>
              <a:rPr lang="en-US" sz="1200" dirty="0" err="1" smtClean="0"/>
              <a:t>chlorosis</a:t>
            </a:r>
            <a:r>
              <a:rPr lang="en-US" sz="1200" dirty="0" smtClean="0"/>
              <a:t>) at 72 </a:t>
            </a:r>
            <a:r>
              <a:rPr lang="en-US" sz="1200" dirty="0" err="1" smtClean="0"/>
              <a:t>hpt</a:t>
            </a:r>
            <a:r>
              <a:rPr lang="en-US" sz="1200" dirty="0" smtClean="0"/>
              <a:t> </a:t>
            </a:r>
            <a:r>
              <a:rPr lang="en-US" sz="1200" b="1" dirty="0" smtClean="0"/>
              <a:t>(E)</a:t>
            </a:r>
            <a:r>
              <a:rPr lang="en-US" sz="1200" dirty="0" smtClean="0"/>
              <a:t>.</a:t>
            </a:r>
            <a:r>
              <a:rPr lang="en-US" sz="1200" dirty="0" smtClean="0">
                <a:solidFill>
                  <a:srgbClr val="000000"/>
                </a:solidFill>
                <a:ea typeface="Arial Unicode MS" pitchFamily="34" charset="-128"/>
                <a:cs typeface="Arial Unicode MS" pitchFamily="34" charset="-128"/>
              </a:rPr>
              <a:t> </a:t>
            </a:r>
            <a:r>
              <a:rPr lang="en-US" sz="1200" dirty="0" smtClean="0"/>
              <a:t>Three independent plants </a:t>
            </a:r>
            <a:r>
              <a:rPr lang="en-US" sz="1200" dirty="0"/>
              <a:t>were analyzed for each </a:t>
            </a:r>
            <a:r>
              <a:rPr lang="en-US" sz="1200" dirty="0" smtClean="0"/>
              <a:t>treatment. </a:t>
            </a:r>
            <a:endParaRPr lang="en-US" sz="1200" dirty="0"/>
          </a:p>
        </p:txBody>
      </p:sp>
      <p:sp>
        <p:nvSpPr>
          <p:cNvPr id="47" name="TextBox 112"/>
          <p:cNvSpPr txBox="1">
            <a:spLocks noChangeArrowheads="1"/>
          </p:cNvSpPr>
          <p:nvPr/>
        </p:nvSpPr>
        <p:spPr bwMode="auto">
          <a:xfrm rot="16200000">
            <a:off x="141862" y="3975769"/>
            <a:ext cx="880369" cy="215444"/>
          </a:xfrm>
          <a:prstGeom prst="rect">
            <a:avLst/>
          </a:prstGeom>
          <a:noFill/>
          <a:ln w="9525">
            <a:noFill/>
            <a:miter lim="800000"/>
            <a:headEnd/>
            <a:tailEnd/>
          </a:ln>
        </p:spPr>
        <p:txBody>
          <a:bodyPr wrap="none">
            <a:spAutoFit/>
          </a:bodyPr>
          <a:lstStyle/>
          <a:p>
            <a:r>
              <a:rPr lang="en-US" sz="800" b="1" dirty="0" smtClean="0">
                <a:latin typeface="Arial" pitchFamily="34" charset="0"/>
                <a:cs typeface="Arial" pitchFamily="34" charset="0"/>
              </a:rPr>
              <a:t>Disease score</a:t>
            </a:r>
            <a:endParaRPr lang="en-US" sz="800" b="1" dirty="0">
              <a:latin typeface="Arial" pitchFamily="34" charset="0"/>
              <a:cs typeface="Arial" pitchFamily="34" charset="0"/>
            </a:endParaRPr>
          </a:p>
        </p:txBody>
      </p:sp>
      <p:sp>
        <p:nvSpPr>
          <p:cNvPr id="48" name="TextBox 112"/>
          <p:cNvSpPr txBox="1">
            <a:spLocks noChangeArrowheads="1"/>
          </p:cNvSpPr>
          <p:nvPr/>
        </p:nvSpPr>
        <p:spPr bwMode="auto">
          <a:xfrm rot="16200000">
            <a:off x="3411639" y="3975769"/>
            <a:ext cx="880369" cy="215444"/>
          </a:xfrm>
          <a:prstGeom prst="rect">
            <a:avLst/>
          </a:prstGeom>
          <a:noFill/>
          <a:ln w="9525">
            <a:noFill/>
            <a:miter lim="800000"/>
            <a:headEnd/>
            <a:tailEnd/>
          </a:ln>
        </p:spPr>
        <p:txBody>
          <a:bodyPr wrap="none">
            <a:spAutoFit/>
          </a:bodyPr>
          <a:lstStyle/>
          <a:p>
            <a:r>
              <a:rPr lang="en-US" sz="800" b="1" dirty="0" smtClean="0">
                <a:latin typeface="Arial" pitchFamily="34" charset="0"/>
                <a:cs typeface="Arial" pitchFamily="34" charset="0"/>
              </a:rPr>
              <a:t>Disease score</a:t>
            </a:r>
            <a:endParaRPr lang="en-US" sz="800" b="1" dirty="0">
              <a:latin typeface="Arial" pitchFamily="34" charset="0"/>
              <a:cs typeface="Arial" pitchFamily="34" charset="0"/>
            </a:endParaRPr>
          </a:p>
        </p:txBody>
      </p:sp>
      <p:sp>
        <p:nvSpPr>
          <p:cNvPr id="49" name="TextBox 112"/>
          <p:cNvSpPr txBox="1">
            <a:spLocks noChangeArrowheads="1"/>
          </p:cNvSpPr>
          <p:nvPr/>
        </p:nvSpPr>
        <p:spPr bwMode="auto">
          <a:xfrm rot="16200000">
            <a:off x="3415628" y="1809515"/>
            <a:ext cx="880369" cy="215444"/>
          </a:xfrm>
          <a:prstGeom prst="rect">
            <a:avLst/>
          </a:prstGeom>
          <a:noFill/>
          <a:ln w="9525">
            <a:noFill/>
            <a:miter lim="800000"/>
            <a:headEnd/>
            <a:tailEnd/>
          </a:ln>
        </p:spPr>
        <p:txBody>
          <a:bodyPr wrap="none">
            <a:spAutoFit/>
          </a:bodyPr>
          <a:lstStyle/>
          <a:p>
            <a:r>
              <a:rPr lang="en-US" sz="800" b="1" dirty="0" smtClean="0">
                <a:latin typeface="Arial" pitchFamily="34" charset="0"/>
                <a:cs typeface="Arial" pitchFamily="34" charset="0"/>
              </a:rPr>
              <a:t>Disease score</a:t>
            </a:r>
            <a:endParaRPr lang="en-US" sz="800" b="1" dirty="0">
              <a:latin typeface="Arial" pitchFamily="34" charset="0"/>
              <a:cs typeface="Arial" pitchFamily="34" charset="0"/>
            </a:endParaRPr>
          </a:p>
        </p:txBody>
      </p:sp>
      <p:sp>
        <p:nvSpPr>
          <p:cNvPr id="50" name="TextBox 112"/>
          <p:cNvSpPr txBox="1">
            <a:spLocks noChangeArrowheads="1"/>
          </p:cNvSpPr>
          <p:nvPr/>
        </p:nvSpPr>
        <p:spPr bwMode="auto">
          <a:xfrm rot="16200000">
            <a:off x="152161" y="1809515"/>
            <a:ext cx="880369" cy="215444"/>
          </a:xfrm>
          <a:prstGeom prst="rect">
            <a:avLst/>
          </a:prstGeom>
          <a:noFill/>
          <a:ln w="9525">
            <a:noFill/>
            <a:miter lim="800000"/>
            <a:headEnd/>
            <a:tailEnd/>
          </a:ln>
        </p:spPr>
        <p:txBody>
          <a:bodyPr wrap="none">
            <a:spAutoFit/>
          </a:bodyPr>
          <a:lstStyle/>
          <a:p>
            <a:r>
              <a:rPr lang="en-US" sz="800" b="1" dirty="0" smtClean="0">
                <a:latin typeface="Arial" pitchFamily="34" charset="0"/>
                <a:cs typeface="Arial" pitchFamily="34" charset="0"/>
              </a:rPr>
              <a:t>Disease score</a:t>
            </a:r>
            <a:endParaRPr lang="en-US" sz="800" b="1" dirty="0">
              <a:latin typeface="Arial" pitchFamily="34" charset="0"/>
              <a:cs typeface="Arial" pitchFamily="34" charset="0"/>
            </a:endParaRPr>
          </a:p>
        </p:txBody>
      </p:sp>
      <p:sp>
        <p:nvSpPr>
          <p:cNvPr id="52" name="TextBox 30"/>
          <p:cNvSpPr txBox="1">
            <a:spLocks noChangeArrowheads="1"/>
          </p:cNvSpPr>
          <p:nvPr/>
        </p:nvSpPr>
        <p:spPr bwMode="auto">
          <a:xfrm>
            <a:off x="-24" y="5590768"/>
            <a:ext cx="287258" cy="215444"/>
          </a:xfrm>
          <a:prstGeom prst="rect">
            <a:avLst/>
          </a:prstGeom>
          <a:noFill/>
          <a:ln w="9525">
            <a:noFill/>
            <a:miter lim="800000"/>
            <a:headEnd/>
            <a:tailEnd/>
          </a:ln>
        </p:spPr>
        <p:txBody>
          <a:bodyPr wrap="none">
            <a:spAutoFit/>
          </a:bodyPr>
          <a:lstStyle/>
          <a:p>
            <a:r>
              <a:rPr lang="en-US" sz="800" b="1" dirty="0" smtClean="0">
                <a:latin typeface="Arial" pitchFamily="34" charset="0"/>
                <a:cs typeface="Arial" pitchFamily="34" charset="0"/>
              </a:rPr>
              <a:t>E)</a:t>
            </a:r>
            <a:endParaRPr lang="en-IN" sz="800" b="1" dirty="0">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315" name="Group 3"/>
          <p:cNvGrpSpPr>
            <a:grpSpLocks noChangeAspect="1"/>
          </p:cNvGrpSpPr>
          <p:nvPr/>
        </p:nvGrpSpPr>
        <p:grpSpPr bwMode="auto">
          <a:xfrm>
            <a:off x="1990715" y="779468"/>
            <a:ext cx="1118849" cy="442371"/>
            <a:chOff x="1538693" y="4873187"/>
            <a:chExt cx="1390799" cy="550809"/>
          </a:xfrm>
        </p:grpSpPr>
        <p:sp>
          <p:nvSpPr>
            <p:cNvPr id="10317" name="TextBox 6"/>
            <p:cNvSpPr txBox="1">
              <a:spLocks noChangeArrowheads="1"/>
            </p:cNvSpPr>
            <p:nvPr/>
          </p:nvSpPr>
          <p:spPr bwMode="auto">
            <a:xfrm rot="-5400000">
              <a:off x="1401283" y="5010597"/>
              <a:ext cx="542922" cy="268101"/>
            </a:xfrm>
            <a:prstGeom prst="rect">
              <a:avLst/>
            </a:prstGeom>
            <a:noFill/>
            <a:ln w="9525">
              <a:noFill/>
              <a:miter lim="800000"/>
              <a:headEnd/>
              <a:tailEnd/>
            </a:ln>
          </p:spPr>
          <p:txBody>
            <a:bodyPr wrap="none">
              <a:spAutoFit/>
            </a:bodyPr>
            <a:lstStyle/>
            <a:p>
              <a:r>
                <a:rPr lang="en-US" sz="800" b="1" dirty="0"/>
                <a:t>FC80</a:t>
              </a:r>
            </a:p>
          </p:txBody>
        </p:sp>
        <p:sp>
          <p:nvSpPr>
            <p:cNvPr id="10318" name="TextBox 7"/>
            <p:cNvSpPr txBox="1">
              <a:spLocks noChangeArrowheads="1"/>
            </p:cNvSpPr>
            <p:nvPr/>
          </p:nvSpPr>
          <p:spPr bwMode="auto">
            <a:xfrm rot="16200000">
              <a:off x="1767624" y="5013560"/>
              <a:ext cx="542922" cy="268101"/>
            </a:xfrm>
            <a:prstGeom prst="rect">
              <a:avLst/>
            </a:prstGeom>
            <a:noFill/>
            <a:ln w="9525">
              <a:noFill/>
              <a:miter lim="800000"/>
              <a:headEnd/>
              <a:tailEnd/>
            </a:ln>
          </p:spPr>
          <p:txBody>
            <a:bodyPr wrap="none">
              <a:spAutoFit/>
            </a:bodyPr>
            <a:lstStyle/>
            <a:p>
              <a:r>
                <a:rPr lang="en-US" sz="800" b="1"/>
                <a:t>FC60</a:t>
              </a:r>
            </a:p>
          </p:txBody>
        </p:sp>
        <p:sp>
          <p:nvSpPr>
            <p:cNvPr id="10319" name="TextBox 8"/>
            <p:cNvSpPr txBox="1">
              <a:spLocks noChangeArrowheads="1"/>
            </p:cNvSpPr>
            <p:nvPr/>
          </p:nvSpPr>
          <p:spPr bwMode="auto">
            <a:xfrm rot="16200000">
              <a:off x="2157644" y="5016511"/>
              <a:ext cx="542920" cy="268100"/>
            </a:xfrm>
            <a:prstGeom prst="rect">
              <a:avLst/>
            </a:prstGeom>
            <a:noFill/>
            <a:ln w="9525">
              <a:noFill/>
              <a:miter lim="800000"/>
              <a:headEnd/>
              <a:tailEnd/>
            </a:ln>
          </p:spPr>
          <p:txBody>
            <a:bodyPr wrap="none">
              <a:spAutoFit/>
            </a:bodyPr>
            <a:lstStyle/>
            <a:p>
              <a:r>
                <a:rPr lang="en-US" sz="800" b="1"/>
                <a:t>FC40</a:t>
              </a:r>
            </a:p>
          </p:txBody>
        </p:sp>
        <p:sp>
          <p:nvSpPr>
            <p:cNvPr id="10320" name="TextBox 9"/>
            <p:cNvSpPr txBox="1">
              <a:spLocks noChangeArrowheads="1"/>
            </p:cNvSpPr>
            <p:nvPr/>
          </p:nvSpPr>
          <p:spPr bwMode="auto">
            <a:xfrm rot="16200000">
              <a:off x="2523982" y="5018486"/>
              <a:ext cx="542920" cy="268100"/>
            </a:xfrm>
            <a:prstGeom prst="rect">
              <a:avLst/>
            </a:prstGeom>
            <a:noFill/>
            <a:ln w="9525">
              <a:noFill/>
              <a:miter lim="800000"/>
              <a:headEnd/>
              <a:tailEnd/>
            </a:ln>
          </p:spPr>
          <p:txBody>
            <a:bodyPr wrap="none">
              <a:spAutoFit/>
            </a:bodyPr>
            <a:lstStyle/>
            <a:p>
              <a:r>
                <a:rPr lang="en-US" sz="800" b="1" dirty="0"/>
                <a:t>FC20</a:t>
              </a:r>
            </a:p>
          </p:txBody>
        </p:sp>
      </p:grpSp>
      <p:sp>
        <p:nvSpPr>
          <p:cNvPr id="10244" name="TextBox 20"/>
          <p:cNvSpPr txBox="1">
            <a:spLocks noChangeArrowheads="1"/>
          </p:cNvSpPr>
          <p:nvPr/>
        </p:nvSpPr>
        <p:spPr bwMode="auto">
          <a:xfrm>
            <a:off x="838200" y="608013"/>
            <a:ext cx="292068" cy="215444"/>
          </a:xfrm>
          <a:prstGeom prst="rect">
            <a:avLst/>
          </a:prstGeom>
          <a:noFill/>
          <a:ln w="9525">
            <a:noFill/>
            <a:miter lim="800000"/>
            <a:headEnd/>
            <a:tailEnd/>
          </a:ln>
        </p:spPr>
        <p:txBody>
          <a:bodyPr wrap="none">
            <a:spAutoFit/>
          </a:bodyPr>
          <a:lstStyle/>
          <a:p>
            <a:r>
              <a:rPr lang="en-US" sz="800" b="1" dirty="0"/>
              <a:t>A)</a:t>
            </a:r>
            <a:endParaRPr lang="en-IN" sz="800" b="1" dirty="0"/>
          </a:p>
        </p:txBody>
      </p:sp>
      <p:sp>
        <p:nvSpPr>
          <p:cNvPr id="10245" name="TextBox 20"/>
          <p:cNvSpPr txBox="1">
            <a:spLocks noChangeArrowheads="1"/>
          </p:cNvSpPr>
          <p:nvPr/>
        </p:nvSpPr>
        <p:spPr bwMode="auto">
          <a:xfrm>
            <a:off x="3790950" y="571500"/>
            <a:ext cx="292068" cy="215444"/>
          </a:xfrm>
          <a:prstGeom prst="rect">
            <a:avLst/>
          </a:prstGeom>
          <a:noFill/>
          <a:ln w="9525">
            <a:noFill/>
            <a:miter lim="800000"/>
            <a:headEnd/>
            <a:tailEnd/>
          </a:ln>
        </p:spPr>
        <p:txBody>
          <a:bodyPr wrap="none">
            <a:spAutoFit/>
          </a:bodyPr>
          <a:lstStyle/>
          <a:p>
            <a:r>
              <a:rPr lang="en-US" sz="800" b="1"/>
              <a:t>B)</a:t>
            </a:r>
            <a:endParaRPr lang="en-IN" sz="800" b="1"/>
          </a:p>
        </p:txBody>
      </p:sp>
      <p:sp>
        <p:nvSpPr>
          <p:cNvPr id="10246" name="TextBox 20"/>
          <p:cNvSpPr txBox="1">
            <a:spLocks noChangeArrowheads="1"/>
          </p:cNvSpPr>
          <p:nvPr/>
        </p:nvSpPr>
        <p:spPr bwMode="auto">
          <a:xfrm>
            <a:off x="142875" y="5083452"/>
            <a:ext cx="292068" cy="215444"/>
          </a:xfrm>
          <a:prstGeom prst="rect">
            <a:avLst/>
          </a:prstGeom>
          <a:noFill/>
          <a:ln w="9525">
            <a:noFill/>
            <a:miter lim="800000"/>
            <a:headEnd/>
            <a:tailEnd/>
          </a:ln>
        </p:spPr>
        <p:txBody>
          <a:bodyPr wrap="none">
            <a:spAutoFit/>
          </a:bodyPr>
          <a:lstStyle/>
          <a:p>
            <a:r>
              <a:rPr lang="en-US" sz="800" b="1"/>
              <a:t>C)</a:t>
            </a:r>
            <a:endParaRPr lang="en-IN" sz="800" b="1"/>
          </a:p>
        </p:txBody>
      </p:sp>
      <p:sp>
        <p:nvSpPr>
          <p:cNvPr id="10247" name="Rectangle 29"/>
          <p:cNvSpPr>
            <a:spLocks noChangeArrowheads="1"/>
          </p:cNvSpPr>
          <p:nvPr/>
        </p:nvSpPr>
        <p:spPr bwMode="auto">
          <a:xfrm>
            <a:off x="2689668" y="167198"/>
            <a:ext cx="1895071" cy="276999"/>
          </a:xfrm>
          <a:prstGeom prst="rect">
            <a:avLst/>
          </a:prstGeom>
          <a:noFill/>
          <a:ln w="9525">
            <a:noFill/>
            <a:miter lim="800000"/>
            <a:headEnd/>
            <a:tailEnd/>
          </a:ln>
        </p:spPr>
        <p:txBody>
          <a:bodyPr wrap="none">
            <a:spAutoFit/>
          </a:bodyPr>
          <a:lstStyle/>
          <a:p>
            <a:r>
              <a:rPr lang="en-US" sz="1200" b="1" dirty="0" smtClean="0"/>
              <a:t>Supplementary figure 6</a:t>
            </a:r>
            <a:endParaRPr lang="en-IN" sz="1200" b="1" dirty="0"/>
          </a:p>
        </p:txBody>
      </p:sp>
      <p:cxnSp>
        <p:nvCxnSpPr>
          <p:cNvPr id="86" name="Straight Connector 85"/>
          <p:cNvCxnSpPr/>
          <p:nvPr/>
        </p:nvCxnSpPr>
        <p:spPr>
          <a:xfrm rot="5400000">
            <a:off x="3081974" y="1829753"/>
            <a:ext cx="10972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Straight Connector 86"/>
          <p:cNvCxnSpPr/>
          <p:nvPr/>
        </p:nvCxnSpPr>
        <p:spPr>
          <a:xfrm rot="5400000">
            <a:off x="3127693" y="3117518"/>
            <a:ext cx="100584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256" name="TextBox 87"/>
          <p:cNvSpPr txBox="1">
            <a:spLocks noChangeArrowheads="1"/>
          </p:cNvSpPr>
          <p:nvPr/>
        </p:nvSpPr>
        <p:spPr bwMode="auto">
          <a:xfrm rot="-5400000">
            <a:off x="3222626" y="1576388"/>
            <a:ext cx="785813" cy="338138"/>
          </a:xfrm>
          <a:prstGeom prst="rect">
            <a:avLst/>
          </a:prstGeom>
          <a:noFill/>
          <a:ln w="9525">
            <a:noFill/>
            <a:miter lim="800000"/>
            <a:headEnd/>
            <a:tailEnd/>
          </a:ln>
        </p:spPr>
        <p:txBody>
          <a:bodyPr>
            <a:spAutoFit/>
          </a:bodyPr>
          <a:lstStyle/>
          <a:p>
            <a:r>
              <a:rPr lang="en-US" sz="800" b="1" dirty="0"/>
              <a:t>Drought responsive</a:t>
            </a:r>
            <a:endParaRPr lang="en-IN" sz="800" b="1" dirty="0"/>
          </a:p>
        </p:txBody>
      </p:sp>
      <p:sp>
        <p:nvSpPr>
          <p:cNvPr id="10257" name="TextBox 88"/>
          <p:cNvSpPr txBox="1">
            <a:spLocks noChangeArrowheads="1"/>
          </p:cNvSpPr>
          <p:nvPr/>
        </p:nvSpPr>
        <p:spPr bwMode="auto">
          <a:xfrm rot="-5400000">
            <a:off x="3223421" y="2913843"/>
            <a:ext cx="785812" cy="339725"/>
          </a:xfrm>
          <a:prstGeom prst="rect">
            <a:avLst/>
          </a:prstGeom>
          <a:noFill/>
          <a:ln w="9525">
            <a:noFill/>
            <a:miter lim="800000"/>
            <a:headEnd/>
            <a:tailEnd/>
          </a:ln>
        </p:spPr>
        <p:txBody>
          <a:bodyPr>
            <a:spAutoFit/>
          </a:bodyPr>
          <a:lstStyle/>
          <a:p>
            <a:r>
              <a:rPr lang="en-US" sz="800" b="1" dirty="0"/>
              <a:t>Pathogen responsive</a:t>
            </a:r>
            <a:endParaRPr lang="en-IN" sz="800" b="1" dirty="0"/>
          </a:p>
        </p:txBody>
      </p:sp>
      <p:grpSp>
        <p:nvGrpSpPr>
          <p:cNvPr id="85" name="Group 84"/>
          <p:cNvGrpSpPr/>
          <p:nvPr/>
        </p:nvGrpSpPr>
        <p:grpSpPr>
          <a:xfrm>
            <a:off x="248598" y="4618298"/>
            <a:ext cx="6437952" cy="3739916"/>
            <a:chOff x="142852" y="1571630"/>
            <a:chExt cx="6437952" cy="3739916"/>
          </a:xfrm>
        </p:grpSpPr>
        <p:pic>
          <p:nvPicPr>
            <p:cNvPr id="88" name="Picture 5"/>
            <p:cNvPicPr preferRelativeResize="0">
              <a:picLocks noChangeArrowheads="1"/>
            </p:cNvPicPr>
            <p:nvPr/>
          </p:nvPicPr>
          <p:blipFill>
            <a:blip r:embed="rId3"/>
            <a:srcRect l="9044" t="51493" r="21843" b="5496"/>
            <a:stretch>
              <a:fillRect/>
            </a:stretch>
          </p:blipFill>
          <p:spPr bwMode="auto">
            <a:xfrm>
              <a:off x="728644" y="2114533"/>
              <a:ext cx="5852160" cy="3197013"/>
            </a:xfrm>
            <a:prstGeom prst="rect">
              <a:avLst/>
            </a:prstGeom>
            <a:noFill/>
            <a:ln w="9525">
              <a:noFill/>
              <a:miter lim="800000"/>
              <a:headEnd/>
              <a:tailEnd/>
            </a:ln>
            <a:effectLst/>
          </p:spPr>
        </p:pic>
        <p:grpSp>
          <p:nvGrpSpPr>
            <p:cNvPr id="89" name="Group 429"/>
            <p:cNvGrpSpPr>
              <a:grpSpLocks/>
            </p:cNvGrpSpPr>
            <p:nvPr/>
          </p:nvGrpSpPr>
          <p:grpSpPr bwMode="auto">
            <a:xfrm>
              <a:off x="903636" y="1571630"/>
              <a:ext cx="5645434" cy="641271"/>
              <a:chOff x="823921" y="4885522"/>
              <a:chExt cx="5644957" cy="641700"/>
            </a:xfrm>
          </p:grpSpPr>
          <p:sp>
            <p:nvSpPr>
              <p:cNvPr id="101" name="TextBox 62"/>
              <p:cNvSpPr txBox="1">
                <a:spLocks noChangeArrowheads="1"/>
              </p:cNvSpPr>
              <p:nvPr/>
            </p:nvSpPr>
            <p:spPr bwMode="auto">
              <a:xfrm rot="18900000">
                <a:off x="823921" y="5303066"/>
                <a:ext cx="465153" cy="215588"/>
              </a:xfrm>
              <a:prstGeom prst="rect">
                <a:avLst/>
              </a:prstGeom>
              <a:noFill/>
              <a:ln w="9525">
                <a:noFill/>
                <a:miter lim="800000"/>
                <a:headEnd/>
                <a:tailEnd/>
              </a:ln>
            </p:spPr>
            <p:txBody>
              <a:bodyPr wrap="none">
                <a:spAutoFit/>
              </a:bodyPr>
              <a:lstStyle/>
              <a:p>
                <a:pPr eaLnBrk="1" hangingPunct="1"/>
                <a:r>
                  <a:rPr lang="en-US" altLang="en-US" sz="800" b="1"/>
                  <a:t>2X10</a:t>
                </a:r>
                <a:r>
                  <a:rPr lang="en-US" altLang="en-US" sz="800" b="1" baseline="30000"/>
                  <a:t>3</a:t>
                </a:r>
                <a:endParaRPr lang="en-US" altLang="en-US" sz="800" b="1"/>
              </a:p>
            </p:txBody>
          </p:sp>
          <p:sp>
            <p:nvSpPr>
              <p:cNvPr id="102" name="TextBox 63"/>
              <p:cNvSpPr txBox="1">
                <a:spLocks noChangeArrowheads="1"/>
              </p:cNvSpPr>
              <p:nvPr/>
            </p:nvSpPr>
            <p:spPr bwMode="auto">
              <a:xfrm rot="18900000">
                <a:off x="1153914" y="5298042"/>
                <a:ext cx="465153" cy="215588"/>
              </a:xfrm>
              <a:prstGeom prst="rect">
                <a:avLst/>
              </a:prstGeom>
              <a:noFill/>
              <a:ln w="9525">
                <a:noFill/>
                <a:miter lim="800000"/>
                <a:headEnd/>
                <a:tailEnd/>
              </a:ln>
            </p:spPr>
            <p:txBody>
              <a:bodyPr wrap="none">
                <a:spAutoFit/>
              </a:bodyPr>
              <a:lstStyle/>
              <a:p>
                <a:pPr eaLnBrk="1" hangingPunct="1"/>
                <a:r>
                  <a:rPr lang="en-US" altLang="en-US" sz="800" b="1"/>
                  <a:t>5X10</a:t>
                </a:r>
                <a:r>
                  <a:rPr lang="en-US" altLang="en-US" sz="800" b="1" baseline="30000"/>
                  <a:t>3</a:t>
                </a:r>
              </a:p>
            </p:txBody>
          </p:sp>
          <p:sp>
            <p:nvSpPr>
              <p:cNvPr id="103" name="TextBox 64"/>
              <p:cNvSpPr txBox="1">
                <a:spLocks noChangeArrowheads="1"/>
              </p:cNvSpPr>
              <p:nvPr/>
            </p:nvSpPr>
            <p:spPr bwMode="auto">
              <a:xfrm rot="18900000">
                <a:off x="1511117" y="5289649"/>
                <a:ext cx="465153" cy="215588"/>
              </a:xfrm>
              <a:prstGeom prst="rect">
                <a:avLst/>
              </a:prstGeom>
              <a:noFill/>
              <a:ln w="9525">
                <a:noFill/>
                <a:miter lim="800000"/>
                <a:headEnd/>
                <a:tailEnd/>
              </a:ln>
            </p:spPr>
            <p:txBody>
              <a:bodyPr wrap="none">
                <a:spAutoFit/>
              </a:bodyPr>
              <a:lstStyle/>
              <a:p>
                <a:pPr eaLnBrk="1" hangingPunct="1"/>
                <a:r>
                  <a:rPr lang="en-US" altLang="en-US" sz="800" b="1"/>
                  <a:t>1X10</a:t>
                </a:r>
                <a:r>
                  <a:rPr lang="en-US" altLang="en-US" sz="800" b="1" baseline="30000"/>
                  <a:t>4</a:t>
                </a:r>
              </a:p>
            </p:txBody>
          </p:sp>
          <p:sp>
            <p:nvSpPr>
              <p:cNvPr id="104" name="TextBox 65"/>
              <p:cNvSpPr txBox="1">
                <a:spLocks noChangeArrowheads="1"/>
              </p:cNvSpPr>
              <p:nvPr/>
            </p:nvSpPr>
            <p:spPr bwMode="auto">
              <a:xfrm rot="18900000">
                <a:off x="1865449" y="5281470"/>
                <a:ext cx="465153" cy="215588"/>
              </a:xfrm>
              <a:prstGeom prst="rect">
                <a:avLst/>
              </a:prstGeom>
              <a:noFill/>
              <a:ln w="9525">
                <a:noFill/>
                <a:miter lim="800000"/>
                <a:headEnd/>
                <a:tailEnd/>
              </a:ln>
            </p:spPr>
            <p:txBody>
              <a:bodyPr wrap="none">
                <a:spAutoFit/>
              </a:bodyPr>
              <a:lstStyle/>
              <a:p>
                <a:pPr eaLnBrk="1" hangingPunct="1"/>
                <a:r>
                  <a:rPr lang="en-US" altLang="en-US" sz="800" b="1"/>
                  <a:t>1X10</a:t>
                </a:r>
                <a:r>
                  <a:rPr lang="en-US" altLang="en-US" sz="800" b="1" baseline="30000"/>
                  <a:t>5</a:t>
                </a:r>
              </a:p>
            </p:txBody>
          </p:sp>
          <p:sp>
            <p:nvSpPr>
              <p:cNvPr id="105" name="TextBox 62"/>
              <p:cNvSpPr txBox="1">
                <a:spLocks noChangeArrowheads="1"/>
              </p:cNvSpPr>
              <p:nvPr/>
            </p:nvSpPr>
            <p:spPr bwMode="auto">
              <a:xfrm rot="18900000">
                <a:off x="2271489" y="5305921"/>
                <a:ext cx="465153" cy="215588"/>
              </a:xfrm>
              <a:prstGeom prst="rect">
                <a:avLst/>
              </a:prstGeom>
              <a:noFill/>
              <a:ln w="9525">
                <a:noFill/>
                <a:miter lim="800000"/>
                <a:headEnd/>
                <a:tailEnd/>
              </a:ln>
            </p:spPr>
            <p:txBody>
              <a:bodyPr wrap="none">
                <a:spAutoFit/>
              </a:bodyPr>
              <a:lstStyle/>
              <a:p>
                <a:pPr eaLnBrk="1" hangingPunct="1"/>
                <a:r>
                  <a:rPr lang="en-US" altLang="en-US" sz="800" b="1"/>
                  <a:t>2X10</a:t>
                </a:r>
                <a:r>
                  <a:rPr lang="en-US" altLang="en-US" sz="800" b="1" baseline="30000"/>
                  <a:t>3</a:t>
                </a:r>
                <a:endParaRPr lang="en-US" altLang="en-US" sz="800" b="1"/>
              </a:p>
            </p:txBody>
          </p:sp>
          <p:sp>
            <p:nvSpPr>
              <p:cNvPr id="106" name="TextBox 63"/>
              <p:cNvSpPr txBox="1">
                <a:spLocks noChangeArrowheads="1"/>
              </p:cNvSpPr>
              <p:nvPr/>
            </p:nvSpPr>
            <p:spPr bwMode="auto">
              <a:xfrm rot="18900000">
                <a:off x="2591042" y="5300898"/>
                <a:ext cx="465153" cy="215588"/>
              </a:xfrm>
              <a:prstGeom prst="rect">
                <a:avLst/>
              </a:prstGeom>
              <a:noFill/>
              <a:ln w="9525">
                <a:noFill/>
                <a:miter lim="800000"/>
                <a:headEnd/>
                <a:tailEnd/>
              </a:ln>
            </p:spPr>
            <p:txBody>
              <a:bodyPr wrap="none">
                <a:spAutoFit/>
              </a:bodyPr>
              <a:lstStyle/>
              <a:p>
                <a:pPr eaLnBrk="1" hangingPunct="1"/>
                <a:r>
                  <a:rPr lang="en-US" altLang="en-US" sz="800" b="1"/>
                  <a:t>5X10</a:t>
                </a:r>
                <a:r>
                  <a:rPr lang="en-US" altLang="en-US" sz="800" b="1" baseline="30000"/>
                  <a:t>3</a:t>
                </a:r>
              </a:p>
            </p:txBody>
          </p:sp>
          <p:sp>
            <p:nvSpPr>
              <p:cNvPr id="107" name="TextBox 64"/>
              <p:cNvSpPr txBox="1">
                <a:spLocks noChangeArrowheads="1"/>
              </p:cNvSpPr>
              <p:nvPr/>
            </p:nvSpPr>
            <p:spPr bwMode="auto">
              <a:xfrm rot="18900000">
                <a:off x="2902523" y="5292504"/>
                <a:ext cx="465153" cy="215588"/>
              </a:xfrm>
              <a:prstGeom prst="rect">
                <a:avLst/>
              </a:prstGeom>
              <a:noFill/>
              <a:ln w="9525">
                <a:noFill/>
                <a:miter lim="800000"/>
                <a:headEnd/>
                <a:tailEnd/>
              </a:ln>
            </p:spPr>
            <p:txBody>
              <a:bodyPr wrap="none">
                <a:spAutoFit/>
              </a:bodyPr>
              <a:lstStyle/>
              <a:p>
                <a:pPr eaLnBrk="1" hangingPunct="1"/>
                <a:r>
                  <a:rPr lang="en-US" altLang="en-US" sz="800" b="1"/>
                  <a:t>1X10</a:t>
                </a:r>
                <a:r>
                  <a:rPr lang="en-US" altLang="en-US" sz="800" b="1" baseline="30000"/>
                  <a:t>4</a:t>
                </a:r>
              </a:p>
            </p:txBody>
          </p:sp>
          <p:sp>
            <p:nvSpPr>
              <p:cNvPr id="108" name="TextBox 65"/>
              <p:cNvSpPr txBox="1">
                <a:spLocks noChangeArrowheads="1"/>
              </p:cNvSpPr>
              <p:nvPr/>
            </p:nvSpPr>
            <p:spPr bwMode="auto">
              <a:xfrm rot="18900000">
                <a:off x="3233994" y="5293856"/>
                <a:ext cx="465153" cy="215588"/>
              </a:xfrm>
              <a:prstGeom prst="rect">
                <a:avLst/>
              </a:prstGeom>
              <a:noFill/>
              <a:ln w="9525">
                <a:noFill/>
                <a:miter lim="800000"/>
                <a:headEnd/>
                <a:tailEnd/>
              </a:ln>
            </p:spPr>
            <p:txBody>
              <a:bodyPr wrap="none">
                <a:spAutoFit/>
              </a:bodyPr>
              <a:lstStyle/>
              <a:p>
                <a:pPr eaLnBrk="1" hangingPunct="1"/>
                <a:r>
                  <a:rPr lang="en-US" altLang="en-US" sz="800" b="1" dirty="0"/>
                  <a:t>1X10</a:t>
                </a:r>
                <a:r>
                  <a:rPr lang="en-US" altLang="en-US" sz="800" b="1" baseline="30000" dirty="0"/>
                  <a:t>5</a:t>
                </a:r>
              </a:p>
            </p:txBody>
          </p:sp>
          <p:sp>
            <p:nvSpPr>
              <p:cNvPr id="110" name="TextBox 62"/>
              <p:cNvSpPr txBox="1">
                <a:spLocks noChangeArrowheads="1"/>
              </p:cNvSpPr>
              <p:nvPr/>
            </p:nvSpPr>
            <p:spPr bwMode="auto">
              <a:xfrm rot="18900000">
                <a:off x="3707100" y="5308776"/>
                <a:ext cx="465153" cy="215588"/>
              </a:xfrm>
              <a:prstGeom prst="rect">
                <a:avLst/>
              </a:prstGeom>
              <a:noFill/>
              <a:ln w="9525">
                <a:noFill/>
                <a:miter lim="800000"/>
                <a:headEnd/>
                <a:tailEnd/>
              </a:ln>
            </p:spPr>
            <p:txBody>
              <a:bodyPr wrap="none">
                <a:spAutoFit/>
              </a:bodyPr>
              <a:lstStyle/>
              <a:p>
                <a:pPr eaLnBrk="1" hangingPunct="1"/>
                <a:r>
                  <a:rPr lang="en-US" altLang="en-US" sz="800" b="1"/>
                  <a:t>2X10</a:t>
                </a:r>
                <a:r>
                  <a:rPr lang="en-US" altLang="en-US" sz="800" b="1" baseline="30000"/>
                  <a:t>3</a:t>
                </a:r>
                <a:endParaRPr lang="en-US" altLang="en-US" sz="800" b="1"/>
              </a:p>
            </p:txBody>
          </p:sp>
          <p:sp>
            <p:nvSpPr>
              <p:cNvPr id="111" name="TextBox 63"/>
              <p:cNvSpPr txBox="1">
                <a:spLocks noChangeArrowheads="1"/>
              </p:cNvSpPr>
              <p:nvPr/>
            </p:nvSpPr>
            <p:spPr bwMode="auto">
              <a:xfrm rot="18900000">
                <a:off x="4037095" y="5303752"/>
                <a:ext cx="465153" cy="215588"/>
              </a:xfrm>
              <a:prstGeom prst="rect">
                <a:avLst/>
              </a:prstGeom>
              <a:noFill/>
              <a:ln w="9525">
                <a:noFill/>
                <a:miter lim="800000"/>
                <a:headEnd/>
                <a:tailEnd/>
              </a:ln>
            </p:spPr>
            <p:txBody>
              <a:bodyPr wrap="none">
                <a:spAutoFit/>
              </a:bodyPr>
              <a:lstStyle/>
              <a:p>
                <a:pPr eaLnBrk="1" hangingPunct="1"/>
                <a:r>
                  <a:rPr lang="en-US" altLang="en-US" sz="800" b="1"/>
                  <a:t>5X10</a:t>
                </a:r>
                <a:r>
                  <a:rPr lang="en-US" altLang="en-US" sz="800" b="1" baseline="30000"/>
                  <a:t>3</a:t>
                </a:r>
              </a:p>
            </p:txBody>
          </p:sp>
          <p:sp>
            <p:nvSpPr>
              <p:cNvPr id="112" name="TextBox 64"/>
              <p:cNvSpPr txBox="1">
                <a:spLocks noChangeArrowheads="1"/>
              </p:cNvSpPr>
              <p:nvPr/>
            </p:nvSpPr>
            <p:spPr bwMode="auto">
              <a:xfrm rot="18900000">
                <a:off x="4363818" y="5295359"/>
                <a:ext cx="465153" cy="215588"/>
              </a:xfrm>
              <a:prstGeom prst="rect">
                <a:avLst/>
              </a:prstGeom>
              <a:noFill/>
              <a:ln w="9525">
                <a:noFill/>
                <a:miter lim="800000"/>
                <a:headEnd/>
                <a:tailEnd/>
              </a:ln>
            </p:spPr>
            <p:txBody>
              <a:bodyPr wrap="none">
                <a:spAutoFit/>
              </a:bodyPr>
              <a:lstStyle/>
              <a:p>
                <a:pPr eaLnBrk="1" hangingPunct="1"/>
                <a:r>
                  <a:rPr lang="en-US" altLang="en-US" sz="800" b="1"/>
                  <a:t>1X10</a:t>
                </a:r>
                <a:r>
                  <a:rPr lang="en-US" altLang="en-US" sz="800" b="1" baseline="30000"/>
                  <a:t>4</a:t>
                </a:r>
              </a:p>
            </p:txBody>
          </p:sp>
          <p:sp>
            <p:nvSpPr>
              <p:cNvPr id="113" name="TextBox 65"/>
              <p:cNvSpPr txBox="1">
                <a:spLocks noChangeArrowheads="1"/>
              </p:cNvSpPr>
              <p:nvPr/>
            </p:nvSpPr>
            <p:spPr bwMode="auto">
              <a:xfrm rot="18900000">
                <a:off x="4695289" y="5287178"/>
                <a:ext cx="465153" cy="215588"/>
              </a:xfrm>
              <a:prstGeom prst="rect">
                <a:avLst/>
              </a:prstGeom>
              <a:noFill/>
              <a:ln w="9525">
                <a:noFill/>
                <a:miter lim="800000"/>
                <a:headEnd/>
                <a:tailEnd/>
              </a:ln>
            </p:spPr>
            <p:txBody>
              <a:bodyPr wrap="none">
                <a:spAutoFit/>
              </a:bodyPr>
              <a:lstStyle/>
              <a:p>
                <a:pPr eaLnBrk="1" hangingPunct="1"/>
                <a:r>
                  <a:rPr lang="en-US" altLang="en-US" sz="800" b="1"/>
                  <a:t>1X10</a:t>
                </a:r>
                <a:r>
                  <a:rPr lang="en-US" altLang="en-US" sz="800" b="1" baseline="30000"/>
                  <a:t>5</a:t>
                </a:r>
              </a:p>
            </p:txBody>
          </p:sp>
          <p:sp>
            <p:nvSpPr>
              <p:cNvPr id="117" name="TextBox 62"/>
              <p:cNvSpPr txBox="1">
                <a:spLocks noChangeArrowheads="1"/>
              </p:cNvSpPr>
              <p:nvPr/>
            </p:nvSpPr>
            <p:spPr bwMode="auto">
              <a:xfrm rot="18900000">
                <a:off x="5015536" y="5311634"/>
                <a:ext cx="465153" cy="215588"/>
              </a:xfrm>
              <a:prstGeom prst="rect">
                <a:avLst/>
              </a:prstGeom>
              <a:noFill/>
              <a:ln w="9525">
                <a:noFill/>
                <a:miter lim="800000"/>
                <a:headEnd/>
                <a:tailEnd/>
              </a:ln>
            </p:spPr>
            <p:txBody>
              <a:bodyPr wrap="none">
                <a:spAutoFit/>
              </a:bodyPr>
              <a:lstStyle/>
              <a:p>
                <a:pPr eaLnBrk="1" hangingPunct="1"/>
                <a:r>
                  <a:rPr lang="en-US" altLang="en-US" sz="800" b="1" dirty="0"/>
                  <a:t>2X10</a:t>
                </a:r>
                <a:r>
                  <a:rPr lang="en-US" altLang="en-US" sz="800" b="1" baseline="30000" dirty="0"/>
                  <a:t>3</a:t>
                </a:r>
                <a:endParaRPr lang="en-US" altLang="en-US" sz="800" b="1" dirty="0"/>
              </a:p>
            </p:txBody>
          </p:sp>
          <p:sp>
            <p:nvSpPr>
              <p:cNvPr id="118" name="TextBox 63"/>
              <p:cNvSpPr txBox="1">
                <a:spLocks noChangeArrowheads="1"/>
              </p:cNvSpPr>
              <p:nvPr/>
            </p:nvSpPr>
            <p:spPr bwMode="auto">
              <a:xfrm rot="18900000">
                <a:off x="5345531" y="5306612"/>
                <a:ext cx="465153" cy="215588"/>
              </a:xfrm>
              <a:prstGeom prst="rect">
                <a:avLst/>
              </a:prstGeom>
              <a:noFill/>
              <a:ln w="9525">
                <a:noFill/>
                <a:miter lim="800000"/>
                <a:headEnd/>
                <a:tailEnd/>
              </a:ln>
            </p:spPr>
            <p:txBody>
              <a:bodyPr wrap="none">
                <a:spAutoFit/>
              </a:bodyPr>
              <a:lstStyle/>
              <a:p>
                <a:pPr eaLnBrk="1" hangingPunct="1"/>
                <a:r>
                  <a:rPr lang="en-US" altLang="en-US" sz="800" b="1"/>
                  <a:t>5X10</a:t>
                </a:r>
                <a:r>
                  <a:rPr lang="en-US" altLang="en-US" sz="800" b="1" baseline="30000"/>
                  <a:t>3</a:t>
                </a:r>
              </a:p>
            </p:txBody>
          </p:sp>
          <p:sp>
            <p:nvSpPr>
              <p:cNvPr id="119" name="TextBox 64"/>
              <p:cNvSpPr txBox="1">
                <a:spLocks noChangeArrowheads="1"/>
              </p:cNvSpPr>
              <p:nvPr/>
            </p:nvSpPr>
            <p:spPr bwMode="auto">
              <a:xfrm rot="18900000">
                <a:off x="5672252" y="5298215"/>
                <a:ext cx="465153" cy="215588"/>
              </a:xfrm>
              <a:prstGeom prst="rect">
                <a:avLst/>
              </a:prstGeom>
              <a:noFill/>
              <a:ln w="9525">
                <a:noFill/>
                <a:miter lim="800000"/>
                <a:headEnd/>
                <a:tailEnd/>
              </a:ln>
            </p:spPr>
            <p:txBody>
              <a:bodyPr wrap="none">
                <a:spAutoFit/>
              </a:bodyPr>
              <a:lstStyle/>
              <a:p>
                <a:pPr eaLnBrk="1" hangingPunct="1"/>
                <a:r>
                  <a:rPr lang="en-US" altLang="en-US" sz="800" b="1"/>
                  <a:t>1X10</a:t>
                </a:r>
                <a:r>
                  <a:rPr lang="en-US" altLang="en-US" sz="800" b="1" baseline="30000"/>
                  <a:t>4</a:t>
                </a:r>
              </a:p>
            </p:txBody>
          </p:sp>
          <p:sp>
            <p:nvSpPr>
              <p:cNvPr id="120" name="TextBox 65"/>
              <p:cNvSpPr txBox="1">
                <a:spLocks noChangeArrowheads="1"/>
              </p:cNvSpPr>
              <p:nvPr/>
            </p:nvSpPr>
            <p:spPr bwMode="auto">
              <a:xfrm rot="18900000">
                <a:off x="6003725" y="5290039"/>
                <a:ext cx="465153" cy="215588"/>
              </a:xfrm>
              <a:prstGeom prst="rect">
                <a:avLst/>
              </a:prstGeom>
              <a:noFill/>
              <a:ln w="9525">
                <a:noFill/>
                <a:miter lim="800000"/>
                <a:headEnd/>
                <a:tailEnd/>
              </a:ln>
            </p:spPr>
            <p:txBody>
              <a:bodyPr wrap="none">
                <a:spAutoFit/>
              </a:bodyPr>
              <a:lstStyle/>
              <a:p>
                <a:pPr eaLnBrk="1" hangingPunct="1"/>
                <a:r>
                  <a:rPr lang="en-US" altLang="en-US" sz="800" b="1"/>
                  <a:t>1X10</a:t>
                </a:r>
                <a:r>
                  <a:rPr lang="en-US" altLang="en-US" sz="800" b="1" baseline="30000"/>
                  <a:t>5</a:t>
                </a:r>
              </a:p>
            </p:txBody>
          </p:sp>
          <p:cxnSp>
            <p:nvCxnSpPr>
              <p:cNvPr id="121" name="Straight Connector 120"/>
              <p:cNvCxnSpPr/>
              <p:nvPr/>
            </p:nvCxnSpPr>
            <p:spPr bwMode="auto">
              <a:xfrm>
                <a:off x="958499" y="5103150"/>
                <a:ext cx="1314339" cy="158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22" name="TextBox 125"/>
              <p:cNvSpPr txBox="1">
                <a:spLocks noChangeArrowheads="1"/>
              </p:cNvSpPr>
              <p:nvPr/>
            </p:nvSpPr>
            <p:spPr bwMode="auto">
              <a:xfrm>
                <a:off x="1305350" y="4888911"/>
                <a:ext cx="465153" cy="215588"/>
              </a:xfrm>
              <a:prstGeom prst="rect">
                <a:avLst/>
              </a:prstGeom>
              <a:noFill/>
              <a:ln w="9525">
                <a:noFill/>
                <a:miter lim="800000"/>
                <a:headEnd/>
                <a:tailEnd/>
              </a:ln>
            </p:spPr>
            <p:txBody>
              <a:bodyPr wrap="none">
                <a:spAutoFit/>
              </a:bodyPr>
              <a:lstStyle/>
              <a:p>
                <a:pPr eaLnBrk="1" hangingPunct="1"/>
                <a:r>
                  <a:rPr lang="en-US" altLang="en-US" sz="800" b="1"/>
                  <a:t>FC 80</a:t>
                </a:r>
              </a:p>
            </p:txBody>
          </p:sp>
          <p:sp>
            <p:nvSpPr>
              <p:cNvPr id="123" name="TextBox 125"/>
              <p:cNvSpPr txBox="1">
                <a:spLocks noChangeArrowheads="1"/>
              </p:cNvSpPr>
              <p:nvPr/>
            </p:nvSpPr>
            <p:spPr bwMode="auto">
              <a:xfrm>
                <a:off x="2618487" y="4887779"/>
                <a:ext cx="465153" cy="215588"/>
              </a:xfrm>
              <a:prstGeom prst="rect">
                <a:avLst/>
              </a:prstGeom>
              <a:noFill/>
              <a:ln w="9525">
                <a:noFill/>
                <a:miter lim="800000"/>
                <a:headEnd/>
                <a:tailEnd/>
              </a:ln>
            </p:spPr>
            <p:txBody>
              <a:bodyPr wrap="none">
                <a:spAutoFit/>
              </a:bodyPr>
              <a:lstStyle/>
              <a:p>
                <a:pPr eaLnBrk="1" hangingPunct="1"/>
                <a:r>
                  <a:rPr lang="en-US" altLang="en-US" sz="800" b="1"/>
                  <a:t>FC 60</a:t>
                </a:r>
              </a:p>
            </p:txBody>
          </p:sp>
          <p:sp>
            <p:nvSpPr>
              <p:cNvPr id="124" name="TextBox 125"/>
              <p:cNvSpPr txBox="1">
                <a:spLocks noChangeArrowheads="1"/>
              </p:cNvSpPr>
              <p:nvPr/>
            </p:nvSpPr>
            <p:spPr bwMode="auto">
              <a:xfrm>
                <a:off x="4007823" y="4886651"/>
                <a:ext cx="465153" cy="215588"/>
              </a:xfrm>
              <a:prstGeom prst="rect">
                <a:avLst/>
              </a:prstGeom>
              <a:noFill/>
              <a:ln w="9525">
                <a:noFill/>
                <a:miter lim="800000"/>
                <a:headEnd/>
                <a:tailEnd/>
              </a:ln>
            </p:spPr>
            <p:txBody>
              <a:bodyPr wrap="none">
                <a:spAutoFit/>
              </a:bodyPr>
              <a:lstStyle/>
              <a:p>
                <a:pPr eaLnBrk="1" hangingPunct="1"/>
                <a:r>
                  <a:rPr lang="en-US" altLang="en-US" sz="800" b="1"/>
                  <a:t>FC 40</a:t>
                </a:r>
              </a:p>
            </p:txBody>
          </p:sp>
          <p:sp>
            <p:nvSpPr>
              <p:cNvPr id="125" name="TextBox 125"/>
              <p:cNvSpPr txBox="1">
                <a:spLocks noChangeArrowheads="1"/>
              </p:cNvSpPr>
              <p:nvPr/>
            </p:nvSpPr>
            <p:spPr bwMode="auto">
              <a:xfrm>
                <a:off x="5397159" y="4885522"/>
                <a:ext cx="465153" cy="215588"/>
              </a:xfrm>
              <a:prstGeom prst="rect">
                <a:avLst/>
              </a:prstGeom>
              <a:noFill/>
              <a:ln w="9525">
                <a:noFill/>
                <a:miter lim="800000"/>
                <a:headEnd/>
                <a:tailEnd/>
              </a:ln>
            </p:spPr>
            <p:txBody>
              <a:bodyPr wrap="none">
                <a:spAutoFit/>
              </a:bodyPr>
              <a:lstStyle/>
              <a:p>
                <a:pPr eaLnBrk="1" hangingPunct="1"/>
                <a:r>
                  <a:rPr lang="en-US" altLang="en-US" sz="800" b="1"/>
                  <a:t>FC 20</a:t>
                </a:r>
              </a:p>
            </p:txBody>
          </p:sp>
          <p:cxnSp>
            <p:nvCxnSpPr>
              <p:cNvPr id="126" name="Straight Connector 125"/>
              <p:cNvCxnSpPr/>
              <p:nvPr/>
            </p:nvCxnSpPr>
            <p:spPr bwMode="auto">
              <a:xfrm>
                <a:off x="2382366" y="5104740"/>
                <a:ext cx="1315926" cy="158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7" name="Straight Connector 126"/>
              <p:cNvCxnSpPr/>
              <p:nvPr/>
            </p:nvCxnSpPr>
            <p:spPr bwMode="auto">
              <a:xfrm>
                <a:off x="3807821" y="5106328"/>
                <a:ext cx="1312751" cy="158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Straight Connector 127"/>
              <p:cNvCxnSpPr/>
              <p:nvPr/>
            </p:nvCxnSpPr>
            <p:spPr bwMode="auto">
              <a:xfrm>
                <a:off x="5230100" y="5107917"/>
                <a:ext cx="1188620" cy="158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0" name="Group 38"/>
            <p:cNvGrpSpPr/>
            <p:nvPr/>
          </p:nvGrpSpPr>
          <p:grpSpPr>
            <a:xfrm>
              <a:off x="142852" y="2357407"/>
              <a:ext cx="927932" cy="2799383"/>
              <a:chOff x="274127" y="4278601"/>
              <a:chExt cx="927932" cy="2799383"/>
            </a:xfrm>
          </p:grpSpPr>
          <p:grpSp>
            <p:nvGrpSpPr>
              <p:cNvPr id="91" name="Group 117"/>
              <p:cNvGrpSpPr>
                <a:grpSpLocks/>
              </p:cNvGrpSpPr>
              <p:nvPr/>
            </p:nvGrpSpPr>
            <p:grpSpPr bwMode="auto">
              <a:xfrm>
                <a:off x="274127" y="4278601"/>
                <a:ext cx="927932" cy="2799383"/>
                <a:chOff x="1164432" y="4783130"/>
                <a:chExt cx="721823" cy="1687441"/>
              </a:xfrm>
            </p:grpSpPr>
            <p:sp>
              <p:nvSpPr>
                <p:cNvPr id="93" name="TextBox 89"/>
                <p:cNvSpPr txBox="1">
                  <a:spLocks noChangeArrowheads="1"/>
                </p:cNvSpPr>
                <p:nvPr/>
              </p:nvSpPr>
              <p:spPr bwMode="auto">
                <a:xfrm>
                  <a:off x="1188645" y="4783130"/>
                  <a:ext cx="431694" cy="129868"/>
                </a:xfrm>
                <a:prstGeom prst="rect">
                  <a:avLst/>
                </a:prstGeom>
                <a:noFill/>
                <a:ln w="9525">
                  <a:noFill/>
                  <a:miter lim="800000"/>
                  <a:headEnd/>
                  <a:tailEnd/>
                </a:ln>
              </p:spPr>
              <p:txBody>
                <a:bodyPr wrap="none">
                  <a:spAutoFit/>
                </a:bodyPr>
                <a:lstStyle/>
                <a:p>
                  <a:r>
                    <a:rPr lang="en-US" sz="800" b="1" i="1" dirty="0"/>
                    <a:t>AtLEA4</a:t>
                  </a:r>
                </a:p>
              </p:txBody>
            </p:sp>
            <p:sp>
              <p:nvSpPr>
                <p:cNvPr id="94" name="TextBox 90"/>
                <p:cNvSpPr txBox="1">
                  <a:spLocks noChangeArrowheads="1"/>
                </p:cNvSpPr>
                <p:nvPr/>
              </p:nvSpPr>
              <p:spPr bwMode="auto">
                <a:xfrm>
                  <a:off x="1182217" y="4994648"/>
                  <a:ext cx="497782" cy="129868"/>
                </a:xfrm>
                <a:prstGeom prst="rect">
                  <a:avLst/>
                </a:prstGeom>
                <a:noFill/>
                <a:ln w="9525">
                  <a:noFill/>
                  <a:miter lim="800000"/>
                  <a:headEnd/>
                  <a:tailEnd/>
                </a:ln>
              </p:spPr>
              <p:txBody>
                <a:bodyPr wrap="none">
                  <a:spAutoFit/>
                </a:bodyPr>
                <a:lstStyle/>
                <a:p>
                  <a:r>
                    <a:rPr lang="en-US" sz="800" b="1" i="1" dirty="0"/>
                    <a:t>AtNCED3</a:t>
                  </a:r>
                </a:p>
              </p:txBody>
            </p:sp>
            <p:sp>
              <p:nvSpPr>
                <p:cNvPr id="95" name="TextBox 91"/>
                <p:cNvSpPr txBox="1">
                  <a:spLocks noChangeArrowheads="1"/>
                </p:cNvSpPr>
                <p:nvPr/>
              </p:nvSpPr>
              <p:spPr bwMode="auto">
                <a:xfrm>
                  <a:off x="1164432" y="5384284"/>
                  <a:ext cx="555142" cy="129868"/>
                </a:xfrm>
                <a:prstGeom prst="rect">
                  <a:avLst/>
                </a:prstGeom>
                <a:noFill/>
                <a:ln w="9525">
                  <a:noFill/>
                  <a:miter lim="800000"/>
                  <a:headEnd/>
                  <a:tailEnd/>
                </a:ln>
              </p:spPr>
              <p:txBody>
                <a:bodyPr wrap="none">
                  <a:spAutoFit/>
                </a:bodyPr>
                <a:lstStyle/>
                <a:p>
                  <a:r>
                    <a:rPr lang="en-US" sz="800" b="1" i="1" dirty="0"/>
                    <a:t>AtDREB1A</a:t>
                  </a:r>
                </a:p>
              </p:txBody>
            </p:sp>
            <p:sp>
              <p:nvSpPr>
                <p:cNvPr id="96" name="TextBox 92"/>
                <p:cNvSpPr txBox="1">
                  <a:spLocks noChangeArrowheads="1"/>
                </p:cNvSpPr>
                <p:nvPr/>
              </p:nvSpPr>
              <p:spPr bwMode="auto">
                <a:xfrm>
                  <a:off x="1182214" y="5762949"/>
                  <a:ext cx="699492" cy="129868"/>
                </a:xfrm>
                <a:prstGeom prst="rect">
                  <a:avLst/>
                </a:prstGeom>
                <a:noFill/>
                <a:ln w="9525">
                  <a:noFill/>
                  <a:miter lim="800000"/>
                  <a:headEnd/>
                  <a:tailEnd/>
                </a:ln>
              </p:spPr>
              <p:txBody>
                <a:bodyPr>
                  <a:spAutoFit/>
                </a:bodyPr>
                <a:lstStyle/>
                <a:p>
                  <a:r>
                    <a:rPr lang="en-US" sz="800" b="1" i="1" dirty="0"/>
                    <a:t>AtPR1</a:t>
                  </a:r>
                </a:p>
              </p:txBody>
            </p:sp>
            <p:sp>
              <p:nvSpPr>
                <p:cNvPr id="97" name="TextBox 93"/>
                <p:cNvSpPr txBox="1">
                  <a:spLocks noChangeArrowheads="1"/>
                </p:cNvSpPr>
                <p:nvPr/>
              </p:nvSpPr>
              <p:spPr bwMode="auto">
                <a:xfrm>
                  <a:off x="1186763" y="5967567"/>
                  <a:ext cx="699492" cy="129868"/>
                </a:xfrm>
                <a:prstGeom prst="rect">
                  <a:avLst/>
                </a:prstGeom>
                <a:noFill/>
                <a:ln w="9525">
                  <a:noFill/>
                  <a:miter lim="800000"/>
                  <a:headEnd/>
                  <a:tailEnd/>
                </a:ln>
              </p:spPr>
              <p:txBody>
                <a:bodyPr>
                  <a:spAutoFit/>
                </a:bodyPr>
                <a:lstStyle/>
                <a:p>
                  <a:r>
                    <a:rPr lang="en-US" sz="800" b="1" i="1"/>
                    <a:t>AtPR5</a:t>
                  </a:r>
                </a:p>
              </p:txBody>
            </p:sp>
            <p:sp>
              <p:nvSpPr>
                <p:cNvPr id="98" name="TextBox 94"/>
                <p:cNvSpPr txBox="1">
                  <a:spLocks noChangeArrowheads="1"/>
                </p:cNvSpPr>
                <p:nvPr/>
              </p:nvSpPr>
              <p:spPr bwMode="auto">
                <a:xfrm>
                  <a:off x="1173462" y="6154134"/>
                  <a:ext cx="699492" cy="129868"/>
                </a:xfrm>
                <a:prstGeom prst="rect">
                  <a:avLst/>
                </a:prstGeom>
                <a:noFill/>
                <a:ln w="9525">
                  <a:noFill/>
                  <a:miter lim="800000"/>
                  <a:headEnd/>
                  <a:tailEnd/>
                </a:ln>
              </p:spPr>
              <p:txBody>
                <a:bodyPr>
                  <a:spAutoFit/>
                </a:bodyPr>
                <a:lstStyle/>
                <a:p>
                  <a:r>
                    <a:rPr lang="en-US" sz="800" b="1" i="1"/>
                    <a:t>AtPAL1</a:t>
                  </a:r>
                </a:p>
              </p:txBody>
            </p:sp>
            <p:sp>
              <p:nvSpPr>
                <p:cNvPr id="99" name="TextBox 95"/>
                <p:cNvSpPr txBox="1">
                  <a:spLocks noChangeArrowheads="1"/>
                </p:cNvSpPr>
                <p:nvPr/>
              </p:nvSpPr>
              <p:spPr bwMode="auto">
                <a:xfrm>
                  <a:off x="1182217" y="6340703"/>
                  <a:ext cx="449151" cy="129868"/>
                </a:xfrm>
                <a:prstGeom prst="rect">
                  <a:avLst/>
                </a:prstGeom>
                <a:noFill/>
                <a:ln w="9525">
                  <a:noFill/>
                  <a:miter lim="800000"/>
                  <a:headEnd/>
                  <a:tailEnd/>
                </a:ln>
              </p:spPr>
              <p:txBody>
                <a:bodyPr wrap="none">
                  <a:spAutoFit/>
                </a:bodyPr>
                <a:lstStyle/>
                <a:p>
                  <a:r>
                    <a:rPr lang="en-US" sz="800" b="1" i="1"/>
                    <a:t>AtLEW2</a:t>
                  </a:r>
                </a:p>
              </p:txBody>
            </p:sp>
            <p:sp>
              <p:nvSpPr>
                <p:cNvPr id="100" name="TextBox 91"/>
                <p:cNvSpPr txBox="1">
                  <a:spLocks noChangeArrowheads="1"/>
                </p:cNvSpPr>
                <p:nvPr/>
              </p:nvSpPr>
              <p:spPr bwMode="auto">
                <a:xfrm>
                  <a:off x="1182214" y="5184476"/>
                  <a:ext cx="444164" cy="129867"/>
                </a:xfrm>
                <a:prstGeom prst="rect">
                  <a:avLst/>
                </a:prstGeom>
                <a:noFill/>
                <a:ln w="9525">
                  <a:noFill/>
                  <a:miter lim="800000"/>
                  <a:headEnd/>
                  <a:tailEnd/>
                </a:ln>
              </p:spPr>
              <p:txBody>
                <a:bodyPr wrap="none">
                  <a:spAutoFit/>
                </a:bodyPr>
                <a:lstStyle/>
                <a:p>
                  <a:r>
                    <a:rPr lang="en-US" sz="800" b="1" i="1" dirty="0" smtClean="0"/>
                    <a:t>AtNAC1</a:t>
                  </a:r>
                  <a:endParaRPr lang="en-US" sz="800" b="1" i="1" dirty="0"/>
                </a:p>
              </p:txBody>
            </p:sp>
          </p:grpSp>
          <p:sp>
            <p:nvSpPr>
              <p:cNvPr id="92" name="TextBox 92"/>
              <p:cNvSpPr txBox="1">
                <a:spLocks noChangeArrowheads="1"/>
              </p:cNvSpPr>
              <p:nvPr/>
            </p:nvSpPr>
            <p:spPr bwMode="auto">
              <a:xfrm>
                <a:off x="293348" y="5602612"/>
                <a:ext cx="899224" cy="215444"/>
              </a:xfrm>
              <a:prstGeom prst="rect">
                <a:avLst/>
              </a:prstGeom>
              <a:noFill/>
              <a:ln w="9525">
                <a:noFill/>
                <a:miter lim="800000"/>
                <a:headEnd/>
                <a:tailEnd/>
              </a:ln>
            </p:spPr>
            <p:txBody>
              <a:bodyPr>
                <a:spAutoFit/>
              </a:bodyPr>
              <a:lstStyle/>
              <a:p>
                <a:r>
                  <a:rPr lang="en-US" sz="800" b="1" i="1" dirty="0" smtClean="0"/>
                  <a:t>AtNPR1</a:t>
                </a:r>
                <a:endParaRPr lang="en-US" sz="800" b="1" i="1" dirty="0"/>
              </a:p>
            </p:txBody>
          </p:sp>
        </p:grpSp>
      </p:grpSp>
      <p:grpSp>
        <p:nvGrpSpPr>
          <p:cNvPr id="130" name="Group 129"/>
          <p:cNvGrpSpPr/>
          <p:nvPr/>
        </p:nvGrpSpPr>
        <p:grpSpPr>
          <a:xfrm>
            <a:off x="5500702" y="571472"/>
            <a:ext cx="1021433" cy="215444"/>
            <a:chOff x="219052" y="2928926"/>
            <a:chExt cx="1021433" cy="215444"/>
          </a:xfrm>
        </p:grpSpPr>
        <p:pic>
          <p:nvPicPr>
            <p:cNvPr id="10242" name="Picture 2"/>
            <p:cNvPicPr>
              <a:picLocks noChangeAspect="1"/>
            </p:cNvPicPr>
            <p:nvPr/>
          </p:nvPicPr>
          <p:blipFill>
            <a:blip r:embed="rId4"/>
            <a:srcRect l="7801" t="1856" r="26110" b="96102"/>
            <a:stretch>
              <a:fillRect/>
            </a:stretch>
          </p:blipFill>
          <p:spPr bwMode="auto">
            <a:xfrm>
              <a:off x="357166" y="2928926"/>
              <a:ext cx="731520" cy="37781"/>
            </a:xfrm>
            <a:prstGeom prst="rect">
              <a:avLst/>
            </a:prstGeom>
            <a:noFill/>
            <a:ln w="9525">
              <a:noFill/>
              <a:miter lim="800000"/>
              <a:headEnd/>
              <a:tailEnd/>
            </a:ln>
          </p:spPr>
        </p:pic>
        <p:sp>
          <p:nvSpPr>
            <p:cNvPr id="129" name="TextBox 128"/>
            <p:cNvSpPr txBox="1"/>
            <p:nvPr/>
          </p:nvSpPr>
          <p:spPr>
            <a:xfrm>
              <a:off x="219052" y="2928926"/>
              <a:ext cx="1021433" cy="215444"/>
            </a:xfrm>
            <a:prstGeom prst="rect">
              <a:avLst/>
            </a:prstGeom>
            <a:noFill/>
          </p:spPr>
          <p:txBody>
            <a:bodyPr wrap="none" rtlCol="0">
              <a:spAutoFit/>
            </a:bodyPr>
            <a:lstStyle/>
            <a:p>
              <a:r>
                <a:rPr lang="en-US" sz="800" b="1" dirty="0" smtClean="0"/>
                <a:t>0.5                   2.5</a:t>
              </a:r>
              <a:endParaRPr lang="en-US" sz="800" b="1" dirty="0"/>
            </a:p>
          </p:txBody>
        </p:sp>
      </p:grpSp>
      <p:pic>
        <p:nvPicPr>
          <p:cNvPr id="1027" name="Picture 3"/>
          <p:cNvPicPr>
            <a:picLocks noChangeAspect="1" noChangeArrowheads="1"/>
          </p:cNvPicPr>
          <p:nvPr/>
        </p:nvPicPr>
        <p:blipFill>
          <a:blip r:embed="rId5"/>
          <a:srcRect l="19594" t="43518" r="44114" b="8405"/>
          <a:stretch>
            <a:fillRect/>
          </a:stretch>
        </p:blipFill>
        <p:spPr bwMode="auto">
          <a:xfrm>
            <a:off x="1857366" y="1128688"/>
            <a:ext cx="1397009" cy="2926080"/>
          </a:xfrm>
          <a:prstGeom prst="rect">
            <a:avLst/>
          </a:prstGeom>
          <a:noFill/>
          <a:ln w="9525">
            <a:noFill/>
            <a:miter lim="800000"/>
            <a:headEnd/>
            <a:tailEnd/>
          </a:ln>
          <a:effectLst/>
        </p:spPr>
      </p:pic>
      <p:grpSp>
        <p:nvGrpSpPr>
          <p:cNvPr id="140" name="Group 139"/>
          <p:cNvGrpSpPr/>
          <p:nvPr/>
        </p:nvGrpSpPr>
        <p:grpSpPr>
          <a:xfrm>
            <a:off x="1285860" y="1200126"/>
            <a:ext cx="927932" cy="2799382"/>
            <a:chOff x="400998" y="5556474"/>
            <a:chExt cx="927932" cy="2799382"/>
          </a:xfrm>
        </p:grpSpPr>
        <p:sp>
          <p:nvSpPr>
            <p:cNvPr id="131" name="TextBox 89"/>
            <p:cNvSpPr txBox="1">
              <a:spLocks noChangeArrowheads="1"/>
            </p:cNvSpPr>
            <p:nvPr/>
          </p:nvSpPr>
          <p:spPr bwMode="auto">
            <a:xfrm>
              <a:off x="432125" y="5556474"/>
              <a:ext cx="554960" cy="215444"/>
            </a:xfrm>
            <a:prstGeom prst="rect">
              <a:avLst/>
            </a:prstGeom>
            <a:noFill/>
            <a:ln w="9525">
              <a:noFill/>
              <a:miter lim="800000"/>
              <a:headEnd/>
              <a:tailEnd/>
            </a:ln>
          </p:spPr>
          <p:txBody>
            <a:bodyPr wrap="none">
              <a:spAutoFit/>
            </a:bodyPr>
            <a:lstStyle/>
            <a:p>
              <a:r>
                <a:rPr lang="en-US" sz="800" b="1" i="1" dirty="0"/>
                <a:t>AtLEA4</a:t>
              </a:r>
            </a:p>
          </p:txBody>
        </p:sp>
        <p:sp>
          <p:nvSpPr>
            <p:cNvPr id="132" name="TextBox 90"/>
            <p:cNvSpPr txBox="1">
              <a:spLocks noChangeArrowheads="1"/>
            </p:cNvSpPr>
            <p:nvPr/>
          </p:nvSpPr>
          <p:spPr bwMode="auto">
            <a:xfrm>
              <a:off x="423861" y="5907372"/>
              <a:ext cx="639919" cy="215444"/>
            </a:xfrm>
            <a:prstGeom prst="rect">
              <a:avLst/>
            </a:prstGeom>
            <a:noFill/>
            <a:ln w="9525">
              <a:noFill/>
              <a:miter lim="800000"/>
              <a:headEnd/>
              <a:tailEnd/>
            </a:ln>
          </p:spPr>
          <p:txBody>
            <a:bodyPr wrap="none">
              <a:spAutoFit/>
            </a:bodyPr>
            <a:lstStyle/>
            <a:p>
              <a:r>
                <a:rPr lang="en-US" sz="800" b="1" i="1" dirty="0"/>
                <a:t>AtNCED3</a:t>
              </a:r>
            </a:p>
          </p:txBody>
        </p:sp>
        <p:sp>
          <p:nvSpPr>
            <p:cNvPr id="133" name="TextBox 91"/>
            <p:cNvSpPr txBox="1">
              <a:spLocks noChangeArrowheads="1"/>
            </p:cNvSpPr>
            <p:nvPr/>
          </p:nvSpPr>
          <p:spPr bwMode="auto">
            <a:xfrm>
              <a:off x="400998" y="6553759"/>
              <a:ext cx="713657" cy="215444"/>
            </a:xfrm>
            <a:prstGeom prst="rect">
              <a:avLst/>
            </a:prstGeom>
            <a:noFill/>
            <a:ln w="9525">
              <a:noFill/>
              <a:miter lim="800000"/>
              <a:headEnd/>
              <a:tailEnd/>
            </a:ln>
          </p:spPr>
          <p:txBody>
            <a:bodyPr wrap="none">
              <a:spAutoFit/>
            </a:bodyPr>
            <a:lstStyle/>
            <a:p>
              <a:r>
                <a:rPr lang="en-US" sz="800" b="1" i="1" dirty="0"/>
                <a:t>AtDREB1A</a:t>
              </a:r>
            </a:p>
          </p:txBody>
        </p:sp>
        <p:sp>
          <p:nvSpPr>
            <p:cNvPr id="134" name="TextBox 92"/>
            <p:cNvSpPr txBox="1">
              <a:spLocks noChangeArrowheads="1"/>
            </p:cNvSpPr>
            <p:nvPr/>
          </p:nvSpPr>
          <p:spPr bwMode="auto">
            <a:xfrm>
              <a:off x="423857" y="7181946"/>
              <a:ext cx="899225" cy="215444"/>
            </a:xfrm>
            <a:prstGeom prst="rect">
              <a:avLst/>
            </a:prstGeom>
            <a:noFill/>
            <a:ln w="9525">
              <a:noFill/>
              <a:miter lim="800000"/>
              <a:headEnd/>
              <a:tailEnd/>
            </a:ln>
          </p:spPr>
          <p:txBody>
            <a:bodyPr>
              <a:spAutoFit/>
            </a:bodyPr>
            <a:lstStyle/>
            <a:p>
              <a:r>
                <a:rPr lang="en-US" sz="800" b="1" i="1" dirty="0"/>
                <a:t>AtPR1</a:t>
              </a:r>
            </a:p>
          </p:txBody>
        </p:sp>
        <p:sp>
          <p:nvSpPr>
            <p:cNvPr id="135" name="TextBox 93"/>
            <p:cNvSpPr txBox="1">
              <a:spLocks noChangeArrowheads="1"/>
            </p:cNvSpPr>
            <p:nvPr/>
          </p:nvSpPr>
          <p:spPr bwMode="auto">
            <a:xfrm>
              <a:off x="429705" y="7521397"/>
              <a:ext cx="899225" cy="215444"/>
            </a:xfrm>
            <a:prstGeom prst="rect">
              <a:avLst/>
            </a:prstGeom>
            <a:noFill/>
            <a:ln w="9525">
              <a:noFill/>
              <a:miter lim="800000"/>
              <a:headEnd/>
              <a:tailEnd/>
            </a:ln>
          </p:spPr>
          <p:txBody>
            <a:bodyPr>
              <a:spAutoFit/>
            </a:bodyPr>
            <a:lstStyle/>
            <a:p>
              <a:r>
                <a:rPr lang="en-US" sz="800" b="1" i="1"/>
                <a:t>AtPR5</a:t>
              </a:r>
            </a:p>
          </p:txBody>
        </p:sp>
        <p:sp>
          <p:nvSpPr>
            <p:cNvPr id="136" name="TextBox 94"/>
            <p:cNvSpPr txBox="1">
              <a:spLocks noChangeArrowheads="1"/>
            </p:cNvSpPr>
            <p:nvPr/>
          </p:nvSpPr>
          <p:spPr bwMode="auto">
            <a:xfrm>
              <a:off x="412606" y="7830903"/>
              <a:ext cx="899225" cy="215444"/>
            </a:xfrm>
            <a:prstGeom prst="rect">
              <a:avLst/>
            </a:prstGeom>
            <a:noFill/>
            <a:ln w="9525">
              <a:noFill/>
              <a:miter lim="800000"/>
              <a:headEnd/>
              <a:tailEnd/>
            </a:ln>
          </p:spPr>
          <p:txBody>
            <a:bodyPr>
              <a:spAutoFit/>
            </a:bodyPr>
            <a:lstStyle/>
            <a:p>
              <a:r>
                <a:rPr lang="en-US" sz="800" b="1" i="1"/>
                <a:t>AtPAL1</a:t>
              </a:r>
            </a:p>
          </p:txBody>
        </p:sp>
        <p:sp>
          <p:nvSpPr>
            <p:cNvPr id="137" name="TextBox 95"/>
            <p:cNvSpPr txBox="1">
              <a:spLocks noChangeArrowheads="1"/>
            </p:cNvSpPr>
            <p:nvPr/>
          </p:nvSpPr>
          <p:spPr bwMode="auto">
            <a:xfrm>
              <a:off x="423861" y="8140412"/>
              <a:ext cx="577402" cy="215444"/>
            </a:xfrm>
            <a:prstGeom prst="rect">
              <a:avLst/>
            </a:prstGeom>
            <a:noFill/>
            <a:ln w="9525">
              <a:noFill/>
              <a:miter lim="800000"/>
              <a:headEnd/>
              <a:tailEnd/>
            </a:ln>
          </p:spPr>
          <p:txBody>
            <a:bodyPr wrap="none">
              <a:spAutoFit/>
            </a:bodyPr>
            <a:lstStyle/>
            <a:p>
              <a:r>
                <a:rPr lang="en-US" sz="800" b="1" i="1"/>
                <a:t>AtLEW2</a:t>
              </a:r>
            </a:p>
          </p:txBody>
        </p:sp>
        <p:sp>
          <p:nvSpPr>
            <p:cNvPr id="138" name="TextBox 91"/>
            <p:cNvSpPr txBox="1">
              <a:spLocks noChangeArrowheads="1"/>
            </p:cNvSpPr>
            <p:nvPr/>
          </p:nvSpPr>
          <p:spPr bwMode="auto">
            <a:xfrm>
              <a:off x="423857" y="6222288"/>
              <a:ext cx="570990" cy="215443"/>
            </a:xfrm>
            <a:prstGeom prst="rect">
              <a:avLst/>
            </a:prstGeom>
            <a:noFill/>
            <a:ln w="9525">
              <a:noFill/>
              <a:miter lim="800000"/>
              <a:headEnd/>
              <a:tailEnd/>
            </a:ln>
          </p:spPr>
          <p:txBody>
            <a:bodyPr wrap="none">
              <a:spAutoFit/>
            </a:bodyPr>
            <a:lstStyle/>
            <a:p>
              <a:r>
                <a:rPr lang="en-US" sz="800" b="1" i="1" dirty="0" smtClean="0"/>
                <a:t>AtNAC1</a:t>
              </a:r>
              <a:endParaRPr lang="en-US" sz="800" b="1" i="1" dirty="0"/>
            </a:p>
          </p:txBody>
        </p:sp>
        <p:sp>
          <p:nvSpPr>
            <p:cNvPr id="139" name="TextBox 92"/>
            <p:cNvSpPr txBox="1">
              <a:spLocks noChangeArrowheads="1"/>
            </p:cNvSpPr>
            <p:nvPr/>
          </p:nvSpPr>
          <p:spPr bwMode="auto">
            <a:xfrm>
              <a:off x="420219" y="6880486"/>
              <a:ext cx="899224" cy="215444"/>
            </a:xfrm>
            <a:prstGeom prst="rect">
              <a:avLst/>
            </a:prstGeom>
            <a:noFill/>
            <a:ln w="9525">
              <a:noFill/>
              <a:miter lim="800000"/>
              <a:headEnd/>
              <a:tailEnd/>
            </a:ln>
          </p:spPr>
          <p:txBody>
            <a:bodyPr>
              <a:spAutoFit/>
            </a:bodyPr>
            <a:lstStyle/>
            <a:p>
              <a:r>
                <a:rPr lang="en-US" sz="800" b="1" i="1" dirty="0" smtClean="0"/>
                <a:t>AtNPR1</a:t>
              </a:r>
              <a:endParaRPr lang="en-US" sz="800" b="1" i="1" dirty="0"/>
            </a:p>
          </p:txBody>
        </p:sp>
      </p:grpSp>
      <p:grpSp>
        <p:nvGrpSpPr>
          <p:cNvPr id="167" name="Group 166"/>
          <p:cNvGrpSpPr/>
          <p:nvPr/>
        </p:nvGrpSpPr>
        <p:grpSpPr>
          <a:xfrm>
            <a:off x="4010791" y="738716"/>
            <a:ext cx="1989977" cy="3297088"/>
            <a:chOff x="4010791" y="738716"/>
            <a:chExt cx="1989977" cy="3297088"/>
          </a:xfrm>
        </p:grpSpPr>
        <p:pic>
          <p:nvPicPr>
            <p:cNvPr id="1028" name="Picture 4"/>
            <p:cNvPicPr>
              <a:picLocks noChangeAspect="1" noChangeArrowheads="1"/>
            </p:cNvPicPr>
            <p:nvPr/>
          </p:nvPicPr>
          <p:blipFill>
            <a:blip r:embed="rId6"/>
            <a:srcRect l="17949" t="42475" r="53846" b="9364"/>
            <a:stretch>
              <a:fillRect/>
            </a:stretch>
          </p:blipFill>
          <p:spPr bwMode="auto">
            <a:xfrm>
              <a:off x="4674888" y="1142974"/>
              <a:ext cx="1325880" cy="2892830"/>
            </a:xfrm>
            <a:prstGeom prst="rect">
              <a:avLst/>
            </a:prstGeom>
            <a:noFill/>
            <a:ln w="9525">
              <a:noFill/>
              <a:miter lim="800000"/>
              <a:headEnd/>
              <a:tailEnd/>
            </a:ln>
            <a:effectLst/>
          </p:spPr>
        </p:pic>
        <p:grpSp>
          <p:nvGrpSpPr>
            <p:cNvPr id="142" name="Group 447"/>
            <p:cNvGrpSpPr>
              <a:grpSpLocks/>
            </p:cNvGrpSpPr>
            <p:nvPr/>
          </p:nvGrpSpPr>
          <p:grpSpPr bwMode="auto">
            <a:xfrm>
              <a:off x="4793036" y="738716"/>
              <a:ext cx="1098046" cy="474723"/>
              <a:chOff x="1408755" y="5508262"/>
              <a:chExt cx="1462635" cy="633329"/>
            </a:xfrm>
          </p:grpSpPr>
          <p:sp>
            <p:nvSpPr>
              <p:cNvPr id="153" name="TextBox 84"/>
              <p:cNvSpPr txBox="1">
                <a:spLocks noChangeArrowheads="1"/>
              </p:cNvSpPr>
              <p:nvPr/>
            </p:nvSpPr>
            <p:spPr bwMode="auto">
              <a:xfrm rot="16200000">
                <a:off x="1241939" y="5687795"/>
                <a:ext cx="620612" cy="286979"/>
              </a:xfrm>
              <a:prstGeom prst="rect">
                <a:avLst/>
              </a:prstGeom>
              <a:noFill/>
              <a:ln w="9525">
                <a:noFill/>
                <a:miter lim="800000"/>
                <a:headEnd/>
                <a:tailEnd/>
              </a:ln>
            </p:spPr>
            <p:txBody>
              <a:bodyPr wrap="none">
                <a:spAutoFit/>
              </a:bodyPr>
              <a:lstStyle/>
              <a:p>
                <a:pPr eaLnBrk="1" hangingPunct="1"/>
                <a:r>
                  <a:rPr lang="en-US" altLang="en-US" sz="800" b="1"/>
                  <a:t>2X10</a:t>
                </a:r>
                <a:r>
                  <a:rPr lang="en-US" altLang="en-US" sz="800" b="1" baseline="30000"/>
                  <a:t>3</a:t>
                </a:r>
              </a:p>
            </p:txBody>
          </p:sp>
          <p:sp>
            <p:nvSpPr>
              <p:cNvPr id="154" name="TextBox 85"/>
              <p:cNvSpPr txBox="1">
                <a:spLocks noChangeArrowheads="1"/>
              </p:cNvSpPr>
              <p:nvPr/>
            </p:nvSpPr>
            <p:spPr bwMode="auto">
              <a:xfrm rot="16200000">
                <a:off x="1617236" y="5675079"/>
                <a:ext cx="620613" cy="286979"/>
              </a:xfrm>
              <a:prstGeom prst="rect">
                <a:avLst/>
              </a:prstGeom>
              <a:noFill/>
              <a:ln w="9525">
                <a:noFill/>
                <a:miter lim="800000"/>
                <a:headEnd/>
                <a:tailEnd/>
              </a:ln>
            </p:spPr>
            <p:txBody>
              <a:bodyPr wrap="none">
                <a:spAutoFit/>
              </a:bodyPr>
              <a:lstStyle/>
              <a:p>
                <a:pPr eaLnBrk="1" hangingPunct="1"/>
                <a:r>
                  <a:rPr lang="en-US" altLang="en-US" sz="800" b="1" dirty="0"/>
                  <a:t>5X10</a:t>
                </a:r>
                <a:r>
                  <a:rPr lang="en-US" altLang="en-US" sz="800" b="1" baseline="30000" dirty="0"/>
                  <a:t>3</a:t>
                </a:r>
              </a:p>
            </p:txBody>
          </p:sp>
          <p:sp>
            <p:nvSpPr>
              <p:cNvPr id="155" name="TextBox 86"/>
              <p:cNvSpPr txBox="1">
                <a:spLocks noChangeArrowheads="1"/>
              </p:cNvSpPr>
              <p:nvPr/>
            </p:nvSpPr>
            <p:spPr bwMode="auto">
              <a:xfrm rot="16200000">
                <a:off x="2036990" y="5676609"/>
                <a:ext cx="620613" cy="286979"/>
              </a:xfrm>
              <a:prstGeom prst="rect">
                <a:avLst/>
              </a:prstGeom>
              <a:noFill/>
              <a:ln w="9525">
                <a:noFill/>
                <a:miter lim="800000"/>
                <a:headEnd/>
                <a:tailEnd/>
              </a:ln>
            </p:spPr>
            <p:txBody>
              <a:bodyPr wrap="none">
                <a:spAutoFit/>
              </a:bodyPr>
              <a:lstStyle/>
              <a:p>
                <a:pPr eaLnBrk="1" hangingPunct="1"/>
                <a:r>
                  <a:rPr lang="en-US" altLang="en-US" sz="800" b="1"/>
                  <a:t>1X10</a:t>
                </a:r>
                <a:r>
                  <a:rPr lang="en-US" altLang="en-US" sz="800" b="1" baseline="30000"/>
                  <a:t>4</a:t>
                </a:r>
              </a:p>
            </p:txBody>
          </p:sp>
          <p:sp>
            <p:nvSpPr>
              <p:cNvPr id="156" name="TextBox 87"/>
              <p:cNvSpPr txBox="1">
                <a:spLocks noChangeArrowheads="1"/>
              </p:cNvSpPr>
              <p:nvPr/>
            </p:nvSpPr>
            <p:spPr bwMode="auto">
              <a:xfrm rot="16200000">
                <a:off x="2417594" y="5676609"/>
                <a:ext cx="620613" cy="286979"/>
              </a:xfrm>
              <a:prstGeom prst="rect">
                <a:avLst/>
              </a:prstGeom>
              <a:noFill/>
              <a:ln w="9525">
                <a:noFill/>
                <a:miter lim="800000"/>
                <a:headEnd/>
                <a:tailEnd/>
              </a:ln>
            </p:spPr>
            <p:txBody>
              <a:bodyPr wrap="none">
                <a:spAutoFit/>
              </a:bodyPr>
              <a:lstStyle/>
              <a:p>
                <a:pPr eaLnBrk="1" hangingPunct="1"/>
                <a:r>
                  <a:rPr lang="en-US" altLang="en-US" sz="800" b="1"/>
                  <a:t>1X10</a:t>
                </a:r>
                <a:r>
                  <a:rPr lang="en-US" altLang="en-US" sz="800" b="1" baseline="30000"/>
                  <a:t>5</a:t>
                </a:r>
              </a:p>
            </p:txBody>
          </p:sp>
        </p:grpSp>
        <p:grpSp>
          <p:nvGrpSpPr>
            <p:cNvPr id="157" name="Group 156"/>
            <p:cNvGrpSpPr/>
            <p:nvPr/>
          </p:nvGrpSpPr>
          <p:grpSpPr>
            <a:xfrm>
              <a:off x="4010791" y="1204889"/>
              <a:ext cx="927932" cy="2799382"/>
              <a:chOff x="400998" y="5556474"/>
              <a:chExt cx="927932" cy="2799382"/>
            </a:xfrm>
          </p:grpSpPr>
          <p:sp>
            <p:nvSpPr>
              <p:cNvPr id="158" name="TextBox 89"/>
              <p:cNvSpPr txBox="1">
                <a:spLocks noChangeArrowheads="1"/>
              </p:cNvSpPr>
              <p:nvPr/>
            </p:nvSpPr>
            <p:spPr bwMode="auto">
              <a:xfrm>
                <a:off x="432125" y="5556474"/>
                <a:ext cx="554960" cy="215444"/>
              </a:xfrm>
              <a:prstGeom prst="rect">
                <a:avLst/>
              </a:prstGeom>
              <a:noFill/>
              <a:ln w="9525">
                <a:noFill/>
                <a:miter lim="800000"/>
                <a:headEnd/>
                <a:tailEnd/>
              </a:ln>
            </p:spPr>
            <p:txBody>
              <a:bodyPr wrap="none">
                <a:spAutoFit/>
              </a:bodyPr>
              <a:lstStyle/>
              <a:p>
                <a:r>
                  <a:rPr lang="en-US" sz="800" b="1" i="1" dirty="0"/>
                  <a:t>AtLEA4</a:t>
                </a:r>
              </a:p>
            </p:txBody>
          </p:sp>
          <p:sp>
            <p:nvSpPr>
              <p:cNvPr id="159" name="TextBox 90"/>
              <p:cNvSpPr txBox="1">
                <a:spLocks noChangeArrowheads="1"/>
              </p:cNvSpPr>
              <p:nvPr/>
            </p:nvSpPr>
            <p:spPr bwMode="auto">
              <a:xfrm>
                <a:off x="423861" y="5907372"/>
                <a:ext cx="639919" cy="215444"/>
              </a:xfrm>
              <a:prstGeom prst="rect">
                <a:avLst/>
              </a:prstGeom>
              <a:noFill/>
              <a:ln w="9525">
                <a:noFill/>
                <a:miter lim="800000"/>
                <a:headEnd/>
                <a:tailEnd/>
              </a:ln>
            </p:spPr>
            <p:txBody>
              <a:bodyPr wrap="none">
                <a:spAutoFit/>
              </a:bodyPr>
              <a:lstStyle/>
              <a:p>
                <a:r>
                  <a:rPr lang="en-US" sz="800" b="1" i="1" dirty="0"/>
                  <a:t>AtNCED3</a:t>
                </a:r>
              </a:p>
            </p:txBody>
          </p:sp>
          <p:sp>
            <p:nvSpPr>
              <p:cNvPr id="160" name="TextBox 91"/>
              <p:cNvSpPr txBox="1">
                <a:spLocks noChangeArrowheads="1"/>
              </p:cNvSpPr>
              <p:nvPr/>
            </p:nvSpPr>
            <p:spPr bwMode="auto">
              <a:xfrm>
                <a:off x="400998" y="6553759"/>
                <a:ext cx="713657" cy="215444"/>
              </a:xfrm>
              <a:prstGeom prst="rect">
                <a:avLst/>
              </a:prstGeom>
              <a:noFill/>
              <a:ln w="9525">
                <a:noFill/>
                <a:miter lim="800000"/>
                <a:headEnd/>
                <a:tailEnd/>
              </a:ln>
            </p:spPr>
            <p:txBody>
              <a:bodyPr wrap="none">
                <a:spAutoFit/>
              </a:bodyPr>
              <a:lstStyle/>
              <a:p>
                <a:r>
                  <a:rPr lang="en-US" sz="800" b="1" i="1" dirty="0"/>
                  <a:t>AtDREB1A</a:t>
                </a:r>
              </a:p>
            </p:txBody>
          </p:sp>
          <p:sp>
            <p:nvSpPr>
              <p:cNvPr id="161" name="TextBox 92"/>
              <p:cNvSpPr txBox="1">
                <a:spLocks noChangeArrowheads="1"/>
              </p:cNvSpPr>
              <p:nvPr/>
            </p:nvSpPr>
            <p:spPr bwMode="auto">
              <a:xfrm>
                <a:off x="423857" y="7181946"/>
                <a:ext cx="899225" cy="215444"/>
              </a:xfrm>
              <a:prstGeom prst="rect">
                <a:avLst/>
              </a:prstGeom>
              <a:noFill/>
              <a:ln w="9525">
                <a:noFill/>
                <a:miter lim="800000"/>
                <a:headEnd/>
                <a:tailEnd/>
              </a:ln>
            </p:spPr>
            <p:txBody>
              <a:bodyPr>
                <a:spAutoFit/>
              </a:bodyPr>
              <a:lstStyle/>
              <a:p>
                <a:r>
                  <a:rPr lang="en-US" sz="800" b="1" i="1" dirty="0"/>
                  <a:t>AtPR1</a:t>
                </a:r>
              </a:p>
            </p:txBody>
          </p:sp>
          <p:sp>
            <p:nvSpPr>
              <p:cNvPr id="162" name="TextBox 93"/>
              <p:cNvSpPr txBox="1">
                <a:spLocks noChangeArrowheads="1"/>
              </p:cNvSpPr>
              <p:nvPr/>
            </p:nvSpPr>
            <p:spPr bwMode="auto">
              <a:xfrm>
                <a:off x="429705" y="7521397"/>
                <a:ext cx="899225" cy="215444"/>
              </a:xfrm>
              <a:prstGeom prst="rect">
                <a:avLst/>
              </a:prstGeom>
              <a:noFill/>
              <a:ln w="9525">
                <a:noFill/>
                <a:miter lim="800000"/>
                <a:headEnd/>
                <a:tailEnd/>
              </a:ln>
            </p:spPr>
            <p:txBody>
              <a:bodyPr>
                <a:spAutoFit/>
              </a:bodyPr>
              <a:lstStyle/>
              <a:p>
                <a:r>
                  <a:rPr lang="en-US" sz="800" b="1" i="1"/>
                  <a:t>AtPR5</a:t>
                </a:r>
              </a:p>
            </p:txBody>
          </p:sp>
          <p:sp>
            <p:nvSpPr>
              <p:cNvPr id="163" name="TextBox 94"/>
              <p:cNvSpPr txBox="1">
                <a:spLocks noChangeArrowheads="1"/>
              </p:cNvSpPr>
              <p:nvPr/>
            </p:nvSpPr>
            <p:spPr bwMode="auto">
              <a:xfrm>
                <a:off x="412606" y="7830903"/>
                <a:ext cx="899225" cy="215444"/>
              </a:xfrm>
              <a:prstGeom prst="rect">
                <a:avLst/>
              </a:prstGeom>
              <a:noFill/>
              <a:ln w="9525">
                <a:noFill/>
                <a:miter lim="800000"/>
                <a:headEnd/>
                <a:tailEnd/>
              </a:ln>
            </p:spPr>
            <p:txBody>
              <a:bodyPr>
                <a:spAutoFit/>
              </a:bodyPr>
              <a:lstStyle/>
              <a:p>
                <a:r>
                  <a:rPr lang="en-US" sz="800" b="1" i="1"/>
                  <a:t>AtPAL1</a:t>
                </a:r>
              </a:p>
            </p:txBody>
          </p:sp>
          <p:sp>
            <p:nvSpPr>
              <p:cNvPr id="164" name="TextBox 95"/>
              <p:cNvSpPr txBox="1">
                <a:spLocks noChangeArrowheads="1"/>
              </p:cNvSpPr>
              <p:nvPr/>
            </p:nvSpPr>
            <p:spPr bwMode="auto">
              <a:xfrm>
                <a:off x="423861" y="8140412"/>
                <a:ext cx="577402" cy="215444"/>
              </a:xfrm>
              <a:prstGeom prst="rect">
                <a:avLst/>
              </a:prstGeom>
              <a:noFill/>
              <a:ln w="9525">
                <a:noFill/>
                <a:miter lim="800000"/>
                <a:headEnd/>
                <a:tailEnd/>
              </a:ln>
            </p:spPr>
            <p:txBody>
              <a:bodyPr wrap="none">
                <a:spAutoFit/>
              </a:bodyPr>
              <a:lstStyle/>
              <a:p>
                <a:r>
                  <a:rPr lang="en-US" sz="800" b="1" i="1"/>
                  <a:t>AtLEW2</a:t>
                </a:r>
              </a:p>
            </p:txBody>
          </p:sp>
          <p:sp>
            <p:nvSpPr>
              <p:cNvPr id="165" name="TextBox 91"/>
              <p:cNvSpPr txBox="1">
                <a:spLocks noChangeArrowheads="1"/>
              </p:cNvSpPr>
              <p:nvPr/>
            </p:nvSpPr>
            <p:spPr bwMode="auto">
              <a:xfrm>
                <a:off x="423857" y="6222288"/>
                <a:ext cx="570990" cy="215443"/>
              </a:xfrm>
              <a:prstGeom prst="rect">
                <a:avLst/>
              </a:prstGeom>
              <a:noFill/>
              <a:ln w="9525">
                <a:noFill/>
                <a:miter lim="800000"/>
                <a:headEnd/>
                <a:tailEnd/>
              </a:ln>
            </p:spPr>
            <p:txBody>
              <a:bodyPr wrap="none">
                <a:spAutoFit/>
              </a:bodyPr>
              <a:lstStyle/>
              <a:p>
                <a:r>
                  <a:rPr lang="en-US" sz="800" b="1" i="1" dirty="0" smtClean="0"/>
                  <a:t>AtNAC1</a:t>
                </a:r>
                <a:endParaRPr lang="en-US" sz="800" b="1" i="1" dirty="0"/>
              </a:p>
            </p:txBody>
          </p:sp>
          <p:sp>
            <p:nvSpPr>
              <p:cNvPr id="166" name="TextBox 92"/>
              <p:cNvSpPr txBox="1">
                <a:spLocks noChangeArrowheads="1"/>
              </p:cNvSpPr>
              <p:nvPr/>
            </p:nvSpPr>
            <p:spPr bwMode="auto">
              <a:xfrm>
                <a:off x="420219" y="6880486"/>
                <a:ext cx="899224" cy="215444"/>
              </a:xfrm>
              <a:prstGeom prst="rect">
                <a:avLst/>
              </a:prstGeom>
              <a:noFill/>
              <a:ln w="9525">
                <a:noFill/>
                <a:miter lim="800000"/>
                <a:headEnd/>
                <a:tailEnd/>
              </a:ln>
            </p:spPr>
            <p:txBody>
              <a:bodyPr>
                <a:spAutoFit/>
              </a:bodyPr>
              <a:lstStyle/>
              <a:p>
                <a:r>
                  <a:rPr lang="en-US" sz="800" b="1" i="1" dirty="0" smtClean="0"/>
                  <a:t>AtNPR1</a:t>
                </a:r>
                <a:endParaRPr lang="en-US" sz="800" b="1" i="1" dirty="0"/>
              </a:p>
            </p:txBody>
          </p:sp>
        </p:grpSp>
      </p:gr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67"/>
          <p:cNvSpPr>
            <a:spLocks noChangeArrowheads="1"/>
          </p:cNvSpPr>
          <p:nvPr/>
        </p:nvSpPr>
        <p:spPr bwMode="auto">
          <a:xfrm>
            <a:off x="0" y="2214546"/>
            <a:ext cx="6858000" cy="2123658"/>
          </a:xfrm>
          <a:prstGeom prst="rect">
            <a:avLst/>
          </a:prstGeom>
          <a:solidFill>
            <a:srgbClr val="FFFFFF"/>
          </a:solidFill>
          <a:ln w="9525">
            <a:noFill/>
            <a:miter lim="800000"/>
            <a:headEnd/>
            <a:tailEnd/>
          </a:ln>
        </p:spPr>
        <p:txBody>
          <a:bodyPr anchor="ctr">
            <a:spAutoFit/>
          </a:bodyPr>
          <a:lstStyle/>
          <a:p>
            <a:pPr algn="just" eaLnBrk="0" hangingPunct="0"/>
            <a:r>
              <a:rPr lang="en-IN" sz="1200" b="1" dirty="0" smtClean="0"/>
              <a:t>Supplementary figure S6</a:t>
            </a:r>
            <a:r>
              <a:rPr lang="en-US" sz="1200" b="1" dirty="0" smtClean="0"/>
              <a:t>. Expression profile of drought and defense related genes</a:t>
            </a:r>
            <a:r>
              <a:rPr lang="en-US" sz="1200" dirty="0" smtClean="0"/>
              <a:t>. The values obtained from q-RT-PCR analysis were used to calculate relative transcript expressions at different treatments over control samples. Heat maps were plotted using these values and the color scheme shows expression levels of drought and pathogen defense related marker genes in plants. Heat map was plotted at varied drought stress levels </a:t>
            </a:r>
            <a:r>
              <a:rPr lang="en-US" sz="1200" b="1" dirty="0" smtClean="0"/>
              <a:t>(A)</a:t>
            </a:r>
            <a:r>
              <a:rPr lang="en-US" sz="1200" dirty="0" smtClean="0"/>
              <a:t>,</a:t>
            </a:r>
            <a:r>
              <a:rPr lang="en-US" sz="1200" b="1" dirty="0" smtClean="0"/>
              <a:t> </a:t>
            </a:r>
            <a:r>
              <a:rPr lang="en-US" sz="1200" dirty="0" smtClean="0"/>
              <a:t>different pathogen concentration </a:t>
            </a:r>
            <a:r>
              <a:rPr lang="en-US" sz="1200" b="1" dirty="0" smtClean="0"/>
              <a:t>(B)</a:t>
            </a:r>
            <a:r>
              <a:rPr lang="en-US" sz="1200" dirty="0" smtClean="0"/>
              <a:t> and under combined stress </a:t>
            </a:r>
            <a:r>
              <a:rPr lang="en-US" sz="1200" b="1" dirty="0" smtClean="0"/>
              <a:t>(C)</a:t>
            </a:r>
            <a:r>
              <a:rPr lang="en-US" sz="1200" dirty="0" smtClean="0"/>
              <a:t> at 24 </a:t>
            </a:r>
            <a:r>
              <a:rPr lang="en-US" sz="1200" dirty="0" err="1" smtClean="0"/>
              <a:t>hpt</a:t>
            </a:r>
            <a:r>
              <a:rPr lang="en-US" sz="1200" dirty="0" smtClean="0"/>
              <a:t>. Color blocks represent mRNA expression pattern with red color as up-regulation and blue color as down-regulation relative to the well watered control or mock control. Data represents the mean of two biological replicates (n= 2). Heat maps were prepared with fold change values using GENE-E software (</a:t>
            </a:r>
            <a:r>
              <a:rPr lang="en-US" sz="1200" u="sng" dirty="0" smtClean="0">
                <a:hlinkClick r:id="rId2"/>
              </a:rPr>
              <a:t>http://www.broadinstitute.org/cancer/software/GENE-E/</a:t>
            </a:r>
            <a:r>
              <a:rPr lang="en-US" sz="1200" dirty="0" smtClean="0"/>
              <a:t>). </a:t>
            </a:r>
            <a:r>
              <a:rPr lang="en-IN" sz="1200" dirty="0" smtClean="0"/>
              <a:t>FC, field capacity (%); </a:t>
            </a:r>
            <a:r>
              <a:rPr lang="en-IN" sz="1200" dirty="0" err="1" smtClean="0"/>
              <a:t>hpt</a:t>
            </a:r>
            <a:r>
              <a:rPr lang="en-IN" sz="1200" dirty="0" smtClean="0"/>
              <a:t>, </a:t>
            </a:r>
            <a:r>
              <a:rPr lang="en-IN" sz="1200" u="sng" dirty="0" smtClean="0"/>
              <a:t>h</a:t>
            </a:r>
            <a:r>
              <a:rPr lang="en-IN" sz="1200" dirty="0" smtClean="0"/>
              <a:t>ours </a:t>
            </a:r>
            <a:r>
              <a:rPr lang="en-IN" sz="1200" u="sng" dirty="0" smtClean="0"/>
              <a:t>p</a:t>
            </a:r>
            <a:r>
              <a:rPr lang="en-IN" sz="1200" dirty="0" smtClean="0"/>
              <a:t>ost combined stress </a:t>
            </a:r>
            <a:r>
              <a:rPr lang="en-IN" sz="1200" u="sng" dirty="0" smtClean="0"/>
              <a:t>t</a:t>
            </a:r>
            <a:r>
              <a:rPr lang="en-IN" sz="1200" dirty="0" smtClean="0"/>
              <a:t>reatment.</a:t>
            </a:r>
            <a:endParaRPr lang="en-US" dirty="0"/>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028C09C9D97D24780058C99077D8847" ma:contentTypeVersion="7" ma:contentTypeDescription="Create a new document." ma:contentTypeScope="" ma:versionID="0132886fdf3e2c25019eb3cd8923805d">
  <xsd:schema xmlns:xsd="http://www.w3.org/2001/XMLSchema" xmlns:p="http://schemas.microsoft.com/office/2006/metadata/properties" xmlns:ns2="39616538-2d66-4de6-9e6e-2b8794b75252" targetNamespace="http://schemas.microsoft.com/office/2006/metadata/properties" ma:root="true" ma:fieldsID="afb14a4498c4490eaa362745f3dd1134" ns2:_="">
    <xsd:import namespace="39616538-2d66-4de6-9e6e-2b8794b7525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9616538-2d66-4de6-9e6e-2b8794b7525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39616538-2d66-4de6-9e6e-2b8794b75252">Presentation</DocumentType>
    <TitleName xmlns="39616538-2d66-4de6-9e6e-2b8794b75252">Presentation 1.PPTX</TitleName>
    <Checked_x0020_Out_x0020_To xmlns="39616538-2d66-4de6-9e6e-2b8794b75252">
      <UserInfo>
        <DisplayName/>
        <AccountId xsi:nil="true"/>
        <AccountType/>
      </UserInfo>
    </Checked_x0020_Out_x0020_To>
    <FileFormat xmlns="39616538-2d66-4de6-9e6e-2b8794b75252">PPTX</FileFormat>
    <DocumentId xmlns="39616538-2d66-4de6-9e6e-2b8794b75252">Presentation 1.PPTX</DocumentId>
    <StageName xmlns="39616538-2d66-4de6-9e6e-2b8794b75252" xsi:nil="true"/>
    <IsDeleted xmlns="39616538-2d66-4de6-9e6e-2b8794b75252">false</IsDeleted>
  </documentManagement>
</p:properties>
</file>

<file path=customXml/itemProps1.xml><?xml version="1.0" encoding="utf-8"?>
<ds:datastoreItem xmlns:ds="http://schemas.openxmlformats.org/officeDocument/2006/customXml" ds:itemID="{222D5A62-5A9D-4620-BB9B-B12A3AC76B4A}"/>
</file>

<file path=customXml/itemProps2.xml><?xml version="1.0" encoding="utf-8"?>
<ds:datastoreItem xmlns:ds="http://schemas.openxmlformats.org/officeDocument/2006/customXml" ds:itemID="{A533879B-FA86-4659-AB38-8C2E7CB1EE45}"/>
</file>

<file path=customXml/itemProps3.xml><?xml version="1.0" encoding="utf-8"?>
<ds:datastoreItem xmlns:ds="http://schemas.openxmlformats.org/officeDocument/2006/customXml" ds:itemID="{BE270BD8-B605-43E9-A6C6-E933BF4D76C2}"/>
</file>

<file path=docProps/app.xml><?xml version="1.0" encoding="utf-8"?>
<Properties xmlns="http://schemas.openxmlformats.org/officeDocument/2006/extended-properties" xmlns:vt="http://schemas.openxmlformats.org/officeDocument/2006/docPropsVTypes">
  <TotalTime>2767</TotalTime>
  <Words>2138</Words>
  <Application>Microsoft Office PowerPoint</Application>
  <PresentationFormat>On-screen Show (4:3)</PresentationFormat>
  <Paragraphs>270</Paragraphs>
  <Slides>13</Slides>
  <Notes>4</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13</vt:i4>
      </vt:variant>
    </vt:vector>
  </HeadingPairs>
  <TitlesOfParts>
    <vt:vector size="19" baseType="lpstr">
      <vt:lpstr>Arial Unicode MS</vt:lpstr>
      <vt:lpstr>Arial</vt:lpstr>
      <vt:lpstr>Calibri</vt:lpstr>
      <vt:lpstr>Times New Roman</vt:lpstr>
      <vt:lpstr>Office Theme</vt:lpstr>
      <vt:lpstr>1_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Grizli777</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arti</dc:creator>
  <cp:lastModifiedBy>Senthil-Kumar Muthappa</cp:lastModifiedBy>
  <cp:revision>47</cp:revision>
  <dcterms:created xsi:type="dcterms:W3CDTF">2015-04-13T10:43:44Z</dcterms:created>
  <dcterms:modified xsi:type="dcterms:W3CDTF">2016-05-19T16:54:2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028C09C9D97D24780058C99077D8847</vt:lpwstr>
  </property>
</Properties>
</file>